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40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804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5600" y="0"/>
            <a:ext cx="294804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71960" cy="3729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3560" cy="447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8040" cy="496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5600" y="9441000"/>
            <a:ext cx="2948040" cy="496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E2C8FE-930D-43A4-9FDC-B4A2138C9381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71960" cy="372924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3560" cy="447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Espace réservé du numéro de diapositive 3"/>
          <p:cNvSpPr/>
          <p:nvPr/>
        </p:nvSpPr>
        <p:spPr>
          <a:xfrm>
            <a:off x="3855960" y="9441000"/>
            <a:ext cx="29480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B5C0BF8-B3EC-4C0B-99BF-1CDCB0ED2AAA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09C3D-64F8-486E-8E32-1A527287CE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83B82-F647-4270-A610-F5B6796F07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ADC79-9A15-4DD0-898B-60EA15B5FA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99944-5406-4457-AEC7-698601B51F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EE389-04F7-41C6-9AE5-2234774E20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3C7BA-C798-463C-8E10-CE28B29F79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FBE9A-348F-4DD8-A8C7-98914072E2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93A29-A935-441F-A5F4-914DE6C242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28C81-5A90-46F4-A552-0CADBCC2B5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87D4E-F6F8-48B1-8724-975DF207A2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D2B20-7844-4034-A465-EB5A3FBD83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5E740-FE9F-458C-AEE6-B3CCD38BAF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52898C0-8A62-4E25-BFA2-53769BD70B47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101"/>
          <p:cNvSpPr/>
          <p:nvPr/>
        </p:nvSpPr>
        <p:spPr>
          <a:xfrm>
            <a:off x="181080" y="-22320"/>
            <a:ext cx="470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e 4"/>
          <p:cNvGrpSpPr/>
          <p:nvPr/>
        </p:nvGrpSpPr>
        <p:grpSpPr>
          <a:xfrm>
            <a:off x="3005280" y="3960720"/>
            <a:ext cx="3719520" cy="2822760"/>
            <a:chOff x="3005280" y="3960720"/>
            <a:chExt cx="3719520" cy="2822760"/>
          </a:xfrm>
        </p:grpSpPr>
        <p:graphicFrame>
          <p:nvGraphicFramePr>
            <p:cNvPr id="50" name="Objet 98"/>
            <p:cNvGraphicFramePr/>
            <p:nvPr/>
          </p:nvGraphicFramePr>
          <p:xfrm>
            <a:off x="3432960" y="3960720"/>
            <a:ext cx="3291840" cy="28227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1" name="Objet 98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432960" y="3960720"/>
                      <a:ext cx="3291840" cy="2822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2" name="ZoneTexte 103"/>
            <p:cNvSpPr/>
            <p:nvPr/>
          </p:nvSpPr>
          <p:spPr>
            <a:xfrm>
              <a:off x="3005280" y="4025160"/>
              <a:ext cx="273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3" name="Groupe 3"/>
          <p:cNvGrpSpPr/>
          <p:nvPr/>
        </p:nvGrpSpPr>
        <p:grpSpPr>
          <a:xfrm>
            <a:off x="181080" y="560520"/>
            <a:ext cx="8908920" cy="5403600"/>
            <a:chOff x="181080" y="560520"/>
            <a:chExt cx="8908920" cy="5403600"/>
          </a:xfrm>
        </p:grpSpPr>
        <p:grpSp>
          <p:nvGrpSpPr>
            <p:cNvPr id="54" name="Groupe 2"/>
            <p:cNvGrpSpPr/>
            <p:nvPr/>
          </p:nvGrpSpPr>
          <p:grpSpPr>
            <a:xfrm>
              <a:off x="181080" y="560520"/>
              <a:ext cx="8602560" cy="5403600"/>
              <a:chOff x="181080" y="560520"/>
              <a:chExt cx="8602560" cy="5403600"/>
            </a:xfrm>
          </p:grpSpPr>
          <p:sp>
            <p:nvSpPr>
              <p:cNvPr id="55" name="Text Box 494"/>
              <p:cNvSpPr/>
              <p:nvPr/>
            </p:nvSpPr>
            <p:spPr>
              <a:xfrm>
                <a:off x="3240000" y="3452400"/>
                <a:ext cx="890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ime (min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 Box 494"/>
              <p:cNvSpPr/>
              <p:nvPr/>
            </p:nvSpPr>
            <p:spPr>
              <a:xfrm>
                <a:off x="7893360" y="3452400"/>
                <a:ext cx="890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ime (min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ZoneTexte 102"/>
              <p:cNvSpPr/>
              <p:nvPr/>
            </p:nvSpPr>
            <p:spPr>
              <a:xfrm>
                <a:off x="181080" y="565200"/>
                <a:ext cx="22730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ZoneTexte 103"/>
              <p:cNvSpPr/>
              <p:nvPr/>
            </p:nvSpPr>
            <p:spPr>
              <a:xfrm>
                <a:off x="5044320" y="560520"/>
                <a:ext cx="22730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9" name="Groupe 163"/>
              <p:cNvGrpSpPr/>
              <p:nvPr/>
            </p:nvGrpSpPr>
            <p:grpSpPr>
              <a:xfrm>
                <a:off x="842400" y="1614960"/>
                <a:ext cx="3229200" cy="1772640"/>
                <a:chOff x="842400" y="1614960"/>
                <a:chExt cx="3229200" cy="1772640"/>
              </a:xfrm>
            </p:grpSpPr>
            <p:grpSp>
              <p:nvGrpSpPr>
                <p:cNvPr id="60" name="Groupe 3"/>
                <p:cNvGrpSpPr/>
                <p:nvPr/>
              </p:nvGrpSpPr>
              <p:grpSpPr>
                <a:xfrm>
                  <a:off x="842400" y="1614960"/>
                  <a:ext cx="3229200" cy="1772640"/>
                  <a:chOff x="842400" y="1614960"/>
                  <a:chExt cx="3229200" cy="1772640"/>
                </a:xfrm>
              </p:grpSpPr>
              <p:sp>
                <p:nvSpPr>
                  <p:cNvPr id="61" name="Line 26"/>
                  <p:cNvSpPr/>
                  <p:nvPr/>
                </p:nvSpPr>
                <p:spPr>
                  <a:xfrm flipH="1">
                    <a:off x="970920" y="3105000"/>
                    <a:ext cx="46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Rectangle 167"/>
                  <p:cNvSpPr/>
                  <p:nvPr/>
                </p:nvSpPr>
                <p:spPr>
                  <a:xfrm>
                    <a:off x="842760" y="3061800"/>
                    <a:ext cx="1072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Freeform 28"/>
                  <p:cNvSpPr/>
                  <p:nvPr/>
                </p:nvSpPr>
                <p:spPr>
                  <a:xfrm>
                    <a:off x="971280" y="274932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Rectangle 169"/>
                  <p:cNvSpPr/>
                  <p:nvPr/>
                </p:nvSpPr>
                <p:spPr>
                  <a:xfrm>
                    <a:off x="842400" y="26895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5" name="Freeform 30"/>
                  <p:cNvSpPr/>
                  <p:nvPr/>
                </p:nvSpPr>
                <p:spPr>
                  <a:xfrm>
                    <a:off x="971280" y="239220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6" name="Rectangle 171"/>
                  <p:cNvSpPr/>
                  <p:nvPr/>
                </p:nvSpPr>
                <p:spPr>
                  <a:xfrm>
                    <a:off x="842400" y="233748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7" name="Freeform 32"/>
                  <p:cNvSpPr/>
                  <p:nvPr/>
                </p:nvSpPr>
                <p:spPr>
                  <a:xfrm>
                    <a:off x="971280" y="203508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Rectangle 173"/>
                  <p:cNvSpPr/>
                  <p:nvPr/>
                </p:nvSpPr>
                <p:spPr>
                  <a:xfrm>
                    <a:off x="842400" y="197028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3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9" name="Freeform 34"/>
                  <p:cNvSpPr/>
                  <p:nvPr/>
                </p:nvSpPr>
                <p:spPr>
                  <a:xfrm>
                    <a:off x="971280" y="167940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0" name="Rectangle 175"/>
                  <p:cNvSpPr/>
                  <p:nvPr/>
                </p:nvSpPr>
                <p:spPr>
                  <a:xfrm>
                    <a:off x="842400" y="16149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1" name="Freeform 40"/>
                  <p:cNvSpPr/>
                  <p:nvPr/>
                </p:nvSpPr>
                <p:spPr>
                  <a:xfrm>
                    <a:off x="975960" y="1661760"/>
                    <a:ext cx="3095640" cy="1486080"/>
                  </a:xfrm>
                  <a:custGeom>
                    <a:avLst/>
                    <a:gdLst/>
                    <a:ahLst/>
                    <a:rect l="l" t="t" r="r" b="b"/>
                    <a:pathLst>
                      <a:path w="1999" h="283">
                        <a:moveTo>
                          <a:pt x="0" y="0"/>
                        </a:moveTo>
                        <a:lnTo>
                          <a:pt x="0" y="283"/>
                        </a:lnTo>
                        <a:lnTo>
                          <a:pt x="1999" y="283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34200" bIns="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" name="Rectangle 177"/>
                  <p:cNvSpPr/>
                  <p:nvPr/>
                </p:nvSpPr>
                <p:spPr>
                  <a:xfrm>
                    <a:off x="1278720" y="32349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" name="Line 74"/>
                  <p:cNvSpPr/>
                  <p:nvPr/>
                </p:nvSpPr>
                <p:spPr>
                  <a:xfrm>
                    <a:off x="1320480" y="3151080"/>
                    <a:ext cx="0" cy="586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4480" bIns="244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Rectangle 179"/>
                  <p:cNvSpPr/>
                  <p:nvPr/>
                </p:nvSpPr>
                <p:spPr>
                  <a:xfrm>
                    <a:off x="2024640" y="32349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Line 80"/>
                  <p:cNvSpPr/>
                  <p:nvPr/>
                </p:nvSpPr>
                <p:spPr>
                  <a:xfrm>
                    <a:off x="2063520" y="3151080"/>
                    <a:ext cx="0" cy="586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4480" bIns="244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" name="Rectangle 181"/>
                  <p:cNvSpPr/>
                  <p:nvPr/>
                </p:nvSpPr>
                <p:spPr>
                  <a:xfrm>
                    <a:off x="2784600" y="32349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" name="Line 86"/>
                  <p:cNvSpPr/>
                  <p:nvPr/>
                </p:nvSpPr>
                <p:spPr>
                  <a:xfrm>
                    <a:off x="2809800" y="3151080"/>
                    <a:ext cx="0" cy="586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4480" bIns="244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Rectangle 183"/>
                  <p:cNvSpPr/>
                  <p:nvPr/>
                </p:nvSpPr>
                <p:spPr>
                  <a:xfrm>
                    <a:off x="3524040" y="32349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3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Line 92"/>
                  <p:cNvSpPr/>
                  <p:nvPr/>
                </p:nvSpPr>
                <p:spPr>
                  <a:xfrm>
                    <a:off x="3552480" y="3151080"/>
                    <a:ext cx="0" cy="586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4480" bIns="244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80" name="Freeform 36"/>
                <p:cNvSpPr/>
                <p:nvPr/>
              </p:nvSpPr>
              <p:spPr>
                <a:xfrm>
                  <a:off x="985320" y="1947600"/>
                  <a:ext cx="3056040" cy="226800"/>
                </a:xfrm>
                <a:custGeom>
                  <a:avLst/>
                  <a:gdLst/>
                  <a:ahLst/>
                  <a:rect l="l" t="t" r="r" b="b"/>
                  <a:pathLst>
                    <a:path w="1993" h="95">
                      <a:moveTo>
                        <a:pt x="0" y="75"/>
                      </a:moveTo>
                      <a:lnTo>
                        <a:pt x="0" y="75"/>
                      </a:lnTo>
                      <a:lnTo>
                        <a:pt x="0" y="79"/>
                      </a:lnTo>
                      <a:lnTo>
                        <a:pt x="0" y="78"/>
                      </a:lnTo>
                      <a:lnTo>
                        <a:pt x="1" y="78"/>
                      </a:lnTo>
                      <a:lnTo>
                        <a:pt x="1" y="76"/>
                      </a:lnTo>
                      <a:lnTo>
                        <a:pt x="1" y="78"/>
                      </a:lnTo>
                      <a:lnTo>
                        <a:pt x="1" y="77"/>
                      </a:lnTo>
                      <a:lnTo>
                        <a:pt x="2" y="77"/>
                      </a:lnTo>
                      <a:lnTo>
                        <a:pt x="2" y="75"/>
                      </a:lnTo>
                      <a:lnTo>
                        <a:pt x="2" y="77"/>
                      </a:lnTo>
                      <a:lnTo>
                        <a:pt x="2" y="76"/>
                      </a:lnTo>
                      <a:lnTo>
                        <a:pt x="3" y="76"/>
                      </a:lnTo>
                      <a:lnTo>
                        <a:pt x="3" y="75"/>
                      </a:lnTo>
                      <a:lnTo>
                        <a:pt x="3" y="79"/>
                      </a:lnTo>
                      <a:lnTo>
                        <a:pt x="3" y="75"/>
                      </a:lnTo>
                      <a:lnTo>
                        <a:pt x="4" y="75"/>
                      </a:lnTo>
                      <a:lnTo>
                        <a:pt x="4" y="77"/>
                      </a:lnTo>
                      <a:lnTo>
                        <a:pt x="4" y="78"/>
                      </a:lnTo>
                      <a:lnTo>
                        <a:pt x="4" y="78"/>
                      </a:lnTo>
                      <a:lnTo>
                        <a:pt x="5" y="78"/>
                      </a:lnTo>
                      <a:lnTo>
                        <a:pt x="5" y="76"/>
                      </a:lnTo>
                      <a:lnTo>
                        <a:pt x="5" y="78"/>
                      </a:lnTo>
                      <a:lnTo>
                        <a:pt x="5" y="77"/>
                      </a:lnTo>
                      <a:lnTo>
                        <a:pt x="6" y="77"/>
                      </a:lnTo>
                      <a:lnTo>
                        <a:pt x="6" y="74"/>
                      </a:lnTo>
                      <a:lnTo>
                        <a:pt x="6" y="79"/>
                      </a:lnTo>
                      <a:lnTo>
                        <a:pt x="6" y="78"/>
                      </a:lnTo>
                      <a:lnTo>
                        <a:pt x="7" y="78"/>
                      </a:lnTo>
                      <a:lnTo>
                        <a:pt x="7" y="75"/>
                      </a:lnTo>
                      <a:lnTo>
                        <a:pt x="7" y="79"/>
                      </a:lnTo>
                      <a:lnTo>
                        <a:pt x="7" y="76"/>
                      </a:lnTo>
                      <a:lnTo>
                        <a:pt x="8" y="76"/>
                      </a:lnTo>
                      <a:lnTo>
                        <a:pt x="8" y="76"/>
                      </a:lnTo>
                      <a:lnTo>
                        <a:pt x="8" y="79"/>
                      </a:lnTo>
                      <a:lnTo>
                        <a:pt x="8" y="76"/>
                      </a:lnTo>
                      <a:lnTo>
                        <a:pt x="9" y="76"/>
                      </a:lnTo>
                      <a:lnTo>
                        <a:pt x="9" y="75"/>
                      </a:lnTo>
                      <a:lnTo>
                        <a:pt x="9" y="78"/>
                      </a:lnTo>
                      <a:lnTo>
                        <a:pt x="9" y="76"/>
                      </a:lnTo>
                      <a:lnTo>
                        <a:pt x="10" y="76"/>
                      </a:lnTo>
                      <a:lnTo>
                        <a:pt x="10" y="75"/>
                      </a:lnTo>
                      <a:lnTo>
                        <a:pt x="10" y="78"/>
                      </a:lnTo>
                      <a:lnTo>
                        <a:pt x="10" y="77"/>
                      </a:lnTo>
                      <a:lnTo>
                        <a:pt x="11" y="77"/>
                      </a:lnTo>
                      <a:lnTo>
                        <a:pt x="11" y="74"/>
                      </a:lnTo>
                      <a:lnTo>
                        <a:pt x="11" y="79"/>
                      </a:lnTo>
                      <a:lnTo>
                        <a:pt x="11" y="79"/>
                      </a:lnTo>
                      <a:lnTo>
                        <a:pt x="12" y="79"/>
                      </a:lnTo>
                      <a:lnTo>
                        <a:pt x="12" y="76"/>
                      </a:lnTo>
                      <a:lnTo>
                        <a:pt x="12" y="79"/>
                      </a:lnTo>
                      <a:lnTo>
                        <a:pt x="12" y="77"/>
                      </a:lnTo>
                      <a:lnTo>
                        <a:pt x="13" y="77"/>
                      </a:lnTo>
                      <a:lnTo>
                        <a:pt x="13" y="75"/>
                      </a:lnTo>
                      <a:lnTo>
                        <a:pt x="13" y="79"/>
                      </a:lnTo>
                      <a:lnTo>
                        <a:pt x="13" y="75"/>
                      </a:lnTo>
                      <a:lnTo>
                        <a:pt x="14" y="75"/>
                      </a:lnTo>
                      <a:lnTo>
                        <a:pt x="14" y="74"/>
                      </a:lnTo>
                      <a:lnTo>
                        <a:pt x="14" y="77"/>
                      </a:lnTo>
                      <a:lnTo>
                        <a:pt x="14" y="77"/>
                      </a:lnTo>
                      <a:lnTo>
                        <a:pt x="15" y="77"/>
                      </a:lnTo>
                      <a:lnTo>
                        <a:pt x="15" y="76"/>
                      </a:lnTo>
                      <a:lnTo>
                        <a:pt x="15" y="79"/>
                      </a:lnTo>
                      <a:lnTo>
                        <a:pt x="15" y="76"/>
                      </a:lnTo>
                      <a:lnTo>
                        <a:pt x="16" y="76"/>
                      </a:lnTo>
                      <a:lnTo>
                        <a:pt x="16" y="73"/>
                      </a:lnTo>
                      <a:lnTo>
                        <a:pt x="16" y="77"/>
                      </a:lnTo>
                      <a:lnTo>
                        <a:pt x="16" y="73"/>
                      </a:lnTo>
                      <a:lnTo>
                        <a:pt x="17" y="73"/>
                      </a:lnTo>
                      <a:lnTo>
                        <a:pt x="17" y="73"/>
                      </a:lnTo>
                      <a:lnTo>
                        <a:pt x="17" y="76"/>
                      </a:lnTo>
                      <a:lnTo>
                        <a:pt x="17" y="73"/>
                      </a:lnTo>
                      <a:lnTo>
                        <a:pt x="18" y="73"/>
                      </a:lnTo>
                      <a:lnTo>
                        <a:pt x="18" y="73"/>
                      </a:lnTo>
                      <a:lnTo>
                        <a:pt x="18" y="76"/>
                      </a:lnTo>
                      <a:lnTo>
                        <a:pt x="18" y="76"/>
                      </a:lnTo>
                      <a:lnTo>
                        <a:pt x="19" y="76"/>
                      </a:lnTo>
                      <a:lnTo>
                        <a:pt x="19" y="74"/>
                      </a:lnTo>
                      <a:lnTo>
                        <a:pt x="19" y="77"/>
                      </a:lnTo>
                      <a:lnTo>
                        <a:pt x="19" y="76"/>
                      </a:lnTo>
                      <a:lnTo>
                        <a:pt x="20" y="76"/>
                      </a:lnTo>
                      <a:lnTo>
                        <a:pt x="20" y="74"/>
                      </a:lnTo>
                      <a:lnTo>
                        <a:pt x="20" y="77"/>
                      </a:lnTo>
                      <a:lnTo>
                        <a:pt x="20" y="77"/>
                      </a:lnTo>
                      <a:lnTo>
                        <a:pt x="21" y="77"/>
                      </a:lnTo>
                      <a:lnTo>
                        <a:pt x="21" y="75"/>
                      </a:lnTo>
                      <a:lnTo>
                        <a:pt x="21" y="78"/>
                      </a:lnTo>
                      <a:lnTo>
                        <a:pt x="21" y="77"/>
                      </a:lnTo>
                      <a:lnTo>
                        <a:pt x="22" y="77"/>
                      </a:lnTo>
                      <a:lnTo>
                        <a:pt x="22" y="74"/>
                      </a:lnTo>
                      <a:lnTo>
                        <a:pt x="22" y="77"/>
                      </a:lnTo>
                      <a:lnTo>
                        <a:pt x="22" y="74"/>
                      </a:lnTo>
                      <a:lnTo>
                        <a:pt x="23" y="74"/>
                      </a:lnTo>
                      <a:lnTo>
                        <a:pt x="23" y="74"/>
                      </a:lnTo>
                      <a:lnTo>
                        <a:pt x="23" y="76"/>
                      </a:lnTo>
                      <a:lnTo>
                        <a:pt x="23" y="74"/>
                      </a:lnTo>
                      <a:lnTo>
                        <a:pt x="24" y="74"/>
                      </a:lnTo>
                      <a:lnTo>
                        <a:pt x="24" y="74"/>
                      </a:lnTo>
                      <a:lnTo>
                        <a:pt x="24" y="78"/>
                      </a:lnTo>
                      <a:lnTo>
                        <a:pt x="24" y="76"/>
                      </a:lnTo>
                      <a:lnTo>
                        <a:pt x="25" y="76"/>
                      </a:lnTo>
                      <a:lnTo>
                        <a:pt x="25" y="76"/>
                      </a:lnTo>
                      <a:lnTo>
                        <a:pt x="25" y="78"/>
                      </a:lnTo>
                      <a:lnTo>
                        <a:pt x="25" y="76"/>
                      </a:lnTo>
                      <a:lnTo>
                        <a:pt x="26" y="76"/>
                      </a:lnTo>
                      <a:lnTo>
                        <a:pt x="26" y="75"/>
                      </a:lnTo>
                      <a:lnTo>
                        <a:pt x="26" y="77"/>
                      </a:lnTo>
                      <a:lnTo>
                        <a:pt x="26" y="77"/>
                      </a:lnTo>
                      <a:lnTo>
                        <a:pt x="27" y="77"/>
                      </a:lnTo>
                      <a:lnTo>
                        <a:pt x="27" y="75"/>
                      </a:lnTo>
                      <a:lnTo>
                        <a:pt x="27" y="78"/>
                      </a:lnTo>
                      <a:lnTo>
                        <a:pt x="27" y="75"/>
                      </a:lnTo>
                      <a:lnTo>
                        <a:pt x="28" y="75"/>
                      </a:lnTo>
                      <a:lnTo>
                        <a:pt x="28" y="74"/>
                      </a:lnTo>
                      <a:lnTo>
                        <a:pt x="28" y="78"/>
                      </a:lnTo>
                      <a:lnTo>
                        <a:pt x="28" y="78"/>
                      </a:lnTo>
                      <a:lnTo>
                        <a:pt x="29" y="78"/>
                      </a:lnTo>
                      <a:lnTo>
                        <a:pt x="29" y="74"/>
                      </a:lnTo>
                      <a:lnTo>
                        <a:pt x="29" y="78"/>
                      </a:lnTo>
                      <a:lnTo>
                        <a:pt x="29" y="77"/>
                      </a:lnTo>
                      <a:lnTo>
                        <a:pt x="30" y="77"/>
                      </a:lnTo>
                      <a:lnTo>
                        <a:pt x="30" y="75"/>
                      </a:lnTo>
                      <a:lnTo>
                        <a:pt x="30" y="78"/>
                      </a:lnTo>
                      <a:lnTo>
                        <a:pt x="30" y="77"/>
                      </a:lnTo>
                      <a:lnTo>
                        <a:pt x="31" y="77"/>
                      </a:lnTo>
                      <a:lnTo>
                        <a:pt x="31" y="73"/>
                      </a:lnTo>
                      <a:lnTo>
                        <a:pt x="31" y="76"/>
                      </a:lnTo>
                      <a:lnTo>
                        <a:pt x="31" y="73"/>
                      </a:lnTo>
                      <a:lnTo>
                        <a:pt x="32" y="73"/>
                      </a:lnTo>
                      <a:lnTo>
                        <a:pt x="32" y="73"/>
                      </a:lnTo>
                      <a:lnTo>
                        <a:pt x="32" y="78"/>
                      </a:lnTo>
                      <a:lnTo>
                        <a:pt x="32" y="78"/>
                      </a:lnTo>
                      <a:lnTo>
                        <a:pt x="33" y="78"/>
                      </a:lnTo>
                      <a:lnTo>
                        <a:pt x="33" y="76"/>
                      </a:lnTo>
                      <a:lnTo>
                        <a:pt x="33" y="79"/>
                      </a:lnTo>
                      <a:lnTo>
                        <a:pt x="33" y="76"/>
                      </a:lnTo>
                      <a:lnTo>
                        <a:pt x="34" y="76"/>
                      </a:lnTo>
                      <a:lnTo>
                        <a:pt x="34" y="73"/>
                      </a:lnTo>
                      <a:lnTo>
                        <a:pt x="34" y="77"/>
                      </a:lnTo>
                      <a:lnTo>
                        <a:pt x="34" y="73"/>
                      </a:lnTo>
                      <a:lnTo>
                        <a:pt x="35" y="73"/>
                      </a:lnTo>
                      <a:lnTo>
                        <a:pt x="35" y="74"/>
                      </a:lnTo>
                      <a:lnTo>
                        <a:pt x="35" y="78"/>
                      </a:lnTo>
                      <a:lnTo>
                        <a:pt x="35" y="78"/>
                      </a:lnTo>
                      <a:lnTo>
                        <a:pt x="36" y="78"/>
                      </a:lnTo>
                      <a:lnTo>
                        <a:pt x="36" y="76"/>
                      </a:lnTo>
                      <a:lnTo>
                        <a:pt x="36" y="78"/>
                      </a:lnTo>
                      <a:lnTo>
                        <a:pt x="36" y="77"/>
                      </a:lnTo>
                      <a:lnTo>
                        <a:pt x="37" y="77"/>
                      </a:lnTo>
                      <a:lnTo>
                        <a:pt x="37" y="75"/>
                      </a:lnTo>
                      <a:lnTo>
                        <a:pt x="37" y="77"/>
                      </a:lnTo>
                      <a:lnTo>
                        <a:pt x="37" y="76"/>
                      </a:lnTo>
                      <a:lnTo>
                        <a:pt x="38" y="76"/>
                      </a:lnTo>
                      <a:lnTo>
                        <a:pt x="38" y="74"/>
                      </a:lnTo>
                      <a:lnTo>
                        <a:pt x="38" y="77"/>
                      </a:lnTo>
                      <a:lnTo>
                        <a:pt x="38" y="77"/>
                      </a:lnTo>
                      <a:lnTo>
                        <a:pt x="39" y="77"/>
                      </a:lnTo>
                      <a:lnTo>
                        <a:pt x="39" y="75"/>
                      </a:lnTo>
                      <a:lnTo>
                        <a:pt x="39" y="78"/>
                      </a:lnTo>
                      <a:lnTo>
                        <a:pt x="39" y="77"/>
                      </a:lnTo>
                      <a:lnTo>
                        <a:pt x="40" y="77"/>
                      </a:lnTo>
                      <a:lnTo>
                        <a:pt x="40" y="74"/>
                      </a:lnTo>
                      <a:lnTo>
                        <a:pt x="40" y="78"/>
                      </a:lnTo>
                      <a:lnTo>
                        <a:pt x="40" y="76"/>
                      </a:lnTo>
                      <a:lnTo>
                        <a:pt x="41" y="76"/>
                      </a:lnTo>
                      <a:lnTo>
                        <a:pt x="41" y="75"/>
                      </a:lnTo>
                      <a:lnTo>
                        <a:pt x="41" y="77"/>
                      </a:lnTo>
                      <a:lnTo>
                        <a:pt x="41" y="76"/>
                      </a:lnTo>
                      <a:lnTo>
                        <a:pt x="42" y="76"/>
                      </a:lnTo>
                      <a:lnTo>
                        <a:pt x="42" y="75"/>
                      </a:lnTo>
                      <a:lnTo>
                        <a:pt x="42" y="79"/>
                      </a:lnTo>
                      <a:lnTo>
                        <a:pt x="42" y="77"/>
                      </a:lnTo>
                      <a:lnTo>
                        <a:pt x="43" y="77"/>
                      </a:lnTo>
                      <a:lnTo>
                        <a:pt x="43" y="75"/>
                      </a:lnTo>
                      <a:lnTo>
                        <a:pt x="43" y="78"/>
                      </a:lnTo>
                      <a:lnTo>
                        <a:pt x="43" y="76"/>
                      </a:lnTo>
                      <a:lnTo>
                        <a:pt x="44" y="76"/>
                      </a:lnTo>
                      <a:lnTo>
                        <a:pt x="44" y="74"/>
                      </a:lnTo>
                      <a:lnTo>
                        <a:pt x="44" y="77"/>
                      </a:lnTo>
                      <a:lnTo>
                        <a:pt x="44" y="76"/>
                      </a:lnTo>
                      <a:lnTo>
                        <a:pt x="45" y="76"/>
                      </a:lnTo>
                      <a:lnTo>
                        <a:pt x="45" y="74"/>
                      </a:lnTo>
                      <a:lnTo>
                        <a:pt x="45" y="77"/>
                      </a:lnTo>
                      <a:lnTo>
                        <a:pt x="45" y="76"/>
                      </a:lnTo>
                      <a:lnTo>
                        <a:pt x="46" y="76"/>
                      </a:lnTo>
                      <a:lnTo>
                        <a:pt x="46" y="74"/>
                      </a:lnTo>
                      <a:lnTo>
                        <a:pt x="46" y="79"/>
                      </a:lnTo>
                      <a:lnTo>
                        <a:pt x="46" y="78"/>
                      </a:lnTo>
                      <a:lnTo>
                        <a:pt x="47" y="78"/>
                      </a:lnTo>
                      <a:lnTo>
                        <a:pt x="47" y="76"/>
                      </a:lnTo>
                      <a:lnTo>
                        <a:pt x="47" y="79"/>
                      </a:lnTo>
                      <a:lnTo>
                        <a:pt x="47" y="77"/>
                      </a:lnTo>
                      <a:lnTo>
                        <a:pt x="48" y="77"/>
                      </a:lnTo>
                      <a:lnTo>
                        <a:pt x="48" y="76"/>
                      </a:lnTo>
                      <a:lnTo>
                        <a:pt x="48" y="80"/>
                      </a:lnTo>
                      <a:lnTo>
                        <a:pt x="48" y="77"/>
                      </a:lnTo>
                      <a:lnTo>
                        <a:pt x="49" y="77"/>
                      </a:lnTo>
                      <a:lnTo>
                        <a:pt x="49" y="75"/>
                      </a:lnTo>
                      <a:lnTo>
                        <a:pt x="49" y="78"/>
                      </a:lnTo>
                      <a:lnTo>
                        <a:pt x="49" y="76"/>
                      </a:lnTo>
                      <a:lnTo>
                        <a:pt x="50" y="76"/>
                      </a:lnTo>
                      <a:lnTo>
                        <a:pt x="50" y="77"/>
                      </a:lnTo>
                      <a:lnTo>
                        <a:pt x="50" y="80"/>
                      </a:lnTo>
                      <a:lnTo>
                        <a:pt x="50" y="80"/>
                      </a:lnTo>
                      <a:lnTo>
                        <a:pt x="51" y="80"/>
                      </a:lnTo>
                      <a:lnTo>
                        <a:pt x="51" y="76"/>
                      </a:lnTo>
                      <a:lnTo>
                        <a:pt x="51" y="82"/>
                      </a:lnTo>
                      <a:lnTo>
                        <a:pt x="51" y="78"/>
                      </a:lnTo>
                      <a:lnTo>
                        <a:pt x="52" y="78"/>
                      </a:lnTo>
                      <a:lnTo>
                        <a:pt x="52" y="76"/>
                      </a:lnTo>
                      <a:lnTo>
                        <a:pt x="52" y="79"/>
                      </a:lnTo>
                      <a:lnTo>
                        <a:pt x="52" y="79"/>
                      </a:lnTo>
                      <a:lnTo>
                        <a:pt x="53" y="79"/>
                      </a:lnTo>
                      <a:lnTo>
                        <a:pt x="53" y="76"/>
                      </a:lnTo>
                      <a:lnTo>
                        <a:pt x="53" y="80"/>
                      </a:lnTo>
                      <a:lnTo>
                        <a:pt x="53" y="79"/>
                      </a:lnTo>
                      <a:lnTo>
                        <a:pt x="54" y="79"/>
                      </a:lnTo>
                      <a:lnTo>
                        <a:pt x="54" y="76"/>
                      </a:lnTo>
                      <a:lnTo>
                        <a:pt x="54" y="79"/>
                      </a:lnTo>
                      <a:lnTo>
                        <a:pt x="54" y="78"/>
                      </a:lnTo>
                      <a:lnTo>
                        <a:pt x="55" y="78"/>
                      </a:lnTo>
                      <a:lnTo>
                        <a:pt x="55" y="77"/>
                      </a:lnTo>
                      <a:lnTo>
                        <a:pt x="55" y="79"/>
                      </a:lnTo>
                      <a:lnTo>
                        <a:pt x="55" y="77"/>
                      </a:lnTo>
                      <a:lnTo>
                        <a:pt x="56" y="77"/>
                      </a:lnTo>
                      <a:lnTo>
                        <a:pt x="56" y="76"/>
                      </a:lnTo>
                      <a:lnTo>
                        <a:pt x="56" y="79"/>
                      </a:lnTo>
                      <a:lnTo>
                        <a:pt x="56" y="77"/>
                      </a:lnTo>
                      <a:lnTo>
                        <a:pt x="57" y="77"/>
                      </a:lnTo>
                      <a:lnTo>
                        <a:pt x="57" y="77"/>
                      </a:lnTo>
                      <a:lnTo>
                        <a:pt x="57" y="79"/>
                      </a:lnTo>
                      <a:lnTo>
                        <a:pt x="57" y="77"/>
                      </a:lnTo>
                      <a:lnTo>
                        <a:pt x="58" y="77"/>
                      </a:lnTo>
                      <a:lnTo>
                        <a:pt x="58" y="76"/>
                      </a:lnTo>
                      <a:lnTo>
                        <a:pt x="58" y="78"/>
                      </a:lnTo>
                      <a:lnTo>
                        <a:pt x="58" y="77"/>
                      </a:lnTo>
                      <a:lnTo>
                        <a:pt x="59" y="77"/>
                      </a:lnTo>
                      <a:lnTo>
                        <a:pt x="59" y="76"/>
                      </a:lnTo>
                      <a:lnTo>
                        <a:pt x="59" y="79"/>
                      </a:lnTo>
                      <a:lnTo>
                        <a:pt x="59" y="78"/>
                      </a:lnTo>
                      <a:lnTo>
                        <a:pt x="60" y="78"/>
                      </a:lnTo>
                      <a:lnTo>
                        <a:pt x="60" y="76"/>
                      </a:lnTo>
                      <a:lnTo>
                        <a:pt x="60" y="79"/>
                      </a:lnTo>
                      <a:lnTo>
                        <a:pt x="60" y="77"/>
                      </a:lnTo>
                      <a:lnTo>
                        <a:pt x="61" y="77"/>
                      </a:lnTo>
                      <a:lnTo>
                        <a:pt x="61" y="76"/>
                      </a:lnTo>
                      <a:lnTo>
                        <a:pt x="61" y="79"/>
                      </a:lnTo>
                      <a:lnTo>
                        <a:pt x="61" y="78"/>
                      </a:lnTo>
                      <a:lnTo>
                        <a:pt x="62" y="78"/>
                      </a:lnTo>
                      <a:lnTo>
                        <a:pt x="62" y="76"/>
                      </a:lnTo>
                      <a:lnTo>
                        <a:pt x="62" y="79"/>
                      </a:lnTo>
                      <a:lnTo>
                        <a:pt x="62" y="79"/>
                      </a:lnTo>
                      <a:lnTo>
                        <a:pt x="63" y="79"/>
                      </a:lnTo>
                      <a:lnTo>
                        <a:pt x="63" y="76"/>
                      </a:lnTo>
                      <a:lnTo>
                        <a:pt x="63" y="78"/>
                      </a:lnTo>
                      <a:lnTo>
                        <a:pt x="63" y="78"/>
                      </a:lnTo>
                      <a:lnTo>
                        <a:pt x="64" y="78"/>
                      </a:lnTo>
                      <a:lnTo>
                        <a:pt x="64" y="74"/>
                      </a:lnTo>
                      <a:lnTo>
                        <a:pt x="64" y="78"/>
                      </a:lnTo>
                      <a:lnTo>
                        <a:pt x="64" y="77"/>
                      </a:lnTo>
                      <a:lnTo>
                        <a:pt x="65" y="77"/>
                      </a:lnTo>
                      <a:lnTo>
                        <a:pt x="65" y="75"/>
                      </a:lnTo>
                      <a:lnTo>
                        <a:pt x="65" y="79"/>
                      </a:lnTo>
                      <a:lnTo>
                        <a:pt x="65" y="77"/>
                      </a:lnTo>
                      <a:lnTo>
                        <a:pt x="66" y="77"/>
                      </a:lnTo>
                      <a:lnTo>
                        <a:pt x="66" y="76"/>
                      </a:lnTo>
                      <a:lnTo>
                        <a:pt x="66" y="79"/>
                      </a:lnTo>
                      <a:lnTo>
                        <a:pt x="66" y="78"/>
                      </a:lnTo>
                      <a:lnTo>
                        <a:pt x="67" y="78"/>
                      </a:lnTo>
                      <a:lnTo>
                        <a:pt x="67" y="76"/>
                      </a:lnTo>
                      <a:lnTo>
                        <a:pt x="67" y="78"/>
                      </a:lnTo>
                      <a:lnTo>
                        <a:pt x="67" y="77"/>
                      </a:lnTo>
                      <a:lnTo>
                        <a:pt x="68" y="77"/>
                      </a:lnTo>
                      <a:lnTo>
                        <a:pt x="68" y="77"/>
                      </a:lnTo>
                      <a:lnTo>
                        <a:pt x="68" y="79"/>
                      </a:lnTo>
                      <a:lnTo>
                        <a:pt x="68" y="79"/>
                      </a:lnTo>
                      <a:lnTo>
                        <a:pt x="69" y="79"/>
                      </a:lnTo>
                      <a:lnTo>
                        <a:pt x="69" y="77"/>
                      </a:lnTo>
                      <a:lnTo>
                        <a:pt x="69" y="79"/>
                      </a:lnTo>
                      <a:lnTo>
                        <a:pt x="69" y="79"/>
                      </a:lnTo>
                      <a:lnTo>
                        <a:pt x="70" y="79"/>
                      </a:lnTo>
                      <a:lnTo>
                        <a:pt x="70" y="77"/>
                      </a:lnTo>
                      <a:lnTo>
                        <a:pt x="70" y="79"/>
                      </a:lnTo>
                      <a:lnTo>
                        <a:pt x="70" y="79"/>
                      </a:lnTo>
                      <a:lnTo>
                        <a:pt x="71" y="79"/>
                      </a:lnTo>
                      <a:lnTo>
                        <a:pt x="71" y="76"/>
                      </a:lnTo>
                      <a:lnTo>
                        <a:pt x="71" y="79"/>
                      </a:lnTo>
                      <a:lnTo>
                        <a:pt x="71" y="77"/>
                      </a:lnTo>
                      <a:lnTo>
                        <a:pt x="72" y="77"/>
                      </a:lnTo>
                      <a:lnTo>
                        <a:pt x="72" y="76"/>
                      </a:lnTo>
                      <a:lnTo>
                        <a:pt x="72" y="80"/>
                      </a:lnTo>
                      <a:lnTo>
                        <a:pt x="72" y="79"/>
                      </a:lnTo>
                      <a:lnTo>
                        <a:pt x="73" y="79"/>
                      </a:lnTo>
                      <a:lnTo>
                        <a:pt x="73" y="79"/>
                      </a:lnTo>
                      <a:lnTo>
                        <a:pt x="73" y="80"/>
                      </a:lnTo>
                      <a:lnTo>
                        <a:pt x="73" y="80"/>
                      </a:lnTo>
                      <a:lnTo>
                        <a:pt x="74" y="80"/>
                      </a:lnTo>
                      <a:lnTo>
                        <a:pt x="74" y="79"/>
                      </a:lnTo>
                      <a:lnTo>
                        <a:pt x="74" y="80"/>
                      </a:lnTo>
                      <a:lnTo>
                        <a:pt x="74" y="79"/>
                      </a:lnTo>
                      <a:lnTo>
                        <a:pt x="75" y="79"/>
                      </a:lnTo>
                      <a:lnTo>
                        <a:pt x="75" y="79"/>
                      </a:lnTo>
                      <a:lnTo>
                        <a:pt x="75" y="82"/>
                      </a:lnTo>
                      <a:lnTo>
                        <a:pt x="75" y="80"/>
                      </a:lnTo>
                      <a:lnTo>
                        <a:pt x="76" y="80"/>
                      </a:lnTo>
                      <a:lnTo>
                        <a:pt x="76" y="77"/>
                      </a:lnTo>
                      <a:lnTo>
                        <a:pt x="76" y="80"/>
                      </a:lnTo>
                      <a:lnTo>
                        <a:pt x="76" y="79"/>
                      </a:lnTo>
                      <a:lnTo>
                        <a:pt x="77" y="79"/>
                      </a:lnTo>
                      <a:lnTo>
                        <a:pt x="77" y="79"/>
                      </a:lnTo>
                      <a:lnTo>
                        <a:pt x="77" y="80"/>
                      </a:lnTo>
                      <a:lnTo>
                        <a:pt x="77" y="80"/>
                      </a:lnTo>
                      <a:lnTo>
                        <a:pt x="78" y="80"/>
                      </a:lnTo>
                      <a:lnTo>
                        <a:pt x="78" y="77"/>
                      </a:lnTo>
                      <a:lnTo>
                        <a:pt x="78" y="82"/>
                      </a:lnTo>
                      <a:lnTo>
                        <a:pt x="78" y="80"/>
                      </a:lnTo>
                      <a:lnTo>
                        <a:pt x="79" y="80"/>
                      </a:lnTo>
                      <a:lnTo>
                        <a:pt x="79" y="78"/>
                      </a:lnTo>
                      <a:lnTo>
                        <a:pt x="79" y="82"/>
                      </a:lnTo>
                      <a:lnTo>
                        <a:pt x="79" y="82"/>
                      </a:lnTo>
                      <a:lnTo>
                        <a:pt x="80" y="82"/>
                      </a:lnTo>
                      <a:lnTo>
                        <a:pt x="80" y="79"/>
                      </a:lnTo>
                      <a:lnTo>
                        <a:pt x="80" y="82"/>
                      </a:lnTo>
                      <a:lnTo>
                        <a:pt x="80" y="79"/>
                      </a:lnTo>
                      <a:lnTo>
                        <a:pt x="81" y="79"/>
                      </a:lnTo>
                      <a:lnTo>
                        <a:pt x="81" y="78"/>
                      </a:lnTo>
                      <a:lnTo>
                        <a:pt x="81" y="81"/>
                      </a:lnTo>
                      <a:lnTo>
                        <a:pt x="81" y="79"/>
                      </a:lnTo>
                      <a:lnTo>
                        <a:pt x="82" y="79"/>
                      </a:lnTo>
                      <a:lnTo>
                        <a:pt x="82" y="78"/>
                      </a:lnTo>
                      <a:lnTo>
                        <a:pt x="82" y="80"/>
                      </a:lnTo>
                      <a:lnTo>
                        <a:pt x="82" y="79"/>
                      </a:lnTo>
                      <a:lnTo>
                        <a:pt x="83" y="79"/>
                      </a:lnTo>
                      <a:lnTo>
                        <a:pt x="83" y="79"/>
                      </a:lnTo>
                      <a:lnTo>
                        <a:pt x="83" y="82"/>
                      </a:lnTo>
                      <a:lnTo>
                        <a:pt x="83" y="80"/>
                      </a:lnTo>
                      <a:lnTo>
                        <a:pt x="84" y="80"/>
                      </a:lnTo>
                      <a:lnTo>
                        <a:pt x="84" y="79"/>
                      </a:lnTo>
                      <a:lnTo>
                        <a:pt x="84" y="83"/>
                      </a:lnTo>
                      <a:lnTo>
                        <a:pt x="84" y="79"/>
                      </a:lnTo>
                      <a:lnTo>
                        <a:pt x="85" y="79"/>
                      </a:lnTo>
                      <a:lnTo>
                        <a:pt x="85" y="77"/>
                      </a:lnTo>
                      <a:lnTo>
                        <a:pt x="85" y="80"/>
                      </a:lnTo>
                      <a:lnTo>
                        <a:pt x="85" y="77"/>
                      </a:lnTo>
                      <a:lnTo>
                        <a:pt x="86" y="77"/>
                      </a:lnTo>
                      <a:lnTo>
                        <a:pt x="86" y="78"/>
                      </a:lnTo>
                      <a:lnTo>
                        <a:pt x="86" y="80"/>
                      </a:lnTo>
                      <a:lnTo>
                        <a:pt x="86" y="80"/>
                      </a:lnTo>
                      <a:lnTo>
                        <a:pt x="87" y="80"/>
                      </a:lnTo>
                      <a:lnTo>
                        <a:pt x="87" y="77"/>
                      </a:lnTo>
                      <a:lnTo>
                        <a:pt x="87" y="80"/>
                      </a:lnTo>
                      <a:lnTo>
                        <a:pt x="87" y="80"/>
                      </a:lnTo>
                      <a:lnTo>
                        <a:pt x="88" y="80"/>
                      </a:lnTo>
                      <a:lnTo>
                        <a:pt x="88" y="77"/>
                      </a:lnTo>
                      <a:lnTo>
                        <a:pt x="88" y="80"/>
                      </a:lnTo>
                      <a:lnTo>
                        <a:pt x="88" y="77"/>
                      </a:lnTo>
                      <a:lnTo>
                        <a:pt x="89" y="77"/>
                      </a:lnTo>
                      <a:lnTo>
                        <a:pt x="89" y="76"/>
                      </a:lnTo>
                      <a:lnTo>
                        <a:pt x="89" y="80"/>
                      </a:lnTo>
                      <a:lnTo>
                        <a:pt x="89" y="77"/>
                      </a:lnTo>
                      <a:lnTo>
                        <a:pt x="90" y="77"/>
                      </a:lnTo>
                      <a:lnTo>
                        <a:pt x="90" y="77"/>
                      </a:lnTo>
                      <a:lnTo>
                        <a:pt x="90" y="81"/>
                      </a:lnTo>
                      <a:lnTo>
                        <a:pt x="90" y="81"/>
                      </a:lnTo>
                      <a:lnTo>
                        <a:pt x="91" y="81"/>
                      </a:lnTo>
                      <a:lnTo>
                        <a:pt x="91" y="77"/>
                      </a:lnTo>
                      <a:lnTo>
                        <a:pt x="91" y="82"/>
                      </a:lnTo>
                      <a:lnTo>
                        <a:pt x="91" y="79"/>
                      </a:lnTo>
                      <a:lnTo>
                        <a:pt x="92" y="79"/>
                      </a:lnTo>
                      <a:lnTo>
                        <a:pt x="92" y="77"/>
                      </a:lnTo>
                      <a:lnTo>
                        <a:pt x="92" y="80"/>
                      </a:lnTo>
                      <a:lnTo>
                        <a:pt x="92" y="78"/>
                      </a:lnTo>
                      <a:lnTo>
                        <a:pt x="93" y="78"/>
                      </a:lnTo>
                      <a:lnTo>
                        <a:pt x="93" y="78"/>
                      </a:lnTo>
                      <a:lnTo>
                        <a:pt x="93" y="80"/>
                      </a:lnTo>
                      <a:lnTo>
                        <a:pt x="93" y="79"/>
                      </a:lnTo>
                      <a:lnTo>
                        <a:pt x="94" y="79"/>
                      </a:lnTo>
                      <a:lnTo>
                        <a:pt x="94" y="77"/>
                      </a:lnTo>
                      <a:lnTo>
                        <a:pt x="94" y="81"/>
                      </a:lnTo>
                      <a:lnTo>
                        <a:pt x="94" y="80"/>
                      </a:lnTo>
                      <a:lnTo>
                        <a:pt x="95" y="80"/>
                      </a:lnTo>
                      <a:lnTo>
                        <a:pt x="95" y="78"/>
                      </a:lnTo>
                      <a:lnTo>
                        <a:pt x="95" y="80"/>
                      </a:lnTo>
                      <a:lnTo>
                        <a:pt x="95" y="80"/>
                      </a:lnTo>
                      <a:lnTo>
                        <a:pt x="96" y="80"/>
                      </a:lnTo>
                      <a:lnTo>
                        <a:pt x="96" y="77"/>
                      </a:lnTo>
                      <a:lnTo>
                        <a:pt x="96" y="80"/>
                      </a:lnTo>
                      <a:lnTo>
                        <a:pt x="96" y="80"/>
                      </a:lnTo>
                      <a:lnTo>
                        <a:pt x="97" y="80"/>
                      </a:lnTo>
                      <a:lnTo>
                        <a:pt x="97" y="79"/>
                      </a:lnTo>
                      <a:lnTo>
                        <a:pt x="97" y="83"/>
                      </a:lnTo>
                      <a:lnTo>
                        <a:pt x="97" y="80"/>
                      </a:lnTo>
                      <a:lnTo>
                        <a:pt x="98" y="80"/>
                      </a:lnTo>
                      <a:lnTo>
                        <a:pt x="98" y="77"/>
                      </a:lnTo>
                      <a:lnTo>
                        <a:pt x="98" y="83"/>
                      </a:lnTo>
                      <a:lnTo>
                        <a:pt x="98" y="79"/>
                      </a:lnTo>
                      <a:lnTo>
                        <a:pt x="99" y="79"/>
                      </a:lnTo>
                      <a:lnTo>
                        <a:pt x="99" y="79"/>
                      </a:lnTo>
                      <a:lnTo>
                        <a:pt x="99" y="80"/>
                      </a:lnTo>
                      <a:lnTo>
                        <a:pt x="99" y="79"/>
                      </a:lnTo>
                      <a:lnTo>
                        <a:pt x="100" y="79"/>
                      </a:lnTo>
                      <a:lnTo>
                        <a:pt x="100" y="78"/>
                      </a:lnTo>
                      <a:lnTo>
                        <a:pt x="100" y="81"/>
                      </a:lnTo>
                      <a:lnTo>
                        <a:pt x="100" y="80"/>
                      </a:lnTo>
                      <a:lnTo>
                        <a:pt x="101" y="80"/>
                      </a:lnTo>
                      <a:lnTo>
                        <a:pt x="101" y="78"/>
                      </a:lnTo>
                      <a:lnTo>
                        <a:pt x="101" y="82"/>
                      </a:lnTo>
                      <a:lnTo>
                        <a:pt x="101" y="80"/>
                      </a:lnTo>
                      <a:lnTo>
                        <a:pt x="102" y="80"/>
                      </a:lnTo>
                      <a:lnTo>
                        <a:pt x="102" y="78"/>
                      </a:lnTo>
                      <a:lnTo>
                        <a:pt x="102" y="81"/>
                      </a:lnTo>
                      <a:lnTo>
                        <a:pt x="102" y="79"/>
                      </a:lnTo>
                      <a:lnTo>
                        <a:pt x="103" y="79"/>
                      </a:lnTo>
                      <a:lnTo>
                        <a:pt x="103" y="78"/>
                      </a:lnTo>
                      <a:lnTo>
                        <a:pt x="103" y="81"/>
                      </a:lnTo>
                      <a:lnTo>
                        <a:pt x="103" y="81"/>
                      </a:lnTo>
                      <a:lnTo>
                        <a:pt x="104" y="81"/>
                      </a:lnTo>
                      <a:lnTo>
                        <a:pt x="104" y="81"/>
                      </a:lnTo>
                      <a:lnTo>
                        <a:pt x="104" y="83"/>
                      </a:lnTo>
                      <a:lnTo>
                        <a:pt x="104" y="82"/>
                      </a:lnTo>
                      <a:lnTo>
                        <a:pt x="105" y="82"/>
                      </a:lnTo>
                      <a:lnTo>
                        <a:pt x="105" y="80"/>
                      </a:lnTo>
                      <a:lnTo>
                        <a:pt x="105" y="82"/>
                      </a:lnTo>
                      <a:lnTo>
                        <a:pt x="105" y="80"/>
                      </a:lnTo>
                      <a:lnTo>
                        <a:pt x="106" y="80"/>
                      </a:lnTo>
                      <a:lnTo>
                        <a:pt x="106" y="77"/>
                      </a:lnTo>
                      <a:lnTo>
                        <a:pt x="106" y="81"/>
                      </a:lnTo>
                      <a:lnTo>
                        <a:pt x="106" y="78"/>
                      </a:lnTo>
                      <a:lnTo>
                        <a:pt x="107" y="78"/>
                      </a:lnTo>
                      <a:lnTo>
                        <a:pt x="107" y="77"/>
                      </a:lnTo>
                      <a:lnTo>
                        <a:pt x="107" y="82"/>
                      </a:lnTo>
                      <a:lnTo>
                        <a:pt x="107" y="79"/>
                      </a:lnTo>
                      <a:lnTo>
                        <a:pt x="108" y="79"/>
                      </a:lnTo>
                      <a:lnTo>
                        <a:pt x="108" y="79"/>
                      </a:lnTo>
                      <a:lnTo>
                        <a:pt x="108" y="81"/>
                      </a:lnTo>
                      <a:lnTo>
                        <a:pt x="108" y="80"/>
                      </a:lnTo>
                      <a:lnTo>
                        <a:pt x="109" y="80"/>
                      </a:lnTo>
                      <a:lnTo>
                        <a:pt x="109" y="79"/>
                      </a:lnTo>
                      <a:lnTo>
                        <a:pt x="109" y="80"/>
                      </a:lnTo>
                      <a:lnTo>
                        <a:pt x="109" y="79"/>
                      </a:lnTo>
                      <a:lnTo>
                        <a:pt x="110" y="79"/>
                      </a:lnTo>
                      <a:lnTo>
                        <a:pt x="110" y="79"/>
                      </a:lnTo>
                      <a:lnTo>
                        <a:pt x="110" y="81"/>
                      </a:lnTo>
                      <a:lnTo>
                        <a:pt x="110" y="79"/>
                      </a:lnTo>
                      <a:lnTo>
                        <a:pt x="111" y="79"/>
                      </a:lnTo>
                      <a:lnTo>
                        <a:pt x="111" y="79"/>
                      </a:lnTo>
                      <a:lnTo>
                        <a:pt x="111" y="81"/>
                      </a:lnTo>
                      <a:lnTo>
                        <a:pt x="111" y="80"/>
                      </a:lnTo>
                      <a:lnTo>
                        <a:pt x="112" y="80"/>
                      </a:lnTo>
                      <a:lnTo>
                        <a:pt x="112" y="78"/>
                      </a:lnTo>
                      <a:lnTo>
                        <a:pt x="112" y="81"/>
                      </a:lnTo>
                      <a:lnTo>
                        <a:pt x="112" y="80"/>
                      </a:lnTo>
                      <a:lnTo>
                        <a:pt x="113" y="80"/>
                      </a:lnTo>
                      <a:lnTo>
                        <a:pt x="113" y="79"/>
                      </a:lnTo>
                      <a:lnTo>
                        <a:pt x="113" y="81"/>
                      </a:lnTo>
                      <a:lnTo>
                        <a:pt x="113" y="80"/>
                      </a:lnTo>
                      <a:lnTo>
                        <a:pt x="114" y="80"/>
                      </a:lnTo>
                      <a:lnTo>
                        <a:pt x="114" y="77"/>
                      </a:lnTo>
                      <a:lnTo>
                        <a:pt x="114" y="82"/>
                      </a:lnTo>
                      <a:lnTo>
                        <a:pt x="114" y="78"/>
                      </a:lnTo>
                      <a:lnTo>
                        <a:pt x="115" y="78"/>
                      </a:lnTo>
                      <a:lnTo>
                        <a:pt x="115" y="79"/>
                      </a:lnTo>
                      <a:lnTo>
                        <a:pt x="115" y="83"/>
                      </a:lnTo>
                      <a:lnTo>
                        <a:pt x="115" y="82"/>
                      </a:lnTo>
                      <a:lnTo>
                        <a:pt x="116" y="82"/>
                      </a:lnTo>
                      <a:lnTo>
                        <a:pt x="116" y="79"/>
                      </a:lnTo>
                      <a:lnTo>
                        <a:pt x="116" y="82"/>
                      </a:lnTo>
                      <a:lnTo>
                        <a:pt x="116" y="80"/>
                      </a:lnTo>
                      <a:lnTo>
                        <a:pt x="117" y="80"/>
                      </a:lnTo>
                      <a:lnTo>
                        <a:pt x="117" y="79"/>
                      </a:lnTo>
                      <a:lnTo>
                        <a:pt x="117" y="80"/>
                      </a:lnTo>
                      <a:lnTo>
                        <a:pt x="117" y="80"/>
                      </a:lnTo>
                      <a:lnTo>
                        <a:pt x="118" y="80"/>
                      </a:lnTo>
                      <a:lnTo>
                        <a:pt x="118" y="78"/>
                      </a:lnTo>
                      <a:lnTo>
                        <a:pt x="118" y="82"/>
                      </a:lnTo>
                      <a:lnTo>
                        <a:pt x="118" y="80"/>
                      </a:lnTo>
                      <a:lnTo>
                        <a:pt x="119" y="80"/>
                      </a:lnTo>
                      <a:lnTo>
                        <a:pt x="119" y="79"/>
                      </a:lnTo>
                      <a:lnTo>
                        <a:pt x="119" y="82"/>
                      </a:lnTo>
                      <a:lnTo>
                        <a:pt x="119" y="79"/>
                      </a:lnTo>
                      <a:lnTo>
                        <a:pt x="120" y="79"/>
                      </a:lnTo>
                      <a:lnTo>
                        <a:pt x="120" y="77"/>
                      </a:lnTo>
                      <a:lnTo>
                        <a:pt x="120" y="80"/>
                      </a:lnTo>
                      <a:lnTo>
                        <a:pt x="120" y="78"/>
                      </a:lnTo>
                      <a:lnTo>
                        <a:pt x="121" y="78"/>
                      </a:lnTo>
                      <a:lnTo>
                        <a:pt x="121" y="77"/>
                      </a:lnTo>
                      <a:lnTo>
                        <a:pt x="121" y="80"/>
                      </a:lnTo>
                      <a:lnTo>
                        <a:pt x="121" y="79"/>
                      </a:lnTo>
                      <a:lnTo>
                        <a:pt x="122" y="79"/>
                      </a:lnTo>
                      <a:lnTo>
                        <a:pt x="122" y="78"/>
                      </a:lnTo>
                      <a:lnTo>
                        <a:pt x="122" y="81"/>
                      </a:lnTo>
                      <a:lnTo>
                        <a:pt x="122" y="80"/>
                      </a:lnTo>
                      <a:lnTo>
                        <a:pt x="123" y="80"/>
                      </a:lnTo>
                      <a:lnTo>
                        <a:pt x="123" y="79"/>
                      </a:lnTo>
                      <a:lnTo>
                        <a:pt x="123" y="82"/>
                      </a:lnTo>
                      <a:lnTo>
                        <a:pt x="123" y="79"/>
                      </a:lnTo>
                      <a:lnTo>
                        <a:pt x="124" y="79"/>
                      </a:lnTo>
                      <a:lnTo>
                        <a:pt x="124" y="78"/>
                      </a:lnTo>
                      <a:lnTo>
                        <a:pt x="124" y="81"/>
                      </a:lnTo>
                      <a:lnTo>
                        <a:pt x="124" y="78"/>
                      </a:lnTo>
                      <a:lnTo>
                        <a:pt x="125" y="78"/>
                      </a:lnTo>
                      <a:lnTo>
                        <a:pt x="125" y="78"/>
                      </a:lnTo>
                      <a:lnTo>
                        <a:pt x="125" y="80"/>
                      </a:lnTo>
                      <a:lnTo>
                        <a:pt x="125" y="80"/>
                      </a:lnTo>
                      <a:lnTo>
                        <a:pt x="126" y="80"/>
                      </a:lnTo>
                      <a:lnTo>
                        <a:pt x="126" y="79"/>
                      </a:lnTo>
                      <a:lnTo>
                        <a:pt x="126" y="81"/>
                      </a:lnTo>
                      <a:lnTo>
                        <a:pt x="126" y="80"/>
                      </a:lnTo>
                      <a:lnTo>
                        <a:pt x="127" y="80"/>
                      </a:lnTo>
                      <a:lnTo>
                        <a:pt x="127" y="78"/>
                      </a:lnTo>
                      <a:lnTo>
                        <a:pt x="127" y="82"/>
                      </a:lnTo>
                      <a:lnTo>
                        <a:pt x="127" y="82"/>
                      </a:lnTo>
                      <a:lnTo>
                        <a:pt x="128" y="82"/>
                      </a:lnTo>
                      <a:lnTo>
                        <a:pt x="128" y="79"/>
                      </a:lnTo>
                      <a:lnTo>
                        <a:pt x="128" y="83"/>
                      </a:lnTo>
                      <a:lnTo>
                        <a:pt x="128" y="82"/>
                      </a:lnTo>
                      <a:lnTo>
                        <a:pt x="129" y="82"/>
                      </a:lnTo>
                      <a:lnTo>
                        <a:pt x="129" y="80"/>
                      </a:lnTo>
                      <a:lnTo>
                        <a:pt x="129" y="83"/>
                      </a:lnTo>
                      <a:lnTo>
                        <a:pt x="129" y="80"/>
                      </a:lnTo>
                      <a:lnTo>
                        <a:pt x="130" y="80"/>
                      </a:lnTo>
                      <a:lnTo>
                        <a:pt x="130" y="80"/>
                      </a:lnTo>
                      <a:lnTo>
                        <a:pt x="130" y="83"/>
                      </a:lnTo>
                      <a:lnTo>
                        <a:pt x="130" y="80"/>
                      </a:lnTo>
                      <a:lnTo>
                        <a:pt x="131" y="80"/>
                      </a:lnTo>
                      <a:lnTo>
                        <a:pt x="131" y="80"/>
                      </a:lnTo>
                      <a:lnTo>
                        <a:pt x="131" y="83"/>
                      </a:lnTo>
                      <a:lnTo>
                        <a:pt x="131" y="80"/>
                      </a:lnTo>
                      <a:lnTo>
                        <a:pt x="132" y="80"/>
                      </a:lnTo>
                      <a:lnTo>
                        <a:pt x="132" y="80"/>
                      </a:lnTo>
                      <a:lnTo>
                        <a:pt x="132" y="82"/>
                      </a:lnTo>
                      <a:lnTo>
                        <a:pt x="132" y="80"/>
                      </a:lnTo>
                      <a:lnTo>
                        <a:pt x="133" y="80"/>
                      </a:lnTo>
                      <a:lnTo>
                        <a:pt x="133" y="80"/>
                      </a:lnTo>
                      <a:lnTo>
                        <a:pt x="133" y="83"/>
                      </a:lnTo>
                      <a:lnTo>
                        <a:pt x="133" y="83"/>
                      </a:lnTo>
                      <a:lnTo>
                        <a:pt x="134" y="83"/>
                      </a:lnTo>
                      <a:lnTo>
                        <a:pt x="134" y="80"/>
                      </a:lnTo>
                      <a:lnTo>
                        <a:pt x="134" y="83"/>
                      </a:lnTo>
                      <a:lnTo>
                        <a:pt x="134" y="82"/>
                      </a:lnTo>
                      <a:lnTo>
                        <a:pt x="135" y="82"/>
                      </a:lnTo>
                      <a:lnTo>
                        <a:pt x="135" y="80"/>
                      </a:lnTo>
                      <a:lnTo>
                        <a:pt x="135" y="83"/>
                      </a:lnTo>
                      <a:lnTo>
                        <a:pt x="135" y="83"/>
                      </a:lnTo>
                      <a:lnTo>
                        <a:pt x="136" y="83"/>
                      </a:lnTo>
                      <a:lnTo>
                        <a:pt x="136" y="81"/>
                      </a:lnTo>
                      <a:lnTo>
                        <a:pt x="136" y="84"/>
                      </a:lnTo>
                      <a:lnTo>
                        <a:pt x="136" y="82"/>
                      </a:lnTo>
                      <a:lnTo>
                        <a:pt x="137" y="82"/>
                      </a:lnTo>
                      <a:lnTo>
                        <a:pt x="137" y="80"/>
                      </a:lnTo>
                      <a:lnTo>
                        <a:pt x="137" y="85"/>
                      </a:lnTo>
                      <a:lnTo>
                        <a:pt x="137" y="83"/>
                      </a:lnTo>
                      <a:lnTo>
                        <a:pt x="138" y="83"/>
                      </a:lnTo>
                      <a:lnTo>
                        <a:pt x="138" y="80"/>
                      </a:lnTo>
                      <a:lnTo>
                        <a:pt x="138" y="84"/>
                      </a:lnTo>
                      <a:lnTo>
                        <a:pt x="138" y="81"/>
                      </a:lnTo>
                      <a:lnTo>
                        <a:pt x="139" y="81"/>
                      </a:lnTo>
                      <a:lnTo>
                        <a:pt x="139" y="80"/>
                      </a:lnTo>
                      <a:lnTo>
                        <a:pt x="139" y="83"/>
                      </a:lnTo>
                      <a:lnTo>
                        <a:pt x="139" y="82"/>
                      </a:lnTo>
                      <a:lnTo>
                        <a:pt x="140" y="82"/>
                      </a:lnTo>
                      <a:lnTo>
                        <a:pt x="140" y="80"/>
                      </a:lnTo>
                      <a:lnTo>
                        <a:pt x="140" y="85"/>
                      </a:lnTo>
                      <a:lnTo>
                        <a:pt x="140" y="82"/>
                      </a:lnTo>
                      <a:lnTo>
                        <a:pt x="141" y="82"/>
                      </a:lnTo>
                      <a:lnTo>
                        <a:pt x="141" y="80"/>
                      </a:lnTo>
                      <a:lnTo>
                        <a:pt x="141" y="84"/>
                      </a:lnTo>
                      <a:lnTo>
                        <a:pt x="141" y="82"/>
                      </a:lnTo>
                      <a:lnTo>
                        <a:pt x="142" y="82"/>
                      </a:lnTo>
                      <a:lnTo>
                        <a:pt x="142" y="80"/>
                      </a:lnTo>
                      <a:lnTo>
                        <a:pt x="142" y="83"/>
                      </a:lnTo>
                      <a:lnTo>
                        <a:pt x="142" y="82"/>
                      </a:lnTo>
                      <a:lnTo>
                        <a:pt x="143" y="82"/>
                      </a:lnTo>
                      <a:lnTo>
                        <a:pt x="143" y="79"/>
                      </a:lnTo>
                      <a:lnTo>
                        <a:pt x="143" y="84"/>
                      </a:lnTo>
                      <a:lnTo>
                        <a:pt x="143" y="82"/>
                      </a:lnTo>
                      <a:lnTo>
                        <a:pt x="144" y="82"/>
                      </a:lnTo>
                      <a:lnTo>
                        <a:pt x="144" y="80"/>
                      </a:lnTo>
                      <a:lnTo>
                        <a:pt x="144" y="83"/>
                      </a:lnTo>
                      <a:lnTo>
                        <a:pt x="144" y="83"/>
                      </a:lnTo>
                      <a:lnTo>
                        <a:pt x="145" y="83"/>
                      </a:lnTo>
                      <a:lnTo>
                        <a:pt x="145" y="80"/>
                      </a:lnTo>
                      <a:lnTo>
                        <a:pt x="145" y="83"/>
                      </a:lnTo>
                      <a:lnTo>
                        <a:pt x="145" y="83"/>
                      </a:lnTo>
                      <a:lnTo>
                        <a:pt x="146" y="83"/>
                      </a:lnTo>
                      <a:lnTo>
                        <a:pt x="146" y="80"/>
                      </a:lnTo>
                      <a:lnTo>
                        <a:pt x="146" y="84"/>
                      </a:lnTo>
                      <a:lnTo>
                        <a:pt x="146" y="81"/>
                      </a:lnTo>
                      <a:lnTo>
                        <a:pt x="147" y="81"/>
                      </a:lnTo>
                      <a:lnTo>
                        <a:pt x="147" y="80"/>
                      </a:lnTo>
                      <a:lnTo>
                        <a:pt x="147" y="84"/>
                      </a:lnTo>
                      <a:lnTo>
                        <a:pt x="147" y="82"/>
                      </a:lnTo>
                      <a:lnTo>
                        <a:pt x="148" y="82"/>
                      </a:lnTo>
                      <a:lnTo>
                        <a:pt x="148" y="80"/>
                      </a:lnTo>
                      <a:lnTo>
                        <a:pt x="148" y="82"/>
                      </a:lnTo>
                      <a:lnTo>
                        <a:pt x="148" y="82"/>
                      </a:lnTo>
                      <a:lnTo>
                        <a:pt x="149" y="82"/>
                      </a:lnTo>
                      <a:lnTo>
                        <a:pt x="149" y="80"/>
                      </a:lnTo>
                      <a:lnTo>
                        <a:pt x="149" y="83"/>
                      </a:lnTo>
                      <a:lnTo>
                        <a:pt x="149" y="80"/>
                      </a:lnTo>
                      <a:lnTo>
                        <a:pt x="150" y="80"/>
                      </a:lnTo>
                      <a:lnTo>
                        <a:pt x="150" y="80"/>
                      </a:lnTo>
                      <a:lnTo>
                        <a:pt x="150" y="83"/>
                      </a:lnTo>
                      <a:lnTo>
                        <a:pt x="150" y="83"/>
                      </a:lnTo>
                      <a:lnTo>
                        <a:pt x="151" y="83"/>
                      </a:lnTo>
                      <a:lnTo>
                        <a:pt x="151" y="79"/>
                      </a:lnTo>
                      <a:lnTo>
                        <a:pt x="151" y="83"/>
                      </a:lnTo>
                      <a:lnTo>
                        <a:pt x="151" y="83"/>
                      </a:lnTo>
                      <a:lnTo>
                        <a:pt x="152" y="83"/>
                      </a:lnTo>
                      <a:lnTo>
                        <a:pt x="152" y="80"/>
                      </a:lnTo>
                      <a:lnTo>
                        <a:pt x="152" y="83"/>
                      </a:lnTo>
                      <a:lnTo>
                        <a:pt x="152" y="81"/>
                      </a:lnTo>
                      <a:lnTo>
                        <a:pt x="153" y="81"/>
                      </a:lnTo>
                      <a:lnTo>
                        <a:pt x="153" y="79"/>
                      </a:lnTo>
                      <a:lnTo>
                        <a:pt x="153" y="82"/>
                      </a:lnTo>
                      <a:lnTo>
                        <a:pt x="153" y="80"/>
                      </a:lnTo>
                      <a:lnTo>
                        <a:pt x="154" y="80"/>
                      </a:lnTo>
                      <a:lnTo>
                        <a:pt x="154" y="80"/>
                      </a:lnTo>
                      <a:lnTo>
                        <a:pt x="154" y="83"/>
                      </a:lnTo>
                      <a:lnTo>
                        <a:pt x="154" y="81"/>
                      </a:lnTo>
                      <a:lnTo>
                        <a:pt x="155" y="81"/>
                      </a:lnTo>
                      <a:lnTo>
                        <a:pt x="155" y="80"/>
                      </a:lnTo>
                      <a:lnTo>
                        <a:pt x="155" y="83"/>
                      </a:lnTo>
                      <a:lnTo>
                        <a:pt x="155" y="82"/>
                      </a:lnTo>
                      <a:lnTo>
                        <a:pt x="156" y="82"/>
                      </a:lnTo>
                      <a:lnTo>
                        <a:pt x="156" y="79"/>
                      </a:lnTo>
                      <a:lnTo>
                        <a:pt x="156" y="83"/>
                      </a:lnTo>
                      <a:lnTo>
                        <a:pt x="156" y="79"/>
                      </a:lnTo>
                      <a:lnTo>
                        <a:pt x="157" y="79"/>
                      </a:lnTo>
                      <a:lnTo>
                        <a:pt x="157" y="79"/>
                      </a:lnTo>
                      <a:lnTo>
                        <a:pt x="157" y="83"/>
                      </a:lnTo>
                      <a:lnTo>
                        <a:pt x="157" y="82"/>
                      </a:lnTo>
                      <a:lnTo>
                        <a:pt x="158" y="82"/>
                      </a:lnTo>
                      <a:lnTo>
                        <a:pt x="158" y="80"/>
                      </a:lnTo>
                      <a:lnTo>
                        <a:pt x="158" y="83"/>
                      </a:lnTo>
                      <a:lnTo>
                        <a:pt x="158" y="82"/>
                      </a:lnTo>
                      <a:lnTo>
                        <a:pt x="159" y="82"/>
                      </a:lnTo>
                      <a:lnTo>
                        <a:pt x="159" y="80"/>
                      </a:lnTo>
                      <a:lnTo>
                        <a:pt x="159" y="84"/>
                      </a:lnTo>
                      <a:lnTo>
                        <a:pt x="159" y="83"/>
                      </a:lnTo>
                      <a:lnTo>
                        <a:pt x="160" y="83"/>
                      </a:lnTo>
                      <a:lnTo>
                        <a:pt x="160" y="80"/>
                      </a:lnTo>
                      <a:lnTo>
                        <a:pt x="160" y="83"/>
                      </a:lnTo>
                      <a:lnTo>
                        <a:pt x="160" y="81"/>
                      </a:lnTo>
                      <a:lnTo>
                        <a:pt x="161" y="81"/>
                      </a:lnTo>
                      <a:lnTo>
                        <a:pt x="161" y="80"/>
                      </a:lnTo>
                      <a:lnTo>
                        <a:pt x="161" y="83"/>
                      </a:lnTo>
                      <a:lnTo>
                        <a:pt x="161" y="82"/>
                      </a:lnTo>
                      <a:lnTo>
                        <a:pt x="162" y="82"/>
                      </a:lnTo>
                      <a:lnTo>
                        <a:pt x="162" y="80"/>
                      </a:lnTo>
                      <a:lnTo>
                        <a:pt x="162" y="83"/>
                      </a:lnTo>
                      <a:lnTo>
                        <a:pt x="162" y="83"/>
                      </a:lnTo>
                      <a:lnTo>
                        <a:pt x="163" y="83"/>
                      </a:lnTo>
                      <a:lnTo>
                        <a:pt x="163" y="82"/>
                      </a:lnTo>
                      <a:lnTo>
                        <a:pt x="163" y="85"/>
                      </a:lnTo>
                      <a:lnTo>
                        <a:pt x="163" y="82"/>
                      </a:lnTo>
                      <a:lnTo>
                        <a:pt x="164" y="82"/>
                      </a:lnTo>
                      <a:lnTo>
                        <a:pt x="164" y="80"/>
                      </a:lnTo>
                      <a:lnTo>
                        <a:pt x="164" y="85"/>
                      </a:lnTo>
                      <a:lnTo>
                        <a:pt x="164" y="82"/>
                      </a:lnTo>
                      <a:lnTo>
                        <a:pt x="165" y="82"/>
                      </a:lnTo>
                      <a:lnTo>
                        <a:pt x="165" y="81"/>
                      </a:lnTo>
                      <a:lnTo>
                        <a:pt x="165" y="85"/>
                      </a:lnTo>
                      <a:lnTo>
                        <a:pt x="165" y="82"/>
                      </a:lnTo>
                      <a:lnTo>
                        <a:pt x="166" y="82"/>
                      </a:lnTo>
                      <a:lnTo>
                        <a:pt x="166" y="82"/>
                      </a:lnTo>
                      <a:lnTo>
                        <a:pt x="166" y="85"/>
                      </a:lnTo>
                      <a:lnTo>
                        <a:pt x="166" y="83"/>
                      </a:lnTo>
                      <a:lnTo>
                        <a:pt x="167" y="83"/>
                      </a:lnTo>
                      <a:lnTo>
                        <a:pt x="167" y="82"/>
                      </a:lnTo>
                      <a:lnTo>
                        <a:pt x="167" y="85"/>
                      </a:lnTo>
                      <a:lnTo>
                        <a:pt x="167" y="84"/>
                      </a:lnTo>
                      <a:lnTo>
                        <a:pt x="168" y="84"/>
                      </a:lnTo>
                      <a:lnTo>
                        <a:pt x="168" y="82"/>
                      </a:lnTo>
                      <a:lnTo>
                        <a:pt x="168" y="85"/>
                      </a:lnTo>
                      <a:lnTo>
                        <a:pt x="168" y="85"/>
                      </a:lnTo>
                      <a:lnTo>
                        <a:pt x="169" y="85"/>
                      </a:lnTo>
                      <a:lnTo>
                        <a:pt x="169" y="82"/>
                      </a:lnTo>
                      <a:lnTo>
                        <a:pt x="169" y="85"/>
                      </a:lnTo>
                      <a:lnTo>
                        <a:pt x="169" y="85"/>
                      </a:lnTo>
                      <a:lnTo>
                        <a:pt x="170" y="85"/>
                      </a:lnTo>
                      <a:lnTo>
                        <a:pt x="170" y="80"/>
                      </a:lnTo>
                      <a:lnTo>
                        <a:pt x="170" y="84"/>
                      </a:lnTo>
                      <a:lnTo>
                        <a:pt x="170" y="80"/>
                      </a:lnTo>
                      <a:lnTo>
                        <a:pt x="171" y="80"/>
                      </a:lnTo>
                      <a:lnTo>
                        <a:pt x="171" y="81"/>
                      </a:lnTo>
                      <a:lnTo>
                        <a:pt x="171" y="83"/>
                      </a:lnTo>
                      <a:lnTo>
                        <a:pt x="171" y="83"/>
                      </a:lnTo>
                      <a:lnTo>
                        <a:pt x="172" y="83"/>
                      </a:lnTo>
                      <a:lnTo>
                        <a:pt x="172" y="81"/>
                      </a:lnTo>
                      <a:lnTo>
                        <a:pt x="172" y="84"/>
                      </a:lnTo>
                      <a:lnTo>
                        <a:pt x="172" y="83"/>
                      </a:lnTo>
                      <a:lnTo>
                        <a:pt x="173" y="83"/>
                      </a:lnTo>
                      <a:lnTo>
                        <a:pt x="173" y="82"/>
                      </a:lnTo>
                      <a:lnTo>
                        <a:pt x="173" y="86"/>
                      </a:lnTo>
                      <a:lnTo>
                        <a:pt x="173" y="83"/>
                      </a:lnTo>
                      <a:lnTo>
                        <a:pt x="174" y="83"/>
                      </a:lnTo>
                      <a:lnTo>
                        <a:pt x="174" y="82"/>
                      </a:lnTo>
                      <a:lnTo>
                        <a:pt x="174" y="84"/>
                      </a:lnTo>
                      <a:lnTo>
                        <a:pt x="174" y="83"/>
                      </a:lnTo>
                      <a:lnTo>
                        <a:pt x="175" y="83"/>
                      </a:lnTo>
                      <a:lnTo>
                        <a:pt x="175" y="82"/>
                      </a:lnTo>
                      <a:lnTo>
                        <a:pt x="175" y="85"/>
                      </a:lnTo>
                      <a:lnTo>
                        <a:pt x="175" y="85"/>
                      </a:lnTo>
                      <a:lnTo>
                        <a:pt x="176" y="85"/>
                      </a:lnTo>
                      <a:lnTo>
                        <a:pt x="176" y="82"/>
                      </a:lnTo>
                      <a:lnTo>
                        <a:pt x="176" y="85"/>
                      </a:lnTo>
                      <a:lnTo>
                        <a:pt x="176" y="82"/>
                      </a:lnTo>
                      <a:lnTo>
                        <a:pt x="177" y="82"/>
                      </a:lnTo>
                      <a:lnTo>
                        <a:pt x="177" y="81"/>
                      </a:lnTo>
                      <a:lnTo>
                        <a:pt x="177" y="84"/>
                      </a:lnTo>
                      <a:lnTo>
                        <a:pt x="177" y="83"/>
                      </a:lnTo>
                      <a:lnTo>
                        <a:pt x="178" y="83"/>
                      </a:lnTo>
                      <a:lnTo>
                        <a:pt x="178" y="80"/>
                      </a:lnTo>
                      <a:lnTo>
                        <a:pt x="178" y="83"/>
                      </a:lnTo>
                      <a:lnTo>
                        <a:pt x="178" y="82"/>
                      </a:lnTo>
                      <a:lnTo>
                        <a:pt x="179" y="82"/>
                      </a:lnTo>
                      <a:lnTo>
                        <a:pt x="179" y="80"/>
                      </a:lnTo>
                      <a:lnTo>
                        <a:pt x="179" y="84"/>
                      </a:lnTo>
                      <a:lnTo>
                        <a:pt x="179" y="83"/>
                      </a:lnTo>
                      <a:lnTo>
                        <a:pt x="180" y="83"/>
                      </a:lnTo>
                      <a:lnTo>
                        <a:pt x="180" y="82"/>
                      </a:lnTo>
                      <a:lnTo>
                        <a:pt x="180" y="85"/>
                      </a:lnTo>
                      <a:lnTo>
                        <a:pt x="180" y="82"/>
                      </a:lnTo>
                      <a:lnTo>
                        <a:pt x="181" y="82"/>
                      </a:lnTo>
                      <a:lnTo>
                        <a:pt x="181" y="82"/>
                      </a:lnTo>
                      <a:lnTo>
                        <a:pt x="181" y="86"/>
                      </a:lnTo>
                      <a:lnTo>
                        <a:pt x="181" y="84"/>
                      </a:lnTo>
                      <a:lnTo>
                        <a:pt x="182" y="84"/>
                      </a:lnTo>
                      <a:lnTo>
                        <a:pt x="182" y="83"/>
                      </a:lnTo>
                      <a:lnTo>
                        <a:pt x="182" y="86"/>
                      </a:lnTo>
                      <a:lnTo>
                        <a:pt x="182" y="83"/>
                      </a:lnTo>
                      <a:lnTo>
                        <a:pt x="183" y="83"/>
                      </a:lnTo>
                      <a:lnTo>
                        <a:pt x="183" y="82"/>
                      </a:lnTo>
                      <a:lnTo>
                        <a:pt x="183" y="85"/>
                      </a:lnTo>
                      <a:lnTo>
                        <a:pt x="183" y="84"/>
                      </a:lnTo>
                      <a:lnTo>
                        <a:pt x="184" y="84"/>
                      </a:lnTo>
                      <a:lnTo>
                        <a:pt x="184" y="83"/>
                      </a:lnTo>
                      <a:lnTo>
                        <a:pt x="184" y="86"/>
                      </a:lnTo>
                      <a:lnTo>
                        <a:pt x="184" y="85"/>
                      </a:lnTo>
                      <a:lnTo>
                        <a:pt x="185" y="85"/>
                      </a:lnTo>
                      <a:lnTo>
                        <a:pt x="185" y="82"/>
                      </a:lnTo>
                      <a:lnTo>
                        <a:pt x="185" y="85"/>
                      </a:lnTo>
                      <a:lnTo>
                        <a:pt x="185" y="85"/>
                      </a:lnTo>
                      <a:lnTo>
                        <a:pt x="186" y="85"/>
                      </a:lnTo>
                      <a:lnTo>
                        <a:pt x="186" y="82"/>
                      </a:lnTo>
                      <a:lnTo>
                        <a:pt x="186" y="86"/>
                      </a:lnTo>
                      <a:lnTo>
                        <a:pt x="186" y="85"/>
                      </a:lnTo>
                      <a:lnTo>
                        <a:pt x="187" y="85"/>
                      </a:lnTo>
                      <a:lnTo>
                        <a:pt x="187" y="83"/>
                      </a:lnTo>
                      <a:lnTo>
                        <a:pt x="187" y="86"/>
                      </a:lnTo>
                      <a:lnTo>
                        <a:pt x="187" y="84"/>
                      </a:lnTo>
                      <a:lnTo>
                        <a:pt x="188" y="84"/>
                      </a:lnTo>
                      <a:lnTo>
                        <a:pt x="188" y="82"/>
                      </a:lnTo>
                      <a:lnTo>
                        <a:pt x="188" y="85"/>
                      </a:lnTo>
                      <a:lnTo>
                        <a:pt x="188" y="82"/>
                      </a:lnTo>
                      <a:lnTo>
                        <a:pt x="189" y="82"/>
                      </a:lnTo>
                      <a:lnTo>
                        <a:pt x="189" y="80"/>
                      </a:lnTo>
                      <a:lnTo>
                        <a:pt x="189" y="85"/>
                      </a:lnTo>
                      <a:lnTo>
                        <a:pt x="189" y="82"/>
                      </a:lnTo>
                      <a:lnTo>
                        <a:pt x="190" y="82"/>
                      </a:lnTo>
                      <a:lnTo>
                        <a:pt x="190" y="82"/>
                      </a:lnTo>
                      <a:lnTo>
                        <a:pt x="190" y="85"/>
                      </a:lnTo>
                      <a:lnTo>
                        <a:pt x="190" y="83"/>
                      </a:lnTo>
                      <a:lnTo>
                        <a:pt x="191" y="83"/>
                      </a:lnTo>
                      <a:lnTo>
                        <a:pt x="191" y="82"/>
                      </a:lnTo>
                      <a:lnTo>
                        <a:pt x="191" y="85"/>
                      </a:lnTo>
                      <a:lnTo>
                        <a:pt x="191" y="83"/>
                      </a:lnTo>
                      <a:lnTo>
                        <a:pt x="192" y="83"/>
                      </a:lnTo>
                      <a:lnTo>
                        <a:pt x="192" y="80"/>
                      </a:lnTo>
                      <a:lnTo>
                        <a:pt x="192" y="83"/>
                      </a:lnTo>
                      <a:lnTo>
                        <a:pt x="192" y="81"/>
                      </a:lnTo>
                      <a:lnTo>
                        <a:pt x="193" y="81"/>
                      </a:lnTo>
                      <a:lnTo>
                        <a:pt x="193" y="82"/>
                      </a:lnTo>
                      <a:lnTo>
                        <a:pt x="193" y="84"/>
                      </a:lnTo>
                      <a:lnTo>
                        <a:pt x="193" y="83"/>
                      </a:lnTo>
                      <a:lnTo>
                        <a:pt x="194" y="83"/>
                      </a:lnTo>
                      <a:lnTo>
                        <a:pt x="194" y="83"/>
                      </a:lnTo>
                      <a:lnTo>
                        <a:pt x="194" y="85"/>
                      </a:lnTo>
                      <a:lnTo>
                        <a:pt x="194" y="84"/>
                      </a:lnTo>
                      <a:lnTo>
                        <a:pt x="195" y="84"/>
                      </a:lnTo>
                      <a:lnTo>
                        <a:pt x="195" y="82"/>
                      </a:lnTo>
                      <a:lnTo>
                        <a:pt x="195" y="85"/>
                      </a:lnTo>
                      <a:lnTo>
                        <a:pt x="195" y="83"/>
                      </a:lnTo>
                      <a:lnTo>
                        <a:pt x="196" y="83"/>
                      </a:lnTo>
                      <a:lnTo>
                        <a:pt x="196" y="80"/>
                      </a:lnTo>
                      <a:lnTo>
                        <a:pt x="196" y="84"/>
                      </a:lnTo>
                      <a:lnTo>
                        <a:pt x="196" y="80"/>
                      </a:lnTo>
                      <a:lnTo>
                        <a:pt x="197" y="80"/>
                      </a:lnTo>
                      <a:lnTo>
                        <a:pt x="197" y="80"/>
                      </a:lnTo>
                      <a:lnTo>
                        <a:pt x="197" y="83"/>
                      </a:lnTo>
                      <a:lnTo>
                        <a:pt x="197" y="83"/>
                      </a:lnTo>
                      <a:lnTo>
                        <a:pt x="198" y="83"/>
                      </a:lnTo>
                      <a:lnTo>
                        <a:pt x="198" y="80"/>
                      </a:lnTo>
                      <a:lnTo>
                        <a:pt x="198" y="84"/>
                      </a:lnTo>
                      <a:lnTo>
                        <a:pt x="198" y="83"/>
                      </a:lnTo>
                      <a:lnTo>
                        <a:pt x="199" y="83"/>
                      </a:lnTo>
                      <a:lnTo>
                        <a:pt x="199" y="80"/>
                      </a:lnTo>
                      <a:lnTo>
                        <a:pt x="199" y="84"/>
                      </a:lnTo>
                      <a:lnTo>
                        <a:pt x="199" y="82"/>
                      </a:lnTo>
                      <a:lnTo>
                        <a:pt x="200" y="82"/>
                      </a:lnTo>
                      <a:lnTo>
                        <a:pt x="200" y="79"/>
                      </a:lnTo>
                      <a:lnTo>
                        <a:pt x="200" y="83"/>
                      </a:lnTo>
                      <a:lnTo>
                        <a:pt x="200" y="82"/>
                      </a:lnTo>
                      <a:lnTo>
                        <a:pt x="201" y="82"/>
                      </a:lnTo>
                      <a:lnTo>
                        <a:pt x="201" y="80"/>
                      </a:lnTo>
                      <a:lnTo>
                        <a:pt x="201" y="83"/>
                      </a:lnTo>
                      <a:lnTo>
                        <a:pt x="201" y="83"/>
                      </a:lnTo>
                      <a:lnTo>
                        <a:pt x="202" y="83"/>
                      </a:lnTo>
                      <a:lnTo>
                        <a:pt x="202" y="80"/>
                      </a:lnTo>
                      <a:lnTo>
                        <a:pt x="202" y="83"/>
                      </a:lnTo>
                      <a:lnTo>
                        <a:pt x="202" y="82"/>
                      </a:lnTo>
                      <a:lnTo>
                        <a:pt x="203" y="82"/>
                      </a:lnTo>
                      <a:lnTo>
                        <a:pt x="203" y="80"/>
                      </a:lnTo>
                      <a:lnTo>
                        <a:pt x="203" y="83"/>
                      </a:lnTo>
                      <a:lnTo>
                        <a:pt x="203" y="80"/>
                      </a:lnTo>
                      <a:lnTo>
                        <a:pt x="204" y="80"/>
                      </a:lnTo>
                      <a:lnTo>
                        <a:pt x="204" y="80"/>
                      </a:lnTo>
                      <a:lnTo>
                        <a:pt x="204" y="83"/>
                      </a:lnTo>
                      <a:lnTo>
                        <a:pt x="204" y="82"/>
                      </a:lnTo>
                      <a:lnTo>
                        <a:pt x="205" y="82"/>
                      </a:lnTo>
                      <a:lnTo>
                        <a:pt x="205" y="79"/>
                      </a:lnTo>
                      <a:lnTo>
                        <a:pt x="205" y="83"/>
                      </a:lnTo>
                      <a:lnTo>
                        <a:pt x="205" y="80"/>
                      </a:lnTo>
                      <a:lnTo>
                        <a:pt x="206" y="80"/>
                      </a:lnTo>
                      <a:lnTo>
                        <a:pt x="206" y="79"/>
                      </a:lnTo>
                      <a:lnTo>
                        <a:pt x="206" y="81"/>
                      </a:lnTo>
                      <a:lnTo>
                        <a:pt x="206" y="80"/>
                      </a:lnTo>
                      <a:lnTo>
                        <a:pt x="207" y="80"/>
                      </a:lnTo>
                      <a:lnTo>
                        <a:pt x="207" y="80"/>
                      </a:lnTo>
                      <a:lnTo>
                        <a:pt x="207" y="82"/>
                      </a:lnTo>
                      <a:lnTo>
                        <a:pt x="207" y="81"/>
                      </a:lnTo>
                      <a:lnTo>
                        <a:pt x="208" y="81"/>
                      </a:lnTo>
                      <a:lnTo>
                        <a:pt x="208" y="80"/>
                      </a:lnTo>
                      <a:lnTo>
                        <a:pt x="208" y="83"/>
                      </a:lnTo>
                      <a:lnTo>
                        <a:pt x="208" y="82"/>
                      </a:lnTo>
                      <a:lnTo>
                        <a:pt x="209" y="82"/>
                      </a:lnTo>
                      <a:lnTo>
                        <a:pt x="209" y="79"/>
                      </a:lnTo>
                      <a:lnTo>
                        <a:pt x="209" y="83"/>
                      </a:lnTo>
                      <a:lnTo>
                        <a:pt x="209" y="80"/>
                      </a:lnTo>
                      <a:lnTo>
                        <a:pt x="210" y="80"/>
                      </a:lnTo>
                      <a:lnTo>
                        <a:pt x="210" y="79"/>
                      </a:lnTo>
                      <a:lnTo>
                        <a:pt x="210" y="82"/>
                      </a:lnTo>
                      <a:lnTo>
                        <a:pt x="210" y="80"/>
                      </a:lnTo>
                      <a:lnTo>
                        <a:pt x="211" y="80"/>
                      </a:lnTo>
                      <a:lnTo>
                        <a:pt x="211" y="79"/>
                      </a:lnTo>
                      <a:lnTo>
                        <a:pt x="211" y="82"/>
                      </a:lnTo>
                      <a:lnTo>
                        <a:pt x="211" y="81"/>
                      </a:lnTo>
                      <a:lnTo>
                        <a:pt x="212" y="81"/>
                      </a:lnTo>
                      <a:lnTo>
                        <a:pt x="212" y="80"/>
                      </a:lnTo>
                      <a:lnTo>
                        <a:pt x="212" y="82"/>
                      </a:lnTo>
                      <a:lnTo>
                        <a:pt x="212" y="80"/>
                      </a:lnTo>
                      <a:lnTo>
                        <a:pt x="213" y="80"/>
                      </a:lnTo>
                      <a:lnTo>
                        <a:pt x="213" y="80"/>
                      </a:lnTo>
                      <a:lnTo>
                        <a:pt x="213" y="83"/>
                      </a:lnTo>
                      <a:lnTo>
                        <a:pt x="213" y="80"/>
                      </a:lnTo>
                      <a:lnTo>
                        <a:pt x="214" y="80"/>
                      </a:lnTo>
                      <a:lnTo>
                        <a:pt x="214" y="78"/>
                      </a:lnTo>
                      <a:lnTo>
                        <a:pt x="214" y="82"/>
                      </a:lnTo>
                      <a:lnTo>
                        <a:pt x="214" y="78"/>
                      </a:lnTo>
                      <a:lnTo>
                        <a:pt x="215" y="78"/>
                      </a:lnTo>
                      <a:lnTo>
                        <a:pt x="215" y="79"/>
                      </a:lnTo>
                      <a:lnTo>
                        <a:pt x="215" y="81"/>
                      </a:lnTo>
                      <a:lnTo>
                        <a:pt x="215" y="80"/>
                      </a:lnTo>
                      <a:lnTo>
                        <a:pt x="216" y="80"/>
                      </a:lnTo>
                      <a:lnTo>
                        <a:pt x="216" y="79"/>
                      </a:lnTo>
                      <a:lnTo>
                        <a:pt x="216" y="81"/>
                      </a:lnTo>
                      <a:lnTo>
                        <a:pt x="216" y="79"/>
                      </a:lnTo>
                      <a:lnTo>
                        <a:pt x="217" y="79"/>
                      </a:lnTo>
                      <a:lnTo>
                        <a:pt x="217" y="77"/>
                      </a:lnTo>
                      <a:lnTo>
                        <a:pt x="217" y="82"/>
                      </a:lnTo>
                      <a:lnTo>
                        <a:pt x="217" y="79"/>
                      </a:lnTo>
                      <a:lnTo>
                        <a:pt x="218" y="79"/>
                      </a:lnTo>
                      <a:lnTo>
                        <a:pt x="218" y="76"/>
                      </a:lnTo>
                      <a:lnTo>
                        <a:pt x="218" y="83"/>
                      </a:lnTo>
                      <a:lnTo>
                        <a:pt x="218" y="79"/>
                      </a:lnTo>
                      <a:lnTo>
                        <a:pt x="219" y="79"/>
                      </a:lnTo>
                      <a:lnTo>
                        <a:pt x="219" y="77"/>
                      </a:lnTo>
                      <a:lnTo>
                        <a:pt x="219" y="82"/>
                      </a:lnTo>
                      <a:lnTo>
                        <a:pt x="219" y="80"/>
                      </a:lnTo>
                      <a:lnTo>
                        <a:pt x="220" y="80"/>
                      </a:lnTo>
                      <a:lnTo>
                        <a:pt x="220" y="79"/>
                      </a:lnTo>
                      <a:lnTo>
                        <a:pt x="220" y="81"/>
                      </a:lnTo>
                      <a:lnTo>
                        <a:pt x="220" y="79"/>
                      </a:lnTo>
                      <a:lnTo>
                        <a:pt x="221" y="79"/>
                      </a:lnTo>
                      <a:lnTo>
                        <a:pt x="221" y="79"/>
                      </a:lnTo>
                      <a:lnTo>
                        <a:pt x="221" y="83"/>
                      </a:lnTo>
                      <a:lnTo>
                        <a:pt x="221" y="80"/>
                      </a:lnTo>
                      <a:lnTo>
                        <a:pt x="222" y="80"/>
                      </a:lnTo>
                      <a:lnTo>
                        <a:pt x="222" y="79"/>
                      </a:lnTo>
                      <a:lnTo>
                        <a:pt x="222" y="82"/>
                      </a:lnTo>
                      <a:lnTo>
                        <a:pt x="222" y="80"/>
                      </a:lnTo>
                      <a:lnTo>
                        <a:pt x="223" y="80"/>
                      </a:lnTo>
                      <a:lnTo>
                        <a:pt x="223" y="79"/>
                      </a:lnTo>
                      <a:lnTo>
                        <a:pt x="223" y="82"/>
                      </a:lnTo>
                      <a:lnTo>
                        <a:pt x="223" y="80"/>
                      </a:lnTo>
                      <a:lnTo>
                        <a:pt x="224" y="80"/>
                      </a:lnTo>
                      <a:lnTo>
                        <a:pt x="224" y="78"/>
                      </a:lnTo>
                      <a:lnTo>
                        <a:pt x="224" y="81"/>
                      </a:lnTo>
                      <a:lnTo>
                        <a:pt x="224" y="80"/>
                      </a:lnTo>
                      <a:lnTo>
                        <a:pt x="225" y="80"/>
                      </a:lnTo>
                      <a:lnTo>
                        <a:pt x="225" y="79"/>
                      </a:lnTo>
                      <a:lnTo>
                        <a:pt x="225" y="80"/>
                      </a:lnTo>
                      <a:lnTo>
                        <a:pt x="225" y="80"/>
                      </a:lnTo>
                      <a:lnTo>
                        <a:pt x="226" y="80"/>
                      </a:lnTo>
                      <a:lnTo>
                        <a:pt x="226" y="80"/>
                      </a:lnTo>
                      <a:lnTo>
                        <a:pt x="226" y="82"/>
                      </a:lnTo>
                      <a:lnTo>
                        <a:pt x="226" y="82"/>
                      </a:lnTo>
                      <a:lnTo>
                        <a:pt x="227" y="82"/>
                      </a:lnTo>
                      <a:lnTo>
                        <a:pt x="227" y="80"/>
                      </a:lnTo>
                      <a:lnTo>
                        <a:pt x="227" y="82"/>
                      </a:lnTo>
                      <a:lnTo>
                        <a:pt x="227" y="80"/>
                      </a:lnTo>
                      <a:lnTo>
                        <a:pt x="228" y="80"/>
                      </a:lnTo>
                      <a:lnTo>
                        <a:pt x="228" y="78"/>
                      </a:lnTo>
                      <a:lnTo>
                        <a:pt x="228" y="81"/>
                      </a:lnTo>
                      <a:lnTo>
                        <a:pt x="228" y="80"/>
                      </a:lnTo>
                      <a:lnTo>
                        <a:pt x="229" y="80"/>
                      </a:lnTo>
                      <a:lnTo>
                        <a:pt x="229" y="79"/>
                      </a:lnTo>
                      <a:lnTo>
                        <a:pt x="229" y="82"/>
                      </a:lnTo>
                      <a:lnTo>
                        <a:pt x="229" y="80"/>
                      </a:lnTo>
                      <a:lnTo>
                        <a:pt x="230" y="80"/>
                      </a:lnTo>
                      <a:lnTo>
                        <a:pt x="230" y="80"/>
                      </a:lnTo>
                      <a:lnTo>
                        <a:pt x="230" y="82"/>
                      </a:lnTo>
                      <a:lnTo>
                        <a:pt x="230" y="82"/>
                      </a:lnTo>
                      <a:lnTo>
                        <a:pt x="231" y="82"/>
                      </a:lnTo>
                      <a:lnTo>
                        <a:pt x="231" y="80"/>
                      </a:lnTo>
                      <a:lnTo>
                        <a:pt x="231" y="83"/>
                      </a:lnTo>
                      <a:lnTo>
                        <a:pt x="231" y="81"/>
                      </a:lnTo>
                      <a:lnTo>
                        <a:pt x="232" y="81"/>
                      </a:lnTo>
                      <a:lnTo>
                        <a:pt x="232" y="79"/>
                      </a:lnTo>
                      <a:lnTo>
                        <a:pt x="232" y="82"/>
                      </a:lnTo>
                      <a:lnTo>
                        <a:pt x="232" y="80"/>
                      </a:lnTo>
                      <a:lnTo>
                        <a:pt x="233" y="80"/>
                      </a:lnTo>
                      <a:lnTo>
                        <a:pt x="233" y="77"/>
                      </a:lnTo>
                      <a:lnTo>
                        <a:pt x="233" y="82"/>
                      </a:lnTo>
                      <a:lnTo>
                        <a:pt x="233" y="77"/>
                      </a:lnTo>
                      <a:lnTo>
                        <a:pt x="234" y="77"/>
                      </a:lnTo>
                      <a:lnTo>
                        <a:pt x="234" y="78"/>
                      </a:lnTo>
                      <a:lnTo>
                        <a:pt x="234" y="84"/>
                      </a:lnTo>
                      <a:lnTo>
                        <a:pt x="234" y="82"/>
                      </a:lnTo>
                      <a:lnTo>
                        <a:pt x="235" y="82"/>
                      </a:lnTo>
                      <a:lnTo>
                        <a:pt x="235" y="80"/>
                      </a:lnTo>
                      <a:lnTo>
                        <a:pt x="235" y="83"/>
                      </a:lnTo>
                      <a:lnTo>
                        <a:pt x="235" y="82"/>
                      </a:lnTo>
                      <a:lnTo>
                        <a:pt x="236" y="82"/>
                      </a:lnTo>
                      <a:lnTo>
                        <a:pt x="236" y="79"/>
                      </a:lnTo>
                      <a:lnTo>
                        <a:pt x="236" y="84"/>
                      </a:lnTo>
                      <a:lnTo>
                        <a:pt x="236" y="79"/>
                      </a:lnTo>
                      <a:lnTo>
                        <a:pt x="237" y="79"/>
                      </a:lnTo>
                      <a:lnTo>
                        <a:pt x="237" y="79"/>
                      </a:lnTo>
                      <a:lnTo>
                        <a:pt x="237" y="83"/>
                      </a:lnTo>
                      <a:lnTo>
                        <a:pt x="237" y="82"/>
                      </a:lnTo>
                      <a:lnTo>
                        <a:pt x="238" y="82"/>
                      </a:lnTo>
                      <a:lnTo>
                        <a:pt x="238" y="80"/>
                      </a:lnTo>
                      <a:lnTo>
                        <a:pt x="238" y="83"/>
                      </a:lnTo>
                      <a:lnTo>
                        <a:pt x="238" y="80"/>
                      </a:lnTo>
                      <a:lnTo>
                        <a:pt x="239" y="80"/>
                      </a:lnTo>
                      <a:lnTo>
                        <a:pt x="239" y="79"/>
                      </a:lnTo>
                      <a:lnTo>
                        <a:pt x="239" y="83"/>
                      </a:lnTo>
                      <a:lnTo>
                        <a:pt x="239" y="82"/>
                      </a:lnTo>
                      <a:lnTo>
                        <a:pt x="240" y="82"/>
                      </a:lnTo>
                      <a:lnTo>
                        <a:pt x="240" y="81"/>
                      </a:lnTo>
                      <a:lnTo>
                        <a:pt x="240" y="84"/>
                      </a:lnTo>
                      <a:lnTo>
                        <a:pt x="240" y="81"/>
                      </a:lnTo>
                      <a:lnTo>
                        <a:pt x="241" y="81"/>
                      </a:lnTo>
                      <a:lnTo>
                        <a:pt x="241" y="79"/>
                      </a:lnTo>
                      <a:lnTo>
                        <a:pt x="241" y="83"/>
                      </a:lnTo>
                      <a:lnTo>
                        <a:pt x="241" y="80"/>
                      </a:lnTo>
                      <a:lnTo>
                        <a:pt x="242" y="80"/>
                      </a:lnTo>
                      <a:lnTo>
                        <a:pt x="242" y="79"/>
                      </a:lnTo>
                      <a:lnTo>
                        <a:pt x="242" y="82"/>
                      </a:lnTo>
                      <a:lnTo>
                        <a:pt x="242" y="82"/>
                      </a:lnTo>
                      <a:lnTo>
                        <a:pt x="243" y="82"/>
                      </a:lnTo>
                      <a:lnTo>
                        <a:pt x="243" y="79"/>
                      </a:lnTo>
                      <a:lnTo>
                        <a:pt x="243" y="80"/>
                      </a:lnTo>
                      <a:lnTo>
                        <a:pt x="243" y="80"/>
                      </a:lnTo>
                      <a:lnTo>
                        <a:pt x="244" y="80"/>
                      </a:lnTo>
                      <a:lnTo>
                        <a:pt x="244" y="80"/>
                      </a:lnTo>
                      <a:lnTo>
                        <a:pt x="244" y="83"/>
                      </a:lnTo>
                      <a:lnTo>
                        <a:pt x="244" y="82"/>
                      </a:lnTo>
                      <a:lnTo>
                        <a:pt x="245" y="82"/>
                      </a:lnTo>
                      <a:lnTo>
                        <a:pt x="245" y="79"/>
                      </a:lnTo>
                      <a:lnTo>
                        <a:pt x="245" y="83"/>
                      </a:lnTo>
                      <a:lnTo>
                        <a:pt x="245" y="80"/>
                      </a:lnTo>
                      <a:lnTo>
                        <a:pt x="246" y="80"/>
                      </a:lnTo>
                      <a:lnTo>
                        <a:pt x="246" y="80"/>
                      </a:lnTo>
                      <a:lnTo>
                        <a:pt x="246" y="82"/>
                      </a:lnTo>
                      <a:lnTo>
                        <a:pt x="246" y="82"/>
                      </a:lnTo>
                      <a:lnTo>
                        <a:pt x="247" y="82"/>
                      </a:lnTo>
                      <a:lnTo>
                        <a:pt x="247" y="80"/>
                      </a:lnTo>
                      <a:lnTo>
                        <a:pt x="247" y="83"/>
                      </a:lnTo>
                      <a:lnTo>
                        <a:pt x="247" y="81"/>
                      </a:lnTo>
                      <a:lnTo>
                        <a:pt x="248" y="81"/>
                      </a:lnTo>
                      <a:lnTo>
                        <a:pt x="248" y="82"/>
                      </a:lnTo>
                      <a:lnTo>
                        <a:pt x="248" y="83"/>
                      </a:lnTo>
                      <a:lnTo>
                        <a:pt x="248" y="83"/>
                      </a:lnTo>
                      <a:lnTo>
                        <a:pt x="249" y="83"/>
                      </a:lnTo>
                      <a:lnTo>
                        <a:pt x="249" y="80"/>
                      </a:lnTo>
                      <a:lnTo>
                        <a:pt x="249" y="84"/>
                      </a:lnTo>
                      <a:lnTo>
                        <a:pt x="249" y="82"/>
                      </a:lnTo>
                      <a:lnTo>
                        <a:pt x="250" y="82"/>
                      </a:lnTo>
                      <a:lnTo>
                        <a:pt x="250" y="80"/>
                      </a:lnTo>
                      <a:lnTo>
                        <a:pt x="250" y="83"/>
                      </a:lnTo>
                      <a:lnTo>
                        <a:pt x="250" y="82"/>
                      </a:lnTo>
                      <a:lnTo>
                        <a:pt x="251" y="82"/>
                      </a:lnTo>
                      <a:lnTo>
                        <a:pt x="251" y="80"/>
                      </a:lnTo>
                      <a:lnTo>
                        <a:pt x="251" y="83"/>
                      </a:lnTo>
                      <a:lnTo>
                        <a:pt x="251" y="83"/>
                      </a:lnTo>
                      <a:lnTo>
                        <a:pt x="252" y="83"/>
                      </a:lnTo>
                      <a:lnTo>
                        <a:pt x="252" y="81"/>
                      </a:lnTo>
                      <a:lnTo>
                        <a:pt x="252" y="83"/>
                      </a:lnTo>
                      <a:lnTo>
                        <a:pt x="252" y="82"/>
                      </a:lnTo>
                      <a:lnTo>
                        <a:pt x="253" y="82"/>
                      </a:lnTo>
                      <a:lnTo>
                        <a:pt x="253" y="80"/>
                      </a:lnTo>
                      <a:lnTo>
                        <a:pt x="253" y="83"/>
                      </a:lnTo>
                      <a:lnTo>
                        <a:pt x="253" y="80"/>
                      </a:lnTo>
                      <a:lnTo>
                        <a:pt x="254" y="80"/>
                      </a:lnTo>
                      <a:lnTo>
                        <a:pt x="254" y="79"/>
                      </a:lnTo>
                      <a:lnTo>
                        <a:pt x="254" y="83"/>
                      </a:lnTo>
                      <a:lnTo>
                        <a:pt x="254" y="82"/>
                      </a:lnTo>
                      <a:lnTo>
                        <a:pt x="255" y="82"/>
                      </a:lnTo>
                      <a:lnTo>
                        <a:pt x="255" y="82"/>
                      </a:lnTo>
                      <a:lnTo>
                        <a:pt x="255" y="84"/>
                      </a:lnTo>
                      <a:lnTo>
                        <a:pt x="255" y="84"/>
                      </a:lnTo>
                      <a:lnTo>
                        <a:pt x="256" y="84"/>
                      </a:lnTo>
                      <a:lnTo>
                        <a:pt x="256" y="81"/>
                      </a:lnTo>
                      <a:lnTo>
                        <a:pt x="256" y="84"/>
                      </a:lnTo>
                      <a:lnTo>
                        <a:pt x="256" y="82"/>
                      </a:lnTo>
                      <a:lnTo>
                        <a:pt x="257" y="82"/>
                      </a:lnTo>
                      <a:lnTo>
                        <a:pt x="257" y="81"/>
                      </a:lnTo>
                      <a:lnTo>
                        <a:pt x="257" y="86"/>
                      </a:lnTo>
                      <a:lnTo>
                        <a:pt x="257" y="84"/>
                      </a:lnTo>
                      <a:lnTo>
                        <a:pt x="258" y="84"/>
                      </a:lnTo>
                      <a:lnTo>
                        <a:pt x="258" y="82"/>
                      </a:lnTo>
                      <a:lnTo>
                        <a:pt x="258" y="84"/>
                      </a:lnTo>
                      <a:lnTo>
                        <a:pt x="258" y="82"/>
                      </a:lnTo>
                      <a:lnTo>
                        <a:pt x="259" y="82"/>
                      </a:lnTo>
                      <a:lnTo>
                        <a:pt x="259" y="82"/>
                      </a:lnTo>
                      <a:lnTo>
                        <a:pt x="259" y="85"/>
                      </a:lnTo>
                      <a:lnTo>
                        <a:pt x="259" y="84"/>
                      </a:lnTo>
                      <a:lnTo>
                        <a:pt x="260" y="84"/>
                      </a:lnTo>
                      <a:lnTo>
                        <a:pt x="260" y="82"/>
                      </a:lnTo>
                      <a:lnTo>
                        <a:pt x="260" y="85"/>
                      </a:lnTo>
                      <a:lnTo>
                        <a:pt x="260" y="85"/>
                      </a:lnTo>
                      <a:lnTo>
                        <a:pt x="261" y="85"/>
                      </a:lnTo>
                      <a:lnTo>
                        <a:pt x="261" y="83"/>
                      </a:lnTo>
                      <a:lnTo>
                        <a:pt x="261" y="86"/>
                      </a:lnTo>
                      <a:lnTo>
                        <a:pt x="261" y="85"/>
                      </a:lnTo>
                      <a:lnTo>
                        <a:pt x="262" y="85"/>
                      </a:lnTo>
                      <a:lnTo>
                        <a:pt x="262" y="84"/>
                      </a:lnTo>
                      <a:lnTo>
                        <a:pt x="262" y="86"/>
                      </a:lnTo>
                      <a:lnTo>
                        <a:pt x="262" y="85"/>
                      </a:lnTo>
                      <a:lnTo>
                        <a:pt x="263" y="85"/>
                      </a:lnTo>
                      <a:lnTo>
                        <a:pt x="263" y="83"/>
                      </a:lnTo>
                      <a:lnTo>
                        <a:pt x="263" y="87"/>
                      </a:lnTo>
                      <a:lnTo>
                        <a:pt x="263" y="85"/>
                      </a:lnTo>
                      <a:lnTo>
                        <a:pt x="264" y="85"/>
                      </a:lnTo>
                      <a:lnTo>
                        <a:pt x="264" y="85"/>
                      </a:lnTo>
                      <a:lnTo>
                        <a:pt x="264" y="87"/>
                      </a:lnTo>
                      <a:lnTo>
                        <a:pt x="264" y="87"/>
                      </a:lnTo>
                      <a:lnTo>
                        <a:pt x="265" y="87"/>
                      </a:lnTo>
                      <a:lnTo>
                        <a:pt x="265" y="85"/>
                      </a:lnTo>
                      <a:lnTo>
                        <a:pt x="265" y="87"/>
                      </a:lnTo>
                      <a:lnTo>
                        <a:pt x="265" y="86"/>
                      </a:lnTo>
                      <a:lnTo>
                        <a:pt x="266" y="86"/>
                      </a:lnTo>
                      <a:lnTo>
                        <a:pt x="266" y="85"/>
                      </a:lnTo>
                      <a:lnTo>
                        <a:pt x="266" y="88"/>
                      </a:lnTo>
                      <a:lnTo>
                        <a:pt x="266" y="88"/>
                      </a:lnTo>
                      <a:lnTo>
                        <a:pt x="267" y="88"/>
                      </a:lnTo>
                      <a:lnTo>
                        <a:pt x="267" y="86"/>
                      </a:lnTo>
                      <a:lnTo>
                        <a:pt x="267" y="88"/>
                      </a:lnTo>
                      <a:lnTo>
                        <a:pt x="267" y="86"/>
                      </a:lnTo>
                      <a:lnTo>
                        <a:pt x="268" y="86"/>
                      </a:lnTo>
                      <a:lnTo>
                        <a:pt x="268" y="86"/>
                      </a:lnTo>
                      <a:lnTo>
                        <a:pt x="268" y="88"/>
                      </a:lnTo>
                      <a:lnTo>
                        <a:pt x="268" y="88"/>
                      </a:lnTo>
                      <a:lnTo>
                        <a:pt x="269" y="88"/>
                      </a:lnTo>
                      <a:lnTo>
                        <a:pt x="269" y="86"/>
                      </a:lnTo>
                      <a:lnTo>
                        <a:pt x="269" y="89"/>
                      </a:lnTo>
                      <a:lnTo>
                        <a:pt x="269" y="86"/>
                      </a:lnTo>
                      <a:lnTo>
                        <a:pt x="270" y="86"/>
                      </a:lnTo>
                      <a:lnTo>
                        <a:pt x="270" y="86"/>
                      </a:lnTo>
                      <a:lnTo>
                        <a:pt x="270" y="90"/>
                      </a:lnTo>
                      <a:lnTo>
                        <a:pt x="270" y="86"/>
                      </a:lnTo>
                      <a:lnTo>
                        <a:pt x="271" y="86"/>
                      </a:lnTo>
                      <a:lnTo>
                        <a:pt x="271" y="87"/>
                      </a:lnTo>
                      <a:lnTo>
                        <a:pt x="271" y="90"/>
                      </a:lnTo>
                      <a:lnTo>
                        <a:pt x="271" y="88"/>
                      </a:lnTo>
                      <a:lnTo>
                        <a:pt x="272" y="88"/>
                      </a:lnTo>
                      <a:lnTo>
                        <a:pt x="272" y="87"/>
                      </a:lnTo>
                      <a:lnTo>
                        <a:pt x="272" y="89"/>
                      </a:lnTo>
                      <a:lnTo>
                        <a:pt x="272" y="87"/>
                      </a:lnTo>
                      <a:lnTo>
                        <a:pt x="273" y="87"/>
                      </a:lnTo>
                      <a:lnTo>
                        <a:pt x="273" y="87"/>
                      </a:lnTo>
                      <a:lnTo>
                        <a:pt x="273" y="90"/>
                      </a:lnTo>
                      <a:lnTo>
                        <a:pt x="273" y="89"/>
                      </a:lnTo>
                      <a:lnTo>
                        <a:pt x="274" y="89"/>
                      </a:lnTo>
                      <a:lnTo>
                        <a:pt x="274" y="86"/>
                      </a:lnTo>
                      <a:lnTo>
                        <a:pt x="274" y="90"/>
                      </a:lnTo>
                      <a:lnTo>
                        <a:pt x="274" y="89"/>
                      </a:lnTo>
                      <a:lnTo>
                        <a:pt x="275" y="89"/>
                      </a:lnTo>
                      <a:lnTo>
                        <a:pt x="275" y="87"/>
                      </a:lnTo>
                      <a:lnTo>
                        <a:pt x="275" y="90"/>
                      </a:lnTo>
                      <a:lnTo>
                        <a:pt x="275" y="90"/>
                      </a:lnTo>
                      <a:lnTo>
                        <a:pt x="276" y="90"/>
                      </a:lnTo>
                      <a:lnTo>
                        <a:pt x="276" y="88"/>
                      </a:lnTo>
                      <a:lnTo>
                        <a:pt x="276" y="91"/>
                      </a:lnTo>
                      <a:lnTo>
                        <a:pt x="276" y="89"/>
                      </a:lnTo>
                      <a:lnTo>
                        <a:pt x="277" y="89"/>
                      </a:lnTo>
                      <a:lnTo>
                        <a:pt x="277" y="89"/>
                      </a:lnTo>
                      <a:lnTo>
                        <a:pt x="277" y="92"/>
                      </a:lnTo>
                      <a:lnTo>
                        <a:pt x="277" y="91"/>
                      </a:lnTo>
                      <a:lnTo>
                        <a:pt x="278" y="91"/>
                      </a:lnTo>
                      <a:lnTo>
                        <a:pt x="278" y="88"/>
                      </a:lnTo>
                      <a:lnTo>
                        <a:pt x="278" y="91"/>
                      </a:lnTo>
                      <a:lnTo>
                        <a:pt x="278" y="90"/>
                      </a:lnTo>
                      <a:lnTo>
                        <a:pt x="279" y="90"/>
                      </a:lnTo>
                      <a:lnTo>
                        <a:pt x="279" y="89"/>
                      </a:lnTo>
                      <a:lnTo>
                        <a:pt x="279" y="91"/>
                      </a:lnTo>
                      <a:lnTo>
                        <a:pt x="279" y="91"/>
                      </a:lnTo>
                      <a:lnTo>
                        <a:pt x="280" y="91"/>
                      </a:lnTo>
                      <a:lnTo>
                        <a:pt x="280" y="89"/>
                      </a:lnTo>
                      <a:lnTo>
                        <a:pt x="280" y="91"/>
                      </a:lnTo>
                      <a:lnTo>
                        <a:pt x="280" y="91"/>
                      </a:lnTo>
                      <a:lnTo>
                        <a:pt x="281" y="91"/>
                      </a:lnTo>
                      <a:lnTo>
                        <a:pt x="281" y="89"/>
                      </a:lnTo>
                      <a:lnTo>
                        <a:pt x="281" y="92"/>
                      </a:lnTo>
                      <a:lnTo>
                        <a:pt x="281" y="90"/>
                      </a:lnTo>
                      <a:lnTo>
                        <a:pt x="282" y="90"/>
                      </a:lnTo>
                      <a:lnTo>
                        <a:pt x="282" y="89"/>
                      </a:lnTo>
                      <a:lnTo>
                        <a:pt x="282" y="91"/>
                      </a:lnTo>
                      <a:lnTo>
                        <a:pt x="282" y="91"/>
                      </a:lnTo>
                      <a:lnTo>
                        <a:pt x="283" y="91"/>
                      </a:lnTo>
                      <a:lnTo>
                        <a:pt x="283" y="89"/>
                      </a:lnTo>
                      <a:lnTo>
                        <a:pt x="283" y="92"/>
                      </a:lnTo>
                      <a:lnTo>
                        <a:pt x="283" y="91"/>
                      </a:lnTo>
                      <a:lnTo>
                        <a:pt x="284" y="91"/>
                      </a:lnTo>
                      <a:lnTo>
                        <a:pt x="284" y="89"/>
                      </a:lnTo>
                      <a:lnTo>
                        <a:pt x="284" y="91"/>
                      </a:lnTo>
                      <a:lnTo>
                        <a:pt x="284" y="91"/>
                      </a:lnTo>
                      <a:lnTo>
                        <a:pt x="285" y="91"/>
                      </a:lnTo>
                      <a:lnTo>
                        <a:pt x="285" y="90"/>
                      </a:lnTo>
                      <a:lnTo>
                        <a:pt x="285" y="92"/>
                      </a:lnTo>
                      <a:lnTo>
                        <a:pt x="285" y="90"/>
                      </a:lnTo>
                      <a:lnTo>
                        <a:pt x="286" y="90"/>
                      </a:lnTo>
                      <a:lnTo>
                        <a:pt x="286" y="89"/>
                      </a:lnTo>
                      <a:lnTo>
                        <a:pt x="286" y="92"/>
                      </a:lnTo>
                      <a:lnTo>
                        <a:pt x="286" y="91"/>
                      </a:lnTo>
                      <a:lnTo>
                        <a:pt x="287" y="91"/>
                      </a:lnTo>
                      <a:lnTo>
                        <a:pt x="287" y="90"/>
                      </a:lnTo>
                      <a:lnTo>
                        <a:pt x="287" y="92"/>
                      </a:lnTo>
                      <a:lnTo>
                        <a:pt x="287" y="90"/>
                      </a:lnTo>
                      <a:lnTo>
                        <a:pt x="288" y="90"/>
                      </a:lnTo>
                      <a:lnTo>
                        <a:pt x="288" y="90"/>
                      </a:lnTo>
                      <a:lnTo>
                        <a:pt x="288" y="93"/>
                      </a:lnTo>
                      <a:lnTo>
                        <a:pt x="288" y="92"/>
                      </a:lnTo>
                      <a:lnTo>
                        <a:pt x="289" y="92"/>
                      </a:lnTo>
                      <a:lnTo>
                        <a:pt x="289" y="91"/>
                      </a:lnTo>
                      <a:lnTo>
                        <a:pt x="289" y="94"/>
                      </a:lnTo>
                      <a:lnTo>
                        <a:pt x="289" y="91"/>
                      </a:lnTo>
                      <a:lnTo>
                        <a:pt x="290" y="91"/>
                      </a:lnTo>
                      <a:lnTo>
                        <a:pt x="290" y="91"/>
                      </a:lnTo>
                      <a:lnTo>
                        <a:pt x="290" y="94"/>
                      </a:lnTo>
                      <a:lnTo>
                        <a:pt x="290" y="94"/>
                      </a:lnTo>
                      <a:lnTo>
                        <a:pt x="291" y="94"/>
                      </a:lnTo>
                      <a:lnTo>
                        <a:pt x="291" y="91"/>
                      </a:lnTo>
                      <a:lnTo>
                        <a:pt x="291" y="94"/>
                      </a:lnTo>
                      <a:lnTo>
                        <a:pt x="291" y="93"/>
                      </a:lnTo>
                      <a:lnTo>
                        <a:pt x="292" y="93"/>
                      </a:lnTo>
                      <a:lnTo>
                        <a:pt x="292" y="91"/>
                      </a:lnTo>
                      <a:lnTo>
                        <a:pt x="292" y="92"/>
                      </a:lnTo>
                      <a:lnTo>
                        <a:pt x="292" y="92"/>
                      </a:lnTo>
                      <a:lnTo>
                        <a:pt x="293" y="92"/>
                      </a:lnTo>
                      <a:lnTo>
                        <a:pt x="293" y="91"/>
                      </a:lnTo>
                      <a:lnTo>
                        <a:pt x="293" y="94"/>
                      </a:lnTo>
                      <a:lnTo>
                        <a:pt x="293" y="94"/>
                      </a:lnTo>
                      <a:lnTo>
                        <a:pt x="294" y="94"/>
                      </a:lnTo>
                      <a:lnTo>
                        <a:pt x="294" y="92"/>
                      </a:lnTo>
                      <a:lnTo>
                        <a:pt x="294" y="95"/>
                      </a:lnTo>
                      <a:lnTo>
                        <a:pt x="294" y="92"/>
                      </a:lnTo>
                      <a:lnTo>
                        <a:pt x="295" y="92"/>
                      </a:lnTo>
                      <a:lnTo>
                        <a:pt x="295" y="91"/>
                      </a:lnTo>
                      <a:lnTo>
                        <a:pt x="295" y="94"/>
                      </a:lnTo>
                      <a:lnTo>
                        <a:pt x="295" y="92"/>
                      </a:lnTo>
                      <a:lnTo>
                        <a:pt x="296" y="92"/>
                      </a:lnTo>
                      <a:lnTo>
                        <a:pt x="296" y="91"/>
                      </a:lnTo>
                      <a:lnTo>
                        <a:pt x="296" y="94"/>
                      </a:lnTo>
                      <a:lnTo>
                        <a:pt x="296" y="91"/>
                      </a:lnTo>
                      <a:lnTo>
                        <a:pt x="297" y="91"/>
                      </a:lnTo>
                      <a:lnTo>
                        <a:pt x="297" y="91"/>
                      </a:lnTo>
                      <a:lnTo>
                        <a:pt x="297" y="95"/>
                      </a:lnTo>
                      <a:lnTo>
                        <a:pt x="297" y="95"/>
                      </a:lnTo>
                      <a:lnTo>
                        <a:pt x="298" y="95"/>
                      </a:lnTo>
                      <a:lnTo>
                        <a:pt x="298" y="91"/>
                      </a:lnTo>
                      <a:lnTo>
                        <a:pt x="298" y="95"/>
                      </a:lnTo>
                      <a:lnTo>
                        <a:pt x="298" y="92"/>
                      </a:lnTo>
                      <a:lnTo>
                        <a:pt x="299" y="92"/>
                      </a:lnTo>
                      <a:lnTo>
                        <a:pt x="299" y="91"/>
                      </a:lnTo>
                      <a:lnTo>
                        <a:pt x="299" y="93"/>
                      </a:lnTo>
                      <a:lnTo>
                        <a:pt x="299" y="93"/>
                      </a:lnTo>
                      <a:lnTo>
                        <a:pt x="300" y="93"/>
                      </a:lnTo>
                      <a:lnTo>
                        <a:pt x="300" y="91"/>
                      </a:lnTo>
                      <a:lnTo>
                        <a:pt x="300" y="94"/>
                      </a:lnTo>
                      <a:lnTo>
                        <a:pt x="300" y="94"/>
                      </a:lnTo>
                      <a:lnTo>
                        <a:pt x="301" y="94"/>
                      </a:lnTo>
                      <a:lnTo>
                        <a:pt x="301" y="91"/>
                      </a:lnTo>
                      <a:lnTo>
                        <a:pt x="301" y="94"/>
                      </a:lnTo>
                      <a:lnTo>
                        <a:pt x="301" y="91"/>
                      </a:lnTo>
                      <a:lnTo>
                        <a:pt x="302" y="91"/>
                      </a:lnTo>
                      <a:lnTo>
                        <a:pt x="302" y="91"/>
                      </a:lnTo>
                      <a:lnTo>
                        <a:pt x="302" y="94"/>
                      </a:lnTo>
                      <a:lnTo>
                        <a:pt x="302" y="91"/>
                      </a:lnTo>
                      <a:lnTo>
                        <a:pt x="303" y="91"/>
                      </a:lnTo>
                      <a:lnTo>
                        <a:pt x="303" y="90"/>
                      </a:lnTo>
                      <a:lnTo>
                        <a:pt x="303" y="93"/>
                      </a:lnTo>
                      <a:lnTo>
                        <a:pt x="303" y="91"/>
                      </a:lnTo>
                      <a:lnTo>
                        <a:pt x="304" y="91"/>
                      </a:lnTo>
                      <a:lnTo>
                        <a:pt x="304" y="90"/>
                      </a:lnTo>
                      <a:lnTo>
                        <a:pt x="304" y="92"/>
                      </a:lnTo>
                      <a:lnTo>
                        <a:pt x="304" y="92"/>
                      </a:lnTo>
                      <a:lnTo>
                        <a:pt x="305" y="92"/>
                      </a:lnTo>
                      <a:lnTo>
                        <a:pt x="305" y="91"/>
                      </a:lnTo>
                      <a:lnTo>
                        <a:pt x="305" y="93"/>
                      </a:lnTo>
                      <a:lnTo>
                        <a:pt x="305" y="92"/>
                      </a:lnTo>
                      <a:lnTo>
                        <a:pt x="306" y="92"/>
                      </a:lnTo>
                      <a:lnTo>
                        <a:pt x="306" y="92"/>
                      </a:lnTo>
                      <a:lnTo>
                        <a:pt x="306" y="94"/>
                      </a:lnTo>
                      <a:lnTo>
                        <a:pt x="306" y="92"/>
                      </a:lnTo>
                      <a:lnTo>
                        <a:pt x="307" y="92"/>
                      </a:lnTo>
                      <a:lnTo>
                        <a:pt x="307" y="91"/>
                      </a:lnTo>
                      <a:lnTo>
                        <a:pt x="307" y="93"/>
                      </a:lnTo>
                      <a:lnTo>
                        <a:pt x="307" y="92"/>
                      </a:lnTo>
                      <a:lnTo>
                        <a:pt x="308" y="92"/>
                      </a:lnTo>
                      <a:lnTo>
                        <a:pt x="308" y="91"/>
                      </a:lnTo>
                      <a:lnTo>
                        <a:pt x="308" y="94"/>
                      </a:lnTo>
                      <a:lnTo>
                        <a:pt x="308" y="94"/>
                      </a:lnTo>
                      <a:lnTo>
                        <a:pt x="309" y="94"/>
                      </a:lnTo>
                      <a:lnTo>
                        <a:pt x="309" y="91"/>
                      </a:lnTo>
                      <a:lnTo>
                        <a:pt x="309" y="95"/>
                      </a:lnTo>
                      <a:lnTo>
                        <a:pt x="309" y="92"/>
                      </a:lnTo>
                      <a:lnTo>
                        <a:pt x="310" y="92"/>
                      </a:lnTo>
                      <a:lnTo>
                        <a:pt x="310" y="90"/>
                      </a:lnTo>
                      <a:lnTo>
                        <a:pt x="310" y="93"/>
                      </a:lnTo>
                      <a:lnTo>
                        <a:pt x="310" y="91"/>
                      </a:lnTo>
                      <a:lnTo>
                        <a:pt x="311" y="91"/>
                      </a:lnTo>
                      <a:lnTo>
                        <a:pt x="311" y="90"/>
                      </a:lnTo>
                      <a:lnTo>
                        <a:pt x="311" y="92"/>
                      </a:lnTo>
                      <a:lnTo>
                        <a:pt x="311" y="90"/>
                      </a:lnTo>
                      <a:lnTo>
                        <a:pt x="312" y="90"/>
                      </a:lnTo>
                      <a:lnTo>
                        <a:pt x="312" y="91"/>
                      </a:lnTo>
                      <a:lnTo>
                        <a:pt x="312" y="94"/>
                      </a:lnTo>
                      <a:lnTo>
                        <a:pt x="312" y="92"/>
                      </a:lnTo>
                      <a:lnTo>
                        <a:pt x="313" y="92"/>
                      </a:lnTo>
                      <a:lnTo>
                        <a:pt x="313" y="91"/>
                      </a:lnTo>
                      <a:lnTo>
                        <a:pt x="313" y="93"/>
                      </a:lnTo>
                      <a:lnTo>
                        <a:pt x="313" y="91"/>
                      </a:lnTo>
                      <a:lnTo>
                        <a:pt x="314" y="91"/>
                      </a:lnTo>
                      <a:lnTo>
                        <a:pt x="314" y="90"/>
                      </a:lnTo>
                      <a:lnTo>
                        <a:pt x="314" y="92"/>
                      </a:lnTo>
                      <a:lnTo>
                        <a:pt x="314" y="92"/>
                      </a:lnTo>
                      <a:lnTo>
                        <a:pt x="315" y="92"/>
                      </a:lnTo>
                      <a:lnTo>
                        <a:pt x="315" y="91"/>
                      </a:lnTo>
                      <a:lnTo>
                        <a:pt x="315" y="92"/>
                      </a:lnTo>
                      <a:lnTo>
                        <a:pt x="315" y="92"/>
                      </a:lnTo>
                      <a:lnTo>
                        <a:pt x="316" y="92"/>
                      </a:lnTo>
                      <a:lnTo>
                        <a:pt x="316" y="89"/>
                      </a:lnTo>
                      <a:lnTo>
                        <a:pt x="316" y="94"/>
                      </a:lnTo>
                      <a:lnTo>
                        <a:pt x="316" y="91"/>
                      </a:lnTo>
                      <a:lnTo>
                        <a:pt x="317" y="91"/>
                      </a:lnTo>
                      <a:lnTo>
                        <a:pt x="317" y="91"/>
                      </a:lnTo>
                      <a:lnTo>
                        <a:pt x="317" y="92"/>
                      </a:lnTo>
                      <a:lnTo>
                        <a:pt x="317" y="92"/>
                      </a:lnTo>
                      <a:lnTo>
                        <a:pt x="318" y="92"/>
                      </a:lnTo>
                      <a:lnTo>
                        <a:pt x="318" y="90"/>
                      </a:lnTo>
                      <a:lnTo>
                        <a:pt x="318" y="92"/>
                      </a:lnTo>
                      <a:lnTo>
                        <a:pt x="318" y="90"/>
                      </a:lnTo>
                      <a:lnTo>
                        <a:pt x="319" y="90"/>
                      </a:lnTo>
                      <a:lnTo>
                        <a:pt x="319" y="90"/>
                      </a:lnTo>
                      <a:lnTo>
                        <a:pt x="319" y="92"/>
                      </a:lnTo>
                      <a:lnTo>
                        <a:pt x="319" y="91"/>
                      </a:lnTo>
                      <a:lnTo>
                        <a:pt x="320" y="91"/>
                      </a:lnTo>
                      <a:lnTo>
                        <a:pt x="320" y="90"/>
                      </a:lnTo>
                      <a:lnTo>
                        <a:pt x="320" y="92"/>
                      </a:lnTo>
                      <a:lnTo>
                        <a:pt x="320" y="91"/>
                      </a:lnTo>
                      <a:lnTo>
                        <a:pt x="321" y="91"/>
                      </a:lnTo>
                      <a:lnTo>
                        <a:pt x="321" y="89"/>
                      </a:lnTo>
                      <a:lnTo>
                        <a:pt x="321" y="92"/>
                      </a:lnTo>
                      <a:lnTo>
                        <a:pt x="321" y="91"/>
                      </a:lnTo>
                      <a:lnTo>
                        <a:pt x="322" y="91"/>
                      </a:lnTo>
                      <a:lnTo>
                        <a:pt x="322" y="89"/>
                      </a:lnTo>
                      <a:lnTo>
                        <a:pt x="322" y="92"/>
                      </a:lnTo>
                      <a:lnTo>
                        <a:pt x="322" y="90"/>
                      </a:lnTo>
                      <a:lnTo>
                        <a:pt x="323" y="90"/>
                      </a:lnTo>
                      <a:lnTo>
                        <a:pt x="323" y="90"/>
                      </a:lnTo>
                      <a:lnTo>
                        <a:pt x="323" y="92"/>
                      </a:lnTo>
                      <a:lnTo>
                        <a:pt x="323" y="91"/>
                      </a:lnTo>
                      <a:lnTo>
                        <a:pt x="324" y="91"/>
                      </a:lnTo>
                      <a:lnTo>
                        <a:pt x="324" y="90"/>
                      </a:lnTo>
                      <a:lnTo>
                        <a:pt x="324" y="92"/>
                      </a:lnTo>
                      <a:lnTo>
                        <a:pt x="324" y="91"/>
                      </a:lnTo>
                      <a:lnTo>
                        <a:pt x="325" y="91"/>
                      </a:lnTo>
                      <a:lnTo>
                        <a:pt x="325" y="89"/>
                      </a:lnTo>
                      <a:lnTo>
                        <a:pt x="325" y="91"/>
                      </a:lnTo>
                      <a:lnTo>
                        <a:pt x="325" y="90"/>
                      </a:lnTo>
                      <a:lnTo>
                        <a:pt x="326" y="90"/>
                      </a:lnTo>
                      <a:lnTo>
                        <a:pt x="326" y="89"/>
                      </a:lnTo>
                      <a:lnTo>
                        <a:pt x="326" y="92"/>
                      </a:lnTo>
                      <a:lnTo>
                        <a:pt x="326" y="91"/>
                      </a:lnTo>
                      <a:lnTo>
                        <a:pt x="327" y="91"/>
                      </a:lnTo>
                      <a:lnTo>
                        <a:pt x="327" y="88"/>
                      </a:lnTo>
                      <a:lnTo>
                        <a:pt x="327" y="91"/>
                      </a:lnTo>
                      <a:lnTo>
                        <a:pt x="327" y="88"/>
                      </a:lnTo>
                      <a:lnTo>
                        <a:pt x="328" y="88"/>
                      </a:lnTo>
                      <a:lnTo>
                        <a:pt x="328" y="87"/>
                      </a:lnTo>
                      <a:lnTo>
                        <a:pt x="328" y="91"/>
                      </a:lnTo>
                      <a:lnTo>
                        <a:pt x="328" y="90"/>
                      </a:lnTo>
                      <a:lnTo>
                        <a:pt x="329" y="90"/>
                      </a:lnTo>
                      <a:lnTo>
                        <a:pt x="329" y="88"/>
                      </a:lnTo>
                      <a:lnTo>
                        <a:pt x="329" y="92"/>
                      </a:lnTo>
                      <a:lnTo>
                        <a:pt x="329" y="91"/>
                      </a:lnTo>
                      <a:lnTo>
                        <a:pt x="330" y="91"/>
                      </a:lnTo>
                      <a:lnTo>
                        <a:pt x="330" y="89"/>
                      </a:lnTo>
                      <a:lnTo>
                        <a:pt x="330" y="92"/>
                      </a:lnTo>
                      <a:lnTo>
                        <a:pt x="330" y="91"/>
                      </a:lnTo>
                      <a:lnTo>
                        <a:pt x="331" y="91"/>
                      </a:lnTo>
                      <a:lnTo>
                        <a:pt x="331" y="89"/>
                      </a:lnTo>
                      <a:lnTo>
                        <a:pt x="331" y="92"/>
                      </a:lnTo>
                      <a:lnTo>
                        <a:pt x="331" y="91"/>
                      </a:lnTo>
                      <a:lnTo>
                        <a:pt x="332" y="91"/>
                      </a:lnTo>
                      <a:lnTo>
                        <a:pt x="332" y="88"/>
                      </a:lnTo>
                      <a:lnTo>
                        <a:pt x="332" y="91"/>
                      </a:lnTo>
                      <a:lnTo>
                        <a:pt x="332" y="89"/>
                      </a:lnTo>
                      <a:lnTo>
                        <a:pt x="333" y="89"/>
                      </a:lnTo>
                      <a:lnTo>
                        <a:pt x="333" y="89"/>
                      </a:lnTo>
                      <a:lnTo>
                        <a:pt x="333" y="91"/>
                      </a:lnTo>
                      <a:lnTo>
                        <a:pt x="333" y="90"/>
                      </a:lnTo>
                      <a:lnTo>
                        <a:pt x="334" y="90"/>
                      </a:lnTo>
                      <a:lnTo>
                        <a:pt x="334" y="88"/>
                      </a:lnTo>
                      <a:lnTo>
                        <a:pt x="334" y="91"/>
                      </a:lnTo>
                      <a:lnTo>
                        <a:pt x="334" y="88"/>
                      </a:lnTo>
                      <a:lnTo>
                        <a:pt x="335" y="88"/>
                      </a:lnTo>
                      <a:lnTo>
                        <a:pt x="335" y="88"/>
                      </a:lnTo>
                      <a:lnTo>
                        <a:pt x="335" y="91"/>
                      </a:lnTo>
                      <a:lnTo>
                        <a:pt x="335" y="89"/>
                      </a:lnTo>
                      <a:lnTo>
                        <a:pt x="336" y="89"/>
                      </a:lnTo>
                      <a:lnTo>
                        <a:pt x="336" y="89"/>
                      </a:lnTo>
                      <a:lnTo>
                        <a:pt x="336" y="92"/>
                      </a:lnTo>
                      <a:lnTo>
                        <a:pt x="336" y="91"/>
                      </a:lnTo>
                      <a:lnTo>
                        <a:pt x="337" y="91"/>
                      </a:lnTo>
                      <a:lnTo>
                        <a:pt x="337" y="89"/>
                      </a:lnTo>
                      <a:lnTo>
                        <a:pt x="337" y="91"/>
                      </a:lnTo>
                      <a:lnTo>
                        <a:pt x="337" y="91"/>
                      </a:lnTo>
                      <a:lnTo>
                        <a:pt x="338" y="91"/>
                      </a:lnTo>
                      <a:lnTo>
                        <a:pt x="338" y="89"/>
                      </a:lnTo>
                      <a:lnTo>
                        <a:pt x="338" y="92"/>
                      </a:lnTo>
                      <a:lnTo>
                        <a:pt x="338" y="91"/>
                      </a:lnTo>
                      <a:lnTo>
                        <a:pt x="339" y="91"/>
                      </a:lnTo>
                      <a:lnTo>
                        <a:pt x="339" y="89"/>
                      </a:lnTo>
                      <a:lnTo>
                        <a:pt x="339" y="91"/>
                      </a:lnTo>
                      <a:lnTo>
                        <a:pt x="339" y="90"/>
                      </a:lnTo>
                      <a:lnTo>
                        <a:pt x="340" y="90"/>
                      </a:lnTo>
                      <a:lnTo>
                        <a:pt x="340" y="89"/>
                      </a:lnTo>
                      <a:lnTo>
                        <a:pt x="340" y="91"/>
                      </a:lnTo>
                      <a:lnTo>
                        <a:pt x="340" y="90"/>
                      </a:lnTo>
                      <a:lnTo>
                        <a:pt x="341" y="90"/>
                      </a:lnTo>
                      <a:lnTo>
                        <a:pt x="341" y="88"/>
                      </a:lnTo>
                      <a:lnTo>
                        <a:pt x="341" y="92"/>
                      </a:lnTo>
                      <a:lnTo>
                        <a:pt x="341" y="89"/>
                      </a:lnTo>
                      <a:lnTo>
                        <a:pt x="342" y="89"/>
                      </a:lnTo>
                      <a:lnTo>
                        <a:pt x="342" y="88"/>
                      </a:lnTo>
                      <a:lnTo>
                        <a:pt x="342" y="91"/>
                      </a:lnTo>
                      <a:lnTo>
                        <a:pt x="342" y="88"/>
                      </a:lnTo>
                      <a:lnTo>
                        <a:pt x="343" y="88"/>
                      </a:lnTo>
                      <a:lnTo>
                        <a:pt x="343" y="87"/>
                      </a:lnTo>
                      <a:lnTo>
                        <a:pt x="343" y="90"/>
                      </a:lnTo>
                      <a:lnTo>
                        <a:pt x="343" y="87"/>
                      </a:lnTo>
                      <a:lnTo>
                        <a:pt x="344" y="87"/>
                      </a:lnTo>
                      <a:lnTo>
                        <a:pt x="344" y="88"/>
                      </a:lnTo>
                      <a:lnTo>
                        <a:pt x="344" y="91"/>
                      </a:lnTo>
                      <a:lnTo>
                        <a:pt x="344" y="90"/>
                      </a:lnTo>
                      <a:lnTo>
                        <a:pt x="345" y="90"/>
                      </a:lnTo>
                      <a:lnTo>
                        <a:pt x="345" y="88"/>
                      </a:lnTo>
                      <a:lnTo>
                        <a:pt x="345" y="91"/>
                      </a:lnTo>
                      <a:lnTo>
                        <a:pt x="345" y="88"/>
                      </a:lnTo>
                      <a:lnTo>
                        <a:pt x="346" y="88"/>
                      </a:lnTo>
                      <a:lnTo>
                        <a:pt x="346" y="87"/>
                      </a:lnTo>
                      <a:lnTo>
                        <a:pt x="346" y="90"/>
                      </a:lnTo>
                      <a:lnTo>
                        <a:pt x="346" y="89"/>
                      </a:lnTo>
                      <a:lnTo>
                        <a:pt x="347" y="89"/>
                      </a:lnTo>
                      <a:lnTo>
                        <a:pt x="347" y="87"/>
                      </a:lnTo>
                      <a:lnTo>
                        <a:pt x="347" y="91"/>
                      </a:lnTo>
                      <a:lnTo>
                        <a:pt x="347" y="90"/>
                      </a:lnTo>
                      <a:lnTo>
                        <a:pt x="348" y="90"/>
                      </a:lnTo>
                      <a:lnTo>
                        <a:pt x="348" y="87"/>
                      </a:lnTo>
                      <a:lnTo>
                        <a:pt x="348" y="91"/>
                      </a:lnTo>
                      <a:lnTo>
                        <a:pt x="348" y="89"/>
                      </a:lnTo>
                      <a:lnTo>
                        <a:pt x="349" y="89"/>
                      </a:lnTo>
                      <a:lnTo>
                        <a:pt x="349" y="86"/>
                      </a:lnTo>
                      <a:lnTo>
                        <a:pt x="349" y="89"/>
                      </a:lnTo>
                      <a:lnTo>
                        <a:pt x="349" y="88"/>
                      </a:lnTo>
                      <a:lnTo>
                        <a:pt x="350" y="88"/>
                      </a:lnTo>
                      <a:lnTo>
                        <a:pt x="350" y="86"/>
                      </a:lnTo>
                      <a:lnTo>
                        <a:pt x="350" y="88"/>
                      </a:lnTo>
                      <a:lnTo>
                        <a:pt x="350" y="87"/>
                      </a:lnTo>
                      <a:lnTo>
                        <a:pt x="351" y="87"/>
                      </a:lnTo>
                      <a:lnTo>
                        <a:pt x="351" y="87"/>
                      </a:lnTo>
                      <a:lnTo>
                        <a:pt x="351" y="90"/>
                      </a:lnTo>
                      <a:lnTo>
                        <a:pt x="351" y="90"/>
                      </a:lnTo>
                      <a:lnTo>
                        <a:pt x="352" y="90"/>
                      </a:lnTo>
                      <a:lnTo>
                        <a:pt x="352" y="86"/>
                      </a:lnTo>
                      <a:lnTo>
                        <a:pt x="352" y="90"/>
                      </a:lnTo>
                      <a:lnTo>
                        <a:pt x="352" y="87"/>
                      </a:lnTo>
                      <a:lnTo>
                        <a:pt x="353" y="87"/>
                      </a:lnTo>
                      <a:lnTo>
                        <a:pt x="353" y="86"/>
                      </a:lnTo>
                      <a:lnTo>
                        <a:pt x="353" y="90"/>
                      </a:lnTo>
                      <a:lnTo>
                        <a:pt x="353" y="87"/>
                      </a:lnTo>
                      <a:lnTo>
                        <a:pt x="354" y="87"/>
                      </a:lnTo>
                      <a:lnTo>
                        <a:pt x="354" y="86"/>
                      </a:lnTo>
                      <a:lnTo>
                        <a:pt x="354" y="90"/>
                      </a:lnTo>
                      <a:lnTo>
                        <a:pt x="354" y="87"/>
                      </a:lnTo>
                      <a:lnTo>
                        <a:pt x="355" y="87"/>
                      </a:lnTo>
                      <a:lnTo>
                        <a:pt x="355" y="87"/>
                      </a:lnTo>
                      <a:lnTo>
                        <a:pt x="355" y="90"/>
                      </a:lnTo>
                      <a:lnTo>
                        <a:pt x="355" y="90"/>
                      </a:lnTo>
                      <a:lnTo>
                        <a:pt x="356" y="90"/>
                      </a:lnTo>
                      <a:lnTo>
                        <a:pt x="356" y="87"/>
                      </a:lnTo>
                      <a:lnTo>
                        <a:pt x="356" y="91"/>
                      </a:lnTo>
                      <a:lnTo>
                        <a:pt x="356" y="89"/>
                      </a:lnTo>
                      <a:lnTo>
                        <a:pt x="357" y="89"/>
                      </a:lnTo>
                      <a:lnTo>
                        <a:pt x="357" y="87"/>
                      </a:lnTo>
                      <a:lnTo>
                        <a:pt x="357" y="89"/>
                      </a:lnTo>
                      <a:lnTo>
                        <a:pt x="357" y="88"/>
                      </a:lnTo>
                      <a:lnTo>
                        <a:pt x="358" y="88"/>
                      </a:lnTo>
                      <a:lnTo>
                        <a:pt x="358" y="86"/>
                      </a:lnTo>
                      <a:lnTo>
                        <a:pt x="358" y="89"/>
                      </a:lnTo>
                      <a:lnTo>
                        <a:pt x="358" y="87"/>
                      </a:lnTo>
                      <a:lnTo>
                        <a:pt x="359" y="87"/>
                      </a:lnTo>
                      <a:lnTo>
                        <a:pt x="359" y="87"/>
                      </a:lnTo>
                      <a:lnTo>
                        <a:pt x="359" y="90"/>
                      </a:lnTo>
                      <a:lnTo>
                        <a:pt x="359" y="88"/>
                      </a:lnTo>
                      <a:lnTo>
                        <a:pt x="360" y="88"/>
                      </a:lnTo>
                      <a:lnTo>
                        <a:pt x="360" y="87"/>
                      </a:lnTo>
                      <a:lnTo>
                        <a:pt x="360" y="91"/>
                      </a:lnTo>
                      <a:lnTo>
                        <a:pt x="360" y="87"/>
                      </a:lnTo>
                      <a:lnTo>
                        <a:pt x="361" y="87"/>
                      </a:lnTo>
                      <a:lnTo>
                        <a:pt x="361" y="87"/>
                      </a:lnTo>
                      <a:lnTo>
                        <a:pt x="361" y="89"/>
                      </a:lnTo>
                      <a:lnTo>
                        <a:pt x="361" y="87"/>
                      </a:lnTo>
                      <a:lnTo>
                        <a:pt x="362" y="87"/>
                      </a:lnTo>
                      <a:lnTo>
                        <a:pt x="362" y="88"/>
                      </a:lnTo>
                      <a:lnTo>
                        <a:pt x="362" y="91"/>
                      </a:lnTo>
                      <a:lnTo>
                        <a:pt x="362" y="88"/>
                      </a:lnTo>
                      <a:lnTo>
                        <a:pt x="363" y="88"/>
                      </a:lnTo>
                      <a:lnTo>
                        <a:pt x="363" y="86"/>
                      </a:lnTo>
                      <a:lnTo>
                        <a:pt x="363" y="91"/>
                      </a:lnTo>
                      <a:lnTo>
                        <a:pt x="363" y="89"/>
                      </a:lnTo>
                      <a:lnTo>
                        <a:pt x="364" y="89"/>
                      </a:lnTo>
                      <a:lnTo>
                        <a:pt x="364" y="86"/>
                      </a:lnTo>
                      <a:lnTo>
                        <a:pt x="364" y="89"/>
                      </a:lnTo>
                      <a:lnTo>
                        <a:pt x="364" y="89"/>
                      </a:lnTo>
                      <a:lnTo>
                        <a:pt x="365" y="89"/>
                      </a:lnTo>
                      <a:lnTo>
                        <a:pt x="365" y="86"/>
                      </a:lnTo>
                      <a:lnTo>
                        <a:pt x="365" y="90"/>
                      </a:lnTo>
                      <a:lnTo>
                        <a:pt x="365" y="89"/>
                      </a:lnTo>
                      <a:lnTo>
                        <a:pt x="366" y="89"/>
                      </a:lnTo>
                      <a:lnTo>
                        <a:pt x="366" y="86"/>
                      </a:lnTo>
                      <a:lnTo>
                        <a:pt x="366" y="90"/>
                      </a:lnTo>
                      <a:lnTo>
                        <a:pt x="366" y="90"/>
                      </a:lnTo>
                      <a:lnTo>
                        <a:pt x="367" y="90"/>
                      </a:lnTo>
                      <a:lnTo>
                        <a:pt x="367" y="86"/>
                      </a:lnTo>
                      <a:lnTo>
                        <a:pt x="367" y="90"/>
                      </a:lnTo>
                      <a:lnTo>
                        <a:pt x="367" y="86"/>
                      </a:lnTo>
                      <a:lnTo>
                        <a:pt x="368" y="86"/>
                      </a:lnTo>
                      <a:lnTo>
                        <a:pt x="368" y="86"/>
                      </a:lnTo>
                      <a:lnTo>
                        <a:pt x="368" y="90"/>
                      </a:lnTo>
                      <a:lnTo>
                        <a:pt x="368" y="90"/>
                      </a:lnTo>
                      <a:lnTo>
                        <a:pt x="369" y="90"/>
                      </a:lnTo>
                      <a:lnTo>
                        <a:pt x="369" y="87"/>
                      </a:lnTo>
                      <a:lnTo>
                        <a:pt x="369" y="89"/>
                      </a:lnTo>
                      <a:lnTo>
                        <a:pt x="369" y="88"/>
                      </a:lnTo>
                      <a:lnTo>
                        <a:pt x="370" y="88"/>
                      </a:lnTo>
                      <a:lnTo>
                        <a:pt x="370" y="86"/>
                      </a:lnTo>
                      <a:lnTo>
                        <a:pt x="370" y="89"/>
                      </a:lnTo>
                      <a:lnTo>
                        <a:pt x="370" y="88"/>
                      </a:lnTo>
                      <a:lnTo>
                        <a:pt x="371" y="88"/>
                      </a:lnTo>
                      <a:lnTo>
                        <a:pt x="371" y="86"/>
                      </a:lnTo>
                      <a:lnTo>
                        <a:pt x="371" y="89"/>
                      </a:lnTo>
                      <a:lnTo>
                        <a:pt x="371" y="86"/>
                      </a:lnTo>
                      <a:lnTo>
                        <a:pt x="372" y="86"/>
                      </a:lnTo>
                      <a:lnTo>
                        <a:pt x="372" y="85"/>
                      </a:lnTo>
                      <a:lnTo>
                        <a:pt x="372" y="89"/>
                      </a:lnTo>
                      <a:lnTo>
                        <a:pt x="372" y="86"/>
                      </a:lnTo>
                      <a:lnTo>
                        <a:pt x="373" y="86"/>
                      </a:lnTo>
                      <a:lnTo>
                        <a:pt x="373" y="86"/>
                      </a:lnTo>
                      <a:lnTo>
                        <a:pt x="373" y="89"/>
                      </a:lnTo>
                      <a:lnTo>
                        <a:pt x="373" y="89"/>
                      </a:lnTo>
                      <a:lnTo>
                        <a:pt x="374" y="89"/>
                      </a:lnTo>
                      <a:lnTo>
                        <a:pt x="374" y="87"/>
                      </a:lnTo>
                      <a:lnTo>
                        <a:pt x="374" y="90"/>
                      </a:lnTo>
                      <a:lnTo>
                        <a:pt x="374" y="88"/>
                      </a:lnTo>
                      <a:lnTo>
                        <a:pt x="375" y="88"/>
                      </a:lnTo>
                      <a:lnTo>
                        <a:pt x="375" y="86"/>
                      </a:lnTo>
                      <a:lnTo>
                        <a:pt x="375" y="89"/>
                      </a:lnTo>
                      <a:lnTo>
                        <a:pt x="375" y="86"/>
                      </a:lnTo>
                      <a:lnTo>
                        <a:pt x="376" y="86"/>
                      </a:lnTo>
                      <a:lnTo>
                        <a:pt x="376" y="86"/>
                      </a:lnTo>
                      <a:lnTo>
                        <a:pt x="376" y="89"/>
                      </a:lnTo>
                      <a:lnTo>
                        <a:pt x="376" y="87"/>
                      </a:lnTo>
                      <a:lnTo>
                        <a:pt x="377" y="87"/>
                      </a:lnTo>
                      <a:lnTo>
                        <a:pt x="377" y="86"/>
                      </a:lnTo>
                      <a:lnTo>
                        <a:pt x="377" y="90"/>
                      </a:lnTo>
                      <a:lnTo>
                        <a:pt x="377" y="89"/>
                      </a:lnTo>
                      <a:lnTo>
                        <a:pt x="378" y="89"/>
                      </a:lnTo>
                      <a:lnTo>
                        <a:pt x="378" y="86"/>
                      </a:lnTo>
                      <a:lnTo>
                        <a:pt x="378" y="90"/>
                      </a:lnTo>
                      <a:lnTo>
                        <a:pt x="378" y="90"/>
                      </a:lnTo>
                      <a:lnTo>
                        <a:pt x="379" y="90"/>
                      </a:lnTo>
                      <a:lnTo>
                        <a:pt x="379" y="87"/>
                      </a:lnTo>
                      <a:lnTo>
                        <a:pt x="379" y="89"/>
                      </a:lnTo>
                      <a:lnTo>
                        <a:pt x="379" y="88"/>
                      </a:lnTo>
                      <a:lnTo>
                        <a:pt x="380" y="88"/>
                      </a:lnTo>
                      <a:lnTo>
                        <a:pt x="380" y="87"/>
                      </a:lnTo>
                      <a:lnTo>
                        <a:pt x="380" y="91"/>
                      </a:lnTo>
                      <a:lnTo>
                        <a:pt x="380" y="90"/>
                      </a:lnTo>
                      <a:lnTo>
                        <a:pt x="381" y="90"/>
                      </a:lnTo>
                      <a:lnTo>
                        <a:pt x="381" y="87"/>
                      </a:lnTo>
                      <a:lnTo>
                        <a:pt x="381" y="90"/>
                      </a:lnTo>
                      <a:lnTo>
                        <a:pt x="381" y="89"/>
                      </a:lnTo>
                      <a:lnTo>
                        <a:pt x="382" y="89"/>
                      </a:lnTo>
                      <a:lnTo>
                        <a:pt x="382" y="86"/>
                      </a:lnTo>
                      <a:lnTo>
                        <a:pt x="382" y="89"/>
                      </a:lnTo>
                      <a:lnTo>
                        <a:pt x="382" y="88"/>
                      </a:lnTo>
                      <a:lnTo>
                        <a:pt x="383" y="88"/>
                      </a:lnTo>
                      <a:lnTo>
                        <a:pt x="383" y="86"/>
                      </a:lnTo>
                      <a:lnTo>
                        <a:pt x="383" y="90"/>
                      </a:lnTo>
                      <a:lnTo>
                        <a:pt x="383" y="86"/>
                      </a:lnTo>
                      <a:lnTo>
                        <a:pt x="384" y="86"/>
                      </a:lnTo>
                      <a:lnTo>
                        <a:pt x="384" y="86"/>
                      </a:lnTo>
                      <a:lnTo>
                        <a:pt x="384" y="90"/>
                      </a:lnTo>
                      <a:lnTo>
                        <a:pt x="384" y="87"/>
                      </a:lnTo>
                      <a:lnTo>
                        <a:pt x="385" y="87"/>
                      </a:lnTo>
                      <a:lnTo>
                        <a:pt x="385" y="86"/>
                      </a:lnTo>
                      <a:lnTo>
                        <a:pt x="385" y="89"/>
                      </a:lnTo>
                      <a:lnTo>
                        <a:pt x="385" y="87"/>
                      </a:lnTo>
                      <a:lnTo>
                        <a:pt x="386" y="87"/>
                      </a:lnTo>
                      <a:lnTo>
                        <a:pt x="386" y="86"/>
                      </a:lnTo>
                      <a:lnTo>
                        <a:pt x="386" y="89"/>
                      </a:lnTo>
                      <a:lnTo>
                        <a:pt x="386" y="88"/>
                      </a:lnTo>
                      <a:lnTo>
                        <a:pt x="387" y="88"/>
                      </a:lnTo>
                      <a:lnTo>
                        <a:pt x="387" y="85"/>
                      </a:lnTo>
                      <a:lnTo>
                        <a:pt x="387" y="89"/>
                      </a:lnTo>
                      <a:lnTo>
                        <a:pt x="387" y="88"/>
                      </a:lnTo>
                      <a:lnTo>
                        <a:pt x="388" y="88"/>
                      </a:lnTo>
                      <a:lnTo>
                        <a:pt x="388" y="85"/>
                      </a:lnTo>
                      <a:lnTo>
                        <a:pt x="388" y="89"/>
                      </a:lnTo>
                      <a:lnTo>
                        <a:pt x="388" y="89"/>
                      </a:lnTo>
                      <a:lnTo>
                        <a:pt x="389" y="89"/>
                      </a:lnTo>
                      <a:lnTo>
                        <a:pt x="389" y="87"/>
                      </a:lnTo>
                      <a:lnTo>
                        <a:pt x="389" y="90"/>
                      </a:lnTo>
                      <a:lnTo>
                        <a:pt x="389" y="87"/>
                      </a:lnTo>
                      <a:lnTo>
                        <a:pt x="390" y="87"/>
                      </a:lnTo>
                      <a:lnTo>
                        <a:pt x="390" y="86"/>
                      </a:lnTo>
                      <a:lnTo>
                        <a:pt x="390" y="89"/>
                      </a:lnTo>
                      <a:lnTo>
                        <a:pt x="390" y="88"/>
                      </a:lnTo>
                      <a:lnTo>
                        <a:pt x="391" y="88"/>
                      </a:lnTo>
                      <a:lnTo>
                        <a:pt x="391" y="88"/>
                      </a:lnTo>
                      <a:lnTo>
                        <a:pt x="391" y="90"/>
                      </a:lnTo>
                      <a:lnTo>
                        <a:pt x="391" y="90"/>
                      </a:lnTo>
                      <a:lnTo>
                        <a:pt x="392" y="90"/>
                      </a:lnTo>
                      <a:lnTo>
                        <a:pt x="392" y="88"/>
                      </a:lnTo>
                      <a:lnTo>
                        <a:pt x="392" y="91"/>
                      </a:lnTo>
                      <a:lnTo>
                        <a:pt x="392" y="88"/>
                      </a:lnTo>
                      <a:lnTo>
                        <a:pt x="393" y="88"/>
                      </a:lnTo>
                      <a:lnTo>
                        <a:pt x="393" y="87"/>
                      </a:lnTo>
                      <a:lnTo>
                        <a:pt x="393" y="89"/>
                      </a:lnTo>
                      <a:lnTo>
                        <a:pt x="393" y="88"/>
                      </a:lnTo>
                      <a:lnTo>
                        <a:pt x="394" y="88"/>
                      </a:lnTo>
                      <a:lnTo>
                        <a:pt x="394" y="86"/>
                      </a:lnTo>
                      <a:lnTo>
                        <a:pt x="394" y="90"/>
                      </a:lnTo>
                      <a:lnTo>
                        <a:pt x="394" y="88"/>
                      </a:lnTo>
                      <a:lnTo>
                        <a:pt x="395" y="88"/>
                      </a:lnTo>
                      <a:lnTo>
                        <a:pt x="395" y="86"/>
                      </a:lnTo>
                      <a:lnTo>
                        <a:pt x="395" y="90"/>
                      </a:lnTo>
                      <a:lnTo>
                        <a:pt x="395" y="88"/>
                      </a:lnTo>
                      <a:lnTo>
                        <a:pt x="396" y="88"/>
                      </a:lnTo>
                      <a:lnTo>
                        <a:pt x="396" y="88"/>
                      </a:lnTo>
                      <a:lnTo>
                        <a:pt x="396" y="90"/>
                      </a:lnTo>
                      <a:lnTo>
                        <a:pt x="396" y="88"/>
                      </a:lnTo>
                      <a:lnTo>
                        <a:pt x="397" y="88"/>
                      </a:lnTo>
                      <a:lnTo>
                        <a:pt x="397" y="87"/>
                      </a:lnTo>
                      <a:lnTo>
                        <a:pt x="397" y="90"/>
                      </a:lnTo>
                      <a:lnTo>
                        <a:pt x="397" y="89"/>
                      </a:lnTo>
                      <a:lnTo>
                        <a:pt x="398" y="89"/>
                      </a:lnTo>
                      <a:lnTo>
                        <a:pt x="398" y="87"/>
                      </a:lnTo>
                      <a:lnTo>
                        <a:pt x="398" y="90"/>
                      </a:lnTo>
                      <a:lnTo>
                        <a:pt x="398" y="88"/>
                      </a:lnTo>
                      <a:lnTo>
                        <a:pt x="399" y="88"/>
                      </a:lnTo>
                      <a:lnTo>
                        <a:pt x="399" y="86"/>
                      </a:lnTo>
                      <a:lnTo>
                        <a:pt x="399" y="89"/>
                      </a:lnTo>
                      <a:lnTo>
                        <a:pt x="399" y="88"/>
                      </a:lnTo>
                      <a:lnTo>
                        <a:pt x="400" y="88"/>
                      </a:lnTo>
                      <a:lnTo>
                        <a:pt x="400" y="86"/>
                      </a:lnTo>
                      <a:lnTo>
                        <a:pt x="400" y="89"/>
                      </a:lnTo>
                      <a:lnTo>
                        <a:pt x="400" y="88"/>
                      </a:lnTo>
                      <a:lnTo>
                        <a:pt x="401" y="88"/>
                      </a:lnTo>
                      <a:lnTo>
                        <a:pt x="401" y="87"/>
                      </a:lnTo>
                      <a:lnTo>
                        <a:pt x="401" y="89"/>
                      </a:lnTo>
                      <a:lnTo>
                        <a:pt x="401" y="87"/>
                      </a:lnTo>
                      <a:lnTo>
                        <a:pt x="402" y="87"/>
                      </a:lnTo>
                      <a:lnTo>
                        <a:pt x="402" y="86"/>
                      </a:lnTo>
                      <a:lnTo>
                        <a:pt x="402" y="90"/>
                      </a:lnTo>
                      <a:lnTo>
                        <a:pt x="402" y="87"/>
                      </a:lnTo>
                      <a:lnTo>
                        <a:pt x="403" y="87"/>
                      </a:lnTo>
                      <a:lnTo>
                        <a:pt x="403" y="86"/>
                      </a:lnTo>
                      <a:lnTo>
                        <a:pt x="403" y="89"/>
                      </a:lnTo>
                      <a:lnTo>
                        <a:pt x="403" y="87"/>
                      </a:lnTo>
                      <a:lnTo>
                        <a:pt x="404" y="87"/>
                      </a:lnTo>
                      <a:lnTo>
                        <a:pt x="404" y="86"/>
                      </a:lnTo>
                      <a:lnTo>
                        <a:pt x="404" y="89"/>
                      </a:lnTo>
                      <a:lnTo>
                        <a:pt x="404" y="87"/>
                      </a:lnTo>
                      <a:lnTo>
                        <a:pt x="405" y="87"/>
                      </a:lnTo>
                      <a:lnTo>
                        <a:pt x="405" y="86"/>
                      </a:lnTo>
                      <a:lnTo>
                        <a:pt x="405" y="89"/>
                      </a:lnTo>
                      <a:lnTo>
                        <a:pt x="405" y="87"/>
                      </a:lnTo>
                      <a:lnTo>
                        <a:pt x="406" y="87"/>
                      </a:lnTo>
                      <a:lnTo>
                        <a:pt x="406" y="86"/>
                      </a:lnTo>
                      <a:lnTo>
                        <a:pt x="406" y="89"/>
                      </a:lnTo>
                      <a:lnTo>
                        <a:pt x="406" y="89"/>
                      </a:lnTo>
                      <a:lnTo>
                        <a:pt x="407" y="89"/>
                      </a:lnTo>
                      <a:lnTo>
                        <a:pt x="407" y="86"/>
                      </a:lnTo>
                      <a:lnTo>
                        <a:pt x="407" y="89"/>
                      </a:lnTo>
                      <a:lnTo>
                        <a:pt x="407" y="87"/>
                      </a:lnTo>
                      <a:lnTo>
                        <a:pt x="408" y="87"/>
                      </a:lnTo>
                      <a:lnTo>
                        <a:pt x="408" y="85"/>
                      </a:lnTo>
                      <a:lnTo>
                        <a:pt x="408" y="88"/>
                      </a:lnTo>
                      <a:lnTo>
                        <a:pt x="408" y="88"/>
                      </a:lnTo>
                      <a:lnTo>
                        <a:pt x="409" y="88"/>
                      </a:lnTo>
                      <a:lnTo>
                        <a:pt x="409" y="86"/>
                      </a:lnTo>
                      <a:lnTo>
                        <a:pt x="409" y="89"/>
                      </a:lnTo>
                      <a:lnTo>
                        <a:pt x="409" y="89"/>
                      </a:lnTo>
                      <a:lnTo>
                        <a:pt x="410" y="89"/>
                      </a:lnTo>
                      <a:lnTo>
                        <a:pt x="410" y="86"/>
                      </a:lnTo>
                      <a:lnTo>
                        <a:pt x="410" y="89"/>
                      </a:lnTo>
                      <a:lnTo>
                        <a:pt x="410" y="87"/>
                      </a:lnTo>
                      <a:lnTo>
                        <a:pt x="411" y="87"/>
                      </a:lnTo>
                      <a:lnTo>
                        <a:pt x="411" y="85"/>
                      </a:lnTo>
                      <a:lnTo>
                        <a:pt x="411" y="88"/>
                      </a:lnTo>
                      <a:lnTo>
                        <a:pt x="411" y="86"/>
                      </a:lnTo>
                      <a:lnTo>
                        <a:pt x="412" y="86"/>
                      </a:lnTo>
                      <a:lnTo>
                        <a:pt x="412" y="85"/>
                      </a:lnTo>
                      <a:lnTo>
                        <a:pt x="412" y="88"/>
                      </a:lnTo>
                      <a:lnTo>
                        <a:pt x="412" y="87"/>
                      </a:lnTo>
                      <a:lnTo>
                        <a:pt x="413" y="87"/>
                      </a:lnTo>
                      <a:lnTo>
                        <a:pt x="413" y="85"/>
                      </a:lnTo>
                      <a:lnTo>
                        <a:pt x="413" y="88"/>
                      </a:lnTo>
                      <a:lnTo>
                        <a:pt x="413" y="87"/>
                      </a:lnTo>
                      <a:lnTo>
                        <a:pt x="414" y="87"/>
                      </a:lnTo>
                      <a:lnTo>
                        <a:pt x="414" y="85"/>
                      </a:lnTo>
                      <a:lnTo>
                        <a:pt x="414" y="87"/>
                      </a:lnTo>
                      <a:lnTo>
                        <a:pt x="414" y="86"/>
                      </a:lnTo>
                      <a:lnTo>
                        <a:pt x="415" y="86"/>
                      </a:lnTo>
                      <a:lnTo>
                        <a:pt x="415" y="86"/>
                      </a:lnTo>
                      <a:lnTo>
                        <a:pt x="415" y="88"/>
                      </a:lnTo>
                      <a:lnTo>
                        <a:pt x="415" y="87"/>
                      </a:lnTo>
                      <a:lnTo>
                        <a:pt x="416" y="87"/>
                      </a:lnTo>
                      <a:lnTo>
                        <a:pt x="416" y="86"/>
                      </a:lnTo>
                      <a:lnTo>
                        <a:pt x="416" y="88"/>
                      </a:lnTo>
                      <a:lnTo>
                        <a:pt x="416" y="87"/>
                      </a:lnTo>
                      <a:lnTo>
                        <a:pt x="417" y="87"/>
                      </a:lnTo>
                      <a:lnTo>
                        <a:pt x="417" y="85"/>
                      </a:lnTo>
                      <a:lnTo>
                        <a:pt x="417" y="88"/>
                      </a:lnTo>
                      <a:lnTo>
                        <a:pt x="417" y="85"/>
                      </a:lnTo>
                      <a:lnTo>
                        <a:pt x="418" y="85"/>
                      </a:lnTo>
                      <a:lnTo>
                        <a:pt x="418" y="85"/>
                      </a:lnTo>
                      <a:lnTo>
                        <a:pt x="418" y="87"/>
                      </a:lnTo>
                      <a:lnTo>
                        <a:pt x="418" y="87"/>
                      </a:lnTo>
                      <a:lnTo>
                        <a:pt x="419" y="87"/>
                      </a:lnTo>
                      <a:lnTo>
                        <a:pt x="419" y="84"/>
                      </a:lnTo>
                      <a:lnTo>
                        <a:pt x="419" y="88"/>
                      </a:lnTo>
                      <a:lnTo>
                        <a:pt x="419" y="88"/>
                      </a:lnTo>
                      <a:lnTo>
                        <a:pt x="420" y="88"/>
                      </a:lnTo>
                      <a:lnTo>
                        <a:pt x="420" y="85"/>
                      </a:lnTo>
                      <a:lnTo>
                        <a:pt x="420" y="89"/>
                      </a:lnTo>
                      <a:lnTo>
                        <a:pt x="420" y="88"/>
                      </a:lnTo>
                      <a:lnTo>
                        <a:pt x="421" y="88"/>
                      </a:lnTo>
                      <a:lnTo>
                        <a:pt x="421" y="86"/>
                      </a:lnTo>
                      <a:lnTo>
                        <a:pt x="421" y="88"/>
                      </a:lnTo>
                      <a:lnTo>
                        <a:pt x="421" y="86"/>
                      </a:lnTo>
                      <a:lnTo>
                        <a:pt x="422" y="86"/>
                      </a:lnTo>
                      <a:lnTo>
                        <a:pt x="422" y="85"/>
                      </a:lnTo>
                      <a:lnTo>
                        <a:pt x="422" y="88"/>
                      </a:lnTo>
                      <a:lnTo>
                        <a:pt x="422" y="87"/>
                      </a:lnTo>
                      <a:lnTo>
                        <a:pt x="423" y="87"/>
                      </a:lnTo>
                      <a:lnTo>
                        <a:pt x="423" y="85"/>
                      </a:lnTo>
                      <a:lnTo>
                        <a:pt x="423" y="87"/>
                      </a:lnTo>
                      <a:lnTo>
                        <a:pt x="423" y="87"/>
                      </a:lnTo>
                      <a:lnTo>
                        <a:pt x="424" y="87"/>
                      </a:lnTo>
                      <a:lnTo>
                        <a:pt x="424" y="86"/>
                      </a:lnTo>
                      <a:lnTo>
                        <a:pt x="424" y="88"/>
                      </a:lnTo>
                      <a:lnTo>
                        <a:pt x="424" y="88"/>
                      </a:lnTo>
                      <a:lnTo>
                        <a:pt x="425" y="88"/>
                      </a:lnTo>
                      <a:lnTo>
                        <a:pt x="425" y="85"/>
                      </a:lnTo>
                      <a:lnTo>
                        <a:pt x="425" y="88"/>
                      </a:lnTo>
                      <a:lnTo>
                        <a:pt x="425" y="86"/>
                      </a:lnTo>
                      <a:lnTo>
                        <a:pt x="426" y="86"/>
                      </a:lnTo>
                      <a:lnTo>
                        <a:pt x="426" y="84"/>
                      </a:lnTo>
                      <a:lnTo>
                        <a:pt x="426" y="86"/>
                      </a:lnTo>
                      <a:lnTo>
                        <a:pt x="426" y="86"/>
                      </a:lnTo>
                      <a:lnTo>
                        <a:pt x="427" y="86"/>
                      </a:lnTo>
                      <a:lnTo>
                        <a:pt x="427" y="85"/>
                      </a:lnTo>
                      <a:lnTo>
                        <a:pt x="427" y="88"/>
                      </a:lnTo>
                      <a:lnTo>
                        <a:pt x="427" y="85"/>
                      </a:lnTo>
                      <a:lnTo>
                        <a:pt x="428" y="85"/>
                      </a:lnTo>
                      <a:lnTo>
                        <a:pt x="428" y="85"/>
                      </a:lnTo>
                      <a:lnTo>
                        <a:pt x="428" y="87"/>
                      </a:lnTo>
                      <a:lnTo>
                        <a:pt x="428" y="85"/>
                      </a:lnTo>
                      <a:lnTo>
                        <a:pt x="429" y="85"/>
                      </a:lnTo>
                      <a:lnTo>
                        <a:pt x="429" y="83"/>
                      </a:lnTo>
                      <a:lnTo>
                        <a:pt x="429" y="86"/>
                      </a:lnTo>
                      <a:lnTo>
                        <a:pt x="429" y="86"/>
                      </a:lnTo>
                      <a:lnTo>
                        <a:pt x="430" y="86"/>
                      </a:lnTo>
                      <a:lnTo>
                        <a:pt x="430" y="84"/>
                      </a:lnTo>
                      <a:lnTo>
                        <a:pt x="430" y="88"/>
                      </a:lnTo>
                      <a:lnTo>
                        <a:pt x="430" y="85"/>
                      </a:lnTo>
                      <a:lnTo>
                        <a:pt x="431" y="85"/>
                      </a:lnTo>
                      <a:lnTo>
                        <a:pt x="431" y="85"/>
                      </a:lnTo>
                      <a:lnTo>
                        <a:pt x="431" y="87"/>
                      </a:lnTo>
                      <a:lnTo>
                        <a:pt x="431" y="85"/>
                      </a:lnTo>
                      <a:lnTo>
                        <a:pt x="432" y="85"/>
                      </a:lnTo>
                      <a:lnTo>
                        <a:pt x="432" y="83"/>
                      </a:lnTo>
                      <a:lnTo>
                        <a:pt x="432" y="87"/>
                      </a:lnTo>
                      <a:lnTo>
                        <a:pt x="432" y="85"/>
                      </a:lnTo>
                      <a:lnTo>
                        <a:pt x="433" y="85"/>
                      </a:lnTo>
                      <a:lnTo>
                        <a:pt x="433" y="83"/>
                      </a:lnTo>
                      <a:lnTo>
                        <a:pt x="433" y="86"/>
                      </a:lnTo>
                      <a:lnTo>
                        <a:pt x="433" y="85"/>
                      </a:lnTo>
                      <a:lnTo>
                        <a:pt x="434" y="85"/>
                      </a:lnTo>
                      <a:lnTo>
                        <a:pt x="434" y="85"/>
                      </a:lnTo>
                      <a:lnTo>
                        <a:pt x="434" y="86"/>
                      </a:lnTo>
                      <a:lnTo>
                        <a:pt x="434" y="85"/>
                      </a:lnTo>
                      <a:lnTo>
                        <a:pt x="435" y="85"/>
                      </a:lnTo>
                      <a:lnTo>
                        <a:pt x="435" y="85"/>
                      </a:lnTo>
                      <a:lnTo>
                        <a:pt x="435" y="86"/>
                      </a:lnTo>
                      <a:lnTo>
                        <a:pt x="435" y="85"/>
                      </a:lnTo>
                      <a:lnTo>
                        <a:pt x="436" y="85"/>
                      </a:lnTo>
                      <a:lnTo>
                        <a:pt x="436" y="83"/>
                      </a:lnTo>
                      <a:lnTo>
                        <a:pt x="436" y="86"/>
                      </a:lnTo>
                      <a:lnTo>
                        <a:pt x="436" y="85"/>
                      </a:lnTo>
                      <a:lnTo>
                        <a:pt x="437" y="85"/>
                      </a:lnTo>
                      <a:lnTo>
                        <a:pt x="437" y="85"/>
                      </a:lnTo>
                      <a:lnTo>
                        <a:pt x="437" y="87"/>
                      </a:lnTo>
                      <a:lnTo>
                        <a:pt x="437" y="86"/>
                      </a:lnTo>
                      <a:lnTo>
                        <a:pt x="438" y="86"/>
                      </a:lnTo>
                      <a:lnTo>
                        <a:pt x="438" y="85"/>
                      </a:lnTo>
                      <a:lnTo>
                        <a:pt x="438" y="87"/>
                      </a:lnTo>
                      <a:lnTo>
                        <a:pt x="438" y="87"/>
                      </a:lnTo>
                      <a:lnTo>
                        <a:pt x="439" y="87"/>
                      </a:lnTo>
                      <a:lnTo>
                        <a:pt x="439" y="84"/>
                      </a:lnTo>
                      <a:lnTo>
                        <a:pt x="439" y="87"/>
                      </a:lnTo>
                      <a:lnTo>
                        <a:pt x="439" y="85"/>
                      </a:lnTo>
                      <a:lnTo>
                        <a:pt x="440" y="85"/>
                      </a:lnTo>
                      <a:lnTo>
                        <a:pt x="440" y="83"/>
                      </a:lnTo>
                      <a:lnTo>
                        <a:pt x="440" y="87"/>
                      </a:lnTo>
                      <a:lnTo>
                        <a:pt x="440" y="85"/>
                      </a:lnTo>
                      <a:lnTo>
                        <a:pt x="441" y="85"/>
                      </a:lnTo>
                      <a:lnTo>
                        <a:pt x="441" y="83"/>
                      </a:lnTo>
                      <a:lnTo>
                        <a:pt x="441" y="87"/>
                      </a:lnTo>
                      <a:lnTo>
                        <a:pt x="441" y="85"/>
                      </a:lnTo>
                      <a:lnTo>
                        <a:pt x="442" y="85"/>
                      </a:lnTo>
                      <a:lnTo>
                        <a:pt x="442" y="84"/>
                      </a:lnTo>
                      <a:lnTo>
                        <a:pt x="442" y="87"/>
                      </a:lnTo>
                      <a:lnTo>
                        <a:pt x="442" y="85"/>
                      </a:lnTo>
                      <a:lnTo>
                        <a:pt x="443" y="85"/>
                      </a:lnTo>
                      <a:lnTo>
                        <a:pt x="443" y="83"/>
                      </a:lnTo>
                      <a:lnTo>
                        <a:pt x="443" y="86"/>
                      </a:lnTo>
                      <a:lnTo>
                        <a:pt x="443" y="85"/>
                      </a:lnTo>
                      <a:lnTo>
                        <a:pt x="444" y="85"/>
                      </a:lnTo>
                      <a:lnTo>
                        <a:pt x="444" y="83"/>
                      </a:lnTo>
                      <a:lnTo>
                        <a:pt x="444" y="86"/>
                      </a:lnTo>
                      <a:lnTo>
                        <a:pt x="444" y="85"/>
                      </a:lnTo>
                      <a:lnTo>
                        <a:pt x="445" y="85"/>
                      </a:lnTo>
                      <a:lnTo>
                        <a:pt x="445" y="83"/>
                      </a:lnTo>
                      <a:lnTo>
                        <a:pt x="445" y="86"/>
                      </a:lnTo>
                      <a:lnTo>
                        <a:pt x="445" y="85"/>
                      </a:lnTo>
                      <a:lnTo>
                        <a:pt x="446" y="85"/>
                      </a:lnTo>
                      <a:lnTo>
                        <a:pt x="446" y="83"/>
                      </a:lnTo>
                      <a:lnTo>
                        <a:pt x="446" y="86"/>
                      </a:lnTo>
                      <a:lnTo>
                        <a:pt x="446" y="84"/>
                      </a:lnTo>
                      <a:lnTo>
                        <a:pt x="447" y="84"/>
                      </a:lnTo>
                      <a:lnTo>
                        <a:pt x="447" y="83"/>
                      </a:lnTo>
                      <a:lnTo>
                        <a:pt x="447" y="85"/>
                      </a:lnTo>
                      <a:lnTo>
                        <a:pt x="447" y="83"/>
                      </a:lnTo>
                      <a:lnTo>
                        <a:pt x="448" y="83"/>
                      </a:lnTo>
                      <a:lnTo>
                        <a:pt x="448" y="83"/>
                      </a:lnTo>
                      <a:lnTo>
                        <a:pt x="448" y="86"/>
                      </a:lnTo>
                      <a:lnTo>
                        <a:pt x="448" y="84"/>
                      </a:lnTo>
                      <a:lnTo>
                        <a:pt x="449" y="84"/>
                      </a:lnTo>
                      <a:lnTo>
                        <a:pt x="449" y="83"/>
                      </a:lnTo>
                      <a:lnTo>
                        <a:pt x="449" y="86"/>
                      </a:lnTo>
                      <a:lnTo>
                        <a:pt x="449" y="84"/>
                      </a:lnTo>
                      <a:lnTo>
                        <a:pt x="450" y="84"/>
                      </a:lnTo>
                      <a:lnTo>
                        <a:pt x="450" y="82"/>
                      </a:lnTo>
                      <a:lnTo>
                        <a:pt x="450" y="86"/>
                      </a:lnTo>
                      <a:lnTo>
                        <a:pt x="450" y="83"/>
                      </a:lnTo>
                      <a:lnTo>
                        <a:pt x="451" y="83"/>
                      </a:lnTo>
                      <a:lnTo>
                        <a:pt x="451" y="82"/>
                      </a:lnTo>
                      <a:lnTo>
                        <a:pt x="451" y="85"/>
                      </a:lnTo>
                      <a:lnTo>
                        <a:pt x="451" y="83"/>
                      </a:lnTo>
                      <a:lnTo>
                        <a:pt x="452" y="83"/>
                      </a:lnTo>
                      <a:lnTo>
                        <a:pt x="452" y="83"/>
                      </a:lnTo>
                      <a:lnTo>
                        <a:pt x="452" y="85"/>
                      </a:lnTo>
                      <a:lnTo>
                        <a:pt x="452" y="83"/>
                      </a:lnTo>
                      <a:lnTo>
                        <a:pt x="453" y="83"/>
                      </a:lnTo>
                      <a:lnTo>
                        <a:pt x="453" y="83"/>
                      </a:lnTo>
                      <a:lnTo>
                        <a:pt x="453" y="85"/>
                      </a:lnTo>
                      <a:lnTo>
                        <a:pt x="453" y="84"/>
                      </a:lnTo>
                      <a:lnTo>
                        <a:pt x="454" y="84"/>
                      </a:lnTo>
                      <a:lnTo>
                        <a:pt x="454" y="82"/>
                      </a:lnTo>
                      <a:lnTo>
                        <a:pt x="454" y="85"/>
                      </a:lnTo>
                      <a:lnTo>
                        <a:pt x="454" y="85"/>
                      </a:lnTo>
                      <a:lnTo>
                        <a:pt x="455" y="85"/>
                      </a:lnTo>
                      <a:lnTo>
                        <a:pt x="455" y="82"/>
                      </a:lnTo>
                      <a:lnTo>
                        <a:pt x="455" y="85"/>
                      </a:lnTo>
                      <a:lnTo>
                        <a:pt x="455" y="83"/>
                      </a:lnTo>
                      <a:lnTo>
                        <a:pt x="456" y="83"/>
                      </a:lnTo>
                      <a:lnTo>
                        <a:pt x="456" y="82"/>
                      </a:lnTo>
                      <a:lnTo>
                        <a:pt x="456" y="86"/>
                      </a:lnTo>
                      <a:lnTo>
                        <a:pt x="456" y="84"/>
                      </a:lnTo>
                      <a:lnTo>
                        <a:pt x="457" y="84"/>
                      </a:lnTo>
                      <a:lnTo>
                        <a:pt x="457" y="83"/>
                      </a:lnTo>
                      <a:lnTo>
                        <a:pt x="457" y="86"/>
                      </a:lnTo>
                      <a:lnTo>
                        <a:pt x="457" y="86"/>
                      </a:lnTo>
                      <a:lnTo>
                        <a:pt x="458" y="86"/>
                      </a:lnTo>
                      <a:lnTo>
                        <a:pt x="458" y="83"/>
                      </a:lnTo>
                      <a:lnTo>
                        <a:pt x="458" y="86"/>
                      </a:lnTo>
                      <a:lnTo>
                        <a:pt x="458" y="83"/>
                      </a:lnTo>
                      <a:lnTo>
                        <a:pt x="459" y="83"/>
                      </a:lnTo>
                      <a:lnTo>
                        <a:pt x="459" y="82"/>
                      </a:lnTo>
                      <a:lnTo>
                        <a:pt x="459" y="85"/>
                      </a:lnTo>
                      <a:lnTo>
                        <a:pt x="459" y="85"/>
                      </a:lnTo>
                      <a:lnTo>
                        <a:pt x="460" y="85"/>
                      </a:lnTo>
                      <a:lnTo>
                        <a:pt x="460" y="83"/>
                      </a:lnTo>
                      <a:lnTo>
                        <a:pt x="460" y="85"/>
                      </a:lnTo>
                      <a:lnTo>
                        <a:pt x="460" y="83"/>
                      </a:lnTo>
                      <a:lnTo>
                        <a:pt x="461" y="83"/>
                      </a:lnTo>
                      <a:lnTo>
                        <a:pt x="461" y="81"/>
                      </a:lnTo>
                      <a:lnTo>
                        <a:pt x="461" y="85"/>
                      </a:lnTo>
                      <a:lnTo>
                        <a:pt x="461" y="82"/>
                      </a:lnTo>
                      <a:lnTo>
                        <a:pt x="462" y="82"/>
                      </a:lnTo>
                      <a:lnTo>
                        <a:pt x="462" y="81"/>
                      </a:lnTo>
                      <a:lnTo>
                        <a:pt x="462" y="85"/>
                      </a:lnTo>
                      <a:lnTo>
                        <a:pt x="462" y="82"/>
                      </a:lnTo>
                      <a:lnTo>
                        <a:pt x="463" y="82"/>
                      </a:lnTo>
                      <a:lnTo>
                        <a:pt x="463" y="82"/>
                      </a:lnTo>
                      <a:lnTo>
                        <a:pt x="463" y="84"/>
                      </a:lnTo>
                      <a:lnTo>
                        <a:pt x="463" y="83"/>
                      </a:lnTo>
                      <a:lnTo>
                        <a:pt x="464" y="83"/>
                      </a:lnTo>
                      <a:lnTo>
                        <a:pt x="464" y="81"/>
                      </a:lnTo>
                      <a:lnTo>
                        <a:pt x="464" y="83"/>
                      </a:lnTo>
                      <a:lnTo>
                        <a:pt x="464" y="82"/>
                      </a:lnTo>
                      <a:lnTo>
                        <a:pt x="465" y="82"/>
                      </a:lnTo>
                      <a:lnTo>
                        <a:pt x="465" y="80"/>
                      </a:lnTo>
                      <a:lnTo>
                        <a:pt x="465" y="83"/>
                      </a:lnTo>
                      <a:lnTo>
                        <a:pt x="465" y="82"/>
                      </a:lnTo>
                      <a:lnTo>
                        <a:pt x="466" y="82"/>
                      </a:lnTo>
                      <a:lnTo>
                        <a:pt x="466" y="80"/>
                      </a:lnTo>
                      <a:lnTo>
                        <a:pt x="466" y="84"/>
                      </a:lnTo>
                      <a:lnTo>
                        <a:pt x="466" y="84"/>
                      </a:lnTo>
                      <a:lnTo>
                        <a:pt x="467" y="84"/>
                      </a:lnTo>
                      <a:lnTo>
                        <a:pt x="467" y="82"/>
                      </a:lnTo>
                      <a:lnTo>
                        <a:pt x="467" y="85"/>
                      </a:lnTo>
                      <a:lnTo>
                        <a:pt x="467" y="82"/>
                      </a:lnTo>
                      <a:lnTo>
                        <a:pt x="468" y="82"/>
                      </a:lnTo>
                      <a:lnTo>
                        <a:pt x="468" y="82"/>
                      </a:lnTo>
                      <a:lnTo>
                        <a:pt x="468" y="84"/>
                      </a:lnTo>
                      <a:lnTo>
                        <a:pt x="468" y="83"/>
                      </a:lnTo>
                      <a:lnTo>
                        <a:pt x="469" y="83"/>
                      </a:lnTo>
                      <a:lnTo>
                        <a:pt x="469" y="80"/>
                      </a:lnTo>
                      <a:lnTo>
                        <a:pt x="469" y="84"/>
                      </a:lnTo>
                      <a:lnTo>
                        <a:pt x="469" y="83"/>
                      </a:lnTo>
                      <a:lnTo>
                        <a:pt x="470" y="83"/>
                      </a:lnTo>
                      <a:lnTo>
                        <a:pt x="470" y="81"/>
                      </a:lnTo>
                      <a:lnTo>
                        <a:pt x="470" y="85"/>
                      </a:lnTo>
                      <a:lnTo>
                        <a:pt x="470" y="83"/>
                      </a:lnTo>
                      <a:lnTo>
                        <a:pt x="471" y="83"/>
                      </a:lnTo>
                      <a:lnTo>
                        <a:pt x="471" y="81"/>
                      </a:lnTo>
                      <a:lnTo>
                        <a:pt x="471" y="85"/>
                      </a:lnTo>
                      <a:lnTo>
                        <a:pt x="471" y="83"/>
                      </a:lnTo>
                      <a:lnTo>
                        <a:pt x="472" y="83"/>
                      </a:lnTo>
                      <a:lnTo>
                        <a:pt x="472" y="80"/>
                      </a:lnTo>
                      <a:lnTo>
                        <a:pt x="472" y="83"/>
                      </a:lnTo>
                      <a:lnTo>
                        <a:pt x="472" y="80"/>
                      </a:lnTo>
                      <a:lnTo>
                        <a:pt x="473" y="80"/>
                      </a:lnTo>
                      <a:lnTo>
                        <a:pt x="473" y="80"/>
                      </a:lnTo>
                      <a:lnTo>
                        <a:pt x="473" y="84"/>
                      </a:lnTo>
                      <a:lnTo>
                        <a:pt x="473" y="83"/>
                      </a:lnTo>
                      <a:lnTo>
                        <a:pt x="474" y="83"/>
                      </a:lnTo>
                      <a:lnTo>
                        <a:pt x="474" y="80"/>
                      </a:lnTo>
                      <a:lnTo>
                        <a:pt x="474" y="85"/>
                      </a:lnTo>
                      <a:lnTo>
                        <a:pt x="474" y="83"/>
                      </a:lnTo>
                      <a:lnTo>
                        <a:pt x="475" y="83"/>
                      </a:lnTo>
                      <a:lnTo>
                        <a:pt x="475" y="82"/>
                      </a:lnTo>
                      <a:lnTo>
                        <a:pt x="475" y="85"/>
                      </a:lnTo>
                      <a:lnTo>
                        <a:pt x="475" y="84"/>
                      </a:lnTo>
                      <a:lnTo>
                        <a:pt x="476" y="84"/>
                      </a:lnTo>
                      <a:lnTo>
                        <a:pt x="476" y="80"/>
                      </a:lnTo>
                      <a:lnTo>
                        <a:pt x="476" y="83"/>
                      </a:lnTo>
                      <a:lnTo>
                        <a:pt x="476" y="82"/>
                      </a:lnTo>
                      <a:lnTo>
                        <a:pt x="477" y="82"/>
                      </a:lnTo>
                      <a:lnTo>
                        <a:pt x="477" y="80"/>
                      </a:lnTo>
                      <a:lnTo>
                        <a:pt x="477" y="83"/>
                      </a:lnTo>
                      <a:lnTo>
                        <a:pt x="477" y="83"/>
                      </a:lnTo>
                      <a:lnTo>
                        <a:pt x="478" y="83"/>
                      </a:lnTo>
                      <a:lnTo>
                        <a:pt x="478" y="80"/>
                      </a:lnTo>
                      <a:lnTo>
                        <a:pt x="478" y="85"/>
                      </a:lnTo>
                      <a:lnTo>
                        <a:pt x="478" y="82"/>
                      </a:lnTo>
                      <a:lnTo>
                        <a:pt x="479" y="82"/>
                      </a:lnTo>
                      <a:lnTo>
                        <a:pt x="479" y="80"/>
                      </a:lnTo>
                      <a:lnTo>
                        <a:pt x="479" y="82"/>
                      </a:lnTo>
                      <a:lnTo>
                        <a:pt x="479" y="80"/>
                      </a:lnTo>
                      <a:lnTo>
                        <a:pt x="480" y="80"/>
                      </a:lnTo>
                      <a:lnTo>
                        <a:pt x="480" y="79"/>
                      </a:lnTo>
                      <a:lnTo>
                        <a:pt x="480" y="84"/>
                      </a:lnTo>
                      <a:lnTo>
                        <a:pt x="480" y="84"/>
                      </a:lnTo>
                      <a:lnTo>
                        <a:pt x="481" y="84"/>
                      </a:lnTo>
                      <a:lnTo>
                        <a:pt x="481" y="82"/>
                      </a:lnTo>
                      <a:lnTo>
                        <a:pt x="481" y="84"/>
                      </a:lnTo>
                      <a:lnTo>
                        <a:pt x="481" y="82"/>
                      </a:lnTo>
                      <a:lnTo>
                        <a:pt x="482" y="82"/>
                      </a:lnTo>
                      <a:lnTo>
                        <a:pt x="482" y="79"/>
                      </a:lnTo>
                      <a:lnTo>
                        <a:pt x="482" y="83"/>
                      </a:lnTo>
                      <a:lnTo>
                        <a:pt x="482" y="79"/>
                      </a:lnTo>
                      <a:lnTo>
                        <a:pt x="483" y="79"/>
                      </a:lnTo>
                      <a:lnTo>
                        <a:pt x="483" y="80"/>
                      </a:lnTo>
                      <a:lnTo>
                        <a:pt x="483" y="83"/>
                      </a:lnTo>
                      <a:lnTo>
                        <a:pt x="483" y="80"/>
                      </a:lnTo>
                      <a:lnTo>
                        <a:pt x="484" y="80"/>
                      </a:lnTo>
                      <a:lnTo>
                        <a:pt x="484" y="80"/>
                      </a:lnTo>
                      <a:lnTo>
                        <a:pt x="484" y="83"/>
                      </a:lnTo>
                      <a:lnTo>
                        <a:pt x="484" y="82"/>
                      </a:lnTo>
                      <a:lnTo>
                        <a:pt x="485" y="82"/>
                      </a:lnTo>
                      <a:lnTo>
                        <a:pt x="485" y="80"/>
                      </a:lnTo>
                      <a:lnTo>
                        <a:pt x="485" y="83"/>
                      </a:lnTo>
                      <a:lnTo>
                        <a:pt x="485" y="80"/>
                      </a:lnTo>
                      <a:lnTo>
                        <a:pt x="486" y="80"/>
                      </a:lnTo>
                      <a:lnTo>
                        <a:pt x="486" y="79"/>
                      </a:lnTo>
                      <a:lnTo>
                        <a:pt x="486" y="83"/>
                      </a:lnTo>
                      <a:lnTo>
                        <a:pt x="486" y="83"/>
                      </a:lnTo>
                      <a:lnTo>
                        <a:pt x="487" y="83"/>
                      </a:lnTo>
                      <a:lnTo>
                        <a:pt x="487" y="79"/>
                      </a:lnTo>
                      <a:lnTo>
                        <a:pt x="487" y="83"/>
                      </a:lnTo>
                      <a:lnTo>
                        <a:pt x="487" y="81"/>
                      </a:lnTo>
                      <a:lnTo>
                        <a:pt x="488" y="81"/>
                      </a:lnTo>
                      <a:lnTo>
                        <a:pt x="488" y="78"/>
                      </a:lnTo>
                      <a:lnTo>
                        <a:pt x="488" y="83"/>
                      </a:lnTo>
                      <a:lnTo>
                        <a:pt x="488" y="82"/>
                      </a:lnTo>
                      <a:lnTo>
                        <a:pt x="489" y="82"/>
                      </a:lnTo>
                      <a:lnTo>
                        <a:pt x="489" y="80"/>
                      </a:lnTo>
                      <a:lnTo>
                        <a:pt x="489" y="82"/>
                      </a:lnTo>
                      <a:lnTo>
                        <a:pt x="489" y="80"/>
                      </a:lnTo>
                      <a:lnTo>
                        <a:pt x="490" y="80"/>
                      </a:lnTo>
                      <a:lnTo>
                        <a:pt x="490" y="79"/>
                      </a:lnTo>
                      <a:lnTo>
                        <a:pt x="490" y="83"/>
                      </a:lnTo>
                      <a:lnTo>
                        <a:pt x="490" y="80"/>
                      </a:lnTo>
                      <a:lnTo>
                        <a:pt x="491" y="80"/>
                      </a:lnTo>
                      <a:lnTo>
                        <a:pt x="491" y="79"/>
                      </a:lnTo>
                      <a:lnTo>
                        <a:pt x="491" y="81"/>
                      </a:lnTo>
                      <a:lnTo>
                        <a:pt x="491" y="79"/>
                      </a:lnTo>
                      <a:lnTo>
                        <a:pt x="492" y="79"/>
                      </a:lnTo>
                      <a:lnTo>
                        <a:pt x="492" y="79"/>
                      </a:lnTo>
                      <a:lnTo>
                        <a:pt x="492" y="83"/>
                      </a:lnTo>
                      <a:lnTo>
                        <a:pt x="492" y="80"/>
                      </a:lnTo>
                      <a:lnTo>
                        <a:pt x="493" y="80"/>
                      </a:lnTo>
                      <a:lnTo>
                        <a:pt x="493" y="80"/>
                      </a:lnTo>
                      <a:lnTo>
                        <a:pt x="493" y="83"/>
                      </a:lnTo>
                      <a:lnTo>
                        <a:pt x="493" y="81"/>
                      </a:lnTo>
                      <a:lnTo>
                        <a:pt x="494" y="81"/>
                      </a:lnTo>
                      <a:lnTo>
                        <a:pt x="494" y="79"/>
                      </a:lnTo>
                      <a:lnTo>
                        <a:pt x="494" y="83"/>
                      </a:lnTo>
                      <a:lnTo>
                        <a:pt x="494" y="80"/>
                      </a:lnTo>
                      <a:lnTo>
                        <a:pt x="495" y="80"/>
                      </a:lnTo>
                      <a:lnTo>
                        <a:pt x="495" y="79"/>
                      </a:lnTo>
                      <a:lnTo>
                        <a:pt x="495" y="83"/>
                      </a:lnTo>
                      <a:lnTo>
                        <a:pt x="495" y="82"/>
                      </a:lnTo>
                      <a:lnTo>
                        <a:pt x="496" y="82"/>
                      </a:lnTo>
                      <a:lnTo>
                        <a:pt x="496" y="79"/>
                      </a:lnTo>
                      <a:lnTo>
                        <a:pt x="496" y="82"/>
                      </a:lnTo>
                      <a:lnTo>
                        <a:pt x="496" y="80"/>
                      </a:lnTo>
                      <a:lnTo>
                        <a:pt x="497" y="80"/>
                      </a:lnTo>
                      <a:lnTo>
                        <a:pt x="497" y="77"/>
                      </a:lnTo>
                      <a:lnTo>
                        <a:pt x="497" y="80"/>
                      </a:lnTo>
                      <a:lnTo>
                        <a:pt x="497" y="80"/>
                      </a:lnTo>
                      <a:lnTo>
                        <a:pt x="498" y="80"/>
                      </a:lnTo>
                      <a:lnTo>
                        <a:pt x="498" y="78"/>
                      </a:lnTo>
                      <a:lnTo>
                        <a:pt x="498" y="81"/>
                      </a:lnTo>
                      <a:lnTo>
                        <a:pt x="498" y="80"/>
                      </a:lnTo>
                      <a:lnTo>
                        <a:pt x="499" y="80"/>
                      </a:lnTo>
                      <a:lnTo>
                        <a:pt x="499" y="79"/>
                      </a:lnTo>
                      <a:lnTo>
                        <a:pt x="499" y="83"/>
                      </a:lnTo>
                      <a:lnTo>
                        <a:pt x="499" y="81"/>
                      </a:lnTo>
                      <a:lnTo>
                        <a:pt x="500" y="81"/>
                      </a:lnTo>
                      <a:lnTo>
                        <a:pt x="500" y="79"/>
                      </a:lnTo>
                      <a:lnTo>
                        <a:pt x="500" y="82"/>
                      </a:lnTo>
                      <a:lnTo>
                        <a:pt x="500" y="80"/>
                      </a:lnTo>
                      <a:lnTo>
                        <a:pt x="501" y="80"/>
                      </a:lnTo>
                      <a:lnTo>
                        <a:pt x="501" y="79"/>
                      </a:lnTo>
                      <a:lnTo>
                        <a:pt x="501" y="82"/>
                      </a:lnTo>
                      <a:lnTo>
                        <a:pt x="501" y="80"/>
                      </a:lnTo>
                      <a:lnTo>
                        <a:pt x="502" y="80"/>
                      </a:lnTo>
                      <a:lnTo>
                        <a:pt x="502" y="79"/>
                      </a:lnTo>
                      <a:lnTo>
                        <a:pt x="502" y="83"/>
                      </a:lnTo>
                      <a:lnTo>
                        <a:pt x="502" y="82"/>
                      </a:lnTo>
                      <a:lnTo>
                        <a:pt x="503" y="82"/>
                      </a:lnTo>
                      <a:lnTo>
                        <a:pt x="503" y="80"/>
                      </a:lnTo>
                      <a:lnTo>
                        <a:pt x="503" y="83"/>
                      </a:lnTo>
                      <a:lnTo>
                        <a:pt x="503" y="82"/>
                      </a:lnTo>
                      <a:lnTo>
                        <a:pt x="504" y="82"/>
                      </a:lnTo>
                      <a:lnTo>
                        <a:pt x="504" y="80"/>
                      </a:lnTo>
                      <a:lnTo>
                        <a:pt x="504" y="83"/>
                      </a:lnTo>
                      <a:lnTo>
                        <a:pt x="504" y="82"/>
                      </a:lnTo>
                      <a:lnTo>
                        <a:pt x="505" y="82"/>
                      </a:lnTo>
                      <a:lnTo>
                        <a:pt x="505" y="79"/>
                      </a:lnTo>
                      <a:lnTo>
                        <a:pt x="505" y="83"/>
                      </a:lnTo>
                      <a:lnTo>
                        <a:pt x="505" y="82"/>
                      </a:lnTo>
                      <a:lnTo>
                        <a:pt x="506" y="82"/>
                      </a:lnTo>
                      <a:lnTo>
                        <a:pt x="506" y="79"/>
                      </a:lnTo>
                      <a:lnTo>
                        <a:pt x="506" y="83"/>
                      </a:lnTo>
                      <a:lnTo>
                        <a:pt x="506" y="82"/>
                      </a:lnTo>
                      <a:lnTo>
                        <a:pt x="507" y="82"/>
                      </a:lnTo>
                      <a:lnTo>
                        <a:pt x="507" y="81"/>
                      </a:lnTo>
                      <a:lnTo>
                        <a:pt x="507" y="83"/>
                      </a:lnTo>
                      <a:lnTo>
                        <a:pt x="507" y="82"/>
                      </a:lnTo>
                      <a:lnTo>
                        <a:pt x="508" y="82"/>
                      </a:lnTo>
                      <a:lnTo>
                        <a:pt x="508" y="79"/>
                      </a:lnTo>
                      <a:lnTo>
                        <a:pt x="508" y="83"/>
                      </a:lnTo>
                      <a:lnTo>
                        <a:pt x="508" y="81"/>
                      </a:lnTo>
                      <a:lnTo>
                        <a:pt x="509" y="81"/>
                      </a:lnTo>
                      <a:lnTo>
                        <a:pt x="509" y="79"/>
                      </a:lnTo>
                      <a:lnTo>
                        <a:pt x="509" y="82"/>
                      </a:lnTo>
                      <a:lnTo>
                        <a:pt x="509" y="80"/>
                      </a:lnTo>
                      <a:lnTo>
                        <a:pt x="510" y="80"/>
                      </a:lnTo>
                      <a:lnTo>
                        <a:pt x="510" y="79"/>
                      </a:lnTo>
                      <a:lnTo>
                        <a:pt x="510" y="83"/>
                      </a:lnTo>
                      <a:lnTo>
                        <a:pt x="510" y="81"/>
                      </a:lnTo>
                      <a:lnTo>
                        <a:pt x="511" y="81"/>
                      </a:lnTo>
                      <a:lnTo>
                        <a:pt x="511" y="80"/>
                      </a:lnTo>
                      <a:lnTo>
                        <a:pt x="511" y="83"/>
                      </a:lnTo>
                      <a:lnTo>
                        <a:pt x="511" y="81"/>
                      </a:lnTo>
                      <a:lnTo>
                        <a:pt x="512" y="81"/>
                      </a:lnTo>
                      <a:lnTo>
                        <a:pt x="512" y="79"/>
                      </a:lnTo>
                      <a:lnTo>
                        <a:pt x="512" y="83"/>
                      </a:lnTo>
                      <a:lnTo>
                        <a:pt x="512" y="83"/>
                      </a:lnTo>
                      <a:lnTo>
                        <a:pt x="513" y="83"/>
                      </a:lnTo>
                      <a:lnTo>
                        <a:pt x="513" y="81"/>
                      </a:lnTo>
                      <a:lnTo>
                        <a:pt x="513" y="85"/>
                      </a:lnTo>
                      <a:lnTo>
                        <a:pt x="513" y="83"/>
                      </a:lnTo>
                      <a:lnTo>
                        <a:pt x="514" y="83"/>
                      </a:lnTo>
                      <a:lnTo>
                        <a:pt x="514" y="80"/>
                      </a:lnTo>
                      <a:lnTo>
                        <a:pt x="514" y="83"/>
                      </a:lnTo>
                      <a:lnTo>
                        <a:pt x="514" y="82"/>
                      </a:lnTo>
                      <a:lnTo>
                        <a:pt x="515" y="82"/>
                      </a:lnTo>
                      <a:lnTo>
                        <a:pt x="515" y="80"/>
                      </a:lnTo>
                      <a:lnTo>
                        <a:pt x="515" y="83"/>
                      </a:lnTo>
                      <a:lnTo>
                        <a:pt x="515" y="82"/>
                      </a:lnTo>
                      <a:lnTo>
                        <a:pt x="516" y="82"/>
                      </a:lnTo>
                      <a:lnTo>
                        <a:pt x="516" y="82"/>
                      </a:lnTo>
                      <a:lnTo>
                        <a:pt x="516" y="85"/>
                      </a:lnTo>
                      <a:lnTo>
                        <a:pt x="516" y="82"/>
                      </a:lnTo>
                      <a:lnTo>
                        <a:pt x="517" y="82"/>
                      </a:lnTo>
                      <a:lnTo>
                        <a:pt x="517" y="82"/>
                      </a:lnTo>
                      <a:lnTo>
                        <a:pt x="517" y="85"/>
                      </a:lnTo>
                      <a:lnTo>
                        <a:pt x="517" y="83"/>
                      </a:lnTo>
                      <a:lnTo>
                        <a:pt x="518" y="83"/>
                      </a:lnTo>
                      <a:lnTo>
                        <a:pt x="518" y="80"/>
                      </a:lnTo>
                      <a:lnTo>
                        <a:pt x="518" y="85"/>
                      </a:lnTo>
                      <a:lnTo>
                        <a:pt x="518" y="82"/>
                      </a:lnTo>
                      <a:lnTo>
                        <a:pt x="519" y="82"/>
                      </a:lnTo>
                      <a:lnTo>
                        <a:pt x="519" y="80"/>
                      </a:lnTo>
                      <a:lnTo>
                        <a:pt x="519" y="84"/>
                      </a:lnTo>
                      <a:lnTo>
                        <a:pt x="519" y="83"/>
                      </a:lnTo>
                      <a:lnTo>
                        <a:pt x="520" y="83"/>
                      </a:lnTo>
                      <a:lnTo>
                        <a:pt x="520" y="82"/>
                      </a:lnTo>
                      <a:lnTo>
                        <a:pt x="520" y="85"/>
                      </a:lnTo>
                      <a:lnTo>
                        <a:pt x="520" y="85"/>
                      </a:lnTo>
                      <a:lnTo>
                        <a:pt x="521" y="85"/>
                      </a:lnTo>
                      <a:lnTo>
                        <a:pt x="521" y="82"/>
                      </a:lnTo>
                      <a:lnTo>
                        <a:pt x="521" y="85"/>
                      </a:lnTo>
                      <a:lnTo>
                        <a:pt x="521" y="82"/>
                      </a:lnTo>
                      <a:lnTo>
                        <a:pt x="522" y="82"/>
                      </a:lnTo>
                      <a:lnTo>
                        <a:pt x="522" y="80"/>
                      </a:lnTo>
                      <a:lnTo>
                        <a:pt x="522" y="83"/>
                      </a:lnTo>
                      <a:lnTo>
                        <a:pt x="522" y="82"/>
                      </a:lnTo>
                      <a:lnTo>
                        <a:pt x="523" y="82"/>
                      </a:lnTo>
                      <a:lnTo>
                        <a:pt x="523" y="80"/>
                      </a:lnTo>
                      <a:lnTo>
                        <a:pt x="523" y="83"/>
                      </a:lnTo>
                      <a:lnTo>
                        <a:pt x="523" y="80"/>
                      </a:lnTo>
                      <a:lnTo>
                        <a:pt x="524" y="80"/>
                      </a:lnTo>
                      <a:lnTo>
                        <a:pt x="524" y="80"/>
                      </a:lnTo>
                      <a:lnTo>
                        <a:pt x="524" y="84"/>
                      </a:lnTo>
                      <a:lnTo>
                        <a:pt x="524" y="81"/>
                      </a:lnTo>
                      <a:lnTo>
                        <a:pt x="525" y="81"/>
                      </a:lnTo>
                      <a:lnTo>
                        <a:pt x="525" y="82"/>
                      </a:lnTo>
                      <a:lnTo>
                        <a:pt x="525" y="83"/>
                      </a:lnTo>
                      <a:lnTo>
                        <a:pt x="525" y="82"/>
                      </a:lnTo>
                      <a:lnTo>
                        <a:pt x="526" y="82"/>
                      </a:lnTo>
                      <a:lnTo>
                        <a:pt x="526" y="80"/>
                      </a:lnTo>
                      <a:lnTo>
                        <a:pt x="526" y="83"/>
                      </a:lnTo>
                      <a:lnTo>
                        <a:pt x="526" y="80"/>
                      </a:lnTo>
                      <a:lnTo>
                        <a:pt x="527" y="80"/>
                      </a:lnTo>
                      <a:lnTo>
                        <a:pt x="527" y="80"/>
                      </a:lnTo>
                      <a:lnTo>
                        <a:pt x="527" y="82"/>
                      </a:lnTo>
                      <a:lnTo>
                        <a:pt x="527" y="80"/>
                      </a:lnTo>
                      <a:lnTo>
                        <a:pt x="528" y="80"/>
                      </a:lnTo>
                      <a:lnTo>
                        <a:pt x="528" y="80"/>
                      </a:lnTo>
                      <a:lnTo>
                        <a:pt x="528" y="83"/>
                      </a:lnTo>
                      <a:lnTo>
                        <a:pt x="528" y="83"/>
                      </a:lnTo>
                      <a:lnTo>
                        <a:pt x="529" y="83"/>
                      </a:lnTo>
                      <a:lnTo>
                        <a:pt x="529" y="80"/>
                      </a:lnTo>
                      <a:lnTo>
                        <a:pt x="529" y="84"/>
                      </a:lnTo>
                      <a:lnTo>
                        <a:pt x="529" y="83"/>
                      </a:lnTo>
                      <a:lnTo>
                        <a:pt x="530" y="83"/>
                      </a:lnTo>
                      <a:lnTo>
                        <a:pt x="530" y="80"/>
                      </a:lnTo>
                      <a:lnTo>
                        <a:pt x="530" y="83"/>
                      </a:lnTo>
                      <a:lnTo>
                        <a:pt x="530" y="83"/>
                      </a:lnTo>
                      <a:lnTo>
                        <a:pt x="531" y="83"/>
                      </a:lnTo>
                      <a:lnTo>
                        <a:pt x="531" y="82"/>
                      </a:lnTo>
                      <a:lnTo>
                        <a:pt x="531" y="85"/>
                      </a:lnTo>
                      <a:lnTo>
                        <a:pt x="531" y="83"/>
                      </a:lnTo>
                      <a:lnTo>
                        <a:pt x="532" y="83"/>
                      </a:lnTo>
                      <a:lnTo>
                        <a:pt x="532" y="80"/>
                      </a:lnTo>
                      <a:lnTo>
                        <a:pt x="532" y="83"/>
                      </a:lnTo>
                      <a:lnTo>
                        <a:pt x="532" y="80"/>
                      </a:lnTo>
                      <a:lnTo>
                        <a:pt x="533" y="80"/>
                      </a:lnTo>
                      <a:lnTo>
                        <a:pt x="533" y="80"/>
                      </a:lnTo>
                      <a:lnTo>
                        <a:pt x="533" y="83"/>
                      </a:lnTo>
                      <a:lnTo>
                        <a:pt x="533" y="80"/>
                      </a:lnTo>
                      <a:lnTo>
                        <a:pt x="534" y="80"/>
                      </a:lnTo>
                      <a:lnTo>
                        <a:pt x="534" y="80"/>
                      </a:lnTo>
                      <a:lnTo>
                        <a:pt x="534" y="83"/>
                      </a:lnTo>
                      <a:lnTo>
                        <a:pt x="534" y="82"/>
                      </a:lnTo>
                      <a:lnTo>
                        <a:pt x="535" y="82"/>
                      </a:lnTo>
                      <a:lnTo>
                        <a:pt x="535" y="80"/>
                      </a:lnTo>
                      <a:lnTo>
                        <a:pt x="535" y="84"/>
                      </a:lnTo>
                      <a:lnTo>
                        <a:pt x="535" y="83"/>
                      </a:lnTo>
                      <a:lnTo>
                        <a:pt x="536" y="83"/>
                      </a:lnTo>
                      <a:lnTo>
                        <a:pt x="536" y="79"/>
                      </a:lnTo>
                      <a:lnTo>
                        <a:pt x="536" y="83"/>
                      </a:lnTo>
                      <a:lnTo>
                        <a:pt x="536" y="83"/>
                      </a:lnTo>
                      <a:lnTo>
                        <a:pt x="537" y="83"/>
                      </a:lnTo>
                      <a:lnTo>
                        <a:pt x="537" y="80"/>
                      </a:lnTo>
                      <a:lnTo>
                        <a:pt x="537" y="83"/>
                      </a:lnTo>
                      <a:lnTo>
                        <a:pt x="537" y="83"/>
                      </a:lnTo>
                      <a:lnTo>
                        <a:pt x="538" y="83"/>
                      </a:lnTo>
                      <a:lnTo>
                        <a:pt x="538" y="80"/>
                      </a:lnTo>
                      <a:lnTo>
                        <a:pt x="538" y="84"/>
                      </a:lnTo>
                      <a:lnTo>
                        <a:pt x="538" y="82"/>
                      </a:lnTo>
                      <a:lnTo>
                        <a:pt x="539" y="82"/>
                      </a:lnTo>
                      <a:lnTo>
                        <a:pt x="539" y="80"/>
                      </a:lnTo>
                      <a:lnTo>
                        <a:pt x="539" y="84"/>
                      </a:lnTo>
                      <a:lnTo>
                        <a:pt x="539" y="82"/>
                      </a:lnTo>
                      <a:lnTo>
                        <a:pt x="540" y="82"/>
                      </a:lnTo>
                      <a:lnTo>
                        <a:pt x="540" y="80"/>
                      </a:lnTo>
                      <a:lnTo>
                        <a:pt x="540" y="85"/>
                      </a:lnTo>
                      <a:lnTo>
                        <a:pt x="540" y="82"/>
                      </a:lnTo>
                      <a:lnTo>
                        <a:pt x="541" y="82"/>
                      </a:lnTo>
                      <a:lnTo>
                        <a:pt x="541" y="82"/>
                      </a:lnTo>
                      <a:lnTo>
                        <a:pt x="541" y="85"/>
                      </a:lnTo>
                      <a:lnTo>
                        <a:pt x="541" y="82"/>
                      </a:lnTo>
                      <a:lnTo>
                        <a:pt x="542" y="82"/>
                      </a:lnTo>
                      <a:lnTo>
                        <a:pt x="542" y="81"/>
                      </a:lnTo>
                      <a:lnTo>
                        <a:pt x="542" y="85"/>
                      </a:lnTo>
                      <a:lnTo>
                        <a:pt x="542" y="85"/>
                      </a:lnTo>
                      <a:lnTo>
                        <a:pt x="543" y="85"/>
                      </a:lnTo>
                      <a:lnTo>
                        <a:pt x="543" y="81"/>
                      </a:lnTo>
                      <a:lnTo>
                        <a:pt x="543" y="85"/>
                      </a:lnTo>
                      <a:lnTo>
                        <a:pt x="543" y="84"/>
                      </a:lnTo>
                      <a:lnTo>
                        <a:pt x="544" y="84"/>
                      </a:lnTo>
                      <a:lnTo>
                        <a:pt x="544" y="81"/>
                      </a:lnTo>
                      <a:lnTo>
                        <a:pt x="544" y="83"/>
                      </a:lnTo>
                      <a:lnTo>
                        <a:pt x="544" y="83"/>
                      </a:lnTo>
                      <a:lnTo>
                        <a:pt x="545" y="83"/>
                      </a:lnTo>
                      <a:lnTo>
                        <a:pt x="545" y="80"/>
                      </a:lnTo>
                      <a:lnTo>
                        <a:pt x="545" y="84"/>
                      </a:lnTo>
                      <a:lnTo>
                        <a:pt x="545" y="82"/>
                      </a:lnTo>
                      <a:lnTo>
                        <a:pt x="546" y="82"/>
                      </a:lnTo>
                      <a:lnTo>
                        <a:pt x="546" y="82"/>
                      </a:lnTo>
                      <a:lnTo>
                        <a:pt x="546" y="85"/>
                      </a:lnTo>
                      <a:lnTo>
                        <a:pt x="546" y="83"/>
                      </a:lnTo>
                      <a:lnTo>
                        <a:pt x="547" y="83"/>
                      </a:lnTo>
                      <a:lnTo>
                        <a:pt x="547" y="82"/>
                      </a:lnTo>
                      <a:lnTo>
                        <a:pt x="547" y="85"/>
                      </a:lnTo>
                      <a:lnTo>
                        <a:pt x="547" y="82"/>
                      </a:lnTo>
                      <a:lnTo>
                        <a:pt x="548" y="82"/>
                      </a:lnTo>
                      <a:lnTo>
                        <a:pt x="548" y="82"/>
                      </a:lnTo>
                      <a:lnTo>
                        <a:pt x="548" y="85"/>
                      </a:lnTo>
                      <a:lnTo>
                        <a:pt x="548" y="83"/>
                      </a:lnTo>
                      <a:lnTo>
                        <a:pt x="549" y="83"/>
                      </a:lnTo>
                      <a:lnTo>
                        <a:pt x="549" y="82"/>
                      </a:lnTo>
                      <a:lnTo>
                        <a:pt x="549" y="85"/>
                      </a:lnTo>
                      <a:lnTo>
                        <a:pt x="549" y="82"/>
                      </a:lnTo>
                      <a:lnTo>
                        <a:pt x="550" y="82"/>
                      </a:lnTo>
                      <a:lnTo>
                        <a:pt x="550" y="82"/>
                      </a:lnTo>
                      <a:lnTo>
                        <a:pt x="550" y="84"/>
                      </a:lnTo>
                      <a:lnTo>
                        <a:pt x="550" y="82"/>
                      </a:lnTo>
                      <a:lnTo>
                        <a:pt x="551" y="82"/>
                      </a:lnTo>
                      <a:lnTo>
                        <a:pt x="551" y="80"/>
                      </a:lnTo>
                      <a:lnTo>
                        <a:pt x="551" y="85"/>
                      </a:lnTo>
                      <a:lnTo>
                        <a:pt x="551" y="83"/>
                      </a:lnTo>
                      <a:lnTo>
                        <a:pt x="552" y="83"/>
                      </a:lnTo>
                      <a:lnTo>
                        <a:pt x="552" y="81"/>
                      </a:lnTo>
                      <a:lnTo>
                        <a:pt x="552" y="85"/>
                      </a:lnTo>
                      <a:lnTo>
                        <a:pt x="552" y="83"/>
                      </a:lnTo>
                      <a:lnTo>
                        <a:pt x="553" y="83"/>
                      </a:lnTo>
                      <a:lnTo>
                        <a:pt x="553" y="82"/>
                      </a:lnTo>
                      <a:lnTo>
                        <a:pt x="553" y="85"/>
                      </a:lnTo>
                      <a:lnTo>
                        <a:pt x="553" y="83"/>
                      </a:lnTo>
                      <a:lnTo>
                        <a:pt x="554" y="83"/>
                      </a:lnTo>
                      <a:lnTo>
                        <a:pt x="554" y="81"/>
                      </a:lnTo>
                      <a:lnTo>
                        <a:pt x="554" y="83"/>
                      </a:lnTo>
                      <a:lnTo>
                        <a:pt x="554" y="83"/>
                      </a:lnTo>
                      <a:lnTo>
                        <a:pt x="555" y="83"/>
                      </a:lnTo>
                      <a:lnTo>
                        <a:pt x="555" y="80"/>
                      </a:lnTo>
                      <a:lnTo>
                        <a:pt x="555" y="85"/>
                      </a:lnTo>
                      <a:lnTo>
                        <a:pt x="555" y="83"/>
                      </a:lnTo>
                      <a:lnTo>
                        <a:pt x="556" y="83"/>
                      </a:lnTo>
                      <a:lnTo>
                        <a:pt x="556" y="82"/>
                      </a:lnTo>
                      <a:lnTo>
                        <a:pt x="556" y="85"/>
                      </a:lnTo>
                      <a:lnTo>
                        <a:pt x="556" y="83"/>
                      </a:lnTo>
                      <a:lnTo>
                        <a:pt x="557" y="83"/>
                      </a:lnTo>
                      <a:lnTo>
                        <a:pt x="557" y="82"/>
                      </a:lnTo>
                      <a:lnTo>
                        <a:pt x="557" y="84"/>
                      </a:lnTo>
                      <a:lnTo>
                        <a:pt x="557" y="82"/>
                      </a:lnTo>
                      <a:lnTo>
                        <a:pt x="558" y="82"/>
                      </a:lnTo>
                      <a:lnTo>
                        <a:pt x="558" y="81"/>
                      </a:lnTo>
                      <a:lnTo>
                        <a:pt x="558" y="84"/>
                      </a:lnTo>
                      <a:lnTo>
                        <a:pt x="558" y="81"/>
                      </a:lnTo>
                      <a:lnTo>
                        <a:pt x="559" y="81"/>
                      </a:lnTo>
                      <a:lnTo>
                        <a:pt x="559" y="80"/>
                      </a:lnTo>
                      <a:lnTo>
                        <a:pt x="559" y="83"/>
                      </a:lnTo>
                      <a:lnTo>
                        <a:pt x="559" y="82"/>
                      </a:lnTo>
                      <a:lnTo>
                        <a:pt x="560" y="82"/>
                      </a:lnTo>
                      <a:lnTo>
                        <a:pt x="560" y="82"/>
                      </a:lnTo>
                      <a:lnTo>
                        <a:pt x="560" y="84"/>
                      </a:lnTo>
                      <a:lnTo>
                        <a:pt x="560" y="83"/>
                      </a:lnTo>
                      <a:lnTo>
                        <a:pt x="561" y="83"/>
                      </a:lnTo>
                      <a:lnTo>
                        <a:pt x="561" y="82"/>
                      </a:lnTo>
                      <a:lnTo>
                        <a:pt x="561" y="83"/>
                      </a:lnTo>
                      <a:lnTo>
                        <a:pt x="561" y="83"/>
                      </a:lnTo>
                      <a:lnTo>
                        <a:pt x="562" y="83"/>
                      </a:lnTo>
                      <a:lnTo>
                        <a:pt x="562" y="80"/>
                      </a:lnTo>
                      <a:lnTo>
                        <a:pt x="562" y="83"/>
                      </a:lnTo>
                      <a:lnTo>
                        <a:pt x="562" y="80"/>
                      </a:lnTo>
                      <a:lnTo>
                        <a:pt x="563" y="80"/>
                      </a:lnTo>
                      <a:lnTo>
                        <a:pt x="563" y="78"/>
                      </a:lnTo>
                      <a:lnTo>
                        <a:pt x="563" y="81"/>
                      </a:lnTo>
                      <a:lnTo>
                        <a:pt x="563" y="80"/>
                      </a:lnTo>
                      <a:lnTo>
                        <a:pt x="564" y="80"/>
                      </a:lnTo>
                      <a:lnTo>
                        <a:pt x="564" y="79"/>
                      </a:lnTo>
                      <a:lnTo>
                        <a:pt x="564" y="84"/>
                      </a:lnTo>
                      <a:lnTo>
                        <a:pt x="564" y="81"/>
                      </a:lnTo>
                      <a:lnTo>
                        <a:pt x="565" y="81"/>
                      </a:lnTo>
                      <a:lnTo>
                        <a:pt x="565" y="80"/>
                      </a:lnTo>
                      <a:lnTo>
                        <a:pt x="565" y="83"/>
                      </a:lnTo>
                      <a:lnTo>
                        <a:pt x="565" y="82"/>
                      </a:lnTo>
                      <a:lnTo>
                        <a:pt x="566" y="82"/>
                      </a:lnTo>
                      <a:lnTo>
                        <a:pt x="566" y="79"/>
                      </a:lnTo>
                      <a:lnTo>
                        <a:pt x="566" y="83"/>
                      </a:lnTo>
                      <a:lnTo>
                        <a:pt x="566" y="80"/>
                      </a:lnTo>
                      <a:lnTo>
                        <a:pt x="567" y="80"/>
                      </a:lnTo>
                      <a:lnTo>
                        <a:pt x="567" y="80"/>
                      </a:lnTo>
                      <a:lnTo>
                        <a:pt x="567" y="83"/>
                      </a:lnTo>
                      <a:lnTo>
                        <a:pt x="567" y="80"/>
                      </a:lnTo>
                      <a:lnTo>
                        <a:pt x="568" y="80"/>
                      </a:lnTo>
                      <a:lnTo>
                        <a:pt x="568" y="79"/>
                      </a:lnTo>
                      <a:lnTo>
                        <a:pt x="568" y="82"/>
                      </a:lnTo>
                      <a:lnTo>
                        <a:pt x="568" y="82"/>
                      </a:lnTo>
                      <a:lnTo>
                        <a:pt x="569" y="82"/>
                      </a:lnTo>
                      <a:lnTo>
                        <a:pt x="569" y="80"/>
                      </a:lnTo>
                      <a:lnTo>
                        <a:pt x="569" y="83"/>
                      </a:lnTo>
                      <a:lnTo>
                        <a:pt x="569" y="82"/>
                      </a:lnTo>
                      <a:lnTo>
                        <a:pt x="570" y="82"/>
                      </a:lnTo>
                      <a:lnTo>
                        <a:pt x="570" y="82"/>
                      </a:lnTo>
                      <a:lnTo>
                        <a:pt x="570" y="85"/>
                      </a:lnTo>
                      <a:lnTo>
                        <a:pt x="570" y="82"/>
                      </a:lnTo>
                      <a:lnTo>
                        <a:pt x="571" y="82"/>
                      </a:lnTo>
                      <a:lnTo>
                        <a:pt x="571" y="79"/>
                      </a:lnTo>
                      <a:lnTo>
                        <a:pt x="571" y="82"/>
                      </a:lnTo>
                      <a:lnTo>
                        <a:pt x="571" y="79"/>
                      </a:lnTo>
                      <a:lnTo>
                        <a:pt x="572" y="79"/>
                      </a:lnTo>
                      <a:lnTo>
                        <a:pt x="572" y="79"/>
                      </a:lnTo>
                      <a:lnTo>
                        <a:pt x="572" y="82"/>
                      </a:lnTo>
                      <a:lnTo>
                        <a:pt x="572" y="79"/>
                      </a:lnTo>
                      <a:lnTo>
                        <a:pt x="573" y="79"/>
                      </a:lnTo>
                      <a:lnTo>
                        <a:pt x="573" y="79"/>
                      </a:lnTo>
                      <a:lnTo>
                        <a:pt x="573" y="83"/>
                      </a:lnTo>
                      <a:lnTo>
                        <a:pt x="573" y="82"/>
                      </a:lnTo>
                      <a:lnTo>
                        <a:pt x="574" y="82"/>
                      </a:lnTo>
                      <a:lnTo>
                        <a:pt x="574" y="79"/>
                      </a:lnTo>
                      <a:lnTo>
                        <a:pt x="574" y="83"/>
                      </a:lnTo>
                      <a:lnTo>
                        <a:pt x="574" y="82"/>
                      </a:lnTo>
                      <a:lnTo>
                        <a:pt x="575" y="82"/>
                      </a:lnTo>
                      <a:lnTo>
                        <a:pt x="575" y="80"/>
                      </a:lnTo>
                      <a:lnTo>
                        <a:pt x="575" y="83"/>
                      </a:lnTo>
                      <a:lnTo>
                        <a:pt x="575" y="83"/>
                      </a:lnTo>
                      <a:lnTo>
                        <a:pt x="576" y="83"/>
                      </a:lnTo>
                      <a:lnTo>
                        <a:pt x="576" y="79"/>
                      </a:lnTo>
                      <a:lnTo>
                        <a:pt x="576" y="83"/>
                      </a:lnTo>
                      <a:lnTo>
                        <a:pt x="576" y="80"/>
                      </a:lnTo>
                      <a:lnTo>
                        <a:pt x="577" y="80"/>
                      </a:lnTo>
                      <a:lnTo>
                        <a:pt x="577" y="79"/>
                      </a:lnTo>
                      <a:lnTo>
                        <a:pt x="577" y="83"/>
                      </a:lnTo>
                      <a:lnTo>
                        <a:pt x="577" y="83"/>
                      </a:lnTo>
                      <a:lnTo>
                        <a:pt x="578" y="83"/>
                      </a:lnTo>
                      <a:lnTo>
                        <a:pt x="578" y="80"/>
                      </a:lnTo>
                      <a:lnTo>
                        <a:pt x="578" y="83"/>
                      </a:lnTo>
                      <a:lnTo>
                        <a:pt x="578" y="83"/>
                      </a:lnTo>
                      <a:lnTo>
                        <a:pt x="579" y="83"/>
                      </a:lnTo>
                      <a:lnTo>
                        <a:pt x="579" y="81"/>
                      </a:lnTo>
                      <a:lnTo>
                        <a:pt x="579" y="84"/>
                      </a:lnTo>
                      <a:lnTo>
                        <a:pt x="579" y="83"/>
                      </a:lnTo>
                      <a:lnTo>
                        <a:pt x="580" y="83"/>
                      </a:lnTo>
                      <a:lnTo>
                        <a:pt x="580" y="79"/>
                      </a:lnTo>
                      <a:lnTo>
                        <a:pt x="580" y="83"/>
                      </a:lnTo>
                      <a:lnTo>
                        <a:pt x="580" y="79"/>
                      </a:lnTo>
                      <a:lnTo>
                        <a:pt x="581" y="79"/>
                      </a:lnTo>
                      <a:lnTo>
                        <a:pt x="581" y="79"/>
                      </a:lnTo>
                      <a:lnTo>
                        <a:pt x="581" y="83"/>
                      </a:lnTo>
                      <a:lnTo>
                        <a:pt x="581" y="80"/>
                      </a:lnTo>
                      <a:lnTo>
                        <a:pt x="582" y="80"/>
                      </a:lnTo>
                      <a:lnTo>
                        <a:pt x="582" y="79"/>
                      </a:lnTo>
                      <a:lnTo>
                        <a:pt x="582" y="83"/>
                      </a:lnTo>
                      <a:lnTo>
                        <a:pt x="582" y="80"/>
                      </a:lnTo>
                      <a:lnTo>
                        <a:pt x="583" y="80"/>
                      </a:lnTo>
                      <a:lnTo>
                        <a:pt x="583" y="80"/>
                      </a:lnTo>
                      <a:lnTo>
                        <a:pt x="583" y="82"/>
                      </a:lnTo>
                      <a:lnTo>
                        <a:pt x="583" y="80"/>
                      </a:lnTo>
                      <a:lnTo>
                        <a:pt x="584" y="80"/>
                      </a:lnTo>
                      <a:lnTo>
                        <a:pt x="584" y="80"/>
                      </a:lnTo>
                      <a:lnTo>
                        <a:pt x="584" y="83"/>
                      </a:lnTo>
                      <a:lnTo>
                        <a:pt x="584" y="83"/>
                      </a:lnTo>
                      <a:lnTo>
                        <a:pt x="585" y="83"/>
                      </a:lnTo>
                      <a:lnTo>
                        <a:pt x="585" y="80"/>
                      </a:lnTo>
                      <a:lnTo>
                        <a:pt x="585" y="84"/>
                      </a:lnTo>
                      <a:lnTo>
                        <a:pt x="585" y="82"/>
                      </a:lnTo>
                      <a:lnTo>
                        <a:pt x="586" y="82"/>
                      </a:lnTo>
                      <a:lnTo>
                        <a:pt x="586" y="80"/>
                      </a:lnTo>
                      <a:lnTo>
                        <a:pt x="586" y="82"/>
                      </a:lnTo>
                      <a:lnTo>
                        <a:pt x="586" y="82"/>
                      </a:lnTo>
                      <a:lnTo>
                        <a:pt x="587" y="82"/>
                      </a:lnTo>
                      <a:lnTo>
                        <a:pt x="587" y="80"/>
                      </a:lnTo>
                      <a:lnTo>
                        <a:pt x="587" y="82"/>
                      </a:lnTo>
                      <a:lnTo>
                        <a:pt x="587" y="81"/>
                      </a:lnTo>
                      <a:lnTo>
                        <a:pt x="588" y="81"/>
                      </a:lnTo>
                      <a:lnTo>
                        <a:pt x="588" y="80"/>
                      </a:lnTo>
                      <a:lnTo>
                        <a:pt x="588" y="83"/>
                      </a:lnTo>
                      <a:lnTo>
                        <a:pt x="588" y="80"/>
                      </a:lnTo>
                      <a:lnTo>
                        <a:pt x="589" y="80"/>
                      </a:lnTo>
                      <a:lnTo>
                        <a:pt x="589" y="80"/>
                      </a:lnTo>
                      <a:lnTo>
                        <a:pt x="589" y="83"/>
                      </a:lnTo>
                      <a:lnTo>
                        <a:pt x="589" y="81"/>
                      </a:lnTo>
                      <a:lnTo>
                        <a:pt x="590" y="81"/>
                      </a:lnTo>
                      <a:lnTo>
                        <a:pt x="590" y="80"/>
                      </a:lnTo>
                      <a:lnTo>
                        <a:pt x="590" y="84"/>
                      </a:lnTo>
                      <a:lnTo>
                        <a:pt x="590" y="83"/>
                      </a:lnTo>
                      <a:lnTo>
                        <a:pt x="591" y="83"/>
                      </a:lnTo>
                      <a:lnTo>
                        <a:pt x="591" y="80"/>
                      </a:lnTo>
                      <a:lnTo>
                        <a:pt x="591" y="84"/>
                      </a:lnTo>
                      <a:lnTo>
                        <a:pt x="591" y="80"/>
                      </a:lnTo>
                      <a:lnTo>
                        <a:pt x="592" y="80"/>
                      </a:lnTo>
                      <a:lnTo>
                        <a:pt x="592" y="79"/>
                      </a:lnTo>
                      <a:lnTo>
                        <a:pt x="592" y="82"/>
                      </a:lnTo>
                      <a:lnTo>
                        <a:pt x="592" y="82"/>
                      </a:lnTo>
                      <a:lnTo>
                        <a:pt x="593" y="82"/>
                      </a:lnTo>
                      <a:lnTo>
                        <a:pt x="593" y="82"/>
                      </a:lnTo>
                      <a:lnTo>
                        <a:pt x="593" y="85"/>
                      </a:lnTo>
                      <a:lnTo>
                        <a:pt x="593" y="85"/>
                      </a:lnTo>
                      <a:lnTo>
                        <a:pt x="594" y="85"/>
                      </a:lnTo>
                      <a:lnTo>
                        <a:pt x="594" y="80"/>
                      </a:lnTo>
                      <a:lnTo>
                        <a:pt x="594" y="83"/>
                      </a:lnTo>
                      <a:lnTo>
                        <a:pt x="594" y="82"/>
                      </a:lnTo>
                      <a:lnTo>
                        <a:pt x="595" y="82"/>
                      </a:lnTo>
                      <a:lnTo>
                        <a:pt x="595" y="81"/>
                      </a:lnTo>
                      <a:lnTo>
                        <a:pt x="595" y="85"/>
                      </a:lnTo>
                      <a:lnTo>
                        <a:pt x="595" y="84"/>
                      </a:lnTo>
                      <a:lnTo>
                        <a:pt x="596" y="84"/>
                      </a:lnTo>
                      <a:lnTo>
                        <a:pt x="596" y="82"/>
                      </a:lnTo>
                      <a:lnTo>
                        <a:pt x="596" y="85"/>
                      </a:lnTo>
                      <a:lnTo>
                        <a:pt x="596" y="84"/>
                      </a:lnTo>
                      <a:lnTo>
                        <a:pt x="597" y="84"/>
                      </a:lnTo>
                      <a:lnTo>
                        <a:pt x="597" y="82"/>
                      </a:lnTo>
                      <a:lnTo>
                        <a:pt x="597" y="85"/>
                      </a:lnTo>
                      <a:lnTo>
                        <a:pt x="597" y="82"/>
                      </a:lnTo>
                      <a:lnTo>
                        <a:pt x="598" y="82"/>
                      </a:lnTo>
                      <a:lnTo>
                        <a:pt x="598" y="80"/>
                      </a:lnTo>
                      <a:lnTo>
                        <a:pt x="598" y="83"/>
                      </a:lnTo>
                      <a:lnTo>
                        <a:pt x="598" y="83"/>
                      </a:lnTo>
                      <a:lnTo>
                        <a:pt x="599" y="83"/>
                      </a:lnTo>
                      <a:lnTo>
                        <a:pt x="599" y="82"/>
                      </a:lnTo>
                      <a:lnTo>
                        <a:pt x="599" y="83"/>
                      </a:lnTo>
                      <a:lnTo>
                        <a:pt x="599" y="83"/>
                      </a:lnTo>
                      <a:lnTo>
                        <a:pt x="600" y="83"/>
                      </a:lnTo>
                      <a:lnTo>
                        <a:pt x="600" y="82"/>
                      </a:lnTo>
                      <a:lnTo>
                        <a:pt x="600" y="83"/>
                      </a:lnTo>
                      <a:lnTo>
                        <a:pt x="600" y="83"/>
                      </a:lnTo>
                      <a:lnTo>
                        <a:pt x="601" y="83"/>
                      </a:lnTo>
                      <a:lnTo>
                        <a:pt x="601" y="80"/>
                      </a:lnTo>
                      <a:lnTo>
                        <a:pt x="601" y="84"/>
                      </a:lnTo>
                      <a:lnTo>
                        <a:pt x="601" y="83"/>
                      </a:lnTo>
                      <a:lnTo>
                        <a:pt x="602" y="83"/>
                      </a:lnTo>
                      <a:lnTo>
                        <a:pt x="602" y="81"/>
                      </a:lnTo>
                      <a:lnTo>
                        <a:pt x="602" y="84"/>
                      </a:lnTo>
                      <a:lnTo>
                        <a:pt x="602" y="83"/>
                      </a:lnTo>
                      <a:lnTo>
                        <a:pt x="603" y="83"/>
                      </a:lnTo>
                      <a:lnTo>
                        <a:pt x="603" y="81"/>
                      </a:lnTo>
                      <a:lnTo>
                        <a:pt x="603" y="85"/>
                      </a:lnTo>
                      <a:lnTo>
                        <a:pt x="603" y="83"/>
                      </a:lnTo>
                      <a:lnTo>
                        <a:pt x="604" y="83"/>
                      </a:lnTo>
                      <a:lnTo>
                        <a:pt x="604" y="80"/>
                      </a:lnTo>
                      <a:lnTo>
                        <a:pt x="604" y="83"/>
                      </a:lnTo>
                      <a:lnTo>
                        <a:pt x="604" y="82"/>
                      </a:lnTo>
                      <a:lnTo>
                        <a:pt x="605" y="82"/>
                      </a:lnTo>
                      <a:lnTo>
                        <a:pt x="605" y="79"/>
                      </a:lnTo>
                      <a:lnTo>
                        <a:pt x="605" y="83"/>
                      </a:lnTo>
                      <a:lnTo>
                        <a:pt x="605" y="81"/>
                      </a:lnTo>
                      <a:lnTo>
                        <a:pt x="606" y="81"/>
                      </a:lnTo>
                      <a:lnTo>
                        <a:pt x="606" y="81"/>
                      </a:lnTo>
                      <a:lnTo>
                        <a:pt x="606" y="83"/>
                      </a:lnTo>
                      <a:lnTo>
                        <a:pt x="606" y="83"/>
                      </a:lnTo>
                      <a:lnTo>
                        <a:pt x="607" y="83"/>
                      </a:lnTo>
                      <a:lnTo>
                        <a:pt x="607" y="80"/>
                      </a:lnTo>
                      <a:lnTo>
                        <a:pt x="607" y="83"/>
                      </a:lnTo>
                      <a:lnTo>
                        <a:pt x="607" y="81"/>
                      </a:lnTo>
                      <a:lnTo>
                        <a:pt x="608" y="81"/>
                      </a:lnTo>
                      <a:lnTo>
                        <a:pt x="608" y="80"/>
                      </a:lnTo>
                      <a:lnTo>
                        <a:pt x="608" y="84"/>
                      </a:lnTo>
                      <a:lnTo>
                        <a:pt x="608" y="83"/>
                      </a:lnTo>
                      <a:lnTo>
                        <a:pt x="609" y="83"/>
                      </a:lnTo>
                      <a:lnTo>
                        <a:pt x="609" y="80"/>
                      </a:lnTo>
                      <a:lnTo>
                        <a:pt x="609" y="83"/>
                      </a:lnTo>
                      <a:lnTo>
                        <a:pt x="609" y="83"/>
                      </a:lnTo>
                      <a:lnTo>
                        <a:pt x="610" y="83"/>
                      </a:lnTo>
                      <a:lnTo>
                        <a:pt x="610" y="80"/>
                      </a:lnTo>
                      <a:lnTo>
                        <a:pt x="610" y="84"/>
                      </a:lnTo>
                      <a:lnTo>
                        <a:pt x="610" y="84"/>
                      </a:lnTo>
                      <a:lnTo>
                        <a:pt x="611" y="84"/>
                      </a:lnTo>
                      <a:lnTo>
                        <a:pt x="611" y="82"/>
                      </a:lnTo>
                      <a:lnTo>
                        <a:pt x="611" y="85"/>
                      </a:lnTo>
                      <a:lnTo>
                        <a:pt x="611" y="83"/>
                      </a:lnTo>
                      <a:lnTo>
                        <a:pt x="612" y="83"/>
                      </a:lnTo>
                      <a:lnTo>
                        <a:pt x="612" y="79"/>
                      </a:lnTo>
                      <a:lnTo>
                        <a:pt x="612" y="82"/>
                      </a:lnTo>
                      <a:lnTo>
                        <a:pt x="612" y="82"/>
                      </a:lnTo>
                      <a:lnTo>
                        <a:pt x="613" y="82"/>
                      </a:lnTo>
                      <a:lnTo>
                        <a:pt x="613" y="80"/>
                      </a:lnTo>
                      <a:lnTo>
                        <a:pt x="613" y="83"/>
                      </a:lnTo>
                      <a:lnTo>
                        <a:pt x="613" y="82"/>
                      </a:lnTo>
                      <a:lnTo>
                        <a:pt x="614" y="82"/>
                      </a:lnTo>
                      <a:lnTo>
                        <a:pt x="614" y="80"/>
                      </a:lnTo>
                      <a:lnTo>
                        <a:pt x="614" y="84"/>
                      </a:lnTo>
                      <a:lnTo>
                        <a:pt x="614" y="83"/>
                      </a:lnTo>
                      <a:lnTo>
                        <a:pt x="615" y="83"/>
                      </a:lnTo>
                      <a:lnTo>
                        <a:pt x="615" y="81"/>
                      </a:lnTo>
                      <a:lnTo>
                        <a:pt x="615" y="83"/>
                      </a:lnTo>
                      <a:lnTo>
                        <a:pt x="615" y="83"/>
                      </a:lnTo>
                      <a:lnTo>
                        <a:pt x="616" y="83"/>
                      </a:lnTo>
                      <a:lnTo>
                        <a:pt x="616" y="79"/>
                      </a:lnTo>
                      <a:lnTo>
                        <a:pt x="616" y="84"/>
                      </a:lnTo>
                      <a:lnTo>
                        <a:pt x="616" y="83"/>
                      </a:lnTo>
                      <a:lnTo>
                        <a:pt x="617" y="83"/>
                      </a:lnTo>
                      <a:lnTo>
                        <a:pt x="617" y="80"/>
                      </a:lnTo>
                      <a:lnTo>
                        <a:pt x="617" y="85"/>
                      </a:lnTo>
                      <a:lnTo>
                        <a:pt x="617" y="80"/>
                      </a:lnTo>
                      <a:lnTo>
                        <a:pt x="618" y="80"/>
                      </a:lnTo>
                      <a:lnTo>
                        <a:pt x="618" y="80"/>
                      </a:lnTo>
                      <a:lnTo>
                        <a:pt x="618" y="83"/>
                      </a:lnTo>
                      <a:lnTo>
                        <a:pt x="618" y="83"/>
                      </a:lnTo>
                      <a:lnTo>
                        <a:pt x="619" y="83"/>
                      </a:lnTo>
                      <a:lnTo>
                        <a:pt x="619" y="80"/>
                      </a:lnTo>
                      <a:lnTo>
                        <a:pt x="619" y="89"/>
                      </a:lnTo>
                      <a:lnTo>
                        <a:pt x="619" y="81"/>
                      </a:lnTo>
                      <a:lnTo>
                        <a:pt x="620" y="81"/>
                      </a:lnTo>
                      <a:lnTo>
                        <a:pt x="620" y="82"/>
                      </a:lnTo>
                      <a:lnTo>
                        <a:pt x="620" y="86"/>
                      </a:lnTo>
                      <a:lnTo>
                        <a:pt x="620" y="82"/>
                      </a:lnTo>
                      <a:lnTo>
                        <a:pt x="621" y="82"/>
                      </a:lnTo>
                      <a:lnTo>
                        <a:pt x="621" y="80"/>
                      </a:lnTo>
                      <a:lnTo>
                        <a:pt x="621" y="84"/>
                      </a:lnTo>
                      <a:lnTo>
                        <a:pt x="621" y="83"/>
                      </a:lnTo>
                      <a:lnTo>
                        <a:pt x="622" y="83"/>
                      </a:lnTo>
                      <a:lnTo>
                        <a:pt x="622" y="80"/>
                      </a:lnTo>
                      <a:lnTo>
                        <a:pt x="622" y="85"/>
                      </a:lnTo>
                      <a:lnTo>
                        <a:pt x="622" y="83"/>
                      </a:lnTo>
                      <a:lnTo>
                        <a:pt x="623" y="83"/>
                      </a:lnTo>
                      <a:lnTo>
                        <a:pt x="623" y="82"/>
                      </a:lnTo>
                      <a:lnTo>
                        <a:pt x="623" y="86"/>
                      </a:lnTo>
                      <a:lnTo>
                        <a:pt x="623" y="83"/>
                      </a:lnTo>
                      <a:lnTo>
                        <a:pt x="624" y="83"/>
                      </a:lnTo>
                      <a:lnTo>
                        <a:pt x="624" y="79"/>
                      </a:lnTo>
                      <a:lnTo>
                        <a:pt x="624" y="85"/>
                      </a:lnTo>
                      <a:lnTo>
                        <a:pt x="624" y="85"/>
                      </a:lnTo>
                      <a:lnTo>
                        <a:pt x="625" y="85"/>
                      </a:lnTo>
                      <a:lnTo>
                        <a:pt x="625" y="80"/>
                      </a:lnTo>
                      <a:lnTo>
                        <a:pt x="625" y="85"/>
                      </a:lnTo>
                      <a:lnTo>
                        <a:pt x="625" y="83"/>
                      </a:lnTo>
                      <a:lnTo>
                        <a:pt x="626" y="83"/>
                      </a:lnTo>
                      <a:lnTo>
                        <a:pt x="626" y="82"/>
                      </a:lnTo>
                      <a:lnTo>
                        <a:pt x="626" y="86"/>
                      </a:lnTo>
                      <a:lnTo>
                        <a:pt x="626" y="84"/>
                      </a:lnTo>
                      <a:lnTo>
                        <a:pt x="627" y="84"/>
                      </a:lnTo>
                      <a:lnTo>
                        <a:pt x="627" y="82"/>
                      </a:lnTo>
                      <a:lnTo>
                        <a:pt x="627" y="86"/>
                      </a:lnTo>
                      <a:lnTo>
                        <a:pt x="627" y="84"/>
                      </a:lnTo>
                      <a:lnTo>
                        <a:pt x="628" y="84"/>
                      </a:lnTo>
                      <a:lnTo>
                        <a:pt x="628" y="82"/>
                      </a:lnTo>
                      <a:lnTo>
                        <a:pt x="628" y="84"/>
                      </a:lnTo>
                      <a:lnTo>
                        <a:pt x="628" y="84"/>
                      </a:lnTo>
                      <a:lnTo>
                        <a:pt x="629" y="84"/>
                      </a:lnTo>
                      <a:lnTo>
                        <a:pt x="629" y="82"/>
                      </a:lnTo>
                      <a:lnTo>
                        <a:pt x="629" y="85"/>
                      </a:lnTo>
                      <a:lnTo>
                        <a:pt x="629" y="82"/>
                      </a:lnTo>
                      <a:lnTo>
                        <a:pt x="630" y="82"/>
                      </a:lnTo>
                      <a:lnTo>
                        <a:pt x="630" y="82"/>
                      </a:lnTo>
                      <a:lnTo>
                        <a:pt x="630" y="85"/>
                      </a:lnTo>
                      <a:lnTo>
                        <a:pt x="630" y="82"/>
                      </a:lnTo>
                      <a:lnTo>
                        <a:pt x="631" y="82"/>
                      </a:lnTo>
                      <a:lnTo>
                        <a:pt x="631" y="82"/>
                      </a:lnTo>
                      <a:lnTo>
                        <a:pt x="631" y="85"/>
                      </a:lnTo>
                      <a:lnTo>
                        <a:pt x="631" y="83"/>
                      </a:lnTo>
                      <a:lnTo>
                        <a:pt x="632" y="83"/>
                      </a:lnTo>
                      <a:lnTo>
                        <a:pt x="632" y="82"/>
                      </a:lnTo>
                      <a:lnTo>
                        <a:pt x="632" y="85"/>
                      </a:lnTo>
                      <a:lnTo>
                        <a:pt x="632" y="82"/>
                      </a:lnTo>
                      <a:lnTo>
                        <a:pt x="633" y="82"/>
                      </a:lnTo>
                      <a:lnTo>
                        <a:pt x="633" y="82"/>
                      </a:lnTo>
                      <a:lnTo>
                        <a:pt x="633" y="85"/>
                      </a:lnTo>
                      <a:lnTo>
                        <a:pt x="633" y="84"/>
                      </a:lnTo>
                      <a:lnTo>
                        <a:pt x="634" y="84"/>
                      </a:lnTo>
                      <a:lnTo>
                        <a:pt x="634" y="81"/>
                      </a:lnTo>
                      <a:lnTo>
                        <a:pt x="634" y="85"/>
                      </a:lnTo>
                      <a:lnTo>
                        <a:pt x="634" y="85"/>
                      </a:lnTo>
                      <a:lnTo>
                        <a:pt x="635" y="85"/>
                      </a:lnTo>
                      <a:lnTo>
                        <a:pt x="635" y="83"/>
                      </a:lnTo>
                      <a:lnTo>
                        <a:pt x="635" y="87"/>
                      </a:lnTo>
                      <a:lnTo>
                        <a:pt x="635" y="85"/>
                      </a:lnTo>
                      <a:lnTo>
                        <a:pt x="636" y="85"/>
                      </a:lnTo>
                      <a:lnTo>
                        <a:pt x="636" y="82"/>
                      </a:lnTo>
                      <a:lnTo>
                        <a:pt x="636" y="86"/>
                      </a:lnTo>
                      <a:lnTo>
                        <a:pt x="636" y="83"/>
                      </a:lnTo>
                      <a:lnTo>
                        <a:pt x="637" y="83"/>
                      </a:lnTo>
                      <a:lnTo>
                        <a:pt x="637" y="82"/>
                      </a:lnTo>
                      <a:lnTo>
                        <a:pt x="637" y="85"/>
                      </a:lnTo>
                      <a:lnTo>
                        <a:pt x="637" y="83"/>
                      </a:lnTo>
                      <a:lnTo>
                        <a:pt x="638" y="83"/>
                      </a:lnTo>
                      <a:lnTo>
                        <a:pt x="638" y="82"/>
                      </a:lnTo>
                      <a:lnTo>
                        <a:pt x="638" y="85"/>
                      </a:lnTo>
                      <a:lnTo>
                        <a:pt x="638" y="82"/>
                      </a:lnTo>
                      <a:lnTo>
                        <a:pt x="639" y="82"/>
                      </a:lnTo>
                      <a:lnTo>
                        <a:pt x="639" y="82"/>
                      </a:lnTo>
                      <a:lnTo>
                        <a:pt x="639" y="85"/>
                      </a:lnTo>
                      <a:lnTo>
                        <a:pt x="639" y="84"/>
                      </a:lnTo>
                      <a:lnTo>
                        <a:pt x="640" y="84"/>
                      </a:lnTo>
                      <a:lnTo>
                        <a:pt x="640" y="83"/>
                      </a:lnTo>
                      <a:lnTo>
                        <a:pt x="640" y="85"/>
                      </a:lnTo>
                      <a:lnTo>
                        <a:pt x="640" y="85"/>
                      </a:lnTo>
                      <a:lnTo>
                        <a:pt x="641" y="85"/>
                      </a:lnTo>
                      <a:lnTo>
                        <a:pt x="641" y="82"/>
                      </a:lnTo>
                      <a:lnTo>
                        <a:pt x="641" y="85"/>
                      </a:lnTo>
                      <a:lnTo>
                        <a:pt x="641" y="83"/>
                      </a:lnTo>
                      <a:lnTo>
                        <a:pt x="642" y="83"/>
                      </a:lnTo>
                      <a:lnTo>
                        <a:pt x="642" y="82"/>
                      </a:lnTo>
                      <a:lnTo>
                        <a:pt x="642" y="84"/>
                      </a:lnTo>
                      <a:lnTo>
                        <a:pt x="642" y="82"/>
                      </a:lnTo>
                      <a:lnTo>
                        <a:pt x="643" y="82"/>
                      </a:lnTo>
                      <a:lnTo>
                        <a:pt x="643" y="80"/>
                      </a:lnTo>
                      <a:lnTo>
                        <a:pt x="643" y="85"/>
                      </a:lnTo>
                      <a:lnTo>
                        <a:pt x="643" y="83"/>
                      </a:lnTo>
                      <a:lnTo>
                        <a:pt x="644" y="83"/>
                      </a:lnTo>
                      <a:lnTo>
                        <a:pt x="644" y="82"/>
                      </a:lnTo>
                      <a:lnTo>
                        <a:pt x="644" y="84"/>
                      </a:lnTo>
                      <a:lnTo>
                        <a:pt x="644" y="84"/>
                      </a:lnTo>
                      <a:lnTo>
                        <a:pt x="645" y="84"/>
                      </a:lnTo>
                      <a:lnTo>
                        <a:pt x="645" y="81"/>
                      </a:lnTo>
                      <a:lnTo>
                        <a:pt x="645" y="84"/>
                      </a:lnTo>
                      <a:lnTo>
                        <a:pt x="645" y="83"/>
                      </a:lnTo>
                      <a:lnTo>
                        <a:pt x="646" y="83"/>
                      </a:lnTo>
                      <a:lnTo>
                        <a:pt x="646" y="80"/>
                      </a:lnTo>
                      <a:lnTo>
                        <a:pt x="646" y="83"/>
                      </a:lnTo>
                      <a:lnTo>
                        <a:pt x="646" y="83"/>
                      </a:lnTo>
                      <a:lnTo>
                        <a:pt x="647" y="83"/>
                      </a:lnTo>
                      <a:lnTo>
                        <a:pt x="647" y="81"/>
                      </a:lnTo>
                      <a:lnTo>
                        <a:pt x="647" y="83"/>
                      </a:lnTo>
                      <a:lnTo>
                        <a:pt x="647" y="82"/>
                      </a:lnTo>
                      <a:lnTo>
                        <a:pt x="648" y="82"/>
                      </a:lnTo>
                      <a:lnTo>
                        <a:pt x="648" y="80"/>
                      </a:lnTo>
                      <a:lnTo>
                        <a:pt x="648" y="83"/>
                      </a:lnTo>
                      <a:lnTo>
                        <a:pt x="648" y="83"/>
                      </a:lnTo>
                      <a:lnTo>
                        <a:pt x="649" y="83"/>
                      </a:lnTo>
                      <a:lnTo>
                        <a:pt x="649" y="82"/>
                      </a:lnTo>
                      <a:lnTo>
                        <a:pt x="649" y="85"/>
                      </a:lnTo>
                      <a:lnTo>
                        <a:pt x="649" y="83"/>
                      </a:lnTo>
                      <a:lnTo>
                        <a:pt x="650" y="83"/>
                      </a:lnTo>
                      <a:lnTo>
                        <a:pt x="650" y="82"/>
                      </a:lnTo>
                      <a:lnTo>
                        <a:pt x="650" y="85"/>
                      </a:lnTo>
                      <a:lnTo>
                        <a:pt x="650" y="83"/>
                      </a:lnTo>
                      <a:lnTo>
                        <a:pt x="651" y="83"/>
                      </a:lnTo>
                      <a:lnTo>
                        <a:pt x="651" y="80"/>
                      </a:lnTo>
                      <a:lnTo>
                        <a:pt x="651" y="84"/>
                      </a:lnTo>
                      <a:lnTo>
                        <a:pt x="651" y="84"/>
                      </a:lnTo>
                      <a:lnTo>
                        <a:pt x="652" y="84"/>
                      </a:lnTo>
                      <a:lnTo>
                        <a:pt x="652" y="80"/>
                      </a:lnTo>
                      <a:lnTo>
                        <a:pt x="652" y="83"/>
                      </a:lnTo>
                      <a:lnTo>
                        <a:pt x="652" y="83"/>
                      </a:lnTo>
                      <a:lnTo>
                        <a:pt x="653" y="83"/>
                      </a:lnTo>
                      <a:lnTo>
                        <a:pt x="653" y="80"/>
                      </a:lnTo>
                      <a:lnTo>
                        <a:pt x="653" y="85"/>
                      </a:lnTo>
                      <a:lnTo>
                        <a:pt x="653" y="83"/>
                      </a:lnTo>
                      <a:lnTo>
                        <a:pt x="654" y="83"/>
                      </a:lnTo>
                      <a:lnTo>
                        <a:pt x="654" y="82"/>
                      </a:lnTo>
                      <a:lnTo>
                        <a:pt x="654" y="84"/>
                      </a:lnTo>
                      <a:lnTo>
                        <a:pt x="654" y="82"/>
                      </a:lnTo>
                      <a:lnTo>
                        <a:pt x="655" y="82"/>
                      </a:lnTo>
                      <a:lnTo>
                        <a:pt x="655" y="80"/>
                      </a:lnTo>
                      <a:lnTo>
                        <a:pt x="655" y="83"/>
                      </a:lnTo>
                      <a:lnTo>
                        <a:pt x="655" y="81"/>
                      </a:lnTo>
                      <a:lnTo>
                        <a:pt x="656" y="81"/>
                      </a:lnTo>
                      <a:lnTo>
                        <a:pt x="656" y="79"/>
                      </a:lnTo>
                      <a:lnTo>
                        <a:pt x="656" y="83"/>
                      </a:lnTo>
                      <a:lnTo>
                        <a:pt x="656" y="80"/>
                      </a:lnTo>
                      <a:lnTo>
                        <a:pt x="657" y="80"/>
                      </a:lnTo>
                      <a:lnTo>
                        <a:pt x="657" y="80"/>
                      </a:lnTo>
                      <a:lnTo>
                        <a:pt x="657" y="83"/>
                      </a:lnTo>
                      <a:lnTo>
                        <a:pt x="657" y="82"/>
                      </a:lnTo>
                      <a:lnTo>
                        <a:pt x="658" y="82"/>
                      </a:lnTo>
                      <a:lnTo>
                        <a:pt x="658" y="82"/>
                      </a:lnTo>
                      <a:lnTo>
                        <a:pt x="658" y="85"/>
                      </a:lnTo>
                      <a:lnTo>
                        <a:pt x="658" y="83"/>
                      </a:lnTo>
                      <a:lnTo>
                        <a:pt x="659" y="83"/>
                      </a:lnTo>
                      <a:lnTo>
                        <a:pt x="659" y="82"/>
                      </a:lnTo>
                      <a:lnTo>
                        <a:pt x="659" y="84"/>
                      </a:lnTo>
                      <a:lnTo>
                        <a:pt x="659" y="83"/>
                      </a:lnTo>
                      <a:lnTo>
                        <a:pt x="660" y="83"/>
                      </a:lnTo>
                      <a:lnTo>
                        <a:pt x="660" y="81"/>
                      </a:lnTo>
                      <a:lnTo>
                        <a:pt x="660" y="85"/>
                      </a:lnTo>
                      <a:lnTo>
                        <a:pt x="660" y="84"/>
                      </a:lnTo>
                      <a:lnTo>
                        <a:pt x="661" y="84"/>
                      </a:lnTo>
                      <a:lnTo>
                        <a:pt x="661" y="80"/>
                      </a:lnTo>
                      <a:lnTo>
                        <a:pt x="661" y="85"/>
                      </a:lnTo>
                      <a:lnTo>
                        <a:pt x="661" y="84"/>
                      </a:lnTo>
                      <a:lnTo>
                        <a:pt x="662" y="84"/>
                      </a:lnTo>
                      <a:lnTo>
                        <a:pt x="662" y="83"/>
                      </a:lnTo>
                      <a:lnTo>
                        <a:pt x="662" y="85"/>
                      </a:lnTo>
                      <a:lnTo>
                        <a:pt x="662" y="85"/>
                      </a:lnTo>
                      <a:lnTo>
                        <a:pt x="663" y="85"/>
                      </a:lnTo>
                      <a:lnTo>
                        <a:pt x="663" y="82"/>
                      </a:lnTo>
                      <a:lnTo>
                        <a:pt x="663" y="83"/>
                      </a:lnTo>
                      <a:lnTo>
                        <a:pt x="663" y="83"/>
                      </a:lnTo>
                      <a:lnTo>
                        <a:pt x="664" y="83"/>
                      </a:lnTo>
                      <a:lnTo>
                        <a:pt x="664" y="81"/>
                      </a:lnTo>
                      <a:lnTo>
                        <a:pt x="664" y="86"/>
                      </a:lnTo>
                      <a:lnTo>
                        <a:pt x="664" y="85"/>
                      </a:lnTo>
                      <a:lnTo>
                        <a:pt x="665" y="85"/>
                      </a:lnTo>
                      <a:lnTo>
                        <a:pt x="665" y="79"/>
                      </a:lnTo>
                      <a:lnTo>
                        <a:pt x="665" y="85"/>
                      </a:lnTo>
                      <a:lnTo>
                        <a:pt x="665" y="79"/>
                      </a:lnTo>
                      <a:lnTo>
                        <a:pt x="666" y="79"/>
                      </a:lnTo>
                      <a:lnTo>
                        <a:pt x="666" y="80"/>
                      </a:lnTo>
                      <a:lnTo>
                        <a:pt x="666" y="84"/>
                      </a:lnTo>
                      <a:lnTo>
                        <a:pt x="666" y="84"/>
                      </a:lnTo>
                      <a:lnTo>
                        <a:pt x="667" y="84"/>
                      </a:lnTo>
                      <a:lnTo>
                        <a:pt x="667" y="80"/>
                      </a:lnTo>
                      <a:lnTo>
                        <a:pt x="667" y="84"/>
                      </a:lnTo>
                      <a:lnTo>
                        <a:pt x="667" y="84"/>
                      </a:lnTo>
                      <a:lnTo>
                        <a:pt x="668" y="84"/>
                      </a:lnTo>
                      <a:lnTo>
                        <a:pt x="668" y="82"/>
                      </a:lnTo>
                      <a:lnTo>
                        <a:pt x="668" y="85"/>
                      </a:lnTo>
                      <a:lnTo>
                        <a:pt x="668" y="83"/>
                      </a:lnTo>
                      <a:lnTo>
                        <a:pt x="669" y="83"/>
                      </a:lnTo>
                      <a:lnTo>
                        <a:pt x="669" y="80"/>
                      </a:lnTo>
                      <a:lnTo>
                        <a:pt x="669" y="83"/>
                      </a:lnTo>
                      <a:lnTo>
                        <a:pt x="669" y="82"/>
                      </a:lnTo>
                      <a:lnTo>
                        <a:pt x="670" y="82"/>
                      </a:lnTo>
                      <a:lnTo>
                        <a:pt x="670" y="79"/>
                      </a:lnTo>
                      <a:lnTo>
                        <a:pt x="670" y="82"/>
                      </a:lnTo>
                      <a:lnTo>
                        <a:pt x="670" y="82"/>
                      </a:lnTo>
                      <a:lnTo>
                        <a:pt x="671" y="82"/>
                      </a:lnTo>
                      <a:lnTo>
                        <a:pt x="671" y="81"/>
                      </a:lnTo>
                      <a:lnTo>
                        <a:pt x="671" y="83"/>
                      </a:lnTo>
                      <a:lnTo>
                        <a:pt x="671" y="82"/>
                      </a:lnTo>
                      <a:lnTo>
                        <a:pt x="672" y="82"/>
                      </a:lnTo>
                      <a:lnTo>
                        <a:pt x="672" y="80"/>
                      </a:lnTo>
                      <a:lnTo>
                        <a:pt x="672" y="84"/>
                      </a:lnTo>
                      <a:lnTo>
                        <a:pt x="672" y="82"/>
                      </a:lnTo>
                      <a:lnTo>
                        <a:pt x="673" y="82"/>
                      </a:lnTo>
                      <a:lnTo>
                        <a:pt x="673" y="80"/>
                      </a:lnTo>
                      <a:lnTo>
                        <a:pt x="673" y="85"/>
                      </a:lnTo>
                      <a:lnTo>
                        <a:pt x="673" y="82"/>
                      </a:lnTo>
                      <a:lnTo>
                        <a:pt x="674" y="82"/>
                      </a:lnTo>
                      <a:lnTo>
                        <a:pt x="674" y="80"/>
                      </a:lnTo>
                      <a:lnTo>
                        <a:pt x="674" y="83"/>
                      </a:lnTo>
                      <a:lnTo>
                        <a:pt x="674" y="80"/>
                      </a:lnTo>
                      <a:lnTo>
                        <a:pt x="675" y="80"/>
                      </a:lnTo>
                      <a:lnTo>
                        <a:pt x="675" y="79"/>
                      </a:lnTo>
                      <a:lnTo>
                        <a:pt x="675" y="84"/>
                      </a:lnTo>
                      <a:lnTo>
                        <a:pt x="675" y="82"/>
                      </a:lnTo>
                      <a:lnTo>
                        <a:pt x="676" y="82"/>
                      </a:lnTo>
                      <a:lnTo>
                        <a:pt x="676" y="80"/>
                      </a:lnTo>
                      <a:lnTo>
                        <a:pt x="676" y="84"/>
                      </a:lnTo>
                      <a:lnTo>
                        <a:pt x="676" y="82"/>
                      </a:lnTo>
                      <a:lnTo>
                        <a:pt x="677" y="82"/>
                      </a:lnTo>
                      <a:lnTo>
                        <a:pt x="677" y="80"/>
                      </a:lnTo>
                      <a:lnTo>
                        <a:pt x="677" y="84"/>
                      </a:lnTo>
                      <a:lnTo>
                        <a:pt x="677" y="83"/>
                      </a:lnTo>
                      <a:lnTo>
                        <a:pt x="678" y="83"/>
                      </a:lnTo>
                      <a:lnTo>
                        <a:pt x="678" y="80"/>
                      </a:lnTo>
                      <a:lnTo>
                        <a:pt x="678" y="83"/>
                      </a:lnTo>
                      <a:lnTo>
                        <a:pt x="678" y="80"/>
                      </a:lnTo>
                      <a:lnTo>
                        <a:pt x="679" y="80"/>
                      </a:lnTo>
                      <a:lnTo>
                        <a:pt x="679" y="80"/>
                      </a:lnTo>
                      <a:lnTo>
                        <a:pt x="679" y="83"/>
                      </a:lnTo>
                      <a:lnTo>
                        <a:pt x="679" y="80"/>
                      </a:lnTo>
                      <a:lnTo>
                        <a:pt x="680" y="80"/>
                      </a:lnTo>
                      <a:lnTo>
                        <a:pt x="680" y="80"/>
                      </a:lnTo>
                      <a:lnTo>
                        <a:pt x="680" y="82"/>
                      </a:lnTo>
                      <a:lnTo>
                        <a:pt x="680" y="80"/>
                      </a:lnTo>
                      <a:lnTo>
                        <a:pt x="681" y="80"/>
                      </a:lnTo>
                      <a:lnTo>
                        <a:pt x="681" y="79"/>
                      </a:lnTo>
                      <a:lnTo>
                        <a:pt x="681" y="82"/>
                      </a:lnTo>
                      <a:lnTo>
                        <a:pt x="681" y="80"/>
                      </a:lnTo>
                      <a:lnTo>
                        <a:pt x="682" y="80"/>
                      </a:lnTo>
                      <a:lnTo>
                        <a:pt x="682" y="80"/>
                      </a:lnTo>
                      <a:lnTo>
                        <a:pt x="682" y="83"/>
                      </a:lnTo>
                      <a:lnTo>
                        <a:pt x="682" y="83"/>
                      </a:lnTo>
                      <a:lnTo>
                        <a:pt x="683" y="83"/>
                      </a:lnTo>
                      <a:lnTo>
                        <a:pt x="683" y="79"/>
                      </a:lnTo>
                      <a:lnTo>
                        <a:pt x="683" y="84"/>
                      </a:lnTo>
                      <a:lnTo>
                        <a:pt x="683" y="82"/>
                      </a:lnTo>
                      <a:lnTo>
                        <a:pt x="684" y="82"/>
                      </a:lnTo>
                      <a:lnTo>
                        <a:pt x="684" y="79"/>
                      </a:lnTo>
                      <a:lnTo>
                        <a:pt x="684" y="82"/>
                      </a:lnTo>
                      <a:lnTo>
                        <a:pt x="684" y="82"/>
                      </a:lnTo>
                      <a:lnTo>
                        <a:pt x="685" y="82"/>
                      </a:lnTo>
                      <a:lnTo>
                        <a:pt x="685" y="79"/>
                      </a:lnTo>
                      <a:lnTo>
                        <a:pt x="685" y="83"/>
                      </a:lnTo>
                      <a:lnTo>
                        <a:pt x="685" y="81"/>
                      </a:lnTo>
                      <a:lnTo>
                        <a:pt x="686" y="81"/>
                      </a:lnTo>
                      <a:lnTo>
                        <a:pt x="686" y="79"/>
                      </a:lnTo>
                      <a:lnTo>
                        <a:pt x="686" y="83"/>
                      </a:lnTo>
                      <a:lnTo>
                        <a:pt x="686" y="83"/>
                      </a:lnTo>
                      <a:lnTo>
                        <a:pt x="687" y="83"/>
                      </a:lnTo>
                      <a:lnTo>
                        <a:pt x="687" y="79"/>
                      </a:lnTo>
                      <a:lnTo>
                        <a:pt x="687" y="82"/>
                      </a:lnTo>
                      <a:lnTo>
                        <a:pt x="687" y="80"/>
                      </a:lnTo>
                      <a:lnTo>
                        <a:pt x="688" y="80"/>
                      </a:lnTo>
                      <a:lnTo>
                        <a:pt x="688" y="79"/>
                      </a:lnTo>
                      <a:lnTo>
                        <a:pt x="688" y="82"/>
                      </a:lnTo>
                      <a:lnTo>
                        <a:pt x="688" y="79"/>
                      </a:lnTo>
                      <a:lnTo>
                        <a:pt x="689" y="79"/>
                      </a:lnTo>
                      <a:lnTo>
                        <a:pt x="689" y="79"/>
                      </a:lnTo>
                      <a:lnTo>
                        <a:pt x="689" y="83"/>
                      </a:lnTo>
                      <a:lnTo>
                        <a:pt x="689" y="80"/>
                      </a:lnTo>
                      <a:lnTo>
                        <a:pt x="690" y="80"/>
                      </a:lnTo>
                      <a:lnTo>
                        <a:pt x="690" y="79"/>
                      </a:lnTo>
                      <a:lnTo>
                        <a:pt x="690" y="82"/>
                      </a:lnTo>
                      <a:lnTo>
                        <a:pt x="690" y="80"/>
                      </a:lnTo>
                      <a:lnTo>
                        <a:pt x="691" y="80"/>
                      </a:lnTo>
                      <a:lnTo>
                        <a:pt x="691" y="80"/>
                      </a:lnTo>
                      <a:lnTo>
                        <a:pt x="691" y="83"/>
                      </a:lnTo>
                      <a:lnTo>
                        <a:pt x="691" y="82"/>
                      </a:lnTo>
                      <a:lnTo>
                        <a:pt x="692" y="82"/>
                      </a:lnTo>
                      <a:lnTo>
                        <a:pt x="692" y="79"/>
                      </a:lnTo>
                      <a:lnTo>
                        <a:pt x="692" y="82"/>
                      </a:lnTo>
                      <a:lnTo>
                        <a:pt x="692" y="79"/>
                      </a:lnTo>
                      <a:lnTo>
                        <a:pt x="693" y="79"/>
                      </a:lnTo>
                      <a:lnTo>
                        <a:pt x="693" y="78"/>
                      </a:lnTo>
                      <a:lnTo>
                        <a:pt x="693" y="81"/>
                      </a:lnTo>
                      <a:lnTo>
                        <a:pt x="693" y="80"/>
                      </a:lnTo>
                      <a:lnTo>
                        <a:pt x="694" y="80"/>
                      </a:lnTo>
                      <a:lnTo>
                        <a:pt x="694" y="79"/>
                      </a:lnTo>
                      <a:lnTo>
                        <a:pt x="694" y="82"/>
                      </a:lnTo>
                      <a:lnTo>
                        <a:pt x="694" y="79"/>
                      </a:lnTo>
                      <a:lnTo>
                        <a:pt x="695" y="79"/>
                      </a:lnTo>
                      <a:lnTo>
                        <a:pt x="695" y="77"/>
                      </a:lnTo>
                      <a:lnTo>
                        <a:pt x="695" y="82"/>
                      </a:lnTo>
                      <a:lnTo>
                        <a:pt x="695" y="78"/>
                      </a:lnTo>
                      <a:lnTo>
                        <a:pt x="696" y="78"/>
                      </a:lnTo>
                      <a:lnTo>
                        <a:pt x="696" y="77"/>
                      </a:lnTo>
                      <a:lnTo>
                        <a:pt x="696" y="80"/>
                      </a:lnTo>
                      <a:lnTo>
                        <a:pt x="696" y="79"/>
                      </a:lnTo>
                      <a:lnTo>
                        <a:pt x="697" y="79"/>
                      </a:lnTo>
                      <a:lnTo>
                        <a:pt x="697" y="79"/>
                      </a:lnTo>
                      <a:lnTo>
                        <a:pt x="697" y="81"/>
                      </a:lnTo>
                      <a:lnTo>
                        <a:pt x="697" y="80"/>
                      </a:lnTo>
                      <a:lnTo>
                        <a:pt x="698" y="80"/>
                      </a:lnTo>
                      <a:lnTo>
                        <a:pt x="698" y="77"/>
                      </a:lnTo>
                      <a:lnTo>
                        <a:pt x="698" y="81"/>
                      </a:lnTo>
                      <a:lnTo>
                        <a:pt x="698" y="79"/>
                      </a:lnTo>
                      <a:lnTo>
                        <a:pt x="699" y="79"/>
                      </a:lnTo>
                      <a:lnTo>
                        <a:pt x="699" y="77"/>
                      </a:lnTo>
                      <a:lnTo>
                        <a:pt x="699" y="80"/>
                      </a:lnTo>
                      <a:lnTo>
                        <a:pt x="699" y="80"/>
                      </a:lnTo>
                      <a:lnTo>
                        <a:pt x="700" y="80"/>
                      </a:lnTo>
                      <a:lnTo>
                        <a:pt x="700" y="79"/>
                      </a:lnTo>
                      <a:lnTo>
                        <a:pt x="700" y="82"/>
                      </a:lnTo>
                      <a:lnTo>
                        <a:pt x="700" y="81"/>
                      </a:lnTo>
                      <a:lnTo>
                        <a:pt x="701" y="81"/>
                      </a:lnTo>
                      <a:lnTo>
                        <a:pt x="701" y="78"/>
                      </a:lnTo>
                      <a:lnTo>
                        <a:pt x="701" y="81"/>
                      </a:lnTo>
                      <a:lnTo>
                        <a:pt x="701" y="79"/>
                      </a:lnTo>
                      <a:lnTo>
                        <a:pt x="702" y="79"/>
                      </a:lnTo>
                      <a:lnTo>
                        <a:pt x="702" y="77"/>
                      </a:lnTo>
                      <a:lnTo>
                        <a:pt x="702" y="82"/>
                      </a:lnTo>
                      <a:lnTo>
                        <a:pt x="702" y="81"/>
                      </a:lnTo>
                      <a:lnTo>
                        <a:pt x="703" y="81"/>
                      </a:lnTo>
                      <a:lnTo>
                        <a:pt x="703" y="77"/>
                      </a:lnTo>
                      <a:lnTo>
                        <a:pt x="703" y="80"/>
                      </a:lnTo>
                      <a:lnTo>
                        <a:pt x="703" y="80"/>
                      </a:lnTo>
                      <a:lnTo>
                        <a:pt x="704" y="80"/>
                      </a:lnTo>
                      <a:lnTo>
                        <a:pt x="704" y="79"/>
                      </a:lnTo>
                      <a:lnTo>
                        <a:pt x="704" y="83"/>
                      </a:lnTo>
                      <a:lnTo>
                        <a:pt x="704" y="81"/>
                      </a:lnTo>
                      <a:lnTo>
                        <a:pt x="705" y="81"/>
                      </a:lnTo>
                      <a:lnTo>
                        <a:pt x="705" y="78"/>
                      </a:lnTo>
                      <a:lnTo>
                        <a:pt x="705" y="81"/>
                      </a:lnTo>
                      <a:lnTo>
                        <a:pt x="705" y="78"/>
                      </a:lnTo>
                      <a:lnTo>
                        <a:pt x="706" y="78"/>
                      </a:lnTo>
                      <a:lnTo>
                        <a:pt x="706" y="78"/>
                      </a:lnTo>
                      <a:lnTo>
                        <a:pt x="706" y="81"/>
                      </a:lnTo>
                      <a:lnTo>
                        <a:pt x="706" y="80"/>
                      </a:lnTo>
                      <a:lnTo>
                        <a:pt x="707" y="80"/>
                      </a:lnTo>
                      <a:lnTo>
                        <a:pt x="707" y="77"/>
                      </a:lnTo>
                      <a:lnTo>
                        <a:pt x="707" y="81"/>
                      </a:lnTo>
                      <a:lnTo>
                        <a:pt x="707" y="79"/>
                      </a:lnTo>
                      <a:lnTo>
                        <a:pt x="708" y="79"/>
                      </a:lnTo>
                      <a:lnTo>
                        <a:pt x="708" y="79"/>
                      </a:lnTo>
                      <a:lnTo>
                        <a:pt x="708" y="91"/>
                      </a:lnTo>
                      <a:lnTo>
                        <a:pt x="708" y="85"/>
                      </a:lnTo>
                      <a:lnTo>
                        <a:pt x="709" y="85"/>
                      </a:lnTo>
                      <a:lnTo>
                        <a:pt x="709" y="73"/>
                      </a:lnTo>
                      <a:lnTo>
                        <a:pt x="709" y="85"/>
                      </a:lnTo>
                      <a:lnTo>
                        <a:pt x="709" y="78"/>
                      </a:lnTo>
                      <a:lnTo>
                        <a:pt x="710" y="78"/>
                      </a:lnTo>
                      <a:lnTo>
                        <a:pt x="710" y="76"/>
                      </a:lnTo>
                      <a:lnTo>
                        <a:pt x="710" y="78"/>
                      </a:lnTo>
                      <a:lnTo>
                        <a:pt x="710" y="77"/>
                      </a:lnTo>
                      <a:lnTo>
                        <a:pt x="711" y="77"/>
                      </a:lnTo>
                      <a:lnTo>
                        <a:pt x="711" y="77"/>
                      </a:lnTo>
                      <a:lnTo>
                        <a:pt x="711" y="79"/>
                      </a:lnTo>
                      <a:lnTo>
                        <a:pt x="711" y="79"/>
                      </a:lnTo>
                      <a:lnTo>
                        <a:pt x="712" y="79"/>
                      </a:lnTo>
                      <a:lnTo>
                        <a:pt x="712" y="78"/>
                      </a:lnTo>
                      <a:lnTo>
                        <a:pt x="712" y="82"/>
                      </a:lnTo>
                      <a:lnTo>
                        <a:pt x="712" y="79"/>
                      </a:lnTo>
                      <a:lnTo>
                        <a:pt x="713" y="79"/>
                      </a:lnTo>
                      <a:lnTo>
                        <a:pt x="713" y="78"/>
                      </a:lnTo>
                      <a:lnTo>
                        <a:pt x="713" y="81"/>
                      </a:lnTo>
                      <a:lnTo>
                        <a:pt x="713" y="79"/>
                      </a:lnTo>
                      <a:lnTo>
                        <a:pt x="714" y="79"/>
                      </a:lnTo>
                      <a:lnTo>
                        <a:pt x="714" y="77"/>
                      </a:lnTo>
                      <a:lnTo>
                        <a:pt x="714" y="81"/>
                      </a:lnTo>
                      <a:lnTo>
                        <a:pt x="714" y="79"/>
                      </a:lnTo>
                      <a:lnTo>
                        <a:pt x="715" y="79"/>
                      </a:lnTo>
                      <a:lnTo>
                        <a:pt x="715" y="78"/>
                      </a:lnTo>
                      <a:lnTo>
                        <a:pt x="715" y="80"/>
                      </a:lnTo>
                      <a:lnTo>
                        <a:pt x="715" y="80"/>
                      </a:lnTo>
                      <a:lnTo>
                        <a:pt x="716" y="80"/>
                      </a:lnTo>
                      <a:lnTo>
                        <a:pt x="716" y="77"/>
                      </a:lnTo>
                      <a:lnTo>
                        <a:pt x="716" y="80"/>
                      </a:lnTo>
                      <a:lnTo>
                        <a:pt x="716" y="79"/>
                      </a:lnTo>
                      <a:lnTo>
                        <a:pt x="717" y="79"/>
                      </a:lnTo>
                      <a:lnTo>
                        <a:pt x="717" y="76"/>
                      </a:lnTo>
                      <a:lnTo>
                        <a:pt x="717" y="80"/>
                      </a:lnTo>
                      <a:lnTo>
                        <a:pt x="717" y="80"/>
                      </a:lnTo>
                      <a:lnTo>
                        <a:pt x="718" y="80"/>
                      </a:lnTo>
                      <a:lnTo>
                        <a:pt x="718" y="77"/>
                      </a:lnTo>
                      <a:lnTo>
                        <a:pt x="718" y="81"/>
                      </a:lnTo>
                      <a:lnTo>
                        <a:pt x="718" y="80"/>
                      </a:lnTo>
                      <a:lnTo>
                        <a:pt x="719" y="80"/>
                      </a:lnTo>
                      <a:lnTo>
                        <a:pt x="719" y="77"/>
                      </a:lnTo>
                      <a:lnTo>
                        <a:pt x="719" y="80"/>
                      </a:lnTo>
                      <a:lnTo>
                        <a:pt x="719" y="78"/>
                      </a:lnTo>
                      <a:lnTo>
                        <a:pt x="720" y="78"/>
                      </a:lnTo>
                      <a:lnTo>
                        <a:pt x="720" y="78"/>
                      </a:lnTo>
                      <a:lnTo>
                        <a:pt x="720" y="80"/>
                      </a:lnTo>
                      <a:lnTo>
                        <a:pt x="720" y="78"/>
                      </a:lnTo>
                      <a:lnTo>
                        <a:pt x="721" y="78"/>
                      </a:lnTo>
                      <a:lnTo>
                        <a:pt x="721" y="77"/>
                      </a:lnTo>
                      <a:lnTo>
                        <a:pt x="721" y="81"/>
                      </a:lnTo>
                      <a:lnTo>
                        <a:pt x="721" y="80"/>
                      </a:lnTo>
                      <a:lnTo>
                        <a:pt x="722" y="80"/>
                      </a:lnTo>
                      <a:lnTo>
                        <a:pt x="722" y="79"/>
                      </a:lnTo>
                      <a:lnTo>
                        <a:pt x="722" y="81"/>
                      </a:lnTo>
                      <a:lnTo>
                        <a:pt x="722" y="79"/>
                      </a:lnTo>
                      <a:lnTo>
                        <a:pt x="723" y="79"/>
                      </a:lnTo>
                      <a:lnTo>
                        <a:pt x="723" y="77"/>
                      </a:lnTo>
                      <a:lnTo>
                        <a:pt x="723" y="80"/>
                      </a:lnTo>
                      <a:lnTo>
                        <a:pt x="723" y="78"/>
                      </a:lnTo>
                      <a:lnTo>
                        <a:pt x="724" y="78"/>
                      </a:lnTo>
                      <a:lnTo>
                        <a:pt x="724" y="78"/>
                      </a:lnTo>
                      <a:lnTo>
                        <a:pt x="724" y="80"/>
                      </a:lnTo>
                      <a:lnTo>
                        <a:pt x="724" y="80"/>
                      </a:lnTo>
                      <a:lnTo>
                        <a:pt x="725" y="80"/>
                      </a:lnTo>
                      <a:lnTo>
                        <a:pt x="725" y="78"/>
                      </a:lnTo>
                      <a:lnTo>
                        <a:pt x="725" y="80"/>
                      </a:lnTo>
                      <a:lnTo>
                        <a:pt x="725" y="80"/>
                      </a:lnTo>
                      <a:lnTo>
                        <a:pt x="726" y="80"/>
                      </a:lnTo>
                      <a:lnTo>
                        <a:pt x="726" y="78"/>
                      </a:lnTo>
                      <a:lnTo>
                        <a:pt x="726" y="81"/>
                      </a:lnTo>
                      <a:lnTo>
                        <a:pt x="726" y="80"/>
                      </a:lnTo>
                      <a:lnTo>
                        <a:pt x="727" y="80"/>
                      </a:lnTo>
                      <a:lnTo>
                        <a:pt x="727" y="77"/>
                      </a:lnTo>
                      <a:lnTo>
                        <a:pt x="727" y="80"/>
                      </a:lnTo>
                      <a:lnTo>
                        <a:pt x="727" y="77"/>
                      </a:lnTo>
                      <a:lnTo>
                        <a:pt x="728" y="77"/>
                      </a:lnTo>
                      <a:lnTo>
                        <a:pt x="728" y="77"/>
                      </a:lnTo>
                      <a:lnTo>
                        <a:pt x="728" y="80"/>
                      </a:lnTo>
                      <a:lnTo>
                        <a:pt x="728" y="79"/>
                      </a:lnTo>
                      <a:lnTo>
                        <a:pt x="729" y="79"/>
                      </a:lnTo>
                      <a:lnTo>
                        <a:pt x="729" y="78"/>
                      </a:lnTo>
                      <a:lnTo>
                        <a:pt x="729" y="80"/>
                      </a:lnTo>
                      <a:lnTo>
                        <a:pt x="729" y="78"/>
                      </a:lnTo>
                      <a:lnTo>
                        <a:pt x="730" y="78"/>
                      </a:lnTo>
                      <a:lnTo>
                        <a:pt x="730" y="77"/>
                      </a:lnTo>
                      <a:lnTo>
                        <a:pt x="730" y="80"/>
                      </a:lnTo>
                      <a:lnTo>
                        <a:pt x="730" y="78"/>
                      </a:lnTo>
                      <a:lnTo>
                        <a:pt x="731" y="78"/>
                      </a:lnTo>
                      <a:lnTo>
                        <a:pt x="731" y="75"/>
                      </a:lnTo>
                      <a:lnTo>
                        <a:pt x="731" y="78"/>
                      </a:lnTo>
                      <a:lnTo>
                        <a:pt x="731" y="77"/>
                      </a:lnTo>
                      <a:lnTo>
                        <a:pt x="732" y="77"/>
                      </a:lnTo>
                      <a:lnTo>
                        <a:pt x="732" y="76"/>
                      </a:lnTo>
                      <a:lnTo>
                        <a:pt x="732" y="79"/>
                      </a:lnTo>
                      <a:lnTo>
                        <a:pt x="732" y="79"/>
                      </a:lnTo>
                      <a:lnTo>
                        <a:pt x="733" y="79"/>
                      </a:lnTo>
                      <a:lnTo>
                        <a:pt x="733" y="77"/>
                      </a:lnTo>
                      <a:lnTo>
                        <a:pt x="733" y="80"/>
                      </a:lnTo>
                      <a:lnTo>
                        <a:pt x="733" y="80"/>
                      </a:lnTo>
                      <a:lnTo>
                        <a:pt x="734" y="80"/>
                      </a:lnTo>
                      <a:lnTo>
                        <a:pt x="734" y="77"/>
                      </a:lnTo>
                      <a:lnTo>
                        <a:pt x="734" y="80"/>
                      </a:lnTo>
                      <a:lnTo>
                        <a:pt x="734" y="77"/>
                      </a:lnTo>
                      <a:lnTo>
                        <a:pt x="735" y="77"/>
                      </a:lnTo>
                      <a:lnTo>
                        <a:pt x="735" y="76"/>
                      </a:lnTo>
                      <a:lnTo>
                        <a:pt x="735" y="79"/>
                      </a:lnTo>
                      <a:lnTo>
                        <a:pt x="735" y="77"/>
                      </a:lnTo>
                      <a:lnTo>
                        <a:pt x="736" y="77"/>
                      </a:lnTo>
                      <a:lnTo>
                        <a:pt x="736" y="76"/>
                      </a:lnTo>
                      <a:lnTo>
                        <a:pt x="736" y="79"/>
                      </a:lnTo>
                      <a:lnTo>
                        <a:pt x="736" y="77"/>
                      </a:lnTo>
                      <a:lnTo>
                        <a:pt x="737" y="77"/>
                      </a:lnTo>
                      <a:lnTo>
                        <a:pt x="737" y="75"/>
                      </a:lnTo>
                      <a:lnTo>
                        <a:pt x="737" y="78"/>
                      </a:lnTo>
                      <a:lnTo>
                        <a:pt x="737" y="75"/>
                      </a:lnTo>
                      <a:lnTo>
                        <a:pt x="738" y="75"/>
                      </a:lnTo>
                      <a:lnTo>
                        <a:pt x="738" y="75"/>
                      </a:lnTo>
                      <a:lnTo>
                        <a:pt x="738" y="79"/>
                      </a:lnTo>
                      <a:lnTo>
                        <a:pt x="738" y="77"/>
                      </a:lnTo>
                      <a:lnTo>
                        <a:pt x="739" y="77"/>
                      </a:lnTo>
                      <a:lnTo>
                        <a:pt x="739" y="76"/>
                      </a:lnTo>
                      <a:lnTo>
                        <a:pt x="739" y="79"/>
                      </a:lnTo>
                      <a:lnTo>
                        <a:pt x="739" y="77"/>
                      </a:lnTo>
                      <a:lnTo>
                        <a:pt x="740" y="77"/>
                      </a:lnTo>
                      <a:lnTo>
                        <a:pt x="740" y="75"/>
                      </a:lnTo>
                      <a:lnTo>
                        <a:pt x="740" y="79"/>
                      </a:lnTo>
                      <a:lnTo>
                        <a:pt x="740" y="77"/>
                      </a:lnTo>
                      <a:lnTo>
                        <a:pt x="741" y="77"/>
                      </a:lnTo>
                      <a:lnTo>
                        <a:pt x="741" y="74"/>
                      </a:lnTo>
                      <a:lnTo>
                        <a:pt x="741" y="77"/>
                      </a:lnTo>
                      <a:lnTo>
                        <a:pt x="741" y="77"/>
                      </a:lnTo>
                      <a:lnTo>
                        <a:pt x="742" y="77"/>
                      </a:lnTo>
                      <a:lnTo>
                        <a:pt x="742" y="76"/>
                      </a:lnTo>
                      <a:lnTo>
                        <a:pt x="742" y="79"/>
                      </a:lnTo>
                      <a:lnTo>
                        <a:pt x="742" y="78"/>
                      </a:lnTo>
                      <a:lnTo>
                        <a:pt x="743" y="78"/>
                      </a:lnTo>
                      <a:lnTo>
                        <a:pt x="743" y="76"/>
                      </a:lnTo>
                      <a:lnTo>
                        <a:pt x="743" y="79"/>
                      </a:lnTo>
                      <a:lnTo>
                        <a:pt x="743" y="76"/>
                      </a:lnTo>
                      <a:lnTo>
                        <a:pt x="744" y="76"/>
                      </a:lnTo>
                      <a:lnTo>
                        <a:pt x="744" y="74"/>
                      </a:lnTo>
                      <a:lnTo>
                        <a:pt x="744" y="78"/>
                      </a:lnTo>
                      <a:lnTo>
                        <a:pt x="744" y="75"/>
                      </a:lnTo>
                      <a:lnTo>
                        <a:pt x="745" y="75"/>
                      </a:lnTo>
                      <a:lnTo>
                        <a:pt x="745" y="75"/>
                      </a:lnTo>
                      <a:lnTo>
                        <a:pt x="745" y="77"/>
                      </a:lnTo>
                      <a:lnTo>
                        <a:pt x="745" y="75"/>
                      </a:lnTo>
                      <a:lnTo>
                        <a:pt x="746" y="75"/>
                      </a:lnTo>
                      <a:lnTo>
                        <a:pt x="746" y="74"/>
                      </a:lnTo>
                      <a:lnTo>
                        <a:pt x="746" y="76"/>
                      </a:lnTo>
                      <a:lnTo>
                        <a:pt x="746" y="76"/>
                      </a:lnTo>
                      <a:lnTo>
                        <a:pt x="747" y="76"/>
                      </a:lnTo>
                      <a:lnTo>
                        <a:pt x="747" y="74"/>
                      </a:lnTo>
                      <a:lnTo>
                        <a:pt x="747" y="77"/>
                      </a:lnTo>
                      <a:lnTo>
                        <a:pt x="747" y="77"/>
                      </a:lnTo>
                      <a:lnTo>
                        <a:pt x="748" y="77"/>
                      </a:lnTo>
                      <a:lnTo>
                        <a:pt x="748" y="74"/>
                      </a:lnTo>
                      <a:lnTo>
                        <a:pt x="748" y="77"/>
                      </a:lnTo>
                      <a:lnTo>
                        <a:pt x="748" y="76"/>
                      </a:lnTo>
                      <a:lnTo>
                        <a:pt x="749" y="76"/>
                      </a:lnTo>
                      <a:lnTo>
                        <a:pt x="749" y="73"/>
                      </a:lnTo>
                      <a:lnTo>
                        <a:pt x="749" y="77"/>
                      </a:lnTo>
                      <a:lnTo>
                        <a:pt x="749" y="75"/>
                      </a:lnTo>
                      <a:lnTo>
                        <a:pt x="750" y="75"/>
                      </a:lnTo>
                      <a:lnTo>
                        <a:pt x="750" y="73"/>
                      </a:lnTo>
                      <a:lnTo>
                        <a:pt x="750" y="75"/>
                      </a:lnTo>
                      <a:lnTo>
                        <a:pt x="750" y="75"/>
                      </a:lnTo>
                      <a:lnTo>
                        <a:pt x="751" y="75"/>
                      </a:lnTo>
                      <a:lnTo>
                        <a:pt x="751" y="72"/>
                      </a:lnTo>
                      <a:lnTo>
                        <a:pt x="751" y="75"/>
                      </a:lnTo>
                      <a:lnTo>
                        <a:pt x="751" y="72"/>
                      </a:lnTo>
                      <a:lnTo>
                        <a:pt x="752" y="72"/>
                      </a:lnTo>
                      <a:lnTo>
                        <a:pt x="752" y="71"/>
                      </a:lnTo>
                      <a:lnTo>
                        <a:pt x="752" y="74"/>
                      </a:lnTo>
                      <a:lnTo>
                        <a:pt x="752" y="73"/>
                      </a:lnTo>
                      <a:lnTo>
                        <a:pt x="753" y="73"/>
                      </a:lnTo>
                      <a:lnTo>
                        <a:pt x="753" y="73"/>
                      </a:lnTo>
                      <a:lnTo>
                        <a:pt x="753" y="75"/>
                      </a:lnTo>
                      <a:lnTo>
                        <a:pt x="753" y="73"/>
                      </a:lnTo>
                      <a:lnTo>
                        <a:pt x="754" y="73"/>
                      </a:lnTo>
                      <a:lnTo>
                        <a:pt x="754" y="74"/>
                      </a:lnTo>
                      <a:lnTo>
                        <a:pt x="754" y="76"/>
                      </a:lnTo>
                      <a:lnTo>
                        <a:pt x="754" y="74"/>
                      </a:lnTo>
                      <a:lnTo>
                        <a:pt x="755" y="74"/>
                      </a:lnTo>
                      <a:lnTo>
                        <a:pt x="755" y="73"/>
                      </a:lnTo>
                      <a:lnTo>
                        <a:pt x="755" y="75"/>
                      </a:lnTo>
                      <a:lnTo>
                        <a:pt x="755" y="73"/>
                      </a:lnTo>
                      <a:lnTo>
                        <a:pt x="756" y="73"/>
                      </a:lnTo>
                      <a:lnTo>
                        <a:pt x="756" y="72"/>
                      </a:lnTo>
                      <a:lnTo>
                        <a:pt x="756" y="75"/>
                      </a:lnTo>
                      <a:lnTo>
                        <a:pt x="756" y="74"/>
                      </a:lnTo>
                      <a:lnTo>
                        <a:pt x="757" y="74"/>
                      </a:lnTo>
                      <a:lnTo>
                        <a:pt x="757" y="72"/>
                      </a:lnTo>
                      <a:lnTo>
                        <a:pt x="757" y="76"/>
                      </a:lnTo>
                      <a:lnTo>
                        <a:pt x="757" y="74"/>
                      </a:lnTo>
                      <a:lnTo>
                        <a:pt x="758" y="74"/>
                      </a:lnTo>
                      <a:lnTo>
                        <a:pt x="758" y="72"/>
                      </a:lnTo>
                      <a:lnTo>
                        <a:pt x="758" y="76"/>
                      </a:lnTo>
                      <a:lnTo>
                        <a:pt x="758" y="74"/>
                      </a:lnTo>
                      <a:lnTo>
                        <a:pt x="759" y="74"/>
                      </a:lnTo>
                      <a:lnTo>
                        <a:pt x="759" y="71"/>
                      </a:lnTo>
                      <a:lnTo>
                        <a:pt x="759" y="75"/>
                      </a:lnTo>
                      <a:lnTo>
                        <a:pt x="759" y="73"/>
                      </a:lnTo>
                      <a:lnTo>
                        <a:pt x="760" y="73"/>
                      </a:lnTo>
                      <a:lnTo>
                        <a:pt x="760" y="71"/>
                      </a:lnTo>
                      <a:lnTo>
                        <a:pt x="760" y="74"/>
                      </a:lnTo>
                      <a:lnTo>
                        <a:pt x="760" y="71"/>
                      </a:lnTo>
                      <a:lnTo>
                        <a:pt x="761" y="71"/>
                      </a:lnTo>
                      <a:lnTo>
                        <a:pt x="761" y="71"/>
                      </a:lnTo>
                      <a:lnTo>
                        <a:pt x="761" y="74"/>
                      </a:lnTo>
                      <a:lnTo>
                        <a:pt x="761" y="71"/>
                      </a:lnTo>
                      <a:lnTo>
                        <a:pt x="762" y="71"/>
                      </a:lnTo>
                      <a:lnTo>
                        <a:pt x="762" y="71"/>
                      </a:lnTo>
                      <a:lnTo>
                        <a:pt x="762" y="75"/>
                      </a:lnTo>
                      <a:lnTo>
                        <a:pt x="762" y="73"/>
                      </a:lnTo>
                      <a:lnTo>
                        <a:pt x="763" y="73"/>
                      </a:lnTo>
                      <a:lnTo>
                        <a:pt x="763" y="72"/>
                      </a:lnTo>
                      <a:lnTo>
                        <a:pt x="763" y="75"/>
                      </a:lnTo>
                      <a:lnTo>
                        <a:pt x="763" y="73"/>
                      </a:lnTo>
                      <a:lnTo>
                        <a:pt x="764" y="73"/>
                      </a:lnTo>
                      <a:lnTo>
                        <a:pt x="764" y="71"/>
                      </a:lnTo>
                      <a:lnTo>
                        <a:pt x="764" y="74"/>
                      </a:lnTo>
                      <a:lnTo>
                        <a:pt x="764" y="74"/>
                      </a:lnTo>
                      <a:lnTo>
                        <a:pt x="765" y="74"/>
                      </a:lnTo>
                      <a:lnTo>
                        <a:pt x="765" y="73"/>
                      </a:lnTo>
                      <a:lnTo>
                        <a:pt x="765" y="74"/>
                      </a:lnTo>
                      <a:lnTo>
                        <a:pt x="765" y="73"/>
                      </a:lnTo>
                      <a:lnTo>
                        <a:pt x="766" y="73"/>
                      </a:lnTo>
                      <a:lnTo>
                        <a:pt x="766" y="70"/>
                      </a:lnTo>
                      <a:lnTo>
                        <a:pt x="766" y="75"/>
                      </a:lnTo>
                      <a:lnTo>
                        <a:pt x="766" y="73"/>
                      </a:lnTo>
                      <a:lnTo>
                        <a:pt x="767" y="73"/>
                      </a:lnTo>
                      <a:lnTo>
                        <a:pt x="767" y="70"/>
                      </a:lnTo>
                      <a:lnTo>
                        <a:pt x="767" y="73"/>
                      </a:lnTo>
                      <a:lnTo>
                        <a:pt x="767" y="71"/>
                      </a:lnTo>
                      <a:lnTo>
                        <a:pt x="768" y="71"/>
                      </a:lnTo>
                      <a:lnTo>
                        <a:pt x="768" y="70"/>
                      </a:lnTo>
                      <a:lnTo>
                        <a:pt x="768" y="73"/>
                      </a:lnTo>
                      <a:lnTo>
                        <a:pt x="768" y="71"/>
                      </a:lnTo>
                      <a:lnTo>
                        <a:pt x="769" y="71"/>
                      </a:lnTo>
                      <a:lnTo>
                        <a:pt x="769" y="69"/>
                      </a:lnTo>
                      <a:lnTo>
                        <a:pt x="769" y="73"/>
                      </a:lnTo>
                      <a:lnTo>
                        <a:pt x="769" y="69"/>
                      </a:lnTo>
                      <a:lnTo>
                        <a:pt x="770" y="69"/>
                      </a:lnTo>
                      <a:lnTo>
                        <a:pt x="770" y="68"/>
                      </a:lnTo>
                      <a:lnTo>
                        <a:pt x="770" y="72"/>
                      </a:lnTo>
                      <a:lnTo>
                        <a:pt x="770" y="70"/>
                      </a:lnTo>
                      <a:lnTo>
                        <a:pt x="771" y="70"/>
                      </a:lnTo>
                      <a:lnTo>
                        <a:pt x="771" y="70"/>
                      </a:lnTo>
                      <a:lnTo>
                        <a:pt x="771" y="74"/>
                      </a:lnTo>
                      <a:lnTo>
                        <a:pt x="771" y="73"/>
                      </a:lnTo>
                      <a:lnTo>
                        <a:pt x="772" y="73"/>
                      </a:lnTo>
                      <a:lnTo>
                        <a:pt x="772" y="68"/>
                      </a:lnTo>
                      <a:lnTo>
                        <a:pt x="772" y="73"/>
                      </a:lnTo>
                      <a:lnTo>
                        <a:pt x="772" y="70"/>
                      </a:lnTo>
                      <a:lnTo>
                        <a:pt x="773" y="70"/>
                      </a:lnTo>
                      <a:lnTo>
                        <a:pt x="773" y="68"/>
                      </a:lnTo>
                      <a:lnTo>
                        <a:pt x="773" y="73"/>
                      </a:lnTo>
                      <a:lnTo>
                        <a:pt x="773" y="71"/>
                      </a:lnTo>
                      <a:lnTo>
                        <a:pt x="774" y="71"/>
                      </a:lnTo>
                      <a:lnTo>
                        <a:pt x="774" y="68"/>
                      </a:lnTo>
                      <a:lnTo>
                        <a:pt x="774" y="71"/>
                      </a:lnTo>
                      <a:lnTo>
                        <a:pt x="774" y="71"/>
                      </a:lnTo>
                      <a:lnTo>
                        <a:pt x="775" y="71"/>
                      </a:lnTo>
                      <a:lnTo>
                        <a:pt x="775" y="68"/>
                      </a:lnTo>
                      <a:lnTo>
                        <a:pt x="775" y="70"/>
                      </a:lnTo>
                      <a:lnTo>
                        <a:pt x="775" y="69"/>
                      </a:lnTo>
                      <a:lnTo>
                        <a:pt x="776" y="69"/>
                      </a:lnTo>
                      <a:lnTo>
                        <a:pt x="776" y="67"/>
                      </a:lnTo>
                      <a:lnTo>
                        <a:pt x="776" y="70"/>
                      </a:lnTo>
                      <a:lnTo>
                        <a:pt x="776" y="67"/>
                      </a:lnTo>
                      <a:lnTo>
                        <a:pt x="777" y="67"/>
                      </a:lnTo>
                      <a:lnTo>
                        <a:pt x="777" y="66"/>
                      </a:lnTo>
                      <a:lnTo>
                        <a:pt x="777" y="69"/>
                      </a:lnTo>
                      <a:lnTo>
                        <a:pt x="777" y="67"/>
                      </a:lnTo>
                      <a:lnTo>
                        <a:pt x="778" y="67"/>
                      </a:lnTo>
                      <a:lnTo>
                        <a:pt x="778" y="67"/>
                      </a:lnTo>
                      <a:lnTo>
                        <a:pt x="778" y="69"/>
                      </a:lnTo>
                      <a:lnTo>
                        <a:pt x="778" y="67"/>
                      </a:lnTo>
                      <a:lnTo>
                        <a:pt x="779" y="67"/>
                      </a:lnTo>
                      <a:lnTo>
                        <a:pt x="779" y="65"/>
                      </a:lnTo>
                      <a:lnTo>
                        <a:pt x="779" y="68"/>
                      </a:lnTo>
                      <a:lnTo>
                        <a:pt x="779" y="66"/>
                      </a:lnTo>
                      <a:lnTo>
                        <a:pt x="780" y="66"/>
                      </a:lnTo>
                      <a:lnTo>
                        <a:pt x="780" y="66"/>
                      </a:lnTo>
                      <a:lnTo>
                        <a:pt x="780" y="70"/>
                      </a:lnTo>
                      <a:lnTo>
                        <a:pt x="780" y="67"/>
                      </a:lnTo>
                      <a:lnTo>
                        <a:pt x="781" y="67"/>
                      </a:lnTo>
                      <a:lnTo>
                        <a:pt x="781" y="65"/>
                      </a:lnTo>
                      <a:lnTo>
                        <a:pt x="781" y="68"/>
                      </a:lnTo>
                      <a:lnTo>
                        <a:pt x="781" y="67"/>
                      </a:lnTo>
                      <a:lnTo>
                        <a:pt x="782" y="67"/>
                      </a:lnTo>
                      <a:lnTo>
                        <a:pt x="782" y="65"/>
                      </a:lnTo>
                      <a:lnTo>
                        <a:pt x="782" y="68"/>
                      </a:lnTo>
                      <a:lnTo>
                        <a:pt x="782" y="67"/>
                      </a:lnTo>
                      <a:lnTo>
                        <a:pt x="783" y="67"/>
                      </a:lnTo>
                      <a:lnTo>
                        <a:pt x="783" y="65"/>
                      </a:lnTo>
                      <a:lnTo>
                        <a:pt x="783" y="67"/>
                      </a:lnTo>
                      <a:lnTo>
                        <a:pt x="783" y="65"/>
                      </a:lnTo>
                      <a:lnTo>
                        <a:pt x="784" y="65"/>
                      </a:lnTo>
                      <a:lnTo>
                        <a:pt x="784" y="64"/>
                      </a:lnTo>
                      <a:lnTo>
                        <a:pt x="784" y="67"/>
                      </a:lnTo>
                      <a:lnTo>
                        <a:pt x="784" y="64"/>
                      </a:lnTo>
                      <a:lnTo>
                        <a:pt x="785" y="64"/>
                      </a:lnTo>
                      <a:lnTo>
                        <a:pt x="785" y="62"/>
                      </a:lnTo>
                      <a:lnTo>
                        <a:pt x="785" y="64"/>
                      </a:lnTo>
                      <a:lnTo>
                        <a:pt x="785" y="62"/>
                      </a:lnTo>
                      <a:lnTo>
                        <a:pt x="786" y="62"/>
                      </a:lnTo>
                      <a:lnTo>
                        <a:pt x="786" y="62"/>
                      </a:lnTo>
                      <a:lnTo>
                        <a:pt x="786" y="65"/>
                      </a:lnTo>
                      <a:lnTo>
                        <a:pt x="786" y="64"/>
                      </a:lnTo>
                      <a:lnTo>
                        <a:pt x="787" y="64"/>
                      </a:lnTo>
                      <a:lnTo>
                        <a:pt x="787" y="62"/>
                      </a:lnTo>
                      <a:lnTo>
                        <a:pt x="787" y="66"/>
                      </a:lnTo>
                      <a:lnTo>
                        <a:pt x="787" y="62"/>
                      </a:lnTo>
                      <a:lnTo>
                        <a:pt x="788" y="62"/>
                      </a:lnTo>
                      <a:lnTo>
                        <a:pt x="788" y="62"/>
                      </a:lnTo>
                      <a:lnTo>
                        <a:pt x="788" y="65"/>
                      </a:lnTo>
                      <a:lnTo>
                        <a:pt x="788" y="64"/>
                      </a:lnTo>
                      <a:lnTo>
                        <a:pt x="789" y="64"/>
                      </a:lnTo>
                      <a:lnTo>
                        <a:pt x="789" y="62"/>
                      </a:lnTo>
                      <a:lnTo>
                        <a:pt x="789" y="65"/>
                      </a:lnTo>
                      <a:lnTo>
                        <a:pt x="789" y="65"/>
                      </a:lnTo>
                      <a:lnTo>
                        <a:pt x="790" y="65"/>
                      </a:lnTo>
                      <a:lnTo>
                        <a:pt x="790" y="60"/>
                      </a:lnTo>
                      <a:lnTo>
                        <a:pt x="790" y="65"/>
                      </a:lnTo>
                      <a:lnTo>
                        <a:pt x="790" y="64"/>
                      </a:lnTo>
                      <a:lnTo>
                        <a:pt x="791" y="64"/>
                      </a:lnTo>
                      <a:lnTo>
                        <a:pt x="791" y="61"/>
                      </a:lnTo>
                      <a:lnTo>
                        <a:pt x="791" y="64"/>
                      </a:lnTo>
                      <a:lnTo>
                        <a:pt x="791" y="61"/>
                      </a:lnTo>
                      <a:lnTo>
                        <a:pt x="792" y="61"/>
                      </a:lnTo>
                      <a:lnTo>
                        <a:pt x="792" y="61"/>
                      </a:lnTo>
                      <a:lnTo>
                        <a:pt x="792" y="64"/>
                      </a:lnTo>
                      <a:lnTo>
                        <a:pt x="792" y="62"/>
                      </a:lnTo>
                      <a:lnTo>
                        <a:pt x="793" y="62"/>
                      </a:lnTo>
                      <a:lnTo>
                        <a:pt x="793" y="61"/>
                      </a:lnTo>
                      <a:lnTo>
                        <a:pt x="793" y="63"/>
                      </a:lnTo>
                      <a:lnTo>
                        <a:pt x="793" y="61"/>
                      </a:lnTo>
                      <a:lnTo>
                        <a:pt x="794" y="61"/>
                      </a:lnTo>
                      <a:lnTo>
                        <a:pt x="794" y="61"/>
                      </a:lnTo>
                      <a:lnTo>
                        <a:pt x="794" y="63"/>
                      </a:lnTo>
                      <a:lnTo>
                        <a:pt x="794" y="61"/>
                      </a:lnTo>
                      <a:lnTo>
                        <a:pt x="795" y="61"/>
                      </a:lnTo>
                      <a:lnTo>
                        <a:pt x="795" y="59"/>
                      </a:lnTo>
                      <a:lnTo>
                        <a:pt x="795" y="63"/>
                      </a:lnTo>
                      <a:lnTo>
                        <a:pt x="795" y="62"/>
                      </a:lnTo>
                      <a:lnTo>
                        <a:pt x="796" y="62"/>
                      </a:lnTo>
                      <a:lnTo>
                        <a:pt x="796" y="61"/>
                      </a:lnTo>
                      <a:lnTo>
                        <a:pt x="796" y="63"/>
                      </a:lnTo>
                      <a:lnTo>
                        <a:pt x="796" y="62"/>
                      </a:lnTo>
                      <a:lnTo>
                        <a:pt x="797" y="62"/>
                      </a:lnTo>
                      <a:lnTo>
                        <a:pt x="797" y="61"/>
                      </a:lnTo>
                      <a:lnTo>
                        <a:pt x="797" y="62"/>
                      </a:lnTo>
                      <a:lnTo>
                        <a:pt x="797" y="62"/>
                      </a:lnTo>
                      <a:lnTo>
                        <a:pt x="798" y="62"/>
                      </a:lnTo>
                      <a:lnTo>
                        <a:pt x="798" y="61"/>
                      </a:lnTo>
                      <a:lnTo>
                        <a:pt x="798" y="63"/>
                      </a:lnTo>
                      <a:lnTo>
                        <a:pt x="798" y="63"/>
                      </a:lnTo>
                      <a:lnTo>
                        <a:pt x="799" y="63"/>
                      </a:lnTo>
                      <a:lnTo>
                        <a:pt x="799" y="58"/>
                      </a:lnTo>
                      <a:lnTo>
                        <a:pt x="799" y="64"/>
                      </a:lnTo>
                      <a:lnTo>
                        <a:pt x="799" y="58"/>
                      </a:lnTo>
                      <a:lnTo>
                        <a:pt x="800" y="58"/>
                      </a:lnTo>
                      <a:lnTo>
                        <a:pt x="800" y="58"/>
                      </a:lnTo>
                      <a:lnTo>
                        <a:pt x="800" y="61"/>
                      </a:lnTo>
                      <a:lnTo>
                        <a:pt x="800" y="61"/>
                      </a:lnTo>
                      <a:lnTo>
                        <a:pt x="801" y="61"/>
                      </a:lnTo>
                      <a:lnTo>
                        <a:pt x="801" y="57"/>
                      </a:lnTo>
                      <a:lnTo>
                        <a:pt x="801" y="61"/>
                      </a:lnTo>
                      <a:lnTo>
                        <a:pt x="801" y="58"/>
                      </a:lnTo>
                      <a:lnTo>
                        <a:pt x="802" y="58"/>
                      </a:lnTo>
                      <a:lnTo>
                        <a:pt x="802" y="56"/>
                      </a:lnTo>
                      <a:lnTo>
                        <a:pt x="802" y="61"/>
                      </a:lnTo>
                      <a:lnTo>
                        <a:pt x="802" y="58"/>
                      </a:lnTo>
                      <a:lnTo>
                        <a:pt x="803" y="58"/>
                      </a:lnTo>
                      <a:lnTo>
                        <a:pt x="803" y="57"/>
                      </a:lnTo>
                      <a:lnTo>
                        <a:pt x="803" y="59"/>
                      </a:lnTo>
                      <a:lnTo>
                        <a:pt x="803" y="58"/>
                      </a:lnTo>
                      <a:lnTo>
                        <a:pt x="804" y="58"/>
                      </a:lnTo>
                      <a:lnTo>
                        <a:pt x="804" y="58"/>
                      </a:lnTo>
                      <a:lnTo>
                        <a:pt x="804" y="61"/>
                      </a:lnTo>
                      <a:lnTo>
                        <a:pt x="804" y="61"/>
                      </a:lnTo>
                      <a:lnTo>
                        <a:pt x="805" y="61"/>
                      </a:lnTo>
                      <a:lnTo>
                        <a:pt x="805" y="58"/>
                      </a:lnTo>
                      <a:lnTo>
                        <a:pt x="805" y="62"/>
                      </a:lnTo>
                      <a:lnTo>
                        <a:pt x="805" y="59"/>
                      </a:lnTo>
                      <a:lnTo>
                        <a:pt x="806" y="59"/>
                      </a:lnTo>
                      <a:lnTo>
                        <a:pt x="806" y="57"/>
                      </a:lnTo>
                      <a:lnTo>
                        <a:pt x="806" y="59"/>
                      </a:lnTo>
                      <a:lnTo>
                        <a:pt x="806" y="59"/>
                      </a:lnTo>
                      <a:lnTo>
                        <a:pt x="807" y="59"/>
                      </a:lnTo>
                      <a:lnTo>
                        <a:pt x="807" y="57"/>
                      </a:lnTo>
                      <a:lnTo>
                        <a:pt x="807" y="60"/>
                      </a:lnTo>
                      <a:lnTo>
                        <a:pt x="807" y="59"/>
                      </a:lnTo>
                      <a:lnTo>
                        <a:pt x="808" y="59"/>
                      </a:lnTo>
                      <a:lnTo>
                        <a:pt x="808" y="56"/>
                      </a:lnTo>
                      <a:lnTo>
                        <a:pt x="808" y="59"/>
                      </a:lnTo>
                      <a:lnTo>
                        <a:pt x="808" y="59"/>
                      </a:lnTo>
                      <a:lnTo>
                        <a:pt x="809" y="59"/>
                      </a:lnTo>
                      <a:lnTo>
                        <a:pt x="809" y="55"/>
                      </a:lnTo>
                      <a:lnTo>
                        <a:pt x="809" y="58"/>
                      </a:lnTo>
                      <a:lnTo>
                        <a:pt x="809" y="57"/>
                      </a:lnTo>
                      <a:lnTo>
                        <a:pt x="810" y="57"/>
                      </a:lnTo>
                      <a:lnTo>
                        <a:pt x="810" y="55"/>
                      </a:lnTo>
                      <a:lnTo>
                        <a:pt x="810" y="58"/>
                      </a:lnTo>
                      <a:lnTo>
                        <a:pt x="810" y="55"/>
                      </a:lnTo>
                      <a:lnTo>
                        <a:pt x="811" y="55"/>
                      </a:lnTo>
                      <a:lnTo>
                        <a:pt x="811" y="55"/>
                      </a:lnTo>
                      <a:lnTo>
                        <a:pt x="811" y="58"/>
                      </a:lnTo>
                      <a:lnTo>
                        <a:pt x="811" y="56"/>
                      </a:lnTo>
                      <a:lnTo>
                        <a:pt x="812" y="56"/>
                      </a:lnTo>
                      <a:lnTo>
                        <a:pt x="812" y="55"/>
                      </a:lnTo>
                      <a:lnTo>
                        <a:pt x="812" y="58"/>
                      </a:lnTo>
                      <a:lnTo>
                        <a:pt x="812" y="55"/>
                      </a:lnTo>
                      <a:lnTo>
                        <a:pt x="813" y="55"/>
                      </a:lnTo>
                      <a:lnTo>
                        <a:pt x="813" y="55"/>
                      </a:lnTo>
                      <a:lnTo>
                        <a:pt x="813" y="58"/>
                      </a:lnTo>
                      <a:lnTo>
                        <a:pt x="813" y="57"/>
                      </a:lnTo>
                      <a:lnTo>
                        <a:pt x="814" y="57"/>
                      </a:lnTo>
                      <a:lnTo>
                        <a:pt x="814" y="55"/>
                      </a:lnTo>
                      <a:lnTo>
                        <a:pt x="814" y="58"/>
                      </a:lnTo>
                      <a:lnTo>
                        <a:pt x="814" y="56"/>
                      </a:lnTo>
                      <a:lnTo>
                        <a:pt x="815" y="56"/>
                      </a:lnTo>
                      <a:lnTo>
                        <a:pt x="815" y="55"/>
                      </a:lnTo>
                      <a:lnTo>
                        <a:pt x="815" y="56"/>
                      </a:lnTo>
                      <a:lnTo>
                        <a:pt x="815" y="56"/>
                      </a:lnTo>
                      <a:lnTo>
                        <a:pt x="816" y="56"/>
                      </a:lnTo>
                      <a:lnTo>
                        <a:pt x="816" y="53"/>
                      </a:lnTo>
                      <a:lnTo>
                        <a:pt x="816" y="56"/>
                      </a:lnTo>
                      <a:lnTo>
                        <a:pt x="816" y="55"/>
                      </a:lnTo>
                      <a:lnTo>
                        <a:pt x="817" y="55"/>
                      </a:lnTo>
                      <a:lnTo>
                        <a:pt x="817" y="52"/>
                      </a:lnTo>
                      <a:lnTo>
                        <a:pt x="817" y="55"/>
                      </a:lnTo>
                      <a:lnTo>
                        <a:pt x="817" y="53"/>
                      </a:lnTo>
                      <a:lnTo>
                        <a:pt x="818" y="53"/>
                      </a:lnTo>
                      <a:lnTo>
                        <a:pt x="818" y="52"/>
                      </a:lnTo>
                      <a:lnTo>
                        <a:pt x="818" y="56"/>
                      </a:lnTo>
                      <a:lnTo>
                        <a:pt x="818" y="54"/>
                      </a:lnTo>
                      <a:lnTo>
                        <a:pt x="819" y="54"/>
                      </a:lnTo>
                      <a:lnTo>
                        <a:pt x="819" y="52"/>
                      </a:lnTo>
                      <a:lnTo>
                        <a:pt x="819" y="55"/>
                      </a:lnTo>
                      <a:lnTo>
                        <a:pt x="819" y="53"/>
                      </a:lnTo>
                      <a:lnTo>
                        <a:pt x="820" y="53"/>
                      </a:lnTo>
                      <a:lnTo>
                        <a:pt x="820" y="53"/>
                      </a:lnTo>
                      <a:lnTo>
                        <a:pt x="820" y="56"/>
                      </a:lnTo>
                      <a:lnTo>
                        <a:pt x="820" y="53"/>
                      </a:lnTo>
                      <a:lnTo>
                        <a:pt x="821" y="53"/>
                      </a:lnTo>
                      <a:lnTo>
                        <a:pt x="821" y="52"/>
                      </a:lnTo>
                      <a:lnTo>
                        <a:pt x="821" y="55"/>
                      </a:lnTo>
                      <a:lnTo>
                        <a:pt x="821" y="53"/>
                      </a:lnTo>
                      <a:lnTo>
                        <a:pt x="822" y="53"/>
                      </a:lnTo>
                      <a:lnTo>
                        <a:pt x="822" y="53"/>
                      </a:lnTo>
                      <a:lnTo>
                        <a:pt x="822" y="57"/>
                      </a:lnTo>
                      <a:lnTo>
                        <a:pt x="822" y="56"/>
                      </a:lnTo>
                      <a:lnTo>
                        <a:pt x="823" y="56"/>
                      </a:lnTo>
                      <a:lnTo>
                        <a:pt x="823" y="53"/>
                      </a:lnTo>
                      <a:lnTo>
                        <a:pt x="823" y="56"/>
                      </a:lnTo>
                      <a:lnTo>
                        <a:pt x="823" y="54"/>
                      </a:lnTo>
                      <a:lnTo>
                        <a:pt x="824" y="54"/>
                      </a:lnTo>
                      <a:lnTo>
                        <a:pt x="824" y="52"/>
                      </a:lnTo>
                      <a:lnTo>
                        <a:pt x="824" y="57"/>
                      </a:lnTo>
                      <a:lnTo>
                        <a:pt x="824" y="56"/>
                      </a:lnTo>
                      <a:lnTo>
                        <a:pt x="825" y="56"/>
                      </a:lnTo>
                      <a:lnTo>
                        <a:pt x="825" y="53"/>
                      </a:lnTo>
                      <a:lnTo>
                        <a:pt x="825" y="55"/>
                      </a:lnTo>
                      <a:lnTo>
                        <a:pt x="825" y="53"/>
                      </a:lnTo>
                      <a:lnTo>
                        <a:pt x="826" y="53"/>
                      </a:lnTo>
                      <a:lnTo>
                        <a:pt x="826" y="52"/>
                      </a:lnTo>
                      <a:lnTo>
                        <a:pt x="826" y="55"/>
                      </a:lnTo>
                      <a:lnTo>
                        <a:pt x="826" y="54"/>
                      </a:lnTo>
                      <a:lnTo>
                        <a:pt x="827" y="54"/>
                      </a:lnTo>
                      <a:lnTo>
                        <a:pt x="827" y="52"/>
                      </a:lnTo>
                      <a:lnTo>
                        <a:pt x="827" y="54"/>
                      </a:lnTo>
                      <a:lnTo>
                        <a:pt x="827" y="53"/>
                      </a:lnTo>
                      <a:lnTo>
                        <a:pt x="828" y="53"/>
                      </a:lnTo>
                      <a:lnTo>
                        <a:pt x="828" y="50"/>
                      </a:lnTo>
                      <a:lnTo>
                        <a:pt x="828" y="53"/>
                      </a:lnTo>
                      <a:lnTo>
                        <a:pt x="828" y="52"/>
                      </a:lnTo>
                      <a:lnTo>
                        <a:pt x="829" y="52"/>
                      </a:lnTo>
                      <a:lnTo>
                        <a:pt x="829" y="51"/>
                      </a:lnTo>
                      <a:lnTo>
                        <a:pt x="829" y="55"/>
                      </a:lnTo>
                      <a:lnTo>
                        <a:pt x="829" y="53"/>
                      </a:lnTo>
                      <a:lnTo>
                        <a:pt x="830" y="53"/>
                      </a:lnTo>
                      <a:lnTo>
                        <a:pt x="830" y="52"/>
                      </a:lnTo>
                      <a:lnTo>
                        <a:pt x="830" y="55"/>
                      </a:lnTo>
                      <a:lnTo>
                        <a:pt x="830" y="53"/>
                      </a:lnTo>
                      <a:lnTo>
                        <a:pt x="831" y="53"/>
                      </a:lnTo>
                      <a:lnTo>
                        <a:pt x="831" y="53"/>
                      </a:lnTo>
                      <a:lnTo>
                        <a:pt x="831" y="56"/>
                      </a:lnTo>
                      <a:lnTo>
                        <a:pt x="831" y="53"/>
                      </a:lnTo>
                      <a:lnTo>
                        <a:pt x="832" y="53"/>
                      </a:lnTo>
                      <a:lnTo>
                        <a:pt x="832" y="52"/>
                      </a:lnTo>
                      <a:lnTo>
                        <a:pt x="832" y="55"/>
                      </a:lnTo>
                      <a:lnTo>
                        <a:pt x="832" y="55"/>
                      </a:lnTo>
                      <a:lnTo>
                        <a:pt x="833" y="55"/>
                      </a:lnTo>
                      <a:lnTo>
                        <a:pt x="833" y="52"/>
                      </a:lnTo>
                      <a:lnTo>
                        <a:pt x="833" y="56"/>
                      </a:lnTo>
                      <a:lnTo>
                        <a:pt x="833" y="54"/>
                      </a:lnTo>
                      <a:lnTo>
                        <a:pt x="834" y="54"/>
                      </a:lnTo>
                      <a:lnTo>
                        <a:pt x="834" y="52"/>
                      </a:lnTo>
                      <a:lnTo>
                        <a:pt x="834" y="57"/>
                      </a:lnTo>
                      <a:lnTo>
                        <a:pt x="834" y="52"/>
                      </a:lnTo>
                      <a:lnTo>
                        <a:pt x="835" y="52"/>
                      </a:lnTo>
                      <a:lnTo>
                        <a:pt x="835" y="51"/>
                      </a:lnTo>
                      <a:lnTo>
                        <a:pt x="835" y="54"/>
                      </a:lnTo>
                      <a:lnTo>
                        <a:pt x="835" y="52"/>
                      </a:lnTo>
                      <a:lnTo>
                        <a:pt x="836" y="52"/>
                      </a:lnTo>
                      <a:lnTo>
                        <a:pt x="836" y="50"/>
                      </a:lnTo>
                      <a:lnTo>
                        <a:pt x="836" y="53"/>
                      </a:lnTo>
                      <a:lnTo>
                        <a:pt x="836" y="51"/>
                      </a:lnTo>
                      <a:lnTo>
                        <a:pt x="837" y="51"/>
                      </a:lnTo>
                      <a:lnTo>
                        <a:pt x="837" y="50"/>
                      </a:lnTo>
                      <a:lnTo>
                        <a:pt x="837" y="55"/>
                      </a:lnTo>
                      <a:lnTo>
                        <a:pt x="837" y="52"/>
                      </a:lnTo>
                      <a:lnTo>
                        <a:pt x="838" y="52"/>
                      </a:lnTo>
                      <a:lnTo>
                        <a:pt x="838" y="50"/>
                      </a:lnTo>
                      <a:lnTo>
                        <a:pt x="838" y="53"/>
                      </a:lnTo>
                      <a:lnTo>
                        <a:pt x="838" y="52"/>
                      </a:lnTo>
                      <a:lnTo>
                        <a:pt x="839" y="52"/>
                      </a:lnTo>
                      <a:lnTo>
                        <a:pt x="839" y="50"/>
                      </a:lnTo>
                      <a:lnTo>
                        <a:pt x="839" y="52"/>
                      </a:lnTo>
                      <a:lnTo>
                        <a:pt x="839" y="52"/>
                      </a:lnTo>
                      <a:lnTo>
                        <a:pt x="840" y="52"/>
                      </a:lnTo>
                      <a:lnTo>
                        <a:pt x="840" y="50"/>
                      </a:lnTo>
                      <a:lnTo>
                        <a:pt x="840" y="53"/>
                      </a:lnTo>
                      <a:lnTo>
                        <a:pt x="840" y="52"/>
                      </a:lnTo>
                      <a:lnTo>
                        <a:pt x="841" y="52"/>
                      </a:lnTo>
                      <a:lnTo>
                        <a:pt x="841" y="50"/>
                      </a:lnTo>
                      <a:lnTo>
                        <a:pt x="841" y="53"/>
                      </a:lnTo>
                      <a:lnTo>
                        <a:pt x="841" y="50"/>
                      </a:lnTo>
                      <a:lnTo>
                        <a:pt x="842" y="50"/>
                      </a:lnTo>
                      <a:lnTo>
                        <a:pt x="842" y="49"/>
                      </a:lnTo>
                      <a:lnTo>
                        <a:pt x="842" y="52"/>
                      </a:lnTo>
                      <a:lnTo>
                        <a:pt x="842" y="50"/>
                      </a:lnTo>
                      <a:lnTo>
                        <a:pt x="843" y="50"/>
                      </a:lnTo>
                      <a:lnTo>
                        <a:pt x="843" y="48"/>
                      </a:lnTo>
                      <a:lnTo>
                        <a:pt x="843" y="51"/>
                      </a:lnTo>
                      <a:lnTo>
                        <a:pt x="843" y="48"/>
                      </a:lnTo>
                      <a:lnTo>
                        <a:pt x="844" y="48"/>
                      </a:lnTo>
                      <a:lnTo>
                        <a:pt x="844" y="47"/>
                      </a:lnTo>
                      <a:lnTo>
                        <a:pt x="844" y="51"/>
                      </a:lnTo>
                      <a:lnTo>
                        <a:pt x="844" y="49"/>
                      </a:lnTo>
                      <a:lnTo>
                        <a:pt x="845" y="49"/>
                      </a:lnTo>
                      <a:lnTo>
                        <a:pt x="845" y="48"/>
                      </a:lnTo>
                      <a:lnTo>
                        <a:pt x="845" y="51"/>
                      </a:lnTo>
                      <a:lnTo>
                        <a:pt x="845" y="49"/>
                      </a:lnTo>
                      <a:lnTo>
                        <a:pt x="846" y="49"/>
                      </a:lnTo>
                      <a:lnTo>
                        <a:pt x="846" y="46"/>
                      </a:lnTo>
                      <a:lnTo>
                        <a:pt x="846" y="50"/>
                      </a:lnTo>
                      <a:lnTo>
                        <a:pt x="846" y="47"/>
                      </a:lnTo>
                      <a:lnTo>
                        <a:pt x="847" y="47"/>
                      </a:lnTo>
                      <a:lnTo>
                        <a:pt x="847" y="46"/>
                      </a:lnTo>
                      <a:lnTo>
                        <a:pt x="847" y="49"/>
                      </a:lnTo>
                      <a:lnTo>
                        <a:pt x="847" y="48"/>
                      </a:lnTo>
                      <a:lnTo>
                        <a:pt x="848" y="48"/>
                      </a:lnTo>
                      <a:lnTo>
                        <a:pt x="848" y="46"/>
                      </a:lnTo>
                      <a:lnTo>
                        <a:pt x="848" y="49"/>
                      </a:lnTo>
                      <a:lnTo>
                        <a:pt x="848" y="48"/>
                      </a:lnTo>
                      <a:lnTo>
                        <a:pt x="849" y="48"/>
                      </a:lnTo>
                      <a:lnTo>
                        <a:pt x="849" y="46"/>
                      </a:lnTo>
                      <a:lnTo>
                        <a:pt x="849" y="50"/>
                      </a:lnTo>
                      <a:lnTo>
                        <a:pt x="849" y="48"/>
                      </a:lnTo>
                      <a:lnTo>
                        <a:pt x="850" y="48"/>
                      </a:lnTo>
                      <a:lnTo>
                        <a:pt x="850" y="47"/>
                      </a:lnTo>
                      <a:lnTo>
                        <a:pt x="850" y="48"/>
                      </a:lnTo>
                      <a:lnTo>
                        <a:pt x="850" y="47"/>
                      </a:lnTo>
                      <a:lnTo>
                        <a:pt x="851" y="47"/>
                      </a:lnTo>
                      <a:lnTo>
                        <a:pt x="851" y="46"/>
                      </a:lnTo>
                      <a:lnTo>
                        <a:pt x="851" y="49"/>
                      </a:lnTo>
                      <a:lnTo>
                        <a:pt x="851" y="47"/>
                      </a:lnTo>
                      <a:lnTo>
                        <a:pt x="852" y="47"/>
                      </a:lnTo>
                      <a:lnTo>
                        <a:pt x="852" y="46"/>
                      </a:lnTo>
                      <a:lnTo>
                        <a:pt x="852" y="49"/>
                      </a:lnTo>
                      <a:lnTo>
                        <a:pt x="852" y="46"/>
                      </a:lnTo>
                      <a:lnTo>
                        <a:pt x="853" y="46"/>
                      </a:lnTo>
                      <a:lnTo>
                        <a:pt x="853" y="46"/>
                      </a:lnTo>
                      <a:lnTo>
                        <a:pt x="853" y="48"/>
                      </a:lnTo>
                      <a:lnTo>
                        <a:pt x="853" y="47"/>
                      </a:lnTo>
                      <a:lnTo>
                        <a:pt x="854" y="47"/>
                      </a:lnTo>
                      <a:lnTo>
                        <a:pt x="854" y="46"/>
                      </a:lnTo>
                      <a:lnTo>
                        <a:pt x="854" y="48"/>
                      </a:lnTo>
                      <a:lnTo>
                        <a:pt x="854" y="47"/>
                      </a:lnTo>
                      <a:lnTo>
                        <a:pt x="855" y="47"/>
                      </a:lnTo>
                      <a:lnTo>
                        <a:pt x="855" y="45"/>
                      </a:lnTo>
                      <a:lnTo>
                        <a:pt x="855" y="49"/>
                      </a:lnTo>
                      <a:lnTo>
                        <a:pt x="855" y="46"/>
                      </a:lnTo>
                      <a:lnTo>
                        <a:pt x="856" y="46"/>
                      </a:lnTo>
                      <a:lnTo>
                        <a:pt x="856" y="44"/>
                      </a:lnTo>
                      <a:lnTo>
                        <a:pt x="856" y="47"/>
                      </a:lnTo>
                      <a:lnTo>
                        <a:pt x="856" y="46"/>
                      </a:lnTo>
                      <a:lnTo>
                        <a:pt x="857" y="46"/>
                      </a:lnTo>
                      <a:lnTo>
                        <a:pt x="857" y="44"/>
                      </a:lnTo>
                      <a:lnTo>
                        <a:pt x="857" y="47"/>
                      </a:lnTo>
                      <a:lnTo>
                        <a:pt x="857" y="46"/>
                      </a:lnTo>
                      <a:lnTo>
                        <a:pt x="858" y="46"/>
                      </a:lnTo>
                      <a:lnTo>
                        <a:pt x="858" y="46"/>
                      </a:lnTo>
                      <a:lnTo>
                        <a:pt x="858" y="48"/>
                      </a:lnTo>
                      <a:lnTo>
                        <a:pt x="858" y="47"/>
                      </a:lnTo>
                      <a:lnTo>
                        <a:pt x="859" y="47"/>
                      </a:lnTo>
                      <a:lnTo>
                        <a:pt x="859" y="44"/>
                      </a:lnTo>
                      <a:lnTo>
                        <a:pt x="859" y="46"/>
                      </a:lnTo>
                      <a:lnTo>
                        <a:pt x="859" y="44"/>
                      </a:lnTo>
                      <a:lnTo>
                        <a:pt x="860" y="44"/>
                      </a:lnTo>
                      <a:lnTo>
                        <a:pt x="860" y="44"/>
                      </a:lnTo>
                      <a:lnTo>
                        <a:pt x="860" y="47"/>
                      </a:lnTo>
                      <a:lnTo>
                        <a:pt x="860" y="46"/>
                      </a:lnTo>
                      <a:lnTo>
                        <a:pt x="861" y="46"/>
                      </a:lnTo>
                      <a:lnTo>
                        <a:pt x="861" y="43"/>
                      </a:lnTo>
                      <a:lnTo>
                        <a:pt x="861" y="46"/>
                      </a:lnTo>
                      <a:lnTo>
                        <a:pt x="861" y="43"/>
                      </a:lnTo>
                      <a:lnTo>
                        <a:pt x="862" y="43"/>
                      </a:lnTo>
                      <a:lnTo>
                        <a:pt x="862" y="42"/>
                      </a:lnTo>
                      <a:lnTo>
                        <a:pt x="862" y="46"/>
                      </a:lnTo>
                      <a:lnTo>
                        <a:pt x="862" y="44"/>
                      </a:lnTo>
                      <a:lnTo>
                        <a:pt x="863" y="44"/>
                      </a:lnTo>
                      <a:lnTo>
                        <a:pt x="863" y="41"/>
                      </a:lnTo>
                      <a:lnTo>
                        <a:pt x="863" y="46"/>
                      </a:lnTo>
                      <a:lnTo>
                        <a:pt x="863" y="42"/>
                      </a:lnTo>
                      <a:lnTo>
                        <a:pt x="864" y="42"/>
                      </a:lnTo>
                      <a:lnTo>
                        <a:pt x="864" y="41"/>
                      </a:lnTo>
                      <a:lnTo>
                        <a:pt x="864" y="46"/>
                      </a:lnTo>
                      <a:lnTo>
                        <a:pt x="864" y="44"/>
                      </a:lnTo>
                      <a:lnTo>
                        <a:pt x="865" y="44"/>
                      </a:lnTo>
                      <a:lnTo>
                        <a:pt x="865" y="41"/>
                      </a:lnTo>
                      <a:lnTo>
                        <a:pt x="865" y="44"/>
                      </a:lnTo>
                      <a:lnTo>
                        <a:pt x="865" y="44"/>
                      </a:lnTo>
                      <a:lnTo>
                        <a:pt x="866" y="44"/>
                      </a:lnTo>
                      <a:lnTo>
                        <a:pt x="866" y="42"/>
                      </a:lnTo>
                      <a:lnTo>
                        <a:pt x="866" y="45"/>
                      </a:lnTo>
                      <a:lnTo>
                        <a:pt x="866" y="44"/>
                      </a:lnTo>
                      <a:lnTo>
                        <a:pt x="867" y="44"/>
                      </a:lnTo>
                      <a:lnTo>
                        <a:pt x="867" y="41"/>
                      </a:lnTo>
                      <a:lnTo>
                        <a:pt x="867" y="44"/>
                      </a:lnTo>
                      <a:lnTo>
                        <a:pt x="867" y="41"/>
                      </a:lnTo>
                      <a:lnTo>
                        <a:pt x="868" y="41"/>
                      </a:lnTo>
                      <a:lnTo>
                        <a:pt x="868" y="41"/>
                      </a:lnTo>
                      <a:lnTo>
                        <a:pt x="868" y="44"/>
                      </a:lnTo>
                      <a:lnTo>
                        <a:pt x="868" y="41"/>
                      </a:lnTo>
                      <a:lnTo>
                        <a:pt x="869" y="41"/>
                      </a:lnTo>
                      <a:lnTo>
                        <a:pt x="869" y="40"/>
                      </a:lnTo>
                      <a:lnTo>
                        <a:pt x="869" y="43"/>
                      </a:lnTo>
                      <a:lnTo>
                        <a:pt x="869" y="43"/>
                      </a:lnTo>
                      <a:lnTo>
                        <a:pt x="870" y="43"/>
                      </a:lnTo>
                      <a:lnTo>
                        <a:pt x="870" y="40"/>
                      </a:lnTo>
                      <a:lnTo>
                        <a:pt x="870" y="43"/>
                      </a:lnTo>
                      <a:lnTo>
                        <a:pt x="870" y="41"/>
                      </a:lnTo>
                      <a:lnTo>
                        <a:pt x="871" y="41"/>
                      </a:lnTo>
                      <a:lnTo>
                        <a:pt x="871" y="40"/>
                      </a:lnTo>
                      <a:lnTo>
                        <a:pt x="871" y="43"/>
                      </a:lnTo>
                      <a:lnTo>
                        <a:pt x="871" y="41"/>
                      </a:lnTo>
                      <a:lnTo>
                        <a:pt x="872" y="41"/>
                      </a:lnTo>
                      <a:lnTo>
                        <a:pt x="872" y="40"/>
                      </a:lnTo>
                      <a:lnTo>
                        <a:pt x="872" y="43"/>
                      </a:lnTo>
                      <a:lnTo>
                        <a:pt x="872" y="41"/>
                      </a:lnTo>
                      <a:lnTo>
                        <a:pt x="873" y="41"/>
                      </a:lnTo>
                      <a:lnTo>
                        <a:pt x="873" y="40"/>
                      </a:lnTo>
                      <a:lnTo>
                        <a:pt x="873" y="43"/>
                      </a:lnTo>
                      <a:lnTo>
                        <a:pt x="873" y="43"/>
                      </a:lnTo>
                      <a:lnTo>
                        <a:pt x="874" y="43"/>
                      </a:lnTo>
                      <a:lnTo>
                        <a:pt x="874" y="40"/>
                      </a:lnTo>
                      <a:lnTo>
                        <a:pt x="874" y="43"/>
                      </a:lnTo>
                      <a:lnTo>
                        <a:pt x="874" y="42"/>
                      </a:lnTo>
                      <a:lnTo>
                        <a:pt x="875" y="42"/>
                      </a:lnTo>
                      <a:lnTo>
                        <a:pt x="875" y="40"/>
                      </a:lnTo>
                      <a:lnTo>
                        <a:pt x="875" y="43"/>
                      </a:lnTo>
                      <a:lnTo>
                        <a:pt x="875" y="41"/>
                      </a:lnTo>
                      <a:lnTo>
                        <a:pt x="876" y="41"/>
                      </a:lnTo>
                      <a:lnTo>
                        <a:pt x="876" y="40"/>
                      </a:lnTo>
                      <a:lnTo>
                        <a:pt x="876" y="42"/>
                      </a:lnTo>
                      <a:lnTo>
                        <a:pt x="876" y="40"/>
                      </a:lnTo>
                      <a:lnTo>
                        <a:pt x="877" y="40"/>
                      </a:lnTo>
                      <a:lnTo>
                        <a:pt x="877" y="39"/>
                      </a:lnTo>
                      <a:lnTo>
                        <a:pt x="877" y="42"/>
                      </a:lnTo>
                      <a:lnTo>
                        <a:pt x="877" y="39"/>
                      </a:lnTo>
                      <a:lnTo>
                        <a:pt x="878" y="39"/>
                      </a:lnTo>
                      <a:lnTo>
                        <a:pt x="878" y="37"/>
                      </a:lnTo>
                      <a:lnTo>
                        <a:pt x="878" y="41"/>
                      </a:lnTo>
                      <a:lnTo>
                        <a:pt x="878" y="40"/>
                      </a:lnTo>
                      <a:lnTo>
                        <a:pt x="879" y="40"/>
                      </a:lnTo>
                      <a:lnTo>
                        <a:pt x="879" y="37"/>
                      </a:lnTo>
                      <a:lnTo>
                        <a:pt x="879" y="41"/>
                      </a:lnTo>
                      <a:lnTo>
                        <a:pt x="879" y="39"/>
                      </a:lnTo>
                      <a:lnTo>
                        <a:pt x="880" y="39"/>
                      </a:lnTo>
                      <a:lnTo>
                        <a:pt x="880" y="37"/>
                      </a:lnTo>
                      <a:lnTo>
                        <a:pt x="880" y="40"/>
                      </a:lnTo>
                      <a:lnTo>
                        <a:pt x="880" y="39"/>
                      </a:lnTo>
                      <a:lnTo>
                        <a:pt x="881" y="39"/>
                      </a:lnTo>
                      <a:lnTo>
                        <a:pt x="881" y="37"/>
                      </a:lnTo>
                      <a:lnTo>
                        <a:pt x="881" y="40"/>
                      </a:lnTo>
                      <a:lnTo>
                        <a:pt x="881" y="40"/>
                      </a:lnTo>
                      <a:lnTo>
                        <a:pt x="882" y="40"/>
                      </a:lnTo>
                      <a:lnTo>
                        <a:pt x="882" y="37"/>
                      </a:lnTo>
                      <a:lnTo>
                        <a:pt x="882" y="41"/>
                      </a:lnTo>
                      <a:lnTo>
                        <a:pt x="882" y="41"/>
                      </a:lnTo>
                      <a:lnTo>
                        <a:pt x="883" y="41"/>
                      </a:lnTo>
                      <a:lnTo>
                        <a:pt x="883" y="38"/>
                      </a:lnTo>
                      <a:lnTo>
                        <a:pt x="883" y="41"/>
                      </a:lnTo>
                      <a:lnTo>
                        <a:pt x="883" y="40"/>
                      </a:lnTo>
                      <a:lnTo>
                        <a:pt x="884" y="40"/>
                      </a:lnTo>
                      <a:lnTo>
                        <a:pt x="884" y="39"/>
                      </a:lnTo>
                      <a:lnTo>
                        <a:pt x="884" y="41"/>
                      </a:lnTo>
                      <a:lnTo>
                        <a:pt x="884" y="41"/>
                      </a:lnTo>
                      <a:lnTo>
                        <a:pt x="885" y="41"/>
                      </a:lnTo>
                      <a:lnTo>
                        <a:pt x="885" y="37"/>
                      </a:lnTo>
                      <a:lnTo>
                        <a:pt x="885" y="40"/>
                      </a:lnTo>
                      <a:lnTo>
                        <a:pt x="885" y="38"/>
                      </a:lnTo>
                      <a:lnTo>
                        <a:pt x="886" y="38"/>
                      </a:lnTo>
                      <a:lnTo>
                        <a:pt x="886" y="37"/>
                      </a:lnTo>
                      <a:lnTo>
                        <a:pt x="886" y="41"/>
                      </a:lnTo>
                      <a:lnTo>
                        <a:pt x="886" y="38"/>
                      </a:lnTo>
                      <a:lnTo>
                        <a:pt x="887" y="38"/>
                      </a:lnTo>
                      <a:lnTo>
                        <a:pt x="887" y="38"/>
                      </a:lnTo>
                      <a:lnTo>
                        <a:pt x="887" y="41"/>
                      </a:lnTo>
                      <a:lnTo>
                        <a:pt x="887" y="40"/>
                      </a:lnTo>
                      <a:lnTo>
                        <a:pt x="888" y="40"/>
                      </a:lnTo>
                      <a:lnTo>
                        <a:pt x="888" y="37"/>
                      </a:lnTo>
                      <a:lnTo>
                        <a:pt x="888" y="40"/>
                      </a:lnTo>
                      <a:lnTo>
                        <a:pt x="888" y="37"/>
                      </a:lnTo>
                      <a:lnTo>
                        <a:pt x="889" y="37"/>
                      </a:lnTo>
                      <a:lnTo>
                        <a:pt x="889" y="35"/>
                      </a:lnTo>
                      <a:lnTo>
                        <a:pt x="889" y="39"/>
                      </a:lnTo>
                      <a:lnTo>
                        <a:pt x="889" y="39"/>
                      </a:lnTo>
                      <a:lnTo>
                        <a:pt x="890" y="39"/>
                      </a:lnTo>
                      <a:lnTo>
                        <a:pt x="890" y="37"/>
                      </a:lnTo>
                      <a:lnTo>
                        <a:pt x="890" y="40"/>
                      </a:lnTo>
                      <a:lnTo>
                        <a:pt x="890" y="39"/>
                      </a:lnTo>
                      <a:lnTo>
                        <a:pt x="891" y="39"/>
                      </a:lnTo>
                      <a:lnTo>
                        <a:pt x="891" y="38"/>
                      </a:lnTo>
                      <a:lnTo>
                        <a:pt x="891" y="41"/>
                      </a:lnTo>
                      <a:lnTo>
                        <a:pt x="891" y="38"/>
                      </a:lnTo>
                      <a:lnTo>
                        <a:pt x="892" y="38"/>
                      </a:lnTo>
                      <a:lnTo>
                        <a:pt x="892" y="37"/>
                      </a:lnTo>
                      <a:lnTo>
                        <a:pt x="892" y="40"/>
                      </a:lnTo>
                      <a:lnTo>
                        <a:pt x="892" y="37"/>
                      </a:lnTo>
                      <a:lnTo>
                        <a:pt x="893" y="37"/>
                      </a:lnTo>
                      <a:lnTo>
                        <a:pt x="893" y="37"/>
                      </a:lnTo>
                      <a:lnTo>
                        <a:pt x="893" y="40"/>
                      </a:lnTo>
                      <a:lnTo>
                        <a:pt x="893" y="38"/>
                      </a:lnTo>
                      <a:lnTo>
                        <a:pt x="894" y="38"/>
                      </a:lnTo>
                      <a:lnTo>
                        <a:pt x="894" y="37"/>
                      </a:lnTo>
                      <a:lnTo>
                        <a:pt x="894" y="40"/>
                      </a:lnTo>
                      <a:lnTo>
                        <a:pt x="894" y="37"/>
                      </a:lnTo>
                      <a:lnTo>
                        <a:pt x="895" y="37"/>
                      </a:lnTo>
                      <a:lnTo>
                        <a:pt x="895" y="37"/>
                      </a:lnTo>
                      <a:lnTo>
                        <a:pt x="895" y="40"/>
                      </a:lnTo>
                      <a:lnTo>
                        <a:pt x="895" y="40"/>
                      </a:lnTo>
                      <a:lnTo>
                        <a:pt x="896" y="40"/>
                      </a:lnTo>
                      <a:lnTo>
                        <a:pt x="896" y="36"/>
                      </a:lnTo>
                      <a:lnTo>
                        <a:pt x="896" y="40"/>
                      </a:lnTo>
                      <a:lnTo>
                        <a:pt x="896" y="38"/>
                      </a:lnTo>
                      <a:lnTo>
                        <a:pt x="897" y="38"/>
                      </a:lnTo>
                      <a:lnTo>
                        <a:pt x="897" y="36"/>
                      </a:lnTo>
                      <a:lnTo>
                        <a:pt x="897" y="40"/>
                      </a:lnTo>
                      <a:lnTo>
                        <a:pt x="897" y="38"/>
                      </a:lnTo>
                      <a:lnTo>
                        <a:pt x="898" y="38"/>
                      </a:lnTo>
                      <a:lnTo>
                        <a:pt x="898" y="36"/>
                      </a:lnTo>
                      <a:lnTo>
                        <a:pt x="898" y="40"/>
                      </a:lnTo>
                      <a:lnTo>
                        <a:pt x="898" y="38"/>
                      </a:lnTo>
                      <a:lnTo>
                        <a:pt x="899" y="38"/>
                      </a:lnTo>
                      <a:lnTo>
                        <a:pt x="899" y="36"/>
                      </a:lnTo>
                      <a:lnTo>
                        <a:pt x="899" y="40"/>
                      </a:lnTo>
                      <a:lnTo>
                        <a:pt x="899" y="37"/>
                      </a:lnTo>
                      <a:lnTo>
                        <a:pt x="900" y="37"/>
                      </a:lnTo>
                      <a:lnTo>
                        <a:pt x="900" y="37"/>
                      </a:lnTo>
                      <a:lnTo>
                        <a:pt x="900" y="39"/>
                      </a:lnTo>
                      <a:lnTo>
                        <a:pt x="900" y="37"/>
                      </a:lnTo>
                      <a:lnTo>
                        <a:pt x="901" y="37"/>
                      </a:lnTo>
                      <a:lnTo>
                        <a:pt x="901" y="36"/>
                      </a:lnTo>
                      <a:lnTo>
                        <a:pt x="901" y="39"/>
                      </a:lnTo>
                      <a:lnTo>
                        <a:pt x="901" y="37"/>
                      </a:lnTo>
                      <a:lnTo>
                        <a:pt x="902" y="37"/>
                      </a:lnTo>
                      <a:lnTo>
                        <a:pt x="902" y="36"/>
                      </a:lnTo>
                      <a:lnTo>
                        <a:pt x="902" y="40"/>
                      </a:lnTo>
                      <a:lnTo>
                        <a:pt x="902" y="37"/>
                      </a:lnTo>
                      <a:lnTo>
                        <a:pt x="903" y="37"/>
                      </a:lnTo>
                      <a:lnTo>
                        <a:pt x="903" y="35"/>
                      </a:lnTo>
                      <a:lnTo>
                        <a:pt x="903" y="37"/>
                      </a:lnTo>
                      <a:lnTo>
                        <a:pt x="903" y="35"/>
                      </a:lnTo>
                      <a:lnTo>
                        <a:pt x="904" y="35"/>
                      </a:lnTo>
                      <a:lnTo>
                        <a:pt x="904" y="35"/>
                      </a:lnTo>
                      <a:lnTo>
                        <a:pt x="904" y="37"/>
                      </a:lnTo>
                      <a:lnTo>
                        <a:pt x="904" y="37"/>
                      </a:lnTo>
                      <a:lnTo>
                        <a:pt x="905" y="37"/>
                      </a:lnTo>
                      <a:lnTo>
                        <a:pt x="905" y="35"/>
                      </a:lnTo>
                      <a:lnTo>
                        <a:pt x="905" y="38"/>
                      </a:lnTo>
                      <a:lnTo>
                        <a:pt x="905" y="37"/>
                      </a:lnTo>
                      <a:lnTo>
                        <a:pt x="906" y="37"/>
                      </a:lnTo>
                      <a:lnTo>
                        <a:pt x="906" y="35"/>
                      </a:lnTo>
                      <a:lnTo>
                        <a:pt x="906" y="38"/>
                      </a:lnTo>
                      <a:lnTo>
                        <a:pt x="906" y="37"/>
                      </a:lnTo>
                      <a:lnTo>
                        <a:pt x="907" y="37"/>
                      </a:lnTo>
                      <a:lnTo>
                        <a:pt x="907" y="34"/>
                      </a:lnTo>
                      <a:lnTo>
                        <a:pt x="907" y="37"/>
                      </a:lnTo>
                      <a:lnTo>
                        <a:pt x="907" y="35"/>
                      </a:lnTo>
                      <a:lnTo>
                        <a:pt x="908" y="35"/>
                      </a:lnTo>
                      <a:lnTo>
                        <a:pt x="908" y="35"/>
                      </a:lnTo>
                      <a:lnTo>
                        <a:pt x="908" y="38"/>
                      </a:lnTo>
                      <a:lnTo>
                        <a:pt x="908" y="37"/>
                      </a:lnTo>
                      <a:lnTo>
                        <a:pt x="909" y="37"/>
                      </a:lnTo>
                      <a:lnTo>
                        <a:pt x="909" y="35"/>
                      </a:lnTo>
                      <a:lnTo>
                        <a:pt x="909" y="37"/>
                      </a:lnTo>
                      <a:lnTo>
                        <a:pt x="909" y="35"/>
                      </a:lnTo>
                      <a:lnTo>
                        <a:pt x="910" y="35"/>
                      </a:lnTo>
                      <a:lnTo>
                        <a:pt x="910" y="34"/>
                      </a:lnTo>
                      <a:lnTo>
                        <a:pt x="910" y="37"/>
                      </a:lnTo>
                      <a:lnTo>
                        <a:pt x="910" y="34"/>
                      </a:lnTo>
                      <a:lnTo>
                        <a:pt x="911" y="34"/>
                      </a:lnTo>
                      <a:lnTo>
                        <a:pt x="911" y="34"/>
                      </a:lnTo>
                      <a:lnTo>
                        <a:pt x="911" y="37"/>
                      </a:lnTo>
                      <a:lnTo>
                        <a:pt x="911" y="35"/>
                      </a:lnTo>
                      <a:lnTo>
                        <a:pt x="912" y="35"/>
                      </a:lnTo>
                      <a:lnTo>
                        <a:pt x="912" y="34"/>
                      </a:lnTo>
                      <a:lnTo>
                        <a:pt x="912" y="37"/>
                      </a:lnTo>
                      <a:lnTo>
                        <a:pt x="912" y="36"/>
                      </a:lnTo>
                      <a:lnTo>
                        <a:pt x="913" y="36"/>
                      </a:lnTo>
                      <a:lnTo>
                        <a:pt x="913" y="36"/>
                      </a:lnTo>
                      <a:lnTo>
                        <a:pt x="913" y="38"/>
                      </a:lnTo>
                      <a:lnTo>
                        <a:pt x="913" y="36"/>
                      </a:lnTo>
                      <a:lnTo>
                        <a:pt x="914" y="36"/>
                      </a:lnTo>
                      <a:lnTo>
                        <a:pt x="914" y="35"/>
                      </a:lnTo>
                      <a:lnTo>
                        <a:pt x="914" y="38"/>
                      </a:lnTo>
                      <a:lnTo>
                        <a:pt x="914" y="37"/>
                      </a:lnTo>
                      <a:lnTo>
                        <a:pt x="915" y="37"/>
                      </a:lnTo>
                      <a:lnTo>
                        <a:pt x="915" y="35"/>
                      </a:lnTo>
                      <a:lnTo>
                        <a:pt x="915" y="37"/>
                      </a:lnTo>
                      <a:lnTo>
                        <a:pt x="915" y="37"/>
                      </a:lnTo>
                      <a:lnTo>
                        <a:pt x="916" y="37"/>
                      </a:lnTo>
                      <a:lnTo>
                        <a:pt x="916" y="35"/>
                      </a:lnTo>
                      <a:lnTo>
                        <a:pt x="916" y="38"/>
                      </a:lnTo>
                      <a:lnTo>
                        <a:pt x="916" y="37"/>
                      </a:lnTo>
                      <a:lnTo>
                        <a:pt x="917" y="37"/>
                      </a:lnTo>
                      <a:lnTo>
                        <a:pt x="917" y="35"/>
                      </a:lnTo>
                      <a:lnTo>
                        <a:pt x="917" y="37"/>
                      </a:lnTo>
                      <a:lnTo>
                        <a:pt x="917" y="35"/>
                      </a:lnTo>
                      <a:lnTo>
                        <a:pt x="918" y="35"/>
                      </a:lnTo>
                      <a:lnTo>
                        <a:pt x="918" y="34"/>
                      </a:lnTo>
                      <a:lnTo>
                        <a:pt x="918" y="36"/>
                      </a:lnTo>
                      <a:lnTo>
                        <a:pt x="918" y="34"/>
                      </a:lnTo>
                      <a:lnTo>
                        <a:pt x="919" y="34"/>
                      </a:lnTo>
                      <a:lnTo>
                        <a:pt x="919" y="33"/>
                      </a:lnTo>
                      <a:lnTo>
                        <a:pt x="919" y="37"/>
                      </a:lnTo>
                      <a:lnTo>
                        <a:pt x="919" y="35"/>
                      </a:lnTo>
                      <a:lnTo>
                        <a:pt x="920" y="35"/>
                      </a:lnTo>
                      <a:lnTo>
                        <a:pt x="920" y="35"/>
                      </a:lnTo>
                      <a:lnTo>
                        <a:pt x="920" y="37"/>
                      </a:lnTo>
                      <a:lnTo>
                        <a:pt x="920" y="35"/>
                      </a:lnTo>
                      <a:lnTo>
                        <a:pt x="921" y="35"/>
                      </a:lnTo>
                      <a:lnTo>
                        <a:pt x="921" y="34"/>
                      </a:lnTo>
                      <a:lnTo>
                        <a:pt x="921" y="36"/>
                      </a:lnTo>
                      <a:lnTo>
                        <a:pt x="921" y="35"/>
                      </a:lnTo>
                      <a:lnTo>
                        <a:pt x="922" y="35"/>
                      </a:lnTo>
                      <a:lnTo>
                        <a:pt x="922" y="34"/>
                      </a:lnTo>
                      <a:lnTo>
                        <a:pt x="922" y="37"/>
                      </a:lnTo>
                      <a:lnTo>
                        <a:pt x="922" y="36"/>
                      </a:lnTo>
                      <a:lnTo>
                        <a:pt x="923" y="36"/>
                      </a:lnTo>
                      <a:lnTo>
                        <a:pt x="923" y="34"/>
                      </a:lnTo>
                      <a:lnTo>
                        <a:pt x="923" y="36"/>
                      </a:lnTo>
                      <a:lnTo>
                        <a:pt x="923" y="35"/>
                      </a:lnTo>
                      <a:lnTo>
                        <a:pt x="924" y="35"/>
                      </a:lnTo>
                      <a:lnTo>
                        <a:pt x="924" y="32"/>
                      </a:lnTo>
                      <a:lnTo>
                        <a:pt x="924" y="37"/>
                      </a:lnTo>
                      <a:lnTo>
                        <a:pt x="924" y="34"/>
                      </a:lnTo>
                      <a:lnTo>
                        <a:pt x="925" y="34"/>
                      </a:lnTo>
                      <a:lnTo>
                        <a:pt x="925" y="31"/>
                      </a:lnTo>
                      <a:lnTo>
                        <a:pt x="925" y="34"/>
                      </a:lnTo>
                      <a:lnTo>
                        <a:pt x="925" y="33"/>
                      </a:lnTo>
                      <a:lnTo>
                        <a:pt x="926" y="33"/>
                      </a:lnTo>
                      <a:lnTo>
                        <a:pt x="926" y="32"/>
                      </a:lnTo>
                      <a:lnTo>
                        <a:pt x="926" y="35"/>
                      </a:lnTo>
                      <a:lnTo>
                        <a:pt x="926" y="34"/>
                      </a:lnTo>
                      <a:lnTo>
                        <a:pt x="927" y="34"/>
                      </a:lnTo>
                      <a:lnTo>
                        <a:pt x="927" y="33"/>
                      </a:lnTo>
                      <a:lnTo>
                        <a:pt x="927" y="37"/>
                      </a:lnTo>
                      <a:lnTo>
                        <a:pt x="927" y="35"/>
                      </a:lnTo>
                      <a:lnTo>
                        <a:pt x="928" y="35"/>
                      </a:lnTo>
                      <a:lnTo>
                        <a:pt x="928" y="33"/>
                      </a:lnTo>
                      <a:lnTo>
                        <a:pt x="928" y="35"/>
                      </a:lnTo>
                      <a:lnTo>
                        <a:pt x="928" y="34"/>
                      </a:lnTo>
                      <a:lnTo>
                        <a:pt x="929" y="34"/>
                      </a:lnTo>
                      <a:lnTo>
                        <a:pt x="929" y="32"/>
                      </a:lnTo>
                      <a:lnTo>
                        <a:pt x="929" y="35"/>
                      </a:lnTo>
                      <a:lnTo>
                        <a:pt x="929" y="35"/>
                      </a:lnTo>
                      <a:lnTo>
                        <a:pt x="930" y="35"/>
                      </a:lnTo>
                      <a:lnTo>
                        <a:pt x="930" y="32"/>
                      </a:lnTo>
                      <a:lnTo>
                        <a:pt x="930" y="35"/>
                      </a:lnTo>
                      <a:lnTo>
                        <a:pt x="930" y="34"/>
                      </a:lnTo>
                      <a:lnTo>
                        <a:pt x="931" y="34"/>
                      </a:lnTo>
                      <a:lnTo>
                        <a:pt x="931" y="31"/>
                      </a:lnTo>
                      <a:lnTo>
                        <a:pt x="931" y="35"/>
                      </a:lnTo>
                      <a:lnTo>
                        <a:pt x="931" y="32"/>
                      </a:lnTo>
                      <a:lnTo>
                        <a:pt x="932" y="32"/>
                      </a:lnTo>
                      <a:lnTo>
                        <a:pt x="932" y="30"/>
                      </a:lnTo>
                      <a:lnTo>
                        <a:pt x="932" y="34"/>
                      </a:lnTo>
                      <a:lnTo>
                        <a:pt x="932" y="32"/>
                      </a:lnTo>
                      <a:lnTo>
                        <a:pt x="933" y="32"/>
                      </a:lnTo>
                      <a:lnTo>
                        <a:pt x="933" y="29"/>
                      </a:lnTo>
                      <a:lnTo>
                        <a:pt x="933" y="33"/>
                      </a:lnTo>
                      <a:lnTo>
                        <a:pt x="933" y="31"/>
                      </a:lnTo>
                      <a:lnTo>
                        <a:pt x="934" y="31"/>
                      </a:lnTo>
                      <a:lnTo>
                        <a:pt x="934" y="29"/>
                      </a:lnTo>
                      <a:lnTo>
                        <a:pt x="934" y="32"/>
                      </a:lnTo>
                      <a:lnTo>
                        <a:pt x="934" y="30"/>
                      </a:lnTo>
                      <a:lnTo>
                        <a:pt x="935" y="30"/>
                      </a:lnTo>
                      <a:lnTo>
                        <a:pt x="935" y="29"/>
                      </a:lnTo>
                      <a:lnTo>
                        <a:pt x="935" y="34"/>
                      </a:lnTo>
                      <a:lnTo>
                        <a:pt x="935" y="32"/>
                      </a:lnTo>
                      <a:lnTo>
                        <a:pt x="936" y="32"/>
                      </a:lnTo>
                      <a:lnTo>
                        <a:pt x="936" y="30"/>
                      </a:lnTo>
                      <a:lnTo>
                        <a:pt x="936" y="34"/>
                      </a:lnTo>
                      <a:lnTo>
                        <a:pt x="936" y="31"/>
                      </a:lnTo>
                      <a:lnTo>
                        <a:pt x="937" y="31"/>
                      </a:lnTo>
                      <a:lnTo>
                        <a:pt x="937" y="29"/>
                      </a:lnTo>
                      <a:lnTo>
                        <a:pt x="937" y="34"/>
                      </a:lnTo>
                      <a:lnTo>
                        <a:pt x="937" y="32"/>
                      </a:lnTo>
                      <a:lnTo>
                        <a:pt x="938" y="32"/>
                      </a:lnTo>
                      <a:lnTo>
                        <a:pt x="938" y="31"/>
                      </a:lnTo>
                      <a:lnTo>
                        <a:pt x="938" y="34"/>
                      </a:lnTo>
                      <a:lnTo>
                        <a:pt x="938" y="34"/>
                      </a:lnTo>
                      <a:lnTo>
                        <a:pt x="939" y="34"/>
                      </a:lnTo>
                      <a:lnTo>
                        <a:pt x="939" y="30"/>
                      </a:lnTo>
                      <a:lnTo>
                        <a:pt x="939" y="34"/>
                      </a:lnTo>
                      <a:lnTo>
                        <a:pt x="939" y="32"/>
                      </a:lnTo>
                      <a:lnTo>
                        <a:pt x="940" y="32"/>
                      </a:lnTo>
                      <a:lnTo>
                        <a:pt x="940" y="30"/>
                      </a:lnTo>
                      <a:lnTo>
                        <a:pt x="940" y="35"/>
                      </a:lnTo>
                      <a:lnTo>
                        <a:pt x="940" y="33"/>
                      </a:lnTo>
                      <a:lnTo>
                        <a:pt x="941" y="33"/>
                      </a:lnTo>
                      <a:lnTo>
                        <a:pt x="941" y="31"/>
                      </a:lnTo>
                      <a:lnTo>
                        <a:pt x="941" y="34"/>
                      </a:lnTo>
                      <a:lnTo>
                        <a:pt x="941" y="33"/>
                      </a:lnTo>
                      <a:lnTo>
                        <a:pt x="942" y="33"/>
                      </a:lnTo>
                      <a:lnTo>
                        <a:pt x="942" y="31"/>
                      </a:lnTo>
                      <a:lnTo>
                        <a:pt x="942" y="34"/>
                      </a:lnTo>
                      <a:lnTo>
                        <a:pt x="942" y="32"/>
                      </a:lnTo>
                      <a:lnTo>
                        <a:pt x="943" y="32"/>
                      </a:lnTo>
                      <a:lnTo>
                        <a:pt x="943" y="32"/>
                      </a:lnTo>
                      <a:lnTo>
                        <a:pt x="943" y="35"/>
                      </a:lnTo>
                      <a:lnTo>
                        <a:pt x="943" y="34"/>
                      </a:lnTo>
                      <a:lnTo>
                        <a:pt x="944" y="34"/>
                      </a:lnTo>
                      <a:lnTo>
                        <a:pt x="944" y="32"/>
                      </a:lnTo>
                      <a:lnTo>
                        <a:pt x="944" y="35"/>
                      </a:lnTo>
                      <a:lnTo>
                        <a:pt x="944" y="35"/>
                      </a:lnTo>
                      <a:lnTo>
                        <a:pt x="945" y="35"/>
                      </a:lnTo>
                      <a:lnTo>
                        <a:pt x="945" y="32"/>
                      </a:lnTo>
                      <a:lnTo>
                        <a:pt x="945" y="35"/>
                      </a:lnTo>
                      <a:lnTo>
                        <a:pt x="945" y="33"/>
                      </a:lnTo>
                      <a:lnTo>
                        <a:pt x="946" y="33"/>
                      </a:lnTo>
                      <a:lnTo>
                        <a:pt x="946" y="31"/>
                      </a:lnTo>
                      <a:lnTo>
                        <a:pt x="946" y="36"/>
                      </a:lnTo>
                      <a:lnTo>
                        <a:pt x="946" y="33"/>
                      </a:lnTo>
                      <a:lnTo>
                        <a:pt x="947" y="33"/>
                      </a:lnTo>
                      <a:lnTo>
                        <a:pt x="947" y="31"/>
                      </a:lnTo>
                      <a:lnTo>
                        <a:pt x="947" y="34"/>
                      </a:lnTo>
                      <a:lnTo>
                        <a:pt x="947" y="31"/>
                      </a:lnTo>
                      <a:lnTo>
                        <a:pt x="948" y="31"/>
                      </a:lnTo>
                      <a:lnTo>
                        <a:pt x="948" y="30"/>
                      </a:lnTo>
                      <a:lnTo>
                        <a:pt x="948" y="32"/>
                      </a:lnTo>
                      <a:lnTo>
                        <a:pt x="948" y="31"/>
                      </a:lnTo>
                      <a:lnTo>
                        <a:pt x="949" y="31"/>
                      </a:lnTo>
                      <a:lnTo>
                        <a:pt x="949" y="30"/>
                      </a:lnTo>
                      <a:lnTo>
                        <a:pt x="949" y="32"/>
                      </a:lnTo>
                      <a:lnTo>
                        <a:pt x="949" y="30"/>
                      </a:lnTo>
                      <a:lnTo>
                        <a:pt x="950" y="30"/>
                      </a:lnTo>
                      <a:lnTo>
                        <a:pt x="950" y="29"/>
                      </a:lnTo>
                      <a:lnTo>
                        <a:pt x="950" y="33"/>
                      </a:lnTo>
                      <a:lnTo>
                        <a:pt x="950" y="31"/>
                      </a:lnTo>
                      <a:lnTo>
                        <a:pt x="951" y="31"/>
                      </a:lnTo>
                      <a:lnTo>
                        <a:pt x="951" y="29"/>
                      </a:lnTo>
                      <a:lnTo>
                        <a:pt x="951" y="34"/>
                      </a:lnTo>
                      <a:lnTo>
                        <a:pt x="951" y="32"/>
                      </a:lnTo>
                      <a:lnTo>
                        <a:pt x="952" y="32"/>
                      </a:lnTo>
                      <a:lnTo>
                        <a:pt x="952" y="31"/>
                      </a:lnTo>
                      <a:lnTo>
                        <a:pt x="952" y="33"/>
                      </a:lnTo>
                      <a:lnTo>
                        <a:pt x="952" y="32"/>
                      </a:lnTo>
                      <a:lnTo>
                        <a:pt x="953" y="32"/>
                      </a:lnTo>
                      <a:lnTo>
                        <a:pt x="953" y="31"/>
                      </a:lnTo>
                      <a:lnTo>
                        <a:pt x="953" y="34"/>
                      </a:lnTo>
                      <a:lnTo>
                        <a:pt x="953" y="32"/>
                      </a:lnTo>
                      <a:lnTo>
                        <a:pt x="954" y="32"/>
                      </a:lnTo>
                      <a:lnTo>
                        <a:pt x="954" y="29"/>
                      </a:lnTo>
                      <a:lnTo>
                        <a:pt x="954" y="32"/>
                      </a:lnTo>
                      <a:lnTo>
                        <a:pt x="954" y="30"/>
                      </a:lnTo>
                      <a:lnTo>
                        <a:pt x="955" y="30"/>
                      </a:lnTo>
                      <a:lnTo>
                        <a:pt x="955" y="28"/>
                      </a:lnTo>
                      <a:lnTo>
                        <a:pt x="955" y="32"/>
                      </a:lnTo>
                      <a:lnTo>
                        <a:pt x="955" y="31"/>
                      </a:lnTo>
                      <a:lnTo>
                        <a:pt x="956" y="31"/>
                      </a:lnTo>
                      <a:lnTo>
                        <a:pt x="956" y="29"/>
                      </a:lnTo>
                      <a:lnTo>
                        <a:pt x="956" y="31"/>
                      </a:lnTo>
                      <a:lnTo>
                        <a:pt x="956" y="31"/>
                      </a:lnTo>
                      <a:lnTo>
                        <a:pt x="957" y="31"/>
                      </a:lnTo>
                      <a:lnTo>
                        <a:pt x="957" y="28"/>
                      </a:lnTo>
                      <a:lnTo>
                        <a:pt x="957" y="32"/>
                      </a:lnTo>
                      <a:lnTo>
                        <a:pt x="957" y="31"/>
                      </a:lnTo>
                      <a:lnTo>
                        <a:pt x="958" y="31"/>
                      </a:lnTo>
                      <a:lnTo>
                        <a:pt x="958" y="30"/>
                      </a:lnTo>
                      <a:lnTo>
                        <a:pt x="958" y="34"/>
                      </a:lnTo>
                      <a:lnTo>
                        <a:pt x="958" y="31"/>
                      </a:lnTo>
                      <a:lnTo>
                        <a:pt x="959" y="31"/>
                      </a:lnTo>
                      <a:lnTo>
                        <a:pt x="959" y="30"/>
                      </a:lnTo>
                      <a:lnTo>
                        <a:pt x="959" y="32"/>
                      </a:lnTo>
                      <a:lnTo>
                        <a:pt x="959" y="31"/>
                      </a:lnTo>
                      <a:lnTo>
                        <a:pt x="960" y="31"/>
                      </a:lnTo>
                      <a:lnTo>
                        <a:pt x="960" y="29"/>
                      </a:lnTo>
                      <a:lnTo>
                        <a:pt x="960" y="33"/>
                      </a:lnTo>
                      <a:lnTo>
                        <a:pt x="960" y="31"/>
                      </a:lnTo>
                      <a:lnTo>
                        <a:pt x="961" y="31"/>
                      </a:lnTo>
                      <a:lnTo>
                        <a:pt x="961" y="31"/>
                      </a:lnTo>
                      <a:lnTo>
                        <a:pt x="961" y="32"/>
                      </a:lnTo>
                      <a:lnTo>
                        <a:pt x="961" y="31"/>
                      </a:lnTo>
                      <a:lnTo>
                        <a:pt x="962" y="31"/>
                      </a:lnTo>
                      <a:lnTo>
                        <a:pt x="962" y="30"/>
                      </a:lnTo>
                      <a:lnTo>
                        <a:pt x="962" y="32"/>
                      </a:lnTo>
                      <a:lnTo>
                        <a:pt x="962" y="32"/>
                      </a:lnTo>
                      <a:lnTo>
                        <a:pt x="963" y="32"/>
                      </a:lnTo>
                      <a:lnTo>
                        <a:pt x="963" y="30"/>
                      </a:lnTo>
                      <a:lnTo>
                        <a:pt x="963" y="34"/>
                      </a:lnTo>
                      <a:lnTo>
                        <a:pt x="963" y="31"/>
                      </a:lnTo>
                      <a:lnTo>
                        <a:pt x="964" y="31"/>
                      </a:lnTo>
                      <a:lnTo>
                        <a:pt x="964" y="29"/>
                      </a:lnTo>
                      <a:lnTo>
                        <a:pt x="964" y="32"/>
                      </a:lnTo>
                      <a:lnTo>
                        <a:pt x="964" y="31"/>
                      </a:lnTo>
                      <a:lnTo>
                        <a:pt x="965" y="31"/>
                      </a:lnTo>
                      <a:lnTo>
                        <a:pt x="965" y="31"/>
                      </a:lnTo>
                      <a:lnTo>
                        <a:pt x="965" y="32"/>
                      </a:lnTo>
                      <a:lnTo>
                        <a:pt x="965" y="32"/>
                      </a:lnTo>
                      <a:lnTo>
                        <a:pt x="966" y="32"/>
                      </a:lnTo>
                      <a:lnTo>
                        <a:pt x="966" y="30"/>
                      </a:lnTo>
                      <a:lnTo>
                        <a:pt x="966" y="34"/>
                      </a:lnTo>
                      <a:lnTo>
                        <a:pt x="966" y="31"/>
                      </a:lnTo>
                      <a:lnTo>
                        <a:pt x="967" y="31"/>
                      </a:lnTo>
                      <a:lnTo>
                        <a:pt x="967" y="32"/>
                      </a:lnTo>
                      <a:lnTo>
                        <a:pt x="967" y="34"/>
                      </a:lnTo>
                      <a:lnTo>
                        <a:pt x="967" y="32"/>
                      </a:lnTo>
                      <a:lnTo>
                        <a:pt x="968" y="32"/>
                      </a:lnTo>
                      <a:lnTo>
                        <a:pt x="968" y="30"/>
                      </a:lnTo>
                      <a:lnTo>
                        <a:pt x="968" y="34"/>
                      </a:lnTo>
                      <a:lnTo>
                        <a:pt x="968" y="31"/>
                      </a:lnTo>
                      <a:lnTo>
                        <a:pt x="969" y="31"/>
                      </a:lnTo>
                      <a:lnTo>
                        <a:pt x="969" y="30"/>
                      </a:lnTo>
                      <a:lnTo>
                        <a:pt x="969" y="34"/>
                      </a:lnTo>
                      <a:lnTo>
                        <a:pt x="969" y="34"/>
                      </a:lnTo>
                      <a:lnTo>
                        <a:pt x="970" y="34"/>
                      </a:lnTo>
                      <a:lnTo>
                        <a:pt x="970" y="31"/>
                      </a:lnTo>
                      <a:lnTo>
                        <a:pt x="970" y="34"/>
                      </a:lnTo>
                      <a:lnTo>
                        <a:pt x="970" y="34"/>
                      </a:lnTo>
                      <a:lnTo>
                        <a:pt x="971" y="34"/>
                      </a:lnTo>
                      <a:lnTo>
                        <a:pt x="971" y="31"/>
                      </a:lnTo>
                      <a:lnTo>
                        <a:pt x="971" y="34"/>
                      </a:lnTo>
                      <a:lnTo>
                        <a:pt x="971" y="32"/>
                      </a:lnTo>
                      <a:lnTo>
                        <a:pt x="972" y="32"/>
                      </a:lnTo>
                      <a:lnTo>
                        <a:pt x="972" y="30"/>
                      </a:lnTo>
                      <a:lnTo>
                        <a:pt x="972" y="34"/>
                      </a:lnTo>
                      <a:lnTo>
                        <a:pt x="972" y="34"/>
                      </a:lnTo>
                      <a:lnTo>
                        <a:pt x="973" y="34"/>
                      </a:lnTo>
                      <a:lnTo>
                        <a:pt x="973" y="31"/>
                      </a:lnTo>
                      <a:lnTo>
                        <a:pt x="973" y="35"/>
                      </a:lnTo>
                      <a:lnTo>
                        <a:pt x="973" y="33"/>
                      </a:lnTo>
                      <a:lnTo>
                        <a:pt x="974" y="33"/>
                      </a:lnTo>
                      <a:lnTo>
                        <a:pt x="974" y="30"/>
                      </a:lnTo>
                      <a:lnTo>
                        <a:pt x="974" y="34"/>
                      </a:lnTo>
                      <a:lnTo>
                        <a:pt x="974" y="31"/>
                      </a:lnTo>
                      <a:lnTo>
                        <a:pt x="975" y="31"/>
                      </a:lnTo>
                      <a:lnTo>
                        <a:pt x="975" y="30"/>
                      </a:lnTo>
                      <a:lnTo>
                        <a:pt x="975" y="32"/>
                      </a:lnTo>
                      <a:lnTo>
                        <a:pt x="975" y="31"/>
                      </a:lnTo>
                      <a:lnTo>
                        <a:pt x="976" y="31"/>
                      </a:lnTo>
                      <a:lnTo>
                        <a:pt x="976" y="29"/>
                      </a:lnTo>
                      <a:lnTo>
                        <a:pt x="976" y="34"/>
                      </a:lnTo>
                      <a:lnTo>
                        <a:pt x="976" y="32"/>
                      </a:lnTo>
                      <a:lnTo>
                        <a:pt x="977" y="32"/>
                      </a:lnTo>
                      <a:lnTo>
                        <a:pt x="977" y="29"/>
                      </a:lnTo>
                      <a:lnTo>
                        <a:pt x="977" y="32"/>
                      </a:lnTo>
                      <a:lnTo>
                        <a:pt x="977" y="30"/>
                      </a:lnTo>
                      <a:lnTo>
                        <a:pt x="978" y="30"/>
                      </a:lnTo>
                      <a:lnTo>
                        <a:pt x="978" y="29"/>
                      </a:lnTo>
                      <a:lnTo>
                        <a:pt x="978" y="32"/>
                      </a:lnTo>
                      <a:lnTo>
                        <a:pt x="978" y="29"/>
                      </a:lnTo>
                      <a:lnTo>
                        <a:pt x="979" y="29"/>
                      </a:lnTo>
                      <a:lnTo>
                        <a:pt x="979" y="29"/>
                      </a:lnTo>
                      <a:lnTo>
                        <a:pt x="979" y="32"/>
                      </a:lnTo>
                      <a:lnTo>
                        <a:pt x="979" y="32"/>
                      </a:lnTo>
                      <a:lnTo>
                        <a:pt x="980" y="32"/>
                      </a:lnTo>
                      <a:lnTo>
                        <a:pt x="980" y="30"/>
                      </a:lnTo>
                      <a:lnTo>
                        <a:pt x="980" y="32"/>
                      </a:lnTo>
                      <a:lnTo>
                        <a:pt x="980" y="32"/>
                      </a:lnTo>
                      <a:lnTo>
                        <a:pt x="981" y="32"/>
                      </a:lnTo>
                      <a:lnTo>
                        <a:pt x="981" y="29"/>
                      </a:lnTo>
                      <a:lnTo>
                        <a:pt x="981" y="32"/>
                      </a:lnTo>
                      <a:lnTo>
                        <a:pt x="981" y="29"/>
                      </a:lnTo>
                      <a:lnTo>
                        <a:pt x="982" y="29"/>
                      </a:lnTo>
                      <a:lnTo>
                        <a:pt x="982" y="29"/>
                      </a:lnTo>
                      <a:lnTo>
                        <a:pt x="982" y="32"/>
                      </a:lnTo>
                      <a:lnTo>
                        <a:pt x="982" y="29"/>
                      </a:lnTo>
                      <a:lnTo>
                        <a:pt x="983" y="29"/>
                      </a:lnTo>
                      <a:lnTo>
                        <a:pt x="983" y="29"/>
                      </a:lnTo>
                      <a:lnTo>
                        <a:pt x="983" y="31"/>
                      </a:lnTo>
                      <a:lnTo>
                        <a:pt x="983" y="29"/>
                      </a:lnTo>
                      <a:lnTo>
                        <a:pt x="984" y="29"/>
                      </a:lnTo>
                      <a:lnTo>
                        <a:pt x="984" y="28"/>
                      </a:lnTo>
                      <a:lnTo>
                        <a:pt x="984" y="31"/>
                      </a:lnTo>
                      <a:lnTo>
                        <a:pt x="984" y="31"/>
                      </a:lnTo>
                      <a:lnTo>
                        <a:pt x="985" y="31"/>
                      </a:lnTo>
                      <a:lnTo>
                        <a:pt x="985" y="29"/>
                      </a:lnTo>
                      <a:lnTo>
                        <a:pt x="985" y="31"/>
                      </a:lnTo>
                      <a:lnTo>
                        <a:pt x="985" y="29"/>
                      </a:lnTo>
                      <a:lnTo>
                        <a:pt x="986" y="29"/>
                      </a:lnTo>
                      <a:lnTo>
                        <a:pt x="986" y="26"/>
                      </a:lnTo>
                      <a:lnTo>
                        <a:pt x="986" y="31"/>
                      </a:lnTo>
                      <a:lnTo>
                        <a:pt x="986" y="29"/>
                      </a:lnTo>
                      <a:lnTo>
                        <a:pt x="987" y="29"/>
                      </a:lnTo>
                      <a:lnTo>
                        <a:pt x="987" y="28"/>
                      </a:lnTo>
                      <a:lnTo>
                        <a:pt x="987" y="31"/>
                      </a:lnTo>
                      <a:lnTo>
                        <a:pt x="987" y="31"/>
                      </a:lnTo>
                      <a:lnTo>
                        <a:pt x="988" y="31"/>
                      </a:lnTo>
                      <a:lnTo>
                        <a:pt x="988" y="29"/>
                      </a:lnTo>
                      <a:lnTo>
                        <a:pt x="988" y="32"/>
                      </a:lnTo>
                      <a:lnTo>
                        <a:pt x="988" y="29"/>
                      </a:lnTo>
                      <a:lnTo>
                        <a:pt x="989" y="29"/>
                      </a:lnTo>
                      <a:lnTo>
                        <a:pt x="989" y="29"/>
                      </a:lnTo>
                      <a:lnTo>
                        <a:pt x="989" y="32"/>
                      </a:lnTo>
                      <a:lnTo>
                        <a:pt x="989" y="29"/>
                      </a:lnTo>
                      <a:lnTo>
                        <a:pt x="990" y="29"/>
                      </a:lnTo>
                      <a:lnTo>
                        <a:pt x="990" y="29"/>
                      </a:lnTo>
                      <a:lnTo>
                        <a:pt x="990" y="32"/>
                      </a:lnTo>
                      <a:lnTo>
                        <a:pt x="990" y="29"/>
                      </a:lnTo>
                      <a:lnTo>
                        <a:pt x="991" y="29"/>
                      </a:lnTo>
                      <a:lnTo>
                        <a:pt x="991" y="29"/>
                      </a:lnTo>
                      <a:lnTo>
                        <a:pt x="991" y="31"/>
                      </a:lnTo>
                      <a:lnTo>
                        <a:pt x="991" y="30"/>
                      </a:lnTo>
                      <a:lnTo>
                        <a:pt x="992" y="30"/>
                      </a:lnTo>
                      <a:lnTo>
                        <a:pt x="992" y="27"/>
                      </a:lnTo>
                      <a:lnTo>
                        <a:pt x="992" y="31"/>
                      </a:lnTo>
                      <a:lnTo>
                        <a:pt x="992" y="28"/>
                      </a:lnTo>
                      <a:lnTo>
                        <a:pt x="993" y="28"/>
                      </a:lnTo>
                      <a:lnTo>
                        <a:pt x="993" y="28"/>
                      </a:lnTo>
                      <a:lnTo>
                        <a:pt x="993" y="30"/>
                      </a:lnTo>
                      <a:lnTo>
                        <a:pt x="993" y="29"/>
                      </a:lnTo>
                      <a:lnTo>
                        <a:pt x="994" y="29"/>
                      </a:lnTo>
                      <a:lnTo>
                        <a:pt x="994" y="28"/>
                      </a:lnTo>
                      <a:lnTo>
                        <a:pt x="994" y="31"/>
                      </a:lnTo>
                      <a:lnTo>
                        <a:pt x="994" y="30"/>
                      </a:lnTo>
                      <a:lnTo>
                        <a:pt x="995" y="30"/>
                      </a:lnTo>
                      <a:lnTo>
                        <a:pt x="995" y="28"/>
                      </a:lnTo>
                      <a:lnTo>
                        <a:pt x="995" y="32"/>
                      </a:lnTo>
                      <a:lnTo>
                        <a:pt x="995" y="32"/>
                      </a:lnTo>
                      <a:lnTo>
                        <a:pt x="996" y="32"/>
                      </a:lnTo>
                      <a:lnTo>
                        <a:pt x="996" y="28"/>
                      </a:lnTo>
                      <a:lnTo>
                        <a:pt x="996" y="31"/>
                      </a:lnTo>
                      <a:lnTo>
                        <a:pt x="996" y="29"/>
                      </a:lnTo>
                      <a:lnTo>
                        <a:pt x="997" y="29"/>
                      </a:lnTo>
                      <a:lnTo>
                        <a:pt x="997" y="28"/>
                      </a:lnTo>
                      <a:lnTo>
                        <a:pt x="997" y="30"/>
                      </a:lnTo>
                      <a:lnTo>
                        <a:pt x="997" y="29"/>
                      </a:lnTo>
                      <a:lnTo>
                        <a:pt x="998" y="29"/>
                      </a:lnTo>
                      <a:lnTo>
                        <a:pt x="998" y="28"/>
                      </a:lnTo>
                      <a:lnTo>
                        <a:pt x="998" y="30"/>
                      </a:lnTo>
                      <a:lnTo>
                        <a:pt x="998" y="29"/>
                      </a:lnTo>
                      <a:lnTo>
                        <a:pt x="999" y="29"/>
                      </a:lnTo>
                      <a:lnTo>
                        <a:pt x="999" y="28"/>
                      </a:lnTo>
                      <a:lnTo>
                        <a:pt x="999" y="31"/>
                      </a:lnTo>
                      <a:lnTo>
                        <a:pt x="999" y="28"/>
                      </a:lnTo>
                      <a:lnTo>
                        <a:pt x="1000" y="28"/>
                      </a:lnTo>
                      <a:lnTo>
                        <a:pt x="1000" y="27"/>
                      </a:lnTo>
                      <a:lnTo>
                        <a:pt x="1000" y="30"/>
                      </a:lnTo>
                      <a:lnTo>
                        <a:pt x="1000" y="28"/>
                      </a:lnTo>
                      <a:lnTo>
                        <a:pt x="1001" y="28"/>
                      </a:lnTo>
                      <a:lnTo>
                        <a:pt x="1001" y="26"/>
                      </a:lnTo>
                      <a:lnTo>
                        <a:pt x="1001" y="29"/>
                      </a:lnTo>
                      <a:lnTo>
                        <a:pt x="1001" y="26"/>
                      </a:lnTo>
                      <a:lnTo>
                        <a:pt x="1002" y="26"/>
                      </a:lnTo>
                      <a:lnTo>
                        <a:pt x="1002" y="27"/>
                      </a:lnTo>
                      <a:lnTo>
                        <a:pt x="1002" y="31"/>
                      </a:lnTo>
                      <a:lnTo>
                        <a:pt x="1002" y="30"/>
                      </a:lnTo>
                      <a:lnTo>
                        <a:pt x="1003" y="30"/>
                      </a:lnTo>
                      <a:lnTo>
                        <a:pt x="1003" y="29"/>
                      </a:lnTo>
                      <a:lnTo>
                        <a:pt x="1003" y="31"/>
                      </a:lnTo>
                      <a:lnTo>
                        <a:pt x="1003" y="31"/>
                      </a:lnTo>
                      <a:lnTo>
                        <a:pt x="1004" y="31"/>
                      </a:lnTo>
                      <a:lnTo>
                        <a:pt x="1004" y="27"/>
                      </a:lnTo>
                      <a:lnTo>
                        <a:pt x="1004" y="31"/>
                      </a:lnTo>
                      <a:lnTo>
                        <a:pt x="1004" y="30"/>
                      </a:lnTo>
                      <a:lnTo>
                        <a:pt x="1005" y="30"/>
                      </a:lnTo>
                      <a:lnTo>
                        <a:pt x="1005" y="28"/>
                      </a:lnTo>
                      <a:lnTo>
                        <a:pt x="1005" y="31"/>
                      </a:lnTo>
                      <a:lnTo>
                        <a:pt x="1005" y="30"/>
                      </a:lnTo>
                      <a:lnTo>
                        <a:pt x="1006" y="30"/>
                      </a:lnTo>
                      <a:lnTo>
                        <a:pt x="1006" y="28"/>
                      </a:lnTo>
                      <a:lnTo>
                        <a:pt x="1006" y="31"/>
                      </a:lnTo>
                      <a:lnTo>
                        <a:pt x="1006" y="28"/>
                      </a:lnTo>
                      <a:lnTo>
                        <a:pt x="1007" y="28"/>
                      </a:lnTo>
                      <a:lnTo>
                        <a:pt x="1007" y="27"/>
                      </a:lnTo>
                      <a:lnTo>
                        <a:pt x="1007" y="29"/>
                      </a:lnTo>
                      <a:lnTo>
                        <a:pt x="1007" y="29"/>
                      </a:lnTo>
                      <a:lnTo>
                        <a:pt x="1008" y="29"/>
                      </a:lnTo>
                      <a:lnTo>
                        <a:pt x="1008" y="26"/>
                      </a:lnTo>
                      <a:lnTo>
                        <a:pt x="1008" y="29"/>
                      </a:lnTo>
                      <a:lnTo>
                        <a:pt x="1008" y="26"/>
                      </a:lnTo>
                      <a:lnTo>
                        <a:pt x="1009" y="26"/>
                      </a:lnTo>
                      <a:lnTo>
                        <a:pt x="1009" y="25"/>
                      </a:lnTo>
                      <a:lnTo>
                        <a:pt x="1009" y="29"/>
                      </a:lnTo>
                      <a:lnTo>
                        <a:pt x="1009" y="28"/>
                      </a:lnTo>
                      <a:lnTo>
                        <a:pt x="1010" y="28"/>
                      </a:lnTo>
                      <a:lnTo>
                        <a:pt x="1010" y="26"/>
                      </a:lnTo>
                      <a:lnTo>
                        <a:pt x="1010" y="29"/>
                      </a:lnTo>
                      <a:lnTo>
                        <a:pt x="1010" y="26"/>
                      </a:lnTo>
                      <a:lnTo>
                        <a:pt x="1011" y="26"/>
                      </a:lnTo>
                      <a:lnTo>
                        <a:pt x="1011" y="27"/>
                      </a:lnTo>
                      <a:lnTo>
                        <a:pt x="1011" y="29"/>
                      </a:lnTo>
                      <a:lnTo>
                        <a:pt x="1011" y="29"/>
                      </a:lnTo>
                      <a:lnTo>
                        <a:pt x="1012" y="29"/>
                      </a:lnTo>
                      <a:lnTo>
                        <a:pt x="1012" y="27"/>
                      </a:lnTo>
                      <a:lnTo>
                        <a:pt x="1012" y="31"/>
                      </a:lnTo>
                      <a:lnTo>
                        <a:pt x="1012" y="31"/>
                      </a:lnTo>
                      <a:lnTo>
                        <a:pt x="1013" y="31"/>
                      </a:lnTo>
                      <a:lnTo>
                        <a:pt x="1013" y="28"/>
                      </a:lnTo>
                      <a:lnTo>
                        <a:pt x="1013" y="31"/>
                      </a:lnTo>
                      <a:lnTo>
                        <a:pt x="1013" y="29"/>
                      </a:lnTo>
                      <a:lnTo>
                        <a:pt x="1014" y="29"/>
                      </a:lnTo>
                      <a:lnTo>
                        <a:pt x="1014" y="27"/>
                      </a:lnTo>
                      <a:lnTo>
                        <a:pt x="1014" y="29"/>
                      </a:lnTo>
                      <a:lnTo>
                        <a:pt x="1014" y="28"/>
                      </a:lnTo>
                      <a:lnTo>
                        <a:pt x="1015" y="28"/>
                      </a:lnTo>
                      <a:lnTo>
                        <a:pt x="1015" y="26"/>
                      </a:lnTo>
                      <a:lnTo>
                        <a:pt x="1015" y="31"/>
                      </a:lnTo>
                      <a:lnTo>
                        <a:pt x="1015" y="29"/>
                      </a:lnTo>
                      <a:lnTo>
                        <a:pt x="1016" y="29"/>
                      </a:lnTo>
                      <a:lnTo>
                        <a:pt x="1016" y="28"/>
                      </a:lnTo>
                      <a:lnTo>
                        <a:pt x="1016" y="29"/>
                      </a:lnTo>
                      <a:lnTo>
                        <a:pt x="1016" y="28"/>
                      </a:lnTo>
                      <a:lnTo>
                        <a:pt x="1017" y="28"/>
                      </a:lnTo>
                      <a:lnTo>
                        <a:pt x="1017" y="25"/>
                      </a:lnTo>
                      <a:lnTo>
                        <a:pt x="1017" y="29"/>
                      </a:lnTo>
                      <a:lnTo>
                        <a:pt x="1017" y="26"/>
                      </a:lnTo>
                      <a:lnTo>
                        <a:pt x="1018" y="26"/>
                      </a:lnTo>
                      <a:lnTo>
                        <a:pt x="1018" y="26"/>
                      </a:lnTo>
                      <a:lnTo>
                        <a:pt x="1018" y="29"/>
                      </a:lnTo>
                      <a:lnTo>
                        <a:pt x="1018" y="29"/>
                      </a:lnTo>
                      <a:lnTo>
                        <a:pt x="1019" y="29"/>
                      </a:lnTo>
                      <a:lnTo>
                        <a:pt x="1019" y="26"/>
                      </a:lnTo>
                      <a:lnTo>
                        <a:pt x="1019" y="30"/>
                      </a:lnTo>
                      <a:lnTo>
                        <a:pt x="1019" y="29"/>
                      </a:lnTo>
                      <a:lnTo>
                        <a:pt x="1020" y="29"/>
                      </a:lnTo>
                      <a:lnTo>
                        <a:pt x="1020" y="26"/>
                      </a:lnTo>
                      <a:lnTo>
                        <a:pt x="1020" y="29"/>
                      </a:lnTo>
                      <a:lnTo>
                        <a:pt x="1020" y="29"/>
                      </a:lnTo>
                      <a:lnTo>
                        <a:pt x="1021" y="29"/>
                      </a:lnTo>
                      <a:lnTo>
                        <a:pt x="1021" y="26"/>
                      </a:lnTo>
                      <a:lnTo>
                        <a:pt x="1021" y="31"/>
                      </a:lnTo>
                      <a:lnTo>
                        <a:pt x="1021" y="29"/>
                      </a:lnTo>
                      <a:lnTo>
                        <a:pt x="1022" y="29"/>
                      </a:lnTo>
                      <a:lnTo>
                        <a:pt x="1022" y="25"/>
                      </a:lnTo>
                      <a:lnTo>
                        <a:pt x="1022" y="30"/>
                      </a:lnTo>
                      <a:lnTo>
                        <a:pt x="1022" y="28"/>
                      </a:lnTo>
                      <a:lnTo>
                        <a:pt x="1023" y="28"/>
                      </a:lnTo>
                      <a:lnTo>
                        <a:pt x="1023" y="26"/>
                      </a:lnTo>
                      <a:lnTo>
                        <a:pt x="1023" y="30"/>
                      </a:lnTo>
                      <a:lnTo>
                        <a:pt x="1023" y="27"/>
                      </a:lnTo>
                      <a:lnTo>
                        <a:pt x="1024" y="27"/>
                      </a:lnTo>
                      <a:lnTo>
                        <a:pt x="1024" y="26"/>
                      </a:lnTo>
                      <a:lnTo>
                        <a:pt x="1024" y="29"/>
                      </a:lnTo>
                      <a:lnTo>
                        <a:pt x="1024" y="29"/>
                      </a:lnTo>
                      <a:lnTo>
                        <a:pt x="1025" y="29"/>
                      </a:lnTo>
                      <a:lnTo>
                        <a:pt x="1025" y="25"/>
                      </a:lnTo>
                      <a:lnTo>
                        <a:pt x="1025" y="29"/>
                      </a:lnTo>
                      <a:lnTo>
                        <a:pt x="1025" y="26"/>
                      </a:lnTo>
                      <a:lnTo>
                        <a:pt x="1026" y="26"/>
                      </a:lnTo>
                      <a:lnTo>
                        <a:pt x="1026" y="25"/>
                      </a:lnTo>
                      <a:lnTo>
                        <a:pt x="1026" y="28"/>
                      </a:lnTo>
                      <a:lnTo>
                        <a:pt x="1026" y="28"/>
                      </a:lnTo>
                      <a:lnTo>
                        <a:pt x="1027" y="28"/>
                      </a:lnTo>
                      <a:lnTo>
                        <a:pt x="1027" y="26"/>
                      </a:lnTo>
                      <a:lnTo>
                        <a:pt x="1027" y="29"/>
                      </a:lnTo>
                      <a:lnTo>
                        <a:pt x="1027" y="29"/>
                      </a:lnTo>
                      <a:lnTo>
                        <a:pt x="1028" y="29"/>
                      </a:lnTo>
                      <a:lnTo>
                        <a:pt x="1028" y="26"/>
                      </a:lnTo>
                      <a:lnTo>
                        <a:pt x="1028" y="29"/>
                      </a:lnTo>
                      <a:lnTo>
                        <a:pt x="1028" y="28"/>
                      </a:lnTo>
                      <a:lnTo>
                        <a:pt x="1029" y="28"/>
                      </a:lnTo>
                      <a:lnTo>
                        <a:pt x="1029" y="26"/>
                      </a:lnTo>
                      <a:lnTo>
                        <a:pt x="1029" y="30"/>
                      </a:lnTo>
                      <a:lnTo>
                        <a:pt x="1029" y="29"/>
                      </a:lnTo>
                      <a:lnTo>
                        <a:pt x="1030" y="29"/>
                      </a:lnTo>
                      <a:lnTo>
                        <a:pt x="1030" y="26"/>
                      </a:lnTo>
                      <a:lnTo>
                        <a:pt x="1030" y="29"/>
                      </a:lnTo>
                      <a:lnTo>
                        <a:pt x="1030" y="28"/>
                      </a:lnTo>
                      <a:lnTo>
                        <a:pt x="1031" y="28"/>
                      </a:lnTo>
                      <a:lnTo>
                        <a:pt x="1031" y="26"/>
                      </a:lnTo>
                      <a:lnTo>
                        <a:pt x="1031" y="29"/>
                      </a:lnTo>
                      <a:lnTo>
                        <a:pt x="1031" y="28"/>
                      </a:lnTo>
                      <a:lnTo>
                        <a:pt x="1032" y="28"/>
                      </a:lnTo>
                      <a:lnTo>
                        <a:pt x="1032" y="26"/>
                      </a:lnTo>
                      <a:lnTo>
                        <a:pt x="1032" y="29"/>
                      </a:lnTo>
                      <a:lnTo>
                        <a:pt x="1032" y="27"/>
                      </a:lnTo>
                      <a:lnTo>
                        <a:pt x="1033" y="27"/>
                      </a:lnTo>
                      <a:lnTo>
                        <a:pt x="1033" y="25"/>
                      </a:lnTo>
                      <a:lnTo>
                        <a:pt x="1033" y="29"/>
                      </a:lnTo>
                      <a:lnTo>
                        <a:pt x="1033" y="28"/>
                      </a:lnTo>
                      <a:lnTo>
                        <a:pt x="1034" y="28"/>
                      </a:lnTo>
                      <a:lnTo>
                        <a:pt x="1034" y="25"/>
                      </a:lnTo>
                      <a:lnTo>
                        <a:pt x="1034" y="28"/>
                      </a:lnTo>
                      <a:lnTo>
                        <a:pt x="1034" y="26"/>
                      </a:lnTo>
                      <a:lnTo>
                        <a:pt x="1035" y="26"/>
                      </a:lnTo>
                      <a:lnTo>
                        <a:pt x="1035" y="26"/>
                      </a:lnTo>
                      <a:lnTo>
                        <a:pt x="1035" y="28"/>
                      </a:lnTo>
                      <a:lnTo>
                        <a:pt x="1035" y="27"/>
                      </a:lnTo>
                      <a:lnTo>
                        <a:pt x="1036" y="27"/>
                      </a:lnTo>
                      <a:lnTo>
                        <a:pt x="1036" y="25"/>
                      </a:lnTo>
                      <a:lnTo>
                        <a:pt x="1036" y="29"/>
                      </a:lnTo>
                      <a:lnTo>
                        <a:pt x="1036" y="28"/>
                      </a:lnTo>
                      <a:lnTo>
                        <a:pt x="1037" y="28"/>
                      </a:lnTo>
                      <a:lnTo>
                        <a:pt x="1037" y="25"/>
                      </a:lnTo>
                      <a:lnTo>
                        <a:pt x="1037" y="29"/>
                      </a:lnTo>
                      <a:lnTo>
                        <a:pt x="1037" y="26"/>
                      </a:lnTo>
                      <a:lnTo>
                        <a:pt x="1038" y="26"/>
                      </a:lnTo>
                      <a:lnTo>
                        <a:pt x="1038" y="25"/>
                      </a:lnTo>
                      <a:lnTo>
                        <a:pt x="1038" y="29"/>
                      </a:lnTo>
                      <a:lnTo>
                        <a:pt x="1038" y="26"/>
                      </a:lnTo>
                      <a:lnTo>
                        <a:pt x="1039" y="26"/>
                      </a:lnTo>
                      <a:lnTo>
                        <a:pt x="1039" y="26"/>
                      </a:lnTo>
                      <a:lnTo>
                        <a:pt x="1039" y="29"/>
                      </a:lnTo>
                      <a:lnTo>
                        <a:pt x="1039" y="26"/>
                      </a:lnTo>
                      <a:lnTo>
                        <a:pt x="1040" y="26"/>
                      </a:lnTo>
                      <a:lnTo>
                        <a:pt x="1040" y="25"/>
                      </a:lnTo>
                      <a:lnTo>
                        <a:pt x="1040" y="28"/>
                      </a:lnTo>
                      <a:lnTo>
                        <a:pt x="1040" y="25"/>
                      </a:lnTo>
                      <a:lnTo>
                        <a:pt x="1041" y="25"/>
                      </a:lnTo>
                      <a:lnTo>
                        <a:pt x="1041" y="23"/>
                      </a:lnTo>
                      <a:lnTo>
                        <a:pt x="1041" y="26"/>
                      </a:lnTo>
                      <a:lnTo>
                        <a:pt x="1041" y="25"/>
                      </a:lnTo>
                      <a:lnTo>
                        <a:pt x="1042" y="25"/>
                      </a:lnTo>
                      <a:lnTo>
                        <a:pt x="1042" y="24"/>
                      </a:lnTo>
                      <a:lnTo>
                        <a:pt x="1042" y="27"/>
                      </a:lnTo>
                      <a:lnTo>
                        <a:pt x="1042" y="25"/>
                      </a:lnTo>
                      <a:lnTo>
                        <a:pt x="1043" y="25"/>
                      </a:lnTo>
                      <a:lnTo>
                        <a:pt x="1043" y="24"/>
                      </a:lnTo>
                      <a:lnTo>
                        <a:pt x="1043" y="27"/>
                      </a:lnTo>
                      <a:lnTo>
                        <a:pt x="1043" y="25"/>
                      </a:lnTo>
                      <a:lnTo>
                        <a:pt x="1044" y="25"/>
                      </a:lnTo>
                      <a:lnTo>
                        <a:pt x="1044" y="24"/>
                      </a:lnTo>
                      <a:lnTo>
                        <a:pt x="1044" y="27"/>
                      </a:lnTo>
                      <a:lnTo>
                        <a:pt x="1044" y="25"/>
                      </a:lnTo>
                      <a:lnTo>
                        <a:pt x="1045" y="25"/>
                      </a:lnTo>
                      <a:lnTo>
                        <a:pt x="1045" y="23"/>
                      </a:lnTo>
                      <a:lnTo>
                        <a:pt x="1045" y="27"/>
                      </a:lnTo>
                      <a:lnTo>
                        <a:pt x="1045" y="25"/>
                      </a:lnTo>
                      <a:lnTo>
                        <a:pt x="1046" y="25"/>
                      </a:lnTo>
                      <a:lnTo>
                        <a:pt x="1046" y="23"/>
                      </a:lnTo>
                      <a:lnTo>
                        <a:pt x="1046" y="27"/>
                      </a:lnTo>
                      <a:lnTo>
                        <a:pt x="1046" y="24"/>
                      </a:lnTo>
                      <a:lnTo>
                        <a:pt x="1047" y="24"/>
                      </a:lnTo>
                      <a:lnTo>
                        <a:pt x="1047" y="23"/>
                      </a:lnTo>
                      <a:lnTo>
                        <a:pt x="1047" y="27"/>
                      </a:lnTo>
                      <a:lnTo>
                        <a:pt x="1047" y="27"/>
                      </a:lnTo>
                      <a:lnTo>
                        <a:pt x="1048" y="27"/>
                      </a:lnTo>
                      <a:lnTo>
                        <a:pt x="1048" y="24"/>
                      </a:lnTo>
                      <a:lnTo>
                        <a:pt x="1048" y="26"/>
                      </a:lnTo>
                      <a:lnTo>
                        <a:pt x="1048" y="24"/>
                      </a:lnTo>
                      <a:lnTo>
                        <a:pt x="1049" y="24"/>
                      </a:lnTo>
                      <a:lnTo>
                        <a:pt x="1049" y="23"/>
                      </a:lnTo>
                      <a:lnTo>
                        <a:pt x="1049" y="25"/>
                      </a:lnTo>
                      <a:lnTo>
                        <a:pt x="1049" y="24"/>
                      </a:lnTo>
                      <a:lnTo>
                        <a:pt x="1050" y="24"/>
                      </a:lnTo>
                      <a:lnTo>
                        <a:pt x="1050" y="22"/>
                      </a:lnTo>
                      <a:lnTo>
                        <a:pt x="1050" y="25"/>
                      </a:lnTo>
                      <a:lnTo>
                        <a:pt x="1050" y="23"/>
                      </a:lnTo>
                      <a:lnTo>
                        <a:pt x="1051" y="23"/>
                      </a:lnTo>
                      <a:lnTo>
                        <a:pt x="1051" y="23"/>
                      </a:lnTo>
                      <a:lnTo>
                        <a:pt x="1051" y="25"/>
                      </a:lnTo>
                      <a:lnTo>
                        <a:pt x="1051" y="25"/>
                      </a:lnTo>
                      <a:lnTo>
                        <a:pt x="1052" y="25"/>
                      </a:lnTo>
                      <a:lnTo>
                        <a:pt x="1052" y="23"/>
                      </a:lnTo>
                      <a:lnTo>
                        <a:pt x="1052" y="26"/>
                      </a:lnTo>
                      <a:lnTo>
                        <a:pt x="1052" y="24"/>
                      </a:lnTo>
                      <a:lnTo>
                        <a:pt x="1053" y="24"/>
                      </a:lnTo>
                      <a:lnTo>
                        <a:pt x="1053" y="23"/>
                      </a:lnTo>
                      <a:lnTo>
                        <a:pt x="1053" y="25"/>
                      </a:lnTo>
                      <a:lnTo>
                        <a:pt x="1053" y="25"/>
                      </a:lnTo>
                      <a:lnTo>
                        <a:pt x="1054" y="25"/>
                      </a:lnTo>
                      <a:lnTo>
                        <a:pt x="1054" y="23"/>
                      </a:lnTo>
                      <a:lnTo>
                        <a:pt x="1054" y="26"/>
                      </a:lnTo>
                      <a:lnTo>
                        <a:pt x="1054" y="25"/>
                      </a:lnTo>
                      <a:lnTo>
                        <a:pt x="1055" y="25"/>
                      </a:lnTo>
                      <a:lnTo>
                        <a:pt x="1055" y="23"/>
                      </a:lnTo>
                      <a:lnTo>
                        <a:pt x="1055" y="26"/>
                      </a:lnTo>
                      <a:lnTo>
                        <a:pt x="1055" y="25"/>
                      </a:lnTo>
                      <a:lnTo>
                        <a:pt x="1056" y="25"/>
                      </a:lnTo>
                      <a:lnTo>
                        <a:pt x="1056" y="24"/>
                      </a:lnTo>
                      <a:lnTo>
                        <a:pt x="1056" y="25"/>
                      </a:lnTo>
                      <a:lnTo>
                        <a:pt x="1056" y="24"/>
                      </a:lnTo>
                      <a:lnTo>
                        <a:pt x="1057" y="24"/>
                      </a:lnTo>
                      <a:lnTo>
                        <a:pt x="1057" y="23"/>
                      </a:lnTo>
                      <a:lnTo>
                        <a:pt x="1057" y="25"/>
                      </a:lnTo>
                      <a:lnTo>
                        <a:pt x="1057" y="23"/>
                      </a:lnTo>
                      <a:lnTo>
                        <a:pt x="1058" y="23"/>
                      </a:lnTo>
                      <a:lnTo>
                        <a:pt x="1058" y="22"/>
                      </a:lnTo>
                      <a:lnTo>
                        <a:pt x="1058" y="25"/>
                      </a:lnTo>
                      <a:lnTo>
                        <a:pt x="1058" y="23"/>
                      </a:lnTo>
                      <a:lnTo>
                        <a:pt x="1059" y="23"/>
                      </a:lnTo>
                      <a:lnTo>
                        <a:pt x="1059" y="23"/>
                      </a:lnTo>
                      <a:lnTo>
                        <a:pt x="1059" y="25"/>
                      </a:lnTo>
                      <a:lnTo>
                        <a:pt x="1059" y="23"/>
                      </a:lnTo>
                      <a:lnTo>
                        <a:pt x="1060" y="23"/>
                      </a:lnTo>
                      <a:lnTo>
                        <a:pt x="1060" y="23"/>
                      </a:lnTo>
                      <a:lnTo>
                        <a:pt x="1060" y="26"/>
                      </a:lnTo>
                      <a:lnTo>
                        <a:pt x="1060" y="23"/>
                      </a:lnTo>
                      <a:lnTo>
                        <a:pt x="1061" y="23"/>
                      </a:lnTo>
                      <a:lnTo>
                        <a:pt x="1061" y="22"/>
                      </a:lnTo>
                      <a:lnTo>
                        <a:pt x="1061" y="26"/>
                      </a:lnTo>
                      <a:lnTo>
                        <a:pt x="1061" y="24"/>
                      </a:lnTo>
                      <a:lnTo>
                        <a:pt x="1062" y="24"/>
                      </a:lnTo>
                      <a:lnTo>
                        <a:pt x="1062" y="22"/>
                      </a:lnTo>
                      <a:lnTo>
                        <a:pt x="1062" y="26"/>
                      </a:lnTo>
                      <a:lnTo>
                        <a:pt x="1062" y="26"/>
                      </a:lnTo>
                      <a:lnTo>
                        <a:pt x="1063" y="26"/>
                      </a:lnTo>
                      <a:lnTo>
                        <a:pt x="1063" y="23"/>
                      </a:lnTo>
                      <a:lnTo>
                        <a:pt x="1063" y="25"/>
                      </a:lnTo>
                      <a:lnTo>
                        <a:pt x="1063" y="24"/>
                      </a:lnTo>
                      <a:lnTo>
                        <a:pt x="1064" y="24"/>
                      </a:lnTo>
                      <a:lnTo>
                        <a:pt x="1064" y="23"/>
                      </a:lnTo>
                      <a:lnTo>
                        <a:pt x="1064" y="26"/>
                      </a:lnTo>
                      <a:lnTo>
                        <a:pt x="1064" y="24"/>
                      </a:lnTo>
                      <a:lnTo>
                        <a:pt x="1065" y="24"/>
                      </a:lnTo>
                      <a:lnTo>
                        <a:pt x="1065" y="23"/>
                      </a:lnTo>
                      <a:lnTo>
                        <a:pt x="1065" y="25"/>
                      </a:lnTo>
                      <a:lnTo>
                        <a:pt x="1065" y="23"/>
                      </a:lnTo>
                      <a:lnTo>
                        <a:pt x="1066" y="23"/>
                      </a:lnTo>
                      <a:lnTo>
                        <a:pt x="1066" y="22"/>
                      </a:lnTo>
                      <a:lnTo>
                        <a:pt x="1066" y="25"/>
                      </a:lnTo>
                      <a:lnTo>
                        <a:pt x="1066" y="23"/>
                      </a:lnTo>
                      <a:lnTo>
                        <a:pt x="1067" y="23"/>
                      </a:lnTo>
                      <a:lnTo>
                        <a:pt x="1067" y="22"/>
                      </a:lnTo>
                      <a:lnTo>
                        <a:pt x="1067" y="25"/>
                      </a:lnTo>
                      <a:lnTo>
                        <a:pt x="1067" y="25"/>
                      </a:lnTo>
                      <a:lnTo>
                        <a:pt x="1068" y="25"/>
                      </a:lnTo>
                      <a:lnTo>
                        <a:pt x="1068" y="22"/>
                      </a:lnTo>
                      <a:lnTo>
                        <a:pt x="1068" y="26"/>
                      </a:lnTo>
                      <a:lnTo>
                        <a:pt x="1068" y="25"/>
                      </a:lnTo>
                      <a:lnTo>
                        <a:pt x="1069" y="25"/>
                      </a:lnTo>
                      <a:lnTo>
                        <a:pt x="1069" y="22"/>
                      </a:lnTo>
                      <a:lnTo>
                        <a:pt x="1069" y="25"/>
                      </a:lnTo>
                      <a:lnTo>
                        <a:pt x="1069" y="24"/>
                      </a:lnTo>
                      <a:lnTo>
                        <a:pt x="1070" y="24"/>
                      </a:lnTo>
                      <a:lnTo>
                        <a:pt x="1070" y="22"/>
                      </a:lnTo>
                      <a:lnTo>
                        <a:pt x="1070" y="24"/>
                      </a:lnTo>
                      <a:lnTo>
                        <a:pt x="1070" y="23"/>
                      </a:lnTo>
                      <a:lnTo>
                        <a:pt x="1071" y="23"/>
                      </a:lnTo>
                      <a:lnTo>
                        <a:pt x="1071" y="21"/>
                      </a:lnTo>
                      <a:lnTo>
                        <a:pt x="1071" y="25"/>
                      </a:lnTo>
                      <a:lnTo>
                        <a:pt x="1071" y="23"/>
                      </a:lnTo>
                      <a:lnTo>
                        <a:pt x="1072" y="23"/>
                      </a:lnTo>
                      <a:lnTo>
                        <a:pt x="1072" y="22"/>
                      </a:lnTo>
                      <a:lnTo>
                        <a:pt x="1072" y="25"/>
                      </a:lnTo>
                      <a:lnTo>
                        <a:pt x="1072" y="23"/>
                      </a:lnTo>
                      <a:lnTo>
                        <a:pt x="1073" y="23"/>
                      </a:lnTo>
                      <a:lnTo>
                        <a:pt x="1073" y="21"/>
                      </a:lnTo>
                      <a:lnTo>
                        <a:pt x="1073" y="24"/>
                      </a:lnTo>
                      <a:lnTo>
                        <a:pt x="1073" y="23"/>
                      </a:lnTo>
                      <a:lnTo>
                        <a:pt x="1074" y="23"/>
                      </a:lnTo>
                      <a:lnTo>
                        <a:pt x="1074" y="21"/>
                      </a:lnTo>
                      <a:lnTo>
                        <a:pt x="1074" y="24"/>
                      </a:lnTo>
                      <a:lnTo>
                        <a:pt x="1074" y="23"/>
                      </a:lnTo>
                      <a:lnTo>
                        <a:pt x="1075" y="23"/>
                      </a:lnTo>
                      <a:lnTo>
                        <a:pt x="1075" y="22"/>
                      </a:lnTo>
                      <a:lnTo>
                        <a:pt x="1075" y="23"/>
                      </a:lnTo>
                      <a:lnTo>
                        <a:pt x="1075" y="23"/>
                      </a:lnTo>
                      <a:lnTo>
                        <a:pt x="1076" y="23"/>
                      </a:lnTo>
                      <a:lnTo>
                        <a:pt x="1076" y="22"/>
                      </a:lnTo>
                      <a:lnTo>
                        <a:pt x="1076" y="24"/>
                      </a:lnTo>
                      <a:lnTo>
                        <a:pt x="1076" y="24"/>
                      </a:lnTo>
                      <a:lnTo>
                        <a:pt x="1077" y="24"/>
                      </a:lnTo>
                      <a:lnTo>
                        <a:pt x="1077" y="21"/>
                      </a:lnTo>
                      <a:lnTo>
                        <a:pt x="1077" y="25"/>
                      </a:lnTo>
                      <a:lnTo>
                        <a:pt x="1077" y="24"/>
                      </a:lnTo>
                      <a:lnTo>
                        <a:pt x="1078" y="24"/>
                      </a:lnTo>
                      <a:lnTo>
                        <a:pt x="1078" y="23"/>
                      </a:lnTo>
                      <a:lnTo>
                        <a:pt x="1078" y="25"/>
                      </a:lnTo>
                      <a:lnTo>
                        <a:pt x="1078" y="23"/>
                      </a:lnTo>
                      <a:lnTo>
                        <a:pt x="1079" y="23"/>
                      </a:lnTo>
                      <a:lnTo>
                        <a:pt x="1079" y="21"/>
                      </a:lnTo>
                      <a:lnTo>
                        <a:pt x="1079" y="25"/>
                      </a:lnTo>
                      <a:lnTo>
                        <a:pt x="1079" y="23"/>
                      </a:lnTo>
                      <a:lnTo>
                        <a:pt x="1080" y="23"/>
                      </a:lnTo>
                      <a:lnTo>
                        <a:pt x="1080" y="22"/>
                      </a:lnTo>
                      <a:lnTo>
                        <a:pt x="1080" y="25"/>
                      </a:lnTo>
                      <a:lnTo>
                        <a:pt x="1080" y="23"/>
                      </a:lnTo>
                      <a:lnTo>
                        <a:pt x="1081" y="23"/>
                      </a:lnTo>
                      <a:lnTo>
                        <a:pt x="1081" y="23"/>
                      </a:lnTo>
                      <a:lnTo>
                        <a:pt x="1081" y="25"/>
                      </a:lnTo>
                      <a:lnTo>
                        <a:pt x="1081" y="23"/>
                      </a:lnTo>
                      <a:lnTo>
                        <a:pt x="1082" y="23"/>
                      </a:lnTo>
                      <a:lnTo>
                        <a:pt x="1082" y="23"/>
                      </a:lnTo>
                      <a:lnTo>
                        <a:pt x="1082" y="25"/>
                      </a:lnTo>
                      <a:lnTo>
                        <a:pt x="1082" y="24"/>
                      </a:lnTo>
                      <a:lnTo>
                        <a:pt x="1083" y="24"/>
                      </a:lnTo>
                      <a:lnTo>
                        <a:pt x="1083" y="21"/>
                      </a:lnTo>
                      <a:lnTo>
                        <a:pt x="1083" y="25"/>
                      </a:lnTo>
                      <a:lnTo>
                        <a:pt x="1083" y="21"/>
                      </a:lnTo>
                      <a:lnTo>
                        <a:pt x="1084" y="21"/>
                      </a:lnTo>
                      <a:lnTo>
                        <a:pt x="1084" y="20"/>
                      </a:lnTo>
                      <a:lnTo>
                        <a:pt x="1084" y="22"/>
                      </a:lnTo>
                      <a:lnTo>
                        <a:pt x="1084" y="20"/>
                      </a:lnTo>
                      <a:lnTo>
                        <a:pt x="1085" y="20"/>
                      </a:lnTo>
                      <a:lnTo>
                        <a:pt x="1085" y="20"/>
                      </a:lnTo>
                      <a:lnTo>
                        <a:pt x="1085" y="25"/>
                      </a:lnTo>
                      <a:lnTo>
                        <a:pt x="1085" y="25"/>
                      </a:lnTo>
                      <a:lnTo>
                        <a:pt x="1086" y="25"/>
                      </a:lnTo>
                      <a:lnTo>
                        <a:pt x="1086" y="22"/>
                      </a:lnTo>
                      <a:lnTo>
                        <a:pt x="1086" y="25"/>
                      </a:lnTo>
                      <a:lnTo>
                        <a:pt x="1086" y="23"/>
                      </a:lnTo>
                      <a:lnTo>
                        <a:pt x="1087" y="23"/>
                      </a:lnTo>
                      <a:lnTo>
                        <a:pt x="1087" y="22"/>
                      </a:lnTo>
                      <a:lnTo>
                        <a:pt x="1087" y="24"/>
                      </a:lnTo>
                      <a:lnTo>
                        <a:pt x="1087" y="23"/>
                      </a:lnTo>
                      <a:lnTo>
                        <a:pt x="1088" y="23"/>
                      </a:lnTo>
                      <a:lnTo>
                        <a:pt x="1088" y="21"/>
                      </a:lnTo>
                      <a:lnTo>
                        <a:pt x="1088" y="23"/>
                      </a:lnTo>
                      <a:lnTo>
                        <a:pt x="1088" y="23"/>
                      </a:lnTo>
                      <a:lnTo>
                        <a:pt x="1089" y="23"/>
                      </a:lnTo>
                      <a:lnTo>
                        <a:pt x="1089" y="21"/>
                      </a:lnTo>
                      <a:lnTo>
                        <a:pt x="1089" y="25"/>
                      </a:lnTo>
                      <a:lnTo>
                        <a:pt x="1089" y="21"/>
                      </a:lnTo>
                      <a:lnTo>
                        <a:pt x="1090" y="21"/>
                      </a:lnTo>
                      <a:lnTo>
                        <a:pt x="1090" y="20"/>
                      </a:lnTo>
                      <a:lnTo>
                        <a:pt x="1090" y="23"/>
                      </a:lnTo>
                      <a:lnTo>
                        <a:pt x="1090" y="20"/>
                      </a:lnTo>
                      <a:lnTo>
                        <a:pt x="1091" y="20"/>
                      </a:lnTo>
                      <a:lnTo>
                        <a:pt x="1091" y="20"/>
                      </a:lnTo>
                      <a:lnTo>
                        <a:pt x="1091" y="24"/>
                      </a:lnTo>
                      <a:lnTo>
                        <a:pt x="1091" y="24"/>
                      </a:lnTo>
                      <a:lnTo>
                        <a:pt x="1092" y="24"/>
                      </a:lnTo>
                      <a:lnTo>
                        <a:pt x="1092" y="21"/>
                      </a:lnTo>
                      <a:lnTo>
                        <a:pt x="1092" y="25"/>
                      </a:lnTo>
                      <a:lnTo>
                        <a:pt x="1092" y="22"/>
                      </a:lnTo>
                      <a:lnTo>
                        <a:pt x="1093" y="22"/>
                      </a:lnTo>
                      <a:lnTo>
                        <a:pt x="1093" y="20"/>
                      </a:lnTo>
                      <a:lnTo>
                        <a:pt x="1093" y="23"/>
                      </a:lnTo>
                      <a:lnTo>
                        <a:pt x="1093" y="21"/>
                      </a:lnTo>
                      <a:lnTo>
                        <a:pt x="1094" y="21"/>
                      </a:lnTo>
                      <a:lnTo>
                        <a:pt x="1094" y="20"/>
                      </a:lnTo>
                      <a:lnTo>
                        <a:pt x="1094" y="23"/>
                      </a:lnTo>
                      <a:lnTo>
                        <a:pt x="1094" y="23"/>
                      </a:lnTo>
                      <a:lnTo>
                        <a:pt x="1095" y="23"/>
                      </a:lnTo>
                      <a:lnTo>
                        <a:pt x="1095" y="21"/>
                      </a:lnTo>
                      <a:lnTo>
                        <a:pt x="1095" y="24"/>
                      </a:lnTo>
                      <a:lnTo>
                        <a:pt x="1095" y="22"/>
                      </a:lnTo>
                      <a:lnTo>
                        <a:pt x="1096" y="22"/>
                      </a:lnTo>
                      <a:lnTo>
                        <a:pt x="1096" y="21"/>
                      </a:lnTo>
                      <a:lnTo>
                        <a:pt x="1096" y="23"/>
                      </a:lnTo>
                      <a:lnTo>
                        <a:pt x="1096" y="23"/>
                      </a:lnTo>
                      <a:lnTo>
                        <a:pt x="1097" y="23"/>
                      </a:lnTo>
                      <a:lnTo>
                        <a:pt x="1097" y="19"/>
                      </a:lnTo>
                      <a:lnTo>
                        <a:pt x="1097" y="23"/>
                      </a:lnTo>
                      <a:lnTo>
                        <a:pt x="1097" y="19"/>
                      </a:lnTo>
                      <a:lnTo>
                        <a:pt x="1098" y="19"/>
                      </a:lnTo>
                      <a:lnTo>
                        <a:pt x="1098" y="19"/>
                      </a:lnTo>
                      <a:lnTo>
                        <a:pt x="1098" y="23"/>
                      </a:lnTo>
                      <a:lnTo>
                        <a:pt x="1098" y="22"/>
                      </a:lnTo>
                      <a:lnTo>
                        <a:pt x="1099" y="22"/>
                      </a:lnTo>
                      <a:lnTo>
                        <a:pt x="1099" y="19"/>
                      </a:lnTo>
                      <a:lnTo>
                        <a:pt x="1099" y="22"/>
                      </a:lnTo>
                      <a:lnTo>
                        <a:pt x="1099" y="20"/>
                      </a:lnTo>
                      <a:lnTo>
                        <a:pt x="1100" y="20"/>
                      </a:lnTo>
                      <a:lnTo>
                        <a:pt x="1100" y="19"/>
                      </a:lnTo>
                      <a:lnTo>
                        <a:pt x="1100" y="22"/>
                      </a:lnTo>
                      <a:lnTo>
                        <a:pt x="1100" y="21"/>
                      </a:lnTo>
                      <a:lnTo>
                        <a:pt x="1101" y="21"/>
                      </a:lnTo>
                      <a:lnTo>
                        <a:pt x="1101" y="19"/>
                      </a:lnTo>
                      <a:lnTo>
                        <a:pt x="1101" y="22"/>
                      </a:lnTo>
                      <a:lnTo>
                        <a:pt x="1101" y="19"/>
                      </a:lnTo>
                      <a:lnTo>
                        <a:pt x="1102" y="19"/>
                      </a:lnTo>
                      <a:lnTo>
                        <a:pt x="1102" y="19"/>
                      </a:lnTo>
                      <a:lnTo>
                        <a:pt x="1102" y="22"/>
                      </a:lnTo>
                      <a:lnTo>
                        <a:pt x="1102" y="21"/>
                      </a:lnTo>
                      <a:lnTo>
                        <a:pt x="1103" y="21"/>
                      </a:lnTo>
                      <a:lnTo>
                        <a:pt x="1103" y="19"/>
                      </a:lnTo>
                      <a:lnTo>
                        <a:pt x="1103" y="24"/>
                      </a:lnTo>
                      <a:lnTo>
                        <a:pt x="1103" y="23"/>
                      </a:lnTo>
                      <a:lnTo>
                        <a:pt x="1104" y="23"/>
                      </a:lnTo>
                      <a:lnTo>
                        <a:pt x="1104" y="20"/>
                      </a:lnTo>
                      <a:lnTo>
                        <a:pt x="1104" y="24"/>
                      </a:lnTo>
                      <a:lnTo>
                        <a:pt x="1104" y="21"/>
                      </a:lnTo>
                      <a:lnTo>
                        <a:pt x="1105" y="21"/>
                      </a:lnTo>
                      <a:lnTo>
                        <a:pt x="1105" y="20"/>
                      </a:lnTo>
                      <a:lnTo>
                        <a:pt x="1105" y="23"/>
                      </a:lnTo>
                      <a:lnTo>
                        <a:pt x="1105" y="21"/>
                      </a:lnTo>
                      <a:lnTo>
                        <a:pt x="1106" y="21"/>
                      </a:lnTo>
                      <a:lnTo>
                        <a:pt x="1106" y="19"/>
                      </a:lnTo>
                      <a:lnTo>
                        <a:pt x="1106" y="23"/>
                      </a:lnTo>
                      <a:lnTo>
                        <a:pt x="1106" y="20"/>
                      </a:lnTo>
                      <a:lnTo>
                        <a:pt x="1107" y="20"/>
                      </a:lnTo>
                      <a:lnTo>
                        <a:pt x="1107" y="20"/>
                      </a:lnTo>
                      <a:lnTo>
                        <a:pt x="1107" y="24"/>
                      </a:lnTo>
                      <a:lnTo>
                        <a:pt x="1107" y="22"/>
                      </a:lnTo>
                      <a:lnTo>
                        <a:pt x="1108" y="22"/>
                      </a:lnTo>
                      <a:lnTo>
                        <a:pt x="1108" y="19"/>
                      </a:lnTo>
                      <a:lnTo>
                        <a:pt x="1108" y="23"/>
                      </a:lnTo>
                      <a:lnTo>
                        <a:pt x="1108" y="22"/>
                      </a:lnTo>
                      <a:lnTo>
                        <a:pt x="1109" y="22"/>
                      </a:lnTo>
                      <a:lnTo>
                        <a:pt x="1109" y="20"/>
                      </a:lnTo>
                      <a:lnTo>
                        <a:pt x="1109" y="22"/>
                      </a:lnTo>
                      <a:lnTo>
                        <a:pt x="1109" y="20"/>
                      </a:lnTo>
                      <a:lnTo>
                        <a:pt x="1110" y="20"/>
                      </a:lnTo>
                      <a:lnTo>
                        <a:pt x="1110" y="19"/>
                      </a:lnTo>
                      <a:lnTo>
                        <a:pt x="1110" y="22"/>
                      </a:lnTo>
                      <a:lnTo>
                        <a:pt x="1110" y="20"/>
                      </a:lnTo>
                      <a:lnTo>
                        <a:pt x="1111" y="20"/>
                      </a:lnTo>
                      <a:lnTo>
                        <a:pt x="1111" y="19"/>
                      </a:lnTo>
                      <a:lnTo>
                        <a:pt x="1111" y="22"/>
                      </a:lnTo>
                      <a:lnTo>
                        <a:pt x="1111" y="21"/>
                      </a:lnTo>
                      <a:lnTo>
                        <a:pt x="1112" y="21"/>
                      </a:lnTo>
                      <a:lnTo>
                        <a:pt x="1112" y="20"/>
                      </a:lnTo>
                      <a:lnTo>
                        <a:pt x="1112" y="23"/>
                      </a:lnTo>
                      <a:lnTo>
                        <a:pt x="1112" y="22"/>
                      </a:lnTo>
                      <a:lnTo>
                        <a:pt x="1113" y="22"/>
                      </a:lnTo>
                      <a:lnTo>
                        <a:pt x="1113" y="20"/>
                      </a:lnTo>
                      <a:lnTo>
                        <a:pt x="1113" y="23"/>
                      </a:lnTo>
                      <a:lnTo>
                        <a:pt x="1113" y="23"/>
                      </a:lnTo>
                      <a:lnTo>
                        <a:pt x="1114" y="23"/>
                      </a:lnTo>
                      <a:lnTo>
                        <a:pt x="1114" y="20"/>
                      </a:lnTo>
                      <a:lnTo>
                        <a:pt x="1114" y="23"/>
                      </a:lnTo>
                      <a:lnTo>
                        <a:pt x="1114" y="20"/>
                      </a:lnTo>
                      <a:lnTo>
                        <a:pt x="1115" y="20"/>
                      </a:lnTo>
                      <a:lnTo>
                        <a:pt x="1115" y="20"/>
                      </a:lnTo>
                      <a:lnTo>
                        <a:pt x="1115" y="23"/>
                      </a:lnTo>
                      <a:lnTo>
                        <a:pt x="1115" y="22"/>
                      </a:lnTo>
                      <a:lnTo>
                        <a:pt x="1116" y="22"/>
                      </a:lnTo>
                      <a:lnTo>
                        <a:pt x="1116" y="21"/>
                      </a:lnTo>
                      <a:lnTo>
                        <a:pt x="1116" y="24"/>
                      </a:lnTo>
                      <a:lnTo>
                        <a:pt x="1116" y="22"/>
                      </a:lnTo>
                      <a:lnTo>
                        <a:pt x="1117" y="22"/>
                      </a:lnTo>
                      <a:lnTo>
                        <a:pt x="1117" y="19"/>
                      </a:lnTo>
                      <a:lnTo>
                        <a:pt x="1117" y="23"/>
                      </a:lnTo>
                      <a:lnTo>
                        <a:pt x="1117" y="22"/>
                      </a:lnTo>
                      <a:lnTo>
                        <a:pt x="1118" y="22"/>
                      </a:lnTo>
                      <a:lnTo>
                        <a:pt x="1118" y="19"/>
                      </a:lnTo>
                      <a:lnTo>
                        <a:pt x="1118" y="23"/>
                      </a:lnTo>
                      <a:lnTo>
                        <a:pt x="1118" y="22"/>
                      </a:lnTo>
                      <a:lnTo>
                        <a:pt x="1119" y="22"/>
                      </a:lnTo>
                      <a:lnTo>
                        <a:pt x="1119" y="19"/>
                      </a:lnTo>
                      <a:lnTo>
                        <a:pt x="1119" y="21"/>
                      </a:lnTo>
                      <a:lnTo>
                        <a:pt x="1119" y="21"/>
                      </a:lnTo>
                      <a:lnTo>
                        <a:pt x="1120" y="21"/>
                      </a:lnTo>
                      <a:lnTo>
                        <a:pt x="1120" y="19"/>
                      </a:lnTo>
                      <a:lnTo>
                        <a:pt x="1120" y="23"/>
                      </a:lnTo>
                      <a:lnTo>
                        <a:pt x="1120" y="21"/>
                      </a:lnTo>
                      <a:lnTo>
                        <a:pt x="1121" y="21"/>
                      </a:lnTo>
                      <a:lnTo>
                        <a:pt x="1121" y="20"/>
                      </a:lnTo>
                      <a:lnTo>
                        <a:pt x="1121" y="24"/>
                      </a:lnTo>
                      <a:lnTo>
                        <a:pt x="1121" y="21"/>
                      </a:lnTo>
                      <a:lnTo>
                        <a:pt x="1122" y="21"/>
                      </a:lnTo>
                      <a:lnTo>
                        <a:pt x="1122" y="21"/>
                      </a:lnTo>
                      <a:lnTo>
                        <a:pt x="1122" y="24"/>
                      </a:lnTo>
                      <a:lnTo>
                        <a:pt x="1122" y="21"/>
                      </a:lnTo>
                      <a:lnTo>
                        <a:pt x="1123" y="21"/>
                      </a:lnTo>
                      <a:lnTo>
                        <a:pt x="1123" y="20"/>
                      </a:lnTo>
                      <a:lnTo>
                        <a:pt x="1123" y="23"/>
                      </a:lnTo>
                      <a:lnTo>
                        <a:pt x="1123" y="20"/>
                      </a:lnTo>
                      <a:lnTo>
                        <a:pt x="1124" y="20"/>
                      </a:lnTo>
                      <a:lnTo>
                        <a:pt x="1124" y="20"/>
                      </a:lnTo>
                      <a:lnTo>
                        <a:pt x="1124" y="23"/>
                      </a:lnTo>
                      <a:lnTo>
                        <a:pt x="1124" y="23"/>
                      </a:lnTo>
                      <a:lnTo>
                        <a:pt x="1125" y="23"/>
                      </a:lnTo>
                      <a:lnTo>
                        <a:pt x="1125" y="20"/>
                      </a:lnTo>
                      <a:lnTo>
                        <a:pt x="1125" y="25"/>
                      </a:lnTo>
                      <a:lnTo>
                        <a:pt x="1125" y="23"/>
                      </a:lnTo>
                      <a:lnTo>
                        <a:pt x="1126" y="23"/>
                      </a:lnTo>
                      <a:lnTo>
                        <a:pt x="1126" y="21"/>
                      </a:lnTo>
                      <a:lnTo>
                        <a:pt x="1126" y="24"/>
                      </a:lnTo>
                      <a:lnTo>
                        <a:pt x="1126" y="22"/>
                      </a:lnTo>
                      <a:lnTo>
                        <a:pt x="1127" y="22"/>
                      </a:lnTo>
                      <a:lnTo>
                        <a:pt x="1127" y="20"/>
                      </a:lnTo>
                      <a:lnTo>
                        <a:pt x="1127" y="23"/>
                      </a:lnTo>
                      <a:lnTo>
                        <a:pt x="1127" y="22"/>
                      </a:lnTo>
                      <a:lnTo>
                        <a:pt x="1128" y="22"/>
                      </a:lnTo>
                      <a:lnTo>
                        <a:pt x="1128" y="21"/>
                      </a:lnTo>
                      <a:lnTo>
                        <a:pt x="1128" y="24"/>
                      </a:lnTo>
                      <a:lnTo>
                        <a:pt x="1128" y="24"/>
                      </a:lnTo>
                      <a:lnTo>
                        <a:pt x="1129" y="24"/>
                      </a:lnTo>
                      <a:lnTo>
                        <a:pt x="1129" y="22"/>
                      </a:lnTo>
                      <a:lnTo>
                        <a:pt x="1129" y="25"/>
                      </a:lnTo>
                      <a:lnTo>
                        <a:pt x="1129" y="24"/>
                      </a:lnTo>
                      <a:lnTo>
                        <a:pt x="1130" y="24"/>
                      </a:lnTo>
                      <a:lnTo>
                        <a:pt x="1130" y="22"/>
                      </a:lnTo>
                      <a:lnTo>
                        <a:pt x="1130" y="25"/>
                      </a:lnTo>
                      <a:lnTo>
                        <a:pt x="1130" y="23"/>
                      </a:lnTo>
                      <a:lnTo>
                        <a:pt x="1131" y="23"/>
                      </a:lnTo>
                      <a:lnTo>
                        <a:pt x="1131" y="23"/>
                      </a:lnTo>
                      <a:lnTo>
                        <a:pt x="1131" y="26"/>
                      </a:lnTo>
                      <a:lnTo>
                        <a:pt x="1131" y="23"/>
                      </a:lnTo>
                      <a:lnTo>
                        <a:pt x="1132" y="23"/>
                      </a:lnTo>
                      <a:lnTo>
                        <a:pt x="1132" y="23"/>
                      </a:lnTo>
                      <a:lnTo>
                        <a:pt x="1132" y="25"/>
                      </a:lnTo>
                      <a:lnTo>
                        <a:pt x="1132" y="23"/>
                      </a:lnTo>
                      <a:lnTo>
                        <a:pt x="1133" y="23"/>
                      </a:lnTo>
                      <a:lnTo>
                        <a:pt x="1133" y="22"/>
                      </a:lnTo>
                      <a:lnTo>
                        <a:pt x="1133" y="25"/>
                      </a:lnTo>
                      <a:lnTo>
                        <a:pt x="1133" y="25"/>
                      </a:lnTo>
                      <a:lnTo>
                        <a:pt x="1134" y="25"/>
                      </a:lnTo>
                      <a:lnTo>
                        <a:pt x="1134" y="21"/>
                      </a:lnTo>
                      <a:lnTo>
                        <a:pt x="1134" y="25"/>
                      </a:lnTo>
                      <a:lnTo>
                        <a:pt x="1134" y="22"/>
                      </a:lnTo>
                      <a:lnTo>
                        <a:pt x="1135" y="22"/>
                      </a:lnTo>
                      <a:lnTo>
                        <a:pt x="1135" y="19"/>
                      </a:lnTo>
                      <a:lnTo>
                        <a:pt x="1135" y="23"/>
                      </a:lnTo>
                      <a:lnTo>
                        <a:pt x="1135" y="22"/>
                      </a:lnTo>
                      <a:lnTo>
                        <a:pt x="1136" y="22"/>
                      </a:lnTo>
                      <a:lnTo>
                        <a:pt x="1136" y="20"/>
                      </a:lnTo>
                      <a:lnTo>
                        <a:pt x="1136" y="24"/>
                      </a:lnTo>
                      <a:lnTo>
                        <a:pt x="1136" y="21"/>
                      </a:lnTo>
                      <a:lnTo>
                        <a:pt x="1137" y="21"/>
                      </a:lnTo>
                      <a:lnTo>
                        <a:pt x="1137" y="20"/>
                      </a:lnTo>
                      <a:lnTo>
                        <a:pt x="1137" y="25"/>
                      </a:lnTo>
                      <a:lnTo>
                        <a:pt x="1137" y="23"/>
                      </a:lnTo>
                      <a:lnTo>
                        <a:pt x="1138" y="23"/>
                      </a:lnTo>
                      <a:lnTo>
                        <a:pt x="1138" y="22"/>
                      </a:lnTo>
                      <a:lnTo>
                        <a:pt x="1138" y="25"/>
                      </a:lnTo>
                      <a:lnTo>
                        <a:pt x="1138" y="23"/>
                      </a:lnTo>
                      <a:lnTo>
                        <a:pt x="1139" y="23"/>
                      </a:lnTo>
                      <a:lnTo>
                        <a:pt x="1139" y="22"/>
                      </a:lnTo>
                      <a:lnTo>
                        <a:pt x="1139" y="25"/>
                      </a:lnTo>
                      <a:lnTo>
                        <a:pt x="1139" y="22"/>
                      </a:lnTo>
                      <a:lnTo>
                        <a:pt x="1140" y="22"/>
                      </a:lnTo>
                      <a:lnTo>
                        <a:pt x="1140" y="22"/>
                      </a:lnTo>
                      <a:lnTo>
                        <a:pt x="1140" y="25"/>
                      </a:lnTo>
                      <a:lnTo>
                        <a:pt x="1140" y="24"/>
                      </a:lnTo>
                      <a:lnTo>
                        <a:pt x="1141" y="24"/>
                      </a:lnTo>
                      <a:lnTo>
                        <a:pt x="1141" y="22"/>
                      </a:lnTo>
                      <a:lnTo>
                        <a:pt x="1141" y="24"/>
                      </a:lnTo>
                      <a:lnTo>
                        <a:pt x="1141" y="23"/>
                      </a:lnTo>
                      <a:lnTo>
                        <a:pt x="1142" y="23"/>
                      </a:lnTo>
                      <a:lnTo>
                        <a:pt x="1142" y="22"/>
                      </a:lnTo>
                      <a:lnTo>
                        <a:pt x="1142" y="25"/>
                      </a:lnTo>
                      <a:lnTo>
                        <a:pt x="1142" y="24"/>
                      </a:lnTo>
                      <a:lnTo>
                        <a:pt x="1143" y="24"/>
                      </a:lnTo>
                      <a:lnTo>
                        <a:pt x="1143" y="21"/>
                      </a:lnTo>
                      <a:lnTo>
                        <a:pt x="1143" y="24"/>
                      </a:lnTo>
                      <a:lnTo>
                        <a:pt x="1143" y="23"/>
                      </a:lnTo>
                      <a:lnTo>
                        <a:pt x="1144" y="23"/>
                      </a:lnTo>
                      <a:lnTo>
                        <a:pt x="1144" y="20"/>
                      </a:lnTo>
                      <a:lnTo>
                        <a:pt x="1144" y="23"/>
                      </a:lnTo>
                      <a:lnTo>
                        <a:pt x="1144" y="23"/>
                      </a:lnTo>
                      <a:lnTo>
                        <a:pt x="1145" y="23"/>
                      </a:lnTo>
                      <a:lnTo>
                        <a:pt x="1145" y="22"/>
                      </a:lnTo>
                      <a:lnTo>
                        <a:pt x="1145" y="25"/>
                      </a:lnTo>
                      <a:lnTo>
                        <a:pt x="1145" y="24"/>
                      </a:lnTo>
                      <a:lnTo>
                        <a:pt x="1146" y="24"/>
                      </a:lnTo>
                      <a:lnTo>
                        <a:pt x="1146" y="22"/>
                      </a:lnTo>
                      <a:lnTo>
                        <a:pt x="1146" y="25"/>
                      </a:lnTo>
                      <a:lnTo>
                        <a:pt x="1146" y="23"/>
                      </a:lnTo>
                      <a:lnTo>
                        <a:pt x="1147" y="23"/>
                      </a:lnTo>
                      <a:lnTo>
                        <a:pt x="1147" y="20"/>
                      </a:lnTo>
                      <a:lnTo>
                        <a:pt x="1147" y="25"/>
                      </a:lnTo>
                      <a:lnTo>
                        <a:pt x="1147" y="20"/>
                      </a:lnTo>
                      <a:lnTo>
                        <a:pt x="1148" y="20"/>
                      </a:lnTo>
                      <a:lnTo>
                        <a:pt x="1148" y="20"/>
                      </a:lnTo>
                      <a:lnTo>
                        <a:pt x="1148" y="23"/>
                      </a:lnTo>
                      <a:lnTo>
                        <a:pt x="1148" y="21"/>
                      </a:lnTo>
                      <a:lnTo>
                        <a:pt x="1149" y="21"/>
                      </a:lnTo>
                      <a:lnTo>
                        <a:pt x="1149" y="21"/>
                      </a:lnTo>
                      <a:lnTo>
                        <a:pt x="1149" y="23"/>
                      </a:lnTo>
                      <a:lnTo>
                        <a:pt x="1149" y="23"/>
                      </a:lnTo>
                      <a:lnTo>
                        <a:pt x="1150" y="23"/>
                      </a:lnTo>
                      <a:lnTo>
                        <a:pt x="1150" y="21"/>
                      </a:lnTo>
                      <a:lnTo>
                        <a:pt x="1150" y="23"/>
                      </a:lnTo>
                      <a:lnTo>
                        <a:pt x="1150" y="23"/>
                      </a:lnTo>
                      <a:lnTo>
                        <a:pt x="1151" y="23"/>
                      </a:lnTo>
                      <a:lnTo>
                        <a:pt x="1151" y="22"/>
                      </a:lnTo>
                      <a:lnTo>
                        <a:pt x="1151" y="25"/>
                      </a:lnTo>
                      <a:lnTo>
                        <a:pt x="1151" y="24"/>
                      </a:lnTo>
                      <a:lnTo>
                        <a:pt x="1152" y="24"/>
                      </a:lnTo>
                      <a:lnTo>
                        <a:pt x="1152" y="20"/>
                      </a:lnTo>
                      <a:lnTo>
                        <a:pt x="1152" y="23"/>
                      </a:lnTo>
                      <a:lnTo>
                        <a:pt x="1152" y="20"/>
                      </a:lnTo>
                      <a:lnTo>
                        <a:pt x="1153" y="20"/>
                      </a:lnTo>
                      <a:lnTo>
                        <a:pt x="1153" y="19"/>
                      </a:lnTo>
                      <a:lnTo>
                        <a:pt x="1153" y="23"/>
                      </a:lnTo>
                      <a:lnTo>
                        <a:pt x="1153" y="22"/>
                      </a:lnTo>
                      <a:lnTo>
                        <a:pt x="1154" y="22"/>
                      </a:lnTo>
                      <a:lnTo>
                        <a:pt x="1154" y="22"/>
                      </a:lnTo>
                      <a:lnTo>
                        <a:pt x="1154" y="24"/>
                      </a:lnTo>
                      <a:lnTo>
                        <a:pt x="1154" y="23"/>
                      </a:lnTo>
                      <a:lnTo>
                        <a:pt x="1155" y="23"/>
                      </a:lnTo>
                      <a:lnTo>
                        <a:pt x="1155" y="21"/>
                      </a:lnTo>
                      <a:lnTo>
                        <a:pt x="1155" y="23"/>
                      </a:lnTo>
                      <a:lnTo>
                        <a:pt x="1155" y="21"/>
                      </a:lnTo>
                      <a:lnTo>
                        <a:pt x="1156" y="21"/>
                      </a:lnTo>
                      <a:lnTo>
                        <a:pt x="1156" y="19"/>
                      </a:lnTo>
                      <a:lnTo>
                        <a:pt x="1156" y="23"/>
                      </a:lnTo>
                      <a:lnTo>
                        <a:pt x="1156" y="20"/>
                      </a:lnTo>
                      <a:lnTo>
                        <a:pt x="1157" y="20"/>
                      </a:lnTo>
                      <a:lnTo>
                        <a:pt x="1157" y="20"/>
                      </a:lnTo>
                      <a:lnTo>
                        <a:pt x="1157" y="24"/>
                      </a:lnTo>
                      <a:lnTo>
                        <a:pt x="1157" y="22"/>
                      </a:lnTo>
                      <a:lnTo>
                        <a:pt x="1158" y="22"/>
                      </a:lnTo>
                      <a:lnTo>
                        <a:pt x="1158" y="21"/>
                      </a:lnTo>
                      <a:lnTo>
                        <a:pt x="1158" y="24"/>
                      </a:lnTo>
                      <a:lnTo>
                        <a:pt x="1158" y="22"/>
                      </a:lnTo>
                      <a:lnTo>
                        <a:pt x="1159" y="22"/>
                      </a:lnTo>
                      <a:lnTo>
                        <a:pt x="1159" y="20"/>
                      </a:lnTo>
                      <a:lnTo>
                        <a:pt x="1159" y="23"/>
                      </a:lnTo>
                      <a:lnTo>
                        <a:pt x="1159" y="23"/>
                      </a:lnTo>
                      <a:lnTo>
                        <a:pt x="1160" y="23"/>
                      </a:lnTo>
                      <a:lnTo>
                        <a:pt x="1160" y="19"/>
                      </a:lnTo>
                      <a:lnTo>
                        <a:pt x="1160" y="23"/>
                      </a:lnTo>
                      <a:lnTo>
                        <a:pt x="1160" y="20"/>
                      </a:lnTo>
                      <a:lnTo>
                        <a:pt x="1161" y="20"/>
                      </a:lnTo>
                      <a:lnTo>
                        <a:pt x="1161" y="19"/>
                      </a:lnTo>
                      <a:lnTo>
                        <a:pt x="1161" y="21"/>
                      </a:lnTo>
                      <a:lnTo>
                        <a:pt x="1161" y="19"/>
                      </a:lnTo>
                      <a:lnTo>
                        <a:pt x="1162" y="19"/>
                      </a:lnTo>
                      <a:lnTo>
                        <a:pt x="1162" y="19"/>
                      </a:lnTo>
                      <a:lnTo>
                        <a:pt x="1162" y="22"/>
                      </a:lnTo>
                      <a:lnTo>
                        <a:pt x="1162" y="22"/>
                      </a:lnTo>
                      <a:lnTo>
                        <a:pt x="1163" y="22"/>
                      </a:lnTo>
                      <a:lnTo>
                        <a:pt x="1163" y="20"/>
                      </a:lnTo>
                      <a:lnTo>
                        <a:pt x="1163" y="23"/>
                      </a:lnTo>
                      <a:lnTo>
                        <a:pt x="1163" y="21"/>
                      </a:lnTo>
                      <a:lnTo>
                        <a:pt x="1164" y="21"/>
                      </a:lnTo>
                      <a:lnTo>
                        <a:pt x="1164" y="20"/>
                      </a:lnTo>
                      <a:lnTo>
                        <a:pt x="1164" y="23"/>
                      </a:lnTo>
                      <a:lnTo>
                        <a:pt x="1164" y="20"/>
                      </a:lnTo>
                      <a:lnTo>
                        <a:pt x="1165" y="20"/>
                      </a:lnTo>
                      <a:lnTo>
                        <a:pt x="1165" y="19"/>
                      </a:lnTo>
                      <a:lnTo>
                        <a:pt x="1165" y="23"/>
                      </a:lnTo>
                      <a:lnTo>
                        <a:pt x="1165" y="20"/>
                      </a:lnTo>
                      <a:lnTo>
                        <a:pt x="1166" y="20"/>
                      </a:lnTo>
                      <a:lnTo>
                        <a:pt x="1166" y="20"/>
                      </a:lnTo>
                      <a:lnTo>
                        <a:pt x="1166" y="22"/>
                      </a:lnTo>
                      <a:lnTo>
                        <a:pt x="1166" y="21"/>
                      </a:lnTo>
                      <a:lnTo>
                        <a:pt x="1167" y="21"/>
                      </a:lnTo>
                      <a:lnTo>
                        <a:pt x="1167" y="19"/>
                      </a:lnTo>
                      <a:lnTo>
                        <a:pt x="1167" y="23"/>
                      </a:lnTo>
                      <a:lnTo>
                        <a:pt x="1167" y="22"/>
                      </a:lnTo>
                      <a:lnTo>
                        <a:pt x="1168" y="22"/>
                      </a:lnTo>
                      <a:lnTo>
                        <a:pt x="1168" y="19"/>
                      </a:lnTo>
                      <a:lnTo>
                        <a:pt x="1168" y="22"/>
                      </a:lnTo>
                      <a:lnTo>
                        <a:pt x="1168" y="22"/>
                      </a:lnTo>
                      <a:lnTo>
                        <a:pt x="1169" y="22"/>
                      </a:lnTo>
                      <a:lnTo>
                        <a:pt x="1169" y="19"/>
                      </a:lnTo>
                      <a:lnTo>
                        <a:pt x="1169" y="22"/>
                      </a:lnTo>
                      <a:lnTo>
                        <a:pt x="1169" y="20"/>
                      </a:lnTo>
                      <a:lnTo>
                        <a:pt x="1170" y="20"/>
                      </a:lnTo>
                      <a:lnTo>
                        <a:pt x="1170" y="19"/>
                      </a:lnTo>
                      <a:lnTo>
                        <a:pt x="1170" y="22"/>
                      </a:lnTo>
                      <a:lnTo>
                        <a:pt x="1170" y="20"/>
                      </a:lnTo>
                      <a:lnTo>
                        <a:pt x="1171" y="20"/>
                      </a:lnTo>
                      <a:lnTo>
                        <a:pt x="1171" y="17"/>
                      </a:lnTo>
                      <a:lnTo>
                        <a:pt x="1171" y="21"/>
                      </a:lnTo>
                      <a:lnTo>
                        <a:pt x="1171" y="19"/>
                      </a:lnTo>
                      <a:lnTo>
                        <a:pt x="1172" y="19"/>
                      </a:lnTo>
                      <a:lnTo>
                        <a:pt x="1172" y="19"/>
                      </a:lnTo>
                      <a:lnTo>
                        <a:pt x="1172" y="22"/>
                      </a:lnTo>
                      <a:lnTo>
                        <a:pt x="1172" y="20"/>
                      </a:lnTo>
                      <a:lnTo>
                        <a:pt x="1173" y="20"/>
                      </a:lnTo>
                      <a:lnTo>
                        <a:pt x="1173" y="19"/>
                      </a:lnTo>
                      <a:lnTo>
                        <a:pt x="1173" y="23"/>
                      </a:lnTo>
                      <a:lnTo>
                        <a:pt x="1173" y="20"/>
                      </a:lnTo>
                      <a:lnTo>
                        <a:pt x="1174" y="20"/>
                      </a:lnTo>
                      <a:lnTo>
                        <a:pt x="1174" y="18"/>
                      </a:lnTo>
                      <a:lnTo>
                        <a:pt x="1174" y="21"/>
                      </a:lnTo>
                      <a:lnTo>
                        <a:pt x="1174" y="20"/>
                      </a:lnTo>
                      <a:lnTo>
                        <a:pt x="1175" y="20"/>
                      </a:lnTo>
                      <a:lnTo>
                        <a:pt x="1175" y="19"/>
                      </a:lnTo>
                      <a:lnTo>
                        <a:pt x="1175" y="22"/>
                      </a:lnTo>
                      <a:lnTo>
                        <a:pt x="1175" y="20"/>
                      </a:lnTo>
                      <a:lnTo>
                        <a:pt x="1176" y="20"/>
                      </a:lnTo>
                      <a:lnTo>
                        <a:pt x="1176" y="19"/>
                      </a:lnTo>
                      <a:lnTo>
                        <a:pt x="1176" y="22"/>
                      </a:lnTo>
                      <a:lnTo>
                        <a:pt x="1176" y="20"/>
                      </a:lnTo>
                      <a:lnTo>
                        <a:pt x="1177" y="20"/>
                      </a:lnTo>
                      <a:lnTo>
                        <a:pt x="1177" y="18"/>
                      </a:lnTo>
                      <a:lnTo>
                        <a:pt x="1177" y="20"/>
                      </a:lnTo>
                      <a:lnTo>
                        <a:pt x="1177" y="19"/>
                      </a:lnTo>
                      <a:lnTo>
                        <a:pt x="1178" y="19"/>
                      </a:lnTo>
                      <a:lnTo>
                        <a:pt x="1178" y="18"/>
                      </a:lnTo>
                      <a:lnTo>
                        <a:pt x="1178" y="22"/>
                      </a:lnTo>
                      <a:lnTo>
                        <a:pt x="1178" y="19"/>
                      </a:lnTo>
                      <a:lnTo>
                        <a:pt x="1179" y="19"/>
                      </a:lnTo>
                      <a:lnTo>
                        <a:pt x="1179" y="16"/>
                      </a:lnTo>
                      <a:lnTo>
                        <a:pt x="1179" y="20"/>
                      </a:lnTo>
                      <a:lnTo>
                        <a:pt x="1179" y="16"/>
                      </a:lnTo>
                      <a:lnTo>
                        <a:pt x="1180" y="16"/>
                      </a:lnTo>
                      <a:lnTo>
                        <a:pt x="1180" y="16"/>
                      </a:lnTo>
                      <a:lnTo>
                        <a:pt x="1180" y="20"/>
                      </a:lnTo>
                      <a:lnTo>
                        <a:pt x="1180" y="20"/>
                      </a:lnTo>
                      <a:lnTo>
                        <a:pt x="1181" y="20"/>
                      </a:lnTo>
                      <a:lnTo>
                        <a:pt x="1181" y="19"/>
                      </a:lnTo>
                      <a:lnTo>
                        <a:pt x="1181" y="21"/>
                      </a:lnTo>
                      <a:lnTo>
                        <a:pt x="1181" y="19"/>
                      </a:lnTo>
                      <a:lnTo>
                        <a:pt x="1182" y="19"/>
                      </a:lnTo>
                      <a:lnTo>
                        <a:pt x="1182" y="18"/>
                      </a:lnTo>
                      <a:lnTo>
                        <a:pt x="1182" y="22"/>
                      </a:lnTo>
                      <a:lnTo>
                        <a:pt x="1182" y="19"/>
                      </a:lnTo>
                      <a:lnTo>
                        <a:pt x="1183" y="19"/>
                      </a:lnTo>
                      <a:lnTo>
                        <a:pt x="1183" y="19"/>
                      </a:lnTo>
                      <a:lnTo>
                        <a:pt x="1183" y="21"/>
                      </a:lnTo>
                      <a:lnTo>
                        <a:pt x="1183" y="20"/>
                      </a:lnTo>
                      <a:lnTo>
                        <a:pt x="1184" y="20"/>
                      </a:lnTo>
                      <a:lnTo>
                        <a:pt x="1184" y="19"/>
                      </a:lnTo>
                      <a:lnTo>
                        <a:pt x="1184" y="21"/>
                      </a:lnTo>
                      <a:lnTo>
                        <a:pt x="1184" y="20"/>
                      </a:lnTo>
                      <a:lnTo>
                        <a:pt x="1185" y="20"/>
                      </a:lnTo>
                      <a:lnTo>
                        <a:pt x="1185" y="18"/>
                      </a:lnTo>
                      <a:lnTo>
                        <a:pt x="1185" y="21"/>
                      </a:lnTo>
                      <a:lnTo>
                        <a:pt x="1185" y="19"/>
                      </a:lnTo>
                      <a:lnTo>
                        <a:pt x="1186" y="19"/>
                      </a:lnTo>
                      <a:lnTo>
                        <a:pt x="1186" y="18"/>
                      </a:lnTo>
                      <a:lnTo>
                        <a:pt x="1186" y="21"/>
                      </a:lnTo>
                      <a:lnTo>
                        <a:pt x="1186" y="19"/>
                      </a:lnTo>
                      <a:lnTo>
                        <a:pt x="1187" y="19"/>
                      </a:lnTo>
                      <a:lnTo>
                        <a:pt x="1187" y="17"/>
                      </a:lnTo>
                      <a:lnTo>
                        <a:pt x="1187" y="20"/>
                      </a:lnTo>
                      <a:lnTo>
                        <a:pt x="1187" y="18"/>
                      </a:lnTo>
                      <a:lnTo>
                        <a:pt x="1188" y="18"/>
                      </a:lnTo>
                      <a:lnTo>
                        <a:pt x="1188" y="18"/>
                      </a:lnTo>
                      <a:lnTo>
                        <a:pt x="1188" y="20"/>
                      </a:lnTo>
                      <a:lnTo>
                        <a:pt x="1188" y="18"/>
                      </a:lnTo>
                      <a:lnTo>
                        <a:pt x="1189" y="18"/>
                      </a:lnTo>
                      <a:lnTo>
                        <a:pt x="1189" y="15"/>
                      </a:lnTo>
                      <a:lnTo>
                        <a:pt x="1189" y="20"/>
                      </a:lnTo>
                      <a:lnTo>
                        <a:pt x="1189" y="17"/>
                      </a:lnTo>
                      <a:lnTo>
                        <a:pt x="1190" y="17"/>
                      </a:lnTo>
                      <a:lnTo>
                        <a:pt x="1190" y="17"/>
                      </a:lnTo>
                      <a:lnTo>
                        <a:pt x="1190" y="20"/>
                      </a:lnTo>
                      <a:lnTo>
                        <a:pt x="1190" y="17"/>
                      </a:lnTo>
                      <a:lnTo>
                        <a:pt x="1191" y="17"/>
                      </a:lnTo>
                      <a:lnTo>
                        <a:pt x="1191" y="17"/>
                      </a:lnTo>
                      <a:lnTo>
                        <a:pt x="1191" y="20"/>
                      </a:lnTo>
                      <a:lnTo>
                        <a:pt x="1191" y="19"/>
                      </a:lnTo>
                      <a:lnTo>
                        <a:pt x="1192" y="19"/>
                      </a:lnTo>
                      <a:lnTo>
                        <a:pt x="1192" y="14"/>
                      </a:lnTo>
                      <a:lnTo>
                        <a:pt x="1192" y="20"/>
                      </a:lnTo>
                      <a:lnTo>
                        <a:pt x="1192" y="20"/>
                      </a:lnTo>
                      <a:lnTo>
                        <a:pt x="1193" y="20"/>
                      </a:lnTo>
                      <a:lnTo>
                        <a:pt x="1193" y="19"/>
                      </a:lnTo>
                      <a:lnTo>
                        <a:pt x="1193" y="22"/>
                      </a:lnTo>
                      <a:lnTo>
                        <a:pt x="1193" y="20"/>
                      </a:lnTo>
                      <a:lnTo>
                        <a:pt x="1194" y="20"/>
                      </a:lnTo>
                      <a:lnTo>
                        <a:pt x="1194" y="17"/>
                      </a:lnTo>
                      <a:lnTo>
                        <a:pt x="1194" y="38"/>
                      </a:lnTo>
                      <a:lnTo>
                        <a:pt x="1194" y="19"/>
                      </a:lnTo>
                      <a:lnTo>
                        <a:pt x="1195" y="19"/>
                      </a:lnTo>
                      <a:lnTo>
                        <a:pt x="1195" y="17"/>
                      </a:lnTo>
                      <a:lnTo>
                        <a:pt x="1195" y="20"/>
                      </a:lnTo>
                      <a:lnTo>
                        <a:pt x="1195" y="17"/>
                      </a:lnTo>
                      <a:lnTo>
                        <a:pt x="1196" y="17"/>
                      </a:lnTo>
                      <a:lnTo>
                        <a:pt x="1196" y="17"/>
                      </a:lnTo>
                      <a:lnTo>
                        <a:pt x="1196" y="19"/>
                      </a:lnTo>
                      <a:lnTo>
                        <a:pt x="1196" y="17"/>
                      </a:lnTo>
                      <a:lnTo>
                        <a:pt x="1197" y="17"/>
                      </a:lnTo>
                      <a:lnTo>
                        <a:pt x="1197" y="16"/>
                      </a:lnTo>
                      <a:lnTo>
                        <a:pt x="1197" y="20"/>
                      </a:lnTo>
                      <a:lnTo>
                        <a:pt x="1197" y="16"/>
                      </a:lnTo>
                      <a:lnTo>
                        <a:pt x="1198" y="16"/>
                      </a:lnTo>
                      <a:lnTo>
                        <a:pt x="1198" y="16"/>
                      </a:lnTo>
                      <a:lnTo>
                        <a:pt x="1198" y="19"/>
                      </a:lnTo>
                      <a:lnTo>
                        <a:pt x="1198" y="17"/>
                      </a:lnTo>
                      <a:lnTo>
                        <a:pt x="1199" y="17"/>
                      </a:lnTo>
                      <a:lnTo>
                        <a:pt x="1199" y="15"/>
                      </a:lnTo>
                      <a:lnTo>
                        <a:pt x="1199" y="19"/>
                      </a:lnTo>
                      <a:lnTo>
                        <a:pt x="1199" y="16"/>
                      </a:lnTo>
                      <a:lnTo>
                        <a:pt x="1200" y="16"/>
                      </a:lnTo>
                      <a:lnTo>
                        <a:pt x="1200" y="14"/>
                      </a:lnTo>
                      <a:lnTo>
                        <a:pt x="1200" y="19"/>
                      </a:lnTo>
                      <a:lnTo>
                        <a:pt x="1200" y="16"/>
                      </a:lnTo>
                      <a:lnTo>
                        <a:pt x="1201" y="16"/>
                      </a:lnTo>
                      <a:lnTo>
                        <a:pt x="1201" y="14"/>
                      </a:lnTo>
                      <a:lnTo>
                        <a:pt x="1201" y="18"/>
                      </a:lnTo>
                      <a:lnTo>
                        <a:pt x="1201" y="15"/>
                      </a:lnTo>
                      <a:lnTo>
                        <a:pt x="1202" y="15"/>
                      </a:lnTo>
                      <a:lnTo>
                        <a:pt x="1202" y="15"/>
                      </a:lnTo>
                      <a:lnTo>
                        <a:pt x="1202" y="19"/>
                      </a:lnTo>
                      <a:lnTo>
                        <a:pt x="1202" y="19"/>
                      </a:lnTo>
                      <a:lnTo>
                        <a:pt x="1203" y="19"/>
                      </a:lnTo>
                      <a:lnTo>
                        <a:pt x="1203" y="17"/>
                      </a:lnTo>
                      <a:lnTo>
                        <a:pt x="1203" y="20"/>
                      </a:lnTo>
                      <a:lnTo>
                        <a:pt x="1203" y="17"/>
                      </a:lnTo>
                      <a:lnTo>
                        <a:pt x="1204" y="17"/>
                      </a:lnTo>
                      <a:lnTo>
                        <a:pt x="1204" y="16"/>
                      </a:lnTo>
                      <a:lnTo>
                        <a:pt x="1204" y="19"/>
                      </a:lnTo>
                      <a:lnTo>
                        <a:pt x="1204" y="19"/>
                      </a:lnTo>
                      <a:lnTo>
                        <a:pt x="1205" y="19"/>
                      </a:lnTo>
                      <a:lnTo>
                        <a:pt x="1205" y="16"/>
                      </a:lnTo>
                      <a:lnTo>
                        <a:pt x="1205" y="19"/>
                      </a:lnTo>
                      <a:lnTo>
                        <a:pt x="1205" y="17"/>
                      </a:lnTo>
                      <a:lnTo>
                        <a:pt x="1206" y="17"/>
                      </a:lnTo>
                      <a:lnTo>
                        <a:pt x="1206" y="16"/>
                      </a:lnTo>
                      <a:lnTo>
                        <a:pt x="1206" y="20"/>
                      </a:lnTo>
                      <a:lnTo>
                        <a:pt x="1206" y="16"/>
                      </a:lnTo>
                      <a:lnTo>
                        <a:pt x="1207" y="16"/>
                      </a:lnTo>
                      <a:lnTo>
                        <a:pt x="1207" y="16"/>
                      </a:lnTo>
                      <a:lnTo>
                        <a:pt x="1207" y="20"/>
                      </a:lnTo>
                      <a:lnTo>
                        <a:pt x="1207" y="19"/>
                      </a:lnTo>
                      <a:lnTo>
                        <a:pt x="1208" y="19"/>
                      </a:lnTo>
                      <a:lnTo>
                        <a:pt x="1208" y="17"/>
                      </a:lnTo>
                      <a:lnTo>
                        <a:pt x="1208" y="20"/>
                      </a:lnTo>
                      <a:lnTo>
                        <a:pt x="1208" y="18"/>
                      </a:lnTo>
                      <a:lnTo>
                        <a:pt x="1209" y="18"/>
                      </a:lnTo>
                      <a:lnTo>
                        <a:pt x="1209" y="14"/>
                      </a:lnTo>
                      <a:lnTo>
                        <a:pt x="1209" y="19"/>
                      </a:lnTo>
                      <a:lnTo>
                        <a:pt x="1209" y="16"/>
                      </a:lnTo>
                      <a:lnTo>
                        <a:pt x="1210" y="16"/>
                      </a:lnTo>
                      <a:lnTo>
                        <a:pt x="1210" y="14"/>
                      </a:lnTo>
                      <a:lnTo>
                        <a:pt x="1210" y="19"/>
                      </a:lnTo>
                      <a:lnTo>
                        <a:pt x="1210" y="19"/>
                      </a:lnTo>
                      <a:lnTo>
                        <a:pt x="1211" y="19"/>
                      </a:lnTo>
                      <a:lnTo>
                        <a:pt x="1211" y="18"/>
                      </a:lnTo>
                      <a:lnTo>
                        <a:pt x="1211" y="20"/>
                      </a:lnTo>
                      <a:lnTo>
                        <a:pt x="1211" y="19"/>
                      </a:lnTo>
                      <a:lnTo>
                        <a:pt x="1212" y="19"/>
                      </a:lnTo>
                      <a:lnTo>
                        <a:pt x="1212" y="17"/>
                      </a:lnTo>
                      <a:lnTo>
                        <a:pt x="1212" y="20"/>
                      </a:lnTo>
                      <a:lnTo>
                        <a:pt x="1212" y="18"/>
                      </a:lnTo>
                      <a:lnTo>
                        <a:pt x="1213" y="18"/>
                      </a:lnTo>
                      <a:lnTo>
                        <a:pt x="1213" y="17"/>
                      </a:lnTo>
                      <a:lnTo>
                        <a:pt x="1213" y="19"/>
                      </a:lnTo>
                      <a:lnTo>
                        <a:pt x="1213" y="18"/>
                      </a:lnTo>
                      <a:lnTo>
                        <a:pt x="1214" y="18"/>
                      </a:lnTo>
                      <a:lnTo>
                        <a:pt x="1214" y="16"/>
                      </a:lnTo>
                      <a:lnTo>
                        <a:pt x="1214" y="19"/>
                      </a:lnTo>
                      <a:lnTo>
                        <a:pt x="1214" y="16"/>
                      </a:lnTo>
                      <a:lnTo>
                        <a:pt x="1215" y="16"/>
                      </a:lnTo>
                      <a:lnTo>
                        <a:pt x="1215" y="16"/>
                      </a:lnTo>
                      <a:lnTo>
                        <a:pt x="1215" y="19"/>
                      </a:lnTo>
                      <a:lnTo>
                        <a:pt x="1215" y="17"/>
                      </a:lnTo>
                      <a:lnTo>
                        <a:pt x="1216" y="17"/>
                      </a:lnTo>
                      <a:lnTo>
                        <a:pt x="1216" y="17"/>
                      </a:lnTo>
                      <a:lnTo>
                        <a:pt x="1216" y="20"/>
                      </a:lnTo>
                      <a:lnTo>
                        <a:pt x="1216" y="20"/>
                      </a:lnTo>
                      <a:lnTo>
                        <a:pt x="1217" y="20"/>
                      </a:lnTo>
                      <a:lnTo>
                        <a:pt x="1217" y="15"/>
                      </a:lnTo>
                      <a:lnTo>
                        <a:pt x="1217" y="20"/>
                      </a:lnTo>
                      <a:lnTo>
                        <a:pt x="1217" y="17"/>
                      </a:lnTo>
                      <a:lnTo>
                        <a:pt x="1218" y="17"/>
                      </a:lnTo>
                      <a:lnTo>
                        <a:pt x="1218" y="14"/>
                      </a:lnTo>
                      <a:lnTo>
                        <a:pt x="1218" y="19"/>
                      </a:lnTo>
                      <a:lnTo>
                        <a:pt x="1218" y="17"/>
                      </a:lnTo>
                      <a:lnTo>
                        <a:pt x="1219" y="17"/>
                      </a:lnTo>
                      <a:lnTo>
                        <a:pt x="1219" y="16"/>
                      </a:lnTo>
                      <a:lnTo>
                        <a:pt x="1219" y="19"/>
                      </a:lnTo>
                      <a:lnTo>
                        <a:pt x="1219" y="18"/>
                      </a:lnTo>
                      <a:lnTo>
                        <a:pt x="1220" y="18"/>
                      </a:lnTo>
                      <a:lnTo>
                        <a:pt x="1220" y="17"/>
                      </a:lnTo>
                      <a:lnTo>
                        <a:pt x="1220" y="20"/>
                      </a:lnTo>
                      <a:lnTo>
                        <a:pt x="1220" y="19"/>
                      </a:lnTo>
                      <a:lnTo>
                        <a:pt x="1221" y="19"/>
                      </a:lnTo>
                      <a:lnTo>
                        <a:pt x="1221" y="17"/>
                      </a:lnTo>
                      <a:lnTo>
                        <a:pt x="1221" y="19"/>
                      </a:lnTo>
                      <a:lnTo>
                        <a:pt x="1221" y="18"/>
                      </a:lnTo>
                      <a:lnTo>
                        <a:pt x="1222" y="18"/>
                      </a:lnTo>
                      <a:lnTo>
                        <a:pt x="1222" y="17"/>
                      </a:lnTo>
                      <a:lnTo>
                        <a:pt x="1222" y="20"/>
                      </a:lnTo>
                      <a:lnTo>
                        <a:pt x="1222" y="19"/>
                      </a:lnTo>
                      <a:lnTo>
                        <a:pt x="1223" y="19"/>
                      </a:lnTo>
                      <a:lnTo>
                        <a:pt x="1223" y="16"/>
                      </a:lnTo>
                      <a:lnTo>
                        <a:pt x="1223" y="20"/>
                      </a:lnTo>
                      <a:lnTo>
                        <a:pt x="1223" y="17"/>
                      </a:lnTo>
                      <a:lnTo>
                        <a:pt x="1224" y="17"/>
                      </a:lnTo>
                      <a:lnTo>
                        <a:pt x="1224" y="17"/>
                      </a:lnTo>
                      <a:lnTo>
                        <a:pt x="1224" y="20"/>
                      </a:lnTo>
                      <a:lnTo>
                        <a:pt x="1224" y="19"/>
                      </a:lnTo>
                      <a:lnTo>
                        <a:pt x="1225" y="19"/>
                      </a:lnTo>
                      <a:lnTo>
                        <a:pt x="1225" y="17"/>
                      </a:lnTo>
                      <a:lnTo>
                        <a:pt x="1225" y="20"/>
                      </a:lnTo>
                      <a:lnTo>
                        <a:pt x="1225" y="19"/>
                      </a:lnTo>
                      <a:lnTo>
                        <a:pt x="1226" y="19"/>
                      </a:lnTo>
                      <a:lnTo>
                        <a:pt x="1226" y="17"/>
                      </a:lnTo>
                      <a:lnTo>
                        <a:pt x="1226" y="20"/>
                      </a:lnTo>
                      <a:lnTo>
                        <a:pt x="1226" y="18"/>
                      </a:lnTo>
                      <a:lnTo>
                        <a:pt x="1227" y="18"/>
                      </a:lnTo>
                      <a:lnTo>
                        <a:pt x="1227" y="15"/>
                      </a:lnTo>
                      <a:lnTo>
                        <a:pt x="1227" y="19"/>
                      </a:lnTo>
                      <a:lnTo>
                        <a:pt x="1227" y="15"/>
                      </a:lnTo>
                      <a:lnTo>
                        <a:pt x="1228" y="15"/>
                      </a:lnTo>
                      <a:lnTo>
                        <a:pt x="1228" y="14"/>
                      </a:lnTo>
                      <a:lnTo>
                        <a:pt x="1228" y="19"/>
                      </a:lnTo>
                      <a:lnTo>
                        <a:pt x="1228" y="18"/>
                      </a:lnTo>
                      <a:lnTo>
                        <a:pt x="1229" y="18"/>
                      </a:lnTo>
                      <a:lnTo>
                        <a:pt x="1229" y="17"/>
                      </a:lnTo>
                      <a:lnTo>
                        <a:pt x="1229" y="19"/>
                      </a:lnTo>
                      <a:lnTo>
                        <a:pt x="1229" y="19"/>
                      </a:lnTo>
                      <a:lnTo>
                        <a:pt x="1230" y="19"/>
                      </a:lnTo>
                      <a:lnTo>
                        <a:pt x="1230" y="17"/>
                      </a:lnTo>
                      <a:lnTo>
                        <a:pt x="1230" y="19"/>
                      </a:lnTo>
                      <a:lnTo>
                        <a:pt x="1230" y="17"/>
                      </a:lnTo>
                      <a:lnTo>
                        <a:pt x="1231" y="17"/>
                      </a:lnTo>
                      <a:lnTo>
                        <a:pt x="1231" y="17"/>
                      </a:lnTo>
                      <a:lnTo>
                        <a:pt x="1231" y="19"/>
                      </a:lnTo>
                      <a:lnTo>
                        <a:pt x="1231" y="19"/>
                      </a:lnTo>
                      <a:lnTo>
                        <a:pt x="1232" y="19"/>
                      </a:lnTo>
                      <a:lnTo>
                        <a:pt x="1232" y="17"/>
                      </a:lnTo>
                      <a:lnTo>
                        <a:pt x="1232" y="19"/>
                      </a:lnTo>
                      <a:lnTo>
                        <a:pt x="1232" y="17"/>
                      </a:lnTo>
                      <a:lnTo>
                        <a:pt x="1233" y="17"/>
                      </a:lnTo>
                      <a:lnTo>
                        <a:pt x="1233" y="17"/>
                      </a:lnTo>
                      <a:lnTo>
                        <a:pt x="1233" y="19"/>
                      </a:lnTo>
                      <a:lnTo>
                        <a:pt x="1233" y="19"/>
                      </a:lnTo>
                      <a:lnTo>
                        <a:pt x="1234" y="19"/>
                      </a:lnTo>
                      <a:lnTo>
                        <a:pt x="1234" y="17"/>
                      </a:lnTo>
                      <a:lnTo>
                        <a:pt x="1234" y="20"/>
                      </a:lnTo>
                      <a:lnTo>
                        <a:pt x="1234" y="18"/>
                      </a:lnTo>
                      <a:lnTo>
                        <a:pt x="1235" y="18"/>
                      </a:lnTo>
                      <a:lnTo>
                        <a:pt x="1235" y="16"/>
                      </a:lnTo>
                      <a:lnTo>
                        <a:pt x="1235" y="19"/>
                      </a:lnTo>
                      <a:lnTo>
                        <a:pt x="1235" y="17"/>
                      </a:lnTo>
                      <a:lnTo>
                        <a:pt x="1236" y="17"/>
                      </a:lnTo>
                      <a:lnTo>
                        <a:pt x="1236" y="14"/>
                      </a:lnTo>
                      <a:lnTo>
                        <a:pt x="1236" y="19"/>
                      </a:lnTo>
                      <a:lnTo>
                        <a:pt x="1236" y="15"/>
                      </a:lnTo>
                      <a:lnTo>
                        <a:pt x="1237" y="15"/>
                      </a:lnTo>
                      <a:lnTo>
                        <a:pt x="1237" y="14"/>
                      </a:lnTo>
                      <a:lnTo>
                        <a:pt x="1237" y="18"/>
                      </a:lnTo>
                      <a:lnTo>
                        <a:pt x="1237" y="16"/>
                      </a:lnTo>
                      <a:lnTo>
                        <a:pt x="1238" y="16"/>
                      </a:lnTo>
                      <a:lnTo>
                        <a:pt x="1238" y="16"/>
                      </a:lnTo>
                      <a:lnTo>
                        <a:pt x="1238" y="19"/>
                      </a:lnTo>
                      <a:lnTo>
                        <a:pt x="1238" y="17"/>
                      </a:lnTo>
                      <a:lnTo>
                        <a:pt x="1239" y="17"/>
                      </a:lnTo>
                      <a:lnTo>
                        <a:pt x="1239" y="16"/>
                      </a:lnTo>
                      <a:lnTo>
                        <a:pt x="1239" y="19"/>
                      </a:lnTo>
                      <a:lnTo>
                        <a:pt x="1239" y="18"/>
                      </a:lnTo>
                      <a:lnTo>
                        <a:pt x="1240" y="18"/>
                      </a:lnTo>
                      <a:lnTo>
                        <a:pt x="1240" y="16"/>
                      </a:lnTo>
                      <a:lnTo>
                        <a:pt x="1240" y="19"/>
                      </a:lnTo>
                      <a:lnTo>
                        <a:pt x="1240" y="19"/>
                      </a:lnTo>
                      <a:lnTo>
                        <a:pt x="1241" y="19"/>
                      </a:lnTo>
                      <a:lnTo>
                        <a:pt x="1241" y="16"/>
                      </a:lnTo>
                      <a:lnTo>
                        <a:pt x="1241" y="19"/>
                      </a:lnTo>
                      <a:lnTo>
                        <a:pt x="1241" y="17"/>
                      </a:lnTo>
                      <a:lnTo>
                        <a:pt x="1242" y="17"/>
                      </a:lnTo>
                      <a:lnTo>
                        <a:pt x="1242" y="16"/>
                      </a:lnTo>
                      <a:lnTo>
                        <a:pt x="1242" y="19"/>
                      </a:lnTo>
                      <a:lnTo>
                        <a:pt x="1242" y="17"/>
                      </a:lnTo>
                      <a:lnTo>
                        <a:pt x="1243" y="17"/>
                      </a:lnTo>
                      <a:lnTo>
                        <a:pt x="1243" y="17"/>
                      </a:lnTo>
                      <a:lnTo>
                        <a:pt x="1243" y="20"/>
                      </a:lnTo>
                      <a:lnTo>
                        <a:pt x="1243" y="19"/>
                      </a:lnTo>
                      <a:lnTo>
                        <a:pt x="1244" y="19"/>
                      </a:lnTo>
                      <a:lnTo>
                        <a:pt x="1244" y="15"/>
                      </a:lnTo>
                      <a:lnTo>
                        <a:pt x="1244" y="19"/>
                      </a:lnTo>
                      <a:lnTo>
                        <a:pt x="1244" y="16"/>
                      </a:lnTo>
                      <a:lnTo>
                        <a:pt x="1245" y="16"/>
                      </a:lnTo>
                      <a:lnTo>
                        <a:pt x="1245" y="14"/>
                      </a:lnTo>
                      <a:lnTo>
                        <a:pt x="1245" y="18"/>
                      </a:lnTo>
                      <a:lnTo>
                        <a:pt x="1245" y="16"/>
                      </a:lnTo>
                      <a:lnTo>
                        <a:pt x="1246" y="16"/>
                      </a:lnTo>
                      <a:lnTo>
                        <a:pt x="1246" y="15"/>
                      </a:lnTo>
                      <a:lnTo>
                        <a:pt x="1246" y="18"/>
                      </a:lnTo>
                      <a:lnTo>
                        <a:pt x="1246" y="17"/>
                      </a:lnTo>
                      <a:lnTo>
                        <a:pt x="1247" y="17"/>
                      </a:lnTo>
                      <a:lnTo>
                        <a:pt x="1247" y="16"/>
                      </a:lnTo>
                      <a:lnTo>
                        <a:pt x="1247" y="19"/>
                      </a:lnTo>
                      <a:lnTo>
                        <a:pt x="1247" y="17"/>
                      </a:lnTo>
                      <a:lnTo>
                        <a:pt x="1248" y="17"/>
                      </a:lnTo>
                      <a:lnTo>
                        <a:pt x="1248" y="14"/>
                      </a:lnTo>
                      <a:lnTo>
                        <a:pt x="1248" y="18"/>
                      </a:lnTo>
                      <a:lnTo>
                        <a:pt x="1248" y="16"/>
                      </a:lnTo>
                      <a:lnTo>
                        <a:pt x="1249" y="16"/>
                      </a:lnTo>
                      <a:lnTo>
                        <a:pt x="1249" y="14"/>
                      </a:lnTo>
                      <a:lnTo>
                        <a:pt x="1249" y="18"/>
                      </a:lnTo>
                      <a:lnTo>
                        <a:pt x="1249" y="16"/>
                      </a:lnTo>
                      <a:lnTo>
                        <a:pt x="1250" y="16"/>
                      </a:lnTo>
                      <a:lnTo>
                        <a:pt x="1250" y="14"/>
                      </a:lnTo>
                      <a:lnTo>
                        <a:pt x="1250" y="19"/>
                      </a:lnTo>
                      <a:lnTo>
                        <a:pt x="1250" y="16"/>
                      </a:lnTo>
                      <a:lnTo>
                        <a:pt x="1251" y="16"/>
                      </a:lnTo>
                      <a:lnTo>
                        <a:pt x="1251" y="14"/>
                      </a:lnTo>
                      <a:lnTo>
                        <a:pt x="1251" y="18"/>
                      </a:lnTo>
                      <a:lnTo>
                        <a:pt x="1251" y="18"/>
                      </a:lnTo>
                      <a:lnTo>
                        <a:pt x="1252" y="18"/>
                      </a:lnTo>
                      <a:lnTo>
                        <a:pt x="1252" y="14"/>
                      </a:lnTo>
                      <a:lnTo>
                        <a:pt x="1252" y="19"/>
                      </a:lnTo>
                      <a:lnTo>
                        <a:pt x="1252" y="14"/>
                      </a:lnTo>
                      <a:lnTo>
                        <a:pt x="1253" y="14"/>
                      </a:lnTo>
                      <a:lnTo>
                        <a:pt x="1253" y="14"/>
                      </a:lnTo>
                      <a:lnTo>
                        <a:pt x="1253" y="17"/>
                      </a:lnTo>
                      <a:lnTo>
                        <a:pt x="1253" y="16"/>
                      </a:lnTo>
                      <a:lnTo>
                        <a:pt x="1254" y="16"/>
                      </a:lnTo>
                      <a:lnTo>
                        <a:pt x="1254" y="14"/>
                      </a:lnTo>
                      <a:lnTo>
                        <a:pt x="1254" y="17"/>
                      </a:lnTo>
                      <a:lnTo>
                        <a:pt x="1254" y="15"/>
                      </a:lnTo>
                      <a:lnTo>
                        <a:pt x="1255" y="15"/>
                      </a:lnTo>
                      <a:lnTo>
                        <a:pt x="1255" y="15"/>
                      </a:lnTo>
                      <a:lnTo>
                        <a:pt x="1255" y="19"/>
                      </a:lnTo>
                      <a:lnTo>
                        <a:pt x="1255" y="16"/>
                      </a:lnTo>
                      <a:lnTo>
                        <a:pt x="1256" y="16"/>
                      </a:lnTo>
                      <a:lnTo>
                        <a:pt x="1256" y="17"/>
                      </a:lnTo>
                      <a:lnTo>
                        <a:pt x="1256" y="19"/>
                      </a:lnTo>
                      <a:lnTo>
                        <a:pt x="1256" y="17"/>
                      </a:lnTo>
                      <a:lnTo>
                        <a:pt x="1257" y="17"/>
                      </a:lnTo>
                      <a:lnTo>
                        <a:pt x="1257" y="16"/>
                      </a:lnTo>
                      <a:lnTo>
                        <a:pt x="1257" y="19"/>
                      </a:lnTo>
                      <a:lnTo>
                        <a:pt x="1257" y="19"/>
                      </a:lnTo>
                      <a:lnTo>
                        <a:pt x="1258" y="19"/>
                      </a:lnTo>
                      <a:lnTo>
                        <a:pt x="1258" y="17"/>
                      </a:lnTo>
                      <a:lnTo>
                        <a:pt x="1258" y="19"/>
                      </a:lnTo>
                      <a:lnTo>
                        <a:pt x="1258" y="19"/>
                      </a:lnTo>
                      <a:lnTo>
                        <a:pt x="1259" y="19"/>
                      </a:lnTo>
                      <a:lnTo>
                        <a:pt x="1259" y="16"/>
                      </a:lnTo>
                      <a:lnTo>
                        <a:pt x="1259" y="19"/>
                      </a:lnTo>
                      <a:lnTo>
                        <a:pt x="1259" y="16"/>
                      </a:lnTo>
                      <a:lnTo>
                        <a:pt x="1260" y="16"/>
                      </a:lnTo>
                      <a:lnTo>
                        <a:pt x="1260" y="14"/>
                      </a:lnTo>
                      <a:lnTo>
                        <a:pt x="1260" y="19"/>
                      </a:lnTo>
                      <a:lnTo>
                        <a:pt x="1260" y="17"/>
                      </a:lnTo>
                      <a:lnTo>
                        <a:pt x="1261" y="17"/>
                      </a:lnTo>
                      <a:lnTo>
                        <a:pt x="1261" y="15"/>
                      </a:lnTo>
                      <a:lnTo>
                        <a:pt x="1261" y="19"/>
                      </a:lnTo>
                      <a:lnTo>
                        <a:pt x="1261" y="15"/>
                      </a:lnTo>
                      <a:lnTo>
                        <a:pt x="1262" y="15"/>
                      </a:lnTo>
                      <a:lnTo>
                        <a:pt x="1262" y="15"/>
                      </a:lnTo>
                      <a:lnTo>
                        <a:pt x="1262" y="19"/>
                      </a:lnTo>
                      <a:lnTo>
                        <a:pt x="1262" y="16"/>
                      </a:lnTo>
                      <a:lnTo>
                        <a:pt x="1263" y="16"/>
                      </a:lnTo>
                      <a:lnTo>
                        <a:pt x="1263" y="13"/>
                      </a:lnTo>
                      <a:lnTo>
                        <a:pt x="1263" y="19"/>
                      </a:lnTo>
                      <a:lnTo>
                        <a:pt x="1263" y="14"/>
                      </a:lnTo>
                      <a:lnTo>
                        <a:pt x="1264" y="14"/>
                      </a:lnTo>
                      <a:lnTo>
                        <a:pt x="1264" y="14"/>
                      </a:lnTo>
                      <a:lnTo>
                        <a:pt x="1264" y="19"/>
                      </a:lnTo>
                      <a:lnTo>
                        <a:pt x="1264" y="19"/>
                      </a:lnTo>
                      <a:lnTo>
                        <a:pt x="1265" y="19"/>
                      </a:lnTo>
                      <a:lnTo>
                        <a:pt x="1265" y="16"/>
                      </a:lnTo>
                      <a:lnTo>
                        <a:pt x="1265" y="20"/>
                      </a:lnTo>
                      <a:lnTo>
                        <a:pt x="1265" y="18"/>
                      </a:lnTo>
                      <a:lnTo>
                        <a:pt x="1266" y="18"/>
                      </a:lnTo>
                      <a:lnTo>
                        <a:pt x="1266" y="14"/>
                      </a:lnTo>
                      <a:lnTo>
                        <a:pt x="1266" y="19"/>
                      </a:lnTo>
                      <a:lnTo>
                        <a:pt x="1266" y="17"/>
                      </a:lnTo>
                      <a:lnTo>
                        <a:pt x="1267" y="17"/>
                      </a:lnTo>
                      <a:lnTo>
                        <a:pt x="1267" y="15"/>
                      </a:lnTo>
                      <a:lnTo>
                        <a:pt x="1267" y="19"/>
                      </a:lnTo>
                      <a:lnTo>
                        <a:pt x="1267" y="17"/>
                      </a:lnTo>
                      <a:lnTo>
                        <a:pt x="1268" y="17"/>
                      </a:lnTo>
                      <a:lnTo>
                        <a:pt x="1268" y="14"/>
                      </a:lnTo>
                      <a:lnTo>
                        <a:pt x="1268" y="17"/>
                      </a:lnTo>
                      <a:lnTo>
                        <a:pt x="1268" y="15"/>
                      </a:lnTo>
                      <a:lnTo>
                        <a:pt x="1269" y="15"/>
                      </a:lnTo>
                      <a:lnTo>
                        <a:pt x="1269" y="15"/>
                      </a:lnTo>
                      <a:lnTo>
                        <a:pt x="1269" y="17"/>
                      </a:lnTo>
                      <a:lnTo>
                        <a:pt x="1269" y="16"/>
                      </a:lnTo>
                      <a:lnTo>
                        <a:pt x="1270" y="16"/>
                      </a:lnTo>
                      <a:lnTo>
                        <a:pt x="1270" y="14"/>
                      </a:lnTo>
                      <a:lnTo>
                        <a:pt x="1270" y="17"/>
                      </a:lnTo>
                      <a:lnTo>
                        <a:pt x="1270" y="14"/>
                      </a:lnTo>
                      <a:lnTo>
                        <a:pt x="1271" y="14"/>
                      </a:lnTo>
                      <a:lnTo>
                        <a:pt x="1271" y="14"/>
                      </a:lnTo>
                      <a:lnTo>
                        <a:pt x="1271" y="17"/>
                      </a:lnTo>
                      <a:lnTo>
                        <a:pt x="1271" y="16"/>
                      </a:lnTo>
                      <a:lnTo>
                        <a:pt x="1272" y="16"/>
                      </a:lnTo>
                      <a:lnTo>
                        <a:pt x="1272" y="12"/>
                      </a:lnTo>
                      <a:lnTo>
                        <a:pt x="1272" y="18"/>
                      </a:lnTo>
                      <a:lnTo>
                        <a:pt x="1272" y="14"/>
                      </a:lnTo>
                      <a:lnTo>
                        <a:pt x="1273" y="14"/>
                      </a:lnTo>
                      <a:lnTo>
                        <a:pt x="1273" y="13"/>
                      </a:lnTo>
                      <a:lnTo>
                        <a:pt x="1273" y="16"/>
                      </a:lnTo>
                      <a:lnTo>
                        <a:pt x="1273" y="15"/>
                      </a:lnTo>
                      <a:lnTo>
                        <a:pt x="1274" y="15"/>
                      </a:lnTo>
                      <a:lnTo>
                        <a:pt x="1274" y="14"/>
                      </a:lnTo>
                      <a:lnTo>
                        <a:pt x="1274" y="17"/>
                      </a:lnTo>
                      <a:lnTo>
                        <a:pt x="1274" y="17"/>
                      </a:lnTo>
                      <a:lnTo>
                        <a:pt x="1275" y="17"/>
                      </a:lnTo>
                      <a:lnTo>
                        <a:pt x="1275" y="15"/>
                      </a:lnTo>
                      <a:lnTo>
                        <a:pt x="1275" y="17"/>
                      </a:lnTo>
                      <a:lnTo>
                        <a:pt x="1275" y="16"/>
                      </a:lnTo>
                      <a:lnTo>
                        <a:pt x="1276" y="16"/>
                      </a:lnTo>
                      <a:lnTo>
                        <a:pt x="1276" y="16"/>
                      </a:lnTo>
                      <a:lnTo>
                        <a:pt x="1276" y="19"/>
                      </a:lnTo>
                      <a:lnTo>
                        <a:pt x="1276" y="16"/>
                      </a:lnTo>
                      <a:lnTo>
                        <a:pt x="1277" y="16"/>
                      </a:lnTo>
                      <a:lnTo>
                        <a:pt x="1277" y="13"/>
                      </a:lnTo>
                      <a:lnTo>
                        <a:pt x="1277" y="17"/>
                      </a:lnTo>
                      <a:lnTo>
                        <a:pt x="1277" y="13"/>
                      </a:lnTo>
                      <a:lnTo>
                        <a:pt x="1278" y="13"/>
                      </a:lnTo>
                      <a:lnTo>
                        <a:pt x="1278" y="14"/>
                      </a:lnTo>
                      <a:lnTo>
                        <a:pt x="1278" y="19"/>
                      </a:lnTo>
                      <a:lnTo>
                        <a:pt x="1278" y="16"/>
                      </a:lnTo>
                      <a:lnTo>
                        <a:pt x="1279" y="16"/>
                      </a:lnTo>
                      <a:lnTo>
                        <a:pt x="1279" y="15"/>
                      </a:lnTo>
                      <a:lnTo>
                        <a:pt x="1279" y="19"/>
                      </a:lnTo>
                      <a:lnTo>
                        <a:pt x="1279" y="16"/>
                      </a:lnTo>
                      <a:lnTo>
                        <a:pt x="1280" y="16"/>
                      </a:lnTo>
                      <a:lnTo>
                        <a:pt x="1280" y="14"/>
                      </a:lnTo>
                      <a:lnTo>
                        <a:pt x="1280" y="17"/>
                      </a:lnTo>
                      <a:lnTo>
                        <a:pt x="1280" y="16"/>
                      </a:lnTo>
                      <a:lnTo>
                        <a:pt x="1281" y="16"/>
                      </a:lnTo>
                      <a:lnTo>
                        <a:pt x="1281" y="13"/>
                      </a:lnTo>
                      <a:lnTo>
                        <a:pt x="1281" y="17"/>
                      </a:lnTo>
                      <a:lnTo>
                        <a:pt x="1281" y="15"/>
                      </a:lnTo>
                      <a:lnTo>
                        <a:pt x="1282" y="15"/>
                      </a:lnTo>
                      <a:lnTo>
                        <a:pt x="1282" y="12"/>
                      </a:lnTo>
                      <a:lnTo>
                        <a:pt x="1282" y="16"/>
                      </a:lnTo>
                      <a:lnTo>
                        <a:pt x="1282" y="14"/>
                      </a:lnTo>
                      <a:lnTo>
                        <a:pt x="1283" y="14"/>
                      </a:lnTo>
                      <a:lnTo>
                        <a:pt x="1283" y="13"/>
                      </a:lnTo>
                      <a:lnTo>
                        <a:pt x="1283" y="16"/>
                      </a:lnTo>
                      <a:lnTo>
                        <a:pt x="1283" y="14"/>
                      </a:lnTo>
                      <a:lnTo>
                        <a:pt x="1284" y="14"/>
                      </a:lnTo>
                      <a:lnTo>
                        <a:pt x="1284" y="12"/>
                      </a:lnTo>
                      <a:lnTo>
                        <a:pt x="1284" y="17"/>
                      </a:lnTo>
                      <a:lnTo>
                        <a:pt x="1284" y="12"/>
                      </a:lnTo>
                      <a:lnTo>
                        <a:pt x="1285" y="12"/>
                      </a:lnTo>
                      <a:lnTo>
                        <a:pt x="1285" y="10"/>
                      </a:lnTo>
                      <a:lnTo>
                        <a:pt x="1285" y="16"/>
                      </a:lnTo>
                      <a:lnTo>
                        <a:pt x="1285" y="15"/>
                      </a:lnTo>
                      <a:lnTo>
                        <a:pt x="1286" y="15"/>
                      </a:lnTo>
                      <a:lnTo>
                        <a:pt x="1286" y="13"/>
                      </a:lnTo>
                      <a:lnTo>
                        <a:pt x="1286" y="16"/>
                      </a:lnTo>
                      <a:lnTo>
                        <a:pt x="1286" y="13"/>
                      </a:lnTo>
                      <a:lnTo>
                        <a:pt x="1287" y="13"/>
                      </a:lnTo>
                      <a:lnTo>
                        <a:pt x="1287" y="13"/>
                      </a:lnTo>
                      <a:lnTo>
                        <a:pt x="1287" y="17"/>
                      </a:lnTo>
                      <a:lnTo>
                        <a:pt x="1287" y="16"/>
                      </a:lnTo>
                      <a:lnTo>
                        <a:pt x="1288" y="16"/>
                      </a:lnTo>
                      <a:lnTo>
                        <a:pt x="1288" y="13"/>
                      </a:lnTo>
                      <a:lnTo>
                        <a:pt x="1288" y="20"/>
                      </a:lnTo>
                      <a:lnTo>
                        <a:pt x="1288" y="13"/>
                      </a:lnTo>
                      <a:lnTo>
                        <a:pt x="1289" y="13"/>
                      </a:lnTo>
                      <a:lnTo>
                        <a:pt x="1289" y="13"/>
                      </a:lnTo>
                      <a:lnTo>
                        <a:pt x="1289" y="16"/>
                      </a:lnTo>
                      <a:lnTo>
                        <a:pt x="1289" y="15"/>
                      </a:lnTo>
                      <a:lnTo>
                        <a:pt x="1290" y="15"/>
                      </a:lnTo>
                      <a:lnTo>
                        <a:pt x="1290" y="13"/>
                      </a:lnTo>
                      <a:lnTo>
                        <a:pt x="1290" y="16"/>
                      </a:lnTo>
                      <a:lnTo>
                        <a:pt x="1290" y="14"/>
                      </a:lnTo>
                      <a:lnTo>
                        <a:pt x="1291" y="14"/>
                      </a:lnTo>
                      <a:lnTo>
                        <a:pt x="1291" y="12"/>
                      </a:lnTo>
                      <a:lnTo>
                        <a:pt x="1291" y="16"/>
                      </a:lnTo>
                      <a:lnTo>
                        <a:pt x="1291" y="14"/>
                      </a:lnTo>
                      <a:lnTo>
                        <a:pt x="1292" y="14"/>
                      </a:lnTo>
                      <a:lnTo>
                        <a:pt x="1292" y="12"/>
                      </a:lnTo>
                      <a:lnTo>
                        <a:pt x="1292" y="14"/>
                      </a:lnTo>
                      <a:lnTo>
                        <a:pt x="1292" y="14"/>
                      </a:lnTo>
                      <a:lnTo>
                        <a:pt x="1293" y="14"/>
                      </a:lnTo>
                      <a:lnTo>
                        <a:pt x="1293" y="12"/>
                      </a:lnTo>
                      <a:lnTo>
                        <a:pt x="1293" y="15"/>
                      </a:lnTo>
                      <a:lnTo>
                        <a:pt x="1293" y="13"/>
                      </a:lnTo>
                      <a:lnTo>
                        <a:pt x="1294" y="13"/>
                      </a:lnTo>
                      <a:lnTo>
                        <a:pt x="1294" y="13"/>
                      </a:lnTo>
                      <a:lnTo>
                        <a:pt x="1294" y="16"/>
                      </a:lnTo>
                      <a:lnTo>
                        <a:pt x="1294" y="14"/>
                      </a:lnTo>
                      <a:lnTo>
                        <a:pt x="1295" y="14"/>
                      </a:lnTo>
                      <a:lnTo>
                        <a:pt x="1295" y="13"/>
                      </a:lnTo>
                      <a:lnTo>
                        <a:pt x="1295" y="15"/>
                      </a:lnTo>
                      <a:lnTo>
                        <a:pt x="1295" y="13"/>
                      </a:lnTo>
                      <a:lnTo>
                        <a:pt x="1296" y="13"/>
                      </a:lnTo>
                      <a:lnTo>
                        <a:pt x="1296" y="11"/>
                      </a:lnTo>
                      <a:lnTo>
                        <a:pt x="1296" y="15"/>
                      </a:lnTo>
                      <a:lnTo>
                        <a:pt x="1296" y="14"/>
                      </a:lnTo>
                      <a:lnTo>
                        <a:pt x="1297" y="14"/>
                      </a:lnTo>
                      <a:lnTo>
                        <a:pt x="1297" y="13"/>
                      </a:lnTo>
                      <a:lnTo>
                        <a:pt x="1297" y="16"/>
                      </a:lnTo>
                      <a:lnTo>
                        <a:pt x="1297" y="14"/>
                      </a:lnTo>
                      <a:lnTo>
                        <a:pt x="1298" y="14"/>
                      </a:lnTo>
                      <a:lnTo>
                        <a:pt x="1298" y="12"/>
                      </a:lnTo>
                      <a:lnTo>
                        <a:pt x="1298" y="14"/>
                      </a:lnTo>
                      <a:lnTo>
                        <a:pt x="1298" y="14"/>
                      </a:lnTo>
                      <a:lnTo>
                        <a:pt x="1299" y="14"/>
                      </a:lnTo>
                      <a:lnTo>
                        <a:pt x="1299" y="11"/>
                      </a:lnTo>
                      <a:lnTo>
                        <a:pt x="1299" y="13"/>
                      </a:lnTo>
                      <a:lnTo>
                        <a:pt x="1299" y="12"/>
                      </a:lnTo>
                      <a:lnTo>
                        <a:pt x="1300" y="12"/>
                      </a:lnTo>
                      <a:lnTo>
                        <a:pt x="1300" y="12"/>
                      </a:lnTo>
                      <a:lnTo>
                        <a:pt x="1300" y="15"/>
                      </a:lnTo>
                      <a:lnTo>
                        <a:pt x="1300" y="15"/>
                      </a:lnTo>
                      <a:lnTo>
                        <a:pt x="1301" y="15"/>
                      </a:lnTo>
                      <a:lnTo>
                        <a:pt x="1301" y="12"/>
                      </a:lnTo>
                      <a:lnTo>
                        <a:pt x="1301" y="15"/>
                      </a:lnTo>
                      <a:lnTo>
                        <a:pt x="1301" y="13"/>
                      </a:lnTo>
                      <a:lnTo>
                        <a:pt x="1302" y="13"/>
                      </a:lnTo>
                      <a:lnTo>
                        <a:pt x="1302" y="12"/>
                      </a:lnTo>
                      <a:lnTo>
                        <a:pt x="1302" y="17"/>
                      </a:lnTo>
                      <a:lnTo>
                        <a:pt x="1302" y="13"/>
                      </a:lnTo>
                      <a:lnTo>
                        <a:pt x="1303" y="13"/>
                      </a:lnTo>
                      <a:lnTo>
                        <a:pt x="1303" y="9"/>
                      </a:lnTo>
                      <a:lnTo>
                        <a:pt x="1303" y="16"/>
                      </a:lnTo>
                      <a:lnTo>
                        <a:pt x="1303" y="14"/>
                      </a:lnTo>
                      <a:lnTo>
                        <a:pt x="1304" y="14"/>
                      </a:lnTo>
                      <a:lnTo>
                        <a:pt x="1304" y="10"/>
                      </a:lnTo>
                      <a:lnTo>
                        <a:pt x="1304" y="15"/>
                      </a:lnTo>
                      <a:lnTo>
                        <a:pt x="1304" y="11"/>
                      </a:lnTo>
                      <a:lnTo>
                        <a:pt x="1305" y="11"/>
                      </a:lnTo>
                      <a:lnTo>
                        <a:pt x="1305" y="11"/>
                      </a:lnTo>
                      <a:lnTo>
                        <a:pt x="1305" y="16"/>
                      </a:lnTo>
                      <a:lnTo>
                        <a:pt x="1305" y="13"/>
                      </a:lnTo>
                      <a:lnTo>
                        <a:pt x="1306" y="13"/>
                      </a:lnTo>
                      <a:lnTo>
                        <a:pt x="1306" y="12"/>
                      </a:lnTo>
                      <a:lnTo>
                        <a:pt x="1306" y="16"/>
                      </a:lnTo>
                      <a:lnTo>
                        <a:pt x="1306" y="14"/>
                      </a:lnTo>
                      <a:lnTo>
                        <a:pt x="1307" y="14"/>
                      </a:lnTo>
                      <a:lnTo>
                        <a:pt x="1307" y="12"/>
                      </a:lnTo>
                      <a:lnTo>
                        <a:pt x="1307" y="17"/>
                      </a:lnTo>
                      <a:lnTo>
                        <a:pt x="1307" y="13"/>
                      </a:lnTo>
                      <a:lnTo>
                        <a:pt x="1308" y="13"/>
                      </a:lnTo>
                      <a:lnTo>
                        <a:pt x="1308" y="9"/>
                      </a:lnTo>
                      <a:lnTo>
                        <a:pt x="1308" y="13"/>
                      </a:lnTo>
                      <a:lnTo>
                        <a:pt x="1308" y="12"/>
                      </a:lnTo>
                      <a:lnTo>
                        <a:pt x="1309" y="12"/>
                      </a:lnTo>
                      <a:lnTo>
                        <a:pt x="1309" y="10"/>
                      </a:lnTo>
                      <a:lnTo>
                        <a:pt x="1309" y="14"/>
                      </a:lnTo>
                      <a:lnTo>
                        <a:pt x="1309" y="13"/>
                      </a:lnTo>
                      <a:lnTo>
                        <a:pt x="1310" y="13"/>
                      </a:lnTo>
                      <a:lnTo>
                        <a:pt x="1310" y="10"/>
                      </a:lnTo>
                      <a:lnTo>
                        <a:pt x="1310" y="14"/>
                      </a:lnTo>
                      <a:lnTo>
                        <a:pt x="1310" y="10"/>
                      </a:lnTo>
                      <a:lnTo>
                        <a:pt x="1311" y="10"/>
                      </a:lnTo>
                      <a:lnTo>
                        <a:pt x="1311" y="10"/>
                      </a:lnTo>
                      <a:lnTo>
                        <a:pt x="1311" y="15"/>
                      </a:lnTo>
                      <a:lnTo>
                        <a:pt x="1311" y="14"/>
                      </a:lnTo>
                      <a:lnTo>
                        <a:pt x="1312" y="14"/>
                      </a:lnTo>
                      <a:lnTo>
                        <a:pt x="1312" y="10"/>
                      </a:lnTo>
                      <a:lnTo>
                        <a:pt x="1312" y="15"/>
                      </a:lnTo>
                      <a:lnTo>
                        <a:pt x="1312" y="10"/>
                      </a:lnTo>
                      <a:lnTo>
                        <a:pt x="1313" y="10"/>
                      </a:lnTo>
                      <a:lnTo>
                        <a:pt x="1313" y="10"/>
                      </a:lnTo>
                      <a:lnTo>
                        <a:pt x="1313" y="17"/>
                      </a:lnTo>
                      <a:lnTo>
                        <a:pt x="1313" y="12"/>
                      </a:lnTo>
                      <a:lnTo>
                        <a:pt x="1314" y="12"/>
                      </a:lnTo>
                      <a:lnTo>
                        <a:pt x="1314" y="10"/>
                      </a:lnTo>
                      <a:lnTo>
                        <a:pt x="1314" y="14"/>
                      </a:lnTo>
                      <a:lnTo>
                        <a:pt x="1314" y="13"/>
                      </a:lnTo>
                      <a:lnTo>
                        <a:pt x="1315" y="13"/>
                      </a:lnTo>
                      <a:lnTo>
                        <a:pt x="1315" y="12"/>
                      </a:lnTo>
                      <a:lnTo>
                        <a:pt x="1315" y="14"/>
                      </a:lnTo>
                      <a:lnTo>
                        <a:pt x="1315" y="12"/>
                      </a:lnTo>
                      <a:lnTo>
                        <a:pt x="1316" y="12"/>
                      </a:lnTo>
                      <a:lnTo>
                        <a:pt x="1316" y="10"/>
                      </a:lnTo>
                      <a:lnTo>
                        <a:pt x="1316" y="13"/>
                      </a:lnTo>
                      <a:lnTo>
                        <a:pt x="1316" y="13"/>
                      </a:lnTo>
                      <a:lnTo>
                        <a:pt x="1317" y="13"/>
                      </a:lnTo>
                      <a:lnTo>
                        <a:pt x="1317" y="10"/>
                      </a:lnTo>
                      <a:lnTo>
                        <a:pt x="1317" y="13"/>
                      </a:lnTo>
                      <a:lnTo>
                        <a:pt x="1317" y="13"/>
                      </a:lnTo>
                      <a:lnTo>
                        <a:pt x="1318" y="13"/>
                      </a:lnTo>
                      <a:lnTo>
                        <a:pt x="1318" y="12"/>
                      </a:lnTo>
                      <a:lnTo>
                        <a:pt x="1318" y="14"/>
                      </a:lnTo>
                      <a:lnTo>
                        <a:pt x="1318" y="13"/>
                      </a:lnTo>
                      <a:lnTo>
                        <a:pt x="1319" y="13"/>
                      </a:lnTo>
                      <a:lnTo>
                        <a:pt x="1319" y="11"/>
                      </a:lnTo>
                      <a:lnTo>
                        <a:pt x="1319" y="14"/>
                      </a:lnTo>
                      <a:lnTo>
                        <a:pt x="1319" y="13"/>
                      </a:lnTo>
                      <a:lnTo>
                        <a:pt x="1320" y="13"/>
                      </a:lnTo>
                      <a:lnTo>
                        <a:pt x="1320" y="11"/>
                      </a:lnTo>
                      <a:lnTo>
                        <a:pt x="1320" y="14"/>
                      </a:lnTo>
                      <a:lnTo>
                        <a:pt x="1320" y="12"/>
                      </a:lnTo>
                      <a:lnTo>
                        <a:pt x="1321" y="12"/>
                      </a:lnTo>
                      <a:lnTo>
                        <a:pt x="1321" y="12"/>
                      </a:lnTo>
                      <a:lnTo>
                        <a:pt x="1321" y="14"/>
                      </a:lnTo>
                      <a:lnTo>
                        <a:pt x="1321" y="13"/>
                      </a:lnTo>
                      <a:lnTo>
                        <a:pt x="1322" y="13"/>
                      </a:lnTo>
                      <a:lnTo>
                        <a:pt x="1322" y="11"/>
                      </a:lnTo>
                      <a:lnTo>
                        <a:pt x="1322" y="14"/>
                      </a:lnTo>
                      <a:lnTo>
                        <a:pt x="1322" y="13"/>
                      </a:lnTo>
                      <a:lnTo>
                        <a:pt x="1323" y="13"/>
                      </a:lnTo>
                      <a:lnTo>
                        <a:pt x="1323" y="13"/>
                      </a:lnTo>
                      <a:lnTo>
                        <a:pt x="1323" y="15"/>
                      </a:lnTo>
                      <a:lnTo>
                        <a:pt x="1323" y="14"/>
                      </a:lnTo>
                      <a:lnTo>
                        <a:pt x="1324" y="14"/>
                      </a:lnTo>
                      <a:lnTo>
                        <a:pt x="1324" y="10"/>
                      </a:lnTo>
                      <a:lnTo>
                        <a:pt x="1324" y="14"/>
                      </a:lnTo>
                      <a:lnTo>
                        <a:pt x="1324" y="13"/>
                      </a:lnTo>
                      <a:lnTo>
                        <a:pt x="1325" y="13"/>
                      </a:lnTo>
                      <a:lnTo>
                        <a:pt x="1325" y="9"/>
                      </a:lnTo>
                      <a:lnTo>
                        <a:pt x="1325" y="17"/>
                      </a:lnTo>
                      <a:lnTo>
                        <a:pt x="1325" y="12"/>
                      </a:lnTo>
                      <a:lnTo>
                        <a:pt x="1326" y="12"/>
                      </a:lnTo>
                      <a:lnTo>
                        <a:pt x="1326" y="10"/>
                      </a:lnTo>
                      <a:lnTo>
                        <a:pt x="1326" y="20"/>
                      </a:lnTo>
                      <a:lnTo>
                        <a:pt x="1326" y="12"/>
                      </a:lnTo>
                      <a:lnTo>
                        <a:pt x="1327" y="12"/>
                      </a:lnTo>
                      <a:lnTo>
                        <a:pt x="1327" y="11"/>
                      </a:lnTo>
                      <a:lnTo>
                        <a:pt x="1327" y="14"/>
                      </a:lnTo>
                      <a:lnTo>
                        <a:pt x="1327" y="13"/>
                      </a:lnTo>
                      <a:lnTo>
                        <a:pt x="1328" y="13"/>
                      </a:lnTo>
                      <a:lnTo>
                        <a:pt x="1328" y="11"/>
                      </a:lnTo>
                      <a:lnTo>
                        <a:pt x="1328" y="14"/>
                      </a:lnTo>
                      <a:lnTo>
                        <a:pt x="1328" y="13"/>
                      </a:lnTo>
                      <a:lnTo>
                        <a:pt x="1329" y="13"/>
                      </a:lnTo>
                      <a:lnTo>
                        <a:pt x="1329" y="13"/>
                      </a:lnTo>
                      <a:lnTo>
                        <a:pt x="1329" y="14"/>
                      </a:lnTo>
                      <a:lnTo>
                        <a:pt x="1329" y="13"/>
                      </a:lnTo>
                      <a:lnTo>
                        <a:pt x="1330" y="13"/>
                      </a:lnTo>
                      <a:lnTo>
                        <a:pt x="1330" y="12"/>
                      </a:lnTo>
                      <a:lnTo>
                        <a:pt x="1330" y="16"/>
                      </a:lnTo>
                      <a:lnTo>
                        <a:pt x="1330" y="13"/>
                      </a:lnTo>
                      <a:lnTo>
                        <a:pt x="1331" y="13"/>
                      </a:lnTo>
                      <a:lnTo>
                        <a:pt x="1331" y="10"/>
                      </a:lnTo>
                      <a:lnTo>
                        <a:pt x="1331" y="13"/>
                      </a:lnTo>
                      <a:lnTo>
                        <a:pt x="1331" y="13"/>
                      </a:lnTo>
                      <a:lnTo>
                        <a:pt x="1332" y="13"/>
                      </a:lnTo>
                      <a:lnTo>
                        <a:pt x="1332" y="12"/>
                      </a:lnTo>
                      <a:lnTo>
                        <a:pt x="1332" y="15"/>
                      </a:lnTo>
                      <a:lnTo>
                        <a:pt x="1332" y="13"/>
                      </a:lnTo>
                      <a:lnTo>
                        <a:pt x="1333" y="13"/>
                      </a:lnTo>
                      <a:lnTo>
                        <a:pt x="1333" y="11"/>
                      </a:lnTo>
                      <a:lnTo>
                        <a:pt x="1333" y="14"/>
                      </a:lnTo>
                      <a:lnTo>
                        <a:pt x="1333" y="14"/>
                      </a:lnTo>
                      <a:lnTo>
                        <a:pt x="1334" y="14"/>
                      </a:lnTo>
                      <a:lnTo>
                        <a:pt x="1334" y="10"/>
                      </a:lnTo>
                      <a:lnTo>
                        <a:pt x="1334" y="14"/>
                      </a:lnTo>
                      <a:lnTo>
                        <a:pt x="1334" y="11"/>
                      </a:lnTo>
                      <a:lnTo>
                        <a:pt x="1335" y="11"/>
                      </a:lnTo>
                      <a:lnTo>
                        <a:pt x="1335" y="11"/>
                      </a:lnTo>
                      <a:lnTo>
                        <a:pt x="1335" y="16"/>
                      </a:lnTo>
                      <a:lnTo>
                        <a:pt x="1335" y="13"/>
                      </a:lnTo>
                      <a:lnTo>
                        <a:pt x="1336" y="13"/>
                      </a:lnTo>
                      <a:lnTo>
                        <a:pt x="1336" y="13"/>
                      </a:lnTo>
                      <a:lnTo>
                        <a:pt x="1336" y="15"/>
                      </a:lnTo>
                      <a:lnTo>
                        <a:pt x="1336" y="13"/>
                      </a:lnTo>
                      <a:lnTo>
                        <a:pt x="1337" y="13"/>
                      </a:lnTo>
                      <a:lnTo>
                        <a:pt x="1337" y="12"/>
                      </a:lnTo>
                      <a:lnTo>
                        <a:pt x="1337" y="15"/>
                      </a:lnTo>
                      <a:lnTo>
                        <a:pt x="1337" y="12"/>
                      </a:lnTo>
                      <a:lnTo>
                        <a:pt x="1338" y="12"/>
                      </a:lnTo>
                      <a:lnTo>
                        <a:pt x="1338" y="12"/>
                      </a:lnTo>
                      <a:lnTo>
                        <a:pt x="1338" y="15"/>
                      </a:lnTo>
                      <a:lnTo>
                        <a:pt x="1338" y="13"/>
                      </a:lnTo>
                      <a:lnTo>
                        <a:pt x="1339" y="13"/>
                      </a:lnTo>
                      <a:lnTo>
                        <a:pt x="1339" y="12"/>
                      </a:lnTo>
                      <a:lnTo>
                        <a:pt x="1339" y="14"/>
                      </a:lnTo>
                      <a:lnTo>
                        <a:pt x="1339" y="14"/>
                      </a:lnTo>
                      <a:lnTo>
                        <a:pt x="1340" y="14"/>
                      </a:lnTo>
                      <a:lnTo>
                        <a:pt x="1340" y="11"/>
                      </a:lnTo>
                      <a:lnTo>
                        <a:pt x="1340" y="14"/>
                      </a:lnTo>
                      <a:lnTo>
                        <a:pt x="1340" y="14"/>
                      </a:lnTo>
                      <a:lnTo>
                        <a:pt x="1341" y="14"/>
                      </a:lnTo>
                      <a:lnTo>
                        <a:pt x="1341" y="12"/>
                      </a:lnTo>
                      <a:lnTo>
                        <a:pt x="1341" y="14"/>
                      </a:lnTo>
                      <a:lnTo>
                        <a:pt x="1341" y="12"/>
                      </a:lnTo>
                      <a:lnTo>
                        <a:pt x="1342" y="12"/>
                      </a:lnTo>
                      <a:lnTo>
                        <a:pt x="1342" y="10"/>
                      </a:lnTo>
                      <a:lnTo>
                        <a:pt x="1342" y="13"/>
                      </a:lnTo>
                      <a:lnTo>
                        <a:pt x="1342" y="12"/>
                      </a:lnTo>
                      <a:lnTo>
                        <a:pt x="1343" y="12"/>
                      </a:lnTo>
                      <a:lnTo>
                        <a:pt x="1343" y="10"/>
                      </a:lnTo>
                      <a:lnTo>
                        <a:pt x="1343" y="13"/>
                      </a:lnTo>
                      <a:lnTo>
                        <a:pt x="1343" y="12"/>
                      </a:lnTo>
                      <a:lnTo>
                        <a:pt x="1344" y="12"/>
                      </a:lnTo>
                      <a:lnTo>
                        <a:pt x="1344" y="11"/>
                      </a:lnTo>
                      <a:lnTo>
                        <a:pt x="1344" y="16"/>
                      </a:lnTo>
                      <a:lnTo>
                        <a:pt x="1344" y="11"/>
                      </a:lnTo>
                      <a:lnTo>
                        <a:pt x="1345" y="11"/>
                      </a:lnTo>
                      <a:lnTo>
                        <a:pt x="1345" y="10"/>
                      </a:lnTo>
                      <a:lnTo>
                        <a:pt x="1345" y="14"/>
                      </a:lnTo>
                      <a:lnTo>
                        <a:pt x="1345" y="14"/>
                      </a:lnTo>
                      <a:lnTo>
                        <a:pt x="1346" y="14"/>
                      </a:lnTo>
                      <a:lnTo>
                        <a:pt x="1346" y="11"/>
                      </a:lnTo>
                      <a:lnTo>
                        <a:pt x="1346" y="14"/>
                      </a:lnTo>
                      <a:lnTo>
                        <a:pt x="1346" y="13"/>
                      </a:lnTo>
                      <a:lnTo>
                        <a:pt x="1347" y="13"/>
                      </a:lnTo>
                      <a:lnTo>
                        <a:pt x="1347" y="12"/>
                      </a:lnTo>
                      <a:lnTo>
                        <a:pt x="1347" y="16"/>
                      </a:lnTo>
                      <a:lnTo>
                        <a:pt x="1347" y="14"/>
                      </a:lnTo>
                      <a:lnTo>
                        <a:pt x="1348" y="14"/>
                      </a:lnTo>
                      <a:lnTo>
                        <a:pt x="1348" y="10"/>
                      </a:lnTo>
                      <a:lnTo>
                        <a:pt x="1348" y="14"/>
                      </a:lnTo>
                      <a:lnTo>
                        <a:pt x="1348" y="12"/>
                      </a:lnTo>
                      <a:lnTo>
                        <a:pt x="1349" y="12"/>
                      </a:lnTo>
                      <a:lnTo>
                        <a:pt x="1349" y="10"/>
                      </a:lnTo>
                      <a:lnTo>
                        <a:pt x="1349" y="13"/>
                      </a:lnTo>
                      <a:lnTo>
                        <a:pt x="1349" y="11"/>
                      </a:lnTo>
                      <a:lnTo>
                        <a:pt x="1350" y="11"/>
                      </a:lnTo>
                      <a:lnTo>
                        <a:pt x="1350" y="10"/>
                      </a:lnTo>
                      <a:lnTo>
                        <a:pt x="1350" y="13"/>
                      </a:lnTo>
                      <a:lnTo>
                        <a:pt x="1350" y="13"/>
                      </a:lnTo>
                      <a:lnTo>
                        <a:pt x="1351" y="13"/>
                      </a:lnTo>
                      <a:lnTo>
                        <a:pt x="1351" y="9"/>
                      </a:lnTo>
                      <a:lnTo>
                        <a:pt x="1351" y="13"/>
                      </a:lnTo>
                      <a:lnTo>
                        <a:pt x="1351" y="9"/>
                      </a:lnTo>
                      <a:lnTo>
                        <a:pt x="1352" y="9"/>
                      </a:lnTo>
                      <a:lnTo>
                        <a:pt x="1352" y="8"/>
                      </a:lnTo>
                      <a:lnTo>
                        <a:pt x="1352" y="11"/>
                      </a:lnTo>
                      <a:lnTo>
                        <a:pt x="1352" y="9"/>
                      </a:lnTo>
                      <a:lnTo>
                        <a:pt x="1353" y="9"/>
                      </a:lnTo>
                      <a:lnTo>
                        <a:pt x="1353" y="10"/>
                      </a:lnTo>
                      <a:lnTo>
                        <a:pt x="1353" y="13"/>
                      </a:lnTo>
                      <a:lnTo>
                        <a:pt x="1353" y="13"/>
                      </a:lnTo>
                      <a:lnTo>
                        <a:pt x="1354" y="13"/>
                      </a:lnTo>
                      <a:lnTo>
                        <a:pt x="1354" y="11"/>
                      </a:lnTo>
                      <a:lnTo>
                        <a:pt x="1354" y="14"/>
                      </a:lnTo>
                      <a:lnTo>
                        <a:pt x="1354" y="13"/>
                      </a:lnTo>
                      <a:lnTo>
                        <a:pt x="1355" y="13"/>
                      </a:lnTo>
                      <a:lnTo>
                        <a:pt x="1355" y="11"/>
                      </a:lnTo>
                      <a:lnTo>
                        <a:pt x="1355" y="13"/>
                      </a:lnTo>
                      <a:lnTo>
                        <a:pt x="1355" y="12"/>
                      </a:lnTo>
                      <a:lnTo>
                        <a:pt x="1356" y="12"/>
                      </a:lnTo>
                      <a:lnTo>
                        <a:pt x="1356" y="11"/>
                      </a:lnTo>
                      <a:lnTo>
                        <a:pt x="1356" y="14"/>
                      </a:lnTo>
                      <a:lnTo>
                        <a:pt x="1356" y="13"/>
                      </a:lnTo>
                      <a:lnTo>
                        <a:pt x="1357" y="13"/>
                      </a:lnTo>
                      <a:lnTo>
                        <a:pt x="1357" y="10"/>
                      </a:lnTo>
                      <a:lnTo>
                        <a:pt x="1357" y="13"/>
                      </a:lnTo>
                      <a:lnTo>
                        <a:pt x="1357" y="11"/>
                      </a:lnTo>
                      <a:lnTo>
                        <a:pt x="1358" y="11"/>
                      </a:lnTo>
                      <a:lnTo>
                        <a:pt x="1358" y="11"/>
                      </a:lnTo>
                      <a:lnTo>
                        <a:pt x="1358" y="16"/>
                      </a:lnTo>
                      <a:lnTo>
                        <a:pt x="1358" y="13"/>
                      </a:lnTo>
                      <a:lnTo>
                        <a:pt x="1359" y="13"/>
                      </a:lnTo>
                      <a:lnTo>
                        <a:pt x="1359" y="10"/>
                      </a:lnTo>
                      <a:lnTo>
                        <a:pt x="1359" y="14"/>
                      </a:lnTo>
                      <a:lnTo>
                        <a:pt x="1359" y="11"/>
                      </a:lnTo>
                      <a:lnTo>
                        <a:pt x="1360" y="11"/>
                      </a:lnTo>
                      <a:lnTo>
                        <a:pt x="1360" y="10"/>
                      </a:lnTo>
                      <a:lnTo>
                        <a:pt x="1360" y="13"/>
                      </a:lnTo>
                      <a:lnTo>
                        <a:pt x="1360" y="10"/>
                      </a:lnTo>
                      <a:lnTo>
                        <a:pt x="1361" y="10"/>
                      </a:lnTo>
                      <a:lnTo>
                        <a:pt x="1361" y="9"/>
                      </a:lnTo>
                      <a:lnTo>
                        <a:pt x="1361" y="11"/>
                      </a:lnTo>
                      <a:lnTo>
                        <a:pt x="1361" y="10"/>
                      </a:lnTo>
                      <a:lnTo>
                        <a:pt x="1362" y="10"/>
                      </a:lnTo>
                      <a:lnTo>
                        <a:pt x="1362" y="9"/>
                      </a:lnTo>
                      <a:lnTo>
                        <a:pt x="1362" y="13"/>
                      </a:lnTo>
                      <a:lnTo>
                        <a:pt x="1362" y="11"/>
                      </a:lnTo>
                      <a:lnTo>
                        <a:pt x="1363" y="11"/>
                      </a:lnTo>
                      <a:lnTo>
                        <a:pt x="1363" y="10"/>
                      </a:lnTo>
                      <a:lnTo>
                        <a:pt x="1363" y="14"/>
                      </a:lnTo>
                      <a:lnTo>
                        <a:pt x="1363" y="13"/>
                      </a:lnTo>
                      <a:lnTo>
                        <a:pt x="1364" y="13"/>
                      </a:lnTo>
                      <a:lnTo>
                        <a:pt x="1364" y="9"/>
                      </a:lnTo>
                      <a:lnTo>
                        <a:pt x="1364" y="14"/>
                      </a:lnTo>
                      <a:lnTo>
                        <a:pt x="1364" y="12"/>
                      </a:lnTo>
                      <a:lnTo>
                        <a:pt x="1365" y="12"/>
                      </a:lnTo>
                      <a:lnTo>
                        <a:pt x="1365" y="11"/>
                      </a:lnTo>
                      <a:lnTo>
                        <a:pt x="1365" y="13"/>
                      </a:lnTo>
                      <a:lnTo>
                        <a:pt x="1365" y="12"/>
                      </a:lnTo>
                      <a:lnTo>
                        <a:pt x="1366" y="12"/>
                      </a:lnTo>
                      <a:lnTo>
                        <a:pt x="1366" y="10"/>
                      </a:lnTo>
                      <a:lnTo>
                        <a:pt x="1366" y="13"/>
                      </a:lnTo>
                      <a:lnTo>
                        <a:pt x="1366" y="11"/>
                      </a:lnTo>
                      <a:lnTo>
                        <a:pt x="1367" y="11"/>
                      </a:lnTo>
                      <a:lnTo>
                        <a:pt x="1367" y="10"/>
                      </a:lnTo>
                      <a:lnTo>
                        <a:pt x="1367" y="13"/>
                      </a:lnTo>
                      <a:lnTo>
                        <a:pt x="1367" y="11"/>
                      </a:lnTo>
                      <a:lnTo>
                        <a:pt x="1368" y="11"/>
                      </a:lnTo>
                      <a:lnTo>
                        <a:pt x="1368" y="10"/>
                      </a:lnTo>
                      <a:lnTo>
                        <a:pt x="1368" y="14"/>
                      </a:lnTo>
                      <a:lnTo>
                        <a:pt x="1368" y="11"/>
                      </a:lnTo>
                      <a:lnTo>
                        <a:pt x="1369" y="11"/>
                      </a:lnTo>
                      <a:lnTo>
                        <a:pt x="1369" y="10"/>
                      </a:lnTo>
                      <a:lnTo>
                        <a:pt x="1369" y="13"/>
                      </a:lnTo>
                      <a:lnTo>
                        <a:pt x="1369" y="11"/>
                      </a:lnTo>
                      <a:lnTo>
                        <a:pt x="1370" y="11"/>
                      </a:lnTo>
                      <a:lnTo>
                        <a:pt x="1370" y="8"/>
                      </a:lnTo>
                      <a:lnTo>
                        <a:pt x="1370" y="13"/>
                      </a:lnTo>
                      <a:lnTo>
                        <a:pt x="1370" y="9"/>
                      </a:lnTo>
                      <a:lnTo>
                        <a:pt x="1371" y="9"/>
                      </a:lnTo>
                      <a:lnTo>
                        <a:pt x="1371" y="9"/>
                      </a:lnTo>
                      <a:lnTo>
                        <a:pt x="1371" y="11"/>
                      </a:lnTo>
                      <a:lnTo>
                        <a:pt x="1371" y="11"/>
                      </a:lnTo>
                      <a:lnTo>
                        <a:pt x="1372" y="11"/>
                      </a:lnTo>
                      <a:lnTo>
                        <a:pt x="1372" y="10"/>
                      </a:lnTo>
                      <a:lnTo>
                        <a:pt x="1372" y="13"/>
                      </a:lnTo>
                      <a:lnTo>
                        <a:pt x="1372" y="11"/>
                      </a:lnTo>
                      <a:lnTo>
                        <a:pt x="1373" y="11"/>
                      </a:lnTo>
                      <a:lnTo>
                        <a:pt x="1373" y="10"/>
                      </a:lnTo>
                      <a:lnTo>
                        <a:pt x="1373" y="14"/>
                      </a:lnTo>
                      <a:lnTo>
                        <a:pt x="1373" y="14"/>
                      </a:lnTo>
                      <a:lnTo>
                        <a:pt x="1374" y="14"/>
                      </a:lnTo>
                      <a:lnTo>
                        <a:pt x="1374" y="10"/>
                      </a:lnTo>
                      <a:lnTo>
                        <a:pt x="1374" y="14"/>
                      </a:lnTo>
                      <a:lnTo>
                        <a:pt x="1374" y="12"/>
                      </a:lnTo>
                      <a:lnTo>
                        <a:pt x="1375" y="12"/>
                      </a:lnTo>
                      <a:lnTo>
                        <a:pt x="1375" y="10"/>
                      </a:lnTo>
                      <a:lnTo>
                        <a:pt x="1375" y="12"/>
                      </a:lnTo>
                      <a:lnTo>
                        <a:pt x="1375" y="11"/>
                      </a:lnTo>
                      <a:lnTo>
                        <a:pt x="1376" y="11"/>
                      </a:lnTo>
                      <a:lnTo>
                        <a:pt x="1376" y="10"/>
                      </a:lnTo>
                      <a:lnTo>
                        <a:pt x="1376" y="14"/>
                      </a:lnTo>
                      <a:lnTo>
                        <a:pt x="1376" y="11"/>
                      </a:lnTo>
                      <a:lnTo>
                        <a:pt x="1377" y="11"/>
                      </a:lnTo>
                      <a:lnTo>
                        <a:pt x="1377" y="10"/>
                      </a:lnTo>
                      <a:lnTo>
                        <a:pt x="1377" y="14"/>
                      </a:lnTo>
                      <a:lnTo>
                        <a:pt x="1377" y="11"/>
                      </a:lnTo>
                      <a:lnTo>
                        <a:pt x="1378" y="11"/>
                      </a:lnTo>
                      <a:lnTo>
                        <a:pt x="1378" y="9"/>
                      </a:lnTo>
                      <a:lnTo>
                        <a:pt x="1378" y="12"/>
                      </a:lnTo>
                      <a:lnTo>
                        <a:pt x="1378" y="10"/>
                      </a:lnTo>
                      <a:lnTo>
                        <a:pt x="1379" y="10"/>
                      </a:lnTo>
                      <a:lnTo>
                        <a:pt x="1379" y="8"/>
                      </a:lnTo>
                      <a:lnTo>
                        <a:pt x="1379" y="11"/>
                      </a:lnTo>
                      <a:lnTo>
                        <a:pt x="1379" y="10"/>
                      </a:lnTo>
                      <a:lnTo>
                        <a:pt x="1380" y="10"/>
                      </a:lnTo>
                      <a:lnTo>
                        <a:pt x="1380" y="10"/>
                      </a:lnTo>
                      <a:lnTo>
                        <a:pt x="1380" y="11"/>
                      </a:lnTo>
                      <a:lnTo>
                        <a:pt x="1380" y="10"/>
                      </a:lnTo>
                      <a:lnTo>
                        <a:pt x="1381" y="10"/>
                      </a:lnTo>
                      <a:lnTo>
                        <a:pt x="1381" y="8"/>
                      </a:lnTo>
                      <a:lnTo>
                        <a:pt x="1381" y="13"/>
                      </a:lnTo>
                      <a:lnTo>
                        <a:pt x="1381" y="11"/>
                      </a:lnTo>
                      <a:lnTo>
                        <a:pt x="1382" y="11"/>
                      </a:lnTo>
                      <a:lnTo>
                        <a:pt x="1382" y="9"/>
                      </a:lnTo>
                      <a:lnTo>
                        <a:pt x="1382" y="11"/>
                      </a:lnTo>
                      <a:lnTo>
                        <a:pt x="1382" y="11"/>
                      </a:lnTo>
                      <a:lnTo>
                        <a:pt x="1383" y="11"/>
                      </a:lnTo>
                      <a:lnTo>
                        <a:pt x="1383" y="10"/>
                      </a:lnTo>
                      <a:lnTo>
                        <a:pt x="1383" y="13"/>
                      </a:lnTo>
                      <a:lnTo>
                        <a:pt x="1383" y="10"/>
                      </a:lnTo>
                      <a:lnTo>
                        <a:pt x="1384" y="10"/>
                      </a:lnTo>
                      <a:lnTo>
                        <a:pt x="1384" y="9"/>
                      </a:lnTo>
                      <a:lnTo>
                        <a:pt x="1384" y="13"/>
                      </a:lnTo>
                      <a:lnTo>
                        <a:pt x="1384" y="9"/>
                      </a:lnTo>
                      <a:lnTo>
                        <a:pt x="1385" y="9"/>
                      </a:lnTo>
                      <a:lnTo>
                        <a:pt x="1385" y="9"/>
                      </a:lnTo>
                      <a:lnTo>
                        <a:pt x="1385" y="13"/>
                      </a:lnTo>
                      <a:lnTo>
                        <a:pt x="1385" y="10"/>
                      </a:lnTo>
                      <a:lnTo>
                        <a:pt x="1386" y="10"/>
                      </a:lnTo>
                      <a:lnTo>
                        <a:pt x="1386" y="8"/>
                      </a:lnTo>
                      <a:lnTo>
                        <a:pt x="1386" y="11"/>
                      </a:lnTo>
                      <a:lnTo>
                        <a:pt x="1386" y="10"/>
                      </a:lnTo>
                      <a:lnTo>
                        <a:pt x="1387" y="10"/>
                      </a:lnTo>
                      <a:lnTo>
                        <a:pt x="1387" y="9"/>
                      </a:lnTo>
                      <a:lnTo>
                        <a:pt x="1387" y="12"/>
                      </a:lnTo>
                      <a:lnTo>
                        <a:pt x="1387" y="10"/>
                      </a:lnTo>
                      <a:lnTo>
                        <a:pt x="1388" y="10"/>
                      </a:lnTo>
                      <a:lnTo>
                        <a:pt x="1388" y="8"/>
                      </a:lnTo>
                      <a:lnTo>
                        <a:pt x="1388" y="10"/>
                      </a:lnTo>
                      <a:lnTo>
                        <a:pt x="1388" y="10"/>
                      </a:lnTo>
                      <a:lnTo>
                        <a:pt x="1389" y="10"/>
                      </a:lnTo>
                      <a:lnTo>
                        <a:pt x="1389" y="7"/>
                      </a:lnTo>
                      <a:lnTo>
                        <a:pt x="1389" y="11"/>
                      </a:lnTo>
                      <a:lnTo>
                        <a:pt x="1389" y="11"/>
                      </a:lnTo>
                      <a:lnTo>
                        <a:pt x="1390" y="11"/>
                      </a:lnTo>
                      <a:lnTo>
                        <a:pt x="1390" y="8"/>
                      </a:lnTo>
                      <a:lnTo>
                        <a:pt x="1390" y="10"/>
                      </a:lnTo>
                      <a:lnTo>
                        <a:pt x="1390" y="9"/>
                      </a:lnTo>
                      <a:lnTo>
                        <a:pt x="1391" y="9"/>
                      </a:lnTo>
                      <a:lnTo>
                        <a:pt x="1391" y="8"/>
                      </a:lnTo>
                      <a:lnTo>
                        <a:pt x="1391" y="12"/>
                      </a:lnTo>
                      <a:lnTo>
                        <a:pt x="1391" y="10"/>
                      </a:lnTo>
                      <a:lnTo>
                        <a:pt x="1392" y="10"/>
                      </a:lnTo>
                      <a:lnTo>
                        <a:pt x="1392" y="7"/>
                      </a:lnTo>
                      <a:lnTo>
                        <a:pt x="1392" y="10"/>
                      </a:lnTo>
                      <a:lnTo>
                        <a:pt x="1392" y="7"/>
                      </a:lnTo>
                      <a:lnTo>
                        <a:pt x="1393" y="7"/>
                      </a:lnTo>
                      <a:lnTo>
                        <a:pt x="1393" y="7"/>
                      </a:lnTo>
                      <a:lnTo>
                        <a:pt x="1393" y="10"/>
                      </a:lnTo>
                      <a:lnTo>
                        <a:pt x="1393" y="8"/>
                      </a:lnTo>
                      <a:lnTo>
                        <a:pt x="1394" y="8"/>
                      </a:lnTo>
                      <a:lnTo>
                        <a:pt x="1394" y="8"/>
                      </a:lnTo>
                      <a:lnTo>
                        <a:pt x="1394" y="10"/>
                      </a:lnTo>
                      <a:lnTo>
                        <a:pt x="1394" y="10"/>
                      </a:lnTo>
                      <a:lnTo>
                        <a:pt x="1395" y="10"/>
                      </a:lnTo>
                      <a:lnTo>
                        <a:pt x="1395" y="7"/>
                      </a:lnTo>
                      <a:lnTo>
                        <a:pt x="1395" y="10"/>
                      </a:lnTo>
                      <a:lnTo>
                        <a:pt x="1395" y="8"/>
                      </a:lnTo>
                      <a:lnTo>
                        <a:pt x="1396" y="8"/>
                      </a:lnTo>
                      <a:lnTo>
                        <a:pt x="1396" y="6"/>
                      </a:lnTo>
                      <a:lnTo>
                        <a:pt x="1396" y="9"/>
                      </a:lnTo>
                      <a:lnTo>
                        <a:pt x="1396" y="9"/>
                      </a:lnTo>
                      <a:lnTo>
                        <a:pt x="1397" y="9"/>
                      </a:lnTo>
                      <a:lnTo>
                        <a:pt x="1397" y="7"/>
                      </a:lnTo>
                      <a:lnTo>
                        <a:pt x="1397" y="9"/>
                      </a:lnTo>
                      <a:lnTo>
                        <a:pt x="1397" y="7"/>
                      </a:lnTo>
                      <a:lnTo>
                        <a:pt x="1398" y="7"/>
                      </a:lnTo>
                      <a:lnTo>
                        <a:pt x="1398" y="7"/>
                      </a:lnTo>
                      <a:lnTo>
                        <a:pt x="1398" y="9"/>
                      </a:lnTo>
                      <a:lnTo>
                        <a:pt x="1398" y="8"/>
                      </a:lnTo>
                      <a:lnTo>
                        <a:pt x="1399" y="8"/>
                      </a:lnTo>
                      <a:lnTo>
                        <a:pt x="1399" y="5"/>
                      </a:lnTo>
                      <a:lnTo>
                        <a:pt x="1399" y="8"/>
                      </a:lnTo>
                      <a:lnTo>
                        <a:pt x="1399" y="8"/>
                      </a:lnTo>
                      <a:lnTo>
                        <a:pt x="1400" y="8"/>
                      </a:lnTo>
                      <a:lnTo>
                        <a:pt x="1400" y="6"/>
                      </a:lnTo>
                      <a:lnTo>
                        <a:pt x="1400" y="9"/>
                      </a:lnTo>
                      <a:lnTo>
                        <a:pt x="1400" y="7"/>
                      </a:lnTo>
                      <a:lnTo>
                        <a:pt x="1401" y="7"/>
                      </a:lnTo>
                      <a:lnTo>
                        <a:pt x="1401" y="5"/>
                      </a:lnTo>
                      <a:lnTo>
                        <a:pt x="1401" y="9"/>
                      </a:lnTo>
                      <a:lnTo>
                        <a:pt x="1401" y="5"/>
                      </a:lnTo>
                      <a:lnTo>
                        <a:pt x="1402" y="5"/>
                      </a:lnTo>
                      <a:lnTo>
                        <a:pt x="1402" y="5"/>
                      </a:lnTo>
                      <a:lnTo>
                        <a:pt x="1402" y="9"/>
                      </a:lnTo>
                      <a:lnTo>
                        <a:pt x="1402" y="7"/>
                      </a:lnTo>
                      <a:lnTo>
                        <a:pt x="1403" y="7"/>
                      </a:lnTo>
                      <a:lnTo>
                        <a:pt x="1403" y="5"/>
                      </a:lnTo>
                      <a:lnTo>
                        <a:pt x="1403" y="9"/>
                      </a:lnTo>
                      <a:lnTo>
                        <a:pt x="1403" y="7"/>
                      </a:lnTo>
                      <a:lnTo>
                        <a:pt x="1404" y="7"/>
                      </a:lnTo>
                      <a:lnTo>
                        <a:pt x="1404" y="5"/>
                      </a:lnTo>
                      <a:lnTo>
                        <a:pt x="1404" y="10"/>
                      </a:lnTo>
                      <a:lnTo>
                        <a:pt x="1404" y="7"/>
                      </a:lnTo>
                      <a:lnTo>
                        <a:pt x="1405" y="7"/>
                      </a:lnTo>
                      <a:lnTo>
                        <a:pt x="1405" y="5"/>
                      </a:lnTo>
                      <a:lnTo>
                        <a:pt x="1405" y="9"/>
                      </a:lnTo>
                      <a:lnTo>
                        <a:pt x="1405" y="8"/>
                      </a:lnTo>
                      <a:lnTo>
                        <a:pt x="1406" y="8"/>
                      </a:lnTo>
                      <a:lnTo>
                        <a:pt x="1406" y="5"/>
                      </a:lnTo>
                      <a:lnTo>
                        <a:pt x="1406" y="8"/>
                      </a:lnTo>
                      <a:lnTo>
                        <a:pt x="1406" y="6"/>
                      </a:lnTo>
                      <a:lnTo>
                        <a:pt x="1407" y="6"/>
                      </a:lnTo>
                      <a:lnTo>
                        <a:pt x="1407" y="5"/>
                      </a:lnTo>
                      <a:lnTo>
                        <a:pt x="1407" y="8"/>
                      </a:lnTo>
                      <a:lnTo>
                        <a:pt x="1407" y="7"/>
                      </a:lnTo>
                      <a:lnTo>
                        <a:pt x="1408" y="7"/>
                      </a:lnTo>
                      <a:lnTo>
                        <a:pt x="1408" y="5"/>
                      </a:lnTo>
                      <a:lnTo>
                        <a:pt x="1408" y="7"/>
                      </a:lnTo>
                      <a:lnTo>
                        <a:pt x="1408" y="5"/>
                      </a:lnTo>
                      <a:lnTo>
                        <a:pt x="1409" y="5"/>
                      </a:lnTo>
                      <a:lnTo>
                        <a:pt x="1409" y="4"/>
                      </a:lnTo>
                      <a:lnTo>
                        <a:pt x="1409" y="10"/>
                      </a:lnTo>
                      <a:lnTo>
                        <a:pt x="1409" y="7"/>
                      </a:lnTo>
                      <a:lnTo>
                        <a:pt x="1410" y="7"/>
                      </a:lnTo>
                      <a:lnTo>
                        <a:pt x="1410" y="5"/>
                      </a:lnTo>
                      <a:lnTo>
                        <a:pt x="1410" y="8"/>
                      </a:lnTo>
                      <a:lnTo>
                        <a:pt x="1410" y="7"/>
                      </a:lnTo>
                      <a:lnTo>
                        <a:pt x="1411" y="7"/>
                      </a:lnTo>
                      <a:lnTo>
                        <a:pt x="1411" y="5"/>
                      </a:lnTo>
                      <a:lnTo>
                        <a:pt x="1411" y="8"/>
                      </a:lnTo>
                      <a:lnTo>
                        <a:pt x="1411" y="8"/>
                      </a:lnTo>
                      <a:lnTo>
                        <a:pt x="1412" y="8"/>
                      </a:lnTo>
                      <a:lnTo>
                        <a:pt x="1412" y="5"/>
                      </a:lnTo>
                      <a:lnTo>
                        <a:pt x="1412" y="8"/>
                      </a:lnTo>
                      <a:lnTo>
                        <a:pt x="1412" y="8"/>
                      </a:lnTo>
                      <a:lnTo>
                        <a:pt x="1413" y="8"/>
                      </a:lnTo>
                      <a:lnTo>
                        <a:pt x="1413" y="4"/>
                      </a:lnTo>
                      <a:lnTo>
                        <a:pt x="1413" y="8"/>
                      </a:lnTo>
                      <a:lnTo>
                        <a:pt x="1413" y="7"/>
                      </a:lnTo>
                      <a:lnTo>
                        <a:pt x="1414" y="7"/>
                      </a:lnTo>
                      <a:lnTo>
                        <a:pt x="1414" y="5"/>
                      </a:lnTo>
                      <a:lnTo>
                        <a:pt x="1414" y="7"/>
                      </a:lnTo>
                      <a:lnTo>
                        <a:pt x="1414" y="7"/>
                      </a:lnTo>
                      <a:lnTo>
                        <a:pt x="1415" y="7"/>
                      </a:lnTo>
                      <a:lnTo>
                        <a:pt x="1415" y="5"/>
                      </a:lnTo>
                      <a:lnTo>
                        <a:pt x="1415" y="7"/>
                      </a:lnTo>
                      <a:lnTo>
                        <a:pt x="1415" y="7"/>
                      </a:lnTo>
                      <a:lnTo>
                        <a:pt x="1416" y="7"/>
                      </a:lnTo>
                      <a:lnTo>
                        <a:pt x="1416" y="5"/>
                      </a:lnTo>
                      <a:lnTo>
                        <a:pt x="1416" y="8"/>
                      </a:lnTo>
                      <a:lnTo>
                        <a:pt x="1416" y="5"/>
                      </a:lnTo>
                      <a:lnTo>
                        <a:pt x="1417" y="5"/>
                      </a:lnTo>
                      <a:lnTo>
                        <a:pt x="1417" y="4"/>
                      </a:lnTo>
                      <a:lnTo>
                        <a:pt x="1417" y="7"/>
                      </a:lnTo>
                      <a:lnTo>
                        <a:pt x="1417" y="4"/>
                      </a:lnTo>
                      <a:lnTo>
                        <a:pt x="1418" y="4"/>
                      </a:lnTo>
                      <a:lnTo>
                        <a:pt x="1418" y="4"/>
                      </a:lnTo>
                      <a:lnTo>
                        <a:pt x="1418" y="7"/>
                      </a:lnTo>
                      <a:lnTo>
                        <a:pt x="1418" y="5"/>
                      </a:lnTo>
                      <a:lnTo>
                        <a:pt x="1419" y="5"/>
                      </a:lnTo>
                      <a:lnTo>
                        <a:pt x="1419" y="4"/>
                      </a:lnTo>
                      <a:lnTo>
                        <a:pt x="1419" y="7"/>
                      </a:lnTo>
                      <a:lnTo>
                        <a:pt x="1419" y="4"/>
                      </a:lnTo>
                      <a:lnTo>
                        <a:pt x="1420" y="4"/>
                      </a:lnTo>
                      <a:lnTo>
                        <a:pt x="1420" y="4"/>
                      </a:lnTo>
                      <a:lnTo>
                        <a:pt x="1420" y="8"/>
                      </a:lnTo>
                      <a:lnTo>
                        <a:pt x="1420" y="7"/>
                      </a:lnTo>
                      <a:lnTo>
                        <a:pt x="1421" y="7"/>
                      </a:lnTo>
                      <a:lnTo>
                        <a:pt x="1421" y="5"/>
                      </a:lnTo>
                      <a:lnTo>
                        <a:pt x="1421" y="7"/>
                      </a:lnTo>
                      <a:lnTo>
                        <a:pt x="1421" y="7"/>
                      </a:lnTo>
                      <a:lnTo>
                        <a:pt x="1422" y="7"/>
                      </a:lnTo>
                      <a:lnTo>
                        <a:pt x="1422" y="5"/>
                      </a:lnTo>
                      <a:lnTo>
                        <a:pt x="1422" y="8"/>
                      </a:lnTo>
                      <a:lnTo>
                        <a:pt x="1422" y="7"/>
                      </a:lnTo>
                      <a:lnTo>
                        <a:pt x="1423" y="7"/>
                      </a:lnTo>
                      <a:lnTo>
                        <a:pt x="1423" y="5"/>
                      </a:lnTo>
                      <a:lnTo>
                        <a:pt x="1423" y="8"/>
                      </a:lnTo>
                      <a:lnTo>
                        <a:pt x="1423" y="7"/>
                      </a:lnTo>
                      <a:lnTo>
                        <a:pt x="1424" y="7"/>
                      </a:lnTo>
                      <a:lnTo>
                        <a:pt x="1424" y="5"/>
                      </a:lnTo>
                      <a:lnTo>
                        <a:pt x="1424" y="7"/>
                      </a:lnTo>
                      <a:lnTo>
                        <a:pt x="1424" y="7"/>
                      </a:lnTo>
                      <a:lnTo>
                        <a:pt x="1425" y="7"/>
                      </a:lnTo>
                      <a:lnTo>
                        <a:pt x="1425" y="5"/>
                      </a:lnTo>
                      <a:lnTo>
                        <a:pt x="1425" y="8"/>
                      </a:lnTo>
                      <a:lnTo>
                        <a:pt x="1425" y="5"/>
                      </a:lnTo>
                      <a:lnTo>
                        <a:pt x="1426" y="5"/>
                      </a:lnTo>
                      <a:lnTo>
                        <a:pt x="1426" y="2"/>
                      </a:lnTo>
                      <a:lnTo>
                        <a:pt x="1426" y="6"/>
                      </a:lnTo>
                      <a:lnTo>
                        <a:pt x="1426" y="4"/>
                      </a:lnTo>
                      <a:lnTo>
                        <a:pt x="1427" y="4"/>
                      </a:lnTo>
                      <a:lnTo>
                        <a:pt x="1427" y="4"/>
                      </a:lnTo>
                      <a:lnTo>
                        <a:pt x="1427" y="7"/>
                      </a:lnTo>
                      <a:lnTo>
                        <a:pt x="1427" y="5"/>
                      </a:lnTo>
                      <a:lnTo>
                        <a:pt x="1428" y="5"/>
                      </a:lnTo>
                      <a:lnTo>
                        <a:pt x="1428" y="2"/>
                      </a:lnTo>
                      <a:lnTo>
                        <a:pt x="1428" y="6"/>
                      </a:lnTo>
                      <a:lnTo>
                        <a:pt x="1428" y="3"/>
                      </a:lnTo>
                      <a:lnTo>
                        <a:pt x="1429" y="3"/>
                      </a:lnTo>
                      <a:lnTo>
                        <a:pt x="1429" y="3"/>
                      </a:lnTo>
                      <a:lnTo>
                        <a:pt x="1429" y="5"/>
                      </a:lnTo>
                      <a:lnTo>
                        <a:pt x="1429" y="5"/>
                      </a:lnTo>
                      <a:lnTo>
                        <a:pt x="1430" y="5"/>
                      </a:lnTo>
                      <a:lnTo>
                        <a:pt x="1430" y="4"/>
                      </a:lnTo>
                      <a:lnTo>
                        <a:pt x="1430" y="7"/>
                      </a:lnTo>
                      <a:lnTo>
                        <a:pt x="1430" y="5"/>
                      </a:lnTo>
                      <a:lnTo>
                        <a:pt x="1431" y="5"/>
                      </a:lnTo>
                      <a:lnTo>
                        <a:pt x="1431" y="4"/>
                      </a:lnTo>
                      <a:lnTo>
                        <a:pt x="1431" y="8"/>
                      </a:lnTo>
                      <a:lnTo>
                        <a:pt x="1431" y="5"/>
                      </a:lnTo>
                      <a:lnTo>
                        <a:pt x="1432" y="5"/>
                      </a:lnTo>
                      <a:lnTo>
                        <a:pt x="1432" y="3"/>
                      </a:lnTo>
                      <a:lnTo>
                        <a:pt x="1432" y="5"/>
                      </a:lnTo>
                      <a:lnTo>
                        <a:pt x="1432" y="3"/>
                      </a:lnTo>
                      <a:lnTo>
                        <a:pt x="1433" y="3"/>
                      </a:lnTo>
                      <a:lnTo>
                        <a:pt x="1433" y="2"/>
                      </a:lnTo>
                      <a:lnTo>
                        <a:pt x="1433" y="7"/>
                      </a:lnTo>
                      <a:lnTo>
                        <a:pt x="1433" y="5"/>
                      </a:lnTo>
                      <a:lnTo>
                        <a:pt x="1434" y="5"/>
                      </a:lnTo>
                      <a:lnTo>
                        <a:pt x="1434" y="2"/>
                      </a:lnTo>
                      <a:lnTo>
                        <a:pt x="1434" y="6"/>
                      </a:lnTo>
                      <a:lnTo>
                        <a:pt x="1434" y="4"/>
                      </a:lnTo>
                      <a:lnTo>
                        <a:pt x="1435" y="4"/>
                      </a:lnTo>
                      <a:lnTo>
                        <a:pt x="1435" y="1"/>
                      </a:lnTo>
                      <a:lnTo>
                        <a:pt x="1435" y="5"/>
                      </a:lnTo>
                      <a:lnTo>
                        <a:pt x="1435" y="4"/>
                      </a:lnTo>
                      <a:lnTo>
                        <a:pt x="1436" y="4"/>
                      </a:lnTo>
                      <a:lnTo>
                        <a:pt x="1436" y="2"/>
                      </a:lnTo>
                      <a:lnTo>
                        <a:pt x="1436" y="5"/>
                      </a:lnTo>
                      <a:lnTo>
                        <a:pt x="1436" y="3"/>
                      </a:lnTo>
                      <a:lnTo>
                        <a:pt x="1437" y="3"/>
                      </a:lnTo>
                      <a:lnTo>
                        <a:pt x="1437" y="1"/>
                      </a:lnTo>
                      <a:lnTo>
                        <a:pt x="1437" y="4"/>
                      </a:lnTo>
                      <a:lnTo>
                        <a:pt x="1437" y="2"/>
                      </a:lnTo>
                      <a:lnTo>
                        <a:pt x="1438" y="2"/>
                      </a:lnTo>
                      <a:lnTo>
                        <a:pt x="1438" y="1"/>
                      </a:lnTo>
                      <a:lnTo>
                        <a:pt x="1438" y="5"/>
                      </a:lnTo>
                      <a:lnTo>
                        <a:pt x="1438" y="4"/>
                      </a:lnTo>
                      <a:lnTo>
                        <a:pt x="1439" y="4"/>
                      </a:lnTo>
                      <a:lnTo>
                        <a:pt x="1439" y="2"/>
                      </a:lnTo>
                      <a:lnTo>
                        <a:pt x="1439" y="6"/>
                      </a:lnTo>
                      <a:lnTo>
                        <a:pt x="1439" y="2"/>
                      </a:lnTo>
                      <a:lnTo>
                        <a:pt x="1440" y="2"/>
                      </a:lnTo>
                      <a:lnTo>
                        <a:pt x="1440" y="2"/>
                      </a:lnTo>
                      <a:lnTo>
                        <a:pt x="1440" y="5"/>
                      </a:lnTo>
                      <a:lnTo>
                        <a:pt x="1440" y="3"/>
                      </a:lnTo>
                      <a:lnTo>
                        <a:pt x="1441" y="3"/>
                      </a:lnTo>
                      <a:lnTo>
                        <a:pt x="1441" y="1"/>
                      </a:lnTo>
                      <a:lnTo>
                        <a:pt x="1441" y="4"/>
                      </a:lnTo>
                      <a:lnTo>
                        <a:pt x="1441" y="4"/>
                      </a:lnTo>
                      <a:lnTo>
                        <a:pt x="1442" y="4"/>
                      </a:lnTo>
                      <a:lnTo>
                        <a:pt x="1442" y="2"/>
                      </a:lnTo>
                      <a:lnTo>
                        <a:pt x="1442" y="4"/>
                      </a:lnTo>
                      <a:lnTo>
                        <a:pt x="1442" y="4"/>
                      </a:lnTo>
                      <a:lnTo>
                        <a:pt x="1443" y="4"/>
                      </a:lnTo>
                      <a:lnTo>
                        <a:pt x="1443" y="1"/>
                      </a:lnTo>
                      <a:lnTo>
                        <a:pt x="1443" y="4"/>
                      </a:lnTo>
                      <a:lnTo>
                        <a:pt x="1443" y="1"/>
                      </a:lnTo>
                      <a:lnTo>
                        <a:pt x="1444" y="1"/>
                      </a:lnTo>
                      <a:lnTo>
                        <a:pt x="1444" y="0"/>
                      </a:lnTo>
                      <a:lnTo>
                        <a:pt x="1444" y="4"/>
                      </a:lnTo>
                      <a:lnTo>
                        <a:pt x="1444" y="3"/>
                      </a:lnTo>
                      <a:lnTo>
                        <a:pt x="1445" y="3"/>
                      </a:lnTo>
                      <a:lnTo>
                        <a:pt x="1445" y="2"/>
                      </a:lnTo>
                      <a:lnTo>
                        <a:pt x="1445" y="5"/>
                      </a:lnTo>
                      <a:lnTo>
                        <a:pt x="1445" y="4"/>
                      </a:lnTo>
                      <a:lnTo>
                        <a:pt x="1446" y="4"/>
                      </a:lnTo>
                      <a:lnTo>
                        <a:pt x="1446" y="1"/>
                      </a:lnTo>
                      <a:lnTo>
                        <a:pt x="1446" y="3"/>
                      </a:lnTo>
                      <a:lnTo>
                        <a:pt x="1446" y="2"/>
                      </a:lnTo>
                      <a:lnTo>
                        <a:pt x="1447" y="2"/>
                      </a:lnTo>
                      <a:lnTo>
                        <a:pt x="1447" y="1"/>
                      </a:lnTo>
                      <a:lnTo>
                        <a:pt x="1447" y="3"/>
                      </a:lnTo>
                      <a:lnTo>
                        <a:pt x="1447" y="2"/>
                      </a:lnTo>
                      <a:lnTo>
                        <a:pt x="1448" y="2"/>
                      </a:lnTo>
                      <a:lnTo>
                        <a:pt x="1448" y="2"/>
                      </a:lnTo>
                      <a:lnTo>
                        <a:pt x="1448" y="4"/>
                      </a:lnTo>
                      <a:lnTo>
                        <a:pt x="1448" y="2"/>
                      </a:lnTo>
                      <a:lnTo>
                        <a:pt x="1449" y="2"/>
                      </a:lnTo>
                      <a:lnTo>
                        <a:pt x="1449" y="1"/>
                      </a:lnTo>
                      <a:lnTo>
                        <a:pt x="1449" y="4"/>
                      </a:lnTo>
                      <a:lnTo>
                        <a:pt x="1449" y="4"/>
                      </a:lnTo>
                      <a:lnTo>
                        <a:pt x="1450" y="4"/>
                      </a:lnTo>
                      <a:lnTo>
                        <a:pt x="1450" y="2"/>
                      </a:lnTo>
                      <a:lnTo>
                        <a:pt x="1450" y="6"/>
                      </a:lnTo>
                      <a:lnTo>
                        <a:pt x="1450" y="2"/>
                      </a:lnTo>
                      <a:lnTo>
                        <a:pt x="1451" y="2"/>
                      </a:lnTo>
                      <a:lnTo>
                        <a:pt x="1451" y="2"/>
                      </a:lnTo>
                      <a:lnTo>
                        <a:pt x="1451" y="5"/>
                      </a:lnTo>
                      <a:lnTo>
                        <a:pt x="1451" y="4"/>
                      </a:lnTo>
                      <a:lnTo>
                        <a:pt x="1452" y="4"/>
                      </a:lnTo>
                      <a:lnTo>
                        <a:pt x="1452" y="2"/>
                      </a:lnTo>
                      <a:lnTo>
                        <a:pt x="1452" y="5"/>
                      </a:lnTo>
                      <a:lnTo>
                        <a:pt x="1452" y="3"/>
                      </a:lnTo>
                      <a:lnTo>
                        <a:pt x="1453" y="3"/>
                      </a:lnTo>
                      <a:lnTo>
                        <a:pt x="1453" y="1"/>
                      </a:lnTo>
                      <a:lnTo>
                        <a:pt x="1453" y="5"/>
                      </a:lnTo>
                      <a:lnTo>
                        <a:pt x="1453" y="3"/>
                      </a:lnTo>
                      <a:lnTo>
                        <a:pt x="1454" y="3"/>
                      </a:lnTo>
                      <a:lnTo>
                        <a:pt x="1454" y="2"/>
                      </a:lnTo>
                      <a:lnTo>
                        <a:pt x="1454" y="7"/>
                      </a:lnTo>
                      <a:lnTo>
                        <a:pt x="1454" y="6"/>
                      </a:lnTo>
                      <a:lnTo>
                        <a:pt x="1455" y="6"/>
                      </a:lnTo>
                      <a:lnTo>
                        <a:pt x="1455" y="2"/>
                      </a:lnTo>
                      <a:lnTo>
                        <a:pt x="1455" y="6"/>
                      </a:lnTo>
                      <a:lnTo>
                        <a:pt x="1455" y="2"/>
                      </a:lnTo>
                      <a:lnTo>
                        <a:pt x="1456" y="2"/>
                      </a:lnTo>
                      <a:lnTo>
                        <a:pt x="1456" y="2"/>
                      </a:lnTo>
                      <a:lnTo>
                        <a:pt x="1456" y="5"/>
                      </a:lnTo>
                      <a:lnTo>
                        <a:pt x="1456" y="5"/>
                      </a:lnTo>
                      <a:lnTo>
                        <a:pt x="1457" y="5"/>
                      </a:lnTo>
                      <a:lnTo>
                        <a:pt x="1457" y="1"/>
                      </a:lnTo>
                      <a:lnTo>
                        <a:pt x="1457" y="5"/>
                      </a:lnTo>
                      <a:lnTo>
                        <a:pt x="1457" y="2"/>
                      </a:lnTo>
                      <a:lnTo>
                        <a:pt x="1458" y="2"/>
                      </a:lnTo>
                      <a:lnTo>
                        <a:pt x="1458" y="1"/>
                      </a:lnTo>
                      <a:lnTo>
                        <a:pt x="1458" y="5"/>
                      </a:lnTo>
                      <a:lnTo>
                        <a:pt x="1458" y="2"/>
                      </a:lnTo>
                      <a:lnTo>
                        <a:pt x="1459" y="2"/>
                      </a:lnTo>
                      <a:lnTo>
                        <a:pt x="1459" y="2"/>
                      </a:lnTo>
                      <a:lnTo>
                        <a:pt x="1459" y="6"/>
                      </a:lnTo>
                      <a:lnTo>
                        <a:pt x="1459" y="4"/>
                      </a:lnTo>
                      <a:lnTo>
                        <a:pt x="1460" y="4"/>
                      </a:lnTo>
                      <a:lnTo>
                        <a:pt x="1460" y="2"/>
                      </a:lnTo>
                      <a:lnTo>
                        <a:pt x="1460" y="7"/>
                      </a:lnTo>
                      <a:lnTo>
                        <a:pt x="1460" y="5"/>
                      </a:lnTo>
                      <a:lnTo>
                        <a:pt x="1461" y="5"/>
                      </a:lnTo>
                      <a:lnTo>
                        <a:pt x="1461" y="2"/>
                      </a:lnTo>
                      <a:lnTo>
                        <a:pt x="1461" y="6"/>
                      </a:lnTo>
                      <a:lnTo>
                        <a:pt x="1461" y="6"/>
                      </a:lnTo>
                      <a:lnTo>
                        <a:pt x="1462" y="6"/>
                      </a:lnTo>
                      <a:lnTo>
                        <a:pt x="1462" y="4"/>
                      </a:lnTo>
                      <a:lnTo>
                        <a:pt x="1462" y="7"/>
                      </a:lnTo>
                      <a:lnTo>
                        <a:pt x="1462" y="7"/>
                      </a:lnTo>
                      <a:lnTo>
                        <a:pt x="1463" y="7"/>
                      </a:lnTo>
                      <a:lnTo>
                        <a:pt x="1463" y="2"/>
                      </a:lnTo>
                      <a:lnTo>
                        <a:pt x="1463" y="8"/>
                      </a:lnTo>
                      <a:lnTo>
                        <a:pt x="1463" y="5"/>
                      </a:lnTo>
                      <a:lnTo>
                        <a:pt x="1464" y="5"/>
                      </a:lnTo>
                      <a:lnTo>
                        <a:pt x="1464" y="2"/>
                      </a:lnTo>
                      <a:lnTo>
                        <a:pt x="1464" y="5"/>
                      </a:lnTo>
                      <a:lnTo>
                        <a:pt x="1464" y="4"/>
                      </a:lnTo>
                      <a:lnTo>
                        <a:pt x="1465" y="4"/>
                      </a:lnTo>
                      <a:lnTo>
                        <a:pt x="1465" y="3"/>
                      </a:lnTo>
                      <a:lnTo>
                        <a:pt x="1465" y="6"/>
                      </a:lnTo>
                      <a:lnTo>
                        <a:pt x="1465" y="4"/>
                      </a:lnTo>
                      <a:lnTo>
                        <a:pt x="1466" y="4"/>
                      </a:lnTo>
                      <a:lnTo>
                        <a:pt x="1466" y="2"/>
                      </a:lnTo>
                      <a:lnTo>
                        <a:pt x="1466" y="6"/>
                      </a:lnTo>
                      <a:lnTo>
                        <a:pt x="1466" y="4"/>
                      </a:lnTo>
                      <a:lnTo>
                        <a:pt x="1467" y="4"/>
                      </a:lnTo>
                      <a:lnTo>
                        <a:pt x="1467" y="2"/>
                      </a:lnTo>
                      <a:lnTo>
                        <a:pt x="1467" y="6"/>
                      </a:lnTo>
                      <a:lnTo>
                        <a:pt x="1467" y="2"/>
                      </a:lnTo>
                      <a:lnTo>
                        <a:pt x="1468" y="2"/>
                      </a:lnTo>
                      <a:lnTo>
                        <a:pt x="1468" y="1"/>
                      </a:lnTo>
                      <a:lnTo>
                        <a:pt x="1468" y="4"/>
                      </a:lnTo>
                      <a:lnTo>
                        <a:pt x="1468" y="2"/>
                      </a:lnTo>
                      <a:lnTo>
                        <a:pt x="1469" y="2"/>
                      </a:lnTo>
                      <a:lnTo>
                        <a:pt x="1469" y="1"/>
                      </a:lnTo>
                      <a:lnTo>
                        <a:pt x="1469" y="4"/>
                      </a:lnTo>
                      <a:lnTo>
                        <a:pt x="1469" y="4"/>
                      </a:lnTo>
                      <a:lnTo>
                        <a:pt x="1470" y="4"/>
                      </a:lnTo>
                      <a:lnTo>
                        <a:pt x="1470" y="2"/>
                      </a:lnTo>
                      <a:lnTo>
                        <a:pt x="1470" y="5"/>
                      </a:lnTo>
                      <a:lnTo>
                        <a:pt x="1470" y="4"/>
                      </a:lnTo>
                      <a:lnTo>
                        <a:pt x="1471" y="4"/>
                      </a:lnTo>
                      <a:lnTo>
                        <a:pt x="1471" y="1"/>
                      </a:lnTo>
                      <a:lnTo>
                        <a:pt x="1471" y="4"/>
                      </a:lnTo>
                      <a:lnTo>
                        <a:pt x="1471" y="4"/>
                      </a:lnTo>
                      <a:lnTo>
                        <a:pt x="1472" y="4"/>
                      </a:lnTo>
                      <a:lnTo>
                        <a:pt x="1472" y="1"/>
                      </a:lnTo>
                      <a:lnTo>
                        <a:pt x="1472" y="5"/>
                      </a:lnTo>
                      <a:lnTo>
                        <a:pt x="1472" y="3"/>
                      </a:lnTo>
                      <a:lnTo>
                        <a:pt x="1473" y="3"/>
                      </a:lnTo>
                      <a:lnTo>
                        <a:pt x="1473" y="1"/>
                      </a:lnTo>
                      <a:lnTo>
                        <a:pt x="1473" y="4"/>
                      </a:lnTo>
                      <a:lnTo>
                        <a:pt x="1473" y="2"/>
                      </a:lnTo>
                      <a:lnTo>
                        <a:pt x="1474" y="2"/>
                      </a:lnTo>
                      <a:lnTo>
                        <a:pt x="1474" y="2"/>
                      </a:lnTo>
                      <a:lnTo>
                        <a:pt x="1474" y="4"/>
                      </a:lnTo>
                      <a:lnTo>
                        <a:pt x="1474" y="2"/>
                      </a:lnTo>
                      <a:lnTo>
                        <a:pt x="1475" y="2"/>
                      </a:lnTo>
                      <a:lnTo>
                        <a:pt x="1475" y="2"/>
                      </a:lnTo>
                      <a:lnTo>
                        <a:pt x="1475" y="5"/>
                      </a:lnTo>
                      <a:lnTo>
                        <a:pt x="1475" y="3"/>
                      </a:lnTo>
                      <a:lnTo>
                        <a:pt x="1476" y="3"/>
                      </a:lnTo>
                      <a:lnTo>
                        <a:pt x="1476" y="3"/>
                      </a:lnTo>
                      <a:lnTo>
                        <a:pt x="1476" y="6"/>
                      </a:lnTo>
                      <a:lnTo>
                        <a:pt x="1476" y="5"/>
                      </a:lnTo>
                      <a:lnTo>
                        <a:pt x="1477" y="5"/>
                      </a:lnTo>
                      <a:lnTo>
                        <a:pt x="1477" y="2"/>
                      </a:lnTo>
                      <a:lnTo>
                        <a:pt x="1477" y="5"/>
                      </a:lnTo>
                      <a:lnTo>
                        <a:pt x="1477" y="4"/>
                      </a:lnTo>
                      <a:lnTo>
                        <a:pt x="1478" y="4"/>
                      </a:lnTo>
                      <a:lnTo>
                        <a:pt x="1478" y="2"/>
                      </a:lnTo>
                      <a:lnTo>
                        <a:pt x="1478" y="7"/>
                      </a:lnTo>
                      <a:lnTo>
                        <a:pt x="1478" y="4"/>
                      </a:lnTo>
                      <a:lnTo>
                        <a:pt x="1479" y="4"/>
                      </a:lnTo>
                      <a:lnTo>
                        <a:pt x="1479" y="2"/>
                      </a:lnTo>
                      <a:lnTo>
                        <a:pt x="1479" y="5"/>
                      </a:lnTo>
                      <a:lnTo>
                        <a:pt x="1479" y="3"/>
                      </a:lnTo>
                      <a:lnTo>
                        <a:pt x="1480" y="3"/>
                      </a:lnTo>
                      <a:lnTo>
                        <a:pt x="1480" y="1"/>
                      </a:lnTo>
                      <a:lnTo>
                        <a:pt x="1480" y="5"/>
                      </a:lnTo>
                      <a:lnTo>
                        <a:pt x="1480" y="5"/>
                      </a:lnTo>
                      <a:lnTo>
                        <a:pt x="1481" y="5"/>
                      </a:lnTo>
                      <a:lnTo>
                        <a:pt x="1481" y="2"/>
                      </a:lnTo>
                      <a:lnTo>
                        <a:pt x="1481" y="5"/>
                      </a:lnTo>
                      <a:lnTo>
                        <a:pt x="1481" y="2"/>
                      </a:lnTo>
                      <a:lnTo>
                        <a:pt x="1482" y="2"/>
                      </a:lnTo>
                      <a:lnTo>
                        <a:pt x="1482" y="2"/>
                      </a:lnTo>
                      <a:lnTo>
                        <a:pt x="1482" y="5"/>
                      </a:lnTo>
                      <a:lnTo>
                        <a:pt x="1482" y="3"/>
                      </a:lnTo>
                      <a:lnTo>
                        <a:pt x="1483" y="3"/>
                      </a:lnTo>
                      <a:lnTo>
                        <a:pt x="1483" y="4"/>
                      </a:lnTo>
                      <a:lnTo>
                        <a:pt x="1483" y="6"/>
                      </a:lnTo>
                      <a:lnTo>
                        <a:pt x="1483" y="5"/>
                      </a:lnTo>
                      <a:lnTo>
                        <a:pt x="1484" y="5"/>
                      </a:lnTo>
                      <a:lnTo>
                        <a:pt x="1484" y="4"/>
                      </a:lnTo>
                      <a:lnTo>
                        <a:pt x="1484" y="7"/>
                      </a:lnTo>
                      <a:lnTo>
                        <a:pt x="1484" y="5"/>
                      </a:lnTo>
                      <a:lnTo>
                        <a:pt x="1485" y="5"/>
                      </a:lnTo>
                      <a:lnTo>
                        <a:pt x="1485" y="2"/>
                      </a:lnTo>
                      <a:lnTo>
                        <a:pt x="1485" y="7"/>
                      </a:lnTo>
                      <a:lnTo>
                        <a:pt x="1485" y="5"/>
                      </a:lnTo>
                      <a:lnTo>
                        <a:pt x="1486" y="5"/>
                      </a:lnTo>
                      <a:lnTo>
                        <a:pt x="1486" y="2"/>
                      </a:lnTo>
                      <a:lnTo>
                        <a:pt x="1486" y="5"/>
                      </a:lnTo>
                      <a:lnTo>
                        <a:pt x="1486" y="4"/>
                      </a:lnTo>
                      <a:lnTo>
                        <a:pt x="1487" y="4"/>
                      </a:lnTo>
                      <a:lnTo>
                        <a:pt x="1487" y="3"/>
                      </a:lnTo>
                      <a:lnTo>
                        <a:pt x="1487" y="7"/>
                      </a:lnTo>
                      <a:lnTo>
                        <a:pt x="1487" y="7"/>
                      </a:lnTo>
                      <a:lnTo>
                        <a:pt x="1488" y="7"/>
                      </a:lnTo>
                      <a:lnTo>
                        <a:pt x="1488" y="3"/>
                      </a:lnTo>
                      <a:lnTo>
                        <a:pt x="1488" y="7"/>
                      </a:lnTo>
                      <a:lnTo>
                        <a:pt x="1488" y="5"/>
                      </a:lnTo>
                      <a:lnTo>
                        <a:pt x="1489" y="5"/>
                      </a:lnTo>
                      <a:lnTo>
                        <a:pt x="1489" y="2"/>
                      </a:lnTo>
                      <a:lnTo>
                        <a:pt x="1489" y="6"/>
                      </a:lnTo>
                      <a:lnTo>
                        <a:pt x="1489" y="5"/>
                      </a:lnTo>
                      <a:lnTo>
                        <a:pt x="1490" y="5"/>
                      </a:lnTo>
                      <a:lnTo>
                        <a:pt x="1490" y="2"/>
                      </a:lnTo>
                      <a:lnTo>
                        <a:pt x="1490" y="6"/>
                      </a:lnTo>
                      <a:lnTo>
                        <a:pt x="1490" y="2"/>
                      </a:lnTo>
                      <a:lnTo>
                        <a:pt x="1491" y="2"/>
                      </a:lnTo>
                      <a:lnTo>
                        <a:pt x="1491" y="2"/>
                      </a:lnTo>
                      <a:lnTo>
                        <a:pt x="1491" y="5"/>
                      </a:lnTo>
                      <a:lnTo>
                        <a:pt x="1491" y="4"/>
                      </a:lnTo>
                      <a:lnTo>
                        <a:pt x="1492" y="4"/>
                      </a:lnTo>
                      <a:lnTo>
                        <a:pt x="1492" y="3"/>
                      </a:lnTo>
                      <a:lnTo>
                        <a:pt x="1492" y="7"/>
                      </a:lnTo>
                      <a:lnTo>
                        <a:pt x="1492" y="5"/>
                      </a:lnTo>
                      <a:lnTo>
                        <a:pt x="1493" y="5"/>
                      </a:lnTo>
                      <a:lnTo>
                        <a:pt x="1493" y="4"/>
                      </a:lnTo>
                      <a:lnTo>
                        <a:pt x="1493" y="7"/>
                      </a:lnTo>
                      <a:lnTo>
                        <a:pt x="1493" y="4"/>
                      </a:lnTo>
                      <a:lnTo>
                        <a:pt x="1494" y="4"/>
                      </a:lnTo>
                      <a:lnTo>
                        <a:pt x="1494" y="4"/>
                      </a:lnTo>
                      <a:lnTo>
                        <a:pt x="1494" y="7"/>
                      </a:lnTo>
                      <a:lnTo>
                        <a:pt x="1494" y="5"/>
                      </a:lnTo>
                      <a:lnTo>
                        <a:pt x="1495" y="5"/>
                      </a:lnTo>
                      <a:lnTo>
                        <a:pt x="1495" y="4"/>
                      </a:lnTo>
                      <a:lnTo>
                        <a:pt x="1495" y="7"/>
                      </a:lnTo>
                      <a:lnTo>
                        <a:pt x="1495" y="6"/>
                      </a:lnTo>
                      <a:lnTo>
                        <a:pt x="1496" y="6"/>
                      </a:lnTo>
                      <a:lnTo>
                        <a:pt x="1496" y="5"/>
                      </a:lnTo>
                      <a:lnTo>
                        <a:pt x="1496" y="7"/>
                      </a:lnTo>
                      <a:lnTo>
                        <a:pt x="1496" y="6"/>
                      </a:lnTo>
                      <a:lnTo>
                        <a:pt x="1497" y="6"/>
                      </a:lnTo>
                      <a:lnTo>
                        <a:pt x="1497" y="2"/>
                      </a:lnTo>
                      <a:lnTo>
                        <a:pt x="1497" y="7"/>
                      </a:lnTo>
                      <a:lnTo>
                        <a:pt x="1497" y="4"/>
                      </a:lnTo>
                      <a:lnTo>
                        <a:pt x="1498" y="4"/>
                      </a:lnTo>
                      <a:lnTo>
                        <a:pt x="1498" y="4"/>
                      </a:lnTo>
                      <a:lnTo>
                        <a:pt x="1498" y="8"/>
                      </a:lnTo>
                      <a:lnTo>
                        <a:pt x="1498" y="6"/>
                      </a:lnTo>
                      <a:lnTo>
                        <a:pt x="1499" y="6"/>
                      </a:lnTo>
                      <a:lnTo>
                        <a:pt x="1499" y="4"/>
                      </a:lnTo>
                      <a:lnTo>
                        <a:pt x="1499" y="7"/>
                      </a:lnTo>
                      <a:lnTo>
                        <a:pt x="1499" y="4"/>
                      </a:lnTo>
                      <a:lnTo>
                        <a:pt x="1500" y="4"/>
                      </a:lnTo>
                      <a:lnTo>
                        <a:pt x="1500" y="2"/>
                      </a:lnTo>
                      <a:lnTo>
                        <a:pt x="1500" y="6"/>
                      </a:lnTo>
                      <a:lnTo>
                        <a:pt x="1500" y="4"/>
                      </a:lnTo>
                      <a:lnTo>
                        <a:pt x="1501" y="4"/>
                      </a:lnTo>
                      <a:lnTo>
                        <a:pt x="1501" y="4"/>
                      </a:lnTo>
                      <a:lnTo>
                        <a:pt x="1501" y="8"/>
                      </a:lnTo>
                      <a:lnTo>
                        <a:pt x="1501" y="7"/>
                      </a:lnTo>
                      <a:lnTo>
                        <a:pt x="1502" y="7"/>
                      </a:lnTo>
                      <a:lnTo>
                        <a:pt x="1502" y="5"/>
                      </a:lnTo>
                      <a:lnTo>
                        <a:pt x="1502" y="8"/>
                      </a:lnTo>
                      <a:lnTo>
                        <a:pt x="1502" y="7"/>
                      </a:lnTo>
                      <a:lnTo>
                        <a:pt x="1503" y="7"/>
                      </a:lnTo>
                      <a:lnTo>
                        <a:pt x="1503" y="4"/>
                      </a:lnTo>
                      <a:lnTo>
                        <a:pt x="1503" y="8"/>
                      </a:lnTo>
                      <a:lnTo>
                        <a:pt x="1503" y="6"/>
                      </a:lnTo>
                      <a:lnTo>
                        <a:pt x="1504" y="6"/>
                      </a:lnTo>
                      <a:lnTo>
                        <a:pt x="1504" y="4"/>
                      </a:lnTo>
                      <a:lnTo>
                        <a:pt x="1504" y="7"/>
                      </a:lnTo>
                      <a:lnTo>
                        <a:pt x="1504" y="5"/>
                      </a:lnTo>
                      <a:lnTo>
                        <a:pt x="1505" y="5"/>
                      </a:lnTo>
                      <a:lnTo>
                        <a:pt x="1505" y="5"/>
                      </a:lnTo>
                      <a:lnTo>
                        <a:pt x="1505" y="8"/>
                      </a:lnTo>
                      <a:lnTo>
                        <a:pt x="1505" y="6"/>
                      </a:lnTo>
                      <a:lnTo>
                        <a:pt x="1506" y="6"/>
                      </a:lnTo>
                      <a:lnTo>
                        <a:pt x="1506" y="5"/>
                      </a:lnTo>
                      <a:lnTo>
                        <a:pt x="1506" y="8"/>
                      </a:lnTo>
                      <a:lnTo>
                        <a:pt x="1506" y="7"/>
                      </a:lnTo>
                      <a:lnTo>
                        <a:pt x="1507" y="7"/>
                      </a:lnTo>
                      <a:lnTo>
                        <a:pt x="1507" y="5"/>
                      </a:lnTo>
                      <a:lnTo>
                        <a:pt x="1507" y="9"/>
                      </a:lnTo>
                      <a:lnTo>
                        <a:pt x="1507" y="6"/>
                      </a:lnTo>
                      <a:lnTo>
                        <a:pt x="1508" y="6"/>
                      </a:lnTo>
                      <a:lnTo>
                        <a:pt x="1508" y="5"/>
                      </a:lnTo>
                      <a:lnTo>
                        <a:pt x="1508" y="8"/>
                      </a:lnTo>
                      <a:lnTo>
                        <a:pt x="1508" y="5"/>
                      </a:lnTo>
                      <a:lnTo>
                        <a:pt x="1509" y="5"/>
                      </a:lnTo>
                      <a:lnTo>
                        <a:pt x="1509" y="5"/>
                      </a:lnTo>
                      <a:lnTo>
                        <a:pt x="1509" y="8"/>
                      </a:lnTo>
                      <a:lnTo>
                        <a:pt x="1509" y="7"/>
                      </a:lnTo>
                      <a:lnTo>
                        <a:pt x="1510" y="7"/>
                      </a:lnTo>
                      <a:lnTo>
                        <a:pt x="1510" y="5"/>
                      </a:lnTo>
                      <a:lnTo>
                        <a:pt x="1510" y="8"/>
                      </a:lnTo>
                      <a:lnTo>
                        <a:pt x="1510" y="6"/>
                      </a:lnTo>
                      <a:lnTo>
                        <a:pt x="1511" y="6"/>
                      </a:lnTo>
                      <a:lnTo>
                        <a:pt x="1511" y="4"/>
                      </a:lnTo>
                      <a:lnTo>
                        <a:pt x="1511" y="7"/>
                      </a:lnTo>
                      <a:lnTo>
                        <a:pt x="1511" y="7"/>
                      </a:lnTo>
                      <a:lnTo>
                        <a:pt x="1512" y="7"/>
                      </a:lnTo>
                      <a:lnTo>
                        <a:pt x="1512" y="4"/>
                      </a:lnTo>
                      <a:lnTo>
                        <a:pt x="1512" y="7"/>
                      </a:lnTo>
                      <a:lnTo>
                        <a:pt x="1512" y="7"/>
                      </a:lnTo>
                      <a:lnTo>
                        <a:pt x="1513" y="7"/>
                      </a:lnTo>
                      <a:lnTo>
                        <a:pt x="1513" y="5"/>
                      </a:lnTo>
                      <a:lnTo>
                        <a:pt x="1513" y="9"/>
                      </a:lnTo>
                      <a:lnTo>
                        <a:pt x="1513" y="8"/>
                      </a:lnTo>
                      <a:lnTo>
                        <a:pt x="1514" y="8"/>
                      </a:lnTo>
                      <a:lnTo>
                        <a:pt x="1514" y="6"/>
                      </a:lnTo>
                      <a:lnTo>
                        <a:pt x="1514" y="10"/>
                      </a:lnTo>
                      <a:lnTo>
                        <a:pt x="1514" y="6"/>
                      </a:lnTo>
                      <a:lnTo>
                        <a:pt x="1515" y="6"/>
                      </a:lnTo>
                      <a:lnTo>
                        <a:pt x="1515" y="5"/>
                      </a:lnTo>
                      <a:lnTo>
                        <a:pt x="1515" y="8"/>
                      </a:lnTo>
                      <a:lnTo>
                        <a:pt x="1515" y="8"/>
                      </a:lnTo>
                      <a:lnTo>
                        <a:pt x="1516" y="8"/>
                      </a:lnTo>
                      <a:lnTo>
                        <a:pt x="1516" y="6"/>
                      </a:lnTo>
                      <a:lnTo>
                        <a:pt x="1516" y="9"/>
                      </a:lnTo>
                      <a:lnTo>
                        <a:pt x="1516" y="7"/>
                      </a:lnTo>
                      <a:lnTo>
                        <a:pt x="1517" y="7"/>
                      </a:lnTo>
                      <a:lnTo>
                        <a:pt x="1517" y="5"/>
                      </a:lnTo>
                      <a:lnTo>
                        <a:pt x="1517" y="9"/>
                      </a:lnTo>
                      <a:lnTo>
                        <a:pt x="1517" y="6"/>
                      </a:lnTo>
                      <a:lnTo>
                        <a:pt x="1518" y="6"/>
                      </a:lnTo>
                      <a:lnTo>
                        <a:pt x="1518" y="5"/>
                      </a:lnTo>
                      <a:lnTo>
                        <a:pt x="1518" y="8"/>
                      </a:lnTo>
                      <a:lnTo>
                        <a:pt x="1518" y="7"/>
                      </a:lnTo>
                      <a:lnTo>
                        <a:pt x="1519" y="7"/>
                      </a:lnTo>
                      <a:lnTo>
                        <a:pt x="1519" y="6"/>
                      </a:lnTo>
                      <a:lnTo>
                        <a:pt x="1519" y="9"/>
                      </a:lnTo>
                      <a:lnTo>
                        <a:pt x="1519" y="9"/>
                      </a:lnTo>
                      <a:lnTo>
                        <a:pt x="1520" y="9"/>
                      </a:lnTo>
                      <a:lnTo>
                        <a:pt x="1520" y="5"/>
                      </a:lnTo>
                      <a:lnTo>
                        <a:pt x="1520" y="9"/>
                      </a:lnTo>
                      <a:lnTo>
                        <a:pt x="1520" y="8"/>
                      </a:lnTo>
                      <a:lnTo>
                        <a:pt x="1521" y="8"/>
                      </a:lnTo>
                      <a:lnTo>
                        <a:pt x="1521" y="4"/>
                      </a:lnTo>
                      <a:lnTo>
                        <a:pt x="1521" y="7"/>
                      </a:lnTo>
                      <a:lnTo>
                        <a:pt x="1521" y="6"/>
                      </a:lnTo>
                      <a:lnTo>
                        <a:pt x="1522" y="6"/>
                      </a:lnTo>
                      <a:lnTo>
                        <a:pt x="1522" y="5"/>
                      </a:lnTo>
                      <a:lnTo>
                        <a:pt x="1522" y="8"/>
                      </a:lnTo>
                      <a:lnTo>
                        <a:pt x="1522" y="8"/>
                      </a:lnTo>
                      <a:lnTo>
                        <a:pt x="1523" y="8"/>
                      </a:lnTo>
                      <a:lnTo>
                        <a:pt x="1523" y="6"/>
                      </a:lnTo>
                      <a:lnTo>
                        <a:pt x="1523" y="9"/>
                      </a:lnTo>
                      <a:lnTo>
                        <a:pt x="1523" y="6"/>
                      </a:lnTo>
                      <a:lnTo>
                        <a:pt x="1524" y="6"/>
                      </a:lnTo>
                      <a:lnTo>
                        <a:pt x="1524" y="7"/>
                      </a:lnTo>
                      <a:lnTo>
                        <a:pt x="1524" y="9"/>
                      </a:lnTo>
                      <a:lnTo>
                        <a:pt x="1524" y="8"/>
                      </a:lnTo>
                      <a:lnTo>
                        <a:pt x="1525" y="8"/>
                      </a:lnTo>
                      <a:lnTo>
                        <a:pt x="1525" y="7"/>
                      </a:lnTo>
                      <a:lnTo>
                        <a:pt x="1525" y="11"/>
                      </a:lnTo>
                      <a:lnTo>
                        <a:pt x="1525" y="8"/>
                      </a:lnTo>
                      <a:lnTo>
                        <a:pt x="1526" y="8"/>
                      </a:lnTo>
                      <a:lnTo>
                        <a:pt x="1526" y="6"/>
                      </a:lnTo>
                      <a:lnTo>
                        <a:pt x="1526" y="9"/>
                      </a:lnTo>
                      <a:lnTo>
                        <a:pt x="1526" y="7"/>
                      </a:lnTo>
                      <a:lnTo>
                        <a:pt x="1527" y="7"/>
                      </a:lnTo>
                      <a:lnTo>
                        <a:pt x="1527" y="6"/>
                      </a:lnTo>
                      <a:lnTo>
                        <a:pt x="1527" y="9"/>
                      </a:lnTo>
                      <a:lnTo>
                        <a:pt x="1527" y="8"/>
                      </a:lnTo>
                      <a:lnTo>
                        <a:pt x="1528" y="8"/>
                      </a:lnTo>
                      <a:lnTo>
                        <a:pt x="1528" y="7"/>
                      </a:lnTo>
                      <a:lnTo>
                        <a:pt x="1528" y="10"/>
                      </a:lnTo>
                      <a:lnTo>
                        <a:pt x="1528" y="8"/>
                      </a:lnTo>
                      <a:lnTo>
                        <a:pt x="1529" y="8"/>
                      </a:lnTo>
                      <a:lnTo>
                        <a:pt x="1529" y="6"/>
                      </a:lnTo>
                      <a:lnTo>
                        <a:pt x="1529" y="8"/>
                      </a:lnTo>
                      <a:lnTo>
                        <a:pt x="1529" y="8"/>
                      </a:lnTo>
                      <a:lnTo>
                        <a:pt x="1530" y="8"/>
                      </a:lnTo>
                      <a:lnTo>
                        <a:pt x="1530" y="5"/>
                      </a:lnTo>
                      <a:lnTo>
                        <a:pt x="1530" y="10"/>
                      </a:lnTo>
                      <a:lnTo>
                        <a:pt x="1530" y="9"/>
                      </a:lnTo>
                      <a:lnTo>
                        <a:pt x="1531" y="9"/>
                      </a:lnTo>
                      <a:lnTo>
                        <a:pt x="1531" y="7"/>
                      </a:lnTo>
                      <a:lnTo>
                        <a:pt x="1531" y="10"/>
                      </a:lnTo>
                      <a:lnTo>
                        <a:pt x="1531" y="8"/>
                      </a:lnTo>
                      <a:lnTo>
                        <a:pt x="1532" y="8"/>
                      </a:lnTo>
                      <a:lnTo>
                        <a:pt x="1532" y="7"/>
                      </a:lnTo>
                      <a:lnTo>
                        <a:pt x="1532" y="10"/>
                      </a:lnTo>
                      <a:lnTo>
                        <a:pt x="1532" y="7"/>
                      </a:lnTo>
                      <a:lnTo>
                        <a:pt x="1533" y="7"/>
                      </a:lnTo>
                      <a:lnTo>
                        <a:pt x="1533" y="7"/>
                      </a:lnTo>
                      <a:lnTo>
                        <a:pt x="1533" y="10"/>
                      </a:lnTo>
                      <a:lnTo>
                        <a:pt x="1533" y="8"/>
                      </a:lnTo>
                      <a:lnTo>
                        <a:pt x="1534" y="8"/>
                      </a:lnTo>
                      <a:lnTo>
                        <a:pt x="1534" y="8"/>
                      </a:lnTo>
                      <a:lnTo>
                        <a:pt x="1534" y="10"/>
                      </a:lnTo>
                      <a:lnTo>
                        <a:pt x="1534" y="10"/>
                      </a:lnTo>
                      <a:lnTo>
                        <a:pt x="1535" y="10"/>
                      </a:lnTo>
                      <a:lnTo>
                        <a:pt x="1535" y="8"/>
                      </a:lnTo>
                      <a:lnTo>
                        <a:pt x="1535" y="11"/>
                      </a:lnTo>
                      <a:lnTo>
                        <a:pt x="1535" y="10"/>
                      </a:lnTo>
                      <a:lnTo>
                        <a:pt x="1536" y="10"/>
                      </a:lnTo>
                      <a:lnTo>
                        <a:pt x="1536" y="8"/>
                      </a:lnTo>
                      <a:lnTo>
                        <a:pt x="1536" y="11"/>
                      </a:lnTo>
                      <a:lnTo>
                        <a:pt x="1536" y="11"/>
                      </a:lnTo>
                      <a:lnTo>
                        <a:pt x="1537" y="11"/>
                      </a:lnTo>
                      <a:lnTo>
                        <a:pt x="1537" y="9"/>
                      </a:lnTo>
                      <a:lnTo>
                        <a:pt x="1537" y="12"/>
                      </a:lnTo>
                      <a:lnTo>
                        <a:pt x="1537" y="10"/>
                      </a:lnTo>
                      <a:lnTo>
                        <a:pt x="1538" y="10"/>
                      </a:lnTo>
                      <a:lnTo>
                        <a:pt x="1538" y="9"/>
                      </a:lnTo>
                      <a:lnTo>
                        <a:pt x="1538" y="13"/>
                      </a:lnTo>
                      <a:lnTo>
                        <a:pt x="1538" y="12"/>
                      </a:lnTo>
                      <a:lnTo>
                        <a:pt x="1539" y="12"/>
                      </a:lnTo>
                      <a:lnTo>
                        <a:pt x="1539" y="8"/>
                      </a:lnTo>
                      <a:lnTo>
                        <a:pt x="1539" y="12"/>
                      </a:lnTo>
                      <a:lnTo>
                        <a:pt x="1539" y="9"/>
                      </a:lnTo>
                      <a:lnTo>
                        <a:pt x="1540" y="9"/>
                      </a:lnTo>
                      <a:lnTo>
                        <a:pt x="1540" y="9"/>
                      </a:lnTo>
                      <a:lnTo>
                        <a:pt x="1540" y="11"/>
                      </a:lnTo>
                      <a:lnTo>
                        <a:pt x="1540" y="10"/>
                      </a:lnTo>
                      <a:lnTo>
                        <a:pt x="1541" y="10"/>
                      </a:lnTo>
                      <a:lnTo>
                        <a:pt x="1541" y="9"/>
                      </a:lnTo>
                      <a:lnTo>
                        <a:pt x="1541" y="13"/>
                      </a:lnTo>
                      <a:lnTo>
                        <a:pt x="1541" y="10"/>
                      </a:lnTo>
                      <a:lnTo>
                        <a:pt x="1542" y="10"/>
                      </a:lnTo>
                      <a:lnTo>
                        <a:pt x="1542" y="10"/>
                      </a:lnTo>
                      <a:lnTo>
                        <a:pt x="1542" y="13"/>
                      </a:lnTo>
                      <a:lnTo>
                        <a:pt x="1542" y="11"/>
                      </a:lnTo>
                      <a:lnTo>
                        <a:pt x="1543" y="11"/>
                      </a:lnTo>
                      <a:lnTo>
                        <a:pt x="1543" y="10"/>
                      </a:lnTo>
                      <a:lnTo>
                        <a:pt x="1543" y="13"/>
                      </a:lnTo>
                      <a:lnTo>
                        <a:pt x="1543" y="12"/>
                      </a:lnTo>
                      <a:lnTo>
                        <a:pt x="1544" y="12"/>
                      </a:lnTo>
                      <a:lnTo>
                        <a:pt x="1544" y="8"/>
                      </a:lnTo>
                      <a:lnTo>
                        <a:pt x="1544" y="13"/>
                      </a:lnTo>
                      <a:lnTo>
                        <a:pt x="1544" y="10"/>
                      </a:lnTo>
                      <a:lnTo>
                        <a:pt x="1545" y="10"/>
                      </a:lnTo>
                      <a:lnTo>
                        <a:pt x="1545" y="8"/>
                      </a:lnTo>
                      <a:lnTo>
                        <a:pt x="1545" y="12"/>
                      </a:lnTo>
                      <a:lnTo>
                        <a:pt x="1545" y="11"/>
                      </a:lnTo>
                      <a:lnTo>
                        <a:pt x="1546" y="11"/>
                      </a:lnTo>
                      <a:lnTo>
                        <a:pt x="1546" y="11"/>
                      </a:lnTo>
                      <a:lnTo>
                        <a:pt x="1546" y="14"/>
                      </a:lnTo>
                      <a:lnTo>
                        <a:pt x="1546" y="13"/>
                      </a:lnTo>
                      <a:lnTo>
                        <a:pt x="1547" y="13"/>
                      </a:lnTo>
                      <a:lnTo>
                        <a:pt x="1547" y="10"/>
                      </a:lnTo>
                      <a:lnTo>
                        <a:pt x="1547" y="14"/>
                      </a:lnTo>
                      <a:lnTo>
                        <a:pt x="1547" y="13"/>
                      </a:lnTo>
                      <a:lnTo>
                        <a:pt x="1548" y="13"/>
                      </a:lnTo>
                      <a:lnTo>
                        <a:pt x="1548" y="12"/>
                      </a:lnTo>
                      <a:lnTo>
                        <a:pt x="1548" y="14"/>
                      </a:lnTo>
                      <a:lnTo>
                        <a:pt x="1548" y="12"/>
                      </a:lnTo>
                      <a:lnTo>
                        <a:pt x="1549" y="12"/>
                      </a:lnTo>
                      <a:lnTo>
                        <a:pt x="1549" y="12"/>
                      </a:lnTo>
                      <a:lnTo>
                        <a:pt x="1549" y="16"/>
                      </a:lnTo>
                      <a:lnTo>
                        <a:pt x="1549" y="14"/>
                      </a:lnTo>
                      <a:lnTo>
                        <a:pt x="1550" y="14"/>
                      </a:lnTo>
                      <a:lnTo>
                        <a:pt x="1550" y="12"/>
                      </a:lnTo>
                      <a:lnTo>
                        <a:pt x="1550" y="16"/>
                      </a:lnTo>
                      <a:lnTo>
                        <a:pt x="1550" y="13"/>
                      </a:lnTo>
                      <a:lnTo>
                        <a:pt x="1551" y="13"/>
                      </a:lnTo>
                      <a:lnTo>
                        <a:pt x="1551" y="13"/>
                      </a:lnTo>
                      <a:lnTo>
                        <a:pt x="1551" y="16"/>
                      </a:lnTo>
                      <a:lnTo>
                        <a:pt x="1551" y="16"/>
                      </a:lnTo>
                      <a:lnTo>
                        <a:pt x="1552" y="16"/>
                      </a:lnTo>
                      <a:lnTo>
                        <a:pt x="1552" y="13"/>
                      </a:lnTo>
                      <a:lnTo>
                        <a:pt x="1552" y="16"/>
                      </a:lnTo>
                      <a:lnTo>
                        <a:pt x="1552" y="14"/>
                      </a:lnTo>
                      <a:lnTo>
                        <a:pt x="1553" y="14"/>
                      </a:lnTo>
                      <a:lnTo>
                        <a:pt x="1553" y="13"/>
                      </a:lnTo>
                      <a:lnTo>
                        <a:pt x="1553" y="16"/>
                      </a:lnTo>
                      <a:lnTo>
                        <a:pt x="1553" y="13"/>
                      </a:lnTo>
                      <a:lnTo>
                        <a:pt x="1554" y="13"/>
                      </a:lnTo>
                      <a:lnTo>
                        <a:pt x="1554" y="13"/>
                      </a:lnTo>
                      <a:lnTo>
                        <a:pt x="1554" y="16"/>
                      </a:lnTo>
                      <a:lnTo>
                        <a:pt x="1554" y="16"/>
                      </a:lnTo>
                      <a:lnTo>
                        <a:pt x="1555" y="16"/>
                      </a:lnTo>
                      <a:lnTo>
                        <a:pt x="1555" y="13"/>
                      </a:lnTo>
                      <a:lnTo>
                        <a:pt x="1555" y="16"/>
                      </a:lnTo>
                      <a:lnTo>
                        <a:pt x="1555" y="15"/>
                      </a:lnTo>
                      <a:lnTo>
                        <a:pt x="1556" y="15"/>
                      </a:lnTo>
                      <a:lnTo>
                        <a:pt x="1556" y="13"/>
                      </a:lnTo>
                      <a:lnTo>
                        <a:pt x="1556" y="17"/>
                      </a:lnTo>
                      <a:lnTo>
                        <a:pt x="1556" y="14"/>
                      </a:lnTo>
                      <a:lnTo>
                        <a:pt x="1557" y="14"/>
                      </a:lnTo>
                      <a:lnTo>
                        <a:pt x="1557" y="13"/>
                      </a:lnTo>
                      <a:lnTo>
                        <a:pt x="1557" y="16"/>
                      </a:lnTo>
                      <a:lnTo>
                        <a:pt x="1557" y="14"/>
                      </a:lnTo>
                      <a:lnTo>
                        <a:pt x="1558" y="14"/>
                      </a:lnTo>
                      <a:lnTo>
                        <a:pt x="1558" y="12"/>
                      </a:lnTo>
                      <a:lnTo>
                        <a:pt x="1558" y="16"/>
                      </a:lnTo>
                      <a:lnTo>
                        <a:pt x="1558" y="12"/>
                      </a:lnTo>
                      <a:lnTo>
                        <a:pt x="1559" y="12"/>
                      </a:lnTo>
                      <a:lnTo>
                        <a:pt x="1559" y="11"/>
                      </a:lnTo>
                      <a:lnTo>
                        <a:pt x="1559" y="16"/>
                      </a:lnTo>
                      <a:lnTo>
                        <a:pt x="1559" y="16"/>
                      </a:lnTo>
                      <a:lnTo>
                        <a:pt x="1560" y="16"/>
                      </a:lnTo>
                      <a:lnTo>
                        <a:pt x="1560" y="13"/>
                      </a:lnTo>
                      <a:lnTo>
                        <a:pt x="1560" y="17"/>
                      </a:lnTo>
                      <a:lnTo>
                        <a:pt x="1560" y="16"/>
                      </a:lnTo>
                      <a:lnTo>
                        <a:pt x="1561" y="16"/>
                      </a:lnTo>
                      <a:lnTo>
                        <a:pt x="1561" y="12"/>
                      </a:lnTo>
                      <a:lnTo>
                        <a:pt x="1561" y="17"/>
                      </a:lnTo>
                      <a:lnTo>
                        <a:pt x="1561" y="15"/>
                      </a:lnTo>
                      <a:lnTo>
                        <a:pt x="1562" y="15"/>
                      </a:lnTo>
                      <a:lnTo>
                        <a:pt x="1562" y="14"/>
                      </a:lnTo>
                      <a:lnTo>
                        <a:pt x="1562" y="17"/>
                      </a:lnTo>
                      <a:lnTo>
                        <a:pt x="1562" y="16"/>
                      </a:lnTo>
                      <a:lnTo>
                        <a:pt x="1563" y="16"/>
                      </a:lnTo>
                      <a:lnTo>
                        <a:pt x="1563" y="14"/>
                      </a:lnTo>
                      <a:lnTo>
                        <a:pt x="1563" y="18"/>
                      </a:lnTo>
                      <a:lnTo>
                        <a:pt x="1563" y="16"/>
                      </a:lnTo>
                      <a:lnTo>
                        <a:pt x="1564" y="16"/>
                      </a:lnTo>
                      <a:lnTo>
                        <a:pt x="1564" y="14"/>
                      </a:lnTo>
                      <a:lnTo>
                        <a:pt x="1564" y="19"/>
                      </a:lnTo>
                      <a:lnTo>
                        <a:pt x="1564" y="14"/>
                      </a:lnTo>
                      <a:lnTo>
                        <a:pt x="1565" y="14"/>
                      </a:lnTo>
                      <a:lnTo>
                        <a:pt x="1565" y="15"/>
                      </a:lnTo>
                      <a:lnTo>
                        <a:pt x="1565" y="19"/>
                      </a:lnTo>
                      <a:lnTo>
                        <a:pt x="1565" y="17"/>
                      </a:lnTo>
                      <a:lnTo>
                        <a:pt x="1566" y="17"/>
                      </a:lnTo>
                      <a:lnTo>
                        <a:pt x="1566" y="14"/>
                      </a:lnTo>
                      <a:lnTo>
                        <a:pt x="1566" y="17"/>
                      </a:lnTo>
                      <a:lnTo>
                        <a:pt x="1566" y="17"/>
                      </a:lnTo>
                      <a:lnTo>
                        <a:pt x="1567" y="17"/>
                      </a:lnTo>
                      <a:lnTo>
                        <a:pt x="1567" y="15"/>
                      </a:lnTo>
                      <a:lnTo>
                        <a:pt x="1567" y="19"/>
                      </a:lnTo>
                      <a:lnTo>
                        <a:pt x="1567" y="16"/>
                      </a:lnTo>
                      <a:lnTo>
                        <a:pt x="1568" y="16"/>
                      </a:lnTo>
                      <a:lnTo>
                        <a:pt x="1568" y="14"/>
                      </a:lnTo>
                      <a:lnTo>
                        <a:pt x="1568" y="18"/>
                      </a:lnTo>
                      <a:lnTo>
                        <a:pt x="1568" y="17"/>
                      </a:lnTo>
                      <a:lnTo>
                        <a:pt x="1569" y="17"/>
                      </a:lnTo>
                      <a:lnTo>
                        <a:pt x="1569" y="15"/>
                      </a:lnTo>
                      <a:lnTo>
                        <a:pt x="1569" y="19"/>
                      </a:lnTo>
                      <a:lnTo>
                        <a:pt x="1569" y="17"/>
                      </a:lnTo>
                      <a:lnTo>
                        <a:pt x="1570" y="17"/>
                      </a:lnTo>
                      <a:lnTo>
                        <a:pt x="1570" y="14"/>
                      </a:lnTo>
                      <a:lnTo>
                        <a:pt x="1570" y="18"/>
                      </a:lnTo>
                      <a:lnTo>
                        <a:pt x="1570" y="16"/>
                      </a:lnTo>
                      <a:lnTo>
                        <a:pt x="1571" y="16"/>
                      </a:lnTo>
                      <a:lnTo>
                        <a:pt x="1571" y="14"/>
                      </a:lnTo>
                      <a:lnTo>
                        <a:pt x="1571" y="17"/>
                      </a:lnTo>
                      <a:lnTo>
                        <a:pt x="1571" y="17"/>
                      </a:lnTo>
                      <a:lnTo>
                        <a:pt x="1572" y="17"/>
                      </a:lnTo>
                      <a:lnTo>
                        <a:pt x="1572" y="15"/>
                      </a:lnTo>
                      <a:lnTo>
                        <a:pt x="1572" y="18"/>
                      </a:lnTo>
                      <a:lnTo>
                        <a:pt x="1572" y="17"/>
                      </a:lnTo>
                      <a:lnTo>
                        <a:pt x="1573" y="17"/>
                      </a:lnTo>
                      <a:lnTo>
                        <a:pt x="1573" y="17"/>
                      </a:lnTo>
                      <a:lnTo>
                        <a:pt x="1573" y="19"/>
                      </a:lnTo>
                      <a:lnTo>
                        <a:pt x="1573" y="17"/>
                      </a:lnTo>
                      <a:lnTo>
                        <a:pt x="1574" y="17"/>
                      </a:lnTo>
                      <a:lnTo>
                        <a:pt x="1574" y="16"/>
                      </a:lnTo>
                      <a:lnTo>
                        <a:pt x="1574" y="20"/>
                      </a:lnTo>
                      <a:lnTo>
                        <a:pt x="1574" y="17"/>
                      </a:lnTo>
                      <a:lnTo>
                        <a:pt x="1575" y="17"/>
                      </a:lnTo>
                      <a:lnTo>
                        <a:pt x="1575" y="16"/>
                      </a:lnTo>
                      <a:lnTo>
                        <a:pt x="1575" y="20"/>
                      </a:lnTo>
                      <a:lnTo>
                        <a:pt x="1575" y="17"/>
                      </a:lnTo>
                      <a:lnTo>
                        <a:pt x="1576" y="17"/>
                      </a:lnTo>
                      <a:lnTo>
                        <a:pt x="1576" y="17"/>
                      </a:lnTo>
                      <a:lnTo>
                        <a:pt x="1576" y="19"/>
                      </a:lnTo>
                      <a:lnTo>
                        <a:pt x="1576" y="19"/>
                      </a:lnTo>
                      <a:lnTo>
                        <a:pt x="1577" y="19"/>
                      </a:lnTo>
                      <a:lnTo>
                        <a:pt x="1577" y="17"/>
                      </a:lnTo>
                      <a:lnTo>
                        <a:pt x="1577" y="19"/>
                      </a:lnTo>
                      <a:lnTo>
                        <a:pt x="1577" y="17"/>
                      </a:lnTo>
                      <a:lnTo>
                        <a:pt x="1578" y="17"/>
                      </a:lnTo>
                      <a:lnTo>
                        <a:pt x="1578" y="17"/>
                      </a:lnTo>
                      <a:lnTo>
                        <a:pt x="1578" y="20"/>
                      </a:lnTo>
                      <a:lnTo>
                        <a:pt x="1578" y="19"/>
                      </a:lnTo>
                      <a:lnTo>
                        <a:pt x="1579" y="19"/>
                      </a:lnTo>
                      <a:lnTo>
                        <a:pt x="1579" y="17"/>
                      </a:lnTo>
                      <a:lnTo>
                        <a:pt x="1579" y="20"/>
                      </a:lnTo>
                      <a:lnTo>
                        <a:pt x="1579" y="19"/>
                      </a:lnTo>
                      <a:lnTo>
                        <a:pt x="1580" y="19"/>
                      </a:lnTo>
                      <a:lnTo>
                        <a:pt x="1580" y="17"/>
                      </a:lnTo>
                      <a:lnTo>
                        <a:pt x="1580" y="19"/>
                      </a:lnTo>
                      <a:lnTo>
                        <a:pt x="1580" y="19"/>
                      </a:lnTo>
                      <a:lnTo>
                        <a:pt x="1581" y="19"/>
                      </a:lnTo>
                      <a:lnTo>
                        <a:pt x="1581" y="17"/>
                      </a:lnTo>
                      <a:lnTo>
                        <a:pt x="1581" y="20"/>
                      </a:lnTo>
                      <a:lnTo>
                        <a:pt x="1581" y="17"/>
                      </a:lnTo>
                      <a:lnTo>
                        <a:pt x="1582" y="17"/>
                      </a:lnTo>
                      <a:lnTo>
                        <a:pt x="1582" y="16"/>
                      </a:lnTo>
                      <a:lnTo>
                        <a:pt x="1582" y="19"/>
                      </a:lnTo>
                      <a:lnTo>
                        <a:pt x="1582" y="18"/>
                      </a:lnTo>
                      <a:lnTo>
                        <a:pt x="1583" y="18"/>
                      </a:lnTo>
                      <a:lnTo>
                        <a:pt x="1583" y="17"/>
                      </a:lnTo>
                      <a:lnTo>
                        <a:pt x="1583" y="21"/>
                      </a:lnTo>
                      <a:lnTo>
                        <a:pt x="1583" y="19"/>
                      </a:lnTo>
                      <a:lnTo>
                        <a:pt x="1584" y="19"/>
                      </a:lnTo>
                      <a:lnTo>
                        <a:pt x="1584" y="17"/>
                      </a:lnTo>
                      <a:lnTo>
                        <a:pt x="1584" y="20"/>
                      </a:lnTo>
                      <a:lnTo>
                        <a:pt x="1584" y="20"/>
                      </a:lnTo>
                      <a:lnTo>
                        <a:pt x="1585" y="20"/>
                      </a:lnTo>
                      <a:lnTo>
                        <a:pt x="1585" y="17"/>
                      </a:lnTo>
                      <a:lnTo>
                        <a:pt x="1585" y="21"/>
                      </a:lnTo>
                      <a:lnTo>
                        <a:pt x="1585" y="19"/>
                      </a:lnTo>
                      <a:lnTo>
                        <a:pt x="1586" y="19"/>
                      </a:lnTo>
                      <a:lnTo>
                        <a:pt x="1586" y="18"/>
                      </a:lnTo>
                      <a:lnTo>
                        <a:pt x="1586" y="23"/>
                      </a:lnTo>
                      <a:lnTo>
                        <a:pt x="1586" y="20"/>
                      </a:lnTo>
                      <a:lnTo>
                        <a:pt x="1587" y="20"/>
                      </a:lnTo>
                      <a:lnTo>
                        <a:pt x="1587" y="18"/>
                      </a:lnTo>
                      <a:lnTo>
                        <a:pt x="1587" y="21"/>
                      </a:lnTo>
                      <a:lnTo>
                        <a:pt x="1587" y="19"/>
                      </a:lnTo>
                      <a:lnTo>
                        <a:pt x="1588" y="19"/>
                      </a:lnTo>
                      <a:lnTo>
                        <a:pt x="1588" y="17"/>
                      </a:lnTo>
                      <a:lnTo>
                        <a:pt x="1588" y="21"/>
                      </a:lnTo>
                      <a:lnTo>
                        <a:pt x="1588" y="18"/>
                      </a:lnTo>
                      <a:lnTo>
                        <a:pt x="1589" y="18"/>
                      </a:lnTo>
                      <a:lnTo>
                        <a:pt x="1589" y="17"/>
                      </a:lnTo>
                      <a:lnTo>
                        <a:pt x="1589" y="20"/>
                      </a:lnTo>
                      <a:lnTo>
                        <a:pt x="1589" y="20"/>
                      </a:lnTo>
                      <a:lnTo>
                        <a:pt x="1590" y="20"/>
                      </a:lnTo>
                      <a:lnTo>
                        <a:pt x="1590" y="18"/>
                      </a:lnTo>
                      <a:lnTo>
                        <a:pt x="1590" y="20"/>
                      </a:lnTo>
                      <a:lnTo>
                        <a:pt x="1590" y="20"/>
                      </a:lnTo>
                      <a:lnTo>
                        <a:pt x="1591" y="20"/>
                      </a:lnTo>
                      <a:lnTo>
                        <a:pt x="1591" y="19"/>
                      </a:lnTo>
                      <a:lnTo>
                        <a:pt x="1591" y="21"/>
                      </a:lnTo>
                      <a:lnTo>
                        <a:pt x="1591" y="20"/>
                      </a:lnTo>
                      <a:lnTo>
                        <a:pt x="1592" y="20"/>
                      </a:lnTo>
                      <a:lnTo>
                        <a:pt x="1592" y="17"/>
                      </a:lnTo>
                      <a:lnTo>
                        <a:pt x="1592" y="21"/>
                      </a:lnTo>
                      <a:lnTo>
                        <a:pt x="1592" y="18"/>
                      </a:lnTo>
                      <a:lnTo>
                        <a:pt x="1593" y="18"/>
                      </a:lnTo>
                      <a:lnTo>
                        <a:pt x="1593" y="17"/>
                      </a:lnTo>
                      <a:lnTo>
                        <a:pt x="1593" y="20"/>
                      </a:lnTo>
                      <a:lnTo>
                        <a:pt x="1593" y="19"/>
                      </a:lnTo>
                      <a:lnTo>
                        <a:pt x="1594" y="19"/>
                      </a:lnTo>
                      <a:lnTo>
                        <a:pt x="1594" y="18"/>
                      </a:lnTo>
                      <a:lnTo>
                        <a:pt x="1594" y="21"/>
                      </a:lnTo>
                      <a:lnTo>
                        <a:pt x="1594" y="20"/>
                      </a:lnTo>
                      <a:lnTo>
                        <a:pt x="1595" y="20"/>
                      </a:lnTo>
                      <a:lnTo>
                        <a:pt x="1595" y="20"/>
                      </a:lnTo>
                      <a:lnTo>
                        <a:pt x="1595" y="23"/>
                      </a:lnTo>
                      <a:lnTo>
                        <a:pt x="1595" y="20"/>
                      </a:lnTo>
                      <a:lnTo>
                        <a:pt x="1596" y="20"/>
                      </a:lnTo>
                      <a:lnTo>
                        <a:pt x="1596" y="20"/>
                      </a:lnTo>
                      <a:lnTo>
                        <a:pt x="1596" y="23"/>
                      </a:lnTo>
                      <a:lnTo>
                        <a:pt x="1596" y="20"/>
                      </a:lnTo>
                      <a:lnTo>
                        <a:pt x="1597" y="20"/>
                      </a:lnTo>
                      <a:lnTo>
                        <a:pt x="1597" y="19"/>
                      </a:lnTo>
                      <a:lnTo>
                        <a:pt x="1597" y="22"/>
                      </a:lnTo>
                      <a:lnTo>
                        <a:pt x="1597" y="19"/>
                      </a:lnTo>
                      <a:lnTo>
                        <a:pt x="1598" y="19"/>
                      </a:lnTo>
                      <a:lnTo>
                        <a:pt x="1598" y="19"/>
                      </a:lnTo>
                      <a:lnTo>
                        <a:pt x="1598" y="22"/>
                      </a:lnTo>
                      <a:lnTo>
                        <a:pt x="1598" y="22"/>
                      </a:lnTo>
                      <a:lnTo>
                        <a:pt x="1599" y="22"/>
                      </a:lnTo>
                      <a:lnTo>
                        <a:pt x="1599" y="20"/>
                      </a:lnTo>
                      <a:lnTo>
                        <a:pt x="1599" y="25"/>
                      </a:lnTo>
                      <a:lnTo>
                        <a:pt x="1599" y="22"/>
                      </a:lnTo>
                      <a:lnTo>
                        <a:pt x="1600" y="22"/>
                      </a:lnTo>
                      <a:lnTo>
                        <a:pt x="1600" y="20"/>
                      </a:lnTo>
                      <a:lnTo>
                        <a:pt x="1600" y="24"/>
                      </a:lnTo>
                      <a:lnTo>
                        <a:pt x="1600" y="23"/>
                      </a:lnTo>
                      <a:lnTo>
                        <a:pt x="1601" y="23"/>
                      </a:lnTo>
                      <a:lnTo>
                        <a:pt x="1601" y="20"/>
                      </a:lnTo>
                      <a:lnTo>
                        <a:pt x="1601" y="23"/>
                      </a:lnTo>
                      <a:lnTo>
                        <a:pt x="1601" y="23"/>
                      </a:lnTo>
                      <a:lnTo>
                        <a:pt x="1602" y="23"/>
                      </a:lnTo>
                      <a:lnTo>
                        <a:pt x="1602" y="20"/>
                      </a:lnTo>
                      <a:lnTo>
                        <a:pt x="1602" y="23"/>
                      </a:lnTo>
                      <a:lnTo>
                        <a:pt x="1602" y="23"/>
                      </a:lnTo>
                      <a:lnTo>
                        <a:pt x="1603" y="23"/>
                      </a:lnTo>
                      <a:lnTo>
                        <a:pt x="1603" y="19"/>
                      </a:lnTo>
                      <a:lnTo>
                        <a:pt x="1603" y="23"/>
                      </a:lnTo>
                      <a:lnTo>
                        <a:pt x="1603" y="22"/>
                      </a:lnTo>
                      <a:lnTo>
                        <a:pt x="1604" y="22"/>
                      </a:lnTo>
                      <a:lnTo>
                        <a:pt x="1604" y="19"/>
                      </a:lnTo>
                      <a:lnTo>
                        <a:pt x="1604" y="22"/>
                      </a:lnTo>
                      <a:lnTo>
                        <a:pt x="1604" y="19"/>
                      </a:lnTo>
                      <a:lnTo>
                        <a:pt x="1605" y="19"/>
                      </a:lnTo>
                      <a:lnTo>
                        <a:pt x="1605" y="20"/>
                      </a:lnTo>
                      <a:lnTo>
                        <a:pt x="1605" y="23"/>
                      </a:lnTo>
                      <a:lnTo>
                        <a:pt x="1605" y="20"/>
                      </a:lnTo>
                      <a:lnTo>
                        <a:pt x="1606" y="20"/>
                      </a:lnTo>
                      <a:lnTo>
                        <a:pt x="1606" y="21"/>
                      </a:lnTo>
                      <a:lnTo>
                        <a:pt x="1606" y="24"/>
                      </a:lnTo>
                      <a:lnTo>
                        <a:pt x="1606" y="22"/>
                      </a:lnTo>
                      <a:lnTo>
                        <a:pt x="1607" y="22"/>
                      </a:lnTo>
                      <a:lnTo>
                        <a:pt x="1607" y="19"/>
                      </a:lnTo>
                      <a:lnTo>
                        <a:pt x="1607" y="25"/>
                      </a:lnTo>
                      <a:lnTo>
                        <a:pt x="1607" y="23"/>
                      </a:lnTo>
                      <a:lnTo>
                        <a:pt x="1608" y="23"/>
                      </a:lnTo>
                      <a:lnTo>
                        <a:pt x="1608" y="20"/>
                      </a:lnTo>
                      <a:lnTo>
                        <a:pt x="1608" y="24"/>
                      </a:lnTo>
                      <a:lnTo>
                        <a:pt x="1608" y="23"/>
                      </a:lnTo>
                      <a:lnTo>
                        <a:pt x="1609" y="23"/>
                      </a:lnTo>
                      <a:lnTo>
                        <a:pt x="1609" y="23"/>
                      </a:lnTo>
                      <a:lnTo>
                        <a:pt x="1609" y="25"/>
                      </a:lnTo>
                      <a:lnTo>
                        <a:pt x="1609" y="25"/>
                      </a:lnTo>
                      <a:lnTo>
                        <a:pt x="1610" y="25"/>
                      </a:lnTo>
                      <a:lnTo>
                        <a:pt x="1610" y="22"/>
                      </a:lnTo>
                      <a:lnTo>
                        <a:pt x="1610" y="25"/>
                      </a:lnTo>
                      <a:lnTo>
                        <a:pt x="1610" y="25"/>
                      </a:lnTo>
                      <a:lnTo>
                        <a:pt x="1611" y="25"/>
                      </a:lnTo>
                      <a:lnTo>
                        <a:pt x="1611" y="22"/>
                      </a:lnTo>
                      <a:lnTo>
                        <a:pt x="1611" y="25"/>
                      </a:lnTo>
                      <a:lnTo>
                        <a:pt x="1611" y="25"/>
                      </a:lnTo>
                      <a:lnTo>
                        <a:pt x="1612" y="25"/>
                      </a:lnTo>
                      <a:lnTo>
                        <a:pt x="1612" y="22"/>
                      </a:lnTo>
                      <a:lnTo>
                        <a:pt x="1612" y="25"/>
                      </a:lnTo>
                      <a:lnTo>
                        <a:pt x="1612" y="23"/>
                      </a:lnTo>
                      <a:lnTo>
                        <a:pt x="1613" y="23"/>
                      </a:lnTo>
                      <a:lnTo>
                        <a:pt x="1613" y="21"/>
                      </a:lnTo>
                      <a:lnTo>
                        <a:pt x="1613" y="25"/>
                      </a:lnTo>
                      <a:lnTo>
                        <a:pt x="1613" y="22"/>
                      </a:lnTo>
                      <a:lnTo>
                        <a:pt x="1614" y="22"/>
                      </a:lnTo>
                      <a:lnTo>
                        <a:pt x="1614" y="22"/>
                      </a:lnTo>
                      <a:lnTo>
                        <a:pt x="1614" y="25"/>
                      </a:lnTo>
                      <a:lnTo>
                        <a:pt x="1614" y="23"/>
                      </a:lnTo>
                      <a:lnTo>
                        <a:pt x="1615" y="23"/>
                      </a:lnTo>
                      <a:lnTo>
                        <a:pt x="1615" y="23"/>
                      </a:lnTo>
                      <a:lnTo>
                        <a:pt x="1615" y="25"/>
                      </a:lnTo>
                      <a:lnTo>
                        <a:pt x="1615" y="23"/>
                      </a:lnTo>
                      <a:lnTo>
                        <a:pt x="1616" y="23"/>
                      </a:lnTo>
                      <a:lnTo>
                        <a:pt x="1616" y="23"/>
                      </a:lnTo>
                      <a:lnTo>
                        <a:pt x="1616" y="26"/>
                      </a:lnTo>
                      <a:lnTo>
                        <a:pt x="1616" y="26"/>
                      </a:lnTo>
                      <a:lnTo>
                        <a:pt x="1617" y="26"/>
                      </a:lnTo>
                      <a:lnTo>
                        <a:pt x="1617" y="23"/>
                      </a:lnTo>
                      <a:lnTo>
                        <a:pt x="1617" y="28"/>
                      </a:lnTo>
                      <a:lnTo>
                        <a:pt x="1617" y="26"/>
                      </a:lnTo>
                      <a:lnTo>
                        <a:pt x="1618" y="26"/>
                      </a:lnTo>
                      <a:lnTo>
                        <a:pt x="1618" y="23"/>
                      </a:lnTo>
                      <a:lnTo>
                        <a:pt x="1618" y="26"/>
                      </a:lnTo>
                      <a:lnTo>
                        <a:pt x="1618" y="26"/>
                      </a:lnTo>
                      <a:lnTo>
                        <a:pt x="1619" y="26"/>
                      </a:lnTo>
                      <a:lnTo>
                        <a:pt x="1619" y="23"/>
                      </a:lnTo>
                      <a:lnTo>
                        <a:pt x="1619" y="26"/>
                      </a:lnTo>
                      <a:lnTo>
                        <a:pt x="1619" y="25"/>
                      </a:lnTo>
                      <a:lnTo>
                        <a:pt x="1620" y="25"/>
                      </a:lnTo>
                      <a:lnTo>
                        <a:pt x="1620" y="23"/>
                      </a:lnTo>
                      <a:lnTo>
                        <a:pt x="1620" y="26"/>
                      </a:lnTo>
                      <a:lnTo>
                        <a:pt x="1620" y="26"/>
                      </a:lnTo>
                      <a:lnTo>
                        <a:pt x="1621" y="26"/>
                      </a:lnTo>
                      <a:lnTo>
                        <a:pt x="1621" y="24"/>
                      </a:lnTo>
                      <a:lnTo>
                        <a:pt x="1621" y="28"/>
                      </a:lnTo>
                      <a:lnTo>
                        <a:pt x="1621" y="26"/>
                      </a:lnTo>
                      <a:lnTo>
                        <a:pt x="1622" y="26"/>
                      </a:lnTo>
                      <a:lnTo>
                        <a:pt x="1622" y="23"/>
                      </a:lnTo>
                      <a:lnTo>
                        <a:pt x="1622" y="27"/>
                      </a:lnTo>
                      <a:lnTo>
                        <a:pt x="1622" y="25"/>
                      </a:lnTo>
                      <a:lnTo>
                        <a:pt x="1623" y="25"/>
                      </a:lnTo>
                      <a:lnTo>
                        <a:pt x="1623" y="24"/>
                      </a:lnTo>
                      <a:lnTo>
                        <a:pt x="1623" y="27"/>
                      </a:lnTo>
                      <a:lnTo>
                        <a:pt x="1623" y="25"/>
                      </a:lnTo>
                      <a:lnTo>
                        <a:pt x="1624" y="25"/>
                      </a:lnTo>
                      <a:lnTo>
                        <a:pt x="1624" y="25"/>
                      </a:lnTo>
                      <a:lnTo>
                        <a:pt x="1624" y="28"/>
                      </a:lnTo>
                      <a:lnTo>
                        <a:pt x="1624" y="26"/>
                      </a:lnTo>
                      <a:lnTo>
                        <a:pt x="1625" y="26"/>
                      </a:lnTo>
                      <a:lnTo>
                        <a:pt x="1625" y="25"/>
                      </a:lnTo>
                      <a:lnTo>
                        <a:pt x="1625" y="28"/>
                      </a:lnTo>
                      <a:lnTo>
                        <a:pt x="1625" y="26"/>
                      </a:lnTo>
                      <a:lnTo>
                        <a:pt x="1626" y="26"/>
                      </a:lnTo>
                      <a:lnTo>
                        <a:pt x="1626" y="25"/>
                      </a:lnTo>
                      <a:lnTo>
                        <a:pt x="1626" y="29"/>
                      </a:lnTo>
                      <a:lnTo>
                        <a:pt x="1626" y="28"/>
                      </a:lnTo>
                      <a:lnTo>
                        <a:pt x="1627" y="28"/>
                      </a:lnTo>
                      <a:lnTo>
                        <a:pt x="1627" y="25"/>
                      </a:lnTo>
                      <a:lnTo>
                        <a:pt x="1627" y="29"/>
                      </a:lnTo>
                      <a:lnTo>
                        <a:pt x="1627" y="28"/>
                      </a:lnTo>
                      <a:lnTo>
                        <a:pt x="1628" y="28"/>
                      </a:lnTo>
                      <a:lnTo>
                        <a:pt x="1628" y="25"/>
                      </a:lnTo>
                      <a:lnTo>
                        <a:pt x="1628" y="27"/>
                      </a:lnTo>
                      <a:lnTo>
                        <a:pt x="1628" y="27"/>
                      </a:lnTo>
                      <a:lnTo>
                        <a:pt x="1629" y="27"/>
                      </a:lnTo>
                      <a:lnTo>
                        <a:pt x="1629" y="25"/>
                      </a:lnTo>
                      <a:lnTo>
                        <a:pt x="1629" y="28"/>
                      </a:lnTo>
                      <a:lnTo>
                        <a:pt x="1629" y="25"/>
                      </a:lnTo>
                      <a:lnTo>
                        <a:pt x="1630" y="25"/>
                      </a:lnTo>
                      <a:lnTo>
                        <a:pt x="1630" y="25"/>
                      </a:lnTo>
                      <a:lnTo>
                        <a:pt x="1630" y="28"/>
                      </a:lnTo>
                      <a:lnTo>
                        <a:pt x="1630" y="26"/>
                      </a:lnTo>
                      <a:lnTo>
                        <a:pt x="1631" y="26"/>
                      </a:lnTo>
                      <a:lnTo>
                        <a:pt x="1631" y="25"/>
                      </a:lnTo>
                      <a:lnTo>
                        <a:pt x="1631" y="29"/>
                      </a:lnTo>
                      <a:lnTo>
                        <a:pt x="1631" y="28"/>
                      </a:lnTo>
                      <a:lnTo>
                        <a:pt x="1632" y="28"/>
                      </a:lnTo>
                      <a:lnTo>
                        <a:pt x="1632" y="25"/>
                      </a:lnTo>
                      <a:lnTo>
                        <a:pt x="1632" y="29"/>
                      </a:lnTo>
                      <a:lnTo>
                        <a:pt x="1632" y="26"/>
                      </a:lnTo>
                      <a:lnTo>
                        <a:pt x="1633" y="26"/>
                      </a:lnTo>
                      <a:lnTo>
                        <a:pt x="1633" y="24"/>
                      </a:lnTo>
                      <a:lnTo>
                        <a:pt x="1633" y="28"/>
                      </a:lnTo>
                      <a:lnTo>
                        <a:pt x="1633" y="26"/>
                      </a:lnTo>
                      <a:lnTo>
                        <a:pt x="1634" y="26"/>
                      </a:lnTo>
                      <a:lnTo>
                        <a:pt x="1634" y="25"/>
                      </a:lnTo>
                      <a:lnTo>
                        <a:pt x="1634" y="28"/>
                      </a:lnTo>
                      <a:lnTo>
                        <a:pt x="1634" y="28"/>
                      </a:lnTo>
                      <a:lnTo>
                        <a:pt x="1635" y="28"/>
                      </a:lnTo>
                      <a:lnTo>
                        <a:pt x="1635" y="26"/>
                      </a:lnTo>
                      <a:lnTo>
                        <a:pt x="1635" y="30"/>
                      </a:lnTo>
                      <a:lnTo>
                        <a:pt x="1635" y="29"/>
                      </a:lnTo>
                      <a:lnTo>
                        <a:pt x="1636" y="29"/>
                      </a:lnTo>
                      <a:lnTo>
                        <a:pt x="1636" y="26"/>
                      </a:lnTo>
                      <a:lnTo>
                        <a:pt x="1636" y="29"/>
                      </a:lnTo>
                      <a:lnTo>
                        <a:pt x="1636" y="29"/>
                      </a:lnTo>
                      <a:lnTo>
                        <a:pt x="1637" y="29"/>
                      </a:lnTo>
                      <a:lnTo>
                        <a:pt x="1637" y="26"/>
                      </a:lnTo>
                      <a:lnTo>
                        <a:pt x="1637" y="30"/>
                      </a:lnTo>
                      <a:lnTo>
                        <a:pt x="1637" y="28"/>
                      </a:lnTo>
                      <a:lnTo>
                        <a:pt x="1638" y="28"/>
                      </a:lnTo>
                      <a:lnTo>
                        <a:pt x="1638" y="28"/>
                      </a:lnTo>
                      <a:lnTo>
                        <a:pt x="1638" y="31"/>
                      </a:lnTo>
                      <a:lnTo>
                        <a:pt x="1638" y="29"/>
                      </a:lnTo>
                      <a:lnTo>
                        <a:pt x="1639" y="29"/>
                      </a:lnTo>
                      <a:lnTo>
                        <a:pt x="1639" y="28"/>
                      </a:lnTo>
                      <a:lnTo>
                        <a:pt x="1639" y="31"/>
                      </a:lnTo>
                      <a:lnTo>
                        <a:pt x="1639" y="28"/>
                      </a:lnTo>
                      <a:lnTo>
                        <a:pt x="1640" y="28"/>
                      </a:lnTo>
                      <a:lnTo>
                        <a:pt x="1640" y="26"/>
                      </a:lnTo>
                      <a:lnTo>
                        <a:pt x="1640" y="30"/>
                      </a:lnTo>
                      <a:lnTo>
                        <a:pt x="1640" y="29"/>
                      </a:lnTo>
                      <a:lnTo>
                        <a:pt x="1641" y="29"/>
                      </a:lnTo>
                      <a:lnTo>
                        <a:pt x="1641" y="27"/>
                      </a:lnTo>
                      <a:lnTo>
                        <a:pt x="1641" y="30"/>
                      </a:lnTo>
                      <a:lnTo>
                        <a:pt x="1641" y="29"/>
                      </a:lnTo>
                      <a:lnTo>
                        <a:pt x="1642" y="29"/>
                      </a:lnTo>
                      <a:lnTo>
                        <a:pt x="1642" y="27"/>
                      </a:lnTo>
                      <a:lnTo>
                        <a:pt x="1642" y="29"/>
                      </a:lnTo>
                      <a:lnTo>
                        <a:pt x="1642" y="29"/>
                      </a:lnTo>
                      <a:lnTo>
                        <a:pt x="1643" y="29"/>
                      </a:lnTo>
                      <a:lnTo>
                        <a:pt x="1643" y="28"/>
                      </a:lnTo>
                      <a:lnTo>
                        <a:pt x="1643" y="30"/>
                      </a:lnTo>
                      <a:lnTo>
                        <a:pt x="1643" y="30"/>
                      </a:lnTo>
                      <a:lnTo>
                        <a:pt x="1644" y="30"/>
                      </a:lnTo>
                      <a:lnTo>
                        <a:pt x="1644" y="28"/>
                      </a:lnTo>
                      <a:lnTo>
                        <a:pt x="1644" y="31"/>
                      </a:lnTo>
                      <a:lnTo>
                        <a:pt x="1644" y="29"/>
                      </a:lnTo>
                      <a:lnTo>
                        <a:pt x="1645" y="29"/>
                      </a:lnTo>
                      <a:lnTo>
                        <a:pt x="1645" y="28"/>
                      </a:lnTo>
                      <a:lnTo>
                        <a:pt x="1645" y="30"/>
                      </a:lnTo>
                      <a:lnTo>
                        <a:pt x="1645" y="28"/>
                      </a:lnTo>
                      <a:lnTo>
                        <a:pt x="1646" y="28"/>
                      </a:lnTo>
                      <a:lnTo>
                        <a:pt x="1646" y="26"/>
                      </a:lnTo>
                      <a:lnTo>
                        <a:pt x="1646" y="31"/>
                      </a:lnTo>
                      <a:lnTo>
                        <a:pt x="1646" y="27"/>
                      </a:lnTo>
                      <a:lnTo>
                        <a:pt x="1647" y="27"/>
                      </a:lnTo>
                      <a:lnTo>
                        <a:pt x="1647" y="27"/>
                      </a:lnTo>
                      <a:lnTo>
                        <a:pt x="1647" y="31"/>
                      </a:lnTo>
                      <a:lnTo>
                        <a:pt x="1647" y="29"/>
                      </a:lnTo>
                      <a:lnTo>
                        <a:pt x="1648" y="29"/>
                      </a:lnTo>
                      <a:lnTo>
                        <a:pt x="1648" y="29"/>
                      </a:lnTo>
                      <a:lnTo>
                        <a:pt x="1648" y="31"/>
                      </a:lnTo>
                      <a:lnTo>
                        <a:pt x="1648" y="29"/>
                      </a:lnTo>
                      <a:lnTo>
                        <a:pt x="1649" y="29"/>
                      </a:lnTo>
                      <a:lnTo>
                        <a:pt x="1649" y="29"/>
                      </a:lnTo>
                      <a:lnTo>
                        <a:pt x="1649" y="32"/>
                      </a:lnTo>
                      <a:lnTo>
                        <a:pt x="1649" y="32"/>
                      </a:lnTo>
                      <a:lnTo>
                        <a:pt x="1650" y="32"/>
                      </a:lnTo>
                      <a:lnTo>
                        <a:pt x="1650" y="29"/>
                      </a:lnTo>
                      <a:lnTo>
                        <a:pt x="1650" y="34"/>
                      </a:lnTo>
                      <a:lnTo>
                        <a:pt x="1650" y="32"/>
                      </a:lnTo>
                      <a:lnTo>
                        <a:pt x="1651" y="32"/>
                      </a:lnTo>
                      <a:lnTo>
                        <a:pt x="1651" y="29"/>
                      </a:lnTo>
                      <a:lnTo>
                        <a:pt x="1651" y="32"/>
                      </a:lnTo>
                      <a:lnTo>
                        <a:pt x="1651" y="31"/>
                      </a:lnTo>
                      <a:lnTo>
                        <a:pt x="1652" y="31"/>
                      </a:lnTo>
                      <a:lnTo>
                        <a:pt x="1652" y="29"/>
                      </a:lnTo>
                      <a:lnTo>
                        <a:pt x="1652" y="33"/>
                      </a:lnTo>
                      <a:lnTo>
                        <a:pt x="1652" y="33"/>
                      </a:lnTo>
                      <a:lnTo>
                        <a:pt x="1653" y="33"/>
                      </a:lnTo>
                      <a:lnTo>
                        <a:pt x="1653" y="31"/>
                      </a:lnTo>
                      <a:lnTo>
                        <a:pt x="1653" y="35"/>
                      </a:lnTo>
                      <a:lnTo>
                        <a:pt x="1653" y="31"/>
                      </a:lnTo>
                      <a:lnTo>
                        <a:pt x="1654" y="31"/>
                      </a:lnTo>
                      <a:lnTo>
                        <a:pt x="1654" y="31"/>
                      </a:lnTo>
                      <a:lnTo>
                        <a:pt x="1654" y="33"/>
                      </a:lnTo>
                      <a:lnTo>
                        <a:pt x="1654" y="32"/>
                      </a:lnTo>
                      <a:lnTo>
                        <a:pt x="1655" y="32"/>
                      </a:lnTo>
                      <a:lnTo>
                        <a:pt x="1655" y="30"/>
                      </a:lnTo>
                      <a:lnTo>
                        <a:pt x="1655" y="32"/>
                      </a:lnTo>
                      <a:lnTo>
                        <a:pt x="1655" y="31"/>
                      </a:lnTo>
                      <a:lnTo>
                        <a:pt x="1656" y="31"/>
                      </a:lnTo>
                      <a:lnTo>
                        <a:pt x="1656" y="30"/>
                      </a:lnTo>
                      <a:lnTo>
                        <a:pt x="1656" y="33"/>
                      </a:lnTo>
                      <a:lnTo>
                        <a:pt x="1656" y="31"/>
                      </a:lnTo>
                      <a:lnTo>
                        <a:pt x="1657" y="31"/>
                      </a:lnTo>
                      <a:lnTo>
                        <a:pt x="1657" y="29"/>
                      </a:lnTo>
                      <a:lnTo>
                        <a:pt x="1657" y="32"/>
                      </a:lnTo>
                      <a:lnTo>
                        <a:pt x="1657" y="32"/>
                      </a:lnTo>
                      <a:lnTo>
                        <a:pt x="1658" y="32"/>
                      </a:lnTo>
                      <a:lnTo>
                        <a:pt x="1658" y="31"/>
                      </a:lnTo>
                      <a:lnTo>
                        <a:pt x="1658" y="33"/>
                      </a:lnTo>
                      <a:lnTo>
                        <a:pt x="1658" y="33"/>
                      </a:lnTo>
                      <a:lnTo>
                        <a:pt x="1659" y="33"/>
                      </a:lnTo>
                      <a:lnTo>
                        <a:pt x="1659" y="31"/>
                      </a:lnTo>
                      <a:lnTo>
                        <a:pt x="1659" y="34"/>
                      </a:lnTo>
                      <a:lnTo>
                        <a:pt x="1659" y="32"/>
                      </a:lnTo>
                      <a:lnTo>
                        <a:pt x="1660" y="32"/>
                      </a:lnTo>
                      <a:lnTo>
                        <a:pt x="1660" y="31"/>
                      </a:lnTo>
                      <a:lnTo>
                        <a:pt x="1660" y="34"/>
                      </a:lnTo>
                      <a:lnTo>
                        <a:pt x="1660" y="33"/>
                      </a:lnTo>
                      <a:lnTo>
                        <a:pt x="1661" y="33"/>
                      </a:lnTo>
                      <a:lnTo>
                        <a:pt x="1661" y="32"/>
                      </a:lnTo>
                      <a:lnTo>
                        <a:pt x="1661" y="35"/>
                      </a:lnTo>
                      <a:lnTo>
                        <a:pt x="1661" y="33"/>
                      </a:lnTo>
                      <a:lnTo>
                        <a:pt x="1662" y="33"/>
                      </a:lnTo>
                      <a:lnTo>
                        <a:pt x="1662" y="31"/>
                      </a:lnTo>
                      <a:lnTo>
                        <a:pt x="1662" y="35"/>
                      </a:lnTo>
                      <a:lnTo>
                        <a:pt x="1662" y="32"/>
                      </a:lnTo>
                      <a:lnTo>
                        <a:pt x="1663" y="32"/>
                      </a:lnTo>
                      <a:lnTo>
                        <a:pt x="1663" y="32"/>
                      </a:lnTo>
                      <a:lnTo>
                        <a:pt x="1663" y="34"/>
                      </a:lnTo>
                      <a:lnTo>
                        <a:pt x="1663" y="34"/>
                      </a:lnTo>
                      <a:lnTo>
                        <a:pt x="1664" y="34"/>
                      </a:lnTo>
                      <a:lnTo>
                        <a:pt x="1664" y="32"/>
                      </a:lnTo>
                      <a:lnTo>
                        <a:pt x="1664" y="36"/>
                      </a:lnTo>
                      <a:lnTo>
                        <a:pt x="1664" y="32"/>
                      </a:lnTo>
                      <a:lnTo>
                        <a:pt x="1665" y="32"/>
                      </a:lnTo>
                      <a:lnTo>
                        <a:pt x="1665" y="31"/>
                      </a:lnTo>
                      <a:lnTo>
                        <a:pt x="1665" y="35"/>
                      </a:lnTo>
                      <a:lnTo>
                        <a:pt x="1665" y="32"/>
                      </a:lnTo>
                      <a:lnTo>
                        <a:pt x="1666" y="32"/>
                      </a:lnTo>
                      <a:lnTo>
                        <a:pt x="1666" y="29"/>
                      </a:lnTo>
                      <a:lnTo>
                        <a:pt x="1666" y="34"/>
                      </a:lnTo>
                      <a:lnTo>
                        <a:pt x="1666" y="32"/>
                      </a:lnTo>
                      <a:lnTo>
                        <a:pt x="1667" y="32"/>
                      </a:lnTo>
                      <a:lnTo>
                        <a:pt x="1667" y="31"/>
                      </a:lnTo>
                      <a:lnTo>
                        <a:pt x="1667" y="35"/>
                      </a:lnTo>
                      <a:lnTo>
                        <a:pt x="1667" y="34"/>
                      </a:lnTo>
                      <a:lnTo>
                        <a:pt x="1668" y="34"/>
                      </a:lnTo>
                      <a:lnTo>
                        <a:pt x="1668" y="30"/>
                      </a:lnTo>
                      <a:lnTo>
                        <a:pt x="1668" y="34"/>
                      </a:lnTo>
                      <a:lnTo>
                        <a:pt x="1668" y="32"/>
                      </a:lnTo>
                      <a:lnTo>
                        <a:pt x="1669" y="32"/>
                      </a:lnTo>
                      <a:lnTo>
                        <a:pt x="1669" y="29"/>
                      </a:lnTo>
                      <a:lnTo>
                        <a:pt x="1669" y="34"/>
                      </a:lnTo>
                      <a:lnTo>
                        <a:pt x="1669" y="33"/>
                      </a:lnTo>
                      <a:lnTo>
                        <a:pt x="1670" y="33"/>
                      </a:lnTo>
                      <a:lnTo>
                        <a:pt x="1670" y="29"/>
                      </a:lnTo>
                      <a:lnTo>
                        <a:pt x="1670" y="34"/>
                      </a:lnTo>
                      <a:lnTo>
                        <a:pt x="1670" y="33"/>
                      </a:lnTo>
                      <a:lnTo>
                        <a:pt x="1671" y="33"/>
                      </a:lnTo>
                      <a:lnTo>
                        <a:pt x="1671" y="34"/>
                      </a:lnTo>
                      <a:lnTo>
                        <a:pt x="1671" y="35"/>
                      </a:lnTo>
                      <a:lnTo>
                        <a:pt x="1671" y="34"/>
                      </a:lnTo>
                      <a:lnTo>
                        <a:pt x="1672" y="34"/>
                      </a:lnTo>
                      <a:lnTo>
                        <a:pt x="1672" y="33"/>
                      </a:lnTo>
                      <a:lnTo>
                        <a:pt x="1672" y="37"/>
                      </a:lnTo>
                      <a:lnTo>
                        <a:pt x="1672" y="33"/>
                      </a:lnTo>
                      <a:lnTo>
                        <a:pt x="1673" y="33"/>
                      </a:lnTo>
                      <a:lnTo>
                        <a:pt x="1673" y="32"/>
                      </a:lnTo>
                      <a:lnTo>
                        <a:pt x="1673" y="35"/>
                      </a:lnTo>
                      <a:lnTo>
                        <a:pt x="1673" y="32"/>
                      </a:lnTo>
                      <a:lnTo>
                        <a:pt x="1674" y="32"/>
                      </a:lnTo>
                      <a:lnTo>
                        <a:pt x="1674" y="31"/>
                      </a:lnTo>
                      <a:lnTo>
                        <a:pt x="1674" y="34"/>
                      </a:lnTo>
                      <a:lnTo>
                        <a:pt x="1674" y="34"/>
                      </a:lnTo>
                      <a:lnTo>
                        <a:pt x="1675" y="34"/>
                      </a:lnTo>
                      <a:lnTo>
                        <a:pt x="1675" y="32"/>
                      </a:lnTo>
                      <a:lnTo>
                        <a:pt x="1675" y="34"/>
                      </a:lnTo>
                      <a:lnTo>
                        <a:pt x="1675" y="34"/>
                      </a:lnTo>
                      <a:lnTo>
                        <a:pt x="1676" y="34"/>
                      </a:lnTo>
                      <a:lnTo>
                        <a:pt x="1676" y="32"/>
                      </a:lnTo>
                      <a:lnTo>
                        <a:pt x="1676" y="35"/>
                      </a:lnTo>
                      <a:lnTo>
                        <a:pt x="1676" y="35"/>
                      </a:lnTo>
                      <a:lnTo>
                        <a:pt x="1677" y="35"/>
                      </a:lnTo>
                      <a:lnTo>
                        <a:pt x="1677" y="33"/>
                      </a:lnTo>
                      <a:lnTo>
                        <a:pt x="1677" y="36"/>
                      </a:lnTo>
                      <a:lnTo>
                        <a:pt x="1677" y="34"/>
                      </a:lnTo>
                      <a:lnTo>
                        <a:pt x="1678" y="34"/>
                      </a:lnTo>
                      <a:lnTo>
                        <a:pt x="1678" y="33"/>
                      </a:lnTo>
                      <a:lnTo>
                        <a:pt x="1678" y="36"/>
                      </a:lnTo>
                      <a:lnTo>
                        <a:pt x="1678" y="35"/>
                      </a:lnTo>
                      <a:lnTo>
                        <a:pt x="1679" y="35"/>
                      </a:lnTo>
                      <a:lnTo>
                        <a:pt x="1679" y="34"/>
                      </a:lnTo>
                      <a:lnTo>
                        <a:pt x="1679" y="36"/>
                      </a:lnTo>
                      <a:lnTo>
                        <a:pt x="1679" y="35"/>
                      </a:lnTo>
                      <a:lnTo>
                        <a:pt x="1680" y="35"/>
                      </a:lnTo>
                      <a:lnTo>
                        <a:pt x="1680" y="33"/>
                      </a:lnTo>
                      <a:lnTo>
                        <a:pt x="1680" y="35"/>
                      </a:lnTo>
                      <a:lnTo>
                        <a:pt x="1680" y="35"/>
                      </a:lnTo>
                      <a:lnTo>
                        <a:pt x="1681" y="35"/>
                      </a:lnTo>
                      <a:lnTo>
                        <a:pt x="1681" y="34"/>
                      </a:lnTo>
                      <a:lnTo>
                        <a:pt x="1681" y="36"/>
                      </a:lnTo>
                      <a:lnTo>
                        <a:pt x="1681" y="36"/>
                      </a:lnTo>
                      <a:lnTo>
                        <a:pt x="1682" y="36"/>
                      </a:lnTo>
                      <a:lnTo>
                        <a:pt x="1682" y="34"/>
                      </a:lnTo>
                      <a:lnTo>
                        <a:pt x="1682" y="37"/>
                      </a:lnTo>
                      <a:lnTo>
                        <a:pt x="1682" y="37"/>
                      </a:lnTo>
                      <a:lnTo>
                        <a:pt x="1683" y="37"/>
                      </a:lnTo>
                      <a:lnTo>
                        <a:pt x="1683" y="34"/>
                      </a:lnTo>
                      <a:lnTo>
                        <a:pt x="1683" y="38"/>
                      </a:lnTo>
                      <a:lnTo>
                        <a:pt x="1683" y="35"/>
                      </a:lnTo>
                      <a:lnTo>
                        <a:pt x="1684" y="35"/>
                      </a:lnTo>
                      <a:lnTo>
                        <a:pt x="1684" y="32"/>
                      </a:lnTo>
                      <a:lnTo>
                        <a:pt x="1684" y="36"/>
                      </a:lnTo>
                      <a:lnTo>
                        <a:pt x="1684" y="35"/>
                      </a:lnTo>
                      <a:lnTo>
                        <a:pt x="1685" y="35"/>
                      </a:lnTo>
                      <a:lnTo>
                        <a:pt x="1685" y="34"/>
                      </a:lnTo>
                      <a:lnTo>
                        <a:pt x="1685" y="37"/>
                      </a:lnTo>
                      <a:lnTo>
                        <a:pt x="1685" y="36"/>
                      </a:lnTo>
                      <a:lnTo>
                        <a:pt x="1686" y="36"/>
                      </a:lnTo>
                      <a:lnTo>
                        <a:pt x="1686" y="34"/>
                      </a:lnTo>
                      <a:lnTo>
                        <a:pt x="1686" y="37"/>
                      </a:lnTo>
                      <a:lnTo>
                        <a:pt x="1686" y="35"/>
                      </a:lnTo>
                      <a:lnTo>
                        <a:pt x="1687" y="35"/>
                      </a:lnTo>
                      <a:lnTo>
                        <a:pt x="1687" y="34"/>
                      </a:lnTo>
                      <a:lnTo>
                        <a:pt x="1687" y="37"/>
                      </a:lnTo>
                      <a:lnTo>
                        <a:pt x="1687" y="35"/>
                      </a:lnTo>
                      <a:lnTo>
                        <a:pt x="1688" y="35"/>
                      </a:lnTo>
                      <a:lnTo>
                        <a:pt x="1688" y="34"/>
                      </a:lnTo>
                      <a:lnTo>
                        <a:pt x="1688" y="38"/>
                      </a:lnTo>
                      <a:lnTo>
                        <a:pt x="1688" y="36"/>
                      </a:lnTo>
                      <a:lnTo>
                        <a:pt x="1689" y="36"/>
                      </a:lnTo>
                      <a:lnTo>
                        <a:pt x="1689" y="35"/>
                      </a:lnTo>
                      <a:lnTo>
                        <a:pt x="1689" y="38"/>
                      </a:lnTo>
                      <a:lnTo>
                        <a:pt x="1689" y="37"/>
                      </a:lnTo>
                      <a:lnTo>
                        <a:pt x="1690" y="37"/>
                      </a:lnTo>
                      <a:lnTo>
                        <a:pt x="1690" y="33"/>
                      </a:lnTo>
                      <a:lnTo>
                        <a:pt x="1690" y="37"/>
                      </a:lnTo>
                      <a:lnTo>
                        <a:pt x="1690" y="35"/>
                      </a:lnTo>
                      <a:lnTo>
                        <a:pt x="1691" y="35"/>
                      </a:lnTo>
                      <a:lnTo>
                        <a:pt x="1691" y="34"/>
                      </a:lnTo>
                      <a:lnTo>
                        <a:pt x="1691" y="37"/>
                      </a:lnTo>
                      <a:lnTo>
                        <a:pt x="1691" y="37"/>
                      </a:lnTo>
                      <a:lnTo>
                        <a:pt x="1692" y="37"/>
                      </a:lnTo>
                      <a:lnTo>
                        <a:pt x="1692" y="32"/>
                      </a:lnTo>
                      <a:lnTo>
                        <a:pt x="1692" y="37"/>
                      </a:lnTo>
                      <a:lnTo>
                        <a:pt x="1692" y="36"/>
                      </a:lnTo>
                      <a:lnTo>
                        <a:pt x="1693" y="36"/>
                      </a:lnTo>
                      <a:lnTo>
                        <a:pt x="1693" y="33"/>
                      </a:lnTo>
                      <a:lnTo>
                        <a:pt x="1693" y="37"/>
                      </a:lnTo>
                      <a:lnTo>
                        <a:pt x="1693" y="35"/>
                      </a:lnTo>
                      <a:lnTo>
                        <a:pt x="1694" y="35"/>
                      </a:lnTo>
                      <a:lnTo>
                        <a:pt x="1694" y="34"/>
                      </a:lnTo>
                      <a:lnTo>
                        <a:pt x="1694" y="38"/>
                      </a:lnTo>
                      <a:lnTo>
                        <a:pt x="1694" y="36"/>
                      </a:lnTo>
                      <a:lnTo>
                        <a:pt x="1695" y="36"/>
                      </a:lnTo>
                      <a:lnTo>
                        <a:pt x="1695" y="35"/>
                      </a:lnTo>
                      <a:lnTo>
                        <a:pt x="1695" y="37"/>
                      </a:lnTo>
                      <a:lnTo>
                        <a:pt x="1695" y="35"/>
                      </a:lnTo>
                      <a:lnTo>
                        <a:pt x="1696" y="35"/>
                      </a:lnTo>
                      <a:lnTo>
                        <a:pt x="1696" y="35"/>
                      </a:lnTo>
                      <a:lnTo>
                        <a:pt x="1696" y="38"/>
                      </a:lnTo>
                      <a:lnTo>
                        <a:pt x="1696" y="38"/>
                      </a:lnTo>
                      <a:lnTo>
                        <a:pt x="1697" y="38"/>
                      </a:lnTo>
                      <a:lnTo>
                        <a:pt x="1697" y="35"/>
                      </a:lnTo>
                      <a:lnTo>
                        <a:pt x="1697" y="38"/>
                      </a:lnTo>
                      <a:lnTo>
                        <a:pt x="1697" y="35"/>
                      </a:lnTo>
                      <a:lnTo>
                        <a:pt x="1698" y="35"/>
                      </a:lnTo>
                      <a:lnTo>
                        <a:pt x="1698" y="35"/>
                      </a:lnTo>
                      <a:lnTo>
                        <a:pt x="1698" y="38"/>
                      </a:lnTo>
                      <a:lnTo>
                        <a:pt x="1698" y="36"/>
                      </a:lnTo>
                      <a:lnTo>
                        <a:pt x="1699" y="36"/>
                      </a:lnTo>
                      <a:lnTo>
                        <a:pt x="1699" y="36"/>
                      </a:lnTo>
                      <a:lnTo>
                        <a:pt x="1699" y="39"/>
                      </a:lnTo>
                      <a:lnTo>
                        <a:pt x="1699" y="37"/>
                      </a:lnTo>
                      <a:lnTo>
                        <a:pt x="1700" y="37"/>
                      </a:lnTo>
                      <a:lnTo>
                        <a:pt x="1700" y="35"/>
                      </a:lnTo>
                      <a:lnTo>
                        <a:pt x="1700" y="39"/>
                      </a:lnTo>
                      <a:lnTo>
                        <a:pt x="1700" y="37"/>
                      </a:lnTo>
                      <a:lnTo>
                        <a:pt x="1701" y="37"/>
                      </a:lnTo>
                      <a:lnTo>
                        <a:pt x="1701" y="35"/>
                      </a:lnTo>
                      <a:lnTo>
                        <a:pt x="1701" y="38"/>
                      </a:lnTo>
                      <a:lnTo>
                        <a:pt x="1701" y="37"/>
                      </a:lnTo>
                      <a:lnTo>
                        <a:pt x="1702" y="37"/>
                      </a:lnTo>
                      <a:lnTo>
                        <a:pt x="1702" y="36"/>
                      </a:lnTo>
                      <a:lnTo>
                        <a:pt x="1702" y="38"/>
                      </a:lnTo>
                      <a:lnTo>
                        <a:pt x="1702" y="38"/>
                      </a:lnTo>
                      <a:lnTo>
                        <a:pt x="1703" y="38"/>
                      </a:lnTo>
                      <a:lnTo>
                        <a:pt x="1703" y="37"/>
                      </a:lnTo>
                      <a:lnTo>
                        <a:pt x="1703" y="39"/>
                      </a:lnTo>
                      <a:lnTo>
                        <a:pt x="1703" y="37"/>
                      </a:lnTo>
                      <a:lnTo>
                        <a:pt x="1704" y="37"/>
                      </a:lnTo>
                      <a:lnTo>
                        <a:pt x="1704" y="34"/>
                      </a:lnTo>
                      <a:lnTo>
                        <a:pt x="1704" y="38"/>
                      </a:lnTo>
                      <a:lnTo>
                        <a:pt x="1704" y="35"/>
                      </a:lnTo>
                      <a:lnTo>
                        <a:pt x="1705" y="35"/>
                      </a:lnTo>
                      <a:lnTo>
                        <a:pt x="1705" y="35"/>
                      </a:lnTo>
                      <a:lnTo>
                        <a:pt x="1705" y="37"/>
                      </a:lnTo>
                      <a:lnTo>
                        <a:pt x="1705" y="37"/>
                      </a:lnTo>
                      <a:lnTo>
                        <a:pt x="1706" y="37"/>
                      </a:lnTo>
                      <a:lnTo>
                        <a:pt x="1706" y="36"/>
                      </a:lnTo>
                      <a:lnTo>
                        <a:pt x="1706" y="40"/>
                      </a:lnTo>
                      <a:lnTo>
                        <a:pt x="1706" y="37"/>
                      </a:lnTo>
                      <a:lnTo>
                        <a:pt x="1707" y="37"/>
                      </a:lnTo>
                      <a:lnTo>
                        <a:pt x="1707" y="36"/>
                      </a:lnTo>
                      <a:lnTo>
                        <a:pt x="1707" y="40"/>
                      </a:lnTo>
                      <a:lnTo>
                        <a:pt x="1707" y="38"/>
                      </a:lnTo>
                      <a:lnTo>
                        <a:pt x="1708" y="38"/>
                      </a:lnTo>
                      <a:lnTo>
                        <a:pt x="1708" y="35"/>
                      </a:lnTo>
                      <a:lnTo>
                        <a:pt x="1708" y="38"/>
                      </a:lnTo>
                      <a:lnTo>
                        <a:pt x="1708" y="37"/>
                      </a:lnTo>
                      <a:lnTo>
                        <a:pt x="1709" y="37"/>
                      </a:lnTo>
                      <a:lnTo>
                        <a:pt x="1709" y="35"/>
                      </a:lnTo>
                      <a:lnTo>
                        <a:pt x="1709" y="38"/>
                      </a:lnTo>
                      <a:lnTo>
                        <a:pt x="1709" y="38"/>
                      </a:lnTo>
                      <a:lnTo>
                        <a:pt x="1710" y="38"/>
                      </a:lnTo>
                      <a:lnTo>
                        <a:pt x="1710" y="36"/>
                      </a:lnTo>
                      <a:lnTo>
                        <a:pt x="1710" y="39"/>
                      </a:lnTo>
                      <a:lnTo>
                        <a:pt x="1710" y="37"/>
                      </a:lnTo>
                      <a:lnTo>
                        <a:pt x="1711" y="37"/>
                      </a:lnTo>
                      <a:lnTo>
                        <a:pt x="1711" y="37"/>
                      </a:lnTo>
                      <a:lnTo>
                        <a:pt x="1711" y="39"/>
                      </a:lnTo>
                      <a:lnTo>
                        <a:pt x="1711" y="37"/>
                      </a:lnTo>
                      <a:lnTo>
                        <a:pt x="1712" y="37"/>
                      </a:lnTo>
                      <a:lnTo>
                        <a:pt x="1712" y="36"/>
                      </a:lnTo>
                      <a:lnTo>
                        <a:pt x="1712" y="40"/>
                      </a:lnTo>
                      <a:lnTo>
                        <a:pt x="1712" y="36"/>
                      </a:lnTo>
                      <a:lnTo>
                        <a:pt x="1713" y="36"/>
                      </a:lnTo>
                      <a:lnTo>
                        <a:pt x="1713" y="35"/>
                      </a:lnTo>
                      <a:lnTo>
                        <a:pt x="1713" y="38"/>
                      </a:lnTo>
                      <a:lnTo>
                        <a:pt x="1713" y="36"/>
                      </a:lnTo>
                      <a:lnTo>
                        <a:pt x="1714" y="36"/>
                      </a:lnTo>
                      <a:lnTo>
                        <a:pt x="1714" y="35"/>
                      </a:lnTo>
                      <a:lnTo>
                        <a:pt x="1714" y="38"/>
                      </a:lnTo>
                      <a:lnTo>
                        <a:pt x="1714" y="37"/>
                      </a:lnTo>
                      <a:lnTo>
                        <a:pt x="1715" y="37"/>
                      </a:lnTo>
                      <a:lnTo>
                        <a:pt x="1715" y="35"/>
                      </a:lnTo>
                      <a:lnTo>
                        <a:pt x="1715" y="38"/>
                      </a:lnTo>
                      <a:lnTo>
                        <a:pt x="1715" y="36"/>
                      </a:lnTo>
                      <a:lnTo>
                        <a:pt x="1716" y="36"/>
                      </a:lnTo>
                      <a:lnTo>
                        <a:pt x="1716" y="35"/>
                      </a:lnTo>
                      <a:lnTo>
                        <a:pt x="1716" y="39"/>
                      </a:lnTo>
                      <a:lnTo>
                        <a:pt x="1716" y="39"/>
                      </a:lnTo>
                      <a:lnTo>
                        <a:pt x="1717" y="39"/>
                      </a:lnTo>
                      <a:lnTo>
                        <a:pt x="1717" y="35"/>
                      </a:lnTo>
                      <a:lnTo>
                        <a:pt x="1717" y="40"/>
                      </a:lnTo>
                      <a:lnTo>
                        <a:pt x="1717" y="38"/>
                      </a:lnTo>
                      <a:lnTo>
                        <a:pt x="1718" y="38"/>
                      </a:lnTo>
                      <a:lnTo>
                        <a:pt x="1718" y="37"/>
                      </a:lnTo>
                      <a:lnTo>
                        <a:pt x="1718" y="41"/>
                      </a:lnTo>
                      <a:lnTo>
                        <a:pt x="1718" y="38"/>
                      </a:lnTo>
                      <a:lnTo>
                        <a:pt x="1719" y="38"/>
                      </a:lnTo>
                      <a:lnTo>
                        <a:pt x="1719" y="36"/>
                      </a:lnTo>
                      <a:lnTo>
                        <a:pt x="1719" y="40"/>
                      </a:lnTo>
                      <a:lnTo>
                        <a:pt x="1719" y="37"/>
                      </a:lnTo>
                      <a:lnTo>
                        <a:pt x="1720" y="37"/>
                      </a:lnTo>
                      <a:lnTo>
                        <a:pt x="1720" y="36"/>
                      </a:lnTo>
                      <a:lnTo>
                        <a:pt x="1720" y="39"/>
                      </a:lnTo>
                      <a:lnTo>
                        <a:pt x="1720" y="38"/>
                      </a:lnTo>
                      <a:lnTo>
                        <a:pt x="1721" y="38"/>
                      </a:lnTo>
                      <a:lnTo>
                        <a:pt x="1721" y="36"/>
                      </a:lnTo>
                      <a:lnTo>
                        <a:pt x="1721" y="39"/>
                      </a:lnTo>
                      <a:lnTo>
                        <a:pt x="1721" y="37"/>
                      </a:lnTo>
                      <a:lnTo>
                        <a:pt x="1722" y="37"/>
                      </a:lnTo>
                      <a:lnTo>
                        <a:pt x="1722" y="35"/>
                      </a:lnTo>
                      <a:lnTo>
                        <a:pt x="1722" y="39"/>
                      </a:lnTo>
                      <a:lnTo>
                        <a:pt x="1722" y="38"/>
                      </a:lnTo>
                      <a:lnTo>
                        <a:pt x="1723" y="38"/>
                      </a:lnTo>
                      <a:lnTo>
                        <a:pt x="1723" y="36"/>
                      </a:lnTo>
                      <a:lnTo>
                        <a:pt x="1723" y="40"/>
                      </a:lnTo>
                      <a:lnTo>
                        <a:pt x="1723" y="40"/>
                      </a:lnTo>
                      <a:lnTo>
                        <a:pt x="1724" y="40"/>
                      </a:lnTo>
                      <a:lnTo>
                        <a:pt x="1724" y="37"/>
                      </a:lnTo>
                      <a:lnTo>
                        <a:pt x="1724" y="40"/>
                      </a:lnTo>
                      <a:lnTo>
                        <a:pt x="1724" y="39"/>
                      </a:lnTo>
                      <a:lnTo>
                        <a:pt x="1725" y="39"/>
                      </a:lnTo>
                      <a:lnTo>
                        <a:pt x="1725" y="36"/>
                      </a:lnTo>
                      <a:lnTo>
                        <a:pt x="1725" y="40"/>
                      </a:lnTo>
                      <a:lnTo>
                        <a:pt x="1725" y="39"/>
                      </a:lnTo>
                      <a:lnTo>
                        <a:pt x="1726" y="39"/>
                      </a:lnTo>
                      <a:lnTo>
                        <a:pt x="1726" y="37"/>
                      </a:lnTo>
                      <a:lnTo>
                        <a:pt x="1726" y="38"/>
                      </a:lnTo>
                      <a:lnTo>
                        <a:pt x="1726" y="37"/>
                      </a:lnTo>
                      <a:lnTo>
                        <a:pt x="1727" y="37"/>
                      </a:lnTo>
                      <a:lnTo>
                        <a:pt x="1727" y="36"/>
                      </a:lnTo>
                      <a:lnTo>
                        <a:pt x="1727" y="38"/>
                      </a:lnTo>
                      <a:lnTo>
                        <a:pt x="1727" y="38"/>
                      </a:lnTo>
                      <a:lnTo>
                        <a:pt x="1728" y="38"/>
                      </a:lnTo>
                      <a:lnTo>
                        <a:pt x="1728" y="36"/>
                      </a:lnTo>
                      <a:lnTo>
                        <a:pt x="1728" y="39"/>
                      </a:lnTo>
                      <a:lnTo>
                        <a:pt x="1728" y="37"/>
                      </a:lnTo>
                      <a:lnTo>
                        <a:pt x="1729" y="37"/>
                      </a:lnTo>
                      <a:lnTo>
                        <a:pt x="1729" y="37"/>
                      </a:lnTo>
                      <a:lnTo>
                        <a:pt x="1729" y="39"/>
                      </a:lnTo>
                      <a:lnTo>
                        <a:pt x="1729" y="38"/>
                      </a:lnTo>
                      <a:lnTo>
                        <a:pt x="1730" y="38"/>
                      </a:lnTo>
                      <a:lnTo>
                        <a:pt x="1730" y="37"/>
                      </a:lnTo>
                      <a:lnTo>
                        <a:pt x="1730" y="39"/>
                      </a:lnTo>
                      <a:lnTo>
                        <a:pt x="1730" y="37"/>
                      </a:lnTo>
                      <a:lnTo>
                        <a:pt x="1731" y="37"/>
                      </a:lnTo>
                      <a:lnTo>
                        <a:pt x="1731" y="37"/>
                      </a:lnTo>
                      <a:lnTo>
                        <a:pt x="1731" y="41"/>
                      </a:lnTo>
                      <a:lnTo>
                        <a:pt x="1731" y="38"/>
                      </a:lnTo>
                      <a:lnTo>
                        <a:pt x="1732" y="38"/>
                      </a:lnTo>
                      <a:lnTo>
                        <a:pt x="1732" y="37"/>
                      </a:lnTo>
                      <a:lnTo>
                        <a:pt x="1732" y="40"/>
                      </a:lnTo>
                      <a:lnTo>
                        <a:pt x="1732" y="40"/>
                      </a:lnTo>
                      <a:lnTo>
                        <a:pt x="1733" y="40"/>
                      </a:lnTo>
                      <a:lnTo>
                        <a:pt x="1733" y="37"/>
                      </a:lnTo>
                      <a:lnTo>
                        <a:pt x="1733" y="40"/>
                      </a:lnTo>
                      <a:lnTo>
                        <a:pt x="1733" y="39"/>
                      </a:lnTo>
                      <a:lnTo>
                        <a:pt x="1734" y="39"/>
                      </a:lnTo>
                      <a:lnTo>
                        <a:pt x="1734" y="37"/>
                      </a:lnTo>
                      <a:lnTo>
                        <a:pt x="1734" y="40"/>
                      </a:lnTo>
                      <a:lnTo>
                        <a:pt x="1734" y="38"/>
                      </a:lnTo>
                      <a:lnTo>
                        <a:pt x="1735" y="38"/>
                      </a:lnTo>
                      <a:lnTo>
                        <a:pt x="1735" y="37"/>
                      </a:lnTo>
                      <a:lnTo>
                        <a:pt x="1735" y="41"/>
                      </a:lnTo>
                      <a:lnTo>
                        <a:pt x="1735" y="38"/>
                      </a:lnTo>
                      <a:lnTo>
                        <a:pt x="1736" y="38"/>
                      </a:lnTo>
                      <a:lnTo>
                        <a:pt x="1736" y="38"/>
                      </a:lnTo>
                      <a:lnTo>
                        <a:pt x="1736" y="41"/>
                      </a:lnTo>
                      <a:lnTo>
                        <a:pt x="1736" y="40"/>
                      </a:lnTo>
                      <a:lnTo>
                        <a:pt x="1737" y="40"/>
                      </a:lnTo>
                      <a:lnTo>
                        <a:pt x="1737" y="35"/>
                      </a:lnTo>
                      <a:lnTo>
                        <a:pt x="1737" y="40"/>
                      </a:lnTo>
                      <a:lnTo>
                        <a:pt x="1737" y="35"/>
                      </a:lnTo>
                      <a:lnTo>
                        <a:pt x="1738" y="35"/>
                      </a:lnTo>
                      <a:lnTo>
                        <a:pt x="1738" y="35"/>
                      </a:lnTo>
                      <a:lnTo>
                        <a:pt x="1738" y="40"/>
                      </a:lnTo>
                      <a:lnTo>
                        <a:pt x="1738" y="39"/>
                      </a:lnTo>
                      <a:lnTo>
                        <a:pt x="1739" y="39"/>
                      </a:lnTo>
                      <a:lnTo>
                        <a:pt x="1739" y="37"/>
                      </a:lnTo>
                      <a:lnTo>
                        <a:pt x="1739" y="40"/>
                      </a:lnTo>
                      <a:lnTo>
                        <a:pt x="1739" y="37"/>
                      </a:lnTo>
                      <a:lnTo>
                        <a:pt x="1740" y="37"/>
                      </a:lnTo>
                      <a:lnTo>
                        <a:pt x="1740" y="36"/>
                      </a:lnTo>
                      <a:lnTo>
                        <a:pt x="1740" y="41"/>
                      </a:lnTo>
                      <a:lnTo>
                        <a:pt x="1740" y="38"/>
                      </a:lnTo>
                      <a:lnTo>
                        <a:pt x="1741" y="38"/>
                      </a:lnTo>
                      <a:lnTo>
                        <a:pt x="1741" y="37"/>
                      </a:lnTo>
                      <a:lnTo>
                        <a:pt x="1741" y="41"/>
                      </a:lnTo>
                      <a:lnTo>
                        <a:pt x="1741" y="41"/>
                      </a:lnTo>
                      <a:lnTo>
                        <a:pt x="1742" y="41"/>
                      </a:lnTo>
                      <a:lnTo>
                        <a:pt x="1742" y="37"/>
                      </a:lnTo>
                      <a:lnTo>
                        <a:pt x="1742" y="40"/>
                      </a:lnTo>
                      <a:lnTo>
                        <a:pt x="1742" y="40"/>
                      </a:lnTo>
                      <a:lnTo>
                        <a:pt x="1743" y="40"/>
                      </a:lnTo>
                      <a:lnTo>
                        <a:pt x="1743" y="38"/>
                      </a:lnTo>
                      <a:lnTo>
                        <a:pt x="1743" y="41"/>
                      </a:lnTo>
                      <a:lnTo>
                        <a:pt x="1743" y="41"/>
                      </a:lnTo>
                      <a:lnTo>
                        <a:pt x="1744" y="41"/>
                      </a:lnTo>
                      <a:lnTo>
                        <a:pt x="1744" y="37"/>
                      </a:lnTo>
                      <a:lnTo>
                        <a:pt x="1744" y="40"/>
                      </a:lnTo>
                      <a:lnTo>
                        <a:pt x="1744" y="38"/>
                      </a:lnTo>
                      <a:lnTo>
                        <a:pt x="1745" y="38"/>
                      </a:lnTo>
                      <a:lnTo>
                        <a:pt x="1745" y="35"/>
                      </a:lnTo>
                      <a:lnTo>
                        <a:pt x="1745" y="40"/>
                      </a:lnTo>
                      <a:lnTo>
                        <a:pt x="1745" y="38"/>
                      </a:lnTo>
                      <a:lnTo>
                        <a:pt x="1746" y="38"/>
                      </a:lnTo>
                      <a:lnTo>
                        <a:pt x="1746" y="37"/>
                      </a:lnTo>
                      <a:lnTo>
                        <a:pt x="1746" y="40"/>
                      </a:lnTo>
                      <a:lnTo>
                        <a:pt x="1746" y="38"/>
                      </a:lnTo>
                      <a:lnTo>
                        <a:pt x="1747" y="38"/>
                      </a:lnTo>
                      <a:lnTo>
                        <a:pt x="1747" y="38"/>
                      </a:lnTo>
                      <a:lnTo>
                        <a:pt x="1747" y="40"/>
                      </a:lnTo>
                      <a:lnTo>
                        <a:pt x="1747" y="38"/>
                      </a:lnTo>
                      <a:lnTo>
                        <a:pt x="1748" y="38"/>
                      </a:lnTo>
                      <a:lnTo>
                        <a:pt x="1748" y="35"/>
                      </a:lnTo>
                      <a:lnTo>
                        <a:pt x="1748" y="39"/>
                      </a:lnTo>
                      <a:lnTo>
                        <a:pt x="1748" y="37"/>
                      </a:lnTo>
                      <a:lnTo>
                        <a:pt x="1749" y="37"/>
                      </a:lnTo>
                      <a:lnTo>
                        <a:pt x="1749" y="36"/>
                      </a:lnTo>
                      <a:lnTo>
                        <a:pt x="1749" y="38"/>
                      </a:lnTo>
                      <a:lnTo>
                        <a:pt x="1749" y="37"/>
                      </a:lnTo>
                      <a:lnTo>
                        <a:pt x="1750" y="37"/>
                      </a:lnTo>
                      <a:lnTo>
                        <a:pt x="1750" y="37"/>
                      </a:lnTo>
                      <a:lnTo>
                        <a:pt x="1750" y="41"/>
                      </a:lnTo>
                      <a:lnTo>
                        <a:pt x="1750" y="40"/>
                      </a:lnTo>
                      <a:lnTo>
                        <a:pt x="1751" y="40"/>
                      </a:lnTo>
                      <a:lnTo>
                        <a:pt x="1751" y="38"/>
                      </a:lnTo>
                      <a:lnTo>
                        <a:pt x="1751" y="41"/>
                      </a:lnTo>
                      <a:lnTo>
                        <a:pt x="1751" y="40"/>
                      </a:lnTo>
                      <a:lnTo>
                        <a:pt x="1752" y="40"/>
                      </a:lnTo>
                      <a:lnTo>
                        <a:pt x="1752" y="37"/>
                      </a:lnTo>
                      <a:lnTo>
                        <a:pt x="1752" y="41"/>
                      </a:lnTo>
                      <a:lnTo>
                        <a:pt x="1752" y="37"/>
                      </a:lnTo>
                      <a:lnTo>
                        <a:pt x="1753" y="37"/>
                      </a:lnTo>
                      <a:lnTo>
                        <a:pt x="1753" y="37"/>
                      </a:lnTo>
                      <a:lnTo>
                        <a:pt x="1753" y="41"/>
                      </a:lnTo>
                      <a:lnTo>
                        <a:pt x="1753" y="39"/>
                      </a:lnTo>
                      <a:lnTo>
                        <a:pt x="1754" y="39"/>
                      </a:lnTo>
                      <a:lnTo>
                        <a:pt x="1754" y="37"/>
                      </a:lnTo>
                      <a:lnTo>
                        <a:pt x="1754" y="41"/>
                      </a:lnTo>
                      <a:lnTo>
                        <a:pt x="1754" y="38"/>
                      </a:lnTo>
                      <a:lnTo>
                        <a:pt x="1755" y="38"/>
                      </a:lnTo>
                      <a:lnTo>
                        <a:pt x="1755" y="38"/>
                      </a:lnTo>
                      <a:lnTo>
                        <a:pt x="1755" y="40"/>
                      </a:lnTo>
                      <a:lnTo>
                        <a:pt x="1755" y="38"/>
                      </a:lnTo>
                      <a:lnTo>
                        <a:pt x="1756" y="38"/>
                      </a:lnTo>
                      <a:lnTo>
                        <a:pt x="1756" y="37"/>
                      </a:lnTo>
                      <a:lnTo>
                        <a:pt x="1756" y="40"/>
                      </a:lnTo>
                      <a:lnTo>
                        <a:pt x="1756" y="40"/>
                      </a:lnTo>
                      <a:lnTo>
                        <a:pt x="1757" y="40"/>
                      </a:lnTo>
                      <a:lnTo>
                        <a:pt x="1757" y="37"/>
                      </a:lnTo>
                      <a:lnTo>
                        <a:pt x="1757" y="41"/>
                      </a:lnTo>
                      <a:lnTo>
                        <a:pt x="1757" y="38"/>
                      </a:lnTo>
                      <a:lnTo>
                        <a:pt x="1758" y="38"/>
                      </a:lnTo>
                      <a:lnTo>
                        <a:pt x="1758" y="35"/>
                      </a:lnTo>
                      <a:lnTo>
                        <a:pt x="1758" y="39"/>
                      </a:lnTo>
                      <a:lnTo>
                        <a:pt x="1758" y="38"/>
                      </a:lnTo>
                      <a:lnTo>
                        <a:pt x="1759" y="38"/>
                      </a:lnTo>
                      <a:lnTo>
                        <a:pt x="1759" y="35"/>
                      </a:lnTo>
                      <a:lnTo>
                        <a:pt x="1759" y="40"/>
                      </a:lnTo>
                      <a:lnTo>
                        <a:pt x="1759" y="37"/>
                      </a:lnTo>
                      <a:lnTo>
                        <a:pt x="1760" y="37"/>
                      </a:lnTo>
                      <a:lnTo>
                        <a:pt x="1760" y="37"/>
                      </a:lnTo>
                      <a:lnTo>
                        <a:pt x="1760" y="41"/>
                      </a:lnTo>
                      <a:lnTo>
                        <a:pt x="1760" y="39"/>
                      </a:lnTo>
                      <a:lnTo>
                        <a:pt x="1761" y="39"/>
                      </a:lnTo>
                      <a:lnTo>
                        <a:pt x="1761" y="38"/>
                      </a:lnTo>
                      <a:lnTo>
                        <a:pt x="1761" y="41"/>
                      </a:lnTo>
                      <a:lnTo>
                        <a:pt x="1761" y="40"/>
                      </a:lnTo>
                      <a:lnTo>
                        <a:pt x="1762" y="40"/>
                      </a:lnTo>
                      <a:lnTo>
                        <a:pt x="1762" y="38"/>
                      </a:lnTo>
                      <a:lnTo>
                        <a:pt x="1762" y="41"/>
                      </a:lnTo>
                      <a:lnTo>
                        <a:pt x="1762" y="38"/>
                      </a:lnTo>
                      <a:lnTo>
                        <a:pt x="1763" y="38"/>
                      </a:lnTo>
                      <a:lnTo>
                        <a:pt x="1763" y="38"/>
                      </a:lnTo>
                      <a:lnTo>
                        <a:pt x="1763" y="41"/>
                      </a:lnTo>
                      <a:lnTo>
                        <a:pt x="1763" y="40"/>
                      </a:lnTo>
                      <a:lnTo>
                        <a:pt x="1764" y="40"/>
                      </a:lnTo>
                      <a:lnTo>
                        <a:pt x="1764" y="38"/>
                      </a:lnTo>
                      <a:lnTo>
                        <a:pt x="1764" y="41"/>
                      </a:lnTo>
                      <a:lnTo>
                        <a:pt x="1764" y="41"/>
                      </a:lnTo>
                      <a:lnTo>
                        <a:pt x="1765" y="41"/>
                      </a:lnTo>
                      <a:lnTo>
                        <a:pt x="1765" y="38"/>
                      </a:lnTo>
                      <a:lnTo>
                        <a:pt x="1765" y="41"/>
                      </a:lnTo>
                      <a:lnTo>
                        <a:pt x="1765" y="40"/>
                      </a:lnTo>
                      <a:lnTo>
                        <a:pt x="1766" y="40"/>
                      </a:lnTo>
                      <a:lnTo>
                        <a:pt x="1766" y="40"/>
                      </a:lnTo>
                      <a:lnTo>
                        <a:pt x="1766" y="41"/>
                      </a:lnTo>
                      <a:lnTo>
                        <a:pt x="1766" y="40"/>
                      </a:lnTo>
                      <a:lnTo>
                        <a:pt x="1767" y="40"/>
                      </a:lnTo>
                      <a:lnTo>
                        <a:pt x="1767" y="37"/>
                      </a:lnTo>
                      <a:lnTo>
                        <a:pt x="1767" y="41"/>
                      </a:lnTo>
                      <a:lnTo>
                        <a:pt x="1767" y="41"/>
                      </a:lnTo>
                      <a:lnTo>
                        <a:pt x="1768" y="41"/>
                      </a:lnTo>
                      <a:lnTo>
                        <a:pt x="1768" y="38"/>
                      </a:lnTo>
                      <a:lnTo>
                        <a:pt x="1768" y="41"/>
                      </a:lnTo>
                      <a:lnTo>
                        <a:pt x="1768" y="40"/>
                      </a:lnTo>
                      <a:lnTo>
                        <a:pt x="1769" y="40"/>
                      </a:lnTo>
                      <a:lnTo>
                        <a:pt x="1769" y="37"/>
                      </a:lnTo>
                      <a:lnTo>
                        <a:pt x="1769" y="39"/>
                      </a:lnTo>
                      <a:lnTo>
                        <a:pt x="1769" y="37"/>
                      </a:lnTo>
                      <a:lnTo>
                        <a:pt x="1770" y="37"/>
                      </a:lnTo>
                      <a:lnTo>
                        <a:pt x="1770" y="36"/>
                      </a:lnTo>
                      <a:lnTo>
                        <a:pt x="1770" y="39"/>
                      </a:lnTo>
                      <a:lnTo>
                        <a:pt x="1770" y="36"/>
                      </a:lnTo>
                      <a:lnTo>
                        <a:pt x="1771" y="36"/>
                      </a:lnTo>
                      <a:lnTo>
                        <a:pt x="1771" y="37"/>
                      </a:lnTo>
                      <a:lnTo>
                        <a:pt x="1771" y="40"/>
                      </a:lnTo>
                      <a:lnTo>
                        <a:pt x="1771" y="39"/>
                      </a:lnTo>
                      <a:lnTo>
                        <a:pt x="1772" y="39"/>
                      </a:lnTo>
                      <a:lnTo>
                        <a:pt x="1772" y="37"/>
                      </a:lnTo>
                      <a:lnTo>
                        <a:pt x="1772" y="41"/>
                      </a:lnTo>
                      <a:lnTo>
                        <a:pt x="1772" y="37"/>
                      </a:lnTo>
                      <a:lnTo>
                        <a:pt x="1773" y="37"/>
                      </a:lnTo>
                      <a:lnTo>
                        <a:pt x="1773" y="36"/>
                      </a:lnTo>
                      <a:lnTo>
                        <a:pt x="1773" y="40"/>
                      </a:lnTo>
                      <a:lnTo>
                        <a:pt x="1773" y="38"/>
                      </a:lnTo>
                      <a:lnTo>
                        <a:pt x="1774" y="38"/>
                      </a:lnTo>
                      <a:lnTo>
                        <a:pt x="1774" y="38"/>
                      </a:lnTo>
                      <a:lnTo>
                        <a:pt x="1774" y="40"/>
                      </a:lnTo>
                      <a:lnTo>
                        <a:pt x="1774" y="39"/>
                      </a:lnTo>
                      <a:lnTo>
                        <a:pt x="1775" y="39"/>
                      </a:lnTo>
                      <a:lnTo>
                        <a:pt x="1775" y="36"/>
                      </a:lnTo>
                      <a:lnTo>
                        <a:pt x="1775" y="40"/>
                      </a:lnTo>
                      <a:lnTo>
                        <a:pt x="1775" y="37"/>
                      </a:lnTo>
                      <a:lnTo>
                        <a:pt x="1776" y="37"/>
                      </a:lnTo>
                      <a:lnTo>
                        <a:pt x="1776" y="35"/>
                      </a:lnTo>
                      <a:lnTo>
                        <a:pt x="1776" y="39"/>
                      </a:lnTo>
                      <a:lnTo>
                        <a:pt x="1776" y="37"/>
                      </a:lnTo>
                      <a:lnTo>
                        <a:pt x="1777" y="37"/>
                      </a:lnTo>
                      <a:lnTo>
                        <a:pt x="1777" y="36"/>
                      </a:lnTo>
                      <a:lnTo>
                        <a:pt x="1777" y="39"/>
                      </a:lnTo>
                      <a:lnTo>
                        <a:pt x="1777" y="38"/>
                      </a:lnTo>
                      <a:lnTo>
                        <a:pt x="1778" y="38"/>
                      </a:lnTo>
                      <a:lnTo>
                        <a:pt x="1778" y="37"/>
                      </a:lnTo>
                      <a:lnTo>
                        <a:pt x="1778" y="40"/>
                      </a:lnTo>
                      <a:lnTo>
                        <a:pt x="1778" y="37"/>
                      </a:lnTo>
                      <a:lnTo>
                        <a:pt x="1779" y="37"/>
                      </a:lnTo>
                      <a:lnTo>
                        <a:pt x="1779" y="35"/>
                      </a:lnTo>
                      <a:lnTo>
                        <a:pt x="1779" y="39"/>
                      </a:lnTo>
                      <a:lnTo>
                        <a:pt x="1779" y="36"/>
                      </a:lnTo>
                      <a:lnTo>
                        <a:pt x="1780" y="36"/>
                      </a:lnTo>
                      <a:lnTo>
                        <a:pt x="1780" y="34"/>
                      </a:lnTo>
                      <a:lnTo>
                        <a:pt x="1780" y="37"/>
                      </a:lnTo>
                      <a:lnTo>
                        <a:pt x="1780" y="37"/>
                      </a:lnTo>
                      <a:lnTo>
                        <a:pt x="1781" y="37"/>
                      </a:lnTo>
                      <a:lnTo>
                        <a:pt x="1781" y="35"/>
                      </a:lnTo>
                      <a:lnTo>
                        <a:pt x="1781" y="38"/>
                      </a:lnTo>
                      <a:lnTo>
                        <a:pt x="1781" y="38"/>
                      </a:lnTo>
                      <a:lnTo>
                        <a:pt x="1782" y="38"/>
                      </a:lnTo>
                      <a:lnTo>
                        <a:pt x="1782" y="35"/>
                      </a:lnTo>
                      <a:lnTo>
                        <a:pt x="1782" y="38"/>
                      </a:lnTo>
                      <a:lnTo>
                        <a:pt x="1782" y="38"/>
                      </a:lnTo>
                      <a:lnTo>
                        <a:pt x="1783" y="38"/>
                      </a:lnTo>
                      <a:lnTo>
                        <a:pt x="1783" y="36"/>
                      </a:lnTo>
                      <a:lnTo>
                        <a:pt x="1783" y="39"/>
                      </a:lnTo>
                      <a:lnTo>
                        <a:pt x="1783" y="38"/>
                      </a:lnTo>
                      <a:lnTo>
                        <a:pt x="1784" y="38"/>
                      </a:lnTo>
                      <a:lnTo>
                        <a:pt x="1784" y="35"/>
                      </a:lnTo>
                      <a:lnTo>
                        <a:pt x="1784" y="38"/>
                      </a:lnTo>
                      <a:lnTo>
                        <a:pt x="1784" y="35"/>
                      </a:lnTo>
                      <a:lnTo>
                        <a:pt x="1785" y="35"/>
                      </a:lnTo>
                      <a:lnTo>
                        <a:pt x="1785" y="34"/>
                      </a:lnTo>
                      <a:lnTo>
                        <a:pt x="1785" y="38"/>
                      </a:lnTo>
                      <a:lnTo>
                        <a:pt x="1785" y="37"/>
                      </a:lnTo>
                      <a:lnTo>
                        <a:pt x="1786" y="37"/>
                      </a:lnTo>
                      <a:lnTo>
                        <a:pt x="1786" y="35"/>
                      </a:lnTo>
                      <a:lnTo>
                        <a:pt x="1786" y="40"/>
                      </a:lnTo>
                      <a:lnTo>
                        <a:pt x="1786" y="35"/>
                      </a:lnTo>
                      <a:lnTo>
                        <a:pt x="1787" y="35"/>
                      </a:lnTo>
                      <a:lnTo>
                        <a:pt x="1787" y="36"/>
                      </a:lnTo>
                      <a:lnTo>
                        <a:pt x="1787" y="39"/>
                      </a:lnTo>
                      <a:lnTo>
                        <a:pt x="1787" y="37"/>
                      </a:lnTo>
                      <a:lnTo>
                        <a:pt x="1788" y="37"/>
                      </a:lnTo>
                      <a:lnTo>
                        <a:pt x="1788" y="35"/>
                      </a:lnTo>
                      <a:lnTo>
                        <a:pt x="1788" y="38"/>
                      </a:lnTo>
                      <a:lnTo>
                        <a:pt x="1788" y="36"/>
                      </a:lnTo>
                      <a:lnTo>
                        <a:pt x="1789" y="36"/>
                      </a:lnTo>
                      <a:lnTo>
                        <a:pt x="1789" y="34"/>
                      </a:lnTo>
                      <a:lnTo>
                        <a:pt x="1789" y="37"/>
                      </a:lnTo>
                      <a:lnTo>
                        <a:pt x="1789" y="36"/>
                      </a:lnTo>
                      <a:lnTo>
                        <a:pt x="1790" y="36"/>
                      </a:lnTo>
                      <a:lnTo>
                        <a:pt x="1790" y="34"/>
                      </a:lnTo>
                      <a:lnTo>
                        <a:pt x="1790" y="37"/>
                      </a:lnTo>
                      <a:lnTo>
                        <a:pt x="1790" y="36"/>
                      </a:lnTo>
                      <a:lnTo>
                        <a:pt x="1791" y="36"/>
                      </a:lnTo>
                      <a:lnTo>
                        <a:pt x="1791" y="34"/>
                      </a:lnTo>
                      <a:lnTo>
                        <a:pt x="1791" y="39"/>
                      </a:lnTo>
                      <a:lnTo>
                        <a:pt x="1791" y="39"/>
                      </a:lnTo>
                      <a:lnTo>
                        <a:pt x="1792" y="39"/>
                      </a:lnTo>
                      <a:lnTo>
                        <a:pt x="1792" y="36"/>
                      </a:lnTo>
                      <a:lnTo>
                        <a:pt x="1792" y="40"/>
                      </a:lnTo>
                      <a:lnTo>
                        <a:pt x="1792" y="38"/>
                      </a:lnTo>
                      <a:lnTo>
                        <a:pt x="1793" y="38"/>
                      </a:lnTo>
                      <a:lnTo>
                        <a:pt x="1793" y="35"/>
                      </a:lnTo>
                      <a:lnTo>
                        <a:pt x="1793" y="38"/>
                      </a:lnTo>
                      <a:lnTo>
                        <a:pt x="1793" y="35"/>
                      </a:lnTo>
                      <a:lnTo>
                        <a:pt x="1794" y="35"/>
                      </a:lnTo>
                      <a:lnTo>
                        <a:pt x="1794" y="35"/>
                      </a:lnTo>
                      <a:lnTo>
                        <a:pt x="1794" y="39"/>
                      </a:lnTo>
                      <a:lnTo>
                        <a:pt x="1794" y="37"/>
                      </a:lnTo>
                      <a:lnTo>
                        <a:pt x="1795" y="37"/>
                      </a:lnTo>
                      <a:lnTo>
                        <a:pt x="1795" y="37"/>
                      </a:lnTo>
                      <a:lnTo>
                        <a:pt x="1795" y="40"/>
                      </a:lnTo>
                      <a:lnTo>
                        <a:pt x="1795" y="37"/>
                      </a:lnTo>
                      <a:lnTo>
                        <a:pt x="1796" y="37"/>
                      </a:lnTo>
                      <a:lnTo>
                        <a:pt x="1796" y="37"/>
                      </a:lnTo>
                      <a:lnTo>
                        <a:pt x="1796" y="40"/>
                      </a:lnTo>
                      <a:lnTo>
                        <a:pt x="1796" y="40"/>
                      </a:lnTo>
                      <a:lnTo>
                        <a:pt x="1797" y="40"/>
                      </a:lnTo>
                      <a:lnTo>
                        <a:pt x="1797" y="37"/>
                      </a:lnTo>
                      <a:lnTo>
                        <a:pt x="1797" y="40"/>
                      </a:lnTo>
                      <a:lnTo>
                        <a:pt x="1797" y="37"/>
                      </a:lnTo>
                      <a:lnTo>
                        <a:pt x="1798" y="37"/>
                      </a:lnTo>
                      <a:lnTo>
                        <a:pt x="1798" y="37"/>
                      </a:lnTo>
                      <a:lnTo>
                        <a:pt x="1798" y="40"/>
                      </a:lnTo>
                      <a:lnTo>
                        <a:pt x="1798" y="40"/>
                      </a:lnTo>
                      <a:lnTo>
                        <a:pt x="1799" y="40"/>
                      </a:lnTo>
                      <a:lnTo>
                        <a:pt x="1799" y="37"/>
                      </a:lnTo>
                      <a:lnTo>
                        <a:pt x="1799" y="40"/>
                      </a:lnTo>
                      <a:lnTo>
                        <a:pt x="1799" y="38"/>
                      </a:lnTo>
                      <a:lnTo>
                        <a:pt x="1800" y="38"/>
                      </a:lnTo>
                      <a:lnTo>
                        <a:pt x="1800" y="36"/>
                      </a:lnTo>
                      <a:lnTo>
                        <a:pt x="1800" y="40"/>
                      </a:lnTo>
                      <a:lnTo>
                        <a:pt x="1800" y="40"/>
                      </a:lnTo>
                      <a:lnTo>
                        <a:pt x="1801" y="40"/>
                      </a:lnTo>
                      <a:lnTo>
                        <a:pt x="1801" y="35"/>
                      </a:lnTo>
                      <a:lnTo>
                        <a:pt x="1801" y="40"/>
                      </a:lnTo>
                      <a:lnTo>
                        <a:pt x="1801" y="35"/>
                      </a:lnTo>
                      <a:lnTo>
                        <a:pt x="1802" y="35"/>
                      </a:lnTo>
                      <a:lnTo>
                        <a:pt x="1802" y="35"/>
                      </a:lnTo>
                      <a:lnTo>
                        <a:pt x="1802" y="37"/>
                      </a:lnTo>
                      <a:lnTo>
                        <a:pt x="1802" y="36"/>
                      </a:lnTo>
                      <a:lnTo>
                        <a:pt x="1803" y="36"/>
                      </a:lnTo>
                      <a:lnTo>
                        <a:pt x="1803" y="35"/>
                      </a:lnTo>
                      <a:lnTo>
                        <a:pt x="1803" y="40"/>
                      </a:lnTo>
                      <a:lnTo>
                        <a:pt x="1803" y="38"/>
                      </a:lnTo>
                      <a:lnTo>
                        <a:pt x="1804" y="38"/>
                      </a:lnTo>
                      <a:lnTo>
                        <a:pt x="1804" y="37"/>
                      </a:lnTo>
                      <a:lnTo>
                        <a:pt x="1804" y="40"/>
                      </a:lnTo>
                      <a:lnTo>
                        <a:pt x="1804" y="37"/>
                      </a:lnTo>
                      <a:lnTo>
                        <a:pt x="1805" y="37"/>
                      </a:lnTo>
                      <a:lnTo>
                        <a:pt x="1805" y="37"/>
                      </a:lnTo>
                      <a:lnTo>
                        <a:pt x="1805" y="40"/>
                      </a:lnTo>
                      <a:lnTo>
                        <a:pt x="1805" y="39"/>
                      </a:lnTo>
                      <a:lnTo>
                        <a:pt x="1806" y="39"/>
                      </a:lnTo>
                      <a:lnTo>
                        <a:pt x="1806" y="37"/>
                      </a:lnTo>
                      <a:lnTo>
                        <a:pt x="1806" y="40"/>
                      </a:lnTo>
                      <a:lnTo>
                        <a:pt x="1806" y="40"/>
                      </a:lnTo>
                      <a:lnTo>
                        <a:pt x="1807" y="40"/>
                      </a:lnTo>
                      <a:lnTo>
                        <a:pt x="1807" y="37"/>
                      </a:lnTo>
                      <a:lnTo>
                        <a:pt x="1807" y="41"/>
                      </a:lnTo>
                      <a:lnTo>
                        <a:pt x="1807" y="39"/>
                      </a:lnTo>
                      <a:lnTo>
                        <a:pt x="1808" y="39"/>
                      </a:lnTo>
                      <a:lnTo>
                        <a:pt x="1808" y="36"/>
                      </a:lnTo>
                      <a:lnTo>
                        <a:pt x="1808" y="40"/>
                      </a:lnTo>
                      <a:lnTo>
                        <a:pt x="1808" y="37"/>
                      </a:lnTo>
                      <a:lnTo>
                        <a:pt x="1809" y="37"/>
                      </a:lnTo>
                      <a:lnTo>
                        <a:pt x="1809" y="37"/>
                      </a:lnTo>
                      <a:lnTo>
                        <a:pt x="1809" y="40"/>
                      </a:lnTo>
                      <a:lnTo>
                        <a:pt x="1809" y="40"/>
                      </a:lnTo>
                      <a:lnTo>
                        <a:pt x="1810" y="40"/>
                      </a:lnTo>
                      <a:lnTo>
                        <a:pt x="1810" y="38"/>
                      </a:lnTo>
                      <a:lnTo>
                        <a:pt x="1810" y="41"/>
                      </a:lnTo>
                      <a:lnTo>
                        <a:pt x="1810" y="38"/>
                      </a:lnTo>
                      <a:lnTo>
                        <a:pt x="1811" y="38"/>
                      </a:lnTo>
                      <a:lnTo>
                        <a:pt x="1811" y="37"/>
                      </a:lnTo>
                      <a:lnTo>
                        <a:pt x="1811" y="40"/>
                      </a:lnTo>
                      <a:lnTo>
                        <a:pt x="1811" y="37"/>
                      </a:lnTo>
                      <a:lnTo>
                        <a:pt x="1812" y="37"/>
                      </a:lnTo>
                      <a:lnTo>
                        <a:pt x="1812" y="37"/>
                      </a:lnTo>
                      <a:lnTo>
                        <a:pt x="1812" y="40"/>
                      </a:lnTo>
                      <a:lnTo>
                        <a:pt x="1812" y="38"/>
                      </a:lnTo>
                      <a:lnTo>
                        <a:pt x="1813" y="38"/>
                      </a:lnTo>
                      <a:lnTo>
                        <a:pt x="1813" y="35"/>
                      </a:lnTo>
                      <a:lnTo>
                        <a:pt x="1813" y="40"/>
                      </a:lnTo>
                      <a:lnTo>
                        <a:pt x="1813" y="38"/>
                      </a:lnTo>
                      <a:lnTo>
                        <a:pt x="1814" y="38"/>
                      </a:lnTo>
                      <a:lnTo>
                        <a:pt x="1814" y="35"/>
                      </a:lnTo>
                      <a:lnTo>
                        <a:pt x="1814" y="38"/>
                      </a:lnTo>
                      <a:lnTo>
                        <a:pt x="1814" y="37"/>
                      </a:lnTo>
                      <a:lnTo>
                        <a:pt x="1815" y="37"/>
                      </a:lnTo>
                      <a:lnTo>
                        <a:pt x="1815" y="37"/>
                      </a:lnTo>
                      <a:lnTo>
                        <a:pt x="1815" y="40"/>
                      </a:lnTo>
                      <a:lnTo>
                        <a:pt x="1815" y="40"/>
                      </a:lnTo>
                      <a:lnTo>
                        <a:pt x="1816" y="40"/>
                      </a:lnTo>
                      <a:lnTo>
                        <a:pt x="1816" y="37"/>
                      </a:lnTo>
                      <a:lnTo>
                        <a:pt x="1816" y="41"/>
                      </a:lnTo>
                      <a:lnTo>
                        <a:pt x="1816" y="41"/>
                      </a:lnTo>
                      <a:lnTo>
                        <a:pt x="1817" y="41"/>
                      </a:lnTo>
                      <a:lnTo>
                        <a:pt x="1817" y="36"/>
                      </a:lnTo>
                      <a:lnTo>
                        <a:pt x="1817" y="41"/>
                      </a:lnTo>
                      <a:lnTo>
                        <a:pt x="1817" y="39"/>
                      </a:lnTo>
                      <a:lnTo>
                        <a:pt x="1818" y="39"/>
                      </a:lnTo>
                      <a:lnTo>
                        <a:pt x="1818" y="39"/>
                      </a:lnTo>
                      <a:lnTo>
                        <a:pt x="1818" y="41"/>
                      </a:lnTo>
                      <a:lnTo>
                        <a:pt x="1818" y="41"/>
                      </a:lnTo>
                      <a:lnTo>
                        <a:pt x="1819" y="41"/>
                      </a:lnTo>
                      <a:lnTo>
                        <a:pt x="1819" y="39"/>
                      </a:lnTo>
                      <a:lnTo>
                        <a:pt x="1819" y="41"/>
                      </a:lnTo>
                      <a:lnTo>
                        <a:pt x="1819" y="39"/>
                      </a:lnTo>
                      <a:lnTo>
                        <a:pt x="1820" y="39"/>
                      </a:lnTo>
                      <a:lnTo>
                        <a:pt x="1820" y="37"/>
                      </a:lnTo>
                      <a:lnTo>
                        <a:pt x="1820" y="41"/>
                      </a:lnTo>
                      <a:lnTo>
                        <a:pt x="1820" y="39"/>
                      </a:lnTo>
                      <a:lnTo>
                        <a:pt x="1821" y="39"/>
                      </a:lnTo>
                      <a:lnTo>
                        <a:pt x="1821" y="36"/>
                      </a:lnTo>
                      <a:lnTo>
                        <a:pt x="1821" y="40"/>
                      </a:lnTo>
                      <a:lnTo>
                        <a:pt x="1821" y="40"/>
                      </a:lnTo>
                      <a:lnTo>
                        <a:pt x="1822" y="40"/>
                      </a:lnTo>
                      <a:lnTo>
                        <a:pt x="1822" y="37"/>
                      </a:lnTo>
                      <a:lnTo>
                        <a:pt x="1822" y="40"/>
                      </a:lnTo>
                      <a:lnTo>
                        <a:pt x="1822" y="40"/>
                      </a:lnTo>
                      <a:lnTo>
                        <a:pt x="1823" y="40"/>
                      </a:lnTo>
                      <a:lnTo>
                        <a:pt x="1823" y="37"/>
                      </a:lnTo>
                      <a:lnTo>
                        <a:pt x="1823" y="40"/>
                      </a:lnTo>
                      <a:lnTo>
                        <a:pt x="1823" y="39"/>
                      </a:lnTo>
                      <a:lnTo>
                        <a:pt x="1824" y="39"/>
                      </a:lnTo>
                      <a:lnTo>
                        <a:pt x="1824" y="38"/>
                      </a:lnTo>
                      <a:lnTo>
                        <a:pt x="1824" y="41"/>
                      </a:lnTo>
                      <a:lnTo>
                        <a:pt x="1824" y="40"/>
                      </a:lnTo>
                      <a:lnTo>
                        <a:pt x="1825" y="40"/>
                      </a:lnTo>
                      <a:lnTo>
                        <a:pt x="1825" y="39"/>
                      </a:lnTo>
                      <a:lnTo>
                        <a:pt x="1825" y="42"/>
                      </a:lnTo>
                      <a:lnTo>
                        <a:pt x="1825" y="42"/>
                      </a:lnTo>
                      <a:lnTo>
                        <a:pt x="1826" y="42"/>
                      </a:lnTo>
                      <a:lnTo>
                        <a:pt x="1826" y="37"/>
                      </a:lnTo>
                      <a:lnTo>
                        <a:pt x="1826" y="41"/>
                      </a:lnTo>
                      <a:lnTo>
                        <a:pt x="1826" y="38"/>
                      </a:lnTo>
                      <a:lnTo>
                        <a:pt x="1827" y="38"/>
                      </a:lnTo>
                      <a:lnTo>
                        <a:pt x="1827" y="36"/>
                      </a:lnTo>
                      <a:lnTo>
                        <a:pt x="1827" y="41"/>
                      </a:lnTo>
                      <a:lnTo>
                        <a:pt x="1827" y="40"/>
                      </a:lnTo>
                      <a:lnTo>
                        <a:pt x="1828" y="40"/>
                      </a:lnTo>
                      <a:lnTo>
                        <a:pt x="1828" y="39"/>
                      </a:lnTo>
                      <a:lnTo>
                        <a:pt x="1828" y="41"/>
                      </a:lnTo>
                      <a:lnTo>
                        <a:pt x="1828" y="39"/>
                      </a:lnTo>
                      <a:lnTo>
                        <a:pt x="1829" y="39"/>
                      </a:lnTo>
                      <a:lnTo>
                        <a:pt x="1829" y="37"/>
                      </a:lnTo>
                      <a:lnTo>
                        <a:pt x="1829" y="40"/>
                      </a:lnTo>
                      <a:lnTo>
                        <a:pt x="1829" y="38"/>
                      </a:lnTo>
                      <a:lnTo>
                        <a:pt x="1830" y="38"/>
                      </a:lnTo>
                      <a:lnTo>
                        <a:pt x="1830" y="35"/>
                      </a:lnTo>
                      <a:lnTo>
                        <a:pt x="1830" y="40"/>
                      </a:lnTo>
                      <a:lnTo>
                        <a:pt x="1830" y="39"/>
                      </a:lnTo>
                      <a:lnTo>
                        <a:pt x="1831" y="39"/>
                      </a:lnTo>
                      <a:lnTo>
                        <a:pt x="1831" y="36"/>
                      </a:lnTo>
                      <a:lnTo>
                        <a:pt x="1831" y="40"/>
                      </a:lnTo>
                      <a:lnTo>
                        <a:pt x="1831" y="39"/>
                      </a:lnTo>
                      <a:lnTo>
                        <a:pt x="1832" y="39"/>
                      </a:lnTo>
                      <a:lnTo>
                        <a:pt x="1832" y="38"/>
                      </a:lnTo>
                      <a:lnTo>
                        <a:pt x="1832" y="41"/>
                      </a:lnTo>
                      <a:lnTo>
                        <a:pt x="1832" y="41"/>
                      </a:lnTo>
                      <a:lnTo>
                        <a:pt x="1833" y="41"/>
                      </a:lnTo>
                      <a:lnTo>
                        <a:pt x="1833" y="37"/>
                      </a:lnTo>
                      <a:lnTo>
                        <a:pt x="1833" y="40"/>
                      </a:lnTo>
                      <a:lnTo>
                        <a:pt x="1833" y="39"/>
                      </a:lnTo>
                      <a:lnTo>
                        <a:pt x="1834" y="39"/>
                      </a:lnTo>
                      <a:lnTo>
                        <a:pt x="1834" y="37"/>
                      </a:lnTo>
                      <a:lnTo>
                        <a:pt x="1834" y="41"/>
                      </a:lnTo>
                      <a:lnTo>
                        <a:pt x="1834" y="38"/>
                      </a:lnTo>
                      <a:lnTo>
                        <a:pt x="1835" y="38"/>
                      </a:lnTo>
                      <a:lnTo>
                        <a:pt x="1835" y="38"/>
                      </a:lnTo>
                      <a:lnTo>
                        <a:pt x="1835" y="41"/>
                      </a:lnTo>
                      <a:lnTo>
                        <a:pt x="1835" y="38"/>
                      </a:lnTo>
                      <a:lnTo>
                        <a:pt x="1836" y="38"/>
                      </a:lnTo>
                      <a:lnTo>
                        <a:pt x="1836" y="37"/>
                      </a:lnTo>
                      <a:lnTo>
                        <a:pt x="1836" y="41"/>
                      </a:lnTo>
                      <a:lnTo>
                        <a:pt x="1836" y="39"/>
                      </a:lnTo>
                      <a:lnTo>
                        <a:pt x="1837" y="39"/>
                      </a:lnTo>
                      <a:lnTo>
                        <a:pt x="1837" y="38"/>
                      </a:lnTo>
                      <a:lnTo>
                        <a:pt x="1837" y="41"/>
                      </a:lnTo>
                      <a:lnTo>
                        <a:pt x="1837" y="38"/>
                      </a:lnTo>
                      <a:lnTo>
                        <a:pt x="1838" y="38"/>
                      </a:lnTo>
                      <a:lnTo>
                        <a:pt x="1838" y="37"/>
                      </a:lnTo>
                      <a:lnTo>
                        <a:pt x="1838" y="40"/>
                      </a:lnTo>
                      <a:lnTo>
                        <a:pt x="1838" y="39"/>
                      </a:lnTo>
                      <a:lnTo>
                        <a:pt x="1839" y="39"/>
                      </a:lnTo>
                      <a:lnTo>
                        <a:pt x="1839" y="35"/>
                      </a:lnTo>
                      <a:lnTo>
                        <a:pt x="1839" y="40"/>
                      </a:lnTo>
                      <a:lnTo>
                        <a:pt x="1839" y="39"/>
                      </a:lnTo>
                      <a:lnTo>
                        <a:pt x="1840" y="39"/>
                      </a:lnTo>
                      <a:lnTo>
                        <a:pt x="1840" y="37"/>
                      </a:lnTo>
                      <a:lnTo>
                        <a:pt x="1840" y="41"/>
                      </a:lnTo>
                      <a:lnTo>
                        <a:pt x="1840" y="41"/>
                      </a:lnTo>
                      <a:lnTo>
                        <a:pt x="1841" y="41"/>
                      </a:lnTo>
                      <a:lnTo>
                        <a:pt x="1841" y="38"/>
                      </a:lnTo>
                      <a:lnTo>
                        <a:pt x="1841" y="40"/>
                      </a:lnTo>
                      <a:lnTo>
                        <a:pt x="1841" y="40"/>
                      </a:lnTo>
                      <a:lnTo>
                        <a:pt x="1842" y="40"/>
                      </a:lnTo>
                      <a:lnTo>
                        <a:pt x="1842" y="38"/>
                      </a:lnTo>
                      <a:lnTo>
                        <a:pt x="1842" y="40"/>
                      </a:lnTo>
                      <a:lnTo>
                        <a:pt x="1842" y="38"/>
                      </a:lnTo>
                      <a:lnTo>
                        <a:pt x="1843" y="38"/>
                      </a:lnTo>
                      <a:lnTo>
                        <a:pt x="1843" y="37"/>
                      </a:lnTo>
                      <a:lnTo>
                        <a:pt x="1843" y="41"/>
                      </a:lnTo>
                      <a:lnTo>
                        <a:pt x="1843" y="40"/>
                      </a:lnTo>
                      <a:lnTo>
                        <a:pt x="1844" y="40"/>
                      </a:lnTo>
                      <a:lnTo>
                        <a:pt x="1844" y="37"/>
                      </a:lnTo>
                      <a:lnTo>
                        <a:pt x="1844" y="40"/>
                      </a:lnTo>
                      <a:lnTo>
                        <a:pt x="1844" y="39"/>
                      </a:lnTo>
                      <a:lnTo>
                        <a:pt x="1845" y="39"/>
                      </a:lnTo>
                      <a:lnTo>
                        <a:pt x="1845" y="37"/>
                      </a:lnTo>
                      <a:lnTo>
                        <a:pt x="1845" y="40"/>
                      </a:lnTo>
                      <a:lnTo>
                        <a:pt x="1845" y="40"/>
                      </a:lnTo>
                      <a:lnTo>
                        <a:pt x="1846" y="40"/>
                      </a:lnTo>
                      <a:lnTo>
                        <a:pt x="1846" y="37"/>
                      </a:lnTo>
                      <a:lnTo>
                        <a:pt x="1846" y="40"/>
                      </a:lnTo>
                      <a:lnTo>
                        <a:pt x="1846" y="38"/>
                      </a:lnTo>
                      <a:lnTo>
                        <a:pt x="1847" y="38"/>
                      </a:lnTo>
                      <a:lnTo>
                        <a:pt x="1847" y="37"/>
                      </a:lnTo>
                      <a:lnTo>
                        <a:pt x="1847" y="40"/>
                      </a:lnTo>
                      <a:lnTo>
                        <a:pt x="1847" y="39"/>
                      </a:lnTo>
                      <a:lnTo>
                        <a:pt x="1848" y="39"/>
                      </a:lnTo>
                      <a:lnTo>
                        <a:pt x="1848" y="37"/>
                      </a:lnTo>
                      <a:lnTo>
                        <a:pt x="1848" y="41"/>
                      </a:lnTo>
                      <a:lnTo>
                        <a:pt x="1848" y="37"/>
                      </a:lnTo>
                      <a:lnTo>
                        <a:pt x="1849" y="37"/>
                      </a:lnTo>
                      <a:lnTo>
                        <a:pt x="1849" y="36"/>
                      </a:lnTo>
                      <a:lnTo>
                        <a:pt x="1849" y="40"/>
                      </a:lnTo>
                      <a:lnTo>
                        <a:pt x="1849" y="39"/>
                      </a:lnTo>
                      <a:lnTo>
                        <a:pt x="1850" y="39"/>
                      </a:lnTo>
                      <a:lnTo>
                        <a:pt x="1850" y="37"/>
                      </a:lnTo>
                      <a:lnTo>
                        <a:pt x="1850" y="41"/>
                      </a:lnTo>
                      <a:lnTo>
                        <a:pt x="1850" y="40"/>
                      </a:lnTo>
                      <a:lnTo>
                        <a:pt x="1851" y="40"/>
                      </a:lnTo>
                      <a:lnTo>
                        <a:pt x="1851" y="38"/>
                      </a:lnTo>
                      <a:lnTo>
                        <a:pt x="1851" y="41"/>
                      </a:lnTo>
                      <a:lnTo>
                        <a:pt x="1851" y="40"/>
                      </a:lnTo>
                      <a:lnTo>
                        <a:pt x="1852" y="40"/>
                      </a:lnTo>
                      <a:lnTo>
                        <a:pt x="1852" y="37"/>
                      </a:lnTo>
                      <a:lnTo>
                        <a:pt x="1852" y="41"/>
                      </a:lnTo>
                      <a:lnTo>
                        <a:pt x="1852" y="40"/>
                      </a:lnTo>
                      <a:lnTo>
                        <a:pt x="1853" y="40"/>
                      </a:lnTo>
                      <a:lnTo>
                        <a:pt x="1853" y="38"/>
                      </a:lnTo>
                      <a:lnTo>
                        <a:pt x="1853" y="41"/>
                      </a:lnTo>
                      <a:lnTo>
                        <a:pt x="1853" y="39"/>
                      </a:lnTo>
                      <a:lnTo>
                        <a:pt x="1854" y="39"/>
                      </a:lnTo>
                      <a:lnTo>
                        <a:pt x="1854" y="39"/>
                      </a:lnTo>
                      <a:lnTo>
                        <a:pt x="1854" y="41"/>
                      </a:lnTo>
                      <a:lnTo>
                        <a:pt x="1854" y="41"/>
                      </a:lnTo>
                      <a:lnTo>
                        <a:pt x="1855" y="41"/>
                      </a:lnTo>
                      <a:lnTo>
                        <a:pt x="1855" y="39"/>
                      </a:lnTo>
                      <a:lnTo>
                        <a:pt x="1855" y="42"/>
                      </a:lnTo>
                      <a:lnTo>
                        <a:pt x="1855" y="40"/>
                      </a:lnTo>
                      <a:lnTo>
                        <a:pt x="1856" y="40"/>
                      </a:lnTo>
                      <a:lnTo>
                        <a:pt x="1856" y="39"/>
                      </a:lnTo>
                      <a:lnTo>
                        <a:pt x="1856" y="41"/>
                      </a:lnTo>
                      <a:lnTo>
                        <a:pt x="1856" y="41"/>
                      </a:lnTo>
                      <a:lnTo>
                        <a:pt x="1857" y="41"/>
                      </a:lnTo>
                      <a:lnTo>
                        <a:pt x="1857" y="39"/>
                      </a:lnTo>
                      <a:lnTo>
                        <a:pt x="1857" y="41"/>
                      </a:lnTo>
                      <a:lnTo>
                        <a:pt x="1857" y="39"/>
                      </a:lnTo>
                      <a:lnTo>
                        <a:pt x="1858" y="39"/>
                      </a:lnTo>
                      <a:lnTo>
                        <a:pt x="1858" y="38"/>
                      </a:lnTo>
                      <a:lnTo>
                        <a:pt x="1858" y="42"/>
                      </a:lnTo>
                      <a:lnTo>
                        <a:pt x="1858" y="40"/>
                      </a:lnTo>
                      <a:lnTo>
                        <a:pt x="1859" y="40"/>
                      </a:lnTo>
                      <a:lnTo>
                        <a:pt x="1859" y="39"/>
                      </a:lnTo>
                      <a:lnTo>
                        <a:pt x="1859" y="42"/>
                      </a:lnTo>
                      <a:lnTo>
                        <a:pt x="1859" y="40"/>
                      </a:lnTo>
                      <a:lnTo>
                        <a:pt x="1860" y="40"/>
                      </a:lnTo>
                      <a:lnTo>
                        <a:pt x="1860" y="40"/>
                      </a:lnTo>
                      <a:lnTo>
                        <a:pt x="1860" y="41"/>
                      </a:lnTo>
                      <a:lnTo>
                        <a:pt x="1860" y="41"/>
                      </a:lnTo>
                      <a:lnTo>
                        <a:pt x="1861" y="41"/>
                      </a:lnTo>
                      <a:lnTo>
                        <a:pt x="1861" y="40"/>
                      </a:lnTo>
                      <a:lnTo>
                        <a:pt x="1861" y="43"/>
                      </a:lnTo>
                      <a:lnTo>
                        <a:pt x="1861" y="40"/>
                      </a:lnTo>
                      <a:lnTo>
                        <a:pt x="1862" y="40"/>
                      </a:lnTo>
                      <a:lnTo>
                        <a:pt x="1862" y="40"/>
                      </a:lnTo>
                      <a:lnTo>
                        <a:pt x="1862" y="43"/>
                      </a:lnTo>
                      <a:lnTo>
                        <a:pt x="1862" y="40"/>
                      </a:lnTo>
                      <a:lnTo>
                        <a:pt x="1863" y="40"/>
                      </a:lnTo>
                      <a:lnTo>
                        <a:pt x="1863" y="41"/>
                      </a:lnTo>
                      <a:lnTo>
                        <a:pt x="1863" y="43"/>
                      </a:lnTo>
                      <a:lnTo>
                        <a:pt x="1863" y="43"/>
                      </a:lnTo>
                      <a:lnTo>
                        <a:pt x="1864" y="43"/>
                      </a:lnTo>
                      <a:lnTo>
                        <a:pt x="1864" y="40"/>
                      </a:lnTo>
                      <a:lnTo>
                        <a:pt x="1864" y="43"/>
                      </a:lnTo>
                      <a:lnTo>
                        <a:pt x="1864" y="41"/>
                      </a:lnTo>
                      <a:lnTo>
                        <a:pt x="1865" y="41"/>
                      </a:lnTo>
                      <a:lnTo>
                        <a:pt x="1865" y="40"/>
                      </a:lnTo>
                      <a:lnTo>
                        <a:pt x="1865" y="43"/>
                      </a:lnTo>
                      <a:lnTo>
                        <a:pt x="1865" y="42"/>
                      </a:lnTo>
                      <a:lnTo>
                        <a:pt x="1866" y="42"/>
                      </a:lnTo>
                      <a:lnTo>
                        <a:pt x="1866" y="40"/>
                      </a:lnTo>
                      <a:lnTo>
                        <a:pt x="1866" y="43"/>
                      </a:lnTo>
                      <a:lnTo>
                        <a:pt x="1866" y="41"/>
                      </a:lnTo>
                      <a:lnTo>
                        <a:pt x="1867" y="41"/>
                      </a:lnTo>
                      <a:lnTo>
                        <a:pt x="1867" y="39"/>
                      </a:lnTo>
                      <a:lnTo>
                        <a:pt x="1867" y="42"/>
                      </a:lnTo>
                      <a:lnTo>
                        <a:pt x="1867" y="40"/>
                      </a:lnTo>
                      <a:lnTo>
                        <a:pt x="1868" y="40"/>
                      </a:lnTo>
                      <a:lnTo>
                        <a:pt x="1868" y="39"/>
                      </a:lnTo>
                      <a:lnTo>
                        <a:pt x="1868" y="41"/>
                      </a:lnTo>
                      <a:lnTo>
                        <a:pt x="1868" y="39"/>
                      </a:lnTo>
                      <a:lnTo>
                        <a:pt x="1869" y="39"/>
                      </a:lnTo>
                      <a:lnTo>
                        <a:pt x="1869" y="39"/>
                      </a:lnTo>
                      <a:lnTo>
                        <a:pt x="1869" y="41"/>
                      </a:lnTo>
                      <a:lnTo>
                        <a:pt x="1869" y="41"/>
                      </a:lnTo>
                      <a:lnTo>
                        <a:pt x="1870" y="41"/>
                      </a:lnTo>
                      <a:lnTo>
                        <a:pt x="1870" y="40"/>
                      </a:lnTo>
                      <a:lnTo>
                        <a:pt x="1870" y="43"/>
                      </a:lnTo>
                      <a:lnTo>
                        <a:pt x="1870" y="40"/>
                      </a:lnTo>
                      <a:lnTo>
                        <a:pt x="1871" y="40"/>
                      </a:lnTo>
                      <a:lnTo>
                        <a:pt x="1871" y="39"/>
                      </a:lnTo>
                      <a:lnTo>
                        <a:pt x="1871" y="44"/>
                      </a:lnTo>
                      <a:lnTo>
                        <a:pt x="1871" y="42"/>
                      </a:lnTo>
                      <a:lnTo>
                        <a:pt x="1872" y="42"/>
                      </a:lnTo>
                      <a:lnTo>
                        <a:pt x="1872" y="40"/>
                      </a:lnTo>
                      <a:lnTo>
                        <a:pt x="1872" y="43"/>
                      </a:lnTo>
                      <a:lnTo>
                        <a:pt x="1872" y="41"/>
                      </a:lnTo>
                      <a:lnTo>
                        <a:pt x="1873" y="41"/>
                      </a:lnTo>
                      <a:lnTo>
                        <a:pt x="1873" y="39"/>
                      </a:lnTo>
                      <a:lnTo>
                        <a:pt x="1873" y="43"/>
                      </a:lnTo>
                      <a:lnTo>
                        <a:pt x="1873" y="41"/>
                      </a:lnTo>
                      <a:lnTo>
                        <a:pt x="1874" y="41"/>
                      </a:lnTo>
                      <a:lnTo>
                        <a:pt x="1874" y="38"/>
                      </a:lnTo>
                      <a:lnTo>
                        <a:pt x="1874" y="41"/>
                      </a:lnTo>
                      <a:lnTo>
                        <a:pt x="1874" y="41"/>
                      </a:lnTo>
                      <a:lnTo>
                        <a:pt x="1875" y="41"/>
                      </a:lnTo>
                      <a:lnTo>
                        <a:pt x="1875" y="38"/>
                      </a:lnTo>
                      <a:lnTo>
                        <a:pt x="1875" y="44"/>
                      </a:lnTo>
                      <a:lnTo>
                        <a:pt x="1875" y="40"/>
                      </a:lnTo>
                      <a:lnTo>
                        <a:pt x="1876" y="40"/>
                      </a:lnTo>
                      <a:lnTo>
                        <a:pt x="1876" y="39"/>
                      </a:lnTo>
                      <a:lnTo>
                        <a:pt x="1876" y="43"/>
                      </a:lnTo>
                      <a:lnTo>
                        <a:pt x="1876" y="40"/>
                      </a:lnTo>
                      <a:lnTo>
                        <a:pt x="1877" y="40"/>
                      </a:lnTo>
                      <a:lnTo>
                        <a:pt x="1877" y="39"/>
                      </a:lnTo>
                      <a:lnTo>
                        <a:pt x="1877" y="41"/>
                      </a:lnTo>
                      <a:lnTo>
                        <a:pt x="1877" y="39"/>
                      </a:lnTo>
                      <a:lnTo>
                        <a:pt x="1878" y="39"/>
                      </a:lnTo>
                      <a:lnTo>
                        <a:pt x="1878" y="37"/>
                      </a:lnTo>
                      <a:lnTo>
                        <a:pt x="1878" y="41"/>
                      </a:lnTo>
                      <a:lnTo>
                        <a:pt x="1878" y="41"/>
                      </a:lnTo>
                      <a:lnTo>
                        <a:pt x="1879" y="41"/>
                      </a:lnTo>
                      <a:lnTo>
                        <a:pt x="1879" y="39"/>
                      </a:lnTo>
                      <a:lnTo>
                        <a:pt x="1879" y="42"/>
                      </a:lnTo>
                      <a:lnTo>
                        <a:pt x="1879" y="40"/>
                      </a:lnTo>
                      <a:lnTo>
                        <a:pt x="1880" y="40"/>
                      </a:lnTo>
                      <a:lnTo>
                        <a:pt x="1880" y="39"/>
                      </a:lnTo>
                      <a:lnTo>
                        <a:pt x="1880" y="41"/>
                      </a:lnTo>
                      <a:lnTo>
                        <a:pt x="1880" y="40"/>
                      </a:lnTo>
                      <a:lnTo>
                        <a:pt x="1881" y="40"/>
                      </a:lnTo>
                      <a:lnTo>
                        <a:pt x="1881" y="40"/>
                      </a:lnTo>
                      <a:lnTo>
                        <a:pt x="1881" y="42"/>
                      </a:lnTo>
                      <a:lnTo>
                        <a:pt x="1881" y="42"/>
                      </a:lnTo>
                      <a:lnTo>
                        <a:pt x="1882" y="42"/>
                      </a:lnTo>
                      <a:lnTo>
                        <a:pt x="1882" y="39"/>
                      </a:lnTo>
                      <a:lnTo>
                        <a:pt x="1882" y="42"/>
                      </a:lnTo>
                      <a:lnTo>
                        <a:pt x="1882" y="40"/>
                      </a:lnTo>
                      <a:lnTo>
                        <a:pt x="1883" y="40"/>
                      </a:lnTo>
                      <a:lnTo>
                        <a:pt x="1883" y="39"/>
                      </a:lnTo>
                      <a:lnTo>
                        <a:pt x="1883" y="41"/>
                      </a:lnTo>
                      <a:lnTo>
                        <a:pt x="1883" y="41"/>
                      </a:lnTo>
                      <a:lnTo>
                        <a:pt x="1884" y="41"/>
                      </a:lnTo>
                      <a:lnTo>
                        <a:pt x="1884" y="39"/>
                      </a:lnTo>
                      <a:lnTo>
                        <a:pt x="1884" y="43"/>
                      </a:lnTo>
                      <a:lnTo>
                        <a:pt x="1884" y="40"/>
                      </a:lnTo>
                      <a:lnTo>
                        <a:pt x="1885" y="40"/>
                      </a:lnTo>
                      <a:lnTo>
                        <a:pt x="1885" y="39"/>
                      </a:lnTo>
                      <a:lnTo>
                        <a:pt x="1885" y="41"/>
                      </a:lnTo>
                      <a:lnTo>
                        <a:pt x="1885" y="41"/>
                      </a:lnTo>
                      <a:lnTo>
                        <a:pt x="1886" y="41"/>
                      </a:lnTo>
                      <a:lnTo>
                        <a:pt x="1886" y="38"/>
                      </a:lnTo>
                      <a:lnTo>
                        <a:pt x="1886" y="42"/>
                      </a:lnTo>
                      <a:lnTo>
                        <a:pt x="1886" y="42"/>
                      </a:lnTo>
                      <a:lnTo>
                        <a:pt x="1887" y="42"/>
                      </a:lnTo>
                      <a:lnTo>
                        <a:pt x="1887" y="41"/>
                      </a:lnTo>
                      <a:lnTo>
                        <a:pt x="1887" y="43"/>
                      </a:lnTo>
                      <a:lnTo>
                        <a:pt x="1887" y="43"/>
                      </a:lnTo>
                      <a:lnTo>
                        <a:pt x="1888" y="43"/>
                      </a:lnTo>
                      <a:lnTo>
                        <a:pt x="1888" y="40"/>
                      </a:lnTo>
                      <a:lnTo>
                        <a:pt x="1888" y="43"/>
                      </a:lnTo>
                      <a:lnTo>
                        <a:pt x="1888" y="42"/>
                      </a:lnTo>
                      <a:lnTo>
                        <a:pt x="1889" y="42"/>
                      </a:lnTo>
                      <a:lnTo>
                        <a:pt x="1889" y="40"/>
                      </a:lnTo>
                      <a:lnTo>
                        <a:pt x="1889" y="43"/>
                      </a:lnTo>
                      <a:lnTo>
                        <a:pt x="1889" y="43"/>
                      </a:lnTo>
                      <a:lnTo>
                        <a:pt x="1890" y="43"/>
                      </a:lnTo>
                      <a:lnTo>
                        <a:pt x="1890" y="40"/>
                      </a:lnTo>
                      <a:lnTo>
                        <a:pt x="1890" y="43"/>
                      </a:lnTo>
                      <a:lnTo>
                        <a:pt x="1890" y="41"/>
                      </a:lnTo>
                      <a:lnTo>
                        <a:pt x="1891" y="41"/>
                      </a:lnTo>
                      <a:lnTo>
                        <a:pt x="1891" y="40"/>
                      </a:lnTo>
                      <a:lnTo>
                        <a:pt x="1891" y="41"/>
                      </a:lnTo>
                      <a:lnTo>
                        <a:pt x="1891" y="41"/>
                      </a:lnTo>
                      <a:lnTo>
                        <a:pt x="1892" y="41"/>
                      </a:lnTo>
                      <a:lnTo>
                        <a:pt x="1892" y="39"/>
                      </a:lnTo>
                      <a:lnTo>
                        <a:pt x="1892" y="42"/>
                      </a:lnTo>
                      <a:lnTo>
                        <a:pt x="1892" y="40"/>
                      </a:lnTo>
                      <a:lnTo>
                        <a:pt x="1893" y="40"/>
                      </a:lnTo>
                      <a:lnTo>
                        <a:pt x="1893" y="38"/>
                      </a:lnTo>
                      <a:lnTo>
                        <a:pt x="1893" y="41"/>
                      </a:lnTo>
                      <a:lnTo>
                        <a:pt x="1893" y="40"/>
                      </a:lnTo>
                      <a:lnTo>
                        <a:pt x="1894" y="40"/>
                      </a:lnTo>
                      <a:lnTo>
                        <a:pt x="1894" y="37"/>
                      </a:lnTo>
                      <a:lnTo>
                        <a:pt x="1894" y="41"/>
                      </a:lnTo>
                      <a:lnTo>
                        <a:pt x="1894" y="40"/>
                      </a:lnTo>
                      <a:lnTo>
                        <a:pt x="1895" y="40"/>
                      </a:lnTo>
                      <a:lnTo>
                        <a:pt x="1895" y="38"/>
                      </a:lnTo>
                      <a:lnTo>
                        <a:pt x="1895" y="40"/>
                      </a:lnTo>
                      <a:lnTo>
                        <a:pt x="1895" y="39"/>
                      </a:lnTo>
                      <a:lnTo>
                        <a:pt x="1896" y="39"/>
                      </a:lnTo>
                      <a:lnTo>
                        <a:pt x="1896" y="38"/>
                      </a:lnTo>
                      <a:lnTo>
                        <a:pt x="1896" y="41"/>
                      </a:lnTo>
                      <a:lnTo>
                        <a:pt x="1896" y="41"/>
                      </a:lnTo>
                      <a:lnTo>
                        <a:pt x="1897" y="41"/>
                      </a:lnTo>
                      <a:lnTo>
                        <a:pt x="1897" y="38"/>
                      </a:lnTo>
                      <a:lnTo>
                        <a:pt x="1897" y="43"/>
                      </a:lnTo>
                      <a:lnTo>
                        <a:pt x="1897" y="40"/>
                      </a:lnTo>
                      <a:lnTo>
                        <a:pt x="1898" y="40"/>
                      </a:lnTo>
                      <a:lnTo>
                        <a:pt x="1898" y="39"/>
                      </a:lnTo>
                      <a:lnTo>
                        <a:pt x="1898" y="42"/>
                      </a:lnTo>
                      <a:lnTo>
                        <a:pt x="1898" y="42"/>
                      </a:lnTo>
                      <a:lnTo>
                        <a:pt x="1899" y="42"/>
                      </a:lnTo>
                      <a:lnTo>
                        <a:pt x="1899" y="38"/>
                      </a:lnTo>
                      <a:lnTo>
                        <a:pt x="1899" y="41"/>
                      </a:lnTo>
                      <a:lnTo>
                        <a:pt x="1899" y="40"/>
                      </a:lnTo>
                      <a:lnTo>
                        <a:pt x="1900" y="40"/>
                      </a:lnTo>
                      <a:lnTo>
                        <a:pt x="1900" y="38"/>
                      </a:lnTo>
                      <a:lnTo>
                        <a:pt x="1900" y="41"/>
                      </a:lnTo>
                      <a:lnTo>
                        <a:pt x="1900" y="41"/>
                      </a:lnTo>
                      <a:lnTo>
                        <a:pt x="1901" y="41"/>
                      </a:lnTo>
                      <a:lnTo>
                        <a:pt x="1901" y="39"/>
                      </a:lnTo>
                      <a:lnTo>
                        <a:pt x="1901" y="43"/>
                      </a:lnTo>
                      <a:lnTo>
                        <a:pt x="1901" y="39"/>
                      </a:lnTo>
                      <a:lnTo>
                        <a:pt x="1902" y="39"/>
                      </a:lnTo>
                      <a:lnTo>
                        <a:pt x="1902" y="37"/>
                      </a:lnTo>
                      <a:lnTo>
                        <a:pt x="1902" y="41"/>
                      </a:lnTo>
                      <a:lnTo>
                        <a:pt x="1902" y="38"/>
                      </a:lnTo>
                      <a:lnTo>
                        <a:pt x="1903" y="38"/>
                      </a:lnTo>
                      <a:lnTo>
                        <a:pt x="1903" y="38"/>
                      </a:lnTo>
                      <a:lnTo>
                        <a:pt x="1903" y="41"/>
                      </a:lnTo>
                      <a:lnTo>
                        <a:pt x="1903" y="40"/>
                      </a:lnTo>
                      <a:lnTo>
                        <a:pt x="1904" y="40"/>
                      </a:lnTo>
                      <a:lnTo>
                        <a:pt x="1904" y="40"/>
                      </a:lnTo>
                      <a:lnTo>
                        <a:pt x="1904" y="43"/>
                      </a:lnTo>
                      <a:lnTo>
                        <a:pt x="1904" y="41"/>
                      </a:lnTo>
                      <a:lnTo>
                        <a:pt x="1905" y="41"/>
                      </a:lnTo>
                      <a:lnTo>
                        <a:pt x="1905" y="40"/>
                      </a:lnTo>
                      <a:lnTo>
                        <a:pt x="1905" y="43"/>
                      </a:lnTo>
                      <a:lnTo>
                        <a:pt x="1905" y="41"/>
                      </a:lnTo>
                      <a:lnTo>
                        <a:pt x="1906" y="41"/>
                      </a:lnTo>
                      <a:lnTo>
                        <a:pt x="1906" y="40"/>
                      </a:lnTo>
                      <a:lnTo>
                        <a:pt x="1906" y="43"/>
                      </a:lnTo>
                      <a:lnTo>
                        <a:pt x="1906" y="42"/>
                      </a:lnTo>
                      <a:lnTo>
                        <a:pt x="1907" y="42"/>
                      </a:lnTo>
                      <a:lnTo>
                        <a:pt x="1907" y="39"/>
                      </a:lnTo>
                      <a:lnTo>
                        <a:pt x="1907" y="43"/>
                      </a:lnTo>
                      <a:lnTo>
                        <a:pt x="1907" y="43"/>
                      </a:lnTo>
                      <a:lnTo>
                        <a:pt x="1908" y="43"/>
                      </a:lnTo>
                      <a:lnTo>
                        <a:pt x="1908" y="40"/>
                      </a:lnTo>
                      <a:lnTo>
                        <a:pt x="1908" y="44"/>
                      </a:lnTo>
                      <a:lnTo>
                        <a:pt x="1908" y="41"/>
                      </a:lnTo>
                      <a:lnTo>
                        <a:pt x="1909" y="41"/>
                      </a:lnTo>
                      <a:lnTo>
                        <a:pt x="1909" y="40"/>
                      </a:lnTo>
                      <a:lnTo>
                        <a:pt x="1909" y="43"/>
                      </a:lnTo>
                      <a:lnTo>
                        <a:pt x="1909" y="41"/>
                      </a:lnTo>
                      <a:lnTo>
                        <a:pt x="1910" y="41"/>
                      </a:lnTo>
                      <a:lnTo>
                        <a:pt x="1910" y="38"/>
                      </a:lnTo>
                      <a:lnTo>
                        <a:pt x="1910" y="41"/>
                      </a:lnTo>
                      <a:lnTo>
                        <a:pt x="1910" y="41"/>
                      </a:lnTo>
                      <a:lnTo>
                        <a:pt x="1911" y="41"/>
                      </a:lnTo>
                      <a:lnTo>
                        <a:pt x="1911" y="40"/>
                      </a:lnTo>
                      <a:lnTo>
                        <a:pt x="1911" y="41"/>
                      </a:lnTo>
                      <a:lnTo>
                        <a:pt x="1911" y="41"/>
                      </a:lnTo>
                      <a:lnTo>
                        <a:pt x="1912" y="41"/>
                      </a:lnTo>
                      <a:lnTo>
                        <a:pt x="1912" y="40"/>
                      </a:lnTo>
                      <a:lnTo>
                        <a:pt x="1912" y="43"/>
                      </a:lnTo>
                      <a:lnTo>
                        <a:pt x="1912" y="42"/>
                      </a:lnTo>
                      <a:lnTo>
                        <a:pt x="1913" y="42"/>
                      </a:lnTo>
                      <a:lnTo>
                        <a:pt x="1913" y="40"/>
                      </a:lnTo>
                      <a:lnTo>
                        <a:pt x="1913" y="43"/>
                      </a:lnTo>
                      <a:lnTo>
                        <a:pt x="1913" y="41"/>
                      </a:lnTo>
                      <a:lnTo>
                        <a:pt x="1914" y="41"/>
                      </a:lnTo>
                      <a:lnTo>
                        <a:pt x="1914" y="41"/>
                      </a:lnTo>
                      <a:lnTo>
                        <a:pt x="1914" y="43"/>
                      </a:lnTo>
                      <a:lnTo>
                        <a:pt x="1914" y="41"/>
                      </a:lnTo>
                      <a:lnTo>
                        <a:pt x="1915" y="41"/>
                      </a:lnTo>
                      <a:lnTo>
                        <a:pt x="1915" y="40"/>
                      </a:lnTo>
                      <a:lnTo>
                        <a:pt x="1915" y="44"/>
                      </a:lnTo>
                      <a:lnTo>
                        <a:pt x="1915" y="41"/>
                      </a:lnTo>
                      <a:lnTo>
                        <a:pt x="1916" y="41"/>
                      </a:lnTo>
                      <a:lnTo>
                        <a:pt x="1916" y="40"/>
                      </a:lnTo>
                      <a:lnTo>
                        <a:pt x="1916" y="42"/>
                      </a:lnTo>
                      <a:lnTo>
                        <a:pt x="1916" y="41"/>
                      </a:lnTo>
                      <a:lnTo>
                        <a:pt x="1917" y="41"/>
                      </a:lnTo>
                      <a:lnTo>
                        <a:pt x="1917" y="40"/>
                      </a:lnTo>
                      <a:lnTo>
                        <a:pt x="1917" y="43"/>
                      </a:lnTo>
                      <a:lnTo>
                        <a:pt x="1917" y="41"/>
                      </a:lnTo>
                      <a:lnTo>
                        <a:pt x="1918" y="41"/>
                      </a:lnTo>
                      <a:lnTo>
                        <a:pt x="1918" y="38"/>
                      </a:lnTo>
                      <a:lnTo>
                        <a:pt x="1918" y="41"/>
                      </a:lnTo>
                      <a:lnTo>
                        <a:pt x="1918" y="39"/>
                      </a:lnTo>
                      <a:lnTo>
                        <a:pt x="1919" y="39"/>
                      </a:lnTo>
                      <a:lnTo>
                        <a:pt x="1919" y="37"/>
                      </a:lnTo>
                      <a:lnTo>
                        <a:pt x="1919" y="41"/>
                      </a:lnTo>
                      <a:lnTo>
                        <a:pt x="1919" y="41"/>
                      </a:lnTo>
                      <a:lnTo>
                        <a:pt x="1920" y="41"/>
                      </a:lnTo>
                      <a:lnTo>
                        <a:pt x="1920" y="38"/>
                      </a:lnTo>
                      <a:lnTo>
                        <a:pt x="1920" y="41"/>
                      </a:lnTo>
                      <a:lnTo>
                        <a:pt x="1920" y="40"/>
                      </a:lnTo>
                      <a:lnTo>
                        <a:pt x="1921" y="40"/>
                      </a:lnTo>
                      <a:lnTo>
                        <a:pt x="1921" y="40"/>
                      </a:lnTo>
                      <a:lnTo>
                        <a:pt x="1921" y="42"/>
                      </a:lnTo>
                      <a:lnTo>
                        <a:pt x="1921" y="40"/>
                      </a:lnTo>
                      <a:lnTo>
                        <a:pt x="1922" y="40"/>
                      </a:lnTo>
                      <a:lnTo>
                        <a:pt x="1922" y="40"/>
                      </a:lnTo>
                      <a:lnTo>
                        <a:pt x="1922" y="43"/>
                      </a:lnTo>
                      <a:lnTo>
                        <a:pt x="1922" y="42"/>
                      </a:lnTo>
                      <a:lnTo>
                        <a:pt x="1923" y="42"/>
                      </a:lnTo>
                      <a:lnTo>
                        <a:pt x="1923" y="40"/>
                      </a:lnTo>
                      <a:lnTo>
                        <a:pt x="1923" y="43"/>
                      </a:lnTo>
                      <a:lnTo>
                        <a:pt x="1923" y="41"/>
                      </a:lnTo>
                      <a:lnTo>
                        <a:pt x="1924" y="41"/>
                      </a:lnTo>
                      <a:lnTo>
                        <a:pt x="1924" y="41"/>
                      </a:lnTo>
                      <a:lnTo>
                        <a:pt x="1924" y="43"/>
                      </a:lnTo>
                      <a:lnTo>
                        <a:pt x="1924" y="41"/>
                      </a:lnTo>
                      <a:lnTo>
                        <a:pt x="1925" y="41"/>
                      </a:lnTo>
                      <a:lnTo>
                        <a:pt x="1925" y="41"/>
                      </a:lnTo>
                      <a:lnTo>
                        <a:pt x="1925" y="43"/>
                      </a:lnTo>
                      <a:lnTo>
                        <a:pt x="1925" y="41"/>
                      </a:lnTo>
                      <a:lnTo>
                        <a:pt x="1926" y="41"/>
                      </a:lnTo>
                      <a:lnTo>
                        <a:pt x="1926" y="41"/>
                      </a:lnTo>
                      <a:lnTo>
                        <a:pt x="1926" y="43"/>
                      </a:lnTo>
                      <a:lnTo>
                        <a:pt x="1926" y="41"/>
                      </a:lnTo>
                      <a:lnTo>
                        <a:pt x="1927" y="41"/>
                      </a:lnTo>
                      <a:lnTo>
                        <a:pt x="1927" y="40"/>
                      </a:lnTo>
                      <a:lnTo>
                        <a:pt x="1927" y="43"/>
                      </a:lnTo>
                      <a:lnTo>
                        <a:pt x="1927" y="42"/>
                      </a:lnTo>
                      <a:lnTo>
                        <a:pt x="1928" y="42"/>
                      </a:lnTo>
                      <a:lnTo>
                        <a:pt x="1928" y="40"/>
                      </a:lnTo>
                      <a:lnTo>
                        <a:pt x="1928" y="42"/>
                      </a:lnTo>
                      <a:lnTo>
                        <a:pt x="1928" y="42"/>
                      </a:lnTo>
                      <a:lnTo>
                        <a:pt x="1929" y="42"/>
                      </a:lnTo>
                      <a:lnTo>
                        <a:pt x="1929" y="40"/>
                      </a:lnTo>
                      <a:lnTo>
                        <a:pt x="1929" y="41"/>
                      </a:lnTo>
                      <a:lnTo>
                        <a:pt x="1929" y="41"/>
                      </a:lnTo>
                      <a:lnTo>
                        <a:pt x="1930" y="41"/>
                      </a:lnTo>
                      <a:lnTo>
                        <a:pt x="1930" y="39"/>
                      </a:lnTo>
                      <a:lnTo>
                        <a:pt x="1930" y="42"/>
                      </a:lnTo>
                      <a:lnTo>
                        <a:pt x="1930" y="41"/>
                      </a:lnTo>
                      <a:lnTo>
                        <a:pt x="1931" y="41"/>
                      </a:lnTo>
                      <a:lnTo>
                        <a:pt x="1931" y="40"/>
                      </a:lnTo>
                      <a:lnTo>
                        <a:pt x="1931" y="43"/>
                      </a:lnTo>
                      <a:lnTo>
                        <a:pt x="1931" y="41"/>
                      </a:lnTo>
                      <a:lnTo>
                        <a:pt x="1932" y="41"/>
                      </a:lnTo>
                      <a:lnTo>
                        <a:pt x="1932" y="40"/>
                      </a:lnTo>
                      <a:lnTo>
                        <a:pt x="1932" y="43"/>
                      </a:lnTo>
                      <a:lnTo>
                        <a:pt x="1932" y="40"/>
                      </a:lnTo>
                      <a:lnTo>
                        <a:pt x="1933" y="40"/>
                      </a:lnTo>
                      <a:lnTo>
                        <a:pt x="1933" y="39"/>
                      </a:lnTo>
                      <a:lnTo>
                        <a:pt x="1933" y="42"/>
                      </a:lnTo>
                      <a:lnTo>
                        <a:pt x="1933" y="39"/>
                      </a:lnTo>
                      <a:lnTo>
                        <a:pt x="1934" y="39"/>
                      </a:lnTo>
                      <a:lnTo>
                        <a:pt x="1934" y="40"/>
                      </a:lnTo>
                      <a:lnTo>
                        <a:pt x="1934" y="43"/>
                      </a:lnTo>
                      <a:lnTo>
                        <a:pt x="1934" y="41"/>
                      </a:lnTo>
                      <a:lnTo>
                        <a:pt x="1935" y="41"/>
                      </a:lnTo>
                      <a:lnTo>
                        <a:pt x="1935" y="40"/>
                      </a:lnTo>
                      <a:lnTo>
                        <a:pt x="1935" y="43"/>
                      </a:lnTo>
                      <a:lnTo>
                        <a:pt x="1935" y="41"/>
                      </a:lnTo>
                      <a:lnTo>
                        <a:pt x="1936" y="41"/>
                      </a:lnTo>
                      <a:lnTo>
                        <a:pt x="1936" y="40"/>
                      </a:lnTo>
                      <a:lnTo>
                        <a:pt x="1936" y="43"/>
                      </a:lnTo>
                      <a:lnTo>
                        <a:pt x="1936" y="43"/>
                      </a:lnTo>
                      <a:lnTo>
                        <a:pt x="1937" y="43"/>
                      </a:lnTo>
                      <a:lnTo>
                        <a:pt x="1937" y="41"/>
                      </a:lnTo>
                      <a:lnTo>
                        <a:pt x="1937" y="43"/>
                      </a:lnTo>
                      <a:lnTo>
                        <a:pt x="1937" y="41"/>
                      </a:lnTo>
                      <a:lnTo>
                        <a:pt x="1938" y="41"/>
                      </a:lnTo>
                      <a:lnTo>
                        <a:pt x="1938" y="40"/>
                      </a:lnTo>
                      <a:lnTo>
                        <a:pt x="1938" y="42"/>
                      </a:lnTo>
                      <a:lnTo>
                        <a:pt x="1938" y="41"/>
                      </a:lnTo>
                      <a:lnTo>
                        <a:pt x="1939" y="41"/>
                      </a:lnTo>
                      <a:lnTo>
                        <a:pt x="1939" y="38"/>
                      </a:lnTo>
                      <a:lnTo>
                        <a:pt x="1939" y="42"/>
                      </a:lnTo>
                      <a:lnTo>
                        <a:pt x="1939" y="41"/>
                      </a:lnTo>
                      <a:lnTo>
                        <a:pt x="1940" y="41"/>
                      </a:lnTo>
                      <a:lnTo>
                        <a:pt x="1940" y="39"/>
                      </a:lnTo>
                      <a:lnTo>
                        <a:pt x="1940" y="42"/>
                      </a:lnTo>
                      <a:lnTo>
                        <a:pt x="1940" y="40"/>
                      </a:lnTo>
                      <a:lnTo>
                        <a:pt x="1941" y="40"/>
                      </a:lnTo>
                      <a:lnTo>
                        <a:pt x="1941" y="40"/>
                      </a:lnTo>
                      <a:lnTo>
                        <a:pt x="1941" y="43"/>
                      </a:lnTo>
                      <a:lnTo>
                        <a:pt x="1941" y="40"/>
                      </a:lnTo>
                      <a:lnTo>
                        <a:pt x="1942" y="40"/>
                      </a:lnTo>
                      <a:lnTo>
                        <a:pt x="1942" y="38"/>
                      </a:lnTo>
                      <a:lnTo>
                        <a:pt x="1942" y="41"/>
                      </a:lnTo>
                      <a:lnTo>
                        <a:pt x="1942" y="41"/>
                      </a:lnTo>
                      <a:lnTo>
                        <a:pt x="1943" y="41"/>
                      </a:lnTo>
                      <a:lnTo>
                        <a:pt x="1943" y="40"/>
                      </a:lnTo>
                      <a:lnTo>
                        <a:pt x="1943" y="43"/>
                      </a:lnTo>
                      <a:lnTo>
                        <a:pt x="1943" y="41"/>
                      </a:lnTo>
                      <a:lnTo>
                        <a:pt x="1944" y="41"/>
                      </a:lnTo>
                      <a:lnTo>
                        <a:pt x="1944" y="40"/>
                      </a:lnTo>
                      <a:lnTo>
                        <a:pt x="1944" y="44"/>
                      </a:lnTo>
                      <a:lnTo>
                        <a:pt x="1944" y="40"/>
                      </a:lnTo>
                      <a:lnTo>
                        <a:pt x="1945" y="40"/>
                      </a:lnTo>
                      <a:lnTo>
                        <a:pt x="1945" y="40"/>
                      </a:lnTo>
                      <a:lnTo>
                        <a:pt x="1945" y="43"/>
                      </a:lnTo>
                      <a:lnTo>
                        <a:pt x="1945" y="43"/>
                      </a:lnTo>
                      <a:lnTo>
                        <a:pt x="1946" y="43"/>
                      </a:lnTo>
                      <a:lnTo>
                        <a:pt x="1946" y="39"/>
                      </a:lnTo>
                      <a:lnTo>
                        <a:pt x="1946" y="42"/>
                      </a:lnTo>
                      <a:lnTo>
                        <a:pt x="1946" y="41"/>
                      </a:lnTo>
                      <a:lnTo>
                        <a:pt x="1947" y="41"/>
                      </a:lnTo>
                      <a:lnTo>
                        <a:pt x="1947" y="39"/>
                      </a:lnTo>
                      <a:lnTo>
                        <a:pt x="1947" y="43"/>
                      </a:lnTo>
                      <a:lnTo>
                        <a:pt x="1947" y="40"/>
                      </a:lnTo>
                      <a:lnTo>
                        <a:pt x="1948" y="40"/>
                      </a:lnTo>
                      <a:lnTo>
                        <a:pt x="1948" y="37"/>
                      </a:lnTo>
                      <a:lnTo>
                        <a:pt x="1948" y="40"/>
                      </a:lnTo>
                      <a:lnTo>
                        <a:pt x="1948" y="40"/>
                      </a:lnTo>
                      <a:lnTo>
                        <a:pt x="1949" y="40"/>
                      </a:lnTo>
                      <a:lnTo>
                        <a:pt x="1949" y="39"/>
                      </a:lnTo>
                      <a:lnTo>
                        <a:pt x="1949" y="41"/>
                      </a:lnTo>
                      <a:lnTo>
                        <a:pt x="1949" y="41"/>
                      </a:lnTo>
                      <a:lnTo>
                        <a:pt x="1950" y="41"/>
                      </a:lnTo>
                      <a:lnTo>
                        <a:pt x="1950" y="40"/>
                      </a:lnTo>
                      <a:lnTo>
                        <a:pt x="1950" y="41"/>
                      </a:lnTo>
                      <a:lnTo>
                        <a:pt x="1950" y="40"/>
                      </a:lnTo>
                      <a:lnTo>
                        <a:pt x="1951" y="40"/>
                      </a:lnTo>
                      <a:lnTo>
                        <a:pt x="1951" y="38"/>
                      </a:lnTo>
                      <a:lnTo>
                        <a:pt x="1951" y="43"/>
                      </a:lnTo>
                      <a:lnTo>
                        <a:pt x="1951" y="38"/>
                      </a:lnTo>
                      <a:lnTo>
                        <a:pt x="1952" y="38"/>
                      </a:lnTo>
                      <a:lnTo>
                        <a:pt x="1952" y="40"/>
                      </a:lnTo>
                      <a:lnTo>
                        <a:pt x="1952" y="43"/>
                      </a:lnTo>
                      <a:lnTo>
                        <a:pt x="1952" y="42"/>
                      </a:lnTo>
                      <a:lnTo>
                        <a:pt x="1953" y="42"/>
                      </a:lnTo>
                      <a:lnTo>
                        <a:pt x="1953" y="39"/>
                      </a:lnTo>
                      <a:lnTo>
                        <a:pt x="1953" y="43"/>
                      </a:lnTo>
                      <a:lnTo>
                        <a:pt x="1953" y="42"/>
                      </a:lnTo>
                      <a:lnTo>
                        <a:pt x="1954" y="42"/>
                      </a:lnTo>
                      <a:lnTo>
                        <a:pt x="1954" y="39"/>
                      </a:lnTo>
                      <a:lnTo>
                        <a:pt x="1954" y="41"/>
                      </a:lnTo>
                      <a:lnTo>
                        <a:pt x="1954" y="41"/>
                      </a:lnTo>
                      <a:lnTo>
                        <a:pt x="1955" y="41"/>
                      </a:lnTo>
                      <a:lnTo>
                        <a:pt x="1955" y="40"/>
                      </a:lnTo>
                      <a:lnTo>
                        <a:pt x="1955" y="43"/>
                      </a:lnTo>
                      <a:lnTo>
                        <a:pt x="1955" y="41"/>
                      </a:lnTo>
                      <a:lnTo>
                        <a:pt x="1956" y="41"/>
                      </a:lnTo>
                      <a:lnTo>
                        <a:pt x="1956" y="38"/>
                      </a:lnTo>
                      <a:lnTo>
                        <a:pt x="1956" y="42"/>
                      </a:lnTo>
                      <a:lnTo>
                        <a:pt x="1956" y="40"/>
                      </a:lnTo>
                      <a:lnTo>
                        <a:pt x="1957" y="40"/>
                      </a:lnTo>
                      <a:lnTo>
                        <a:pt x="1957" y="37"/>
                      </a:lnTo>
                      <a:lnTo>
                        <a:pt x="1957" y="41"/>
                      </a:lnTo>
                      <a:lnTo>
                        <a:pt x="1957" y="37"/>
                      </a:lnTo>
                      <a:lnTo>
                        <a:pt x="1958" y="37"/>
                      </a:lnTo>
                      <a:lnTo>
                        <a:pt x="1958" y="38"/>
                      </a:lnTo>
                      <a:lnTo>
                        <a:pt x="1958" y="41"/>
                      </a:lnTo>
                      <a:lnTo>
                        <a:pt x="1958" y="40"/>
                      </a:lnTo>
                      <a:lnTo>
                        <a:pt x="1959" y="40"/>
                      </a:lnTo>
                      <a:lnTo>
                        <a:pt x="1959" y="39"/>
                      </a:lnTo>
                      <a:lnTo>
                        <a:pt x="1959" y="42"/>
                      </a:lnTo>
                      <a:lnTo>
                        <a:pt x="1959" y="39"/>
                      </a:lnTo>
                      <a:lnTo>
                        <a:pt x="1960" y="39"/>
                      </a:lnTo>
                      <a:lnTo>
                        <a:pt x="1960" y="39"/>
                      </a:lnTo>
                      <a:lnTo>
                        <a:pt x="1960" y="42"/>
                      </a:lnTo>
                      <a:lnTo>
                        <a:pt x="1960" y="42"/>
                      </a:lnTo>
                      <a:lnTo>
                        <a:pt x="1961" y="42"/>
                      </a:lnTo>
                      <a:lnTo>
                        <a:pt x="1961" y="40"/>
                      </a:lnTo>
                      <a:lnTo>
                        <a:pt x="1961" y="43"/>
                      </a:lnTo>
                      <a:lnTo>
                        <a:pt x="1961" y="41"/>
                      </a:lnTo>
                      <a:lnTo>
                        <a:pt x="1962" y="41"/>
                      </a:lnTo>
                      <a:lnTo>
                        <a:pt x="1962" y="39"/>
                      </a:lnTo>
                      <a:lnTo>
                        <a:pt x="1962" y="41"/>
                      </a:lnTo>
                      <a:lnTo>
                        <a:pt x="1962" y="40"/>
                      </a:lnTo>
                      <a:lnTo>
                        <a:pt x="1963" y="40"/>
                      </a:lnTo>
                      <a:lnTo>
                        <a:pt x="1963" y="39"/>
                      </a:lnTo>
                      <a:lnTo>
                        <a:pt x="1963" y="41"/>
                      </a:lnTo>
                      <a:lnTo>
                        <a:pt x="1963" y="40"/>
                      </a:lnTo>
                      <a:lnTo>
                        <a:pt x="1964" y="40"/>
                      </a:lnTo>
                      <a:lnTo>
                        <a:pt x="1964" y="38"/>
                      </a:lnTo>
                      <a:lnTo>
                        <a:pt x="1964" y="41"/>
                      </a:lnTo>
                      <a:lnTo>
                        <a:pt x="1964" y="39"/>
                      </a:lnTo>
                      <a:lnTo>
                        <a:pt x="1965" y="39"/>
                      </a:lnTo>
                      <a:lnTo>
                        <a:pt x="1965" y="37"/>
                      </a:lnTo>
                      <a:lnTo>
                        <a:pt x="1965" y="40"/>
                      </a:lnTo>
                      <a:lnTo>
                        <a:pt x="1965" y="38"/>
                      </a:lnTo>
                      <a:lnTo>
                        <a:pt x="1966" y="38"/>
                      </a:lnTo>
                      <a:lnTo>
                        <a:pt x="1966" y="36"/>
                      </a:lnTo>
                      <a:lnTo>
                        <a:pt x="1966" y="40"/>
                      </a:lnTo>
                      <a:lnTo>
                        <a:pt x="1966" y="38"/>
                      </a:lnTo>
                      <a:lnTo>
                        <a:pt x="1967" y="38"/>
                      </a:lnTo>
                      <a:lnTo>
                        <a:pt x="1967" y="37"/>
                      </a:lnTo>
                      <a:lnTo>
                        <a:pt x="1967" y="40"/>
                      </a:lnTo>
                      <a:lnTo>
                        <a:pt x="1967" y="40"/>
                      </a:lnTo>
                      <a:lnTo>
                        <a:pt x="1968" y="40"/>
                      </a:lnTo>
                      <a:lnTo>
                        <a:pt x="1968" y="38"/>
                      </a:lnTo>
                      <a:lnTo>
                        <a:pt x="1968" y="41"/>
                      </a:lnTo>
                      <a:lnTo>
                        <a:pt x="1968" y="39"/>
                      </a:lnTo>
                      <a:lnTo>
                        <a:pt x="1969" y="39"/>
                      </a:lnTo>
                      <a:lnTo>
                        <a:pt x="1969" y="38"/>
                      </a:lnTo>
                      <a:lnTo>
                        <a:pt x="1969" y="41"/>
                      </a:lnTo>
                      <a:lnTo>
                        <a:pt x="1969" y="41"/>
                      </a:lnTo>
                      <a:lnTo>
                        <a:pt x="1970" y="41"/>
                      </a:lnTo>
                      <a:lnTo>
                        <a:pt x="1970" y="40"/>
                      </a:lnTo>
                      <a:lnTo>
                        <a:pt x="1970" y="41"/>
                      </a:lnTo>
                      <a:lnTo>
                        <a:pt x="1970" y="40"/>
                      </a:lnTo>
                      <a:lnTo>
                        <a:pt x="1971" y="40"/>
                      </a:lnTo>
                      <a:lnTo>
                        <a:pt x="1971" y="39"/>
                      </a:lnTo>
                      <a:lnTo>
                        <a:pt x="1971" y="43"/>
                      </a:lnTo>
                      <a:lnTo>
                        <a:pt x="1971" y="40"/>
                      </a:lnTo>
                      <a:lnTo>
                        <a:pt x="1972" y="40"/>
                      </a:lnTo>
                      <a:lnTo>
                        <a:pt x="1972" y="39"/>
                      </a:lnTo>
                      <a:lnTo>
                        <a:pt x="1972" y="43"/>
                      </a:lnTo>
                      <a:lnTo>
                        <a:pt x="1972" y="41"/>
                      </a:lnTo>
                      <a:lnTo>
                        <a:pt x="1973" y="41"/>
                      </a:lnTo>
                      <a:lnTo>
                        <a:pt x="1973" y="39"/>
                      </a:lnTo>
                      <a:lnTo>
                        <a:pt x="1973" y="42"/>
                      </a:lnTo>
                      <a:lnTo>
                        <a:pt x="1973" y="39"/>
                      </a:lnTo>
                      <a:lnTo>
                        <a:pt x="1974" y="39"/>
                      </a:lnTo>
                      <a:lnTo>
                        <a:pt x="1974" y="39"/>
                      </a:lnTo>
                      <a:lnTo>
                        <a:pt x="1974" y="43"/>
                      </a:lnTo>
                      <a:lnTo>
                        <a:pt x="1974" y="39"/>
                      </a:lnTo>
                      <a:lnTo>
                        <a:pt x="1975" y="39"/>
                      </a:lnTo>
                      <a:lnTo>
                        <a:pt x="1975" y="38"/>
                      </a:lnTo>
                      <a:lnTo>
                        <a:pt x="1975" y="41"/>
                      </a:lnTo>
                      <a:lnTo>
                        <a:pt x="1975" y="40"/>
                      </a:lnTo>
                      <a:lnTo>
                        <a:pt x="1976" y="40"/>
                      </a:lnTo>
                      <a:lnTo>
                        <a:pt x="1976" y="38"/>
                      </a:lnTo>
                      <a:lnTo>
                        <a:pt x="1976" y="41"/>
                      </a:lnTo>
                      <a:lnTo>
                        <a:pt x="1976" y="41"/>
                      </a:lnTo>
                      <a:lnTo>
                        <a:pt x="1977" y="41"/>
                      </a:lnTo>
                      <a:lnTo>
                        <a:pt x="1977" y="38"/>
                      </a:lnTo>
                      <a:lnTo>
                        <a:pt x="1977" y="42"/>
                      </a:lnTo>
                      <a:lnTo>
                        <a:pt x="1977" y="41"/>
                      </a:lnTo>
                      <a:lnTo>
                        <a:pt x="1978" y="41"/>
                      </a:lnTo>
                      <a:lnTo>
                        <a:pt x="1978" y="38"/>
                      </a:lnTo>
                      <a:lnTo>
                        <a:pt x="1978" y="42"/>
                      </a:lnTo>
                      <a:lnTo>
                        <a:pt x="1978" y="40"/>
                      </a:lnTo>
                      <a:lnTo>
                        <a:pt x="1979" y="40"/>
                      </a:lnTo>
                      <a:lnTo>
                        <a:pt x="1979" y="39"/>
                      </a:lnTo>
                      <a:lnTo>
                        <a:pt x="1979" y="41"/>
                      </a:lnTo>
                      <a:lnTo>
                        <a:pt x="1979" y="40"/>
                      </a:lnTo>
                      <a:lnTo>
                        <a:pt x="1980" y="40"/>
                      </a:lnTo>
                      <a:lnTo>
                        <a:pt x="1980" y="38"/>
                      </a:lnTo>
                      <a:lnTo>
                        <a:pt x="1980" y="41"/>
                      </a:lnTo>
                      <a:lnTo>
                        <a:pt x="1980" y="40"/>
                      </a:lnTo>
                      <a:lnTo>
                        <a:pt x="1981" y="40"/>
                      </a:lnTo>
                      <a:lnTo>
                        <a:pt x="1981" y="37"/>
                      </a:lnTo>
                      <a:lnTo>
                        <a:pt x="1981" y="41"/>
                      </a:lnTo>
                      <a:lnTo>
                        <a:pt x="1981" y="38"/>
                      </a:lnTo>
                      <a:lnTo>
                        <a:pt x="1982" y="38"/>
                      </a:lnTo>
                      <a:lnTo>
                        <a:pt x="1982" y="37"/>
                      </a:lnTo>
                      <a:lnTo>
                        <a:pt x="1982" y="40"/>
                      </a:lnTo>
                      <a:lnTo>
                        <a:pt x="1982" y="38"/>
                      </a:lnTo>
                      <a:lnTo>
                        <a:pt x="1983" y="38"/>
                      </a:lnTo>
                      <a:lnTo>
                        <a:pt x="1983" y="37"/>
                      </a:lnTo>
                      <a:lnTo>
                        <a:pt x="1983" y="41"/>
                      </a:lnTo>
                      <a:lnTo>
                        <a:pt x="1983" y="38"/>
                      </a:lnTo>
                      <a:lnTo>
                        <a:pt x="1984" y="38"/>
                      </a:lnTo>
                      <a:lnTo>
                        <a:pt x="1984" y="37"/>
                      </a:lnTo>
                      <a:lnTo>
                        <a:pt x="1984" y="40"/>
                      </a:lnTo>
                      <a:lnTo>
                        <a:pt x="1984" y="38"/>
                      </a:lnTo>
                      <a:lnTo>
                        <a:pt x="1985" y="38"/>
                      </a:lnTo>
                      <a:lnTo>
                        <a:pt x="1985" y="38"/>
                      </a:lnTo>
                      <a:lnTo>
                        <a:pt x="1985" y="40"/>
                      </a:lnTo>
                      <a:lnTo>
                        <a:pt x="1985" y="38"/>
                      </a:lnTo>
                      <a:lnTo>
                        <a:pt x="1986" y="38"/>
                      </a:lnTo>
                      <a:lnTo>
                        <a:pt x="1986" y="37"/>
                      </a:lnTo>
                      <a:lnTo>
                        <a:pt x="1986" y="40"/>
                      </a:lnTo>
                      <a:lnTo>
                        <a:pt x="1986" y="38"/>
                      </a:lnTo>
                      <a:lnTo>
                        <a:pt x="1987" y="38"/>
                      </a:lnTo>
                      <a:lnTo>
                        <a:pt x="1987" y="38"/>
                      </a:lnTo>
                      <a:lnTo>
                        <a:pt x="1987" y="41"/>
                      </a:lnTo>
                      <a:lnTo>
                        <a:pt x="1987" y="40"/>
                      </a:lnTo>
                      <a:lnTo>
                        <a:pt x="1988" y="40"/>
                      </a:lnTo>
                      <a:lnTo>
                        <a:pt x="1988" y="39"/>
                      </a:lnTo>
                      <a:lnTo>
                        <a:pt x="1988" y="41"/>
                      </a:lnTo>
                      <a:lnTo>
                        <a:pt x="1988" y="41"/>
                      </a:lnTo>
                      <a:lnTo>
                        <a:pt x="1989" y="41"/>
                      </a:lnTo>
                      <a:lnTo>
                        <a:pt x="1989" y="38"/>
                      </a:lnTo>
                      <a:lnTo>
                        <a:pt x="1989" y="41"/>
                      </a:lnTo>
                      <a:lnTo>
                        <a:pt x="1989" y="40"/>
                      </a:lnTo>
                      <a:lnTo>
                        <a:pt x="1990" y="40"/>
                      </a:lnTo>
                      <a:lnTo>
                        <a:pt x="1990" y="38"/>
                      </a:lnTo>
                      <a:lnTo>
                        <a:pt x="1990" y="41"/>
                      </a:lnTo>
                      <a:lnTo>
                        <a:pt x="1990" y="40"/>
                      </a:lnTo>
                      <a:lnTo>
                        <a:pt x="1991" y="40"/>
                      </a:lnTo>
                      <a:lnTo>
                        <a:pt x="1991" y="40"/>
                      </a:lnTo>
                      <a:lnTo>
                        <a:pt x="1991" y="41"/>
                      </a:lnTo>
                      <a:lnTo>
                        <a:pt x="1991" y="40"/>
                      </a:lnTo>
                      <a:lnTo>
                        <a:pt x="1992" y="40"/>
                      </a:lnTo>
                      <a:lnTo>
                        <a:pt x="1992" y="38"/>
                      </a:lnTo>
                      <a:lnTo>
                        <a:pt x="1992" y="43"/>
                      </a:lnTo>
                      <a:lnTo>
                        <a:pt x="1992" y="38"/>
                      </a:lnTo>
                      <a:lnTo>
                        <a:pt x="1993" y="38"/>
                      </a:lnTo>
                      <a:lnTo>
                        <a:pt x="1993" y="40"/>
                      </a:lnTo>
                      <a:lnTo>
                        <a:pt x="1993" y="41"/>
                      </a:lnTo>
                    </a:path>
                  </a:pathLst>
                </a:custGeom>
                <a:noFill/>
                <a:ln w="11160">
                  <a:solidFill>
                    <a:srgbClr val="0070c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8400" rIns="68400" tIns="34200" bIns="34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81" name="Text Box 493"/>
              <p:cNvSpPr/>
              <p:nvPr/>
            </p:nvSpPr>
            <p:spPr>
              <a:xfrm rot="16200000">
                <a:off x="96840" y="2170440"/>
                <a:ext cx="1046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sc (µA/cm</a:t>
                </a:r>
                <a:r>
                  <a:rPr b="0" lang="fr-FR" sz="10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Connecteur droit 92"/>
              <p:cNvSpPr/>
              <p:nvPr/>
            </p:nvSpPr>
            <p:spPr>
              <a:xfrm flipV="1">
                <a:off x="1596960" y="1360440"/>
                <a:ext cx="2444760" cy="9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Connecteur droit 215"/>
              <p:cNvSpPr/>
              <p:nvPr/>
            </p:nvSpPr>
            <p:spPr>
              <a:xfrm>
                <a:off x="2212920" y="1560600"/>
                <a:ext cx="1823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Connecteur droit 217"/>
              <p:cNvSpPr/>
              <p:nvPr/>
            </p:nvSpPr>
            <p:spPr>
              <a:xfrm>
                <a:off x="3173400" y="1751040"/>
                <a:ext cx="880920" cy="18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ZoneTexte 11265"/>
              <p:cNvSpPr/>
              <p:nvPr/>
            </p:nvSpPr>
            <p:spPr>
              <a:xfrm>
                <a:off x="2454120" y="1146600"/>
                <a:ext cx="135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milorid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ZoneTexte 221"/>
              <p:cNvSpPr/>
              <p:nvPr/>
            </p:nvSpPr>
            <p:spPr>
              <a:xfrm>
                <a:off x="2819520" y="1350000"/>
                <a:ext cx="135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sk/IBMx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ZoneTexte 222"/>
              <p:cNvSpPr/>
              <p:nvPr/>
            </p:nvSpPr>
            <p:spPr>
              <a:xfrm>
                <a:off x="3278160" y="1538640"/>
                <a:ext cx="135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0umetanid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ZoneTexte 229"/>
              <p:cNvSpPr/>
              <p:nvPr/>
            </p:nvSpPr>
            <p:spPr>
              <a:xfrm>
                <a:off x="6811920" y="1076760"/>
                <a:ext cx="1352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milorid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 Box 493"/>
              <p:cNvSpPr/>
              <p:nvPr/>
            </p:nvSpPr>
            <p:spPr>
              <a:xfrm rot="16200000">
                <a:off x="2680200" y="4857120"/>
                <a:ext cx="1815120" cy="398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1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orskolin/IBMX         (µA/cm</a:t>
                </a:r>
                <a:r>
                  <a:rPr b="1" lang="fr-FR" sz="10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0" name="Groupe 5"/>
            <p:cNvGrpSpPr/>
            <p:nvPr/>
          </p:nvGrpSpPr>
          <p:grpSpPr>
            <a:xfrm>
              <a:off x="4935600" y="1257840"/>
              <a:ext cx="4154400" cy="2131560"/>
              <a:chOff x="4935600" y="1257840"/>
              <a:chExt cx="4154400" cy="2131560"/>
            </a:xfrm>
          </p:grpSpPr>
          <p:grpSp>
            <p:nvGrpSpPr>
              <p:cNvPr id="91" name="Groupe 185"/>
              <p:cNvGrpSpPr/>
              <p:nvPr/>
            </p:nvGrpSpPr>
            <p:grpSpPr>
              <a:xfrm>
                <a:off x="5249520" y="1436040"/>
                <a:ext cx="3456360" cy="1953360"/>
                <a:chOff x="5249520" y="1436040"/>
                <a:chExt cx="3456360" cy="1953360"/>
              </a:xfrm>
            </p:grpSpPr>
            <p:grpSp>
              <p:nvGrpSpPr>
                <p:cNvPr id="92" name="Groupe 45"/>
                <p:cNvGrpSpPr/>
                <p:nvPr/>
              </p:nvGrpSpPr>
              <p:grpSpPr>
                <a:xfrm>
                  <a:off x="5249520" y="1436040"/>
                  <a:ext cx="3456360" cy="1953360"/>
                  <a:chOff x="5249520" y="1436040"/>
                  <a:chExt cx="3456360" cy="1953360"/>
                </a:xfrm>
              </p:grpSpPr>
              <p:sp>
                <p:nvSpPr>
                  <p:cNvPr id="93" name="Freeform 45"/>
                  <p:cNvSpPr/>
                  <p:nvPr/>
                </p:nvSpPr>
                <p:spPr>
                  <a:xfrm>
                    <a:off x="5440320" y="308016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" name="Rectangle 46"/>
                  <p:cNvSpPr/>
                  <p:nvPr/>
                </p:nvSpPr>
                <p:spPr>
                  <a:xfrm>
                    <a:off x="5249520" y="301968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5" name="Freeform 47"/>
                  <p:cNvSpPr/>
                  <p:nvPr/>
                </p:nvSpPr>
                <p:spPr>
                  <a:xfrm>
                    <a:off x="5440320" y="268956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" name="Rectangle 48"/>
                  <p:cNvSpPr/>
                  <p:nvPr/>
                </p:nvSpPr>
                <p:spPr>
                  <a:xfrm>
                    <a:off x="5249520" y="265392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3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7" name="Freeform 49"/>
                  <p:cNvSpPr/>
                  <p:nvPr/>
                </p:nvSpPr>
                <p:spPr>
                  <a:xfrm>
                    <a:off x="5440320" y="229572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8" name="Rectangle 50"/>
                  <p:cNvSpPr/>
                  <p:nvPr/>
                </p:nvSpPr>
                <p:spPr>
                  <a:xfrm>
                    <a:off x="5249520" y="220140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9" name="Line 51"/>
                  <p:cNvSpPr/>
                  <p:nvPr/>
                </p:nvSpPr>
                <p:spPr>
                  <a:xfrm flipH="1">
                    <a:off x="5439960" y="1902240"/>
                    <a:ext cx="46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4200" bIns="-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Rectangle 52"/>
                  <p:cNvSpPr/>
                  <p:nvPr/>
                </p:nvSpPr>
                <p:spPr>
                  <a:xfrm>
                    <a:off x="5249520" y="177984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5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Freeform 53"/>
                  <p:cNvSpPr/>
                  <p:nvPr/>
                </p:nvSpPr>
                <p:spPr>
                  <a:xfrm>
                    <a:off x="5440320" y="1508400"/>
                    <a:ext cx="468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3" h="0">
                        <a:moveTo>
                          <a:pt x="3" y="0"/>
                        </a:moveTo>
                        <a:lnTo>
                          <a:pt x="1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2" name="Rectangle 54"/>
                  <p:cNvSpPr/>
                  <p:nvPr/>
                </p:nvSpPr>
                <p:spPr>
                  <a:xfrm>
                    <a:off x="5249520" y="143604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6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3" name="Freeform 60"/>
                  <p:cNvSpPr/>
                  <p:nvPr/>
                </p:nvSpPr>
                <p:spPr>
                  <a:xfrm>
                    <a:off x="5454360" y="1499040"/>
                    <a:ext cx="3251520" cy="1645920"/>
                  </a:xfrm>
                  <a:custGeom>
                    <a:avLst/>
                    <a:gdLst/>
                    <a:ahLst/>
                    <a:rect l="l" t="t" r="r" b="b"/>
                    <a:pathLst>
                      <a:path w="1999" h="282">
                        <a:moveTo>
                          <a:pt x="0" y="0"/>
                        </a:moveTo>
                        <a:lnTo>
                          <a:pt x="0" y="282"/>
                        </a:lnTo>
                        <a:lnTo>
                          <a:pt x="1999" y="282"/>
                        </a:lnTo>
                      </a:path>
                    </a:pathLst>
                  </a:custGeom>
                  <a:noFill/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34200" bIns="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4" name="Rectangle 78"/>
                  <p:cNvSpPr/>
                  <p:nvPr/>
                </p:nvSpPr>
                <p:spPr>
                  <a:xfrm>
                    <a:off x="5493960" y="3236760"/>
                    <a:ext cx="5580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5" name="Line 79"/>
                  <p:cNvSpPr/>
                  <p:nvPr/>
                </p:nvSpPr>
                <p:spPr>
                  <a:xfrm>
                    <a:off x="5505480" y="3144960"/>
                    <a:ext cx="0" cy="633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9160" bIns="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6" name="Rectangle 84"/>
                  <p:cNvSpPr/>
                  <p:nvPr/>
                </p:nvSpPr>
                <p:spPr>
                  <a:xfrm>
                    <a:off x="6077160" y="32367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7" name="Line 85"/>
                  <p:cNvSpPr/>
                  <p:nvPr/>
                </p:nvSpPr>
                <p:spPr>
                  <a:xfrm>
                    <a:off x="6153120" y="3144960"/>
                    <a:ext cx="0" cy="633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9160" bIns="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8" name="Rectangle 90"/>
                  <p:cNvSpPr/>
                  <p:nvPr/>
                </p:nvSpPr>
                <p:spPr>
                  <a:xfrm>
                    <a:off x="6724080" y="32367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9" name="Line 91"/>
                  <p:cNvSpPr/>
                  <p:nvPr/>
                </p:nvSpPr>
                <p:spPr>
                  <a:xfrm>
                    <a:off x="6800760" y="3144960"/>
                    <a:ext cx="0" cy="633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9160" bIns="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0" name="Rectangle 96"/>
                  <p:cNvSpPr/>
                  <p:nvPr/>
                </p:nvSpPr>
                <p:spPr>
                  <a:xfrm>
                    <a:off x="7384320" y="32367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0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1" name="Line 97"/>
                  <p:cNvSpPr/>
                  <p:nvPr/>
                </p:nvSpPr>
                <p:spPr>
                  <a:xfrm>
                    <a:off x="7450200" y="3144960"/>
                    <a:ext cx="0" cy="633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9160" bIns="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2" name="Rectangle 102"/>
                  <p:cNvSpPr/>
                  <p:nvPr/>
                </p:nvSpPr>
                <p:spPr>
                  <a:xfrm>
                    <a:off x="8031240" y="3236760"/>
                    <a:ext cx="128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fr-FR" sz="10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5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3" name="Line 103"/>
                  <p:cNvSpPr/>
                  <p:nvPr/>
                </p:nvSpPr>
                <p:spPr>
                  <a:xfrm>
                    <a:off x="8097840" y="3144960"/>
                    <a:ext cx="0" cy="6336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68400" rIns="68400" tIns="29160" bIns="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114" name="Freeform 55"/>
                <p:cNvSpPr/>
                <p:nvPr/>
              </p:nvSpPr>
              <p:spPr>
                <a:xfrm>
                  <a:off x="5462280" y="1974960"/>
                  <a:ext cx="3225960" cy="679320"/>
                </a:xfrm>
                <a:custGeom>
                  <a:avLst/>
                  <a:gdLst/>
                  <a:ahLst/>
                  <a:rect l="l" t="t" r="r" b="b"/>
                  <a:pathLst>
                    <a:path w="1993" h="158">
                      <a:moveTo>
                        <a:pt x="0" y="104"/>
                      </a:moveTo>
                      <a:lnTo>
                        <a:pt x="0" y="104"/>
                      </a:lnTo>
                      <a:lnTo>
                        <a:pt x="0" y="108"/>
                      </a:lnTo>
                      <a:lnTo>
                        <a:pt x="0" y="105"/>
                      </a:lnTo>
                      <a:lnTo>
                        <a:pt x="1" y="105"/>
                      </a:lnTo>
                      <a:lnTo>
                        <a:pt x="1" y="103"/>
                      </a:lnTo>
                      <a:lnTo>
                        <a:pt x="1" y="107"/>
                      </a:lnTo>
                      <a:lnTo>
                        <a:pt x="1" y="105"/>
                      </a:lnTo>
                      <a:lnTo>
                        <a:pt x="2" y="105"/>
                      </a:lnTo>
                      <a:lnTo>
                        <a:pt x="2" y="104"/>
                      </a:lnTo>
                      <a:lnTo>
                        <a:pt x="2" y="108"/>
                      </a:lnTo>
                      <a:lnTo>
                        <a:pt x="2" y="107"/>
                      </a:lnTo>
                      <a:lnTo>
                        <a:pt x="3" y="107"/>
                      </a:lnTo>
                      <a:lnTo>
                        <a:pt x="3" y="105"/>
                      </a:lnTo>
                      <a:lnTo>
                        <a:pt x="3" y="108"/>
                      </a:lnTo>
                      <a:lnTo>
                        <a:pt x="3" y="108"/>
                      </a:lnTo>
                      <a:lnTo>
                        <a:pt x="4" y="108"/>
                      </a:lnTo>
                      <a:lnTo>
                        <a:pt x="4" y="104"/>
                      </a:lnTo>
                      <a:lnTo>
                        <a:pt x="4" y="108"/>
                      </a:lnTo>
                      <a:lnTo>
                        <a:pt x="4" y="105"/>
                      </a:lnTo>
                      <a:lnTo>
                        <a:pt x="5" y="105"/>
                      </a:lnTo>
                      <a:lnTo>
                        <a:pt x="5" y="104"/>
                      </a:lnTo>
                      <a:lnTo>
                        <a:pt x="5" y="108"/>
                      </a:lnTo>
                      <a:lnTo>
                        <a:pt x="5" y="104"/>
                      </a:lnTo>
                      <a:lnTo>
                        <a:pt x="6" y="104"/>
                      </a:lnTo>
                      <a:lnTo>
                        <a:pt x="6" y="104"/>
                      </a:lnTo>
                      <a:lnTo>
                        <a:pt x="6" y="107"/>
                      </a:lnTo>
                      <a:lnTo>
                        <a:pt x="6" y="104"/>
                      </a:lnTo>
                      <a:lnTo>
                        <a:pt x="7" y="104"/>
                      </a:lnTo>
                      <a:lnTo>
                        <a:pt x="7" y="103"/>
                      </a:lnTo>
                      <a:lnTo>
                        <a:pt x="7" y="108"/>
                      </a:lnTo>
                      <a:lnTo>
                        <a:pt x="7" y="105"/>
                      </a:lnTo>
                      <a:lnTo>
                        <a:pt x="8" y="105"/>
                      </a:lnTo>
                      <a:lnTo>
                        <a:pt x="8" y="103"/>
                      </a:lnTo>
                      <a:lnTo>
                        <a:pt x="8" y="107"/>
                      </a:lnTo>
                      <a:lnTo>
                        <a:pt x="8" y="105"/>
                      </a:lnTo>
                      <a:lnTo>
                        <a:pt x="9" y="105"/>
                      </a:lnTo>
                      <a:lnTo>
                        <a:pt x="9" y="103"/>
                      </a:lnTo>
                      <a:lnTo>
                        <a:pt x="9" y="108"/>
                      </a:lnTo>
                      <a:lnTo>
                        <a:pt x="9" y="103"/>
                      </a:lnTo>
                      <a:lnTo>
                        <a:pt x="10" y="103"/>
                      </a:lnTo>
                      <a:lnTo>
                        <a:pt x="10" y="103"/>
                      </a:lnTo>
                      <a:lnTo>
                        <a:pt x="10" y="106"/>
                      </a:lnTo>
                      <a:lnTo>
                        <a:pt x="10" y="105"/>
                      </a:lnTo>
                      <a:lnTo>
                        <a:pt x="11" y="105"/>
                      </a:lnTo>
                      <a:lnTo>
                        <a:pt x="11" y="104"/>
                      </a:lnTo>
                      <a:lnTo>
                        <a:pt x="11" y="107"/>
                      </a:lnTo>
                      <a:lnTo>
                        <a:pt x="11" y="105"/>
                      </a:lnTo>
                      <a:lnTo>
                        <a:pt x="12" y="105"/>
                      </a:lnTo>
                      <a:lnTo>
                        <a:pt x="12" y="103"/>
                      </a:lnTo>
                      <a:lnTo>
                        <a:pt x="12" y="105"/>
                      </a:lnTo>
                      <a:lnTo>
                        <a:pt x="12" y="104"/>
                      </a:lnTo>
                      <a:lnTo>
                        <a:pt x="13" y="104"/>
                      </a:lnTo>
                      <a:lnTo>
                        <a:pt x="13" y="104"/>
                      </a:lnTo>
                      <a:lnTo>
                        <a:pt x="13" y="107"/>
                      </a:lnTo>
                      <a:lnTo>
                        <a:pt x="13" y="105"/>
                      </a:lnTo>
                      <a:lnTo>
                        <a:pt x="14" y="105"/>
                      </a:lnTo>
                      <a:lnTo>
                        <a:pt x="14" y="104"/>
                      </a:lnTo>
                      <a:lnTo>
                        <a:pt x="14" y="107"/>
                      </a:lnTo>
                      <a:lnTo>
                        <a:pt x="14" y="106"/>
                      </a:lnTo>
                      <a:lnTo>
                        <a:pt x="15" y="106"/>
                      </a:lnTo>
                      <a:lnTo>
                        <a:pt x="15" y="104"/>
                      </a:lnTo>
                      <a:lnTo>
                        <a:pt x="15" y="108"/>
                      </a:lnTo>
                      <a:lnTo>
                        <a:pt x="15" y="106"/>
                      </a:lnTo>
                      <a:lnTo>
                        <a:pt x="16" y="106"/>
                      </a:lnTo>
                      <a:lnTo>
                        <a:pt x="16" y="104"/>
                      </a:lnTo>
                      <a:lnTo>
                        <a:pt x="16" y="108"/>
                      </a:lnTo>
                      <a:lnTo>
                        <a:pt x="16" y="105"/>
                      </a:lnTo>
                      <a:lnTo>
                        <a:pt x="17" y="105"/>
                      </a:lnTo>
                      <a:lnTo>
                        <a:pt x="17" y="103"/>
                      </a:lnTo>
                      <a:lnTo>
                        <a:pt x="17" y="106"/>
                      </a:lnTo>
                      <a:lnTo>
                        <a:pt x="17" y="104"/>
                      </a:lnTo>
                      <a:lnTo>
                        <a:pt x="18" y="104"/>
                      </a:lnTo>
                      <a:lnTo>
                        <a:pt x="18" y="104"/>
                      </a:lnTo>
                      <a:lnTo>
                        <a:pt x="18" y="107"/>
                      </a:lnTo>
                      <a:lnTo>
                        <a:pt x="18" y="106"/>
                      </a:lnTo>
                      <a:lnTo>
                        <a:pt x="19" y="106"/>
                      </a:lnTo>
                      <a:lnTo>
                        <a:pt x="19" y="104"/>
                      </a:lnTo>
                      <a:lnTo>
                        <a:pt x="19" y="108"/>
                      </a:lnTo>
                      <a:lnTo>
                        <a:pt x="19" y="106"/>
                      </a:lnTo>
                      <a:lnTo>
                        <a:pt x="20" y="106"/>
                      </a:lnTo>
                      <a:lnTo>
                        <a:pt x="20" y="104"/>
                      </a:lnTo>
                      <a:lnTo>
                        <a:pt x="20" y="107"/>
                      </a:lnTo>
                      <a:lnTo>
                        <a:pt x="20" y="106"/>
                      </a:lnTo>
                      <a:lnTo>
                        <a:pt x="21" y="106"/>
                      </a:lnTo>
                      <a:lnTo>
                        <a:pt x="21" y="105"/>
                      </a:lnTo>
                      <a:lnTo>
                        <a:pt x="21" y="108"/>
                      </a:lnTo>
                      <a:lnTo>
                        <a:pt x="21" y="105"/>
                      </a:lnTo>
                      <a:lnTo>
                        <a:pt x="22" y="105"/>
                      </a:lnTo>
                      <a:lnTo>
                        <a:pt x="22" y="103"/>
                      </a:lnTo>
                      <a:lnTo>
                        <a:pt x="22" y="110"/>
                      </a:lnTo>
                      <a:lnTo>
                        <a:pt x="22" y="105"/>
                      </a:lnTo>
                      <a:lnTo>
                        <a:pt x="23" y="105"/>
                      </a:lnTo>
                      <a:lnTo>
                        <a:pt x="23" y="104"/>
                      </a:lnTo>
                      <a:lnTo>
                        <a:pt x="23" y="107"/>
                      </a:lnTo>
                      <a:lnTo>
                        <a:pt x="23" y="106"/>
                      </a:lnTo>
                      <a:lnTo>
                        <a:pt x="24" y="106"/>
                      </a:lnTo>
                      <a:lnTo>
                        <a:pt x="24" y="105"/>
                      </a:lnTo>
                      <a:lnTo>
                        <a:pt x="24" y="108"/>
                      </a:lnTo>
                      <a:lnTo>
                        <a:pt x="24" y="105"/>
                      </a:lnTo>
                      <a:lnTo>
                        <a:pt x="25" y="105"/>
                      </a:lnTo>
                      <a:lnTo>
                        <a:pt x="25" y="104"/>
                      </a:lnTo>
                      <a:lnTo>
                        <a:pt x="25" y="107"/>
                      </a:lnTo>
                      <a:lnTo>
                        <a:pt x="25" y="105"/>
                      </a:lnTo>
                      <a:lnTo>
                        <a:pt x="26" y="105"/>
                      </a:lnTo>
                      <a:lnTo>
                        <a:pt x="26" y="104"/>
                      </a:lnTo>
                      <a:lnTo>
                        <a:pt x="26" y="107"/>
                      </a:lnTo>
                      <a:lnTo>
                        <a:pt x="26" y="104"/>
                      </a:lnTo>
                      <a:lnTo>
                        <a:pt x="27" y="104"/>
                      </a:lnTo>
                      <a:lnTo>
                        <a:pt x="27" y="104"/>
                      </a:lnTo>
                      <a:lnTo>
                        <a:pt x="27" y="106"/>
                      </a:lnTo>
                      <a:lnTo>
                        <a:pt x="27" y="105"/>
                      </a:lnTo>
                      <a:lnTo>
                        <a:pt x="28" y="105"/>
                      </a:lnTo>
                      <a:lnTo>
                        <a:pt x="28" y="103"/>
                      </a:lnTo>
                      <a:lnTo>
                        <a:pt x="28" y="107"/>
                      </a:lnTo>
                      <a:lnTo>
                        <a:pt x="28" y="106"/>
                      </a:lnTo>
                      <a:lnTo>
                        <a:pt x="29" y="106"/>
                      </a:lnTo>
                      <a:lnTo>
                        <a:pt x="29" y="103"/>
                      </a:lnTo>
                      <a:lnTo>
                        <a:pt x="29" y="108"/>
                      </a:lnTo>
                      <a:lnTo>
                        <a:pt x="29" y="105"/>
                      </a:lnTo>
                      <a:lnTo>
                        <a:pt x="30" y="105"/>
                      </a:lnTo>
                      <a:lnTo>
                        <a:pt x="30" y="103"/>
                      </a:lnTo>
                      <a:lnTo>
                        <a:pt x="30" y="107"/>
                      </a:lnTo>
                      <a:lnTo>
                        <a:pt x="30" y="106"/>
                      </a:lnTo>
                      <a:lnTo>
                        <a:pt x="31" y="106"/>
                      </a:lnTo>
                      <a:lnTo>
                        <a:pt x="31" y="104"/>
                      </a:lnTo>
                      <a:lnTo>
                        <a:pt x="31" y="107"/>
                      </a:lnTo>
                      <a:lnTo>
                        <a:pt x="31" y="104"/>
                      </a:lnTo>
                      <a:lnTo>
                        <a:pt x="32" y="104"/>
                      </a:lnTo>
                      <a:lnTo>
                        <a:pt x="32" y="103"/>
                      </a:lnTo>
                      <a:lnTo>
                        <a:pt x="32" y="106"/>
                      </a:lnTo>
                      <a:lnTo>
                        <a:pt x="32" y="105"/>
                      </a:lnTo>
                      <a:lnTo>
                        <a:pt x="33" y="105"/>
                      </a:lnTo>
                      <a:lnTo>
                        <a:pt x="33" y="103"/>
                      </a:lnTo>
                      <a:lnTo>
                        <a:pt x="33" y="107"/>
                      </a:lnTo>
                      <a:lnTo>
                        <a:pt x="33" y="106"/>
                      </a:lnTo>
                      <a:lnTo>
                        <a:pt x="34" y="106"/>
                      </a:lnTo>
                      <a:lnTo>
                        <a:pt x="34" y="103"/>
                      </a:lnTo>
                      <a:lnTo>
                        <a:pt x="34" y="106"/>
                      </a:lnTo>
                      <a:lnTo>
                        <a:pt x="34" y="104"/>
                      </a:lnTo>
                      <a:lnTo>
                        <a:pt x="35" y="104"/>
                      </a:lnTo>
                      <a:lnTo>
                        <a:pt x="35" y="103"/>
                      </a:lnTo>
                      <a:lnTo>
                        <a:pt x="35" y="106"/>
                      </a:lnTo>
                      <a:lnTo>
                        <a:pt x="35" y="105"/>
                      </a:lnTo>
                      <a:lnTo>
                        <a:pt x="36" y="105"/>
                      </a:lnTo>
                      <a:lnTo>
                        <a:pt x="36" y="103"/>
                      </a:lnTo>
                      <a:lnTo>
                        <a:pt x="36" y="106"/>
                      </a:lnTo>
                      <a:lnTo>
                        <a:pt x="36" y="105"/>
                      </a:lnTo>
                      <a:lnTo>
                        <a:pt x="37" y="105"/>
                      </a:lnTo>
                      <a:lnTo>
                        <a:pt x="37" y="102"/>
                      </a:lnTo>
                      <a:lnTo>
                        <a:pt x="37" y="105"/>
                      </a:lnTo>
                      <a:lnTo>
                        <a:pt x="37" y="103"/>
                      </a:lnTo>
                      <a:lnTo>
                        <a:pt x="38" y="103"/>
                      </a:lnTo>
                      <a:lnTo>
                        <a:pt x="38" y="102"/>
                      </a:lnTo>
                      <a:lnTo>
                        <a:pt x="38" y="107"/>
                      </a:lnTo>
                      <a:lnTo>
                        <a:pt x="38" y="104"/>
                      </a:lnTo>
                      <a:lnTo>
                        <a:pt x="39" y="104"/>
                      </a:lnTo>
                      <a:lnTo>
                        <a:pt x="39" y="103"/>
                      </a:lnTo>
                      <a:lnTo>
                        <a:pt x="39" y="106"/>
                      </a:lnTo>
                      <a:lnTo>
                        <a:pt x="39" y="105"/>
                      </a:lnTo>
                      <a:lnTo>
                        <a:pt x="40" y="105"/>
                      </a:lnTo>
                      <a:lnTo>
                        <a:pt x="40" y="103"/>
                      </a:lnTo>
                      <a:lnTo>
                        <a:pt x="40" y="105"/>
                      </a:lnTo>
                      <a:lnTo>
                        <a:pt x="40" y="104"/>
                      </a:lnTo>
                      <a:lnTo>
                        <a:pt x="41" y="104"/>
                      </a:lnTo>
                      <a:lnTo>
                        <a:pt x="41" y="104"/>
                      </a:lnTo>
                      <a:lnTo>
                        <a:pt x="41" y="106"/>
                      </a:lnTo>
                      <a:lnTo>
                        <a:pt x="41" y="104"/>
                      </a:lnTo>
                      <a:lnTo>
                        <a:pt x="42" y="104"/>
                      </a:lnTo>
                      <a:lnTo>
                        <a:pt x="42" y="103"/>
                      </a:lnTo>
                      <a:lnTo>
                        <a:pt x="42" y="105"/>
                      </a:lnTo>
                      <a:lnTo>
                        <a:pt x="42" y="103"/>
                      </a:lnTo>
                      <a:lnTo>
                        <a:pt x="43" y="103"/>
                      </a:lnTo>
                      <a:lnTo>
                        <a:pt x="43" y="101"/>
                      </a:lnTo>
                      <a:lnTo>
                        <a:pt x="43" y="105"/>
                      </a:lnTo>
                      <a:lnTo>
                        <a:pt x="43" y="104"/>
                      </a:lnTo>
                      <a:lnTo>
                        <a:pt x="44" y="104"/>
                      </a:lnTo>
                      <a:lnTo>
                        <a:pt x="44" y="103"/>
                      </a:lnTo>
                      <a:lnTo>
                        <a:pt x="44" y="105"/>
                      </a:lnTo>
                      <a:lnTo>
                        <a:pt x="44" y="103"/>
                      </a:lnTo>
                      <a:lnTo>
                        <a:pt x="45" y="103"/>
                      </a:lnTo>
                      <a:lnTo>
                        <a:pt x="45" y="101"/>
                      </a:lnTo>
                      <a:lnTo>
                        <a:pt x="45" y="105"/>
                      </a:lnTo>
                      <a:lnTo>
                        <a:pt x="45" y="104"/>
                      </a:lnTo>
                      <a:lnTo>
                        <a:pt x="46" y="104"/>
                      </a:lnTo>
                      <a:lnTo>
                        <a:pt x="46" y="102"/>
                      </a:lnTo>
                      <a:lnTo>
                        <a:pt x="46" y="105"/>
                      </a:lnTo>
                      <a:lnTo>
                        <a:pt x="46" y="103"/>
                      </a:lnTo>
                      <a:lnTo>
                        <a:pt x="47" y="103"/>
                      </a:lnTo>
                      <a:lnTo>
                        <a:pt x="47" y="100"/>
                      </a:lnTo>
                      <a:lnTo>
                        <a:pt x="47" y="104"/>
                      </a:lnTo>
                      <a:lnTo>
                        <a:pt x="47" y="101"/>
                      </a:lnTo>
                      <a:lnTo>
                        <a:pt x="48" y="101"/>
                      </a:lnTo>
                      <a:lnTo>
                        <a:pt x="48" y="100"/>
                      </a:lnTo>
                      <a:lnTo>
                        <a:pt x="48" y="103"/>
                      </a:lnTo>
                      <a:lnTo>
                        <a:pt x="48" y="100"/>
                      </a:lnTo>
                      <a:lnTo>
                        <a:pt x="49" y="100"/>
                      </a:lnTo>
                      <a:lnTo>
                        <a:pt x="49" y="100"/>
                      </a:lnTo>
                      <a:lnTo>
                        <a:pt x="49" y="103"/>
                      </a:lnTo>
                      <a:lnTo>
                        <a:pt x="49" y="103"/>
                      </a:lnTo>
                      <a:lnTo>
                        <a:pt x="50" y="103"/>
                      </a:lnTo>
                      <a:lnTo>
                        <a:pt x="50" y="100"/>
                      </a:lnTo>
                      <a:lnTo>
                        <a:pt x="50" y="104"/>
                      </a:lnTo>
                      <a:lnTo>
                        <a:pt x="50" y="103"/>
                      </a:lnTo>
                      <a:lnTo>
                        <a:pt x="51" y="103"/>
                      </a:lnTo>
                      <a:lnTo>
                        <a:pt x="51" y="101"/>
                      </a:lnTo>
                      <a:lnTo>
                        <a:pt x="51" y="104"/>
                      </a:lnTo>
                      <a:lnTo>
                        <a:pt x="51" y="104"/>
                      </a:lnTo>
                      <a:lnTo>
                        <a:pt x="52" y="104"/>
                      </a:lnTo>
                      <a:lnTo>
                        <a:pt x="52" y="101"/>
                      </a:lnTo>
                      <a:lnTo>
                        <a:pt x="52" y="104"/>
                      </a:lnTo>
                      <a:lnTo>
                        <a:pt x="52" y="101"/>
                      </a:lnTo>
                      <a:lnTo>
                        <a:pt x="53" y="101"/>
                      </a:lnTo>
                      <a:lnTo>
                        <a:pt x="53" y="100"/>
                      </a:lnTo>
                      <a:lnTo>
                        <a:pt x="53" y="105"/>
                      </a:lnTo>
                      <a:lnTo>
                        <a:pt x="53" y="105"/>
                      </a:lnTo>
                      <a:lnTo>
                        <a:pt x="54" y="105"/>
                      </a:lnTo>
                      <a:lnTo>
                        <a:pt x="54" y="99"/>
                      </a:lnTo>
                      <a:lnTo>
                        <a:pt x="54" y="104"/>
                      </a:lnTo>
                      <a:lnTo>
                        <a:pt x="54" y="103"/>
                      </a:lnTo>
                      <a:lnTo>
                        <a:pt x="55" y="103"/>
                      </a:lnTo>
                      <a:lnTo>
                        <a:pt x="55" y="101"/>
                      </a:lnTo>
                      <a:lnTo>
                        <a:pt x="55" y="104"/>
                      </a:lnTo>
                      <a:lnTo>
                        <a:pt x="55" y="103"/>
                      </a:lnTo>
                      <a:lnTo>
                        <a:pt x="56" y="103"/>
                      </a:lnTo>
                      <a:lnTo>
                        <a:pt x="56" y="101"/>
                      </a:lnTo>
                      <a:lnTo>
                        <a:pt x="56" y="104"/>
                      </a:lnTo>
                      <a:lnTo>
                        <a:pt x="56" y="102"/>
                      </a:lnTo>
                      <a:lnTo>
                        <a:pt x="57" y="102"/>
                      </a:lnTo>
                      <a:lnTo>
                        <a:pt x="57" y="100"/>
                      </a:lnTo>
                      <a:lnTo>
                        <a:pt x="57" y="104"/>
                      </a:lnTo>
                      <a:lnTo>
                        <a:pt x="57" y="100"/>
                      </a:lnTo>
                      <a:lnTo>
                        <a:pt x="58" y="100"/>
                      </a:lnTo>
                      <a:lnTo>
                        <a:pt x="58" y="100"/>
                      </a:lnTo>
                      <a:lnTo>
                        <a:pt x="58" y="103"/>
                      </a:lnTo>
                      <a:lnTo>
                        <a:pt x="58" y="103"/>
                      </a:lnTo>
                      <a:lnTo>
                        <a:pt x="59" y="103"/>
                      </a:lnTo>
                      <a:lnTo>
                        <a:pt x="59" y="100"/>
                      </a:lnTo>
                      <a:lnTo>
                        <a:pt x="59" y="104"/>
                      </a:lnTo>
                      <a:lnTo>
                        <a:pt x="59" y="101"/>
                      </a:lnTo>
                      <a:lnTo>
                        <a:pt x="60" y="101"/>
                      </a:lnTo>
                      <a:lnTo>
                        <a:pt x="60" y="100"/>
                      </a:lnTo>
                      <a:lnTo>
                        <a:pt x="60" y="104"/>
                      </a:lnTo>
                      <a:lnTo>
                        <a:pt x="60" y="100"/>
                      </a:lnTo>
                      <a:lnTo>
                        <a:pt x="61" y="100"/>
                      </a:lnTo>
                      <a:lnTo>
                        <a:pt x="61" y="99"/>
                      </a:lnTo>
                      <a:lnTo>
                        <a:pt x="61" y="105"/>
                      </a:lnTo>
                      <a:lnTo>
                        <a:pt x="61" y="101"/>
                      </a:lnTo>
                      <a:lnTo>
                        <a:pt x="62" y="101"/>
                      </a:lnTo>
                      <a:lnTo>
                        <a:pt x="62" y="98"/>
                      </a:lnTo>
                      <a:lnTo>
                        <a:pt x="62" y="104"/>
                      </a:lnTo>
                      <a:lnTo>
                        <a:pt x="62" y="104"/>
                      </a:lnTo>
                      <a:lnTo>
                        <a:pt x="63" y="104"/>
                      </a:lnTo>
                      <a:lnTo>
                        <a:pt x="63" y="99"/>
                      </a:lnTo>
                      <a:lnTo>
                        <a:pt x="63" y="103"/>
                      </a:lnTo>
                      <a:lnTo>
                        <a:pt x="63" y="100"/>
                      </a:lnTo>
                      <a:lnTo>
                        <a:pt x="64" y="100"/>
                      </a:lnTo>
                      <a:lnTo>
                        <a:pt x="64" y="100"/>
                      </a:lnTo>
                      <a:lnTo>
                        <a:pt x="64" y="103"/>
                      </a:lnTo>
                      <a:lnTo>
                        <a:pt x="64" y="100"/>
                      </a:lnTo>
                      <a:lnTo>
                        <a:pt x="65" y="100"/>
                      </a:lnTo>
                      <a:lnTo>
                        <a:pt x="65" y="100"/>
                      </a:lnTo>
                      <a:lnTo>
                        <a:pt x="65" y="104"/>
                      </a:lnTo>
                      <a:lnTo>
                        <a:pt x="65" y="103"/>
                      </a:lnTo>
                      <a:lnTo>
                        <a:pt x="66" y="103"/>
                      </a:lnTo>
                      <a:lnTo>
                        <a:pt x="66" y="100"/>
                      </a:lnTo>
                      <a:lnTo>
                        <a:pt x="66" y="104"/>
                      </a:lnTo>
                      <a:lnTo>
                        <a:pt x="66" y="103"/>
                      </a:lnTo>
                      <a:lnTo>
                        <a:pt x="67" y="103"/>
                      </a:lnTo>
                      <a:lnTo>
                        <a:pt x="67" y="100"/>
                      </a:lnTo>
                      <a:lnTo>
                        <a:pt x="67" y="103"/>
                      </a:lnTo>
                      <a:lnTo>
                        <a:pt x="67" y="102"/>
                      </a:lnTo>
                      <a:lnTo>
                        <a:pt x="68" y="102"/>
                      </a:lnTo>
                      <a:lnTo>
                        <a:pt x="68" y="100"/>
                      </a:lnTo>
                      <a:lnTo>
                        <a:pt x="68" y="104"/>
                      </a:lnTo>
                      <a:lnTo>
                        <a:pt x="68" y="100"/>
                      </a:lnTo>
                      <a:lnTo>
                        <a:pt x="69" y="100"/>
                      </a:lnTo>
                      <a:lnTo>
                        <a:pt x="69" y="100"/>
                      </a:lnTo>
                      <a:lnTo>
                        <a:pt x="69" y="104"/>
                      </a:lnTo>
                      <a:lnTo>
                        <a:pt x="69" y="100"/>
                      </a:lnTo>
                      <a:lnTo>
                        <a:pt x="70" y="100"/>
                      </a:lnTo>
                      <a:lnTo>
                        <a:pt x="70" y="100"/>
                      </a:lnTo>
                      <a:lnTo>
                        <a:pt x="70" y="104"/>
                      </a:lnTo>
                      <a:lnTo>
                        <a:pt x="70" y="101"/>
                      </a:lnTo>
                      <a:lnTo>
                        <a:pt x="71" y="101"/>
                      </a:lnTo>
                      <a:lnTo>
                        <a:pt x="71" y="100"/>
                      </a:lnTo>
                      <a:lnTo>
                        <a:pt x="71" y="103"/>
                      </a:lnTo>
                      <a:lnTo>
                        <a:pt x="71" y="103"/>
                      </a:lnTo>
                      <a:lnTo>
                        <a:pt x="72" y="103"/>
                      </a:lnTo>
                      <a:lnTo>
                        <a:pt x="72" y="100"/>
                      </a:lnTo>
                      <a:lnTo>
                        <a:pt x="72" y="105"/>
                      </a:lnTo>
                      <a:lnTo>
                        <a:pt x="72" y="101"/>
                      </a:lnTo>
                      <a:lnTo>
                        <a:pt x="73" y="101"/>
                      </a:lnTo>
                      <a:lnTo>
                        <a:pt x="73" y="100"/>
                      </a:lnTo>
                      <a:lnTo>
                        <a:pt x="73" y="103"/>
                      </a:lnTo>
                      <a:lnTo>
                        <a:pt x="73" y="101"/>
                      </a:lnTo>
                      <a:lnTo>
                        <a:pt x="74" y="101"/>
                      </a:lnTo>
                      <a:lnTo>
                        <a:pt x="74" y="101"/>
                      </a:lnTo>
                      <a:lnTo>
                        <a:pt x="74" y="105"/>
                      </a:lnTo>
                      <a:lnTo>
                        <a:pt x="74" y="103"/>
                      </a:lnTo>
                      <a:lnTo>
                        <a:pt x="75" y="103"/>
                      </a:lnTo>
                      <a:lnTo>
                        <a:pt x="75" y="100"/>
                      </a:lnTo>
                      <a:lnTo>
                        <a:pt x="75" y="103"/>
                      </a:lnTo>
                      <a:lnTo>
                        <a:pt x="75" y="103"/>
                      </a:lnTo>
                      <a:lnTo>
                        <a:pt x="76" y="103"/>
                      </a:lnTo>
                      <a:lnTo>
                        <a:pt x="76" y="101"/>
                      </a:lnTo>
                      <a:lnTo>
                        <a:pt x="76" y="105"/>
                      </a:lnTo>
                      <a:lnTo>
                        <a:pt x="76" y="104"/>
                      </a:lnTo>
                      <a:lnTo>
                        <a:pt x="77" y="104"/>
                      </a:lnTo>
                      <a:lnTo>
                        <a:pt x="77" y="101"/>
                      </a:lnTo>
                      <a:lnTo>
                        <a:pt x="77" y="105"/>
                      </a:lnTo>
                      <a:lnTo>
                        <a:pt x="77" y="101"/>
                      </a:lnTo>
                      <a:lnTo>
                        <a:pt x="78" y="101"/>
                      </a:lnTo>
                      <a:lnTo>
                        <a:pt x="78" y="101"/>
                      </a:lnTo>
                      <a:lnTo>
                        <a:pt x="78" y="104"/>
                      </a:lnTo>
                      <a:lnTo>
                        <a:pt x="78" y="103"/>
                      </a:lnTo>
                      <a:lnTo>
                        <a:pt x="79" y="103"/>
                      </a:lnTo>
                      <a:lnTo>
                        <a:pt x="79" y="101"/>
                      </a:lnTo>
                      <a:lnTo>
                        <a:pt x="79" y="106"/>
                      </a:lnTo>
                      <a:lnTo>
                        <a:pt x="79" y="104"/>
                      </a:lnTo>
                      <a:lnTo>
                        <a:pt x="80" y="104"/>
                      </a:lnTo>
                      <a:lnTo>
                        <a:pt x="80" y="101"/>
                      </a:lnTo>
                      <a:lnTo>
                        <a:pt x="80" y="105"/>
                      </a:lnTo>
                      <a:lnTo>
                        <a:pt x="80" y="104"/>
                      </a:lnTo>
                      <a:lnTo>
                        <a:pt x="81" y="104"/>
                      </a:lnTo>
                      <a:lnTo>
                        <a:pt x="81" y="103"/>
                      </a:lnTo>
                      <a:lnTo>
                        <a:pt x="81" y="104"/>
                      </a:lnTo>
                      <a:lnTo>
                        <a:pt x="81" y="103"/>
                      </a:lnTo>
                      <a:lnTo>
                        <a:pt x="82" y="103"/>
                      </a:lnTo>
                      <a:lnTo>
                        <a:pt x="82" y="101"/>
                      </a:lnTo>
                      <a:lnTo>
                        <a:pt x="82" y="104"/>
                      </a:lnTo>
                      <a:lnTo>
                        <a:pt x="82" y="103"/>
                      </a:lnTo>
                      <a:lnTo>
                        <a:pt x="83" y="103"/>
                      </a:lnTo>
                      <a:lnTo>
                        <a:pt x="83" y="100"/>
                      </a:lnTo>
                      <a:lnTo>
                        <a:pt x="83" y="103"/>
                      </a:lnTo>
                      <a:lnTo>
                        <a:pt x="83" y="101"/>
                      </a:lnTo>
                      <a:lnTo>
                        <a:pt x="84" y="101"/>
                      </a:lnTo>
                      <a:lnTo>
                        <a:pt x="84" y="100"/>
                      </a:lnTo>
                      <a:lnTo>
                        <a:pt x="84" y="105"/>
                      </a:lnTo>
                      <a:lnTo>
                        <a:pt x="84" y="103"/>
                      </a:lnTo>
                      <a:lnTo>
                        <a:pt x="85" y="103"/>
                      </a:lnTo>
                      <a:lnTo>
                        <a:pt x="85" y="100"/>
                      </a:lnTo>
                      <a:lnTo>
                        <a:pt x="85" y="104"/>
                      </a:lnTo>
                      <a:lnTo>
                        <a:pt x="85" y="103"/>
                      </a:lnTo>
                      <a:lnTo>
                        <a:pt x="86" y="103"/>
                      </a:lnTo>
                      <a:lnTo>
                        <a:pt x="86" y="100"/>
                      </a:lnTo>
                      <a:lnTo>
                        <a:pt x="86" y="104"/>
                      </a:lnTo>
                      <a:lnTo>
                        <a:pt x="86" y="101"/>
                      </a:lnTo>
                      <a:lnTo>
                        <a:pt x="87" y="101"/>
                      </a:lnTo>
                      <a:lnTo>
                        <a:pt x="87" y="100"/>
                      </a:lnTo>
                      <a:lnTo>
                        <a:pt x="87" y="105"/>
                      </a:lnTo>
                      <a:lnTo>
                        <a:pt x="87" y="104"/>
                      </a:lnTo>
                      <a:lnTo>
                        <a:pt x="88" y="104"/>
                      </a:lnTo>
                      <a:lnTo>
                        <a:pt x="88" y="100"/>
                      </a:lnTo>
                      <a:lnTo>
                        <a:pt x="88" y="103"/>
                      </a:lnTo>
                      <a:lnTo>
                        <a:pt x="88" y="101"/>
                      </a:lnTo>
                      <a:lnTo>
                        <a:pt x="89" y="101"/>
                      </a:lnTo>
                      <a:lnTo>
                        <a:pt x="89" y="101"/>
                      </a:lnTo>
                      <a:lnTo>
                        <a:pt x="89" y="105"/>
                      </a:lnTo>
                      <a:lnTo>
                        <a:pt x="89" y="103"/>
                      </a:lnTo>
                      <a:lnTo>
                        <a:pt x="90" y="103"/>
                      </a:lnTo>
                      <a:lnTo>
                        <a:pt x="90" y="100"/>
                      </a:lnTo>
                      <a:lnTo>
                        <a:pt x="90" y="104"/>
                      </a:lnTo>
                      <a:lnTo>
                        <a:pt x="90" y="103"/>
                      </a:lnTo>
                      <a:lnTo>
                        <a:pt x="91" y="103"/>
                      </a:lnTo>
                      <a:lnTo>
                        <a:pt x="91" y="100"/>
                      </a:lnTo>
                      <a:lnTo>
                        <a:pt x="91" y="104"/>
                      </a:lnTo>
                      <a:lnTo>
                        <a:pt x="91" y="104"/>
                      </a:lnTo>
                      <a:lnTo>
                        <a:pt x="92" y="104"/>
                      </a:lnTo>
                      <a:lnTo>
                        <a:pt x="92" y="101"/>
                      </a:lnTo>
                      <a:lnTo>
                        <a:pt x="92" y="105"/>
                      </a:lnTo>
                      <a:lnTo>
                        <a:pt x="92" y="103"/>
                      </a:lnTo>
                      <a:lnTo>
                        <a:pt x="93" y="103"/>
                      </a:lnTo>
                      <a:lnTo>
                        <a:pt x="93" y="100"/>
                      </a:lnTo>
                      <a:lnTo>
                        <a:pt x="93" y="104"/>
                      </a:lnTo>
                      <a:lnTo>
                        <a:pt x="93" y="103"/>
                      </a:lnTo>
                      <a:lnTo>
                        <a:pt x="94" y="103"/>
                      </a:lnTo>
                      <a:lnTo>
                        <a:pt x="94" y="101"/>
                      </a:lnTo>
                      <a:lnTo>
                        <a:pt x="94" y="104"/>
                      </a:lnTo>
                      <a:lnTo>
                        <a:pt x="94" y="103"/>
                      </a:lnTo>
                      <a:lnTo>
                        <a:pt x="95" y="103"/>
                      </a:lnTo>
                      <a:lnTo>
                        <a:pt x="95" y="101"/>
                      </a:lnTo>
                      <a:lnTo>
                        <a:pt x="95" y="104"/>
                      </a:lnTo>
                      <a:lnTo>
                        <a:pt x="95" y="102"/>
                      </a:lnTo>
                      <a:lnTo>
                        <a:pt x="96" y="102"/>
                      </a:lnTo>
                      <a:lnTo>
                        <a:pt x="96" y="101"/>
                      </a:lnTo>
                      <a:lnTo>
                        <a:pt x="96" y="103"/>
                      </a:lnTo>
                      <a:lnTo>
                        <a:pt x="96" y="101"/>
                      </a:lnTo>
                      <a:lnTo>
                        <a:pt x="97" y="101"/>
                      </a:lnTo>
                      <a:lnTo>
                        <a:pt x="97" y="101"/>
                      </a:lnTo>
                      <a:lnTo>
                        <a:pt x="97" y="104"/>
                      </a:lnTo>
                      <a:lnTo>
                        <a:pt x="97" y="104"/>
                      </a:lnTo>
                      <a:lnTo>
                        <a:pt x="98" y="104"/>
                      </a:lnTo>
                      <a:lnTo>
                        <a:pt x="98" y="101"/>
                      </a:lnTo>
                      <a:lnTo>
                        <a:pt x="98" y="104"/>
                      </a:lnTo>
                      <a:lnTo>
                        <a:pt x="98" y="101"/>
                      </a:lnTo>
                      <a:lnTo>
                        <a:pt x="99" y="101"/>
                      </a:lnTo>
                      <a:lnTo>
                        <a:pt x="99" y="101"/>
                      </a:lnTo>
                      <a:lnTo>
                        <a:pt x="99" y="104"/>
                      </a:lnTo>
                      <a:lnTo>
                        <a:pt x="99" y="103"/>
                      </a:lnTo>
                      <a:lnTo>
                        <a:pt x="100" y="103"/>
                      </a:lnTo>
                      <a:lnTo>
                        <a:pt x="100" y="100"/>
                      </a:lnTo>
                      <a:lnTo>
                        <a:pt x="100" y="103"/>
                      </a:lnTo>
                      <a:lnTo>
                        <a:pt x="100" y="101"/>
                      </a:lnTo>
                      <a:lnTo>
                        <a:pt x="101" y="101"/>
                      </a:lnTo>
                      <a:lnTo>
                        <a:pt x="101" y="100"/>
                      </a:lnTo>
                      <a:lnTo>
                        <a:pt x="101" y="104"/>
                      </a:lnTo>
                      <a:lnTo>
                        <a:pt x="101" y="101"/>
                      </a:lnTo>
                      <a:lnTo>
                        <a:pt x="102" y="101"/>
                      </a:lnTo>
                      <a:lnTo>
                        <a:pt x="102" y="100"/>
                      </a:lnTo>
                      <a:lnTo>
                        <a:pt x="102" y="104"/>
                      </a:lnTo>
                      <a:lnTo>
                        <a:pt x="102" y="103"/>
                      </a:lnTo>
                      <a:lnTo>
                        <a:pt x="103" y="103"/>
                      </a:lnTo>
                      <a:lnTo>
                        <a:pt x="103" y="99"/>
                      </a:lnTo>
                      <a:lnTo>
                        <a:pt x="103" y="103"/>
                      </a:lnTo>
                      <a:lnTo>
                        <a:pt x="103" y="103"/>
                      </a:lnTo>
                      <a:lnTo>
                        <a:pt x="104" y="103"/>
                      </a:lnTo>
                      <a:lnTo>
                        <a:pt x="104" y="100"/>
                      </a:lnTo>
                      <a:lnTo>
                        <a:pt x="104" y="104"/>
                      </a:lnTo>
                      <a:lnTo>
                        <a:pt x="104" y="103"/>
                      </a:lnTo>
                      <a:lnTo>
                        <a:pt x="105" y="103"/>
                      </a:lnTo>
                      <a:lnTo>
                        <a:pt x="105" y="99"/>
                      </a:lnTo>
                      <a:lnTo>
                        <a:pt x="105" y="103"/>
                      </a:lnTo>
                      <a:lnTo>
                        <a:pt x="105" y="103"/>
                      </a:lnTo>
                      <a:lnTo>
                        <a:pt x="106" y="103"/>
                      </a:lnTo>
                      <a:lnTo>
                        <a:pt x="106" y="100"/>
                      </a:lnTo>
                      <a:lnTo>
                        <a:pt x="106" y="103"/>
                      </a:lnTo>
                      <a:lnTo>
                        <a:pt x="106" y="103"/>
                      </a:lnTo>
                      <a:lnTo>
                        <a:pt x="107" y="103"/>
                      </a:lnTo>
                      <a:lnTo>
                        <a:pt x="107" y="100"/>
                      </a:lnTo>
                      <a:lnTo>
                        <a:pt x="107" y="105"/>
                      </a:lnTo>
                      <a:lnTo>
                        <a:pt x="107" y="100"/>
                      </a:lnTo>
                      <a:lnTo>
                        <a:pt x="108" y="100"/>
                      </a:lnTo>
                      <a:lnTo>
                        <a:pt x="108" y="100"/>
                      </a:lnTo>
                      <a:lnTo>
                        <a:pt x="108" y="104"/>
                      </a:lnTo>
                      <a:lnTo>
                        <a:pt x="108" y="104"/>
                      </a:lnTo>
                      <a:lnTo>
                        <a:pt x="109" y="104"/>
                      </a:lnTo>
                      <a:lnTo>
                        <a:pt x="109" y="100"/>
                      </a:lnTo>
                      <a:lnTo>
                        <a:pt x="109" y="104"/>
                      </a:lnTo>
                      <a:lnTo>
                        <a:pt x="109" y="102"/>
                      </a:lnTo>
                      <a:lnTo>
                        <a:pt x="110" y="102"/>
                      </a:lnTo>
                      <a:lnTo>
                        <a:pt x="110" y="100"/>
                      </a:lnTo>
                      <a:lnTo>
                        <a:pt x="110" y="104"/>
                      </a:lnTo>
                      <a:lnTo>
                        <a:pt x="110" y="101"/>
                      </a:lnTo>
                      <a:lnTo>
                        <a:pt x="111" y="101"/>
                      </a:lnTo>
                      <a:lnTo>
                        <a:pt x="111" y="100"/>
                      </a:lnTo>
                      <a:lnTo>
                        <a:pt x="111" y="103"/>
                      </a:lnTo>
                      <a:lnTo>
                        <a:pt x="111" y="103"/>
                      </a:lnTo>
                      <a:lnTo>
                        <a:pt x="112" y="103"/>
                      </a:lnTo>
                      <a:lnTo>
                        <a:pt x="112" y="100"/>
                      </a:lnTo>
                      <a:lnTo>
                        <a:pt x="112" y="104"/>
                      </a:lnTo>
                      <a:lnTo>
                        <a:pt x="112" y="100"/>
                      </a:lnTo>
                      <a:lnTo>
                        <a:pt x="113" y="100"/>
                      </a:lnTo>
                      <a:lnTo>
                        <a:pt x="113" y="100"/>
                      </a:lnTo>
                      <a:lnTo>
                        <a:pt x="113" y="104"/>
                      </a:lnTo>
                      <a:lnTo>
                        <a:pt x="113" y="103"/>
                      </a:lnTo>
                      <a:lnTo>
                        <a:pt x="114" y="103"/>
                      </a:lnTo>
                      <a:lnTo>
                        <a:pt x="114" y="101"/>
                      </a:lnTo>
                      <a:lnTo>
                        <a:pt x="114" y="104"/>
                      </a:lnTo>
                      <a:lnTo>
                        <a:pt x="114" y="103"/>
                      </a:lnTo>
                      <a:lnTo>
                        <a:pt x="115" y="103"/>
                      </a:lnTo>
                      <a:lnTo>
                        <a:pt x="115" y="100"/>
                      </a:lnTo>
                      <a:lnTo>
                        <a:pt x="115" y="103"/>
                      </a:lnTo>
                      <a:lnTo>
                        <a:pt x="115" y="103"/>
                      </a:lnTo>
                      <a:lnTo>
                        <a:pt x="116" y="103"/>
                      </a:lnTo>
                      <a:lnTo>
                        <a:pt x="116" y="101"/>
                      </a:lnTo>
                      <a:lnTo>
                        <a:pt x="116" y="104"/>
                      </a:lnTo>
                      <a:lnTo>
                        <a:pt x="116" y="103"/>
                      </a:lnTo>
                      <a:lnTo>
                        <a:pt x="117" y="103"/>
                      </a:lnTo>
                      <a:lnTo>
                        <a:pt x="117" y="101"/>
                      </a:lnTo>
                      <a:lnTo>
                        <a:pt x="117" y="105"/>
                      </a:lnTo>
                      <a:lnTo>
                        <a:pt x="117" y="104"/>
                      </a:lnTo>
                      <a:lnTo>
                        <a:pt x="118" y="104"/>
                      </a:lnTo>
                      <a:lnTo>
                        <a:pt x="118" y="100"/>
                      </a:lnTo>
                      <a:lnTo>
                        <a:pt x="118" y="104"/>
                      </a:lnTo>
                      <a:lnTo>
                        <a:pt x="118" y="103"/>
                      </a:lnTo>
                      <a:lnTo>
                        <a:pt x="119" y="103"/>
                      </a:lnTo>
                      <a:lnTo>
                        <a:pt x="119" y="100"/>
                      </a:lnTo>
                      <a:lnTo>
                        <a:pt x="119" y="103"/>
                      </a:lnTo>
                      <a:lnTo>
                        <a:pt x="119" y="101"/>
                      </a:lnTo>
                      <a:lnTo>
                        <a:pt x="120" y="101"/>
                      </a:lnTo>
                      <a:lnTo>
                        <a:pt x="120" y="100"/>
                      </a:lnTo>
                      <a:lnTo>
                        <a:pt x="120" y="104"/>
                      </a:lnTo>
                      <a:lnTo>
                        <a:pt x="120" y="101"/>
                      </a:lnTo>
                      <a:lnTo>
                        <a:pt x="121" y="101"/>
                      </a:lnTo>
                      <a:lnTo>
                        <a:pt x="121" y="101"/>
                      </a:lnTo>
                      <a:lnTo>
                        <a:pt x="121" y="104"/>
                      </a:lnTo>
                      <a:lnTo>
                        <a:pt x="121" y="104"/>
                      </a:lnTo>
                      <a:lnTo>
                        <a:pt x="122" y="104"/>
                      </a:lnTo>
                      <a:lnTo>
                        <a:pt x="122" y="103"/>
                      </a:lnTo>
                      <a:lnTo>
                        <a:pt x="122" y="105"/>
                      </a:lnTo>
                      <a:lnTo>
                        <a:pt x="122" y="104"/>
                      </a:lnTo>
                      <a:lnTo>
                        <a:pt x="123" y="104"/>
                      </a:lnTo>
                      <a:lnTo>
                        <a:pt x="123" y="100"/>
                      </a:lnTo>
                      <a:lnTo>
                        <a:pt x="123" y="104"/>
                      </a:lnTo>
                      <a:lnTo>
                        <a:pt x="123" y="103"/>
                      </a:lnTo>
                      <a:lnTo>
                        <a:pt x="124" y="103"/>
                      </a:lnTo>
                      <a:lnTo>
                        <a:pt x="124" y="101"/>
                      </a:lnTo>
                      <a:lnTo>
                        <a:pt x="124" y="105"/>
                      </a:lnTo>
                      <a:lnTo>
                        <a:pt x="124" y="104"/>
                      </a:lnTo>
                      <a:lnTo>
                        <a:pt x="125" y="104"/>
                      </a:lnTo>
                      <a:lnTo>
                        <a:pt x="125" y="102"/>
                      </a:lnTo>
                      <a:lnTo>
                        <a:pt x="125" y="106"/>
                      </a:lnTo>
                      <a:lnTo>
                        <a:pt x="125" y="103"/>
                      </a:lnTo>
                      <a:lnTo>
                        <a:pt x="126" y="103"/>
                      </a:lnTo>
                      <a:lnTo>
                        <a:pt x="126" y="101"/>
                      </a:lnTo>
                      <a:lnTo>
                        <a:pt x="126" y="105"/>
                      </a:lnTo>
                      <a:lnTo>
                        <a:pt x="126" y="103"/>
                      </a:lnTo>
                      <a:lnTo>
                        <a:pt x="127" y="103"/>
                      </a:lnTo>
                      <a:lnTo>
                        <a:pt x="127" y="102"/>
                      </a:lnTo>
                      <a:lnTo>
                        <a:pt x="127" y="105"/>
                      </a:lnTo>
                      <a:lnTo>
                        <a:pt x="127" y="104"/>
                      </a:lnTo>
                      <a:lnTo>
                        <a:pt x="128" y="104"/>
                      </a:lnTo>
                      <a:lnTo>
                        <a:pt x="128" y="101"/>
                      </a:lnTo>
                      <a:lnTo>
                        <a:pt x="128" y="105"/>
                      </a:lnTo>
                      <a:lnTo>
                        <a:pt x="128" y="101"/>
                      </a:lnTo>
                      <a:lnTo>
                        <a:pt x="129" y="101"/>
                      </a:lnTo>
                      <a:lnTo>
                        <a:pt x="129" y="100"/>
                      </a:lnTo>
                      <a:lnTo>
                        <a:pt x="129" y="104"/>
                      </a:lnTo>
                      <a:lnTo>
                        <a:pt x="129" y="101"/>
                      </a:lnTo>
                      <a:lnTo>
                        <a:pt x="130" y="101"/>
                      </a:lnTo>
                      <a:lnTo>
                        <a:pt x="130" y="100"/>
                      </a:lnTo>
                      <a:lnTo>
                        <a:pt x="130" y="103"/>
                      </a:lnTo>
                      <a:lnTo>
                        <a:pt x="130" y="101"/>
                      </a:lnTo>
                      <a:lnTo>
                        <a:pt x="131" y="101"/>
                      </a:lnTo>
                      <a:lnTo>
                        <a:pt x="131" y="100"/>
                      </a:lnTo>
                      <a:lnTo>
                        <a:pt x="131" y="104"/>
                      </a:lnTo>
                      <a:lnTo>
                        <a:pt x="131" y="104"/>
                      </a:lnTo>
                      <a:lnTo>
                        <a:pt x="132" y="104"/>
                      </a:lnTo>
                      <a:lnTo>
                        <a:pt x="132" y="101"/>
                      </a:lnTo>
                      <a:lnTo>
                        <a:pt x="132" y="105"/>
                      </a:lnTo>
                      <a:lnTo>
                        <a:pt x="132" y="103"/>
                      </a:lnTo>
                      <a:lnTo>
                        <a:pt x="133" y="103"/>
                      </a:lnTo>
                      <a:lnTo>
                        <a:pt x="133" y="100"/>
                      </a:lnTo>
                      <a:lnTo>
                        <a:pt x="133" y="105"/>
                      </a:lnTo>
                      <a:lnTo>
                        <a:pt x="133" y="102"/>
                      </a:lnTo>
                      <a:lnTo>
                        <a:pt x="134" y="102"/>
                      </a:lnTo>
                      <a:lnTo>
                        <a:pt x="134" y="100"/>
                      </a:lnTo>
                      <a:lnTo>
                        <a:pt x="134" y="103"/>
                      </a:lnTo>
                      <a:lnTo>
                        <a:pt x="134" y="101"/>
                      </a:lnTo>
                      <a:lnTo>
                        <a:pt x="135" y="101"/>
                      </a:lnTo>
                      <a:lnTo>
                        <a:pt x="135" y="100"/>
                      </a:lnTo>
                      <a:lnTo>
                        <a:pt x="135" y="103"/>
                      </a:lnTo>
                      <a:lnTo>
                        <a:pt x="135" y="103"/>
                      </a:lnTo>
                      <a:lnTo>
                        <a:pt x="136" y="103"/>
                      </a:lnTo>
                      <a:lnTo>
                        <a:pt x="136" y="101"/>
                      </a:lnTo>
                      <a:lnTo>
                        <a:pt x="136" y="104"/>
                      </a:lnTo>
                      <a:lnTo>
                        <a:pt x="136" y="102"/>
                      </a:lnTo>
                      <a:lnTo>
                        <a:pt x="137" y="102"/>
                      </a:lnTo>
                      <a:lnTo>
                        <a:pt x="137" y="101"/>
                      </a:lnTo>
                      <a:lnTo>
                        <a:pt x="137" y="105"/>
                      </a:lnTo>
                      <a:lnTo>
                        <a:pt x="137" y="102"/>
                      </a:lnTo>
                      <a:lnTo>
                        <a:pt x="138" y="102"/>
                      </a:lnTo>
                      <a:lnTo>
                        <a:pt x="138" y="101"/>
                      </a:lnTo>
                      <a:lnTo>
                        <a:pt x="138" y="105"/>
                      </a:lnTo>
                      <a:lnTo>
                        <a:pt x="138" y="104"/>
                      </a:lnTo>
                      <a:lnTo>
                        <a:pt x="139" y="104"/>
                      </a:lnTo>
                      <a:lnTo>
                        <a:pt x="139" y="101"/>
                      </a:lnTo>
                      <a:lnTo>
                        <a:pt x="139" y="104"/>
                      </a:lnTo>
                      <a:lnTo>
                        <a:pt x="139" y="103"/>
                      </a:lnTo>
                      <a:lnTo>
                        <a:pt x="140" y="103"/>
                      </a:lnTo>
                      <a:lnTo>
                        <a:pt x="140" y="100"/>
                      </a:lnTo>
                      <a:lnTo>
                        <a:pt x="140" y="105"/>
                      </a:lnTo>
                      <a:lnTo>
                        <a:pt x="140" y="100"/>
                      </a:lnTo>
                      <a:lnTo>
                        <a:pt x="141" y="100"/>
                      </a:lnTo>
                      <a:lnTo>
                        <a:pt x="141" y="100"/>
                      </a:lnTo>
                      <a:lnTo>
                        <a:pt x="141" y="104"/>
                      </a:lnTo>
                      <a:lnTo>
                        <a:pt x="141" y="103"/>
                      </a:lnTo>
                      <a:lnTo>
                        <a:pt x="142" y="103"/>
                      </a:lnTo>
                      <a:lnTo>
                        <a:pt x="142" y="101"/>
                      </a:lnTo>
                      <a:lnTo>
                        <a:pt x="142" y="104"/>
                      </a:lnTo>
                      <a:lnTo>
                        <a:pt x="142" y="104"/>
                      </a:lnTo>
                      <a:lnTo>
                        <a:pt x="143" y="104"/>
                      </a:lnTo>
                      <a:lnTo>
                        <a:pt x="143" y="100"/>
                      </a:lnTo>
                      <a:lnTo>
                        <a:pt x="143" y="104"/>
                      </a:lnTo>
                      <a:lnTo>
                        <a:pt x="143" y="101"/>
                      </a:lnTo>
                      <a:lnTo>
                        <a:pt x="144" y="101"/>
                      </a:lnTo>
                      <a:lnTo>
                        <a:pt x="144" y="100"/>
                      </a:lnTo>
                      <a:lnTo>
                        <a:pt x="144" y="104"/>
                      </a:lnTo>
                      <a:lnTo>
                        <a:pt x="144" y="102"/>
                      </a:lnTo>
                      <a:lnTo>
                        <a:pt x="145" y="102"/>
                      </a:lnTo>
                      <a:lnTo>
                        <a:pt x="145" y="100"/>
                      </a:lnTo>
                      <a:lnTo>
                        <a:pt x="145" y="103"/>
                      </a:lnTo>
                      <a:lnTo>
                        <a:pt x="145" y="100"/>
                      </a:lnTo>
                      <a:lnTo>
                        <a:pt x="146" y="100"/>
                      </a:lnTo>
                      <a:lnTo>
                        <a:pt x="146" y="100"/>
                      </a:lnTo>
                      <a:lnTo>
                        <a:pt x="146" y="105"/>
                      </a:lnTo>
                      <a:lnTo>
                        <a:pt x="146" y="103"/>
                      </a:lnTo>
                      <a:lnTo>
                        <a:pt x="147" y="103"/>
                      </a:lnTo>
                      <a:lnTo>
                        <a:pt x="147" y="101"/>
                      </a:lnTo>
                      <a:lnTo>
                        <a:pt x="147" y="107"/>
                      </a:lnTo>
                      <a:lnTo>
                        <a:pt x="147" y="103"/>
                      </a:lnTo>
                      <a:lnTo>
                        <a:pt x="148" y="103"/>
                      </a:lnTo>
                      <a:lnTo>
                        <a:pt x="148" y="98"/>
                      </a:lnTo>
                      <a:lnTo>
                        <a:pt x="148" y="104"/>
                      </a:lnTo>
                      <a:lnTo>
                        <a:pt x="148" y="100"/>
                      </a:lnTo>
                      <a:lnTo>
                        <a:pt x="149" y="100"/>
                      </a:lnTo>
                      <a:lnTo>
                        <a:pt x="149" y="98"/>
                      </a:lnTo>
                      <a:lnTo>
                        <a:pt x="149" y="104"/>
                      </a:lnTo>
                      <a:lnTo>
                        <a:pt x="149" y="100"/>
                      </a:lnTo>
                      <a:lnTo>
                        <a:pt x="150" y="100"/>
                      </a:lnTo>
                      <a:lnTo>
                        <a:pt x="150" y="99"/>
                      </a:lnTo>
                      <a:lnTo>
                        <a:pt x="150" y="104"/>
                      </a:lnTo>
                      <a:lnTo>
                        <a:pt x="150" y="101"/>
                      </a:lnTo>
                      <a:lnTo>
                        <a:pt x="151" y="101"/>
                      </a:lnTo>
                      <a:lnTo>
                        <a:pt x="151" y="100"/>
                      </a:lnTo>
                      <a:lnTo>
                        <a:pt x="151" y="104"/>
                      </a:lnTo>
                      <a:lnTo>
                        <a:pt x="151" y="101"/>
                      </a:lnTo>
                      <a:lnTo>
                        <a:pt x="152" y="101"/>
                      </a:lnTo>
                      <a:lnTo>
                        <a:pt x="152" y="100"/>
                      </a:lnTo>
                      <a:lnTo>
                        <a:pt x="152" y="104"/>
                      </a:lnTo>
                      <a:lnTo>
                        <a:pt x="152" y="103"/>
                      </a:lnTo>
                      <a:lnTo>
                        <a:pt x="153" y="103"/>
                      </a:lnTo>
                      <a:lnTo>
                        <a:pt x="153" y="101"/>
                      </a:lnTo>
                      <a:lnTo>
                        <a:pt x="153" y="103"/>
                      </a:lnTo>
                      <a:lnTo>
                        <a:pt x="153" y="102"/>
                      </a:lnTo>
                      <a:lnTo>
                        <a:pt x="154" y="102"/>
                      </a:lnTo>
                      <a:lnTo>
                        <a:pt x="154" y="100"/>
                      </a:lnTo>
                      <a:lnTo>
                        <a:pt x="154" y="104"/>
                      </a:lnTo>
                      <a:lnTo>
                        <a:pt x="154" y="102"/>
                      </a:lnTo>
                      <a:lnTo>
                        <a:pt x="155" y="102"/>
                      </a:lnTo>
                      <a:lnTo>
                        <a:pt x="155" y="99"/>
                      </a:lnTo>
                      <a:lnTo>
                        <a:pt x="155" y="103"/>
                      </a:lnTo>
                      <a:lnTo>
                        <a:pt x="155" y="103"/>
                      </a:lnTo>
                      <a:lnTo>
                        <a:pt x="156" y="103"/>
                      </a:lnTo>
                      <a:lnTo>
                        <a:pt x="156" y="99"/>
                      </a:lnTo>
                      <a:lnTo>
                        <a:pt x="156" y="104"/>
                      </a:lnTo>
                      <a:lnTo>
                        <a:pt x="156" y="103"/>
                      </a:lnTo>
                      <a:lnTo>
                        <a:pt x="157" y="103"/>
                      </a:lnTo>
                      <a:lnTo>
                        <a:pt x="157" y="100"/>
                      </a:lnTo>
                      <a:lnTo>
                        <a:pt x="157" y="104"/>
                      </a:lnTo>
                      <a:lnTo>
                        <a:pt x="157" y="103"/>
                      </a:lnTo>
                      <a:lnTo>
                        <a:pt x="158" y="103"/>
                      </a:lnTo>
                      <a:lnTo>
                        <a:pt x="158" y="101"/>
                      </a:lnTo>
                      <a:lnTo>
                        <a:pt x="158" y="105"/>
                      </a:lnTo>
                      <a:lnTo>
                        <a:pt x="158" y="101"/>
                      </a:lnTo>
                      <a:lnTo>
                        <a:pt x="159" y="101"/>
                      </a:lnTo>
                      <a:lnTo>
                        <a:pt x="159" y="101"/>
                      </a:lnTo>
                      <a:lnTo>
                        <a:pt x="159" y="105"/>
                      </a:lnTo>
                      <a:lnTo>
                        <a:pt x="159" y="103"/>
                      </a:lnTo>
                      <a:lnTo>
                        <a:pt x="160" y="103"/>
                      </a:lnTo>
                      <a:lnTo>
                        <a:pt x="160" y="101"/>
                      </a:lnTo>
                      <a:lnTo>
                        <a:pt x="160" y="104"/>
                      </a:lnTo>
                      <a:lnTo>
                        <a:pt x="160" y="103"/>
                      </a:lnTo>
                      <a:lnTo>
                        <a:pt x="161" y="103"/>
                      </a:lnTo>
                      <a:lnTo>
                        <a:pt x="161" y="101"/>
                      </a:lnTo>
                      <a:lnTo>
                        <a:pt x="161" y="104"/>
                      </a:lnTo>
                      <a:lnTo>
                        <a:pt x="161" y="103"/>
                      </a:lnTo>
                      <a:lnTo>
                        <a:pt x="162" y="103"/>
                      </a:lnTo>
                      <a:lnTo>
                        <a:pt x="162" y="102"/>
                      </a:lnTo>
                      <a:lnTo>
                        <a:pt x="162" y="105"/>
                      </a:lnTo>
                      <a:lnTo>
                        <a:pt x="162" y="104"/>
                      </a:lnTo>
                      <a:lnTo>
                        <a:pt x="163" y="104"/>
                      </a:lnTo>
                      <a:lnTo>
                        <a:pt x="163" y="101"/>
                      </a:lnTo>
                      <a:lnTo>
                        <a:pt x="163" y="104"/>
                      </a:lnTo>
                      <a:lnTo>
                        <a:pt x="163" y="103"/>
                      </a:lnTo>
                      <a:lnTo>
                        <a:pt x="164" y="103"/>
                      </a:lnTo>
                      <a:lnTo>
                        <a:pt x="164" y="102"/>
                      </a:lnTo>
                      <a:lnTo>
                        <a:pt x="164" y="104"/>
                      </a:lnTo>
                      <a:lnTo>
                        <a:pt x="164" y="104"/>
                      </a:lnTo>
                      <a:lnTo>
                        <a:pt x="165" y="104"/>
                      </a:lnTo>
                      <a:lnTo>
                        <a:pt x="165" y="103"/>
                      </a:lnTo>
                      <a:lnTo>
                        <a:pt x="165" y="108"/>
                      </a:lnTo>
                      <a:lnTo>
                        <a:pt x="165" y="105"/>
                      </a:lnTo>
                      <a:lnTo>
                        <a:pt x="166" y="105"/>
                      </a:lnTo>
                      <a:lnTo>
                        <a:pt x="166" y="103"/>
                      </a:lnTo>
                      <a:lnTo>
                        <a:pt x="166" y="105"/>
                      </a:lnTo>
                      <a:lnTo>
                        <a:pt x="166" y="104"/>
                      </a:lnTo>
                      <a:lnTo>
                        <a:pt x="167" y="104"/>
                      </a:lnTo>
                      <a:lnTo>
                        <a:pt x="167" y="103"/>
                      </a:lnTo>
                      <a:lnTo>
                        <a:pt x="167" y="106"/>
                      </a:lnTo>
                      <a:lnTo>
                        <a:pt x="167" y="105"/>
                      </a:lnTo>
                      <a:lnTo>
                        <a:pt x="168" y="105"/>
                      </a:lnTo>
                      <a:lnTo>
                        <a:pt x="168" y="103"/>
                      </a:lnTo>
                      <a:lnTo>
                        <a:pt x="168" y="105"/>
                      </a:lnTo>
                      <a:lnTo>
                        <a:pt x="168" y="103"/>
                      </a:lnTo>
                      <a:lnTo>
                        <a:pt x="169" y="103"/>
                      </a:lnTo>
                      <a:lnTo>
                        <a:pt x="169" y="101"/>
                      </a:lnTo>
                      <a:lnTo>
                        <a:pt x="169" y="105"/>
                      </a:lnTo>
                      <a:lnTo>
                        <a:pt x="169" y="103"/>
                      </a:lnTo>
                      <a:lnTo>
                        <a:pt x="170" y="103"/>
                      </a:lnTo>
                      <a:lnTo>
                        <a:pt x="170" y="103"/>
                      </a:lnTo>
                      <a:lnTo>
                        <a:pt x="170" y="105"/>
                      </a:lnTo>
                      <a:lnTo>
                        <a:pt x="170" y="104"/>
                      </a:lnTo>
                      <a:lnTo>
                        <a:pt x="171" y="104"/>
                      </a:lnTo>
                      <a:lnTo>
                        <a:pt x="171" y="101"/>
                      </a:lnTo>
                      <a:lnTo>
                        <a:pt x="171" y="105"/>
                      </a:lnTo>
                      <a:lnTo>
                        <a:pt x="171" y="103"/>
                      </a:lnTo>
                      <a:lnTo>
                        <a:pt x="172" y="103"/>
                      </a:lnTo>
                      <a:lnTo>
                        <a:pt x="172" y="103"/>
                      </a:lnTo>
                      <a:lnTo>
                        <a:pt x="172" y="107"/>
                      </a:lnTo>
                      <a:lnTo>
                        <a:pt x="172" y="105"/>
                      </a:lnTo>
                      <a:lnTo>
                        <a:pt x="173" y="105"/>
                      </a:lnTo>
                      <a:lnTo>
                        <a:pt x="173" y="103"/>
                      </a:lnTo>
                      <a:lnTo>
                        <a:pt x="173" y="105"/>
                      </a:lnTo>
                      <a:lnTo>
                        <a:pt x="173" y="103"/>
                      </a:lnTo>
                      <a:lnTo>
                        <a:pt x="174" y="103"/>
                      </a:lnTo>
                      <a:lnTo>
                        <a:pt x="174" y="103"/>
                      </a:lnTo>
                      <a:lnTo>
                        <a:pt x="174" y="106"/>
                      </a:lnTo>
                      <a:lnTo>
                        <a:pt x="174" y="106"/>
                      </a:lnTo>
                      <a:lnTo>
                        <a:pt x="175" y="106"/>
                      </a:lnTo>
                      <a:lnTo>
                        <a:pt x="175" y="104"/>
                      </a:lnTo>
                      <a:lnTo>
                        <a:pt x="175" y="107"/>
                      </a:lnTo>
                      <a:lnTo>
                        <a:pt x="175" y="104"/>
                      </a:lnTo>
                      <a:lnTo>
                        <a:pt x="176" y="104"/>
                      </a:lnTo>
                      <a:lnTo>
                        <a:pt x="176" y="103"/>
                      </a:lnTo>
                      <a:lnTo>
                        <a:pt x="176" y="107"/>
                      </a:lnTo>
                      <a:lnTo>
                        <a:pt x="176" y="103"/>
                      </a:lnTo>
                      <a:lnTo>
                        <a:pt x="177" y="103"/>
                      </a:lnTo>
                      <a:lnTo>
                        <a:pt x="177" y="103"/>
                      </a:lnTo>
                      <a:lnTo>
                        <a:pt x="177" y="106"/>
                      </a:lnTo>
                      <a:lnTo>
                        <a:pt x="177" y="104"/>
                      </a:lnTo>
                      <a:lnTo>
                        <a:pt x="178" y="104"/>
                      </a:lnTo>
                      <a:lnTo>
                        <a:pt x="178" y="102"/>
                      </a:lnTo>
                      <a:lnTo>
                        <a:pt x="178" y="105"/>
                      </a:lnTo>
                      <a:lnTo>
                        <a:pt x="178" y="104"/>
                      </a:lnTo>
                      <a:lnTo>
                        <a:pt x="179" y="104"/>
                      </a:lnTo>
                      <a:lnTo>
                        <a:pt x="179" y="102"/>
                      </a:lnTo>
                      <a:lnTo>
                        <a:pt x="179" y="105"/>
                      </a:lnTo>
                      <a:lnTo>
                        <a:pt x="179" y="104"/>
                      </a:lnTo>
                      <a:lnTo>
                        <a:pt x="180" y="104"/>
                      </a:lnTo>
                      <a:lnTo>
                        <a:pt x="180" y="103"/>
                      </a:lnTo>
                      <a:lnTo>
                        <a:pt x="180" y="105"/>
                      </a:lnTo>
                      <a:lnTo>
                        <a:pt x="180" y="104"/>
                      </a:lnTo>
                      <a:lnTo>
                        <a:pt x="181" y="104"/>
                      </a:lnTo>
                      <a:lnTo>
                        <a:pt x="181" y="101"/>
                      </a:lnTo>
                      <a:lnTo>
                        <a:pt x="181" y="105"/>
                      </a:lnTo>
                      <a:lnTo>
                        <a:pt x="181" y="104"/>
                      </a:lnTo>
                      <a:lnTo>
                        <a:pt x="182" y="104"/>
                      </a:lnTo>
                      <a:lnTo>
                        <a:pt x="182" y="102"/>
                      </a:lnTo>
                      <a:lnTo>
                        <a:pt x="182" y="105"/>
                      </a:lnTo>
                      <a:lnTo>
                        <a:pt x="182" y="105"/>
                      </a:lnTo>
                      <a:lnTo>
                        <a:pt x="183" y="105"/>
                      </a:lnTo>
                      <a:lnTo>
                        <a:pt x="183" y="103"/>
                      </a:lnTo>
                      <a:lnTo>
                        <a:pt x="183" y="105"/>
                      </a:lnTo>
                      <a:lnTo>
                        <a:pt x="183" y="103"/>
                      </a:lnTo>
                      <a:lnTo>
                        <a:pt x="184" y="103"/>
                      </a:lnTo>
                      <a:lnTo>
                        <a:pt x="184" y="102"/>
                      </a:lnTo>
                      <a:lnTo>
                        <a:pt x="184" y="105"/>
                      </a:lnTo>
                      <a:lnTo>
                        <a:pt x="184" y="103"/>
                      </a:lnTo>
                      <a:lnTo>
                        <a:pt x="185" y="103"/>
                      </a:lnTo>
                      <a:lnTo>
                        <a:pt x="185" y="101"/>
                      </a:lnTo>
                      <a:lnTo>
                        <a:pt x="185" y="107"/>
                      </a:lnTo>
                      <a:lnTo>
                        <a:pt x="185" y="103"/>
                      </a:lnTo>
                      <a:lnTo>
                        <a:pt x="186" y="103"/>
                      </a:lnTo>
                      <a:lnTo>
                        <a:pt x="186" y="101"/>
                      </a:lnTo>
                      <a:lnTo>
                        <a:pt x="186" y="104"/>
                      </a:lnTo>
                      <a:lnTo>
                        <a:pt x="186" y="104"/>
                      </a:lnTo>
                      <a:lnTo>
                        <a:pt x="187" y="104"/>
                      </a:lnTo>
                      <a:lnTo>
                        <a:pt x="187" y="102"/>
                      </a:lnTo>
                      <a:lnTo>
                        <a:pt x="187" y="104"/>
                      </a:lnTo>
                      <a:lnTo>
                        <a:pt x="187" y="103"/>
                      </a:lnTo>
                      <a:lnTo>
                        <a:pt x="188" y="103"/>
                      </a:lnTo>
                      <a:lnTo>
                        <a:pt x="188" y="101"/>
                      </a:lnTo>
                      <a:lnTo>
                        <a:pt x="188" y="105"/>
                      </a:lnTo>
                      <a:lnTo>
                        <a:pt x="188" y="102"/>
                      </a:lnTo>
                      <a:lnTo>
                        <a:pt x="189" y="102"/>
                      </a:lnTo>
                      <a:lnTo>
                        <a:pt x="189" y="100"/>
                      </a:lnTo>
                      <a:lnTo>
                        <a:pt x="189" y="104"/>
                      </a:lnTo>
                      <a:lnTo>
                        <a:pt x="189" y="101"/>
                      </a:lnTo>
                      <a:lnTo>
                        <a:pt x="190" y="101"/>
                      </a:lnTo>
                      <a:lnTo>
                        <a:pt x="190" y="100"/>
                      </a:lnTo>
                      <a:lnTo>
                        <a:pt x="190" y="104"/>
                      </a:lnTo>
                      <a:lnTo>
                        <a:pt x="190" y="103"/>
                      </a:lnTo>
                      <a:lnTo>
                        <a:pt x="191" y="103"/>
                      </a:lnTo>
                      <a:lnTo>
                        <a:pt x="191" y="101"/>
                      </a:lnTo>
                      <a:lnTo>
                        <a:pt x="191" y="104"/>
                      </a:lnTo>
                      <a:lnTo>
                        <a:pt x="191" y="101"/>
                      </a:lnTo>
                      <a:lnTo>
                        <a:pt x="192" y="101"/>
                      </a:lnTo>
                      <a:lnTo>
                        <a:pt x="192" y="101"/>
                      </a:lnTo>
                      <a:lnTo>
                        <a:pt x="192" y="104"/>
                      </a:lnTo>
                      <a:lnTo>
                        <a:pt x="192" y="104"/>
                      </a:lnTo>
                      <a:lnTo>
                        <a:pt x="193" y="104"/>
                      </a:lnTo>
                      <a:lnTo>
                        <a:pt x="193" y="100"/>
                      </a:lnTo>
                      <a:lnTo>
                        <a:pt x="193" y="105"/>
                      </a:lnTo>
                      <a:lnTo>
                        <a:pt x="193" y="102"/>
                      </a:lnTo>
                      <a:lnTo>
                        <a:pt x="194" y="102"/>
                      </a:lnTo>
                      <a:lnTo>
                        <a:pt x="194" y="101"/>
                      </a:lnTo>
                      <a:lnTo>
                        <a:pt x="194" y="104"/>
                      </a:lnTo>
                      <a:lnTo>
                        <a:pt x="194" y="104"/>
                      </a:lnTo>
                      <a:lnTo>
                        <a:pt x="195" y="104"/>
                      </a:lnTo>
                      <a:lnTo>
                        <a:pt x="195" y="102"/>
                      </a:lnTo>
                      <a:lnTo>
                        <a:pt x="195" y="104"/>
                      </a:lnTo>
                      <a:lnTo>
                        <a:pt x="195" y="104"/>
                      </a:lnTo>
                      <a:lnTo>
                        <a:pt x="196" y="104"/>
                      </a:lnTo>
                      <a:lnTo>
                        <a:pt x="196" y="100"/>
                      </a:lnTo>
                      <a:lnTo>
                        <a:pt x="196" y="104"/>
                      </a:lnTo>
                      <a:lnTo>
                        <a:pt x="196" y="100"/>
                      </a:lnTo>
                      <a:lnTo>
                        <a:pt x="197" y="100"/>
                      </a:lnTo>
                      <a:lnTo>
                        <a:pt x="197" y="100"/>
                      </a:lnTo>
                      <a:lnTo>
                        <a:pt x="197" y="104"/>
                      </a:lnTo>
                      <a:lnTo>
                        <a:pt x="197" y="103"/>
                      </a:lnTo>
                      <a:lnTo>
                        <a:pt x="198" y="103"/>
                      </a:lnTo>
                      <a:lnTo>
                        <a:pt x="198" y="101"/>
                      </a:lnTo>
                      <a:lnTo>
                        <a:pt x="198" y="106"/>
                      </a:lnTo>
                      <a:lnTo>
                        <a:pt x="198" y="103"/>
                      </a:lnTo>
                      <a:lnTo>
                        <a:pt x="199" y="103"/>
                      </a:lnTo>
                      <a:lnTo>
                        <a:pt x="199" y="101"/>
                      </a:lnTo>
                      <a:lnTo>
                        <a:pt x="199" y="105"/>
                      </a:lnTo>
                      <a:lnTo>
                        <a:pt x="199" y="101"/>
                      </a:lnTo>
                      <a:lnTo>
                        <a:pt x="200" y="101"/>
                      </a:lnTo>
                      <a:lnTo>
                        <a:pt x="200" y="101"/>
                      </a:lnTo>
                      <a:lnTo>
                        <a:pt x="200" y="112"/>
                      </a:lnTo>
                      <a:lnTo>
                        <a:pt x="200" y="102"/>
                      </a:lnTo>
                      <a:lnTo>
                        <a:pt x="201" y="102"/>
                      </a:lnTo>
                      <a:lnTo>
                        <a:pt x="201" y="101"/>
                      </a:lnTo>
                      <a:lnTo>
                        <a:pt x="201" y="104"/>
                      </a:lnTo>
                      <a:lnTo>
                        <a:pt x="201" y="101"/>
                      </a:lnTo>
                      <a:lnTo>
                        <a:pt x="202" y="101"/>
                      </a:lnTo>
                      <a:lnTo>
                        <a:pt x="202" y="102"/>
                      </a:lnTo>
                      <a:lnTo>
                        <a:pt x="202" y="105"/>
                      </a:lnTo>
                      <a:lnTo>
                        <a:pt x="202" y="104"/>
                      </a:lnTo>
                      <a:lnTo>
                        <a:pt x="203" y="104"/>
                      </a:lnTo>
                      <a:lnTo>
                        <a:pt x="203" y="102"/>
                      </a:lnTo>
                      <a:lnTo>
                        <a:pt x="203" y="105"/>
                      </a:lnTo>
                      <a:lnTo>
                        <a:pt x="203" y="104"/>
                      </a:lnTo>
                      <a:lnTo>
                        <a:pt x="204" y="104"/>
                      </a:lnTo>
                      <a:lnTo>
                        <a:pt x="204" y="101"/>
                      </a:lnTo>
                      <a:lnTo>
                        <a:pt x="204" y="106"/>
                      </a:lnTo>
                      <a:lnTo>
                        <a:pt x="204" y="104"/>
                      </a:lnTo>
                      <a:lnTo>
                        <a:pt x="205" y="104"/>
                      </a:lnTo>
                      <a:lnTo>
                        <a:pt x="205" y="103"/>
                      </a:lnTo>
                      <a:lnTo>
                        <a:pt x="205" y="105"/>
                      </a:lnTo>
                      <a:lnTo>
                        <a:pt x="205" y="104"/>
                      </a:lnTo>
                      <a:lnTo>
                        <a:pt x="206" y="104"/>
                      </a:lnTo>
                      <a:lnTo>
                        <a:pt x="206" y="102"/>
                      </a:lnTo>
                      <a:lnTo>
                        <a:pt x="206" y="105"/>
                      </a:lnTo>
                      <a:lnTo>
                        <a:pt x="206" y="105"/>
                      </a:lnTo>
                      <a:lnTo>
                        <a:pt x="207" y="105"/>
                      </a:lnTo>
                      <a:lnTo>
                        <a:pt x="207" y="102"/>
                      </a:lnTo>
                      <a:lnTo>
                        <a:pt x="207" y="105"/>
                      </a:lnTo>
                      <a:lnTo>
                        <a:pt x="207" y="104"/>
                      </a:lnTo>
                      <a:lnTo>
                        <a:pt x="208" y="104"/>
                      </a:lnTo>
                      <a:lnTo>
                        <a:pt x="208" y="102"/>
                      </a:lnTo>
                      <a:lnTo>
                        <a:pt x="208" y="105"/>
                      </a:lnTo>
                      <a:lnTo>
                        <a:pt x="208" y="104"/>
                      </a:lnTo>
                      <a:lnTo>
                        <a:pt x="209" y="104"/>
                      </a:lnTo>
                      <a:lnTo>
                        <a:pt x="209" y="101"/>
                      </a:lnTo>
                      <a:lnTo>
                        <a:pt x="209" y="104"/>
                      </a:lnTo>
                      <a:lnTo>
                        <a:pt x="209" y="103"/>
                      </a:lnTo>
                      <a:lnTo>
                        <a:pt x="210" y="103"/>
                      </a:lnTo>
                      <a:lnTo>
                        <a:pt x="210" y="103"/>
                      </a:lnTo>
                      <a:lnTo>
                        <a:pt x="210" y="105"/>
                      </a:lnTo>
                      <a:lnTo>
                        <a:pt x="210" y="105"/>
                      </a:lnTo>
                      <a:lnTo>
                        <a:pt x="211" y="105"/>
                      </a:lnTo>
                      <a:lnTo>
                        <a:pt x="211" y="102"/>
                      </a:lnTo>
                      <a:lnTo>
                        <a:pt x="211" y="105"/>
                      </a:lnTo>
                      <a:lnTo>
                        <a:pt x="211" y="103"/>
                      </a:lnTo>
                      <a:lnTo>
                        <a:pt x="212" y="103"/>
                      </a:lnTo>
                      <a:lnTo>
                        <a:pt x="212" y="102"/>
                      </a:lnTo>
                      <a:lnTo>
                        <a:pt x="212" y="105"/>
                      </a:lnTo>
                      <a:lnTo>
                        <a:pt x="212" y="103"/>
                      </a:lnTo>
                      <a:lnTo>
                        <a:pt x="213" y="103"/>
                      </a:lnTo>
                      <a:lnTo>
                        <a:pt x="213" y="103"/>
                      </a:lnTo>
                      <a:lnTo>
                        <a:pt x="213" y="105"/>
                      </a:lnTo>
                      <a:lnTo>
                        <a:pt x="213" y="104"/>
                      </a:lnTo>
                      <a:lnTo>
                        <a:pt x="214" y="104"/>
                      </a:lnTo>
                      <a:lnTo>
                        <a:pt x="214" y="101"/>
                      </a:lnTo>
                      <a:lnTo>
                        <a:pt x="214" y="105"/>
                      </a:lnTo>
                      <a:lnTo>
                        <a:pt x="214" y="104"/>
                      </a:lnTo>
                      <a:lnTo>
                        <a:pt x="215" y="104"/>
                      </a:lnTo>
                      <a:lnTo>
                        <a:pt x="215" y="102"/>
                      </a:lnTo>
                      <a:lnTo>
                        <a:pt x="215" y="105"/>
                      </a:lnTo>
                      <a:lnTo>
                        <a:pt x="215" y="103"/>
                      </a:lnTo>
                      <a:lnTo>
                        <a:pt x="216" y="103"/>
                      </a:lnTo>
                      <a:lnTo>
                        <a:pt x="216" y="101"/>
                      </a:lnTo>
                      <a:lnTo>
                        <a:pt x="216" y="104"/>
                      </a:lnTo>
                      <a:lnTo>
                        <a:pt x="216" y="104"/>
                      </a:lnTo>
                      <a:lnTo>
                        <a:pt x="217" y="104"/>
                      </a:lnTo>
                      <a:lnTo>
                        <a:pt x="217" y="102"/>
                      </a:lnTo>
                      <a:lnTo>
                        <a:pt x="217" y="106"/>
                      </a:lnTo>
                      <a:lnTo>
                        <a:pt x="217" y="104"/>
                      </a:lnTo>
                      <a:lnTo>
                        <a:pt x="218" y="104"/>
                      </a:lnTo>
                      <a:lnTo>
                        <a:pt x="218" y="102"/>
                      </a:lnTo>
                      <a:lnTo>
                        <a:pt x="218" y="105"/>
                      </a:lnTo>
                      <a:lnTo>
                        <a:pt x="218" y="104"/>
                      </a:lnTo>
                      <a:lnTo>
                        <a:pt x="219" y="104"/>
                      </a:lnTo>
                      <a:lnTo>
                        <a:pt x="219" y="103"/>
                      </a:lnTo>
                      <a:lnTo>
                        <a:pt x="219" y="106"/>
                      </a:lnTo>
                      <a:lnTo>
                        <a:pt x="219" y="104"/>
                      </a:lnTo>
                      <a:lnTo>
                        <a:pt x="220" y="104"/>
                      </a:lnTo>
                      <a:lnTo>
                        <a:pt x="220" y="104"/>
                      </a:lnTo>
                      <a:lnTo>
                        <a:pt x="220" y="105"/>
                      </a:lnTo>
                      <a:lnTo>
                        <a:pt x="220" y="105"/>
                      </a:lnTo>
                      <a:lnTo>
                        <a:pt x="221" y="105"/>
                      </a:lnTo>
                      <a:lnTo>
                        <a:pt x="221" y="104"/>
                      </a:lnTo>
                      <a:lnTo>
                        <a:pt x="221" y="107"/>
                      </a:lnTo>
                      <a:lnTo>
                        <a:pt x="221" y="104"/>
                      </a:lnTo>
                      <a:lnTo>
                        <a:pt x="222" y="104"/>
                      </a:lnTo>
                      <a:lnTo>
                        <a:pt x="222" y="104"/>
                      </a:lnTo>
                      <a:lnTo>
                        <a:pt x="222" y="109"/>
                      </a:lnTo>
                      <a:lnTo>
                        <a:pt x="222" y="109"/>
                      </a:lnTo>
                      <a:lnTo>
                        <a:pt x="223" y="109"/>
                      </a:lnTo>
                      <a:lnTo>
                        <a:pt x="223" y="107"/>
                      </a:lnTo>
                      <a:lnTo>
                        <a:pt x="223" y="110"/>
                      </a:lnTo>
                      <a:lnTo>
                        <a:pt x="223" y="110"/>
                      </a:lnTo>
                      <a:lnTo>
                        <a:pt x="224" y="110"/>
                      </a:lnTo>
                      <a:lnTo>
                        <a:pt x="224" y="108"/>
                      </a:lnTo>
                      <a:lnTo>
                        <a:pt x="224" y="113"/>
                      </a:lnTo>
                      <a:lnTo>
                        <a:pt x="224" y="111"/>
                      </a:lnTo>
                      <a:lnTo>
                        <a:pt x="225" y="111"/>
                      </a:lnTo>
                      <a:lnTo>
                        <a:pt x="225" y="111"/>
                      </a:lnTo>
                      <a:lnTo>
                        <a:pt x="225" y="116"/>
                      </a:lnTo>
                      <a:lnTo>
                        <a:pt x="225" y="112"/>
                      </a:lnTo>
                      <a:lnTo>
                        <a:pt x="226" y="112"/>
                      </a:lnTo>
                      <a:lnTo>
                        <a:pt x="226" y="112"/>
                      </a:lnTo>
                      <a:lnTo>
                        <a:pt x="226" y="116"/>
                      </a:lnTo>
                      <a:lnTo>
                        <a:pt x="226" y="114"/>
                      </a:lnTo>
                      <a:lnTo>
                        <a:pt x="227" y="114"/>
                      </a:lnTo>
                      <a:lnTo>
                        <a:pt x="227" y="113"/>
                      </a:lnTo>
                      <a:lnTo>
                        <a:pt x="227" y="117"/>
                      </a:lnTo>
                      <a:lnTo>
                        <a:pt x="227" y="115"/>
                      </a:lnTo>
                      <a:lnTo>
                        <a:pt x="228" y="115"/>
                      </a:lnTo>
                      <a:lnTo>
                        <a:pt x="228" y="114"/>
                      </a:lnTo>
                      <a:lnTo>
                        <a:pt x="228" y="117"/>
                      </a:lnTo>
                      <a:lnTo>
                        <a:pt x="228" y="116"/>
                      </a:lnTo>
                      <a:lnTo>
                        <a:pt x="229" y="116"/>
                      </a:lnTo>
                      <a:lnTo>
                        <a:pt x="229" y="116"/>
                      </a:lnTo>
                      <a:lnTo>
                        <a:pt x="229" y="119"/>
                      </a:lnTo>
                      <a:lnTo>
                        <a:pt x="229" y="119"/>
                      </a:lnTo>
                      <a:lnTo>
                        <a:pt x="230" y="119"/>
                      </a:lnTo>
                      <a:lnTo>
                        <a:pt x="230" y="117"/>
                      </a:lnTo>
                      <a:lnTo>
                        <a:pt x="230" y="120"/>
                      </a:lnTo>
                      <a:lnTo>
                        <a:pt x="230" y="119"/>
                      </a:lnTo>
                      <a:lnTo>
                        <a:pt x="231" y="119"/>
                      </a:lnTo>
                      <a:lnTo>
                        <a:pt x="231" y="119"/>
                      </a:lnTo>
                      <a:lnTo>
                        <a:pt x="231" y="122"/>
                      </a:lnTo>
                      <a:lnTo>
                        <a:pt x="231" y="120"/>
                      </a:lnTo>
                      <a:lnTo>
                        <a:pt x="232" y="120"/>
                      </a:lnTo>
                      <a:lnTo>
                        <a:pt x="232" y="120"/>
                      </a:lnTo>
                      <a:lnTo>
                        <a:pt x="232" y="125"/>
                      </a:lnTo>
                      <a:lnTo>
                        <a:pt x="232" y="122"/>
                      </a:lnTo>
                      <a:lnTo>
                        <a:pt x="233" y="122"/>
                      </a:lnTo>
                      <a:lnTo>
                        <a:pt x="233" y="121"/>
                      </a:lnTo>
                      <a:lnTo>
                        <a:pt x="233" y="125"/>
                      </a:lnTo>
                      <a:lnTo>
                        <a:pt x="233" y="123"/>
                      </a:lnTo>
                      <a:lnTo>
                        <a:pt x="234" y="123"/>
                      </a:lnTo>
                      <a:lnTo>
                        <a:pt x="234" y="122"/>
                      </a:lnTo>
                      <a:lnTo>
                        <a:pt x="234" y="126"/>
                      </a:lnTo>
                      <a:lnTo>
                        <a:pt x="234" y="125"/>
                      </a:lnTo>
                      <a:lnTo>
                        <a:pt x="235" y="125"/>
                      </a:lnTo>
                      <a:lnTo>
                        <a:pt x="235" y="124"/>
                      </a:lnTo>
                      <a:lnTo>
                        <a:pt x="235" y="129"/>
                      </a:lnTo>
                      <a:lnTo>
                        <a:pt x="235" y="126"/>
                      </a:lnTo>
                      <a:lnTo>
                        <a:pt x="236" y="126"/>
                      </a:lnTo>
                      <a:lnTo>
                        <a:pt x="236" y="126"/>
                      </a:lnTo>
                      <a:lnTo>
                        <a:pt x="236" y="129"/>
                      </a:lnTo>
                      <a:lnTo>
                        <a:pt x="236" y="127"/>
                      </a:lnTo>
                      <a:lnTo>
                        <a:pt x="237" y="127"/>
                      </a:lnTo>
                      <a:lnTo>
                        <a:pt x="237" y="126"/>
                      </a:lnTo>
                      <a:lnTo>
                        <a:pt x="237" y="129"/>
                      </a:lnTo>
                      <a:lnTo>
                        <a:pt x="237" y="129"/>
                      </a:lnTo>
                      <a:lnTo>
                        <a:pt x="238" y="129"/>
                      </a:lnTo>
                      <a:lnTo>
                        <a:pt x="238" y="127"/>
                      </a:lnTo>
                      <a:lnTo>
                        <a:pt x="238" y="132"/>
                      </a:lnTo>
                      <a:lnTo>
                        <a:pt x="238" y="129"/>
                      </a:lnTo>
                      <a:lnTo>
                        <a:pt x="239" y="129"/>
                      </a:lnTo>
                      <a:lnTo>
                        <a:pt x="239" y="129"/>
                      </a:lnTo>
                      <a:lnTo>
                        <a:pt x="239" y="132"/>
                      </a:lnTo>
                      <a:lnTo>
                        <a:pt x="239" y="131"/>
                      </a:lnTo>
                      <a:lnTo>
                        <a:pt x="240" y="131"/>
                      </a:lnTo>
                      <a:lnTo>
                        <a:pt x="240" y="130"/>
                      </a:lnTo>
                      <a:lnTo>
                        <a:pt x="240" y="135"/>
                      </a:lnTo>
                      <a:lnTo>
                        <a:pt x="240" y="132"/>
                      </a:lnTo>
                      <a:lnTo>
                        <a:pt x="241" y="132"/>
                      </a:lnTo>
                      <a:lnTo>
                        <a:pt x="241" y="132"/>
                      </a:lnTo>
                      <a:lnTo>
                        <a:pt x="241" y="136"/>
                      </a:lnTo>
                      <a:lnTo>
                        <a:pt x="241" y="136"/>
                      </a:lnTo>
                      <a:lnTo>
                        <a:pt x="242" y="136"/>
                      </a:lnTo>
                      <a:lnTo>
                        <a:pt x="242" y="134"/>
                      </a:lnTo>
                      <a:lnTo>
                        <a:pt x="242" y="138"/>
                      </a:lnTo>
                      <a:lnTo>
                        <a:pt x="242" y="136"/>
                      </a:lnTo>
                      <a:lnTo>
                        <a:pt x="243" y="136"/>
                      </a:lnTo>
                      <a:lnTo>
                        <a:pt x="243" y="135"/>
                      </a:lnTo>
                      <a:lnTo>
                        <a:pt x="243" y="138"/>
                      </a:lnTo>
                      <a:lnTo>
                        <a:pt x="243" y="136"/>
                      </a:lnTo>
                      <a:lnTo>
                        <a:pt x="244" y="136"/>
                      </a:lnTo>
                      <a:lnTo>
                        <a:pt x="244" y="136"/>
                      </a:lnTo>
                      <a:lnTo>
                        <a:pt x="244" y="139"/>
                      </a:lnTo>
                      <a:lnTo>
                        <a:pt x="244" y="139"/>
                      </a:lnTo>
                      <a:lnTo>
                        <a:pt x="245" y="139"/>
                      </a:lnTo>
                      <a:lnTo>
                        <a:pt x="245" y="138"/>
                      </a:lnTo>
                      <a:lnTo>
                        <a:pt x="245" y="141"/>
                      </a:lnTo>
                      <a:lnTo>
                        <a:pt x="245" y="138"/>
                      </a:lnTo>
                      <a:lnTo>
                        <a:pt x="246" y="138"/>
                      </a:lnTo>
                      <a:lnTo>
                        <a:pt x="246" y="138"/>
                      </a:lnTo>
                      <a:lnTo>
                        <a:pt x="246" y="142"/>
                      </a:lnTo>
                      <a:lnTo>
                        <a:pt x="246" y="139"/>
                      </a:lnTo>
                      <a:lnTo>
                        <a:pt x="247" y="139"/>
                      </a:lnTo>
                      <a:lnTo>
                        <a:pt x="247" y="138"/>
                      </a:lnTo>
                      <a:lnTo>
                        <a:pt x="247" y="143"/>
                      </a:lnTo>
                      <a:lnTo>
                        <a:pt x="247" y="140"/>
                      </a:lnTo>
                      <a:lnTo>
                        <a:pt x="248" y="140"/>
                      </a:lnTo>
                      <a:lnTo>
                        <a:pt x="248" y="140"/>
                      </a:lnTo>
                      <a:lnTo>
                        <a:pt x="248" y="144"/>
                      </a:lnTo>
                      <a:lnTo>
                        <a:pt x="248" y="140"/>
                      </a:lnTo>
                      <a:lnTo>
                        <a:pt x="249" y="140"/>
                      </a:lnTo>
                      <a:lnTo>
                        <a:pt x="249" y="140"/>
                      </a:lnTo>
                      <a:lnTo>
                        <a:pt x="249" y="143"/>
                      </a:lnTo>
                      <a:lnTo>
                        <a:pt x="249" y="141"/>
                      </a:lnTo>
                      <a:lnTo>
                        <a:pt x="250" y="141"/>
                      </a:lnTo>
                      <a:lnTo>
                        <a:pt x="250" y="140"/>
                      </a:lnTo>
                      <a:lnTo>
                        <a:pt x="250" y="145"/>
                      </a:lnTo>
                      <a:lnTo>
                        <a:pt x="250" y="145"/>
                      </a:lnTo>
                      <a:lnTo>
                        <a:pt x="251" y="145"/>
                      </a:lnTo>
                      <a:lnTo>
                        <a:pt x="251" y="141"/>
                      </a:lnTo>
                      <a:lnTo>
                        <a:pt x="251" y="146"/>
                      </a:lnTo>
                      <a:lnTo>
                        <a:pt x="251" y="141"/>
                      </a:lnTo>
                      <a:lnTo>
                        <a:pt x="252" y="141"/>
                      </a:lnTo>
                      <a:lnTo>
                        <a:pt x="252" y="142"/>
                      </a:lnTo>
                      <a:lnTo>
                        <a:pt x="252" y="146"/>
                      </a:lnTo>
                      <a:lnTo>
                        <a:pt x="252" y="144"/>
                      </a:lnTo>
                      <a:lnTo>
                        <a:pt x="253" y="144"/>
                      </a:lnTo>
                      <a:lnTo>
                        <a:pt x="253" y="144"/>
                      </a:lnTo>
                      <a:lnTo>
                        <a:pt x="253" y="146"/>
                      </a:lnTo>
                      <a:lnTo>
                        <a:pt x="253" y="145"/>
                      </a:lnTo>
                      <a:lnTo>
                        <a:pt x="254" y="145"/>
                      </a:lnTo>
                      <a:lnTo>
                        <a:pt x="254" y="144"/>
                      </a:lnTo>
                      <a:lnTo>
                        <a:pt x="254" y="148"/>
                      </a:lnTo>
                      <a:lnTo>
                        <a:pt x="254" y="146"/>
                      </a:lnTo>
                      <a:lnTo>
                        <a:pt x="255" y="146"/>
                      </a:lnTo>
                      <a:lnTo>
                        <a:pt x="255" y="145"/>
                      </a:lnTo>
                      <a:lnTo>
                        <a:pt x="255" y="148"/>
                      </a:lnTo>
                      <a:lnTo>
                        <a:pt x="255" y="145"/>
                      </a:lnTo>
                      <a:lnTo>
                        <a:pt x="256" y="145"/>
                      </a:lnTo>
                      <a:lnTo>
                        <a:pt x="256" y="145"/>
                      </a:lnTo>
                      <a:lnTo>
                        <a:pt x="256" y="148"/>
                      </a:lnTo>
                      <a:lnTo>
                        <a:pt x="256" y="146"/>
                      </a:lnTo>
                      <a:lnTo>
                        <a:pt x="257" y="146"/>
                      </a:lnTo>
                      <a:lnTo>
                        <a:pt x="257" y="143"/>
                      </a:lnTo>
                      <a:lnTo>
                        <a:pt x="257" y="148"/>
                      </a:lnTo>
                      <a:lnTo>
                        <a:pt x="257" y="145"/>
                      </a:lnTo>
                      <a:lnTo>
                        <a:pt x="258" y="145"/>
                      </a:lnTo>
                      <a:lnTo>
                        <a:pt x="258" y="144"/>
                      </a:lnTo>
                      <a:lnTo>
                        <a:pt x="258" y="148"/>
                      </a:lnTo>
                      <a:lnTo>
                        <a:pt x="258" y="148"/>
                      </a:lnTo>
                      <a:lnTo>
                        <a:pt x="259" y="148"/>
                      </a:lnTo>
                      <a:lnTo>
                        <a:pt x="259" y="144"/>
                      </a:lnTo>
                      <a:lnTo>
                        <a:pt x="259" y="151"/>
                      </a:lnTo>
                      <a:lnTo>
                        <a:pt x="259" y="145"/>
                      </a:lnTo>
                      <a:lnTo>
                        <a:pt x="260" y="145"/>
                      </a:lnTo>
                      <a:lnTo>
                        <a:pt x="260" y="145"/>
                      </a:lnTo>
                      <a:lnTo>
                        <a:pt x="260" y="148"/>
                      </a:lnTo>
                      <a:lnTo>
                        <a:pt x="260" y="147"/>
                      </a:lnTo>
                      <a:lnTo>
                        <a:pt x="261" y="147"/>
                      </a:lnTo>
                      <a:lnTo>
                        <a:pt x="261" y="146"/>
                      </a:lnTo>
                      <a:lnTo>
                        <a:pt x="261" y="150"/>
                      </a:lnTo>
                      <a:lnTo>
                        <a:pt x="261" y="148"/>
                      </a:lnTo>
                      <a:lnTo>
                        <a:pt x="262" y="148"/>
                      </a:lnTo>
                      <a:lnTo>
                        <a:pt x="262" y="148"/>
                      </a:lnTo>
                      <a:lnTo>
                        <a:pt x="262" y="152"/>
                      </a:lnTo>
                      <a:lnTo>
                        <a:pt x="262" y="151"/>
                      </a:lnTo>
                      <a:lnTo>
                        <a:pt x="263" y="151"/>
                      </a:lnTo>
                      <a:lnTo>
                        <a:pt x="263" y="147"/>
                      </a:lnTo>
                      <a:lnTo>
                        <a:pt x="263" y="152"/>
                      </a:lnTo>
                      <a:lnTo>
                        <a:pt x="263" y="149"/>
                      </a:lnTo>
                      <a:lnTo>
                        <a:pt x="264" y="149"/>
                      </a:lnTo>
                      <a:lnTo>
                        <a:pt x="264" y="149"/>
                      </a:lnTo>
                      <a:lnTo>
                        <a:pt x="264" y="151"/>
                      </a:lnTo>
                      <a:lnTo>
                        <a:pt x="264" y="150"/>
                      </a:lnTo>
                      <a:lnTo>
                        <a:pt x="265" y="150"/>
                      </a:lnTo>
                      <a:lnTo>
                        <a:pt x="265" y="149"/>
                      </a:lnTo>
                      <a:lnTo>
                        <a:pt x="265" y="153"/>
                      </a:lnTo>
                      <a:lnTo>
                        <a:pt x="265" y="152"/>
                      </a:lnTo>
                      <a:lnTo>
                        <a:pt x="266" y="152"/>
                      </a:lnTo>
                      <a:lnTo>
                        <a:pt x="266" y="149"/>
                      </a:lnTo>
                      <a:lnTo>
                        <a:pt x="266" y="152"/>
                      </a:lnTo>
                      <a:lnTo>
                        <a:pt x="266" y="150"/>
                      </a:lnTo>
                      <a:lnTo>
                        <a:pt x="267" y="150"/>
                      </a:lnTo>
                      <a:lnTo>
                        <a:pt x="267" y="149"/>
                      </a:lnTo>
                      <a:lnTo>
                        <a:pt x="267" y="151"/>
                      </a:lnTo>
                      <a:lnTo>
                        <a:pt x="267" y="151"/>
                      </a:lnTo>
                      <a:lnTo>
                        <a:pt x="268" y="151"/>
                      </a:lnTo>
                      <a:lnTo>
                        <a:pt x="268" y="151"/>
                      </a:lnTo>
                      <a:lnTo>
                        <a:pt x="268" y="154"/>
                      </a:lnTo>
                      <a:lnTo>
                        <a:pt x="268" y="151"/>
                      </a:lnTo>
                      <a:lnTo>
                        <a:pt x="269" y="151"/>
                      </a:lnTo>
                      <a:lnTo>
                        <a:pt x="269" y="149"/>
                      </a:lnTo>
                      <a:lnTo>
                        <a:pt x="269" y="154"/>
                      </a:lnTo>
                      <a:lnTo>
                        <a:pt x="269" y="151"/>
                      </a:lnTo>
                      <a:lnTo>
                        <a:pt x="270" y="151"/>
                      </a:lnTo>
                      <a:lnTo>
                        <a:pt x="270" y="151"/>
                      </a:lnTo>
                      <a:lnTo>
                        <a:pt x="270" y="154"/>
                      </a:lnTo>
                      <a:lnTo>
                        <a:pt x="270" y="152"/>
                      </a:lnTo>
                      <a:lnTo>
                        <a:pt x="271" y="152"/>
                      </a:lnTo>
                      <a:lnTo>
                        <a:pt x="271" y="151"/>
                      </a:lnTo>
                      <a:lnTo>
                        <a:pt x="271" y="153"/>
                      </a:lnTo>
                      <a:lnTo>
                        <a:pt x="271" y="152"/>
                      </a:lnTo>
                      <a:lnTo>
                        <a:pt x="272" y="152"/>
                      </a:lnTo>
                      <a:lnTo>
                        <a:pt x="272" y="149"/>
                      </a:lnTo>
                      <a:lnTo>
                        <a:pt x="272" y="155"/>
                      </a:lnTo>
                      <a:lnTo>
                        <a:pt x="272" y="152"/>
                      </a:lnTo>
                      <a:lnTo>
                        <a:pt x="273" y="152"/>
                      </a:lnTo>
                      <a:lnTo>
                        <a:pt x="273" y="151"/>
                      </a:lnTo>
                      <a:lnTo>
                        <a:pt x="273" y="156"/>
                      </a:lnTo>
                      <a:lnTo>
                        <a:pt x="273" y="153"/>
                      </a:lnTo>
                      <a:lnTo>
                        <a:pt x="274" y="153"/>
                      </a:lnTo>
                      <a:lnTo>
                        <a:pt x="274" y="151"/>
                      </a:lnTo>
                      <a:lnTo>
                        <a:pt x="274" y="154"/>
                      </a:lnTo>
                      <a:lnTo>
                        <a:pt x="274" y="152"/>
                      </a:lnTo>
                      <a:lnTo>
                        <a:pt x="275" y="152"/>
                      </a:lnTo>
                      <a:lnTo>
                        <a:pt x="275" y="151"/>
                      </a:lnTo>
                      <a:lnTo>
                        <a:pt x="275" y="154"/>
                      </a:lnTo>
                      <a:lnTo>
                        <a:pt x="275" y="154"/>
                      </a:lnTo>
                      <a:lnTo>
                        <a:pt x="276" y="154"/>
                      </a:lnTo>
                      <a:lnTo>
                        <a:pt x="276" y="151"/>
                      </a:lnTo>
                      <a:lnTo>
                        <a:pt x="276" y="156"/>
                      </a:lnTo>
                      <a:lnTo>
                        <a:pt x="276" y="154"/>
                      </a:lnTo>
                      <a:lnTo>
                        <a:pt x="277" y="154"/>
                      </a:lnTo>
                      <a:lnTo>
                        <a:pt x="277" y="151"/>
                      </a:lnTo>
                      <a:lnTo>
                        <a:pt x="277" y="155"/>
                      </a:lnTo>
                      <a:lnTo>
                        <a:pt x="277" y="154"/>
                      </a:lnTo>
                      <a:lnTo>
                        <a:pt x="278" y="154"/>
                      </a:lnTo>
                      <a:lnTo>
                        <a:pt x="278" y="152"/>
                      </a:lnTo>
                      <a:lnTo>
                        <a:pt x="278" y="156"/>
                      </a:lnTo>
                      <a:lnTo>
                        <a:pt x="278" y="154"/>
                      </a:lnTo>
                      <a:lnTo>
                        <a:pt x="279" y="154"/>
                      </a:lnTo>
                      <a:lnTo>
                        <a:pt x="279" y="152"/>
                      </a:lnTo>
                      <a:lnTo>
                        <a:pt x="279" y="158"/>
                      </a:lnTo>
                      <a:lnTo>
                        <a:pt x="279" y="154"/>
                      </a:lnTo>
                      <a:lnTo>
                        <a:pt x="280" y="154"/>
                      </a:lnTo>
                      <a:lnTo>
                        <a:pt x="280" y="152"/>
                      </a:lnTo>
                      <a:lnTo>
                        <a:pt x="280" y="155"/>
                      </a:lnTo>
                      <a:lnTo>
                        <a:pt x="280" y="155"/>
                      </a:lnTo>
                      <a:lnTo>
                        <a:pt x="281" y="155"/>
                      </a:lnTo>
                      <a:lnTo>
                        <a:pt x="281" y="153"/>
                      </a:lnTo>
                      <a:lnTo>
                        <a:pt x="281" y="157"/>
                      </a:lnTo>
                      <a:lnTo>
                        <a:pt x="281" y="154"/>
                      </a:lnTo>
                      <a:lnTo>
                        <a:pt x="282" y="154"/>
                      </a:lnTo>
                      <a:lnTo>
                        <a:pt x="282" y="152"/>
                      </a:lnTo>
                      <a:lnTo>
                        <a:pt x="282" y="155"/>
                      </a:lnTo>
                      <a:lnTo>
                        <a:pt x="282" y="154"/>
                      </a:lnTo>
                      <a:lnTo>
                        <a:pt x="283" y="154"/>
                      </a:lnTo>
                      <a:lnTo>
                        <a:pt x="283" y="152"/>
                      </a:lnTo>
                      <a:lnTo>
                        <a:pt x="283" y="155"/>
                      </a:lnTo>
                      <a:lnTo>
                        <a:pt x="283" y="155"/>
                      </a:lnTo>
                      <a:lnTo>
                        <a:pt x="284" y="155"/>
                      </a:lnTo>
                      <a:lnTo>
                        <a:pt x="284" y="150"/>
                      </a:lnTo>
                      <a:lnTo>
                        <a:pt x="284" y="156"/>
                      </a:lnTo>
                      <a:lnTo>
                        <a:pt x="284" y="152"/>
                      </a:lnTo>
                      <a:lnTo>
                        <a:pt x="285" y="152"/>
                      </a:lnTo>
                      <a:lnTo>
                        <a:pt x="285" y="151"/>
                      </a:lnTo>
                      <a:lnTo>
                        <a:pt x="285" y="154"/>
                      </a:lnTo>
                      <a:lnTo>
                        <a:pt x="285" y="154"/>
                      </a:lnTo>
                      <a:lnTo>
                        <a:pt x="286" y="154"/>
                      </a:lnTo>
                      <a:lnTo>
                        <a:pt x="286" y="151"/>
                      </a:lnTo>
                      <a:lnTo>
                        <a:pt x="286" y="154"/>
                      </a:lnTo>
                      <a:lnTo>
                        <a:pt x="286" y="153"/>
                      </a:lnTo>
                      <a:lnTo>
                        <a:pt x="287" y="153"/>
                      </a:lnTo>
                      <a:lnTo>
                        <a:pt x="287" y="151"/>
                      </a:lnTo>
                      <a:lnTo>
                        <a:pt x="287" y="155"/>
                      </a:lnTo>
                      <a:lnTo>
                        <a:pt x="287" y="152"/>
                      </a:lnTo>
                      <a:lnTo>
                        <a:pt x="288" y="152"/>
                      </a:lnTo>
                      <a:lnTo>
                        <a:pt x="288" y="152"/>
                      </a:lnTo>
                      <a:lnTo>
                        <a:pt x="288" y="154"/>
                      </a:lnTo>
                      <a:lnTo>
                        <a:pt x="288" y="153"/>
                      </a:lnTo>
                      <a:lnTo>
                        <a:pt x="289" y="153"/>
                      </a:lnTo>
                      <a:lnTo>
                        <a:pt x="289" y="151"/>
                      </a:lnTo>
                      <a:lnTo>
                        <a:pt x="289" y="155"/>
                      </a:lnTo>
                      <a:lnTo>
                        <a:pt x="289" y="155"/>
                      </a:lnTo>
                      <a:lnTo>
                        <a:pt x="290" y="155"/>
                      </a:lnTo>
                      <a:lnTo>
                        <a:pt x="290" y="151"/>
                      </a:lnTo>
                      <a:lnTo>
                        <a:pt x="290" y="155"/>
                      </a:lnTo>
                      <a:lnTo>
                        <a:pt x="290" y="151"/>
                      </a:lnTo>
                      <a:lnTo>
                        <a:pt x="291" y="151"/>
                      </a:lnTo>
                      <a:lnTo>
                        <a:pt x="291" y="151"/>
                      </a:lnTo>
                      <a:lnTo>
                        <a:pt x="291" y="156"/>
                      </a:lnTo>
                      <a:lnTo>
                        <a:pt x="291" y="151"/>
                      </a:lnTo>
                      <a:lnTo>
                        <a:pt x="292" y="151"/>
                      </a:lnTo>
                      <a:lnTo>
                        <a:pt x="292" y="151"/>
                      </a:lnTo>
                      <a:lnTo>
                        <a:pt x="292" y="155"/>
                      </a:lnTo>
                      <a:lnTo>
                        <a:pt x="292" y="152"/>
                      </a:lnTo>
                      <a:lnTo>
                        <a:pt x="293" y="152"/>
                      </a:lnTo>
                      <a:lnTo>
                        <a:pt x="293" y="150"/>
                      </a:lnTo>
                      <a:lnTo>
                        <a:pt x="293" y="154"/>
                      </a:lnTo>
                      <a:lnTo>
                        <a:pt x="293" y="154"/>
                      </a:lnTo>
                      <a:lnTo>
                        <a:pt x="294" y="154"/>
                      </a:lnTo>
                      <a:lnTo>
                        <a:pt x="294" y="150"/>
                      </a:lnTo>
                      <a:lnTo>
                        <a:pt x="294" y="154"/>
                      </a:lnTo>
                      <a:lnTo>
                        <a:pt x="294" y="152"/>
                      </a:lnTo>
                      <a:lnTo>
                        <a:pt x="295" y="152"/>
                      </a:lnTo>
                      <a:lnTo>
                        <a:pt x="295" y="149"/>
                      </a:lnTo>
                      <a:lnTo>
                        <a:pt x="295" y="154"/>
                      </a:lnTo>
                      <a:lnTo>
                        <a:pt x="295" y="151"/>
                      </a:lnTo>
                      <a:lnTo>
                        <a:pt x="296" y="151"/>
                      </a:lnTo>
                      <a:lnTo>
                        <a:pt x="296" y="150"/>
                      </a:lnTo>
                      <a:lnTo>
                        <a:pt x="296" y="153"/>
                      </a:lnTo>
                      <a:lnTo>
                        <a:pt x="296" y="151"/>
                      </a:lnTo>
                      <a:lnTo>
                        <a:pt x="297" y="151"/>
                      </a:lnTo>
                      <a:lnTo>
                        <a:pt x="297" y="149"/>
                      </a:lnTo>
                      <a:lnTo>
                        <a:pt x="297" y="154"/>
                      </a:lnTo>
                      <a:lnTo>
                        <a:pt x="297" y="152"/>
                      </a:lnTo>
                      <a:lnTo>
                        <a:pt x="298" y="152"/>
                      </a:lnTo>
                      <a:lnTo>
                        <a:pt x="298" y="151"/>
                      </a:lnTo>
                      <a:lnTo>
                        <a:pt x="298" y="153"/>
                      </a:lnTo>
                      <a:lnTo>
                        <a:pt x="298" y="152"/>
                      </a:lnTo>
                      <a:lnTo>
                        <a:pt x="299" y="152"/>
                      </a:lnTo>
                      <a:lnTo>
                        <a:pt x="299" y="150"/>
                      </a:lnTo>
                      <a:lnTo>
                        <a:pt x="299" y="154"/>
                      </a:lnTo>
                      <a:lnTo>
                        <a:pt x="299" y="150"/>
                      </a:lnTo>
                      <a:lnTo>
                        <a:pt x="300" y="150"/>
                      </a:lnTo>
                      <a:lnTo>
                        <a:pt x="300" y="149"/>
                      </a:lnTo>
                      <a:lnTo>
                        <a:pt x="300" y="154"/>
                      </a:lnTo>
                      <a:lnTo>
                        <a:pt x="300" y="151"/>
                      </a:lnTo>
                      <a:lnTo>
                        <a:pt x="301" y="151"/>
                      </a:lnTo>
                      <a:lnTo>
                        <a:pt x="301" y="149"/>
                      </a:lnTo>
                      <a:lnTo>
                        <a:pt x="301" y="153"/>
                      </a:lnTo>
                      <a:lnTo>
                        <a:pt x="301" y="152"/>
                      </a:lnTo>
                      <a:lnTo>
                        <a:pt x="302" y="152"/>
                      </a:lnTo>
                      <a:lnTo>
                        <a:pt x="302" y="148"/>
                      </a:lnTo>
                      <a:lnTo>
                        <a:pt x="302" y="152"/>
                      </a:lnTo>
                      <a:lnTo>
                        <a:pt x="302" y="149"/>
                      </a:lnTo>
                      <a:lnTo>
                        <a:pt x="303" y="149"/>
                      </a:lnTo>
                      <a:lnTo>
                        <a:pt x="303" y="149"/>
                      </a:lnTo>
                      <a:lnTo>
                        <a:pt x="303" y="153"/>
                      </a:lnTo>
                      <a:lnTo>
                        <a:pt x="303" y="149"/>
                      </a:lnTo>
                      <a:lnTo>
                        <a:pt x="304" y="149"/>
                      </a:lnTo>
                      <a:lnTo>
                        <a:pt x="304" y="148"/>
                      </a:lnTo>
                      <a:lnTo>
                        <a:pt x="304" y="151"/>
                      </a:lnTo>
                      <a:lnTo>
                        <a:pt x="304" y="151"/>
                      </a:lnTo>
                      <a:lnTo>
                        <a:pt x="305" y="151"/>
                      </a:lnTo>
                      <a:lnTo>
                        <a:pt x="305" y="148"/>
                      </a:lnTo>
                      <a:lnTo>
                        <a:pt x="305" y="151"/>
                      </a:lnTo>
                      <a:lnTo>
                        <a:pt x="305" y="149"/>
                      </a:lnTo>
                      <a:lnTo>
                        <a:pt x="306" y="149"/>
                      </a:lnTo>
                      <a:lnTo>
                        <a:pt x="306" y="148"/>
                      </a:lnTo>
                      <a:lnTo>
                        <a:pt x="306" y="152"/>
                      </a:lnTo>
                      <a:lnTo>
                        <a:pt x="306" y="149"/>
                      </a:lnTo>
                      <a:lnTo>
                        <a:pt x="307" y="149"/>
                      </a:lnTo>
                      <a:lnTo>
                        <a:pt x="307" y="147"/>
                      </a:lnTo>
                      <a:lnTo>
                        <a:pt x="307" y="151"/>
                      </a:lnTo>
                      <a:lnTo>
                        <a:pt x="307" y="148"/>
                      </a:lnTo>
                      <a:lnTo>
                        <a:pt x="308" y="148"/>
                      </a:lnTo>
                      <a:lnTo>
                        <a:pt x="308" y="146"/>
                      </a:lnTo>
                      <a:lnTo>
                        <a:pt x="308" y="151"/>
                      </a:lnTo>
                      <a:lnTo>
                        <a:pt x="308" y="149"/>
                      </a:lnTo>
                      <a:lnTo>
                        <a:pt x="309" y="149"/>
                      </a:lnTo>
                      <a:lnTo>
                        <a:pt x="309" y="148"/>
                      </a:lnTo>
                      <a:lnTo>
                        <a:pt x="309" y="152"/>
                      </a:lnTo>
                      <a:lnTo>
                        <a:pt x="309" y="149"/>
                      </a:lnTo>
                      <a:lnTo>
                        <a:pt x="310" y="149"/>
                      </a:lnTo>
                      <a:lnTo>
                        <a:pt x="310" y="148"/>
                      </a:lnTo>
                      <a:lnTo>
                        <a:pt x="310" y="150"/>
                      </a:lnTo>
                      <a:lnTo>
                        <a:pt x="310" y="149"/>
                      </a:lnTo>
                      <a:lnTo>
                        <a:pt x="311" y="149"/>
                      </a:lnTo>
                      <a:lnTo>
                        <a:pt x="311" y="148"/>
                      </a:lnTo>
                      <a:lnTo>
                        <a:pt x="311" y="151"/>
                      </a:lnTo>
                      <a:lnTo>
                        <a:pt x="311" y="148"/>
                      </a:lnTo>
                      <a:lnTo>
                        <a:pt x="312" y="148"/>
                      </a:lnTo>
                      <a:lnTo>
                        <a:pt x="312" y="146"/>
                      </a:lnTo>
                      <a:lnTo>
                        <a:pt x="312" y="149"/>
                      </a:lnTo>
                      <a:lnTo>
                        <a:pt x="312" y="146"/>
                      </a:lnTo>
                      <a:lnTo>
                        <a:pt x="313" y="146"/>
                      </a:lnTo>
                      <a:lnTo>
                        <a:pt x="313" y="146"/>
                      </a:lnTo>
                      <a:lnTo>
                        <a:pt x="313" y="149"/>
                      </a:lnTo>
                      <a:lnTo>
                        <a:pt x="313" y="148"/>
                      </a:lnTo>
                      <a:lnTo>
                        <a:pt x="314" y="148"/>
                      </a:lnTo>
                      <a:lnTo>
                        <a:pt x="314" y="147"/>
                      </a:lnTo>
                      <a:lnTo>
                        <a:pt x="314" y="148"/>
                      </a:lnTo>
                      <a:lnTo>
                        <a:pt x="314" y="148"/>
                      </a:lnTo>
                      <a:lnTo>
                        <a:pt x="315" y="148"/>
                      </a:lnTo>
                      <a:lnTo>
                        <a:pt x="315" y="145"/>
                      </a:lnTo>
                      <a:lnTo>
                        <a:pt x="315" y="149"/>
                      </a:lnTo>
                      <a:lnTo>
                        <a:pt x="315" y="146"/>
                      </a:lnTo>
                      <a:lnTo>
                        <a:pt x="316" y="146"/>
                      </a:lnTo>
                      <a:lnTo>
                        <a:pt x="316" y="145"/>
                      </a:lnTo>
                      <a:lnTo>
                        <a:pt x="316" y="149"/>
                      </a:lnTo>
                      <a:lnTo>
                        <a:pt x="316" y="148"/>
                      </a:lnTo>
                      <a:lnTo>
                        <a:pt x="317" y="148"/>
                      </a:lnTo>
                      <a:lnTo>
                        <a:pt x="317" y="145"/>
                      </a:lnTo>
                      <a:lnTo>
                        <a:pt x="317" y="149"/>
                      </a:lnTo>
                      <a:lnTo>
                        <a:pt x="317" y="147"/>
                      </a:lnTo>
                      <a:lnTo>
                        <a:pt x="318" y="147"/>
                      </a:lnTo>
                      <a:lnTo>
                        <a:pt x="318" y="145"/>
                      </a:lnTo>
                      <a:lnTo>
                        <a:pt x="318" y="148"/>
                      </a:lnTo>
                      <a:lnTo>
                        <a:pt x="318" y="148"/>
                      </a:lnTo>
                      <a:lnTo>
                        <a:pt x="319" y="148"/>
                      </a:lnTo>
                      <a:lnTo>
                        <a:pt x="319" y="145"/>
                      </a:lnTo>
                      <a:lnTo>
                        <a:pt x="319" y="149"/>
                      </a:lnTo>
                      <a:lnTo>
                        <a:pt x="319" y="146"/>
                      </a:lnTo>
                      <a:lnTo>
                        <a:pt x="320" y="146"/>
                      </a:lnTo>
                      <a:lnTo>
                        <a:pt x="320" y="145"/>
                      </a:lnTo>
                      <a:lnTo>
                        <a:pt x="320" y="149"/>
                      </a:lnTo>
                      <a:lnTo>
                        <a:pt x="320" y="145"/>
                      </a:lnTo>
                      <a:lnTo>
                        <a:pt x="321" y="145"/>
                      </a:lnTo>
                      <a:lnTo>
                        <a:pt x="321" y="144"/>
                      </a:lnTo>
                      <a:lnTo>
                        <a:pt x="321" y="148"/>
                      </a:lnTo>
                      <a:lnTo>
                        <a:pt x="321" y="146"/>
                      </a:lnTo>
                      <a:lnTo>
                        <a:pt x="322" y="146"/>
                      </a:lnTo>
                      <a:lnTo>
                        <a:pt x="322" y="142"/>
                      </a:lnTo>
                      <a:lnTo>
                        <a:pt x="322" y="146"/>
                      </a:lnTo>
                      <a:lnTo>
                        <a:pt x="322" y="144"/>
                      </a:lnTo>
                      <a:lnTo>
                        <a:pt x="323" y="144"/>
                      </a:lnTo>
                      <a:lnTo>
                        <a:pt x="323" y="143"/>
                      </a:lnTo>
                      <a:lnTo>
                        <a:pt x="323" y="146"/>
                      </a:lnTo>
                      <a:lnTo>
                        <a:pt x="323" y="146"/>
                      </a:lnTo>
                      <a:lnTo>
                        <a:pt x="324" y="146"/>
                      </a:lnTo>
                      <a:lnTo>
                        <a:pt x="324" y="145"/>
                      </a:lnTo>
                      <a:lnTo>
                        <a:pt x="324" y="148"/>
                      </a:lnTo>
                      <a:lnTo>
                        <a:pt x="324" y="146"/>
                      </a:lnTo>
                      <a:lnTo>
                        <a:pt x="325" y="146"/>
                      </a:lnTo>
                      <a:lnTo>
                        <a:pt x="325" y="144"/>
                      </a:lnTo>
                      <a:lnTo>
                        <a:pt x="325" y="148"/>
                      </a:lnTo>
                      <a:lnTo>
                        <a:pt x="325" y="146"/>
                      </a:lnTo>
                      <a:lnTo>
                        <a:pt x="326" y="146"/>
                      </a:lnTo>
                      <a:lnTo>
                        <a:pt x="326" y="144"/>
                      </a:lnTo>
                      <a:lnTo>
                        <a:pt x="326" y="148"/>
                      </a:lnTo>
                      <a:lnTo>
                        <a:pt x="326" y="145"/>
                      </a:lnTo>
                      <a:lnTo>
                        <a:pt x="327" y="145"/>
                      </a:lnTo>
                      <a:lnTo>
                        <a:pt x="327" y="143"/>
                      </a:lnTo>
                      <a:lnTo>
                        <a:pt x="327" y="146"/>
                      </a:lnTo>
                      <a:lnTo>
                        <a:pt x="327" y="144"/>
                      </a:lnTo>
                      <a:lnTo>
                        <a:pt x="328" y="144"/>
                      </a:lnTo>
                      <a:lnTo>
                        <a:pt x="328" y="144"/>
                      </a:lnTo>
                      <a:lnTo>
                        <a:pt x="328" y="148"/>
                      </a:lnTo>
                      <a:lnTo>
                        <a:pt x="328" y="145"/>
                      </a:lnTo>
                      <a:lnTo>
                        <a:pt x="329" y="145"/>
                      </a:lnTo>
                      <a:lnTo>
                        <a:pt x="329" y="142"/>
                      </a:lnTo>
                      <a:lnTo>
                        <a:pt x="329" y="147"/>
                      </a:lnTo>
                      <a:lnTo>
                        <a:pt x="329" y="145"/>
                      </a:lnTo>
                      <a:lnTo>
                        <a:pt x="330" y="145"/>
                      </a:lnTo>
                      <a:lnTo>
                        <a:pt x="330" y="142"/>
                      </a:lnTo>
                      <a:lnTo>
                        <a:pt x="330" y="145"/>
                      </a:lnTo>
                      <a:lnTo>
                        <a:pt x="330" y="144"/>
                      </a:lnTo>
                      <a:lnTo>
                        <a:pt x="331" y="144"/>
                      </a:lnTo>
                      <a:lnTo>
                        <a:pt x="331" y="142"/>
                      </a:lnTo>
                      <a:lnTo>
                        <a:pt x="331" y="146"/>
                      </a:lnTo>
                      <a:lnTo>
                        <a:pt x="331" y="143"/>
                      </a:lnTo>
                      <a:lnTo>
                        <a:pt x="332" y="143"/>
                      </a:lnTo>
                      <a:lnTo>
                        <a:pt x="332" y="143"/>
                      </a:lnTo>
                      <a:lnTo>
                        <a:pt x="332" y="146"/>
                      </a:lnTo>
                      <a:lnTo>
                        <a:pt x="332" y="145"/>
                      </a:lnTo>
                      <a:lnTo>
                        <a:pt x="333" y="145"/>
                      </a:lnTo>
                      <a:lnTo>
                        <a:pt x="333" y="142"/>
                      </a:lnTo>
                      <a:lnTo>
                        <a:pt x="333" y="147"/>
                      </a:lnTo>
                      <a:lnTo>
                        <a:pt x="333" y="146"/>
                      </a:lnTo>
                      <a:lnTo>
                        <a:pt x="334" y="146"/>
                      </a:lnTo>
                      <a:lnTo>
                        <a:pt x="334" y="142"/>
                      </a:lnTo>
                      <a:lnTo>
                        <a:pt x="334" y="148"/>
                      </a:lnTo>
                      <a:lnTo>
                        <a:pt x="334" y="145"/>
                      </a:lnTo>
                      <a:lnTo>
                        <a:pt x="335" y="145"/>
                      </a:lnTo>
                      <a:lnTo>
                        <a:pt x="335" y="142"/>
                      </a:lnTo>
                      <a:lnTo>
                        <a:pt x="335" y="146"/>
                      </a:lnTo>
                      <a:lnTo>
                        <a:pt x="335" y="144"/>
                      </a:lnTo>
                      <a:lnTo>
                        <a:pt x="336" y="144"/>
                      </a:lnTo>
                      <a:lnTo>
                        <a:pt x="336" y="143"/>
                      </a:lnTo>
                      <a:lnTo>
                        <a:pt x="336" y="146"/>
                      </a:lnTo>
                      <a:lnTo>
                        <a:pt x="336" y="146"/>
                      </a:lnTo>
                      <a:lnTo>
                        <a:pt x="337" y="146"/>
                      </a:lnTo>
                      <a:lnTo>
                        <a:pt x="337" y="142"/>
                      </a:lnTo>
                      <a:lnTo>
                        <a:pt x="337" y="146"/>
                      </a:lnTo>
                      <a:lnTo>
                        <a:pt x="337" y="142"/>
                      </a:lnTo>
                      <a:lnTo>
                        <a:pt x="338" y="142"/>
                      </a:lnTo>
                      <a:lnTo>
                        <a:pt x="338" y="141"/>
                      </a:lnTo>
                      <a:lnTo>
                        <a:pt x="338" y="145"/>
                      </a:lnTo>
                      <a:lnTo>
                        <a:pt x="338" y="145"/>
                      </a:lnTo>
                      <a:lnTo>
                        <a:pt x="339" y="145"/>
                      </a:lnTo>
                      <a:lnTo>
                        <a:pt x="339" y="142"/>
                      </a:lnTo>
                      <a:lnTo>
                        <a:pt x="339" y="146"/>
                      </a:lnTo>
                      <a:lnTo>
                        <a:pt x="339" y="143"/>
                      </a:lnTo>
                      <a:lnTo>
                        <a:pt x="340" y="143"/>
                      </a:lnTo>
                      <a:lnTo>
                        <a:pt x="340" y="142"/>
                      </a:lnTo>
                      <a:lnTo>
                        <a:pt x="340" y="146"/>
                      </a:lnTo>
                      <a:lnTo>
                        <a:pt x="340" y="144"/>
                      </a:lnTo>
                      <a:lnTo>
                        <a:pt x="341" y="144"/>
                      </a:lnTo>
                      <a:lnTo>
                        <a:pt x="341" y="142"/>
                      </a:lnTo>
                      <a:lnTo>
                        <a:pt x="341" y="146"/>
                      </a:lnTo>
                      <a:lnTo>
                        <a:pt x="341" y="146"/>
                      </a:lnTo>
                      <a:lnTo>
                        <a:pt x="342" y="146"/>
                      </a:lnTo>
                      <a:lnTo>
                        <a:pt x="342" y="142"/>
                      </a:lnTo>
                      <a:lnTo>
                        <a:pt x="342" y="145"/>
                      </a:lnTo>
                      <a:lnTo>
                        <a:pt x="342" y="143"/>
                      </a:lnTo>
                      <a:lnTo>
                        <a:pt x="343" y="143"/>
                      </a:lnTo>
                      <a:lnTo>
                        <a:pt x="343" y="142"/>
                      </a:lnTo>
                      <a:lnTo>
                        <a:pt x="343" y="146"/>
                      </a:lnTo>
                      <a:lnTo>
                        <a:pt x="343" y="143"/>
                      </a:lnTo>
                      <a:lnTo>
                        <a:pt x="344" y="143"/>
                      </a:lnTo>
                      <a:lnTo>
                        <a:pt x="344" y="141"/>
                      </a:lnTo>
                      <a:lnTo>
                        <a:pt x="344" y="145"/>
                      </a:lnTo>
                      <a:lnTo>
                        <a:pt x="344" y="144"/>
                      </a:lnTo>
                      <a:lnTo>
                        <a:pt x="345" y="144"/>
                      </a:lnTo>
                      <a:lnTo>
                        <a:pt x="345" y="142"/>
                      </a:lnTo>
                      <a:lnTo>
                        <a:pt x="345" y="144"/>
                      </a:lnTo>
                      <a:lnTo>
                        <a:pt x="345" y="144"/>
                      </a:lnTo>
                      <a:lnTo>
                        <a:pt x="346" y="144"/>
                      </a:lnTo>
                      <a:lnTo>
                        <a:pt x="346" y="141"/>
                      </a:lnTo>
                      <a:lnTo>
                        <a:pt x="346" y="144"/>
                      </a:lnTo>
                      <a:lnTo>
                        <a:pt x="346" y="142"/>
                      </a:lnTo>
                      <a:lnTo>
                        <a:pt x="347" y="142"/>
                      </a:lnTo>
                      <a:lnTo>
                        <a:pt x="347" y="141"/>
                      </a:lnTo>
                      <a:lnTo>
                        <a:pt x="347" y="145"/>
                      </a:lnTo>
                      <a:lnTo>
                        <a:pt x="347" y="142"/>
                      </a:lnTo>
                      <a:lnTo>
                        <a:pt x="348" y="142"/>
                      </a:lnTo>
                      <a:lnTo>
                        <a:pt x="348" y="140"/>
                      </a:lnTo>
                      <a:lnTo>
                        <a:pt x="348" y="144"/>
                      </a:lnTo>
                      <a:lnTo>
                        <a:pt x="348" y="143"/>
                      </a:lnTo>
                      <a:lnTo>
                        <a:pt x="349" y="143"/>
                      </a:lnTo>
                      <a:lnTo>
                        <a:pt x="349" y="140"/>
                      </a:lnTo>
                      <a:lnTo>
                        <a:pt x="349" y="144"/>
                      </a:lnTo>
                      <a:lnTo>
                        <a:pt x="349" y="144"/>
                      </a:lnTo>
                      <a:lnTo>
                        <a:pt x="350" y="144"/>
                      </a:lnTo>
                      <a:lnTo>
                        <a:pt x="350" y="141"/>
                      </a:lnTo>
                      <a:lnTo>
                        <a:pt x="350" y="144"/>
                      </a:lnTo>
                      <a:lnTo>
                        <a:pt x="350" y="142"/>
                      </a:lnTo>
                      <a:lnTo>
                        <a:pt x="351" y="142"/>
                      </a:lnTo>
                      <a:lnTo>
                        <a:pt x="351" y="139"/>
                      </a:lnTo>
                      <a:lnTo>
                        <a:pt x="351" y="143"/>
                      </a:lnTo>
                      <a:lnTo>
                        <a:pt x="351" y="142"/>
                      </a:lnTo>
                      <a:lnTo>
                        <a:pt x="352" y="142"/>
                      </a:lnTo>
                      <a:lnTo>
                        <a:pt x="352" y="140"/>
                      </a:lnTo>
                      <a:lnTo>
                        <a:pt x="352" y="144"/>
                      </a:lnTo>
                      <a:lnTo>
                        <a:pt x="352" y="142"/>
                      </a:lnTo>
                      <a:lnTo>
                        <a:pt x="353" y="142"/>
                      </a:lnTo>
                      <a:lnTo>
                        <a:pt x="353" y="140"/>
                      </a:lnTo>
                      <a:lnTo>
                        <a:pt x="353" y="144"/>
                      </a:lnTo>
                      <a:lnTo>
                        <a:pt x="353" y="144"/>
                      </a:lnTo>
                      <a:lnTo>
                        <a:pt x="354" y="144"/>
                      </a:lnTo>
                      <a:lnTo>
                        <a:pt x="354" y="139"/>
                      </a:lnTo>
                      <a:lnTo>
                        <a:pt x="354" y="145"/>
                      </a:lnTo>
                      <a:lnTo>
                        <a:pt x="354" y="140"/>
                      </a:lnTo>
                      <a:lnTo>
                        <a:pt x="355" y="140"/>
                      </a:lnTo>
                      <a:lnTo>
                        <a:pt x="355" y="139"/>
                      </a:lnTo>
                      <a:lnTo>
                        <a:pt x="355" y="142"/>
                      </a:lnTo>
                      <a:lnTo>
                        <a:pt x="355" y="140"/>
                      </a:lnTo>
                      <a:lnTo>
                        <a:pt x="356" y="140"/>
                      </a:lnTo>
                      <a:lnTo>
                        <a:pt x="356" y="139"/>
                      </a:lnTo>
                      <a:lnTo>
                        <a:pt x="356" y="142"/>
                      </a:lnTo>
                      <a:lnTo>
                        <a:pt x="356" y="142"/>
                      </a:lnTo>
                      <a:lnTo>
                        <a:pt x="357" y="142"/>
                      </a:lnTo>
                      <a:lnTo>
                        <a:pt x="357" y="140"/>
                      </a:lnTo>
                      <a:lnTo>
                        <a:pt x="357" y="142"/>
                      </a:lnTo>
                      <a:lnTo>
                        <a:pt x="357" y="142"/>
                      </a:lnTo>
                      <a:lnTo>
                        <a:pt x="358" y="142"/>
                      </a:lnTo>
                      <a:lnTo>
                        <a:pt x="358" y="140"/>
                      </a:lnTo>
                      <a:lnTo>
                        <a:pt x="358" y="143"/>
                      </a:lnTo>
                      <a:lnTo>
                        <a:pt x="358" y="141"/>
                      </a:lnTo>
                      <a:lnTo>
                        <a:pt x="359" y="141"/>
                      </a:lnTo>
                      <a:lnTo>
                        <a:pt x="359" y="139"/>
                      </a:lnTo>
                      <a:lnTo>
                        <a:pt x="359" y="142"/>
                      </a:lnTo>
                      <a:lnTo>
                        <a:pt x="359" y="140"/>
                      </a:lnTo>
                      <a:lnTo>
                        <a:pt x="360" y="140"/>
                      </a:lnTo>
                      <a:lnTo>
                        <a:pt x="360" y="138"/>
                      </a:lnTo>
                      <a:lnTo>
                        <a:pt x="360" y="142"/>
                      </a:lnTo>
                      <a:lnTo>
                        <a:pt x="360" y="141"/>
                      </a:lnTo>
                      <a:lnTo>
                        <a:pt x="361" y="141"/>
                      </a:lnTo>
                      <a:lnTo>
                        <a:pt x="361" y="138"/>
                      </a:lnTo>
                      <a:lnTo>
                        <a:pt x="361" y="142"/>
                      </a:lnTo>
                      <a:lnTo>
                        <a:pt x="361" y="142"/>
                      </a:lnTo>
                      <a:lnTo>
                        <a:pt x="362" y="142"/>
                      </a:lnTo>
                      <a:lnTo>
                        <a:pt x="362" y="139"/>
                      </a:lnTo>
                      <a:lnTo>
                        <a:pt x="362" y="143"/>
                      </a:lnTo>
                      <a:lnTo>
                        <a:pt x="362" y="139"/>
                      </a:lnTo>
                      <a:lnTo>
                        <a:pt x="363" y="139"/>
                      </a:lnTo>
                      <a:lnTo>
                        <a:pt x="363" y="139"/>
                      </a:lnTo>
                      <a:lnTo>
                        <a:pt x="363" y="142"/>
                      </a:lnTo>
                      <a:lnTo>
                        <a:pt x="363" y="140"/>
                      </a:lnTo>
                      <a:lnTo>
                        <a:pt x="364" y="140"/>
                      </a:lnTo>
                      <a:lnTo>
                        <a:pt x="364" y="140"/>
                      </a:lnTo>
                      <a:lnTo>
                        <a:pt x="364" y="143"/>
                      </a:lnTo>
                      <a:lnTo>
                        <a:pt x="364" y="141"/>
                      </a:lnTo>
                      <a:lnTo>
                        <a:pt x="365" y="141"/>
                      </a:lnTo>
                      <a:lnTo>
                        <a:pt x="365" y="138"/>
                      </a:lnTo>
                      <a:lnTo>
                        <a:pt x="365" y="142"/>
                      </a:lnTo>
                      <a:lnTo>
                        <a:pt x="365" y="142"/>
                      </a:lnTo>
                      <a:lnTo>
                        <a:pt x="366" y="142"/>
                      </a:lnTo>
                      <a:lnTo>
                        <a:pt x="366" y="138"/>
                      </a:lnTo>
                      <a:lnTo>
                        <a:pt x="366" y="142"/>
                      </a:lnTo>
                      <a:lnTo>
                        <a:pt x="366" y="138"/>
                      </a:lnTo>
                      <a:lnTo>
                        <a:pt x="367" y="138"/>
                      </a:lnTo>
                      <a:lnTo>
                        <a:pt x="367" y="139"/>
                      </a:lnTo>
                      <a:lnTo>
                        <a:pt x="367" y="142"/>
                      </a:lnTo>
                      <a:lnTo>
                        <a:pt x="367" y="141"/>
                      </a:lnTo>
                      <a:lnTo>
                        <a:pt x="368" y="141"/>
                      </a:lnTo>
                      <a:lnTo>
                        <a:pt x="368" y="138"/>
                      </a:lnTo>
                      <a:lnTo>
                        <a:pt x="368" y="141"/>
                      </a:lnTo>
                      <a:lnTo>
                        <a:pt x="368" y="141"/>
                      </a:lnTo>
                      <a:lnTo>
                        <a:pt x="369" y="141"/>
                      </a:lnTo>
                      <a:lnTo>
                        <a:pt x="369" y="138"/>
                      </a:lnTo>
                      <a:lnTo>
                        <a:pt x="369" y="144"/>
                      </a:lnTo>
                      <a:lnTo>
                        <a:pt x="369" y="141"/>
                      </a:lnTo>
                      <a:lnTo>
                        <a:pt x="370" y="141"/>
                      </a:lnTo>
                      <a:lnTo>
                        <a:pt x="370" y="137"/>
                      </a:lnTo>
                      <a:lnTo>
                        <a:pt x="370" y="142"/>
                      </a:lnTo>
                      <a:lnTo>
                        <a:pt x="370" y="138"/>
                      </a:lnTo>
                      <a:lnTo>
                        <a:pt x="371" y="138"/>
                      </a:lnTo>
                      <a:lnTo>
                        <a:pt x="371" y="136"/>
                      </a:lnTo>
                      <a:lnTo>
                        <a:pt x="371" y="141"/>
                      </a:lnTo>
                      <a:lnTo>
                        <a:pt x="371" y="141"/>
                      </a:lnTo>
                      <a:lnTo>
                        <a:pt x="372" y="141"/>
                      </a:lnTo>
                      <a:lnTo>
                        <a:pt x="372" y="137"/>
                      </a:lnTo>
                      <a:lnTo>
                        <a:pt x="372" y="141"/>
                      </a:lnTo>
                      <a:lnTo>
                        <a:pt x="372" y="138"/>
                      </a:lnTo>
                      <a:lnTo>
                        <a:pt x="373" y="138"/>
                      </a:lnTo>
                      <a:lnTo>
                        <a:pt x="373" y="137"/>
                      </a:lnTo>
                      <a:lnTo>
                        <a:pt x="373" y="142"/>
                      </a:lnTo>
                      <a:lnTo>
                        <a:pt x="373" y="139"/>
                      </a:lnTo>
                      <a:lnTo>
                        <a:pt x="374" y="139"/>
                      </a:lnTo>
                      <a:lnTo>
                        <a:pt x="374" y="137"/>
                      </a:lnTo>
                      <a:lnTo>
                        <a:pt x="374" y="141"/>
                      </a:lnTo>
                      <a:lnTo>
                        <a:pt x="374" y="138"/>
                      </a:lnTo>
                      <a:lnTo>
                        <a:pt x="375" y="138"/>
                      </a:lnTo>
                      <a:lnTo>
                        <a:pt x="375" y="137"/>
                      </a:lnTo>
                      <a:lnTo>
                        <a:pt x="375" y="141"/>
                      </a:lnTo>
                      <a:lnTo>
                        <a:pt x="375" y="138"/>
                      </a:lnTo>
                      <a:lnTo>
                        <a:pt x="376" y="138"/>
                      </a:lnTo>
                      <a:lnTo>
                        <a:pt x="376" y="137"/>
                      </a:lnTo>
                      <a:lnTo>
                        <a:pt x="376" y="142"/>
                      </a:lnTo>
                      <a:lnTo>
                        <a:pt x="376" y="138"/>
                      </a:lnTo>
                      <a:lnTo>
                        <a:pt x="377" y="138"/>
                      </a:lnTo>
                      <a:lnTo>
                        <a:pt x="377" y="137"/>
                      </a:lnTo>
                      <a:lnTo>
                        <a:pt x="377" y="140"/>
                      </a:lnTo>
                      <a:lnTo>
                        <a:pt x="377" y="140"/>
                      </a:lnTo>
                      <a:lnTo>
                        <a:pt x="378" y="140"/>
                      </a:lnTo>
                      <a:lnTo>
                        <a:pt x="378" y="136"/>
                      </a:lnTo>
                      <a:lnTo>
                        <a:pt x="378" y="141"/>
                      </a:lnTo>
                      <a:lnTo>
                        <a:pt x="378" y="140"/>
                      </a:lnTo>
                      <a:lnTo>
                        <a:pt x="379" y="140"/>
                      </a:lnTo>
                      <a:lnTo>
                        <a:pt x="379" y="136"/>
                      </a:lnTo>
                      <a:lnTo>
                        <a:pt x="379" y="141"/>
                      </a:lnTo>
                      <a:lnTo>
                        <a:pt x="379" y="137"/>
                      </a:lnTo>
                      <a:lnTo>
                        <a:pt x="380" y="137"/>
                      </a:lnTo>
                      <a:lnTo>
                        <a:pt x="380" y="136"/>
                      </a:lnTo>
                      <a:lnTo>
                        <a:pt x="380" y="139"/>
                      </a:lnTo>
                      <a:lnTo>
                        <a:pt x="380" y="137"/>
                      </a:lnTo>
                      <a:lnTo>
                        <a:pt x="381" y="137"/>
                      </a:lnTo>
                      <a:lnTo>
                        <a:pt x="381" y="135"/>
                      </a:lnTo>
                      <a:lnTo>
                        <a:pt x="381" y="139"/>
                      </a:lnTo>
                      <a:lnTo>
                        <a:pt x="381" y="137"/>
                      </a:lnTo>
                      <a:lnTo>
                        <a:pt x="382" y="137"/>
                      </a:lnTo>
                      <a:lnTo>
                        <a:pt x="382" y="136"/>
                      </a:lnTo>
                      <a:lnTo>
                        <a:pt x="382" y="139"/>
                      </a:lnTo>
                      <a:lnTo>
                        <a:pt x="382" y="136"/>
                      </a:lnTo>
                      <a:lnTo>
                        <a:pt x="383" y="136"/>
                      </a:lnTo>
                      <a:lnTo>
                        <a:pt x="383" y="135"/>
                      </a:lnTo>
                      <a:lnTo>
                        <a:pt x="383" y="139"/>
                      </a:lnTo>
                      <a:lnTo>
                        <a:pt x="383" y="138"/>
                      </a:lnTo>
                      <a:lnTo>
                        <a:pt x="384" y="138"/>
                      </a:lnTo>
                      <a:lnTo>
                        <a:pt x="384" y="136"/>
                      </a:lnTo>
                      <a:lnTo>
                        <a:pt x="384" y="141"/>
                      </a:lnTo>
                      <a:lnTo>
                        <a:pt x="384" y="136"/>
                      </a:lnTo>
                      <a:lnTo>
                        <a:pt x="385" y="136"/>
                      </a:lnTo>
                      <a:lnTo>
                        <a:pt x="385" y="135"/>
                      </a:lnTo>
                      <a:lnTo>
                        <a:pt x="385" y="138"/>
                      </a:lnTo>
                      <a:lnTo>
                        <a:pt x="385" y="136"/>
                      </a:lnTo>
                      <a:lnTo>
                        <a:pt x="386" y="136"/>
                      </a:lnTo>
                      <a:lnTo>
                        <a:pt x="386" y="135"/>
                      </a:lnTo>
                      <a:lnTo>
                        <a:pt x="386" y="139"/>
                      </a:lnTo>
                      <a:lnTo>
                        <a:pt x="386" y="138"/>
                      </a:lnTo>
                      <a:lnTo>
                        <a:pt x="387" y="138"/>
                      </a:lnTo>
                      <a:lnTo>
                        <a:pt x="387" y="136"/>
                      </a:lnTo>
                      <a:lnTo>
                        <a:pt x="387" y="139"/>
                      </a:lnTo>
                      <a:lnTo>
                        <a:pt x="387" y="138"/>
                      </a:lnTo>
                      <a:lnTo>
                        <a:pt x="388" y="138"/>
                      </a:lnTo>
                      <a:lnTo>
                        <a:pt x="388" y="135"/>
                      </a:lnTo>
                      <a:lnTo>
                        <a:pt x="388" y="138"/>
                      </a:lnTo>
                      <a:lnTo>
                        <a:pt x="388" y="136"/>
                      </a:lnTo>
                      <a:lnTo>
                        <a:pt x="389" y="136"/>
                      </a:lnTo>
                      <a:lnTo>
                        <a:pt x="389" y="135"/>
                      </a:lnTo>
                      <a:lnTo>
                        <a:pt x="389" y="140"/>
                      </a:lnTo>
                      <a:lnTo>
                        <a:pt x="389" y="137"/>
                      </a:lnTo>
                      <a:lnTo>
                        <a:pt x="390" y="137"/>
                      </a:lnTo>
                      <a:lnTo>
                        <a:pt x="390" y="135"/>
                      </a:lnTo>
                      <a:lnTo>
                        <a:pt x="390" y="141"/>
                      </a:lnTo>
                      <a:lnTo>
                        <a:pt x="390" y="136"/>
                      </a:lnTo>
                      <a:lnTo>
                        <a:pt x="391" y="136"/>
                      </a:lnTo>
                      <a:lnTo>
                        <a:pt x="391" y="135"/>
                      </a:lnTo>
                      <a:lnTo>
                        <a:pt x="391" y="138"/>
                      </a:lnTo>
                      <a:lnTo>
                        <a:pt x="391" y="136"/>
                      </a:lnTo>
                      <a:lnTo>
                        <a:pt x="392" y="136"/>
                      </a:lnTo>
                      <a:lnTo>
                        <a:pt x="392" y="134"/>
                      </a:lnTo>
                      <a:lnTo>
                        <a:pt x="392" y="139"/>
                      </a:lnTo>
                      <a:lnTo>
                        <a:pt x="392" y="135"/>
                      </a:lnTo>
                      <a:lnTo>
                        <a:pt x="393" y="135"/>
                      </a:lnTo>
                      <a:lnTo>
                        <a:pt x="393" y="134"/>
                      </a:lnTo>
                      <a:lnTo>
                        <a:pt x="393" y="139"/>
                      </a:lnTo>
                      <a:lnTo>
                        <a:pt x="393" y="135"/>
                      </a:lnTo>
                      <a:lnTo>
                        <a:pt x="394" y="135"/>
                      </a:lnTo>
                      <a:lnTo>
                        <a:pt x="394" y="135"/>
                      </a:lnTo>
                      <a:lnTo>
                        <a:pt x="394" y="139"/>
                      </a:lnTo>
                      <a:lnTo>
                        <a:pt x="394" y="138"/>
                      </a:lnTo>
                      <a:lnTo>
                        <a:pt x="395" y="138"/>
                      </a:lnTo>
                      <a:lnTo>
                        <a:pt x="395" y="135"/>
                      </a:lnTo>
                      <a:lnTo>
                        <a:pt x="395" y="138"/>
                      </a:lnTo>
                      <a:lnTo>
                        <a:pt x="395" y="136"/>
                      </a:lnTo>
                      <a:lnTo>
                        <a:pt x="396" y="136"/>
                      </a:lnTo>
                      <a:lnTo>
                        <a:pt x="396" y="134"/>
                      </a:lnTo>
                      <a:lnTo>
                        <a:pt x="396" y="138"/>
                      </a:lnTo>
                      <a:lnTo>
                        <a:pt x="396" y="135"/>
                      </a:lnTo>
                      <a:lnTo>
                        <a:pt x="397" y="135"/>
                      </a:lnTo>
                      <a:lnTo>
                        <a:pt x="397" y="135"/>
                      </a:lnTo>
                      <a:lnTo>
                        <a:pt x="397" y="138"/>
                      </a:lnTo>
                      <a:lnTo>
                        <a:pt x="397" y="137"/>
                      </a:lnTo>
                      <a:lnTo>
                        <a:pt x="398" y="137"/>
                      </a:lnTo>
                      <a:lnTo>
                        <a:pt x="398" y="134"/>
                      </a:lnTo>
                      <a:lnTo>
                        <a:pt x="398" y="138"/>
                      </a:lnTo>
                      <a:lnTo>
                        <a:pt x="398" y="135"/>
                      </a:lnTo>
                      <a:lnTo>
                        <a:pt x="399" y="135"/>
                      </a:lnTo>
                      <a:lnTo>
                        <a:pt x="399" y="134"/>
                      </a:lnTo>
                      <a:lnTo>
                        <a:pt x="399" y="137"/>
                      </a:lnTo>
                      <a:lnTo>
                        <a:pt x="399" y="136"/>
                      </a:lnTo>
                      <a:lnTo>
                        <a:pt x="400" y="136"/>
                      </a:lnTo>
                      <a:lnTo>
                        <a:pt x="400" y="133"/>
                      </a:lnTo>
                      <a:lnTo>
                        <a:pt x="400" y="137"/>
                      </a:lnTo>
                      <a:lnTo>
                        <a:pt x="400" y="136"/>
                      </a:lnTo>
                      <a:lnTo>
                        <a:pt x="401" y="136"/>
                      </a:lnTo>
                      <a:lnTo>
                        <a:pt x="401" y="135"/>
                      </a:lnTo>
                      <a:lnTo>
                        <a:pt x="401" y="137"/>
                      </a:lnTo>
                      <a:lnTo>
                        <a:pt x="401" y="136"/>
                      </a:lnTo>
                      <a:lnTo>
                        <a:pt x="402" y="136"/>
                      </a:lnTo>
                      <a:lnTo>
                        <a:pt x="402" y="134"/>
                      </a:lnTo>
                      <a:lnTo>
                        <a:pt x="402" y="137"/>
                      </a:lnTo>
                      <a:lnTo>
                        <a:pt x="402" y="136"/>
                      </a:lnTo>
                      <a:lnTo>
                        <a:pt x="403" y="136"/>
                      </a:lnTo>
                      <a:lnTo>
                        <a:pt x="403" y="135"/>
                      </a:lnTo>
                      <a:lnTo>
                        <a:pt x="403" y="138"/>
                      </a:lnTo>
                      <a:lnTo>
                        <a:pt x="403" y="136"/>
                      </a:lnTo>
                      <a:lnTo>
                        <a:pt x="404" y="136"/>
                      </a:lnTo>
                      <a:lnTo>
                        <a:pt x="404" y="135"/>
                      </a:lnTo>
                      <a:lnTo>
                        <a:pt x="404" y="137"/>
                      </a:lnTo>
                      <a:lnTo>
                        <a:pt x="404" y="136"/>
                      </a:lnTo>
                      <a:lnTo>
                        <a:pt x="405" y="136"/>
                      </a:lnTo>
                      <a:lnTo>
                        <a:pt x="405" y="133"/>
                      </a:lnTo>
                      <a:lnTo>
                        <a:pt x="405" y="136"/>
                      </a:lnTo>
                      <a:lnTo>
                        <a:pt x="405" y="136"/>
                      </a:lnTo>
                      <a:lnTo>
                        <a:pt x="406" y="136"/>
                      </a:lnTo>
                      <a:lnTo>
                        <a:pt x="406" y="135"/>
                      </a:lnTo>
                      <a:lnTo>
                        <a:pt x="406" y="137"/>
                      </a:lnTo>
                      <a:lnTo>
                        <a:pt x="406" y="135"/>
                      </a:lnTo>
                      <a:lnTo>
                        <a:pt x="407" y="135"/>
                      </a:lnTo>
                      <a:lnTo>
                        <a:pt x="407" y="135"/>
                      </a:lnTo>
                      <a:lnTo>
                        <a:pt x="407" y="139"/>
                      </a:lnTo>
                      <a:lnTo>
                        <a:pt x="407" y="137"/>
                      </a:lnTo>
                      <a:lnTo>
                        <a:pt x="408" y="137"/>
                      </a:lnTo>
                      <a:lnTo>
                        <a:pt x="408" y="133"/>
                      </a:lnTo>
                      <a:lnTo>
                        <a:pt x="408" y="138"/>
                      </a:lnTo>
                      <a:lnTo>
                        <a:pt x="408" y="137"/>
                      </a:lnTo>
                      <a:lnTo>
                        <a:pt x="409" y="137"/>
                      </a:lnTo>
                      <a:lnTo>
                        <a:pt x="409" y="135"/>
                      </a:lnTo>
                      <a:lnTo>
                        <a:pt x="409" y="139"/>
                      </a:lnTo>
                      <a:lnTo>
                        <a:pt x="409" y="138"/>
                      </a:lnTo>
                      <a:lnTo>
                        <a:pt x="410" y="138"/>
                      </a:lnTo>
                      <a:lnTo>
                        <a:pt x="410" y="135"/>
                      </a:lnTo>
                      <a:lnTo>
                        <a:pt x="410" y="139"/>
                      </a:lnTo>
                      <a:lnTo>
                        <a:pt x="410" y="135"/>
                      </a:lnTo>
                      <a:lnTo>
                        <a:pt x="411" y="135"/>
                      </a:lnTo>
                      <a:lnTo>
                        <a:pt x="411" y="134"/>
                      </a:lnTo>
                      <a:lnTo>
                        <a:pt x="411" y="137"/>
                      </a:lnTo>
                      <a:lnTo>
                        <a:pt x="411" y="136"/>
                      </a:lnTo>
                      <a:lnTo>
                        <a:pt x="412" y="136"/>
                      </a:lnTo>
                      <a:lnTo>
                        <a:pt x="412" y="135"/>
                      </a:lnTo>
                      <a:lnTo>
                        <a:pt x="412" y="138"/>
                      </a:lnTo>
                      <a:lnTo>
                        <a:pt x="412" y="136"/>
                      </a:lnTo>
                      <a:lnTo>
                        <a:pt x="413" y="136"/>
                      </a:lnTo>
                      <a:lnTo>
                        <a:pt x="413" y="135"/>
                      </a:lnTo>
                      <a:lnTo>
                        <a:pt x="413" y="138"/>
                      </a:lnTo>
                      <a:lnTo>
                        <a:pt x="413" y="137"/>
                      </a:lnTo>
                      <a:lnTo>
                        <a:pt x="414" y="137"/>
                      </a:lnTo>
                      <a:lnTo>
                        <a:pt x="414" y="136"/>
                      </a:lnTo>
                      <a:lnTo>
                        <a:pt x="414" y="138"/>
                      </a:lnTo>
                      <a:lnTo>
                        <a:pt x="414" y="136"/>
                      </a:lnTo>
                      <a:lnTo>
                        <a:pt x="415" y="136"/>
                      </a:lnTo>
                      <a:lnTo>
                        <a:pt x="415" y="134"/>
                      </a:lnTo>
                      <a:lnTo>
                        <a:pt x="415" y="138"/>
                      </a:lnTo>
                      <a:lnTo>
                        <a:pt x="415" y="137"/>
                      </a:lnTo>
                      <a:lnTo>
                        <a:pt x="416" y="137"/>
                      </a:lnTo>
                      <a:lnTo>
                        <a:pt x="416" y="135"/>
                      </a:lnTo>
                      <a:lnTo>
                        <a:pt x="416" y="137"/>
                      </a:lnTo>
                      <a:lnTo>
                        <a:pt x="416" y="137"/>
                      </a:lnTo>
                      <a:lnTo>
                        <a:pt x="417" y="137"/>
                      </a:lnTo>
                      <a:lnTo>
                        <a:pt x="417" y="135"/>
                      </a:lnTo>
                      <a:lnTo>
                        <a:pt x="417" y="139"/>
                      </a:lnTo>
                      <a:lnTo>
                        <a:pt x="417" y="136"/>
                      </a:lnTo>
                      <a:lnTo>
                        <a:pt x="418" y="136"/>
                      </a:lnTo>
                      <a:lnTo>
                        <a:pt x="418" y="133"/>
                      </a:lnTo>
                      <a:lnTo>
                        <a:pt x="418" y="138"/>
                      </a:lnTo>
                      <a:lnTo>
                        <a:pt x="418" y="134"/>
                      </a:lnTo>
                      <a:lnTo>
                        <a:pt x="419" y="134"/>
                      </a:lnTo>
                      <a:lnTo>
                        <a:pt x="419" y="133"/>
                      </a:lnTo>
                      <a:lnTo>
                        <a:pt x="419" y="138"/>
                      </a:lnTo>
                      <a:lnTo>
                        <a:pt x="419" y="138"/>
                      </a:lnTo>
                      <a:lnTo>
                        <a:pt x="420" y="138"/>
                      </a:lnTo>
                      <a:lnTo>
                        <a:pt x="420" y="135"/>
                      </a:lnTo>
                      <a:lnTo>
                        <a:pt x="420" y="141"/>
                      </a:lnTo>
                      <a:lnTo>
                        <a:pt x="420" y="138"/>
                      </a:lnTo>
                      <a:lnTo>
                        <a:pt x="421" y="138"/>
                      </a:lnTo>
                      <a:lnTo>
                        <a:pt x="421" y="135"/>
                      </a:lnTo>
                      <a:lnTo>
                        <a:pt x="421" y="138"/>
                      </a:lnTo>
                      <a:lnTo>
                        <a:pt x="421" y="138"/>
                      </a:lnTo>
                      <a:lnTo>
                        <a:pt x="422" y="138"/>
                      </a:lnTo>
                      <a:lnTo>
                        <a:pt x="422" y="135"/>
                      </a:lnTo>
                      <a:lnTo>
                        <a:pt x="422" y="138"/>
                      </a:lnTo>
                      <a:lnTo>
                        <a:pt x="422" y="137"/>
                      </a:lnTo>
                      <a:lnTo>
                        <a:pt x="423" y="137"/>
                      </a:lnTo>
                      <a:lnTo>
                        <a:pt x="423" y="135"/>
                      </a:lnTo>
                      <a:lnTo>
                        <a:pt x="423" y="139"/>
                      </a:lnTo>
                      <a:lnTo>
                        <a:pt x="423" y="135"/>
                      </a:lnTo>
                      <a:lnTo>
                        <a:pt x="424" y="135"/>
                      </a:lnTo>
                      <a:lnTo>
                        <a:pt x="424" y="135"/>
                      </a:lnTo>
                      <a:lnTo>
                        <a:pt x="424" y="137"/>
                      </a:lnTo>
                      <a:lnTo>
                        <a:pt x="424" y="136"/>
                      </a:lnTo>
                      <a:lnTo>
                        <a:pt x="425" y="136"/>
                      </a:lnTo>
                      <a:lnTo>
                        <a:pt x="425" y="134"/>
                      </a:lnTo>
                      <a:lnTo>
                        <a:pt x="425" y="139"/>
                      </a:lnTo>
                      <a:lnTo>
                        <a:pt x="425" y="136"/>
                      </a:lnTo>
                      <a:lnTo>
                        <a:pt x="426" y="136"/>
                      </a:lnTo>
                      <a:lnTo>
                        <a:pt x="426" y="134"/>
                      </a:lnTo>
                      <a:lnTo>
                        <a:pt x="426" y="136"/>
                      </a:lnTo>
                      <a:lnTo>
                        <a:pt x="426" y="135"/>
                      </a:lnTo>
                      <a:lnTo>
                        <a:pt x="427" y="135"/>
                      </a:lnTo>
                      <a:lnTo>
                        <a:pt x="427" y="135"/>
                      </a:lnTo>
                      <a:lnTo>
                        <a:pt x="427" y="138"/>
                      </a:lnTo>
                      <a:lnTo>
                        <a:pt x="427" y="136"/>
                      </a:lnTo>
                      <a:lnTo>
                        <a:pt x="428" y="136"/>
                      </a:lnTo>
                      <a:lnTo>
                        <a:pt x="428" y="135"/>
                      </a:lnTo>
                      <a:lnTo>
                        <a:pt x="428" y="138"/>
                      </a:lnTo>
                      <a:lnTo>
                        <a:pt x="428" y="136"/>
                      </a:lnTo>
                      <a:lnTo>
                        <a:pt x="429" y="136"/>
                      </a:lnTo>
                      <a:lnTo>
                        <a:pt x="429" y="135"/>
                      </a:lnTo>
                      <a:lnTo>
                        <a:pt x="429" y="138"/>
                      </a:lnTo>
                      <a:lnTo>
                        <a:pt x="429" y="138"/>
                      </a:lnTo>
                      <a:lnTo>
                        <a:pt x="430" y="138"/>
                      </a:lnTo>
                      <a:lnTo>
                        <a:pt x="430" y="134"/>
                      </a:lnTo>
                      <a:lnTo>
                        <a:pt x="430" y="137"/>
                      </a:lnTo>
                      <a:lnTo>
                        <a:pt x="430" y="135"/>
                      </a:lnTo>
                      <a:lnTo>
                        <a:pt x="431" y="135"/>
                      </a:lnTo>
                      <a:lnTo>
                        <a:pt x="431" y="135"/>
                      </a:lnTo>
                      <a:lnTo>
                        <a:pt x="431" y="138"/>
                      </a:lnTo>
                      <a:lnTo>
                        <a:pt x="431" y="136"/>
                      </a:lnTo>
                      <a:lnTo>
                        <a:pt x="432" y="136"/>
                      </a:lnTo>
                      <a:lnTo>
                        <a:pt x="432" y="135"/>
                      </a:lnTo>
                      <a:lnTo>
                        <a:pt x="432" y="139"/>
                      </a:lnTo>
                      <a:lnTo>
                        <a:pt x="432" y="137"/>
                      </a:lnTo>
                      <a:lnTo>
                        <a:pt x="433" y="137"/>
                      </a:lnTo>
                      <a:lnTo>
                        <a:pt x="433" y="134"/>
                      </a:lnTo>
                      <a:lnTo>
                        <a:pt x="433" y="137"/>
                      </a:lnTo>
                      <a:lnTo>
                        <a:pt x="433" y="136"/>
                      </a:lnTo>
                      <a:lnTo>
                        <a:pt x="434" y="136"/>
                      </a:lnTo>
                      <a:lnTo>
                        <a:pt x="434" y="135"/>
                      </a:lnTo>
                      <a:lnTo>
                        <a:pt x="434" y="139"/>
                      </a:lnTo>
                      <a:lnTo>
                        <a:pt x="434" y="136"/>
                      </a:lnTo>
                      <a:lnTo>
                        <a:pt x="435" y="136"/>
                      </a:lnTo>
                      <a:lnTo>
                        <a:pt x="435" y="135"/>
                      </a:lnTo>
                      <a:lnTo>
                        <a:pt x="435" y="137"/>
                      </a:lnTo>
                      <a:lnTo>
                        <a:pt x="435" y="135"/>
                      </a:lnTo>
                      <a:lnTo>
                        <a:pt x="436" y="135"/>
                      </a:lnTo>
                      <a:lnTo>
                        <a:pt x="436" y="133"/>
                      </a:lnTo>
                      <a:lnTo>
                        <a:pt x="436" y="138"/>
                      </a:lnTo>
                      <a:lnTo>
                        <a:pt x="436" y="137"/>
                      </a:lnTo>
                      <a:lnTo>
                        <a:pt x="437" y="137"/>
                      </a:lnTo>
                      <a:lnTo>
                        <a:pt x="437" y="135"/>
                      </a:lnTo>
                      <a:lnTo>
                        <a:pt x="437" y="138"/>
                      </a:lnTo>
                      <a:lnTo>
                        <a:pt x="437" y="137"/>
                      </a:lnTo>
                      <a:lnTo>
                        <a:pt x="438" y="137"/>
                      </a:lnTo>
                      <a:lnTo>
                        <a:pt x="438" y="136"/>
                      </a:lnTo>
                      <a:lnTo>
                        <a:pt x="438" y="139"/>
                      </a:lnTo>
                      <a:lnTo>
                        <a:pt x="438" y="136"/>
                      </a:lnTo>
                      <a:lnTo>
                        <a:pt x="439" y="136"/>
                      </a:lnTo>
                      <a:lnTo>
                        <a:pt x="439" y="136"/>
                      </a:lnTo>
                      <a:lnTo>
                        <a:pt x="439" y="140"/>
                      </a:lnTo>
                      <a:lnTo>
                        <a:pt x="439" y="138"/>
                      </a:lnTo>
                      <a:lnTo>
                        <a:pt x="440" y="138"/>
                      </a:lnTo>
                      <a:lnTo>
                        <a:pt x="440" y="138"/>
                      </a:lnTo>
                      <a:lnTo>
                        <a:pt x="440" y="140"/>
                      </a:lnTo>
                      <a:lnTo>
                        <a:pt x="440" y="138"/>
                      </a:lnTo>
                      <a:lnTo>
                        <a:pt x="441" y="138"/>
                      </a:lnTo>
                      <a:lnTo>
                        <a:pt x="441" y="136"/>
                      </a:lnTo>
                      <a:lnTo>
                        <a:pt x="441" y="140"/>
                      </a:lnTo>
                      <a:lnTo>
                        <a:pt x="441" y="140"/>
                      </a:lnTo>
                      <a:lnTo>
                        <a:pt x="442" y="140"/>
                      </a:lnTo>
                      <a:lnTo>
                        <a:pt x="442" y="138"/>
                      </a:lnTo>
                      <a:lnTo>
                        <a:pt x="442" y="140"/>
                      </a:lnTo>
                      <a:lnTo>
                        <a:pt x="442" y="138"/>
                      </a:lnTo>
                      <a:lnTo>
                        <a:pt x="443" y="138"/>
                      </a:lnTo>
                      <a:lnTo>
                        <a:pt x="443" y="136"/>
                      </a:lnTo>
                      <a:lnTo>
                        <a:pt x="443" y="140"/>
                      </a:lnTo>
                      <a:lnTo>
                        <a:pt x="443" y="138"/>
                      </a:lnTo>
                      <a:lnTo>
                        <a:pt x="444" y="138"/>
                      </a:lnTo>
                      <a:lnTo>
                        <a:pt x="444" y="136"/>
                      </a:lnTo>
                      <a:lnTo>
                        <a:pt x="444" y="139"/>
                      </a:lnTo>
                      <a:lnTo>
                        <a:pt x="444" y="138"/>
                      </a:lnTo>
                      <a:lnTo>
                        <a:pt x="445" y="138"/>
                      </a:lnTo>
                      <a:lnTo>
                        <a:pt x="445" y="136"/>
                      </a:lnTo>
                      <a:lnTo>
                        <a:pt x="445" y="139"/>
                      </a:lnTo>
                      <a:lnTo>
                        <a:pt x="445" y="139"/>
                      </a:lnTo>
                      <a:lnTo>
                        <a:pt x="446" y="139"/>
                      </a:lnTo>
                      <a:lnTo>
                        <a:pt x="446" y="136"/>
                      </a:lnTo>
                      <a:lnTo>
                        <a:pt x="446" y="140"/>
                      </a:lnTo>
                      <a:lnTo>
                        <a:pt x="446" y="138"/>
                      </a:lnTo>
                      <a:lnTo>
                        <a:pt x="447" y="138"/>
                      </a:lnTo>
                      <a:lnTo>
                        <a:pt x="447" y="136"/>
                      </a:lnTo>
                      <a:lnTo>
                        <a:pt x="447" y="139"/>
                      </a:lnTo>
                      <a:lnTo>
                        <a:pt x="447" y="137"/>
                      </a:lnTo>
                      <a:lnTo>
                        <a:pt x="448" y="137"/>
                      </a:lnTo>
                      <a:lnTo>
                        <a:pt x="448" y="136"/>
                      </a:lnTo>
                      <a:lnTo>
                        <a:pt x="448" y="139"/>
                      </a:lnTo>
                      <a:lnTo>
                        <a:pt x="448" y="137"/>
                      </a:lnTo>
                      <a:lnTo>
                        <a:pt x="449" y="137"/>
                      </a:lnTo>
                      <a:lnTo>
                        <a:pt x="449" y="136"/>
                      </a:lnTo>
                      <a:lnTo>
                        <a:pt x="449" y="141"/>
                      </a:lnTo>
                      <a:lnTo>
                        <a:pt x="449" y="138"/>
                      </a:lnTo>
                      <a:lnTo>
                        <a:pt x="450" y="138"/>
                      </a:lnTo>
                      <a:lnTo>
                        <a:pt x="450" y="138"/>
                      </a:lnTo>
                      <a:lnTo>
                        <a:pt x="450" y="141"/>
                      </a:lnTo>
                      <a:lnTo>
                        <a:pt x="450" y="138"/>
                      </a:lnTo>
                      <a:lnTo>
                        <a:pt x="451" y="138"/>
                      </a:lnTo>
                      <a:lnTo>
                        <a:pt x="451" y="138"/>
                      </a:lnTo>
                      <a:lnTo>
                        <a:pt x="451" y="142"/>
                      </a:lnTo>
                      <a:lnTo>
                        <a:pt x="451" y="139"/>
                      </a:lnTo>
                      <a:lnTo>
                        <a:pt x="452" y="139"/>
                      </a:lnTo>
                      <a:lnTo>
                        <a:pt x="452" y="138"/>
                      </a:lnTo>
                      <a:lnTo>
                        <a:pt x="452" y="141"/>
                      </a:lnTo>
                      <a:lnTo>
                        <a:pt x="452" y="138"/>
                      </a:lnTo>
                      <a:lnTo>
                        <a:pt x="453" y="138"/>
                      </a:lnTo>
                      <a:lnTo>
                        <a:pt x="453" y="138"/>
                      </a:lnTo>
                      <a:lnTo>
                        <a:pt x="453" y="141"/>
                      </a:lnTo>
                      <a:lnTo>
                        <a:pt x="453" y="141"/>
                      </a:lnTo>
                      <a:lnTo>
                        <a:pt x="454" y="141"/>
                      </a:lnTo>
                      <a:lnTo>
                        <a:pt x="454" y="138"/>
                      </a:lnTo>
                      <a:lnTo>
                        <a:pt x="454" y="142"/>
                      </a:lnTo>
                      <a:lnTo>
                        <a:pt x="454" y="140"/>
                      </a:lnTo>
                      <a:lnTo>
                        <a:pt x="455" y="140"/>
                      </a:lnTo>
                      <a:lnTo>
                        <a:pt x="455" y="138"/>
                      </a:lnTo>
                      <a:lnTo>
                        <a:pt x="455" y="142"/>
                      </a:lnTo>
                      <a:lnTo>
                        <a:pt x="455" y="138"/>
                      </a:lnTo>
                      <a:lnTo>
                        <a:pt x="456" y="138"/>
                      </a:lnTo>
                      <a:lnTo>
                        <a:pt x="456" y="137"/>
                      </a:lnTo>
                      <a:lnTo>
                        <a:pt x="456" y="141"/>
                      </a:lnTo>
                      <a:lnTo>
                        <a:pt x="456" y="141"/>
                      </a:lnTo>
                      <a:lnTo>
                        <a:pt x="457" y="141"/>
                      </a:lnTo>
                      <a:lnTo>
                        <a:pt x="457" y="138"/>
                      </a:lnTo>
                      <a:lnTo>
                        <a:pt x="457" y="142"/>
                      </a:lnTo>
                      <a:lnTo>
                        <a:pt x="457" y="140"/>
                      </a:lnTo>
                      <a:lnTo>
                        <a:pt x="458" y="140"/>
                      </a:lnTo>
                      <a:lnTo>
                        <a:pt x="458" y="138"/>
                      </a:lnTo>
                      <a:lnTo>
                        <a:pt x="458" y="144"/>
                      </a:lnTo>
                      <a:lnTo>
                        <a:pt x="458" y="141"/>
                      </a:lnTo>
                      <a:lnTo>
                        <a:pt x="459" y="141"/>
                      </a:lnTo>
                      <a:lnTo>
                        <a:pt x="459" y="138"/>
                      </a:lnTo>
                      <a:lnTo>
                        <a:pt x="459" y="142"/>
                      </a:lnTo>
                      <a:lnTo>
                        <a:pt x="459" y="139"/>
                      </a:lnTo>
                      <a:lnTo>
                        <a:pt x="460" y="139"/>
                      </a:lnTo>
                      <a:lnTo>
                        <a:pt x="460" y="138"/>
                      </a:lnTo>
                      <a:lnTo>
                        <a:pt x="460" y="142"/>
                      </a:lnTo>
                      <a:lnTo>
                        <a:pt x="460" y="140"/>
                      </a:lnTo>
                      <a:lnTo>
                        <a:pt x="461" y="140"/>
                      </a:lnTo>
                      <a:lnTo>
                        <a:pt x="461" y="140"/>
                      </a:lnTo>
                      <a:lnTo>
                        <a:pt x="461" y="143"/>
                      </a:lnTo>
                      <a:lnTo>
                        <a:pt x="461" y="142"/>
                      </a:lnTo>
                      <a:lnTo>
                        <a:pt x="462" y="142"/>
                      </a:lnTo>
                      <a:lnTo>
                        <a:pt x="462" y="139"/>
                      </a:lnTo>
                      <a:lnTo>
                        <a:pt x="462" y="144"/>
                      </a:lnTo>
                      <a:lnTo>
                        <a:pt x="462" y="142"/>
                      </a:lnTo>
                      <a:lnTo>
                        <a:pt x="463" y="142"/>
                      </a:lnTo>
                      <a:lnTo>
                        <a:pt x="463" y="137"/>
                      </a:lnTo>
                      <a:lnTo>
                        <a:pt x="463" y="142"/>
                      </a:lnTo>
                      <a:lnTo>
                        <a:pt x="463" y="140"/>
                      </a:lnTo>
                      <a:lnTo>
                        <a:pt x="464" y="140"/>
                      </a:lnTo>
                      <a:lnTo>
                        <a:pt x="464" y="138"/>
                      </a:lnTo>
                      <a:lnTo>
                        <a:pt x="464" y="142"/>
                      </a:lnTo>
                      <a:lnTo>
                        <a:pt x="464" y="142"/>
                      </a:lnTo>
                      <a:lnTo>
                        <a:pt x="465" y="142"/>
                      </a:lnTo>
                      <a:lnTo>
                        <a:pt x="465" y="141"/>
                      </a:lnTo>
                      <a:lnTo>
                        <a:pt x="465" y="144"/>
                      </a:lnTo>
                      <a:lnTo>
                        <a:pt x="465" y="141"/>
                      </a:lnTo>
                      <a:lnTo>
                        <a:pt x="466" y="141"/>
                      </a:lnTo>
                      <a:lnTo>
                        <a:pt x="466" y="140"/>
                      </a:lnTo>
                      <a:lnTo>
                        <a:pt x="466" y="145"/>
                      </a:lnTo>
                      <a:lnTo>
                        <a:pt x="466" y="142"/>
                      </a:lnTo>
                      <a:lnTo>
                        <a:pt x="467" y="142"/>
                      </a:lnTo>
                      <a:lnTo>
                        <a:pt x="467" y="141"/>
                      </a:lnTo>
                      <a:lnTo>
                        <a:pt x="467" y="144"/>
                      </a:lnTo>
                      <a:lnTo>
                        <a:pt x="467" y="143"/>
                      </a:lnTo>
                      <a:lnTo>
                        <a:pt x="468" y="143"/>
                      </a:lnTo>
                      <a:lnTo>
                        <a:pt x="468" y="140"/>
                      </a:lnTo>
                      <a:lnTo>
                        <a:pt x="468" y="144"/>
                      </a:lnTo>
                      <a:lnTo>
                        <a:pt x="468" y="142"/>
                      </a:lnTo>
                      <a:lnTo>
                        <a:pt x="469" y="142"/>
                      </a:lnTo>
                      <a:lnTo>
                        <a:pt x="469" y="141"/>
                      </a:lnTo>
                      <a:lnTo>
                        <a:pt x="469" y="143"/>
                      </a:lnTo>
                      <a:lnTo>
                        <a:pt x="469" y="142"/>
                      </a:lnTo>
                      <a:lnTo>
                        <a:pt x="470" y="142"/>
                      </a:lnTo>
                      <a:lnTo>
                        <a:pt x="470" y="141"/>
                      </a:lnTo>
                      <a:lnTo>
                        <a:pt x="470" y="144"/>
                      </a:lnTo>
                      <a:lnTo>
                        <a:pt x="470" y="141"/>
                      </a:lnTo>
                      <a:lnTo>
                        <a:pt x="471" y="141"/>
                      </a:lnTo>
                      <a:lnTo>
                        <a:pt x="471" y="141"/>
                      </a:lnTo>
                      <a:lnTo>
                        <a:pt x="471" y="144"/>
                      </a:lnTo>
                      <a:lnTo>
                        <a:pt x="471" y="142"/>
                      </a:lnTo>
                      <a:lnTo>
                        <a:pt x="472" y="142"/>
                      </a:lnTo>
                      <a:lnTo>
                        <a:pt x="472" y="141"/>
                      </a:lnTo>
                      <a:lnTo>
                        <a:pt x="472" y="144"/>
                      </a:lnTo>
                      <a:lnTo>
                        <a:pt x="472" y="142"/>
                      </a:lnTo>
                      <a:lnTo>
                        <a:pt x="473" y="142"/>
                      </a:lnTo>
                      <a:lnTo>
                        <a:pt x="473" y="141"/>
                      </a:lnTo>
                      <a:lnTo>
                        <a:pt x="473" y="145"/>
                      </a:lnTo>
                      <a:lnTo>
                        <a:pt x="473" y="142"/>
                      </a:lnTo>
                      <a:lnTo>
                        <a:pt x="474" y="142"/>
                      </a:lnTo>
                      <a:lnTo>
                        <a:pt x="474" y="141"/>
                      </a:lnTo>
                      <a:lnTo>
                        <a:pt x="474" y="145"/>
                      </a:lnTo>
                      <a:lnTo>
                        <a:pt x="474" y="144"/>
                      </a:lnTo>
                      <a:lnTo>
                        <a:pt x="475" y="144"/>
                      </a:lnTo>
                      <a:lnTo>
                        <a:pt x="475" y="142"/>
                      </a:lnTo>
                      <a:lnTo>
                        <a:pt x="475" y="145"/>
                      </a:lnTo>
                      <a:lnTo>
                        <a:pt x="475" y="142"/>
                      </a:lnTo>
                      <a:lnTo>
                        <a:pt x="476" y="142"/>
                      </a:lnTo>
                      <a:lnTo>
                        <a:pt x="476" y="141"/>
                      </a:lnTo>
                      <a:lnTo>
                        <a:pt x="476" y="144"/>
                      </a:lnTo>
                      <a:lnTo>
                        <a:pt x="476" y="142"/>
                      </a:lnTo>
                      <a:lnTo>
                        <a:pt x="477" y="142"/>
                      </a:lnTo>
                      <a:lnTo>
                        <a:pt x="477" y="142"/>
                      </a:lnTo>
                      <a:lnTo>
                        <a:pt x="477" y="145"/>
                      </a:lnTo>
                      <a:lnTo>
                        <a:pt x="477" y="144"/>
                      </a:lnTo>
                      <a:lnTo>
                        <a:pt x="478" y="144"/>
                      </a:lnTo>
                      <a:lnTo>
                        <a:pt x="478" y="141"/>
                      </a:lnTo>
                      <a:lnTo>
                        <a:pt x="478" y="146"/>
                      </a:lnTo>
                      <a:lnTo>
                        <a:pt x="478" y="143"/>
                      </a:lnTo>
                      <a:lnTo>
                        <a:pt x="479" y="143"/>
                      </a:lnTo>
                      <a:lnTo>
                        <a:pt x="479" y="141"/>
                      </a:lnTo>
                      <a:lnTo>
                        <a:pt x="479" y="145"/>
                      </a:lnTo>
                      <a:lnTo>
                        <a:pt x="479" y="144"/>
                      </a:lnTo>
                      <a:lnTo>
                        <a:pt x="480" y="144"/>
                      </a:lnTo>
                      <a:lnTo>
                        <a:pt x="480" y="141"/>
                      </a:lnTo>
                      <a:lnTo>
                        <a:pt x="480" y="146"/>
                      </a:lnTo>
                      <a:lnTo>
                        <a:pt x="480" y="144"/>
                      </a:lnTo>
                      <a:lnTo>
                        <a:pt x="481" y="144"/>
                      </a:lnTo>
                      <a:lnTo>
                        <a:pt x="481" y="142"/>
                      </a:lnTo>
                      <a:lnTo>
                        <a:pt x="481" y="144"/>
                      </a:lnTo>
                      <a:lnTo>
                        <a:pt x="481" y="144"/>
                      </a:lnTo>
                      <a:lnTo>
                        <a:pt x="482" y="144"/>
                      </a:lnTo>
                      <a:lnTo>
                        <a:pt x="482" y="141"/>
                      </a:lnTo>
                      <a:lnTo>
                        <a:pt x="482" y="145"/>
                      </a:lnTo>
                      <a:lnTo>
                        <a:pt x="482" y="142"/>
                      </a:lnTo>
                      <a:lnTo>
                        <a:pt x="483" y="142"/>
                      </a:lnTo>
                      <a:lnTo>
                        <a:pt x="483" y="141"/>
                      </a:lnTo>
                      <a:lnTo>
                        <a:pt x="483" y="143"/>
                      </a:lnTo>
                      <a:lnTo>
                        <a:pt x="483" y="141"/>
                      </a:lnTo>
                      <a:lnTo>
                        <a:pt x="484" y="141"/>
                      </a:lnTo>
                      <a:lnTo>
                        <a:pt x="484" y="140"/>
                      </a:lnTo>
                      <a:lnTo>
                        <a:pt x="484" y="144"/>
                      </a:lnTo>
                      <a:lnTo>
                        <a:pt x="484" y="144"/>
                      </a:lnTo>
                      <a:lnTo>
                        <a:pt x="485" y="144"/>
                      </a:lnTo>
                      <a:lnTo>
                        <a:pt x="485" y="141"/>
                      </a:lnTo>
                      <a:lnTo>
                        <a:pt x="485" y="144"/>
                      </a:lnTo>
                      <a:lnTo>
                        <a:pt x="485" y="144"/>
                      </a:lnTo>
                      <a:lnTo>
                        <a:pt x="486" y="144"/>
                      </a:lnTo>
                      <a:lnTo>
                        <a:pt x="486" y="141"/>
                      </a:lnTo>
                      <a:lnTo>
                        <a:pt x="486" y="144"/>
                      </a:lnTo>
                      <a:lnTo>
                        <a:pt x="486" y="142"/>
                      </a:lnTo>
                      <a:lnTo>
                        <a:pt x="487" y="142"/>
                      </a:lnTo>
                      <a:lnTo>
                        <a:pt x="487" y="141"/>
                      </a:lnTo>
                      <a:lnTo>
                        <a:pt x="487" y="146"/>
                      </a:lnTo>
                      <a:lnTo>
                        <a:pt x="487" y="143"/>
                      </a:lnTo>
                      <a:lnTo>
                        <a:pt x="488" y="143"/>
                      </a:lnTo>
                      <a:lnTo>
                        <a:pt x="488" y="141"/>
                      </a:lnTo>
                      <a:lnTo>
                        <a:pt x="488" y="145"/>
                      </a:lnTo>
                      <a:lnTo>
                        <a:pt x="488" y="144"/>
                      </a:lnTo>
                      <a:lnTo>
                        <a:pt x="489" y="144"/>
                      </a:lnTo>
                      <a:lnTo>
                        <a:pt x="489" y="141"/>
                      </a:lnTo>
                      <a:lnTo>
                        <a:pt x="489" y="146"/>
                      </a:lnTo>
                      <a:lnTo>
                        <a:pt x="489" y="146"/>
                      </a:lnTo>
                      <a:lnTo>
                        <a:pt x="490" y="146"/>
                      </a:lnTo>
                      <a:lnTo>
                        <a:pt x="490" y="142"/>
                      </a:lnTo>
                      <a:lnTo>
                        <a:pt x="490" y="145"/>
                      </a:lnTo>
                      <a:lnTo>
                        <a:pt x="490" y="143"/>
                      </a:lnTo>
                      <a:lnTo>
                        <a:pt x="491" y="143"/>
                      </a:lnTo>
                      <a:lnTo>
                        <a:pt x="491" y="142"/>
                      </a:lnTo>
                      <a:lnTo>
                        <a:pt x="491" y="144"/>
                      </a:lnTo>
                      <a:lnTo>
                        <a:pt x="491" y="142"/>
                      </a:lnTo>
                      <a:lnTo>
                        <a:pt x="492" y="142"/>
                      </a:lnTo>
                      <a:lnTo>
                        <a:pt x="492" y="142"/>
                      </a:lnTo>
                      <a:lnTo>
                        <a:pt x="492" y="146"/>
                      </a:lnTo>
                      <a:lnTo>
                        <a:pt x="492" y="143"/>
                      </a:lnTo>
                      <a:lnTo>
                        <a:pt x="493" y="143"/>
                      </a:lnTo>
                      <a:lnTo>
                        <a:pt x="493" y="141"/>
                      </a:lnTo>
                      <a:lnTo>
                        <a:pt x="493" y="144"/>
                      </a:lnTo>
                      <a:lnTo>
                        <a:pt x="493" y="141"/>
                      </a:lnTo>
                      <a:lnTo>
                        <a:pt x="494" y="141"/>
                      </a:lnTo>
                      <a:lnTo>
                        <a:pt x="494" y="141"/>
                      </a:lnTo>
                      <a:lnTo>
                        <a:pt x="494" y="145"/>
                      </a:lnTo>
                      <a:lnTo>
                        <a:pt x="494" y="143"/>
                      </a:lnTo>
                      <a:lnTo>
                        <a:pt x="495" y="143"/>
                      </a:lnTo>
                      <a:lnTo>
                        <a:pt x="495" y="142"/>
                      </a:lnTo>
                      <a:lnTo>
                        <a:pt x="495" y="145"/>
                      </a:lnTo>
                      <a:lnTo>
                        <a:pt x="495" y="145"/>
                      </a:lnTo>
                      <a:lnTo>
                        <a:pt x="496" y="145"/>
                      </a:lnTo>
                      <a:lnTo>
                        <a:pt x="496" y="140"/>
                      </a:lnTo>
                      <a:lnTo>
                        <a:pt x="496" y="144"/>
                      </a:lnTo>
                      <a:lnTo>
                        <a:pt x="496" y="142"/>
                      </a:lnTo>
                      <a:lnTo>
                        <a:pt x="497" y="142"/>
                      </a:lnTo>
                      <a:lnTo>
                        <a:pt x="497" y="140"/>
                      </a:lnTo>
                      <a:lnTo>
                        <a:pt x="497" y="144"/>
                      </a:lnTo>
                      <a:lnTo>
                        <a:pt x="497" y="143"/>
                      </a:lnTo>
                      <a:lnTo>
                        <a:pt x="498" y="143"/>
                      </a:lnTo>
                      <a:lnTo>
                        <a:pt x="498" y="141"/>
                      </a:lnTo>
                      <a:lnTo>
                        <a:pt x="498" y="144"/>
                      </a:lnTo>
                      <a:lnTo>
                        <a:pt x="498" y="142"/>
                      </a:lnTo>
                      <a:lnTo>
                        <a:pt x="499" y="142"/>
                      </a:lnTo>
                      <a:lnTo>
                        <a:pt x="499" y="141"/>
                      </a:lnTo>
                      <a:lnTo>
                        <a:pt x="499" y="145"/>
                      </a:lnTo>
                      <a:lnTo>
                        <a:pt x="499" y="141"/>
                      </a:lnTo>
                      <a:lnTo>
                        <a:pt x="500" y="141"/>
                      </a:lnTo>
                      <a:lnTo>
                        <a:pt x="500" y="140"/>
                      </a:lnTo>
                      <a:lnTo>
                        <a:pt x="500" y="144"/>
                      </a:lnTo>
                      <a:lnTo>
                        <a:pt x="500" y="142"/>
                      </a:lnTo>
                      <a:lnTo>
                        <a:pt x="501" y="142"/>
                      </a:lnTo>
                      <a:lnTo>
                        <a:pt x="501" y="140"/>
                      </a:lnTo>
                      <a:lnTo>
                        <a:pt x="501" y="144"/>
                      </a:lnTo>
                      <a:lnTo>
                        <a:pt x="501" y="142"/>
                      </a:lnTo>
                      <a:lnTo>
                        <a:pt x="502" y="142"/>
                      </a:lnTo>
                      <a:lnTo>
                        <a:pt x="502" y="140"/>
                      </a:lnTo>
                      <a:lnTo>
                        <a:pt x="502" y="143"/>
                      </a:lnTo>
                      <a:lnTo>
                        <a:pt x="502" y="143"/>
                      </a:lnTo>
                      <a:lnTo>
                        <a:pt x="503" y="143"/>
                      </a:lnTo>
                      <a:lnTo>
                        <a:pt x="503" y="141"/>
                      </a:lnTo>
                      <a:lnTo>
                        <a:pt x="503" y="144"/>
                      </a:lnTo>
                      <a:lnTo>
                        <a:pt x="503" y="141"/>
                      </a:lnTo>
                      <a:lnTo>
                        <a:pt x="504" y="141"/>
                      </a:lnTo>
                      <a:lnTo>
                        <a:pt x="504" y="140"/>
                      </a:lnTo>
                      <a:lnTo>
                        <a:pt x="504" y="144"/>
                      </a:lnTo>
                      <a:lnTo>
                        <a:pt x="504" y="143"/>
                      </a:lnTo>
                      <a:lnTo>
                        <a:pt x="505" y="143"/>
                      </a:lnTo>
                      <a:lnTo>
                        <a:pt x="505" y="142"/>
                      </a:lnTo>
                      <a:lnTo>
                        <a:pt x="505" y="144"/>
                      </a:lnTo>
                      <a:lnTo>
                        <a:pt x="505" y="144"/>
                      </a:lnTo>
                      <a:lnTo>
                        <a:pt x="506" y="144"/>
                      </a:lnTo>
                      <a:lnTo>
                        <a:pt x="506" y="141"/>
                      </a:lnTo>
                      <a:lnTo>
                        <a:pt x="506" y="144"/>
                      </a:lnTo>
                      <a:lnTo>
                        <a:pt x="506" y="142"/>
                      </a:lnTo>
                      <a:lnTo>
                        <a:pt x="507" y="142"/>
                      </a:lnTo>
                      <a:lnTo>
                        <a:pt x="507" y="141"/>
                      </a:lnTo>
                      <a:lnTo>
                        <a:pt x="507" y="143"/>
                      </a:lnTo>
                      <a:lnTo>
                        <a:pt x="507" y="142"/>
                      </a:lnTo>
                      <a:lnTo>
                        <a:pt x="508" y="142"/>
                      </a:lnTo>
                      <a:lnTo>
                        <a:pt x="508" y="141"/>
                      </a:lnTo>
                      <a:lnTo>
                        <a:pt x="508" y="144"/>
                      </a:lnTo>
                      <a:lnTo>
                        <a:pt x="508" y="142"/>
                      </a:lnTo>
                      <a:lnTo>
                        <a:pt x="509" y="142"/>
                      </a:lnTo>
                      <a:lnTo>
                        <a:pt x="509" y="142"/>
                      </a:lnTo>
                      <a:lnTo>
                        <a:pt x="509" y="144"/>
                      </a:lnTo>
                      <a:lnTo>
                        <a:pt x="509" y="142"/>
                      </a:lnTo>
                      <a:lnTo>
                        <a:pt x="510" y="142"/>
                      </a:lnTo>
                      <a:lnTo>
                        <a:pt x="510" y="141"/>
                      </a:lnTo>
                      <a:lnTo>
                        <a:pt x="510" y="145"/>
                      </a:lnTo>
                      <a:lnTo>
                        <a:pt x="510" y="145"/>
                      </a:lnTo>
                      <a:lnTo>
                        <a:pt x="511" y="145"/>
                      </a:lnTo>
                      <a:lnTo>
                        <a:pt x="511" y="140"/>
                      </a:lnTo>
                      <a:lnTo>
                        <a:pt x="511" y="144"/>
                      </a:lnTo>
                      <a:lnTo>
                        <a:pt x="511" y="141"/>
                      </a:lnTo>
                      <a:lnTo>
                        <a:pt x="512" y="141"/>
                      </a:lnTo>
                      <a:lnTo>
                        <a:pt x="512" y="140"/>
                      </a:lnTo>
                      <a:lnTo>
                        <a:pt x="512" y="144"/>
                      </a:lnTo>
                      <a:lnTo>
                        <a:pt x="512" y="142"/>
                      </a:lnTo>
                      <a:lnTo>
                        <a:pt x="513" y="142"/>
                      </a:lnTo>
                      <a:lnTo>
                        <a:pt x="513" y="139"/>
                      </a:lnTo>
                      <a:lnTo>
                        <a:pt x="513" y="143"/>
                      </a:lnTo>
                      <a:lnTo>
                        <a:pt x="513" y="140"/>
                      </a:lnTo>
                      <a:lnTo>
                        <a:pt x="514" y="140"/>
                      </a:lnTo>
                      <a:lnTo>
                        <a:pt x="514" y="138"/>
                      </a:lnTo>
                      <a:lnTo>
                        <a:pt x="514" y="141"/>
                      </a:lnTo>
                      <a:lnTo>
                        <a:pt x="514" y="141"/>
                      </a:lnTo>
                      <a:lnTo>
                        <a:pt x="515" y="141"/>
                      </a:lnTo>
                      <a:lnTo>
                        <a:pt x="515" y="139"/>
                      </a:lnTo>
                      <a:lnTo>
                        <a:pt x="515" y="144"/>
                      </a:lnTo>
                      <a:lnTo>
                        <a:pt x="515" y="139"/>
                      </a:lnTo>
                      <a:lnTo>
                        <a:pt x="516" y="139"/>
                      </a:lnTo>
                      <a:lnTo>
                        <a:pt x="516" y="137"/>
                      </a:lnTo>
                      <a:lnTo>
                        <a:pt x="516" y="142"/>
                      </a:lnTo>
                      <a:lnTo>
                        <a:pt x="516" y="141"/>
                      </a:lnTo>
                      <a:lnTo>
                        <a:pt x="517" y="141"/>
                      </a:lnTo>
                      <a:lnTo>
                        <a:pt x="517" y="138"/>
                      </a:lnTo>
                      <a:lnTo>
                        <a:pt x="517" y="142"/>
                      </a:lnTo>
                      <a:lnTo>
                        <a:pt x="517" y="141"/>
                      </a:lnTo>
                      <a:lnTo>
                        <a:pt x="518" y="141"/>
                      </a:lnTo>
                      <a:lnTo>
                        <a:pt x="518" y="137"/>
                      </a:lnTo>
                      <a:lnTo>
                        <a:pt x="518" y="142"/>
                      </a:lnTo>
                      <a:lnTo>
                        <a:pt x="518" y="140"/>
                      </a:lnTo>
                      <a:lnTo>
                        <a:pt x="519" y="140"/>
                      </a:lnTo>
                      <a:lnTo>
                        <a:pt x="519" y="136"/>
                      </a:lnTo>
                      <a:lnTo>
                        <a:pt x="519" y="141"/>
                      </a:lnTo>
                      <a:lnTo>
                        <a:pt x="519" y="141"/>
                      </a:lnTo>
                      <a:lnTo>
                        <a:pt x="520" y="141"/>
                      </a:lnTo>
                      <a:lnTo>
                        <a:pt x="520" y="137"/>
                      </a:lnTo>
                      <a:lnTo>
                        <a:pt x="520" y="140"/>
                      </a:lnTo>
                      <a:lnTo>
                        <a:pt x="520" y="138"/>
                      </a:lnTo>
                      <a:lnTo>
                        <a:pt x="521" y="138"/>
                      </a:lnTo>
                      <a:lnTo>
                        <a:pt x="521" y="133"/>
                      </a:lnTo>
                      <a:lnTo>
                        <a:pt x="521" y="138"/>
                      </a:lnTo>
                      <a:lnTo>
                        <a:pt x="521" y="133"/>
                      </a:lnTo>
                      <a:lnTo>
                        <a:pt x="522" y="133"/>
                      </a:lnTo>
                      <a:lnTo>
                        <a:pt x="522" y="133"/>
                      </a:lnTo>
                      <a:lnTo>
                        <a:pt x="522" y="136"/>
                      </a:lnTo>
                      <a:lnTo>
                        <a:pt x="522" y="135"/>
                      </a:lnTo>
                      <a:lnTo>
                        <a:pt x="523" y="135"/>
                      </a:lnTo>
                      <a:lnTo>
                        <a:pt x="523" y="132"/>
                      </a:lnTo>
                      <a:lnTo>
                        <a:pt x="523" y="137"/>
                      </a:lnTo>
                      <a:lnTo>
                        <a:pt x="523" y="133"/>
                      </a:lnTo>
                      <a:lnTo>
                        <a:pt x="524" y="133"/>
                      </a:lnTo>
                      <a:lnTo>
                        <a:pt x="524" y="131"/>
                      </a:lnTo>
                      <a:lnTo>
                        <a:pt x="524" y="134"/>
                      </a:lnTo>
                      <a:lnTo>
                        <a:pt x="524" y="133"/>
                      </a:lnTo>
                      <a:lnTo>
                        <a:pt x="525" y="133"/>
                      </a:lnTo>
                      <a:lnTo>
                        <a:pt x="525" y="130"/>
                      </a:lnTo>
                      <a:lnTo>
                        <a:pt x="525" y="133"/>
                      </a:lnTo>
                      <a:lnTo>
                        <a:pt x="525" y="130"/>
                      </a:lnTo>
                      <a:lnTo>
                        <a:pt x="526" y="130"/>
                      </a:lnTo>
                      <a:lnTo>
                        <a:pt x="526" y="128"/>
                      </a:lnTo>
                      <a:lnTo>
                        <a:pt x="526" y="133"/>
                      </a:lnTo>
                      <a:lnTo>
                        <a:pt x="526" y="129"/>
                      </a:lnTo>
                      <a:lnTo>
                        <a:pt x="527" y="129"/>
                      </a:lnTo>
                      <a:lnTo>
                        <a:pt x="527" y="126"/>
                      </a:lnTo>
                      <a:lnTo>
                        <a:pt x="527" y="129"/>
                      </a:lnTo>
                      <a:lnTo>
                        <a:pt x="527" y="127"/>
                      </a:lnTo>
                      <a:lnTo>
                        <a:pt x="528" y="127"/>
                      </a:lnTo>
                      <a:lnTo>
                        <a:pt x="528" y="126"/>
                      </a:lnTo>
                      <a:lnTo>
                        <a:pt x="528" y="129"/>
                      </a:lnTo>
                      <a:lnTo>
                        <a:pt x="528" y="126"/>
                      </a:lnTo>
                      <a:lnTo>
                        <a:pt x="529" y="126"/>
                      </a:lnTo>
                      <a:lnTo>
                        <a:pt x="529" y="123"/>
                      </a:lnTo>
                      <a:lnTo>
                        <a:pt x="529" y="127"/>
                      </a:lnTo>
                      <a:lnTo>
                        <a:pt x="529" y="125"/>
                      </a:lnTo>
                      <a:lnTo>
                        <a:pt x="530" y="125"/>
                      </a:lnTo>
                      <a:lnTo>
                        <a:pt x="530" y="121"/>
                      </a:lnTo>
                      <a:lnTo>
                        <a:pt x="530" y="125"/>
                      </a:lnTo>
                      <a:lnTo>
                        <a:pt x="530" y="122"/>
                      </a:lnTo>
                      <a:lnTo>
                        <a:pt x="531" y="122"/>
                      </a:lnTo>
                      <a:lnTo>
                        <a:pt x="531" y="119"/>
                      </a:lnTo>
                      <a:lnTo>
                        <a:pt x="531" y="124"/>
                      </a:lnTo>
                      <a:lnTo>
                        <a:pt x="531" y="119"/>
                      </a:lnTo>
                      <a:lnTo>
                        <a:pt x="532" y="119"/>
                      </a:lnTo>
                      <a:lnTo>
                        <a:pt x="532" y="118"/>
                      </a:lnTo>
                      <a:lnTo>
                        <a:pt x="532" y="122"/>
                      </a:lnTo>
                      <a:lnTo>
                        <a:pt x="532" y="119"/>
                      </a:lnTo>
                      <a:lnTo>
                        <a:pt x="533" y="119"/>
                      </a:lnTo>
                      <a:lnTo>
                        <a:pt x="533" y="116"/>
                      </a:lnTo>
                      <a:lnTo>
                        <a:pt x="533" y="120"/>
                      </a:lnTo>
                      <a:lnTo>
                        <a:pt x="533" y="116"/>
                      </a:lnTo>
                      <a:lnTo>
                        <a:pt x="534" y="116"/>
                      </a:lnTo>
                      <a:lnTo>
                        <a:pt x="534" y="113"/>
                      </a:lnTo>
                      <a:lnTo>
                        <a:pt x="534" y="117"/>
                      </a:lnTo>
                      <a:lnTo>
                        <a:pt x="534" y="114"/>
                      </a:lnTo>
                      <a:lnTo>
                        <a:pt x="535" y="114"/>
                      </a:lnTo>
                      <a:lnTo>
                        <a:pt x="535" y="113"/>
                      </a:lnTo>
                      <a:lnTo>
                        <a:pt x="535" y="117"/>
                      </a:lnTo>
                      <a:lnTo>
                        <a:pt x="535" y="113"/>
                      </a:lnTo>
                      <a:lnTo>
                        <a:pt x="536" y="113"/>
                      </a:lnTo>
                      <a:lnTo>
                        <a:pt x="536" y="108"/>
                      </a:lnTo>
                      <a:lnTo>
                        <a:pt x="536" y="114"/>
                      </a:lnTo>
                      <a:lnTo>
                        <a:pt x="536" y="110"/>
                      </a:lnTo>
                      <a:lnTo>
                        <a:pt x="537" y="110"/>
                      </a:lnTo>
                      <a:lnTo>
                        <a:pt x="537" y="107"/>
                      </a:lnTo>
                      <a:lnTo>
                        <a:pt x="537" y="111"/>
                      </a:lnTo>
                      <a:lnTo>
                        <a:pt x="537" y="108"/>
                      </a:lnTo>
                      <a:lnTo>
                        <a:pt x="538" y="108"/>
                      </a:lnTo>
                      <a:lnTo>
                        <a:pt x="538" y="105"/>
                      </a:lnTo>
                      <a:lnTo>
                        <a:pt x="538" y="110"/>
                      </a:lnTo>
                      <a:lnTo>
                        <a:pt x="538" y="105"/>
                      </a:lnTo>
                      <a:lnTo>
                        <a:pt x="539" y="105"/>
                      </a:lnTo>
                      <a:lnTo>
                        <a:pt x="539" y="104"/>
                      </a:lnTo>
                      <a:lnTo>
                        <a:pt x="539" y="108"/>
                      </a:lnTo>
                      <a:lnTo>
                        <a:pt x="539" y="104"/>
                      </a:lnTo>
                      <a:lnTo>
                        <a:pt x="540" y="104"/>
                      </a:lnTo>
                      <a:lnTo>
                        <a:pt x="540" y="103"/>
                      </a:lnTo>
                      <a:lnTo>
                        <a:pt x="540" y="106"/>
                      </a:lnTo>
                      <a:lnTo>
                        <a:pt x="540" y="104"/>
                      </a:lnTo>
                      <a:lnTo>
                        <a:pt x="541" y="104"/>
                      </a:lnTo>
                      <a:lnTo>
                        <a:pt x="541" y="101"/>
                      </a:lnTo>
                      <a:lnTo>
                        <a:pt x="541" y="104"/>
                      </a:lnTo>
                      <a:lnTo>
                        <a:pt x="541" y="101"/>
                      </a:lnTo>
                      <a:lnTo>
                        <a:pt x="542" y="101"/>
                      </a:lnTo>
                      <a:lnTo>
                        <a:pt x="542" y="100"/>
                      </a:lnTo>
                      <a:lnTo>
                        <a:pt x="542" y="103"/>
                      </a:lnTo>
                      <a:lnTo>
                        <a:pt x="542" y="100"/>
                      </a:lnTo>
                      <a:lnTo>
                        <a:pt x="543" y="100"/>
                      </a:lnTo>
                      <a:lnTo>
                        <a:pt x="543" y="100"/>
                      </a:lnTo>
                      <a:lnTo>
                        <a:pt x="543" y="103"/>
                      </a:lnTo>
                      <a:lnTo>
                        <a:pt x="543" y="100"/>
                      </a:lnTo>
                      <a:lnTo>
                        <a:pt x="544" y="100"/>
                      </a:lnTo>
                      <a:lnTo>
                        <a:pt x="544" y="96"/>
                      </a:lnTo>
                      <a:lnTo>
                        <a:pt x="544" y="101"/>
                      </a:lnTo>
                      <a:lnTo>
                        <a:pt x="544" y="98"/>
                      </a:lnTo>
                      <a:lnTo>
                        <a:pt x="545" y="98"/>
                      </a:lnTo>
                      <a:lnTo>
                        <a:pt x="545" y="97"/>
                      </a:lnTo>
                      <a:lnTo>
                        <a:pt x="545" y="100"/>
                      </a:lnTo>
                      <a:lnTo>
                        <a:pt x="545" y="98"/>
                      </a:lnTo>
                      <a:lnTo>
                        <a:pt x="546" y="98"/>
                      </a:lnTo>
                      <a:lnTo>
                        <a:pt x="546" y="95"/>
                      </a:lnTo>
                      <a:lnTo>
                        <a:pt x="546" y="101"/>
                      </a:lnTo>
                      <a:lnTo>
                        <a:pt x="546" y="97"/>
                      </a:lnTo>
                      <a:lnTo>
                        <a:pt x="547" y="97"/>
                      </a:lnTo>
                      <a:lnTo>
                        <a:pt x="547" y="94"/>
                      </a:lnTo>
                      <a:lnTo>
                        <a:pt x="547" y="98"/>
                      </a:lnTo>
                      <a:lnTo>
                        <a:pt x="547" y="96"/>
                      </a:lnTo>
                      <a:lnTo>
                        <a:pt x="548" y="96"/>
                      </a:lnTo>
                      <a:lnTo>
                        <a:pt x="548" y="94"/>
                      </a:lnTo>
                      <a:lnTo>
                        <a:pt x="548" y="97"/>
                      </a:lnTo>
                      <a:lnTo>
                        <a:pt x="548" y="96"/>
                      </a:lnTo>
                      <a:lnTo>
                        <a:pt x="549" y="96"/>
                      </a:lnTo>
                      <a:lnTo>
                        <a:pt x="549" y="92"/>
                      </a:lnTo>
                      <a:lnTo>
                        <a:pt x="549" y="96"/>
                      </a:lnTo>
                      <a:lnTo>
                        <a:pt x="549" y="95"/>
                      </a:lnTo>
                      <a:lnTo>
                        <a:pt x="550" y="95"/>
                      </a:lnTo>
                      <a:lnTo>
                        <a:pt x="550" y="91"/>
                      </a:lnTo>
                      <a:lnTo>
                        <a:pt x="550" y="95"/>
                      </a:lnTo>
                      <a:lnTo>
                        <a:pt x="550" y="91"/>
                      </a:lnTo>
                      <a:lnTo>
                        <a:pt x="551" y="91"/>
                      </a:lnTo>
                      <a:lnTo>
                        <a:pt x="551" y="90"/>
                      </a:lnTo>
                      <a:lnTo>
                        <a:pt x="551" y="95"/>
                      </a:lnTo>
                      <a:lnTo>
                        <a:pt x="551" y="90"/>
                      </a:lnTo>
                      <a:lnTo>
                        <a:pt x="552" y="90"/>
                      </a:lnTo>
                      <a:lnTo>
                        <a:pt x="552" y="88"/>
                      </a:lnTo>
                      <a:lnTo>
                        <a:pt x="552" y="92"/>
                      </a:lnTo>
                      <a:lnTo>
                        <a:pt x="552" y="91"/>
                      </a:lnTo>
                      <a:lnTo>
                        <a:pt x="553" y="91"/>
                      </a:lnTo>
                      <a:lnTo>
                        <a:pt x="553" y="88"/>
                      </a:lnTo>
                      <a:lnTo>
                        <a:pt x="553" y="92"/>
                      </a:lnTo>
                      <a:lnTo>
                        <a:pt x="553" y="89"/>
                      </a:lnTo>
                      <a:lnTo>
                        <a:pt x="554" y="89"/>
                      </a:lnTo>
                      <a:lnTo>
                        <a:pt x="554" y="86"/>
                      </a:lnTo>
                      <a:lnTo>
                        <a:pt x="554" y="91"/>
                      </a:lnTo>
                      <a:lnTo>
                        <a:pt x="554" y="87"/>
                      </a:lnTo>
                      <a:lnTo>
                        <a:pt x="555" y="87"/>
                      </a:lnTo>
                      <a:lnTo>
                        <a:pt x="555" y="85"/>
                      </a:lnTo>
                      <a:lnTo>
                        <a:pt x="555" y="89"/>
                      </a:lnTo>
                      <a:lnTo>
                        <a:pt x="555" y="87"/>
                      </a:lnTo>
                      <a:lnTo>
                        <a:pt x="556" y="87"/>
                      </a:lnTo>
                      <a:lnTo>
                        <a:pt x="556" y="86"/>
                      </a:lnTo>
                      <a:lnTo>
                        <a:pt x="556" y="89"/>
                      </a:lnTo>
                      <a:lnTo>
                        <a:pt x="556" y="87"/>
                      </a:lnTo>
                      <a:lnTo>
                        <a:pt x="557" y="87"/>
                      </a:lnTo>
                      <a:lnTo>
                        <a:pt x="557" y="84"/>
                      </a:lnTo>
                      <a:lnTo>
                        <a:pt x="557" y="88"/>
                      </a:lnTo>
                      <a:lnTo>
                        <a:pt x="557" y="85"/>
                      </a:lnTo>
                      <a:lnTo>
                        <a:pt x="558" y="85"/>
                      </a:lnTo>
                      <a:lnTo>
                        <a:pt x="558" y="82"/>
                      </a:lnTo>
                      <a:lnTo>
                        <a:pt x="558" y="87"/>
                      </a:lnTo>
                      <a:lnTo>
                        <a:pt x="558" y="84"/>
                      </a:lnTo>
                      <a:lnTo>
                        <a:pt x="559" y="84"/>
                      </a:lnTo>
                      <a:lnTo>
                        <a:pt x="559" y="82"/>
                      </a:lnTo>
                      <a:lnTo>
                        <a:pt x="559" y="84"/>
                      </a:lnTo>
                      <a:lnTo>
                        <a:pt x="559" y="82"/>
                      </a:lnTo>
                      <a:lnTo>
                        <a:pt x="560" y="82"/>
                      </a:lnTo>
                      <a:lnTo>
                        <a:pt x="560" y="82"/>
                      </a:lnTo>
                      <a:lnTo>
                        <a:pt x="560" y="85"/>
                      </a:lnTo>
                      <a:lnTo>
                        <a:pt x="560" y="82"/>
                      </a:lnTo>
                      <a:lnTo>
                        <a:pt x="561" y="82"/>
                      </a:lnTo>
                      <a:lnTo>
                        <a:pt x="561" y="80"/>
                      </a:lnTo>
                      <a:lnTo>
                        <a:pt x="561" y="85"/>
                      </a:lnTo>
                      <a:lnTo>
                        <a:pt x="561" y="81"/>
                      </a:lnTo>
                      <a:lnTo>
                        <a:pt x="562" y="81"/>
                      </a:lnTo>
                      <a:lnTo>
                        <a:pt x="562" y="80"/>
                      </a:lnTo>
                      <a:lnTo>
                        <a:pt x="562" y="82"/>
                      </a:lnTo>
                      <a:lnTo>
                        <a:pt x="562" y="81"/>
                      </a:lnTo>
                      <a:lnTo>
                        <a:pt x="563" y="81"/>
                      </a:lnTo>
                      <a:lnTo>
                        <a:pt x="563" y="80"/>
                      </a:lnTo>
                      <a:lnTo>
                        <a:pt x="563" y="82"/>
                      </a:lnTo>
                      <a:lnTo>
                        <a:pt x="563" y="81"/>
                      </a:lnTo>
                      <a:lnTo>
                        <a:pt x="564" y="81"/>
                      </a:lnTo>
                      <a:lnTo>
                        <a:pt x="564" y="77"/>
                      </a:lnTo>
                      <a:lnTo>
                        <a:pt x="564" y="81"/>
                      </a:lnTo>
                      <a:lnTo>
                        <a:pt x="564" y="81"/>
                      </a:lnTo>
                      <a:lnTo>
                        <a:pt x="565" y="81"/>
                      </a:lnTo>
                      <a:lnTo>
                        <a:pt x="565" y="78"/>
                      </a:lnTo>
                      <a:lnTo>
                        <a:pt x="565" y="82"/>
                      </a:lnTo>
                      <a:lnTo>
                        <a:pt x="565" y="78"/>
                      </a:lnTo>
                      <a:lnTo>
                        <a:pt x="566" y="78"/>
                      </a:lnTo>
                      <a:lnTo>
                        <a:pt x="566" y="75"/>
                      </a:lnTo>
                      <a:lnTo>
                        <a:pt x="566" y="78"/>
                      </a:lnTo>
                      <a:lnTo>
                        <a:pt x="566" y="76"/>
                      </a:lnTo>
                      <a:lnTo>
                        <a:pt x="567" y="76"/>
                      </a:lnTo>
                      <a:lnTo>
                        <a:pt x="567" y="75"/>
                      </a:lnTo>
                      <a:lnTo>
                        <a:pt x="567" y="78"/>
                      </a:lnTo>
                      <a:lnTo>
                        <a:pt x="567" y="76"/>
                      </a:lnTo>
                      <a:lnTo>
                        <a:pt x="568" y="76"/>
                      </a:lnTo>
                      <a:lnTo>
                        <a:pt x="568" y="73"/>
                      </a:lnTo>
                      <a:lnTo>
                        <a:pt x="568" y="78"/>
                      </a:lnTo>
                      <a:lnTo>
                        <a:pt x="568" y="74"/>
                      </a:lnTo>
                      <a:lnTo>
                        <a:pt x="569" y="74"/>
                      </a:lnTo>
                      <a:lnTo>
                        <a:pt x="569" y="72"/>
                      </a:lnTo>
                      <a:lnTo>
                        <a:pt x="569" y="75"/>
                      </a:lnTo>
                      <a:lnTo>
                        <a:pt x="569" y="73"/>
                      </a:lnTo>
                      <a:lnTo>
                        <a:pt x="570" y="73"/>
                      </a:lnTo>
                      <a:lnTo>
                        <a:pt x="570" y="72"/>
                      </a:lnTo>
                      <a:lnTo>
                        <a:pt x="570" y="76"/>
                      </a:lnTo>
                      <a:lnTo>
                        <a:pt x="570" y="73"/>
                      </a:lnTo>
                      <a:lnTo>
                        <a:pt x="571" y="73"/>
                      </a:lnTo>
                      <a:lnTo>
                        <a:pt x="571" y="72"/>
                      </a:lnTo>
                      <a:lnTo>
                        <a:pt x="571" y="76"/>
                      </a:lnTo>
                      <a:lnTo>
                        <a:pt x="571" y="72"/>
                      </a:lnTo>
                      <a:lnTo>
                        <a:pt x="572" y="72"/>
                      </a:lnTo>
                      <a:lnTo>
                        <a:pt x="572" y="70"/>
                      </a:lnTo>
                      <a:lnTo>
                        <a:pt x="572" y="74"/>
                      </a:lnTo>
                      <a:lnTo>
                        <a:pt x="572" y="72"/>
                      </a:lnTo>
                      <a:lnTo>
                        <a:pt x="573" y="72"/>
                      </a:lnTo>
                      <a:lnTo>
                        <a:pt x="573" y="70"/>
                      </a:lnTo>
                      <a:lnTo>
                        <a:pt x="573" y="73"/>
                      </a:lnTo>
                      <a:lnTo>
                        <a:pt x="573" y="72"/>
                      </a:lnTo>
                      <a:lnTo>
                        <a:pt x="574" y="72"/>
                      </a:lnTo>
                      <a:lnTo>
                        <a:pt x="574" y="67"/>
                      </a:lnTo>
                      <a:lnTo>
                        <a:pt x="574" y="73"/>
                      </a:lnTo>
                      <a:lnTo>
                        <a:pt x="574" y="71"/>
                      </a:lnTo>
                      <a:lnTo>
                        <a:pt x="575" y="71"/>
                      </a:lnTo>
                      <a:lnTo>
                        <a:pt x="575" y="69"/>
                      </a:lnTo>
                      <a:lnTo>
                        <a:pt x="575" y="73"/>
                      </a:lnTo>
                      <a:lnTo>
                        <a:pt x="575" y="70"/>
                      </a:lnTo>
                      <a:lnTo>
                        <a:pt x="576" y="70"/>
                      </a:lnTo>
                      <a:lnTo>
                        <a:pt x="576" y="68"/>
                      </a:lnTo>
                      <a:lnTo>
                        <a:pt x="576" y="72"/>
                      </a:lnTo>
                      <a:lnTo>
                        <a:pt x="576" y="69"/>
                      </a:lnTo>
                      <a:lnTo>
                        <a:pt x="577" y="69"/>
                      </a:lnTo>
                      <a:lnTo>
                        <a:pt x="577" y="66"/>
                      </a:lnTo>
                      <a:lnTo>
                        <a:pt x="577" y="70"/>
                      </a:lnTo>
                      <a:lnTo>
                        <a:pt x="577" y="66"/>
                      </a:lnTo>
                      <a:lnTo>
                        <a:pt x="578" y="66"/>
                      </a:lnTo>
                      <a:lnTo>
                        <a:pt x="578" y="66"/>
                      </a:lnTo>
                      <a:lnTo>
                        <a:pt x="578" y="69"/>
                      </a:lnTo>
                      <a:lnTo>
                        <a:pt x="578" y="67"/>
                      </a:lnTo>
                      <a:lnTo>
                        <a:pt x="579" y="67"/>
                      </a:lnTo>
                      <a:lnTo>
                        <a:pt x="579" y="65"/>
                      </a:lnTo>
                      <a:lnTo>
                        <a:pt x="579" y="67"/>
                      </a:lnTo>
                      <a:lnTo>
                        <a:pt x="579" y="65"/>
                      </a:lnTo>
                      <a:lnTo>
                        <a:pt x="580" y="65"/>
                      </a:lnTo>
                      <a:lnTo>
                        <a:pt x="580" y="63"/>
                      </a:lnTo>
                      <a:lnTo>
                        <a:pt x="580" y="67"/>
                      </a:lnTo>
                      <a:lnTo>
                        <a:pt x="580" y="65"/>
                      </a:lnTo>
                      <a:lnTo>
                        <a:pt x="581" y="65"/>
                      </a:lnTo>
                      <a:lnTo>
                        <a:pt x="581" y="62"/>
                      </a:lnTo>
                      <a:lnTo>
                        <a:pt x="581" y="66"/>
                      </a:lnTo>
                      <a:lnTo>
                        <a:pt x="581" y="62"/>
                      </a:lnTo>
                      <a:lnTo>
                        <a:pt x="582" y="62"/>
                      </a:lnTo>
                      <a:lnTo>
                        <a:pt x="582" y="62"/>
                      </a:lnTo>
                      <a:lnTo>
                        <a:pt x="582" y="65"/>
                      </a:lnTo>
                      <a:lnTo>
                        <a:pt x="582" y="65"/>
                      </a:lnTo>
                      <a:lnTo>
                        <a:pt x="583" y="65"/>
                      </a:lnTo>
                      <a:lnTo>
                        <a:pt x="583" y="60"/>
                      </a:lnTo>
                      <a:lnTo>
                        <a:pt x="583" y="66"/>
                      </a:lnTo>
                      <a:lnTo>
                        <a:pt x="583" y="60"/>
                      </a:lnTo>
                      <a:lnTo>
                        <a:pt x="584" y="60"/>
                      </a:lnTo>
                      <a:lnTo>
                        <a:pt x="584" y="59"/>
                      </a:lnTo>
                      <a:lnTo>
                        <a:pt x="584" y="62"/>
                      </a:lnTo>
                      <a:lnTo>
                        <a:pt x="584" y="59"/>
                      </a:lnTo>
                      <a:lnTo>
                        <a:pt x="585" y="59"/>
                      </a:lnTo>
                      <a:lnTo>
                        <a:pt x="585" y="59"/>
                      </a:lnTo>
                      <a:lnTo>
                        <a:pt x="585" y="62"/>
                      </a:lnTo>
                      <a:lnTo>
                        <a:pt x="585" y="60"/>
                      </a:lnTo>
                      <a:lnTo>
                        <a:pt x="586" y="60"/>
                      </a:lnTo>
                      <a:lnTo>
                        <a:pt x="586" y="57"/>
                      </a:lnTo>
                      <a:lnTo>
                        <a:pt x="586" y="60"/>
                      </a:lnTo>
                      <a:lnTo>
                        <a:pt x="586" y="59"/>
                      </a:lnTo>
                      <a:lnTo>
                        <a:pt x="587" y="59"/>
                      </a:lnTo>
                      <a:lnTo>
                        <a:pt x="587" y="56"/>
                      </a:lnTo>
                      <a:lnTo>
                        <a:pt x="587" y="60"/>
                      </a:lnTo>
                      <a:lnTo>
                        <a:pt x="587" y="56"/>
                      </a:lnTo>
                      <a:lnTo>
                        <a:pt x="588" y="56"/>
                      </a:lnTo>
                      <a:lnTo>
                        <a:pt x="588" y="55"/>
                      </a:lnTo>
                      <a:lnTo>
                        <a:pt x="588" y="61"/>
                      </a:lnTo>
                      <a:lnTo>
                        <a:pt x="588" y="56"/>
                      </a:lnTo>
                      <a:lnTo>
                        <a:pt x="589" y="56"/>
                      </a:lnTo>
                      <a:lnTo>
                        <a:pt x="589" y="53"/>
                      </a:lnTo>
                      <a:lnTo>
                        <a:pt x="589" y="58"/>
                      </a:lnTo>
                      <a:lnTo>
                        <a:pt x="589" y="54"/>
                      </a:lnTo>
                      <a:lnTo>
                        <a:pt x="590" y="54"/>
                      </a:lnTo>
                      <a:lnTo>
                        <a:pt x="590" y="53"/>
                      </a:lnTo>
                      <a:lnTo>
                        <a:pt x="590" y="56"/>
                      </a:lnTo>
                      <a:lnTo>
                        <a:pt x="590" y="54"/>
                      </a:lnTo>
                      <a:lnTo>
                        <a:pt x="591" y="54"/>
                      </a:lnTo>
                      <a:lnTo>
                        <a:pt x="591" y="53"/>
                      </a:lnTo>
                      <a:lnTo>
                        <a:pt x="591" y="56"/>
                      </a:lnTo>
                      <a:lnTo>
                        <a:pt x="591" y="54"/>
                      </a:lnTo>
                      <a:lnTo>
                        <a:pt x="592" y="54"/>
                      </a:lnTo>
                      <a:lnTo>
                        <a:pt x="592" y="50"/>
                      </a:lnTo>
                      <a:lnTo>
                        <a:pt x="592" y="56"/>
                      </a:lnTo>
                      <a:lnTo>
                        <a:pt x="592" y="53"/>
                      </a:lnTo>
                      <a:lnTo>
                        <a:pt x="593" y="53"/>
                      </a:lnTo>
                      <a:lnTo>
                        <a:pt x="593" y="49"/>
                      </a:lnTo>
                      <a:lnTo>
                        <a:pt x="593" y="54"/>
                      </a:lnTo>
                      <a:lnTo>
                        <a:pt x="593" y="49"/>
                      </a:lnTo>
                      <a:lnTo>
                        <a:pt x="594" y="49"/>
                      </a:lnTo>
                      <a:lnTo>
                        <a:pt x="594" y="48"/>
                      </a:lnTo>
                      <a:lnTo>
                        <a:pt x="594" y="51"/>
                      </a:lnTo>
                      <a:lnTo>
                        <a:pt x="594" y="50"/>
                      </a:lnTo>
                      <a:lnTo>
                        <a:pt x="595" y="50"/>
                      </a:lnTo>
                      <a:lnTo>
                        <a:pt x="595" y="47"/>
                      </a:lnTo>
                      <a:lnTo>
                        <a:pt x="595" y="51"/>
                      </a:lnTo>
                      <a:lnTo>
                        <a:pt x="595" y="51"/>
                      </a:lnTo>
                      <a:lnTo>
                        <a:pt x="596" y="51"/>
                      </a:lnTo>
                      <a:lnTo>
                        <a:pt x="596" y="47"/>
                      </a:lnTo>
                      <a:lnTo>
                        <a:pt x="596" y="51"/>
                      </a:lnTo>
                      <a:lnTo>
                        <a:pt x="596" y="49"/>
                      </a:lnTo>
                      <a:lnTo>
                        <a:pt x="597" y="49"/>
                      </a:lnTo>
                      <a:lnTo>
                        <a:pt x="597" y="46"/>
                      </a:lnTo>
                      <a:lnTo>
                        <a:pt x="597" y="50"/>
                      </a:lnTo>
                      <a:lnTo>
                        <a:pt x="597" y="47"/>
                      </a:lnTo>
                      <a:lnTo>
                        <a:pt x="598" y="47"/>
                      </a:lnTo>
                      <a:lnTo>
                        <a:pt x="598" y="46"/>
                      </a:lnTo>
                      <a:lnTo>
                        <a:pt x="598" y="50"/>
                      </a:lnTo>
                      <a:lnTo>
                        <a:pt x="598" y="47"/>
                      </a:lnTo>
                      <a:lnTo>
                        <a:pt x="599" y="47"/>
                      </a:lnTo>
                      <a:lnTo>
                        <a:pt x="599" y="44"/>
                      </a:lnTo>
                      <a:lnTo>
                        <a:pt x="599" y="50"/>
                      </a:lnTo>
                      <a:lnTo>
                        <a:pt x="599" y="44"/>
                      </a:lnTo>
                      <a:lnTo>
                        <a:pt x="600" y="44"/>
                      </a:lnTo>
                      <a:lnTo>
                        <a:pt x="600" y="44"/>
                      </a:lnTo>
                      <a:lnTo>
                        <a:pt x="600" y="50"/>
                      </a:lnTo>
                      <a:lnTo>
                        <a:pt x="600" y="46"/>
                      </a:lnTo>
                      <a:lnTo>
                        <a:pt x="601" y="46"/>
                      </a:lnTo>
                      <a:lnTo>
                        <a:pt x="601" y="43"/>
                      </a:lnTo>
                      <a:lnTo>
                        <a:pt x="601" y="47"/>
                      </a:lnTo>
                      <a:lnTo>
                        <a:pt x="601" y="44"/>
                      </a:lnTo>
                      <a:lnTo>
                        <a:pt x="602" y="44"/>
                      </a:lnTo>
                      <a:lnTo>
                        <a:pt x="602" y="43"/>
                      </a:lnTo>
                      <a:lnTo>
                        <a:pt x="602" y="46"/>
                      </a:lnTo>
                      <a:lnTo>
                        <a:pt x="602" y="44"/>
                      </a:lnTo>
                      <a:lnTo>
                        <a:pt x="603" y="44"/>
                      </a:lnTo>
                      <a:lnTo>
                        <a:pt x="603" y="40"/>
                      </a:lnTo>
                      <a:lnTo>
                        <a:pt x="603" y="44"/>
                      </a:lnTo>
                      <a:lnTo>
                        <a:pt x="603" y="43"/>
                      </a:lnTo>
                      <a:lnTo>
                        <a:pt x="604" y="43"/>
                      </a:lnTo>
                      <a:lnTo>
                        <a:pt x="604" y="40"/>
                      </a:lnTo>
                      <a:lnTo>
                        <a:pt x="604" y="43"/>
                      </a:lnTo>
                      <a:lnTo>
                        <a:pt x="604" y="41"/>
                      </a:lnTo>
                      <a:lnTo>
                        <a:pt x="605" y="41"/>
                      </a:lnTo>
                      <a:lnTo>
                        <a:pt x="605" y="39"/>
                      </a:lnTo>
                      <a:lnTo>
                        <a:pt x="605" y="43"/>
                      </a:lnTo>
                      <a:lnTo>
                        <a:pt x="605" y="40"/>
                      </a:lnTo>
                      <a:lnTo>
                        <a:pt x="606" y="40"/>
                      </a:lnTo>
                      <a:lnTo>
                        <a:pt x="606" y="38"/>
                      </a:lnTo>
                      <a:lnTo>
                        <a:pt x="606" y="43"/>
                      </a:lnTo>
                      <a:lnTo>
                        <a:pt x="606" y="38"/>
                      </a:lnTo>
                      <a:lnTo>
                        <a:pt x="607" y="38"/>
                      </a:lnTo>
                      <a:lnTo>
                        <a:pt x="607" y="37"/>
                      </a:lnTo>
                      <a:lnTo>
                        <a:pt x="607" y="41"/>
                      </a:lnTo>
                      <a:lnTo>
                        <a:pt x="607" y="38"/>
                      </a:lnTo>
                      <a:lnTo>
                        <a:pt x="608" y="38"/>
                      </a:lnTo>
                      <a:lnTo>
                        <a:pt x="608" y="35"/>
                      </a:lnTo>
                      <a:lnTo>
                        <a:pt x="608" y="40"/>
                      </a:lnTo>
                      <a:lnTo>
                        <a:pt x="608" y="38"/>
                      </a:lnTo>
                      <a:lnTo>
                        <a:pt x="609" y="38"/>
                      </a:lnTo>
                      <a:lnTo>
                        <a:pt x="609" y="35"/>
                      </a:lnTo>
                      <a:lnTo>
                        <a:pt x="609" y="38"/>
                      </a:lnTo>
                      <a:lnTo>
                        <a:pt x="609" y="37"/>
                      </a:lnTo>
                      <a:lnTo>
                        <a:pt x="610" y="37"/>
                      </a:lnTo>
                      <a:lnTo>
                        <a:pt x="610" y="34"/>
                      </a:lnTo>
                      <a:lnTo>
                        <a:pt x="610" y="37"/>
                      </a:lnTo>
                      <a:lnTo>
                        <a:pt x="610" y="34"/>
                      </a:lnTo>
                      <a:lnTo>
                        <a:pt x="611" y="34"/>
                      </a:lnTo>
                      <a:lnTo>
                        <a:pt x="611" y="32"/>
                      </a:lnTo>
                      <a:lnTo>
                        <a:pt x="611" y="37"/>
                      </a:lnTo>
                      <a:lnTo>
                        <a:pt x="611" y="34"/>
                      </a:lnTo>
                      <a:lnTo>
                        <a:pt x="612" y="34"/>
                      </a:lnTo>
                      <a:lnTo>
                        <a:pt x="612" y="31"/>
                      </a:lnTo>
                      <a:lnTo>
                        <a:pt x="612" y="38"/>
                      </a:lnTo>
                      <a:lnTo>
                        <a:pt x="612" y="33"/>
                      </a:lnTo>
                      <a:lnTo>
                        <a:pt x="613" y="33"/>
                      </a:lnTo>
                      <a:lnTo>
                        <a:pt x="613" y="31"/>
                      </a:lnTo>
                      <a:lnTo>
                        <a:pt x="613" y="34"/>
                      </a:lnTo>
                      <a:lnTo>
                        <a:pt x="613" y="32"/>
                      </a:lnTo>
                      <a:lnTo>
                        <a:pt x="614" y="32"/>
                      </a:lnTo>
                      <a:lnTo>
                        <a:pt x="614" y="29"/>
                      </a:lnTo>
                      <a:lnTo>
                        <a:pt x="614" y="33"/>
                      </a:lnTo>
                      <a:lnTo>
                        <a:pt x="614" y="30"/>
                      </a:lnTo>
                      <a:lnTo>
                        <a:pt x="615" y="30"/>
                      </a:lnTo>
                      <a:lnTo>
                        <a:pt x="615" y="28"/>
                      </a:lnTo>
                      <a:lnTo>
                        <a:pt x="615" y="32"/>
                      </a:lnTo>
                      <a:lnTo>
                        <a:pt x="615" y="32"/>
                      </a:lnTo>
                      <a:lnTo>
                        <a:pt x="616" y="32"/>
                      </a:lnTo>
                      <a:lnTo>
                        <a:pt x="616" y="29"/>
                      </a:lnTo>
                      <a:lnTo>
                        <a:pt x="616" y="32"/>
                      </a:lnTo>
                      <a:lnTo>
                        <a:pt x="616" y="30"/>
                      </a:lnTo>
                      <a:lnTo>
                        <a:pt x="617" y="30"/>
                      </a:lnTo>
                      <a:lnTo>
                        <a:pt x="617" y="29"/>
                      </a:lnTo>
                      <a:lnTo>
                        <a:pt x="617" y="32"/>
                      </a:lnTo>
                      <a:lnTo>
                        <a:pt x="617" y="29"/>
                      </a:lnTo>
                      <a:lnTo>
                        <a:pt x="618" y="29"/>
                      </a:lnTo>
                      <a:lnTo>
                        <a:pt x="618" y="28"/>
                      </a:lnTo>
                      <a:lnTo>
                        <a:pt x="618" y="30"/>
                      </a:lnTo>
                      <a:lnTo>
                        <a:pt x="618" y="28"/>
                      </a:lnTo>
                      <a:lnTo>
                        <a:pt x="619" y="28"/>
                      </a:lnTo>
                      <a:lnTo>
                        <a:pt x="619" y="27"/>
                      </a:lnTo>
                      <a:lnTo>
                        <a:pt x="619" y="29"/>
                      </a:lnTo>
                      <a:lnTo>
                        <a:pt x="619" y="27"/>
                      </a:lnTo>
                      <a:lnTo>
                        <a:pt x="620" y="27"/>
                      </a:lnTo>
                      <a:lnTo>
                        <a:pt x="620" y="26"/>
                      </a:lnTo>
                      <a:lnTo>
                        <a:pt x="620" y="29"/>
                      </a:lnTo>
                      <a:lnTo>
                        <a:pt x="620" y="29"/>
                      </a:lnTo>
                      <a:lnTo>
                        <a:pt x="621" y="29"/>
                      </a:lnTo>
                      <a:lnTo>
                        <a:pt x="621" y="27"/>
                      </a:lnTo>
                      <a:lnTo>
                        <a:pt x="621" y="29"/>
                      </a:lnTo>
                      <a:lnTo>
                        <a:pt x="621" y="28"/>
                      </a:lnTo>
                      <a:lnTo>
                        <a:pt x="622" y="28"/>
                      </a:lnTo>
                      <a:lnTo>
                        <a:pt x="622" y="25"/>
                      </a:lnTo>
                      <a:lnTo>
                        <a:pt x="622" y="28"/>
                      </a:lnTo>
                      <a:lnTo>
                        <a:pt x="622" y="26"/>
                      </a:lnTo>
                      <a:lnTo>
                        <a:pt x="623" y="26"/>
                      </a:lnTo>
                      <a:lnTo>
                        <a:pt x="623" y="24"/>
                      </a:lnTo>
                      <a:lnTo>
                        <a:pt x="623" y="29"/>
                      </a:lnTo>
                      <a:lnTo>
                        <a:pt x="623" y="27"/>
                      </a:lnTo>
                      <a:lnTo>
                        <a:pt x="624" y="27"/>
                      </a:lnTo>
                      <a:lnTo>
                        <a:pt x="624" y="24"/>
                      </a:lnTo>
                      <a:lnTo>
                        <a:pt x="624" y="28"/>
                      </a:lnTo>
                      <a:lnTo>
                        <a:pt x="624" y="25"/>
                      </a:lnTo>
                      <a:lnTo>
                        <a:pt x="625" y="25"/>
                      </a:lnTo>
                      <a:lnTo>
                        <a:pt x="625" y="22"/>
                      </a:lnTo>
                      <a:lnTo>
                        <a:pt x="625" y="27"/>
                      </a:lnTo>
                      <a:lnTo>
                        <a:pt x="625" y="25"/>
                      </a:lnTo>
                      <a:lnTo>
                        <a:pt x="626" y="25"/>
                      </a:lnTo>
                      <a:lnTo>
                        <a:pt x="626" y="23"/>
                      </a:lnTo>
                      <a:lnTo>
                        <a:pt x="626" y="27"/>
                      </a:lnTo>
                      <a:lnTo>
                        <a:pt x="626" y="24"/>
                      </a:lnTo>
                      <a:lnTo>
                        <a:pt x="627" y="24"/>
                      </a:lnTo>
                      <a:lnTo>
                        <a:pt x="627" y="22"/>
                      </a:lnTo>
                      <a:lnTo>
                        <a:pt x="627" y="27"/>
                      </a:lnTo>
                      <a:lnTo>
                        <a:pt x="627" y="22"/>
                      </a:lnTo>
                      <a:lnTo>
                        <a:pt x="628" y="22"/>
                      </a:lnTo>
                      <a:lnTo>
                        <a:pt x="628" y="23"/>
                      </a:lnTo>
                      <a:lnTo>
                        <a:pt x="628" y="25"/>
                      </a:lnTo>
                      <a:lnTo>
                        <a:pt x="628" y="25"/>
                      </a:lnTo>
                      <a:lnTo>
                        <a:pt x="629" y="25"/>
                      </a:lnTo>
                      <a:lnTo>
                        <a:pt x="629" y="21"/>
                      </a:lnTo>
                      <a:lnTo>
                        <a:pt x="629" y="25"/>
                      </a:lnTo>
                      <a:lnTo>
                        <a:pt x="629" y="22"/>
                      </a:lnTo>
                      <a:lnTo>
                        <a:pt x="630" y="22"/>
                      </a:lnTo>
                      <a:lnTo>
                        <a:pt x="630" y="20"/>
                      </a:lnTo>
                      <a:lnTo>
                        <a:pt x="630" y="24"/>
                      </a:lnTo>
                      <a:lnTo>
                        <a:pt x="630" y="22"/>
                      </a:lnTo>
                      <a:lnTo>
                        <a:pt x="631" y="22"/>
                      </a:lnTo>
                      <a:lnTo>
                        <a:pt x="631" y="21"/>
                      </a:lnTo>
                      <a:lnTo>
                        <a:pt x="631" y="23"/>
                      </a:lnTo>
                      <a:lnTo>
                        <a:pt x="631" y="23"/>
                      </a:lnTo>
                      <a:lnTo>
                        <a:pt x="632" y="23"/>
                      </a:lnTo>
                      <a:lnTo>
                        <a:pt x="632" y="18"/>
                      </a:lnTo>
                      <a:lnTo>
                        <a:pt x="632" y="25"/>
                      </a:lnTo>
                      <a:lnTo>
                        <a:pt x="632" y="21"/>
                      </a:lnTo>
                      <a:lnTo>
                        <a:pt x="633" y="21"/>
                      </a:lnTo>
                      <a:lnTo>
                        <a:pt x="633" y="18"/>
                      </a:lnTo>
                      <a:lnTo>
                        <a:pt x="633" y="22"/>
                      </a:lnTo>
                      <a:lnTo>
                        <a:pt x="633" y="19"/>
                      </a:lnTo>
                      <a:lnTo>
                        <a:pt x="634" y="19"/>
                      </a:lnTo>
                      <a:lnTo>
                        <a:pt x="634" y="19"/>
                      </a:lnTo>
                      <a:lnTo>
                        <a:pt x="634" y="23"/>
                      </a:lnTo>
                      <a:lnTo>
                        <a:pt x="634" y="23"/>
                      </a:lnTo>
                      <a:lnTo>
                        <a:pt x="635" y="23"/>
                      </a:lnTo>
                      <a:lnTo>
                        <a:pt x="635" y="19"/>
                      </a:lnTo>
                      <a:lnTo>
                        <a:pt x="635" y="22"/>
                      </a:lnTo>
                      <a:lnTo>
                        <a:pt x="635" y="21"/>
                      </a:lnTo>
                      <a:lnTo>
                        <a:pt x="636" y="21"/>
                      </a:lnTo>
                      <a:lnTo>
                        <a:pt x="636" y="19"/>
                      </a:lnTo>
                      <a:lnTo>
                        <a:pt x="636" y="23"/>
                      </a:lnTo>
                      <a:lnTo>
                        <a:pt x="636" y="19"/>
                      </a:lnTo>
                      <a:lnTo>
                        <a:pt x="637" y="19"/>
                      </a:lnTo>
                      <a:lnTo>
                        <a:pt x="637" y="18"/>
                      </a:lnTo>
                      <a:lnTo>
                        <a:pt x="637" y="22"/>
                      </a:lnTo>
                      <a:lnTo>
                        <a:pt x="637" y="19"/>
                      </a:lnTo>
                      <a:lnTo>
                        <a:pt x="638" y="19"/>
                      </a:lnTo>
                      <a:lnTo>
                        <a:pt x="638" y="17"/>
                      </a:lnTo>
                      <a:lnTo>
                        <a:pt x="638" y="21"/>
                      </a:lnTo>
                      <a:lnTo>
                        <a:pt x="638" y="18"/>
                      </a:lnTo>
                      <a:lnTo>
                        <a:pt x="639" y="18"/>
                      </a:lnTo>
                      <a:lnTo>
                        <a:pt x="639" y="17"/>
                      </a:lnTo>
                      <a:lnTo>
                        <a:pt x="639" y="21"/>
                      </a:lnTo>
                      <a:lnTo>
                        <a:pt x="639" y="18"/>
                      </a:lnTo>
                      <a:lnTo>
                        <a:pt x="640" y="18"/>
                      </a:lnTo>
                      <a:lnTo>
                        <a:pt x="640" y="16"/>
                      </a:lnTo>
                      <a:lnTo>
                        <a:pt x="640" y="19"/>
                      </a:lnTo>
                      <a:lnTo>
                        <a:pt x="640" y="17"/>
                      </a:lnTo>
                      <a:lnTo>
                        <a:pt x="641" y="17"/>
                      </a:lnTo>
                      <a:lnTo>
                        <a:pt x="641" y="16"/>
                      </a:lnTo>
                      <a:lnTo>
                        <a:pt x="641" y="21"/>
                      </a:lnTo>
                      <a:lnTo>
                        <a:pt x="641" y="19"/>
                      </a:lnTo>
                      <a:lnTo>
                        <a:pt x="642" y="19"/>
                      </a:lnTo>
                      <a:lnTo>
                        <a:pt x="642" y="16"/>
                      </a:lnTo>
                      <a:lnTo>
                        <a:pt x="642" y="20"/>
                      </a:lnTo>
                      <a:lnTo>
                        <a:pt x="642" y="18"/>
                      </a:lnTo>
                      <a:lnTo>
                        <a:pt x="643" y="18"/>
                      </a:lnTo>
                      <a:lnTo>
                        <a:pt x="643" y="15"/>
                      </a:lnTo>
                      <a:lnTo>
                        <a:pt x="643" y="18"/>
                      </a:lnTo>
                      <a:lnTo>
                        <a:pt x="643" y="17"/>
                      </a:lnTo>
                      <a:lnTo>
                        <a:pt x="644" y="17"/>
                      </a:lnTo>
                      <a:lnTo>
                        <a:pt x="644" y="15"/>
                      </a:lnTo>
                      <a:lnTo>
                        <a:pt x="644" y="19"/>
                      </a:lnTo>
                      <a:lnTo>
                        <a:pt x="644" y="15"/>
                      </a:lnTo>
                      <a:lnTo>
                        <a:pt x="645" y="15"/>
                      </a:lnTo>
                      <a:lnTo>
                        <a:pt x="645" y="15"/>
                      </a:lnTo>
                      <a:lnTo>
                        <a:pt x="645" y="20"/>
                      </a:lnTo>
                      <a:lnTo>
                        <a:pt x="645" y="16"/>
                      </a:lnTo>
                      <a:lnTo>
                        <a:pt x="646" y="16"/>
                      </a:lnTo>
                      <a:lnTo>
                        <a:pt x="646" y="15"/>
                      </a:lnTo>
                      <a:lnTo>
                        <a:pt x="646" y="19"/>
                      </a:lnTo>
                      <a:lnTo>
                        <a:pt x="646" y="16"/>
                      </a:lnTo>
                      <a:lnTo>
                        <a:pt x="647" y="16"/>
                      </a:lnTo>
                      <a:lnTo>
                        <a:pt x="647" y="14"/>
                      </a:lnTo>
                      <a:lnTo>
                        <a:pt x="647" y="18"/>
                      </a:lnTo>
                      <a:lnTo>
                        <a:pt x="647" y="17"/>
                      </a:lnTo>
                      <a:lnTo>
                        <a:pt x="648" y="17"/>
                      </a:lnTo>
                      <a:lnTo>
                        <a:pt x="648" y="13"/>
                      </a:lnTo>
                      <a:lnTo>
                        <a:pt x="648" y="17"/>
                      </a:lnTo>
                      <a:lnTo>
                        <a:pt x="648" y="14"/>
                      </a:lnTo>
                      <a:lnTo>
                        <a:pt x="649" y="14"/>
                      </a:lnTo>
                      <a:lnTo>
                        <a:pt x="649" y="14"/>
                      </a:lnTo>
                      <a:lnTo>
                        <a:pt x="649" y="16"/>
                      </a:lnTo>
                      <a:lnTo>
                        <a:pt x="649" y="15"/>
                      </a:lnTo>
                      <a:lnTo>
                        <a:pt x="650" y="15"/>
                      </a:lnTo>
                      <a:lnTo>
                        <a:pt x="650" y="13"/>
                      </a:lnTo>
                      <a:lnTo>
                        <a:pt x="650" y="16"/>
                      </a:lnTo>
                      <a:lnTo>
                        <a:pt x="650" y="15"/>
                      </a:lnTo>
                      <a:lnTo>
                        <a:pt x="651" y="15"/>
                      </a:lnTo>
                      <a:lnTo>
                        <a:pt x="651" y="12"/>
                      </a:lnTo>
                      <a:lnTo>
                        <a:pt x="651" y="16"/>
                      </a:lnTo>
                      <a:lnTo>
                        <a:pt x="651" y="15"/>
                      </a:lnTo>
                      <a:lnTo>
                        <a:pt x="652" y="15"/>
                      </a:lnTo>
                      <a:lnTo>
                        <a:pt x="652" y="12"/>
                      </a:lnTo>
                      <a:lnTo>
                        <a:pt x="652" y="15"/>
                      </a:lnTo>
                      <a:lnTo>
                        <a:pt x="652" y="12"/>
                      </a:lnTo>
                      <a:lnTo>
                        <a:pt x="653" y="12"/>
                      </a:lnTo>
                      <a:lnTo>
                        <a:pt x="653" y="12"/>
                      </a:lnTo>
                      <a:lnTo>
                        <a:pt x="653" y="15"/>
                      </a:lnTo>
                      <a:lnTo>
                        <a:pt x="653" y="13"/>
                      </a:lnTo>
                      <a:lnTo>
                        <a:pt x="654" y="13"/>
                      </a:lnTo>
                      <a:lnTo>
                        <a:pt x="654" y="13"/>
                      </a:lnTo>
                      <a:lnTo>
                        <a:pt x="654" y="18"/>
                      </a:lnTo>
                      <a:lnTo>
                        <a:pt x="654" y="13"/>
                      </a:lnTo>
                      <a:lnTo>
                        <a:pt x="655" y="13"/>
                      </a:lnTo>
                      <a:lnTo>
                        <a:pt x="655" y="9"/>
                      </a:lnTo>
                      <a:lnTo>
                        <a:pt x="655" y="13"/>
                      </a:lnTo>
                      <a:lnTo>
                        <a:pt x="655" y="12"/>
                      </a:lnTo>
                      <a:lnTo>
                        <a:pt x="656" y="12"/>
                      </a:lnTo>
                      <a:lnTo>
                        <a:pt x="656" y="11"/>
                      </a:lnTo>
                      <a:lnTo>
                        <a:pt x="656" y="16"/>
                      </a:lnTo>
                      <a:lnTo>
                        <a:pt x="656" y="13"/>
                      </a:lnTo>
                      <a:lnTo>
                        <a:pt x="657" y="13"/>
                      </a:lnTo>
                      <a:lnTo>
                        <a:pt x="657" y="11"/>
                      </a:lnTo>
                      <a:lnTo>
                        <a:pt x="657" y="16"/>
                      </a:lnTo>
                      <a:lnTo>
                        <a:pt x="657" y="14"/>
                      </a:lnTo>
                      <a:lnTo>
                        <a:pt x="658" y="14"/>
                      </a:lnTo>
                      <a:lnTo>
                        <a:pt x="658" y="10"/>
                      </a:lnTo>
                      <a:lnTo>
                        <a:pt x="658" y="13"/>
                      </a:lnTo>
                      <a:lnTo>
                        <a:pt x="658" y="12"/>
                      </a:lnTo>
                      <a:lnTo>
                        <a:pt x="659" y="12"/>
                      </a:lnTo>
                      <a:lnTo>
                        <a:pt x="659" y="10"/>
                      </a:lnTo>
                      <a:lnTo>
                        <a:pt x="659" y="15"/>
                      </a:lnTo>
                      <a:lnTo>
                        <a:pt x="659" y="15"/>
                      </a:lnTo>
                      <a:lnTo>
                        <a:pt x="660" y="15"/>
                      </a:lnTo>
                      <a:lnTo>
                        <a:pt x="660" y="10"/>
                      </a:lnTo>
                      <a:lnTo>
                        <a:pt x="660" y="14"/>
                      </a:lnTo>
                      <a:lnTo>
                        <a:pt x="660" y="12"/>
                      </a:lnTo>
                      <a:lnTo>
                        <a:pt x="661" y="12"/>
                      </a:lnTo>
                      <a:lnTo>
                        <a:pt x="661" y="9"/>
                      </a:lnTo>
                      <a:lnTo>
                        <a:pt x="661" y="13"/>
                      </a:lnTo>
                      <a:lnTo>
                        <a:pt x="661" y="10"/>
                      </a:lnTo>
                      <a:lnTo>
                        <a:pt x="662" y="10"/>
                      </a:lnTo>
                      <a:lnTo>
                        <a:pt x="662" y="9"/>
                      </a:lnTo>
                      <a:lnTo>
                        <a:pt x="662" y="13"/>
                      </a:lnTo>
                      <a:lnTo>
                        <a:pt x="662" y="10"/>
                      </a:lnTo>
                      <a:lnTo>
                        <a:pt x="663" y="10"/>
                      </a:lnTo>
                      <a:lnTo>
                        <a:pt x="663" y="9"/>
                      </a:lnTo>
                      <a:lnTo>
                        <a:pt x="663" y="13"/>
                      </a:lnTo>
                      <a:lnTo>
                        <a:pt x="663" y="13"/>
                      </a:lnTo>
                      <a:lnTo>
                        <a:pt x="664" y="13"/>
                      </a:lnTo>
                      <a:lnTo>
                        <a:pt x="664" y="9"/>
                      </a:lnTo>
                      <a:lnTo>
                        <a:pt x="664" y="13"/>
                      </a:lnTo>
                      <a:lnTo>
                        <a:pt x="664" y="11"/>
                      </a:lnTo>
                      <a:lnTo>
                        <a:pt x="665" y="11"/>
                      </a:lnTo>
                      <a:lnTo>
                        <a:pt x="665" y="9"/>
                      </a:lnTo>
                      <a:lnTo>
                        <a:pt x="665" y="12"/>
                      </a:lnTo>
                      <a:lnTo>
                        <a:pt x="665" y="10"/>
                      </a:lnTo>
                      <a:lnTo>
                        <a:pt x="666" y="10"/>
                      </a:lnTo>
                      <a:lnTo>
                        <a:pt x="666" y="9"/>
                      </a:lnTo>
                      <a:lnTo>
                        <a:pt x="666" y="13"/>
                      </a:lnTo>
                      <a:lnTo>
                        <a:pt x="666" y="9"/>
                      </a:lnTo>
                      <a:lnTo>
                        <a:pt x="667" y="9"/>
                      </a:lnTo>
                      <a:lnTo>
                        <a:pt x="667" y="8"/>
                      </a:lnTo>
                      <a:lnTo>
                        <a:pt x="667" y="13"/>
                      </a:lnTo>
                      <a:lnTo>
                        <a:pt x="667" y="11"/>
                      </a:lnTo>
                      <a:lnTo>
                        <a:pt x="668" y="11"/>
                      </a:lnTo>
                      <a:lnTo>
                        <a:pt x="668" y="9"/>
                      </a:lnTo>
                      <a:lnTo>
                        <a:pt x="668" y="13"/>
                      </a:lnTo>
                      <a:lnTo>
                        <a:pt x="668" y="10"/>
                      </a:lnTo>
                      <a:lnTo>
                        <a:pt x="669" y="10"/>
                      </a:lnTo>
                      <a:lnTo>
                        <a:pt x="669" y="9"/>
                      </a:lnTo>
                      <a:lnTo>
                        <a:pt x="669" y="12"/>
                      </a:lnTo>
                      <a:lnTo>
                        <a:pt x="669" y="9"/>
                      </a:lnTo>
                      <a:lnTo>
                        <a:pt x="670" y="9"/>
                      </a:lnTo>
                      <a:lnTo>
                        <a:pt x="670" y="8"/>
                      </a:lnTo>
                      <a:lnTo>
                        <a:pt x="670" y="13"/>
                      </a:lnTo>
                      <a:lnTo>
                        <a:pt x="670" y="10"/>
                      </a:lnTo>
                      <a:lnTo>
                        <a:pt x="671" y="10"/>
                      </a:lnTo>
                      <a:lnTo>
                        <a:pt x="671" y="9"/>
                      </a:lnTo>
                      <a:lnTo>
                        <a:pt x="671" y="13"/>
                      </a:lnTo>
                      <a:lnTo>
                        <a:pt x="671" y="11"/>
                      </a:lnTo>
                      <a:lnTo>
                        <a:pt x="672" y="11"/>
                      </a:lnTo>
                      <a:lnTo>
                        <a:pt x="672" y="9"/>
                      </a:lnTo>
                      <a:lnTo>
                        <a:pt x="672" y="12"/>
                      </a:lnTo>
                      <a:lnTo>
                        <a:pt x="672" y="9"/>
                      </a:lnTo>
                      <a:lnTo>
                        <a:pt x="673" y="9"/>
                      </a:lnTo>
                      <a:lnTo>
                        <a:pt x="673" y="9"/>
                      </a:lnTo>
                      <a:lnTo>
                        <a:pt x="673" y="12"/>
                      </a:lnTo>
                      <a:lnTo>
                        <a:pt x="673" y="9"/>
                      </a:lnTo>
                      <a:lnTo>
                        <a:pt x="674" y="9"/>
                      </a:lnTo>
                      <a:lnTo>
                        <a:pt x="674" y="10"/>
                      </a:lnTo>
                      <a:lnTo>
                        <a:pt x="674" y="13"/>
                      </a:lnTo>
                      <a:lnTo>
                        <a:pt x="674" y="10"/>
                      </a:lnTo>
                      <a:lnTo>
                        <a:pt x="675" y="10"/>
                      </a:lnTo>
                      <a:lnTo>
                        <a:pt x="675" y="9"/>
                      </a:lnTo>
                      <a:lnTo>
                        <a:pt x="675" y="12"/>
                      </a:lnTo>
                      <a:lnTo>
                        <a:pt x="675" y="10"/>
                      </a:lnTo>
                      <a:lnTo>
                        <a:pt x="676" y="10"/>
                      </a:lnTo>
                      <a:lnTo>
                        <a:pt x="676" y="9"/>
                      </a:lnTo>
                      <a:lnTo>
                        <a:pt x="676" y="12"/>
                      </a:lnTo>
                      <a:lnTo>
                        <a:pt x="676" y="10"/>
                      </a:lnTo>
                      <a:lnTo>
                        <a:pt x="677" y="10"/>
                      </a:lnTo>
                      <a:lnTo>
                        <a:pt x="677" y="7"/>
                      </a:lnTo>
                      <a:lnTo>
                        <a:pt x="677" y="12"/>
                      </a:lnTo>
                      <a:lnTo>
                        <a:pt x="677" y="7"/>
                      </a:lnTo>
                      <a:lnTo>
                        <a:pt x="678" y="7"/>
                      </a:lnTo>
                      <a:lnTo>
                        <a:pt x="678" y="8"/>
                      </a:lnTo>
                      <a:lnTo>
                        <a:pt x="678" y="11"/>
                      </a:lnTo>
                      <a:lnTo>
                        <a:pt x="678" y="10"/>
                      </a:lnTo>
                      <a:lnTo>
                        <a:pt x="679" y="10"/>
                      </a:lnTo>
                      <a:lnTo>
                        <a:pt x="679" y="9"/>
                      </a:lnTo>
                      <a:lnTo>
                        <a:pt x="679" y="12"/>
                      </a:lnTo>
                      <a:lnTo>
                        <a:pt x="679" y="10"/>
                      </a:lnTo>
                      <a:lnTo>
                        <a:pt x="680" y="10"/>
                      </a:lnTo>
                      <a:lnTo>
                        <a:pt x="680" y="6"/>
                      </a:lnTo>
                      <a:lnTo>
                        <a:pt x="680" y="12"/>
                      </a:lnTo>
                      <a:lnTo>
                        <a:pt x="680" y="8"/>
                      </a:lnTo>
                      <a:lnTo>
                        <a:pt x="681" y="8"/>
                      </a:lnTo>
                      <a:lnTo>
                        <a:pt x="681" y="7"/>
                      </a:lnTo>
                      <a:lnTo>
                        <a:pt x="681" y="10"/>
                      </a:lnTo>
                      <a:lnTo>
                        <a:pt x="681" y="9"/>
                      </a:lnTo>
                      <a:lnTo>
                        <a:pt x="682" y="9"/>
                      </a:lnTo>
                      <a:lnTo>
                        <a:pt x="682" y="6"/>
                      </a:lnTo>
                      <a:lnTo>
                        <a:pt x="682" y="11"/>
                      </a:lnTo>
                      <a:lnTo>
                        <a:pt x="682" y="6"/>
                      </a:lnTo>
                      <a:lnTo>
                        <a:pt x="683" y="6"/>
                      </a:lnTo>
                      <a:lnTo>
                        <a:pt x="683" y="6"/>
                      </a:lnTo>
                      <a:lnTo>
                        <a:pt x="683" y="11"/>
                      </a:lnTo>
                      <a:lnTo>
                        <a:pt x="683" y="8"/>
                      </a:lnTo>
                      <a:lnTo>
                        <a:pt x="684" y="8"/>
                      </a:lnTo>
                      <a:lnTo>
                        <a:pt x="684" y="6"/>
                      </a:lnTo>
                      <a:lnTo>
                        <a:pt x="684" y="11"/>
                      </a:lnTo>
                      <a:lnTo>
                        <a:pt x="684" y="11"/>
                      </a:lnTo>
                      <a:lnTo>
                        <a:pt x="685" y="11"/>
                      </a:lnTo>
                      <a:lnTo>
                        <a:pt x="685" y="5"/>
                      </a:lnTo>
                      <a:lnTo>
                        <a:pt x="685" y="10"/>
                      </a:lnTo>
                      <a:lnTo>
                        <a:pt x="685" y="6"/>
                      </a:lnTo>
                      <a:lnTo>
                        <a:pt x="686" y="6"/>
                      </a:lnTo>
                      <a:lnTo>
                        <a:pt x="686" y="6"/>
                      </a:lnTo>
                      <a:lnTo>
                        <a:pt x="686" y="9"/>
                      </a:lnTo>
                      <a:lnTo>
                        <a:pt x="686" y="8"/>
                      </a:lnTo>
                      <a:lnTo>
                        <a:pt x="687" y="8"/>
                      </a:lnTo>
                      <a:lnTo>
                        <a:pt x="687" y="6"/>
                      </a:lnTo>
                      <a:lnTo>
                        <a:pt x="687" y="9"/>
                      </a:lnTo>
                      <a:lnTo>
                        <a:pt x="687" y="8"/>
                      </a:lnTo>
                      <a:lnTo>
                        <a:pt x="688" y="8"/>
                      </a:lnTo>
                      <a:lnTo>
                        <a:pt x="688" y="5"/>
                      </a:lnTo>
                      <a:lnTo>
                        <a:pt x="688" y="9"/>
                      </a:lnTo>
                      <a:lnTo>
                        <a:pt x="688" y="8"/>
                      </a:lnTo>
                      <a:lnTo>
                        <a:pt x="689" y="8"/>
                      </a:lnTo>
                      <a:lnTo>
                        <a:pt x="689" y="6"/>
                      </a:lnTo>
                      <a:lnTo>
                        <a:pt x="689" y="8"/>
                      </a:lnTo>
                      <a:lnTo>
                        <a:pt x="689" y="6"/>
                      </a:lnTo>
                      <a:lnTo>
                        <a:pt x="690" y="6"/>
                      </a:lnTo>
                      <a:lnTo>
                        <a:pt x="690" y="6"/>
                      </a:lnTo>
                      <a:lnTo>
                        <a:pt x="690" y="9"/>
                      </a:lnTo>
                      <a:lnTo>
                        <a:pt x="690" y="9"/>
                      </a:lnTo>
                      <a:lnTo>
                        <a:pt x="691" y="9"/>
                      </a:lnTo>
                      <a:lnTo>
                        <a:pt x="691" y="5"/>
                      </a:lnTo>
                      <a:lnTo>
                        <a:pt x="691" y="9"/>
                      </a:lnTo>
                      <a:lnTo>
                        <a:pt x="691" y="6"/>
                      </a:lnTo>
                      <a:lnTo>
                        <a:pt x="692" y="6"/>
                      </a:lnTo>
                      <a:lnTo>
                        <a:pt x="692" y="5"/>
                      </a:lnTo>
                      <a:lnTo>
                        <a:pt x="692" y="9"/>
                      </a:lnTo>
                      <a:lnTo>
                        <a:pt x="692" y="7"/>
                      </a:lnTo>
                      <a:lnTo>
                        <a:pt x="693" y="7"/>
                      </a:lnTo>
                      <a:lnTo>
                        <a:pt x="693" y="5"/>
                      </a:lnTo>
                      <a:lnTo>
                        <a:pt x="693" y="9"/>
                      </a:lnTo>
                      <a:lnTo>
                        <a:pt x="693" y="8"/>
                      </a:lnTo>
                      <a:lnTo>
                        <a:pt x="694" y="8"/>
                      </a:lnTo>
                      <a:lnTo>
                        <a:pt x="694" y="6"/>
                      </a:lnTo>
                      <a:lnTo>
                        <a:pt x="694" y="9"/>
                      </a:lnTo>
                      <a:lnTo>
                        <a:pt x="694" y="7"/>
                      </a:lnTo>
                      <a:lnTo>
                        <a:pt x="695" y="7"/>
                      </a:lnTo>
                      <a:lnTo>
                        <a:pt x="695" y="6"/>
                      </a:lnTo>
                      <a:lnTo>
                        <a:pt x="695" y="9"/>
                      </a:lnTo>
                      <a:lnTo>
                        <a:pt x="695" y="8"/>
                      </a:lnTo>
                      <a:lnTo>
                        <a:pt x="696" y="8"/>
                      </a:lnTo>
                      <a:lnTo>
                        <a:pt x="696" y="6"/>
                      </a:lnTo>
                      <a:lnTo>
                        <a:pt x="696" y="11"/>
                      </a:lnTo>
                      <a:lnTo>
                        <a:pt x="696" y="9"/>
                      </a:lnTo>
                      <a:lnTo>
                        <a:pt x="697" y="9"/>
                      </a:lnTo>
                      <a:lnTo>
                        <a:pt x="697" y="6"/>
                      </a:lnTo>
                      <a:lnTo>
                        <a:pt x="697" y="9"/>
                      </a:lnTo>
                      <a:lnTo>
                        <a:pt x="697" y="8"/>
                      </a:lnTo>
                      <a:lnTo>
                        <a:pt x="698" y="8"/>
                      </a:lnTo>
                      <a:lnTo>
                        <a:pt x="698" y="6"/>
                      </a:lnTo>
                      <a:lnTo>
                        <a:pt x="698" y="8"/>
                      </a:lnTo>
                      <a:lnTo>
                        <a:pt x="698" y="6"/>
                      </a:lnTo>
                      <a:lnTo>
                        <a:pt x="699" y="6"/>
                      </a:lnTo>
                      <a:lnTo>
                        <a:pt x="699" y="4"/>
                      </a:lnTo>
                      <a:lnTo>
                        <a:pt x="699" y="8"/>
                      </a:lnTo>
                      <a:lnTo>
                        <a:pt x="699" y="6"/>
                      </a:lnTo>
                      <a:lnTo>
                        <a:pt x="700" y="6"/>
                      </a:lnTo>
                      <a:lnTo>
                        <a:pt x="700" y="5"/>
                      </a:lnTo>
                      <a:lnTo>
                        <a:pt x="700" y="9"/>
                      </a:lnTo>
                      <a:lnTo>
                        <a:pt x="700" y="6"/>
                      </a:lnTo>
                      <a:lnTo>
                        <a:pt x="701" y="6"/>
                      </a:lnTo>
                      <a:lnTo>
                        <a:pt x="701" y="5"/>
                      </a:lnTo>
                      <a:lnTo>
                        <a:pt x="701" y="9"/>
                      </a:lnTo>
                      <a:lnTo>
                        <a:pt x="701" y="8"/>
                      </a:lnTo>
                      <a:lnTo>
                        <a:pt x="702" y="8"/>
                      </a:lnTo>
                      <a:lnTo>
                        <a:pt x="702" y="5"/>
                      </a:lnTo>
                      <a:lnTo>
                        <a:pt x="702" y="8"/>
                      </a:lnTo>
                      <a:lnTo>
                        <a:pt x="702" y="7"/>
                      </a:lnTo>
                      <a:lnTo>
                        <a:pt x="703" y="7"/>
                      </a:lnTo>
                      <a:lnTo>
                        <a:pt x="703" y="4"/>
                      </a:lnTo>
                      <a:lnTo>
                        <a:pt x="703" y="9"/>
                      </a:lnTo>
                      <a:lnTo>
                        <a:pt x="703" y="6"/>
                      </a:lnTo>
                      <a:lnTo>
                        <a:pt x="704" y="6"/>
                      </a:lnTo>
                      <a:lnTo>
                        <a:pt x="704" y="4"/>
                      </a:lnTo>
                      <a:lnTo>
                        <a:pt x="704" y="8"/>
                      </a:lnTo>
                      <a:lnTo>
                        <a:pt x="704" y="6"/>
                      </a:lnTo>
                      <a:lnTo>
                        <a:pt x="705" y="6"/>
                      </a:lnTo>
                      <a:lnTo>
                        <a:pt x="705" y="4"/>
                      </a:lnTo>
                      <a:lnTo>
                        <a:pt x="705" y="8"/>
                      </a:lnTo>
                      <a:lnTo>
                        <a:pt x="705" y="6"/>
                      </a:lnTo>
                      <a:lnTo>
                        <a:pt x="706" y="6"/>
                      </a:lnTo>
                      <a:lnTo>
                        <a:pt x="706" y="4"/>
                      </a:lnTo>
                      <a:lnTo>
                        <a:pt x="706" y="9"/>
                      </a:lnTo>
                      <a:lnTo>
                        <a:pt x="706" y="8"/>
                      </a:lnTo>
                      <a:lnTo>
                        <a:pt x="707" y="8"/>
                      </a:lnTo>
                      <a:lnTo>
                        <a:pt x="707" y="5"/>
                      </a:lnTo>
                      <a:lnTo>
                        <a:pt x="707" y="9"/>
                      </a:lnTo>
                      <a:lnTo>
                        <a:pt x="707" y="5"/>
                      </a:lnTo>
                      <a:lnTo>
                        <a:pt x="708" y="5"/>
                      </a:lnTo>
                      <a:lnTo>
                        <a:pt x="708" y="3"/>
                      </a:lnTo>
                      <a:lnTo>
                        <a:pt x="708" y="7"/>
                      </a:lnTo>
                      <a:lnTo>
                        <a:pt x="708" y="3"/>
                      </a:lnTo>
                      <a:lnTo>
                        <a:pt x="709" y="3"/>
                      </a:lnTo>
                      <a:lnTo>
                        <a:pt x="709" y="3"/>
                      </a:lnTo>
                      <a:lnTo>
                        <a:pt x="709" y="7"/>
                      </a:lnTo>
                      <a:lnTo>
                        <a:pt x="709" y="6"/>
                      </a:lnTo>
                      <a:lnTo>
                        <a:pt x="710" y="6"/>
                      </a:lnTo>
                      <a:lnTo>
                        <a:pt x="710" y="5"/>
                      </a:lnTo>
                      <a:lnTo>
                        <a:pt x="710" y="8"/>
                      </a:lnTo>
                      <a:lnTo>
                        <a:pt x="710" y="6"/>
                      </a:lnTo>
                      <a:lnTo>
                        <a:pt x="711" y="6"/>
                      </a:lnTo>
                      <a:lnTo>
                        <a:pt x="711" y="5"/>
                      </a:lnTo>
                      <a:lnTo>
                        <a:pt x="711" y="7"/>
                      </a:lnTo>
                      <a:lnTo>
                        <a:pt x="711" y="7"/>
                      </a:lnTo>
                      <a:lnTo>
                        <a:pt x="712" y="7"/>
                      </a:lnTo>
                      <a:lnTo>
                        <a:pt x="712" y="5"/>
                      </a:lnTo>
                      <a:lnTo>
                        <a:pt x="712" y="8"/>
                      </a:lnTo>
                      <a:lnTo>
                        <a:pt x="712" y="5"/>
                      </a:lnTo>
                      <a:lnTo>
                        <a:pt x="713" y="5"/>
                      </a:lnTo>
                      <a:lnTo>
                        <a:pt x="713" y="5"/>
                      </a:lnTo>
                      <a:lnTo>
                        <a:pt x="713" y="8"/>
                      </a:lnTo>
                      <a:lnTo>
                        <a:pt x="713" y="8"/>
                      </a:lnTo>
                      <a:lnTo>
                        <a:pt x="714" y="8"/>
                      </a:lnTo>
                      <a:lnTo>
                        <a:pt x="714" y="4"/>
                      </a:lnTo>
                      <a:lnTo>
                        <a:pt x="714" y="8"/>
                      </a:lnTo>
                      <a:lnTo>
                        <a:pt x="714" y="6"/>
                      </a:lnTo>
                      <a:lnTo>
                        <a:pt x="715" y="6"/>
                      </a:lnTo>
                      <a:lnTo>
                        <a:pt x="715" y="5"/>
                      </a:lnTo>
                      <a:lnTo>
                        <a:pt x="715" y="7"/>
                      </a:lnTo>
                      <a:lnTo>
                        <a:pt x="715" y="7"/>
                      </a:lnTo>
                      <a:lnTo>
                        <a:pt x="716" y="7"/>
                      </a:lnTo>
                      <a:lnTo>
                        <a:pt x="716" y="4"/>
                      </a:lnTo>
                      <a:lnTo>
                        <a:pt x="716" y="6"/>
                      </a:lnTo>
                      <a:lnTo>
                        <a:pt x="716" y="6"/>
                      </a:lnTo>
                      <a:lnTo>
                        <a:pt x="717" y="6"/>
                      </a:lnTo>
                      <a:lnTo>
                        <a:pt x="717" y="4"/>
                      </a:lnTo>
                      <a:lnTo>
                        <a:pt x="717" y="9"/>
                      </a:lnTo>
                      <a:lnTo>
                        <a:pt x="717" y="4"/>
                      </a:lnTo>
                      <a:lnTo>
                        <a:pt x="718" y="4"/>
                      </a:lnTo>
                      <a:lnTo>
                        <a:pt x="718" y="4"/>
                      </a:lnTo>
                      <a:lnTo>
                        <a:pt x="718" y="8"/>
                      </a:lnTo>
                      <a:lnTo>
                        <a:pt x="718" y="6"/>
                      </a:lnTo>
                      <a:lnTo>
                        <a:pt x="719" y="6"/>
                      </a:lnTo>
                      <a:lnTo>
                        <a:pt x="719" y="5"/>
                      </a:lnTo>
                      <a:lnTo>
                        <a:pt x="719" y="8"/>
                      </a:lnTo>
                      <a:lnTo>
                        <a:pt x="719" y="6"/>
                      </a:lnTo>
                      <a:lnTo>
                        <a:pt x="720" y="6"/>
                      </a:lnTo>
                      <a:lnTo>
                        <a:pt x="720" y="4"/>
                      </a:lnTo>
                      <a:lnTo>
                        <a:pt x="720" y="6"/>
                      </a:lnTo>
                      <a:lnTo>
                        <a:pt x="720" y="5"/>
                      </a:lnTo>
                      <a:lnTo>
                        <a:pt x="721" y="5"/>
                      </a:lnTo>
                      <a:lnTo>
                        <a:pt x="721" y="4"/>
                      </a:lnTo>
                      <a:lnTo>
                        <a:pt x="721" y="7"/>
                      </a:lnTo>
                      <a:lnTo>
                        <a:pt x="721" y="5"/>
                      </a:lnTo>
                      <a:lnTo>
                        <a:pt x="722" y="5"/>
                      </a:lnTo>
                      <a:lnTo>
                        <a:pt x="722" y="3"/>
                      </a:lnTo>
                      <a:lnTo>
                        <a:pt x="722" y="13"/>
                      </a:lnTo>
                      <a:lnTo>
                        <a:pt x="722" y="6"/>
                      </a:lnTo>
                      <a:lnTo>
                        <a:pt x="723" y="6"/>
                      </a:lnTo>
                      <a:lnTo>
                        <a:pt x="723" y="5"/>
                      </a:lnTo>
                      <a:lnTo>
                        <a:pt x="723" y="8"/>
                      </a:lnTo>
                      <a:lnTo>
                        <a:pt x="723" y="8"/>
                      </a:lnTo>
                      <a:lnTo>
                        <a:pt x="724" y="8"/>
                      </a:lnTo>
                      <a:lnTo>
                        <a:pt x="724" y="5"/>
                      </a:lnTo>
                      <a:lnTo>
                        <a:pt x="724" y="9"/>
                      </a:lnTo>
                      <a:lnTo>
                        <a:pt x="724" y="6"/>
                      </a:lnTo>
                      <a:lnTo>
                        <a:pt x="725" y="6"/>
                      </a:lnTo>
                      <a:lnTo>
                        <a:pt x="725" y="5"/>
                      </a:lnTo>
                      <a:lnTo>
                        <a:pt x="725" y="8"/>
                      </a:lnTo>
                      <a:lnTo>
                        <a:pt x="725" y="5"/>
                      </a:lnTo>
                      <a:lnTo>
                        <a:pt x="726" y="5"/>
                      </a:lnTo>
                      <a:lnTo>
                        <a:pt x="726" y="4"/>
                      </a:lnTo>
                      <a:lnTo>
                        <a:pt x="726" y="7"/>
                      </a:lnTo>
                      <a:lnTo>
                        <a:pt x="726" y="6"/>
                      </a:lnTo>
                      <a:lnTo>
                        <a:pt x="727" y="6"/>
                      </a:lnTo>
                      <a:lnTo>
                        <a:pt x="727" y="4"/>
                      </a:lnTo>
                      <a:lnTo>
                        <a:pt x="727" y="6"/>
                      </a:lnTo>
                      <a:lnTo>
                        <a:pt x="727" y="5"/>
                      </a:lnTo>
                      <a:lnTo>
                        <a:pt x="728" y="5"/>
                      </a:lnTo>
                      <a:lnTo>
                        <a:pt x="728" y="2"/>
                      </a:lnTo>
                      <a:lnTo>
                        <a:pt x="728" y="6"/>
                      </a:lnTo>
                      <a:lnTo>
                        <a:pt x="728" y="4"/>
                      </a:lnTo>
                      <a:lnTo>
                        <a:pt x="729" y="4"/>
                      </a:lnTo>
                      <a:lnTo>
                        <a:pt x="729" y="4"/>
                      </a:lnTo>
                      <a:lnTo>
                        <a:pt x="729" y="6"/>
                      </a:lnTo>
                      <a:lnTo>
                        <a:pt x="729" y="5"/>
                      </a:lnTo>
                      <a:lnTo>
                        <a:pt x="730" y="5"/>
                      </a:lnTo>
                      <a:lnTo>
                        <a:pt x="730" y="3"/>
                      </a:lnTo>
                      <a:lnTo>
                        <a:pt x="730" y="7"/>
                      </a:lnTo>
                      <a:lnTo>
                        <a:pt x="730" y="4"/>
                      </a:lnTo>
                      <a:lnTo>
                        <a:pt x="731" y="4"/>
                      </a:lnTo>
                      <a:lnTo>
                        <a:pt x="731" y="2"/>
                      </a:lnTo>
                      <a:lnTo>
                        <a:pt x="731" y="8"/>
                      </a:lnTo>
                      <a:lnTo>
                        <a:pt x="731" y="8"/>
                      </a:lnTo>
                      <a:lnTo>
                        <a:pt x="732" y="8"/>
                      </a:lnTo>
                      <a:lnTo>
                        <a:pt x="732" y="4"/>
                      </a:lnTo>
                      <a:lnTo>
                        <a:pt x="732" y="7"/>
                      </a:lnTo>
                      <a:lnTo>
                        <a:pt x="732" y="5"/>
                      </a:lnTo>
                      <a:lnTo>
                        <a:pt x="733" y="5"/>
                      </a:lnTo>
                      <a:lnTo>
                        <a:pt x="733" y="2"/>
                      </a:lnTo>
                      <a:lnTo>
                        <a:pt x="733" y="6"/>
                      </a:lnTo>
                      <a:lnTo>
                        <a:pt x="733" y="6"/>
                      </a:lnTo>
                      <a:lnTo>
                        <a:pt x="734" y="6"/>
                      </a:lnTo>
                      <a:lnTo>
                        <a:pt x="734" y="3"/>
                      </a:lnTo>
                      <a:lnTo>
                        <a:pt x="734" y="7"/>
                      </a:lnTo>
                      <a:lnTo>
                        <a:pt x="734" y="4"/>
                      </a:lnTo>
                      <a:lnTo>
                        <a:pt x="735" y="4"/>
                      </a:lnTo>
                      <a:lnTo>
                        <a:pt x="735" y="2"/>
                      </a:lnTo>
                      <a:lnTo>
                        <a:pt x="735" y="8"/>
                      </a:lnTo>
                      <a:lnTo>
                        <a:pt x="735" y="6"/>
                      </a:lnTo>
                      <a:lnTo>
                        <a:pt x="736" y="6"/>
                      </a:lnTo>
                      <a:lnTo>
                        <a:pt x="736" y="4"/>
                      </a:lnTo>
                      <a:lnTo>
                        <a:pt x="736" y="6"/>
                      </a:lnTo>
                      <a:lnTo>
                        <a:pt x="736" y="6"/>
                      </a:lnTo>
                      <a:lnTo>
                        <a:pt x="737" y="6"/>
                      </a:lnTo>
                      <a:lnTo>
                        <a:pt x="737" y="5"/>
                      </a:lnTo>
                      <a:lnTo>
                        <a:pt x="737" y="6"/>
                      </a:lnTo>
                      <a:lnTo>
                        <a:pt x="737" y="5"/>
                      </a:lnTo>
                      <a:lnTo>
                        <a:pt x="738" y="5"/>
                      </a:lnTo>
                      <a:lnTo>
                        <a:pt x="738" y="4"/>
                      </a:lnTo>
                      <a:lnTo>
                        <a:pt x="738" y="8"/>
                      </a:lnTo>
                      <a:lnTo>
                        <a:pt x="738" y="5"/>
                      </a:lnTo>
                      <a:lnTo>
                        <a:pt x="739" y="5"/>
                      </a:lnTo>
                      <a:lnTo>
                        <a:pt x="739" y="3"/>
                      </a:lnTo>
                      <a:lnTo>
                        <a:pt x="739" y="7"/>
                      </a:lnTo>
                      <a:lnTo>
                        <a:pt x="739" y="6"/>
                      </a:lnTo>
                      <a:lnTo>
                        <a:pt x="740" y="6"/>
                      </a:lnTo>
                      <a:lnTo>
                        <a:pt x="740" y="4"/>
                      </a:lnTo>
                      <a:lnTo>
                        <a:pt x="740" y="6"/>
                      </a:lnTo>
                      <a:lnTo>
                        <a:pt x="740" y="4"/>
                      </a:lnTo>
                      <a:lnTo>
                        <a:pt x="741" y="4"/>
                      </a:lnTo>
                      <a:lnTo>
                        <a:pt x="741" y="3"/>
                      </a:lnTo>
                      <a:lnTo>
                        <a:pt x="741" y="6"/>
                      </a:lnTo>
                      <a:lnTo>
                        <a:pt x="741" y="6"/>
                      </a:lnTo>
                      <a:lnTo>
                        <a:pt x="742" y="6"/>
                      </a:lnTo>
                      <a:lnTo>
                        <a:pt x="742" y="3"/>
                      </a:lnTo>
                      <a:lnTo>
                        <a:pt x="742" y="6"/>
                      </a:lnTo>
                      <a:lnTo>
                        <a:pt x="742" y="6"/>
                      </a:lnTo>
                      <a:lnTo>
                        <a:pt x="743" y="6"/>
                      </a:lnTo>
                      <a:lnTo>
                        <a:pt x="743" y="4"/>
                      </a:lnTo>
                      <a:lnTo>
                        <a:pt x="743" y="6"/>
                      </a:lnTo>
                      <a:lnTo>
                        <a:pt x="743" y="6"/>
                      </a:lnTo>
                      <a:lnTo>
                        <a:pt x="744" y="6"/>
                      </a:lnTo>
                      <a:lnTo>
                        <a:pt x="744" y="4"/>
                      </a:lnTo>
                      <a:lnTo>
                        <a:pt x="744" y="7"/>
                      </a:lnTo>
                      <a:lnTo>
                        <a:pt x="744" y="7"/>
                      </a:lnTo>
                      <a:lnTo>
                        <a:pt x="745" y="7"/>
                      </a:lnTo>
                      <a:lnTo>
                        <a:pt x="745" y="4"/>
                      </a:lnTo>
                      <a:lnTo>
                        <a:pt x="745" y="6"/>
                      </a:lnTo>
                      <a:lnTo>
                        <a:pt x="745" y="4"/>
                      </a:lnTo>
                      <a:lnTo>
                        <a:pt x="746" y="4"/>
                      </a:lnTo>
                      <a:lnTo>
                        <a:pt x="746" y="3"/>
                      </a:lnTo>
                      <a:lnTo>
                        <a:pt x="746" y="6"/>
                      </a:lnTo>
                      <a:lnTo>
                        <a:pt x="746" y="6"/>
                      </a:lnTo>
                      <a:lnTo>
                        <a:pt x="747" y="6"/>
                      </a:lnTo>
                      <a:lnTo>
                        <a:pt x="747" y="2"/>
                      </a:lnTo>
                      <a:lnTo>
                        <a:pt x="747" y="7"/>
                      </a:lnTo>
                      <a:lnTo>
                        <a:pt x="747" y="5"/>
                      </a:lnTo>
                      <a:lnTo>
                        <a:pt x="748" y="5"/>
                      </a:lnTo>
                      <a:lnTo>
                        <a:pt x="748" y="3"/>
                      </a:lnTo>
                      <a:lnTo>
                        <a:pt x="748" y="5"/>
                      </a:lnTo>
                      <a:lnTo>
                        <a:pt x="748" y="4"/>
                      </a:lnTo>
                      <a:lnTo>
                        <a:pt x="749" y="4"/>
                      </a:lnTo>
                      <a:lnTo>
                        <a:pt x="749" y="2"/>
                      </a:lnTo>
                      <a:lnTo>
                        <a:pt x="749" y="7"/>
                      </a:lnTo>
                      <a:lnTo>
                        <a:pt x="749" y="5"/>
                      </a:lnTo>
                      <a:lnTo>
                        <a:pt x="750" y="5"/>
                      </a:lnTo>
                      <a:lnTo>
                        <a:pt x="750" y="2"/>
                      </a:lnTo>
                      <a:lnTo>
                        <a:pt x="750" y="7"/>
                      </a:lnTo>
                      <a:lnTo>
                        <a:pt x="750" y="4"/>
                      </a:lnTo>
                      <a:lnTo>
                        <a:pt x="751" y="4"/>
                      </a:lnTo>
                      <a:lnTo>
                        <a:pt x="751" y="2"/>
                      </a:lnTo>
                      <a:lnTo>
                        <a:pt x="751" y="7"/>
                      </a:lnTo>
                      <a:lnTo>
                        <a:pt x="751" y="6"/>
                      </a:lnTo>
                      <a:lnTo>
                        <a:pt x="752" y="6"/>
                      </a:lnTo>
                      <a:lnTo>
                        <a:pt x="752" y="5"/>
                      </a:lnTo>
                      <a:lnTo>
                        <a:pt x="752" y="6"/>
                      </a:lnTo>
                      <a:lnTo>
                        <a:pt x="752" y="6"/>
                      </a:lnTo>
                      <a:lnTo>
                        <a:pt x="753" y="6"/>
                      </a:lnTo>
                      <a:lnTo>
                        <a:pt x="753" y="3"/>
                      </a:lnTo>
                      <a:lnTo>
                        <a:pt x="753" y="8"/>
                      </a:lnTo>
                      <a:lnTo>
                        <a:pt x="753" y="6"/>
                      </a:lnTo>
                      <a:lnTo>
                        <a:pt x="754" y="6"/>
                      </a:lnTo>
                      <a:lnTo>
                        <a:pt x="754" y="4"/>
                      </a:lnTo>
                      <a:lnTo>
                        <a:pt x="754" y="7"/>
                      </a:lnTo>
                      <a:lnTo>
                        <a:pt x="754" y="5"/>
                      </a:lnTo>
                      <a:lnTo>
                        <a:pt x="755" y="5"/>
                      </a:lnTo>
                      <a:lnTo>
                        <a:pt x="755" y="4"/>
                      </a:lnTo>
                      <a:lnTo>
                        <a:pt x="755" y="7"/>
                      </a:lnTo>
                      <a:lnTo>
                        <a:pt x="755" y="5"/>
                      </a:lnTo>
                      <a:lnTo>
                        <a:pt x="756" y="5"/>
                      </a:lnTo>
                      <a:lnTo>
                        <a:pt x="756" y="3"/>
                      </a:lnTo>
                      <a:lnTo>
                        <a:pt x="756" y="7"/>
                      </a:lnTo>
                      <a:lnTo>
                        <a:pt x="756" y="4"/>
                      </a:lnTo>
                      <a:lnTo>
                        <a:pt x="757" y="4"/>
                      </a:lnTo>
                      <a:lnTo>
                        <a:pt x="757" y="4"/>
                      </a:lnTo>
                      <a:lnTo>
                        <a:pt x="757" y="8"/>
                      </a:lnTo>
                      <a:lnTo>
                        <a:pt x="757" y="5"/>
                      </a:lnTo>
                      <a:lnTo>
                        <a:pt x="758" y="5"/>
                      </a:lnTo>
                      <a:lnTo>
                        <a:pt x="758" y="4"/>
                      </a:lnTo>
                      <a:lnTo>
                        <a:pt x="758" y="6"/>
                      </a:lnTo>
                      <a:lnTo>
                        <a:pt x="758" y="6"/>
                      </a:lnTo>
                      <a:lnTo>
                        <a:pt x="759" y="6"/>
                      </a:lnTo>
                      <a:lnTo>
                        <a:pt x="759" y="3"/>
                      </a:lnTo>
                      <a:lnTo>
                        <a:pt x="759" y="7"/>
                      </a:lnTo>
                      <a:lnTo>
                        <a:pt x="759" y="5"/>
                      </a:lnTo>
                      <a:lnTo>
                        <a:pt x="760" y="5"/>
                      </a:lnTo>
                      <a:lnTo>
                        <a:pt x="760" y="4"/>
                      </a:lnTo>
                      <a:lnTo>
                        <a:pt x="760" y="8"/>
                      </a:lnTo>
                      <a:lnTo>
                        <a:pt x="760" y="5"/>
                      </a:lnTo>
                      <a:lnTo>
                        <a:pt x="761" y="5"/>
                      </a:lnTo>
                      <a:lnTo>
                        <a:pt x="761" y="2"/>
                      </a:lnTo>
                      <a:lnTo>
                        <a:pt x="761" y="8"/>
                      </a:lnTo>
                      <a:lnTo>
                        <a:pt x="761" y="5"/>
                      </a:lnTo>
                      <a:lnTo>
                        <a:pt x="762" y="5"/>
                      </a:lnTo>
                      <a:lnTo>
                        <a:pt x="762" y="3"/>
                      </a:lnTo>
                      <a:lnTo>
                        <a:pt x="762" y="8"/>
                      </a:lnTo>
                      <a:lnTo>
                        <a:pt x="762" y="5"/>
                      </a:lnTo>
                      <a:lnTo>
                        <a:pt x="763" y="5"/>
                      </a:lnTo>
                      <a:lnTo>
                        <a:pt x="763" y="2"/>
                      </a:lnTo>
                      <a:lnTo>
                        <a:pt x="763" y="7"/>
                      </a:lnTo>
                      <a:lnTo>
                        <a:pt x="763" y="6"/>
                      </a:lnTo>
                      <a:lnTo>
                        <a:pt x="764" y="6"/>
                      </a:lnTo>
                      <a:lnTo>
                        <a:pt x="764" y="4"/>
                      </a:lnTo>
                      <a:lnTo>
                        <a:pt x="764" y="8"/>
                      </a:lnTo>
                      <a:lnTo>
                        <a:pt x="764" y="5"/>
                      </a:lnTo>
                      <a:lnTo>
                        <a:pt x="765" y="5"/>
                      </a:lnTo>
                      <a:lnTo>
                        <a:pt x="765" y="5"/>
                      </a:lnTo>
                      <a:lnTo>
                        <a:pt x="765" y="9"/>
                      </a:lnTo>
                      <a:lnTo>
                        <a:pt x="765" y="7"/>
                      </a:lnTo>
                      <a:lnTo>
                        <a:pt x="766" y="7"/>
                      </a:lnTo>
                      <a:lnTo>
                        <a:pt x="766" y="4"/>
                      </a:lnTo>
                      <a:lnTo>
                        <a:pt x="766" y="8"/>
                      </a:lnTo>
                      <a:lnTo>
                        <a:pt x="766" y="6"/>
                      </a:lnTo>
                      <a:lnTo>
                        <a:pt x="767" y="6"/>
                      </a:lnTo>
                      <a:lnTo>
                        <a:pt x="767" y="3"/>
                      </a:lnTo>
                      <a:lnTo>
                        <a:pt x="767" y="8"/>
                      </a:lnTo>
                      <a:lnTo>
                        <a:pt x="767" y="6"/>
                      </a:lnTo>
                      <a:lnTo>
                        <a:pt x="768" y="6"/>
                      </a:lnTo>
                      <a:lnTo>
                        <a:pt x="768" y="4"/>
                      </a:lnTo>
                      <a:lnTo>
                        <a:pt x="768" y="9"/>
                      </a:lnTo>
                      <a:lnTo>
                        <a:pt x="768" y="4"/>
                      </a:lnTo>
                      <a:lnTo>
                        <a:pt x="769" y="4"/>
                      </a:lnTo>
                      <a:lnTo>
                        <a:pt x="769" y="4"/>
                      </a:lnTo>
                      <a:lnTo>
                        <a:pt x="769" y="7"/>
                      </a:lnTo>
                      <a:lnTo>
                        <a:pt x="769" y="6"/>
                      </a:lnTo>
                      <a:lnTo>
                        <a:pt x="770" y="6"/>
                      </a:lnTo>
                      <a:lnTo>
                        <a:pt x="770" y="4"/>
                      </a:lnTo>
                      <a:lnTo>
                        <a:pt x="770" y="8"/>
                      </a:lnTo>
                      <a:lnTo>
                        <a:pt x="770" y="5"/>
                      </a:lnTo>
                      <a:lnTo>
                        <a:pt x="771" y="5"/>
                      </a:lnTo>
                      <a:lnTo>
                        <a:pt x="771" y="3"/>
                      </a:lnTo>
                      <a:lnTo>
                        <a:pt x="771" y="6"/>
                      </a:lnTo>
                      <a:lnTo>
                        <a:pt x="771" y="6"/>
                      </a:lnTo>
                      <a:lnTo>
                        <a:pt x="772" y="6"/>
                      </a:lnTo>
                      <a:lnTo>
                        <a:pt x="772" y="3"/>
                      </a:lnTo>
                      <a:lnTo>
                        <a:pt x="772" y="8"/>
                      </a:lnTo>
                      <a:lnTo>
                        <a:pt x="772" y="3"/>
                      </a:lnTo>
                      <a:lnTo>
                        <a:pt x="773" y="3"/>
                      </a:lnTo>
                      <a:lnTo>
                        <a:pt x="773" y="3"/>
                      </a:lnTo>
                      <a:lnTo>
                        <a:pt x="773" y="6"/>
                      </a:lnTo>
                      <a:lnTo>
                        <a:pt x="773" y="4"/>
                      </a:lnTo>
                      <a:lnTo>
                        <a:pt x="774" y="4"/>
                      </a:lnTo>
                      <a:lnTo>
                        <a:pt x="774" y="3"/>
                      </a:lnTo>
                      <a:lnTo>
                        <a:pt x="774" y="8"/>
                      </a:lnTo>
                      <a:lnTo>
                        <a:pt x="774" y="6"/>
                      </a:lnTo>
                      <a:lnTo>
                        <a:pt x="775" y="6"/>
                      </a:lnTo>
                      <a:lnTo>
                        <a:pt x="775" y="3"/>
                      </a:lnTo>
                      <a:lnTo>
                        <a:pt x="775" y="6"/>
                      </a:lnTo>
                      <a:lnTo>
                        <a:pt x="775" y="6"/>
                      </a:lnTo>
                      <a:lnTo>
                        <a:pt x="776" y="6"/>
                      </a:lnTo>
                      <a:lnTo>
                        <a:pt x="776" y="3"/>
                      </a:lnTo>
                      <a:lnTo>
                        <a:pt x="776" y="6"/>
                      </a:lnTo>
                      <a:lnTo>
                        <a:pt x="776" y="4"/>
                      </a:lnTo>
                      <a:lnTo>
                        <a:pt x="777" y="4"/>
                      </a:lnTo>
                      <a:lnTo>
                        <a:pt x="777" y="2"/>
                      </a:lnTo>
                      <a:lnTo>
                        <a:pt x="777" y="7"/>
                      </a:lnTo>
                      <a:lnTo>
                        <a:pt x="777" y="5"/>
                      </a:lnTo>
                      <a:lnTo>
                        <a:pt x="778" y="5"/>
                      </a:lnTo>
                      <a:lnTo>
                        <a:pt x="778" y="3"/>
                      </a:lnTo>
                      <a:lnTo>
                        <a:pt x="778" y="8"/>
                      </a:lnTo>
                      <a:lnTo>
                        <a:pt x="778" y="5"/>
                      </a:lnTo>
                      <a:lnTo>
                        <a:pt x="779" y="5"/>
                      </a:lnTo>
                      <a:lnTo>
                        <a:pt x="779" y="2"/>
                      </a:lnTo>
                      <a:lnTo>
                        <a:pt x="779" y="6"/>
                      </a:lnTo>
                      <a:lnTo>
                        <a:pt x="779" y="6"/>
                      </a:lnTo>
                      <a:lnTo>
                        <a:pt x="780" y="6"/>
                      </a:lnTo>
                      <a:lnTo>
                        <a:pt x="780" y="2"/>
                      </a:lnTo>
                      <a:lnTo>
                        <a:pt x="780" y="6"/>
                      </a:lnTo>
                      <a:lnTo>
                        <a:pt x="780" y="2"/>
                      </a:lnTo>
                      <a:lnTo>
                        <a:pt x="781" y="2"/>
                      </a:lnTo>
                      <a:lnTo>
                        <a:pt x="781" y="1"/>
                      </a:lnTo>
                      <a:lnTo>
                        <a:pt x="781" y="5"/>
                      </a:lnTo>
                      <a:lnTo>
                        <a:pt x="781" y="2"/>
                      </a:lnTo>
                      <a:lnTo>
                        <a:pt x="782" y="2"/>
                      </a:lnTo>
                      <a:lnTo>
                        <a:pt x="782" y="2"/>
                      </a:lnTo>
                      <a:lnTo>
                        <a:pt x="782" y="6"/>
                      </a:lnTo>
                      <a:lnTo>
                        <a:pt x="782" y="5"/>
                      </a:lnTo>
                      <a:lnTo>
                        <a:pt x="783" y="5"/>
                      </a:lnTo>
                      <a:lnTo>
                        <a:pt x="783" y="2"/>
                      </a:lnTo>
                      <a:lnTo>
                        <a:pt x="783" y="5"/>
                      </a:lnTo>
                      <a:lnTo>
                        <a:pt x="783" y="2"/>
                      </a:lnTo>
                      <a:lnTo>
                        <a:pt x="784" y="2"/>
                      </a:lnTo>
                      <a:lnTo>
                        <a:pt x="784" y="1"/>
                      </a:lnTo>
                      <a:lnTo>
                        <a:pt x="784" y="6"/>
                      </a:lnTo>
                      <a:lnTo>
                        <a:pt x="784" y="6"/>
                      </a:lnTo>
                      <a:lnTo>
                        <a:pt x="785" y="6"/>
                      </a:lnTo>
                      <a:lnTo>
                        <a:pt x="785" y="2"/>
                      </a:lnTo>
                      <a:lnTo>
                        <a:pt x="785" y="5"/>
                      </a:lnTo>
                      <a:lnTo>
                        <a:pt x="785" y="4"/>
                      </a:lnTo>
                      <a:lnTo>
                        <a:pt x="786" y="4"/>
                      </a:lnTo>
                      <a:lnTo>
                        <a:pt x="786" y="2"/>
                      </a:lnTo>
                      <a:lnTo>
                        <a:pt x="786" y="5"/>
                      </a:lnTo>
                      <a:lnTo>
                        <a:pt x="786" y="5"/>
                      </a:lnTo>
                      <a:lnTo>
                        <a:pt x="787" y="5"/>
                      </a:lnTo>
                      <a:lnTo>
                        <a:pt x="787" y="2"/>
                      </a:lnTo>
                      <a:lnTo>
                        <a:pt x="787" y="8"/>
                      </a:lnTo>
                      <a:lnTo>
                        <a:pt x="787" y="8"/>
                      </a:lnTo>
                      <a:lnTo>
                        <a:pt x="788" y="8"/>
                      </a:lnTo>
                      <a:lnTo>
                        <a:pt x="788" y="1"/>
                      </a:lnTo>
                      <a:lnTo>
                        <a:pt x="788" y="8"/>
                      </a:lnTo>
                      <a:lnTo>
                        <a:pt x="788" y="1"/>
                      </a:lnTo>
                      <a:lnTo>
                        <a:pt x="789" y="1"/>
                      </a:lnTo>
                      <a:lnTo>
                        <a:pt x="789" y="0"/>
                      </a:lnTo>
                      <a:lnTo>
                        <a:pt x="789" y="3"/>
                      </a:lnTo>
                      <a:lnTo>
                        <a:pt x="789" y="3"/>
                      </a:lnTo>
                      <a:lnTo>
                        <a:pt x="790" y="3"/>
                      </a:lnTo>
                      <a:lnTo>
                        <a:pt x="790" y="1"/>
                      </a:lnTo>
                      <a:lnTo>
                        <a:pt x="790" y="6"/>
                      </a:lnTo>
                      <a:lnTo>
                        <a:pt x="790" y="2"/>
                      </a:lnTo>
                      <a:lnTo>
                        <a:pt x="791" y="2"/>
                      </a:lnTo>
                      <a:lnTo>
                        <a:pt x="791" y="0"/>
                      </a:lnTo>
                      <a:lnTo>
                        <a:pt x="791" y="5"/>
                      </a:lnTo>
                      <a:lnTo>
                        <a:pt x="791" y="3"/>
                      </a:lnTo>
                      <a:lnTo>
                        <a:pt x="792" y="3"/>
                      </a:lnTo>
                      <a:lnTo>
                        <a:pt x="792" y="0"/>
                      </a:lnTo>
                      <a:lnTo>
                        <a:pt x="792" y="5"/>
                      </a:lnTo>
                      <a:lnTo>
                        <a:pt x="792" y="4"/>
                      </a:lnTo>
                      <a:lnTo>
                        <a:pt x="793" y="4"/>
                      </a:lnTo>
                      <a:lnTo>
                        <a:pt x="793" y="2"/>
                      </a:lnTo>
                      <a:lnTo>
                        <a:pt x="793" y="6"/>
                      </a:lnTo>
                      <a:lnTo>
                        <a:pt x="793" y="2"/>
                      </a:lnTo>
                      <a:lnTo>
                        <a:pt x="794" y="2"/>
                      </a:lnTo>
                      <a:lnTo>
                        <a:pt x="794" y="1"/>
                      </a:lnTo>
                      <a:lnTo>
                        <a:pt x="794" y="6"/>
                      </a:lnTo>
                      <a:lnTo>
                        <a:pt x="794" y="3"/>
                      </a:lnTo>
                      <a:lnTo>
                        <a:pt x="795" y="3"/>
                      </a:lnTo>
                      <a:lnTo>
                        <a:pt x="795" y="1"/>
                      </a:lnTo>
                      <a:lnTo>
                        <a:pt x="795" y="5"/>
                      </a:lnTo>
                      <a:lnTo>
                        <a:pt x="795" y="4"/>
                      </a:lnTo>
                      <a:lnTo>
                        <a:pt x="796" y="4"/>
                      </a:lnTo>
                      <a:lnTo>
                        <a:pt x="796" y="1"/>
                      </a:lnTo>
                      <a:lnTo>
                        <a:pt x="796" y="5"/>
                      </a:lnTo>
                      <a:lnTo>
                        <a:pt x="796" y="3"/>
                      </a:lnTo>
                      <a:lnTo>
                        <a:pt x="797" y="3"/>
                      </a:lnTo>
                      <a:lnTo>
                        <a:pt x="797" y="2"/>
                      </a:lnTo>
                      <a:lnTo>
                        <a:pt x="797" y="5"/>
                      </a:lnTo>
                      <a:lnTo>
                        <a:pt x="797" y="2"/>
                      </a:lnTo>
                      <a:lnTo>
                        <a:pt x="798" y="2"/>
                      </a:lnTo>
                      <a:lnTo>
                        <a:pt x="798" y="1"/>
                      </a:lnTo>
                      <a:lnTo>
                        <a:pt x="798" y="5"/>
                      </a:lnTo>
                      <a:lnTo>
                        <a:pt x="798" y="4"/>
                      </a:lnTo>
                      <a:lnTo>
                        <a:pt x="799" y="4"/>
                      </a:lnTo>
                      <a:lnTo>
                        <a:pt x="799" y="2"/>
                      </a:lnTo>
                      <a:lnTo>
                        <a:pt x="799" y="4"/>
                      </a:lnTo>
                      <a:lnTo>
                        <a:pt x="799" y="3"/>
                      </a:lnTo>
                      <a:lnTo>
                        <a:pt x="800" y="3"/>
                      </a:lnTo>
                      <a:lnTo>
                        <a:pt x="800" y="2"/>
                      </a:lnTo>
                      <a:lnTo>
                        <a:pt x="800" y="5"/>
                      </a:lnTo>
                      <a:lnTo>
                        <a:pt x="800" y="4"/>
                      </a:lnTo>
                      <a:lnTo>
                        <a:pt x="801" y="4"/>
                      </a:lnTo>
                      <a:lnTo>
                        <a:pt x="801" y="2"/>
                      </a:lnTo>
                      <a:lnTo>
                        <a:pt x="801" y="5"/>
                      </a:lnTo>
                      <a:lnTo>
                        <a:pt x="801" y="2"/>
                      </a:lnTo>
                      <a:lnTo>
                        <a:pt x="802" y="2"/>
                      </a:lnTo>
                      <a:lnTo>
                        <a:pt x="802" y="1"/>
                      </a:lnTo>
                      <a:lnTo>
                        <a:pt x="802" y="5"/>
                      </a:lnTo>
                      <a:lnTo>
                        <a:pt x="802" y="5"/>
                      </a:lnTo>
                      <a:lnTo>
                        <a:pt x="803" y="5"/>
                      </a:lnTo>
                      <a:lnTo>
                        <a:pt x="803" y="1"/>
                      </a:lnTo>
                      <a:lnTo>
                        <a:pt x="803" y="4"/>
                      </a:lnTo>
                      <a:lnTo>
                        <a:pt x="803" y="2"/>
                      </a:lnTo>
                      <a:lnTo>
                        <a:pt x="804" y="2"/>
                      </a:lnTo>
                      <a:lnTo>
                        <a:pt x="804" y="1"/>
                      </a:lnTo>
                      <a:lnTo>
                        <a:pt x="804" y="11"/>
                      </a:lnTo>
                      <a:lnTo>
                        <a:pt x="804" y="11"/>
                      </a:lnTo>
                      <a:lnTo>
                        <a:pt x="805" y="11"/>
                      </a:lnTo>
                      <a:lnTo>
                        <a:pt x="805" y="5"/>
                      </a:lnTo>
                      <a:lnTo>
                        <a:pt x="805" y="16"/>
                      </a:lnTo>
                      <a:lnTo>
                        <a:pt x="805" y="5"/>
                      </a:lnTo>
                      <a:lnTo>
                        <a:pt x="806" y="5"/>
                      </a:lnTo>
                      <a:lnTo>
                        <a:pt x="806" y="4"/>
                      </a:lnTo>
                      <a:lnTo>
                        <a:pt x="806" y="8"/>
                      </a:lnTo>
                      <a:lnTo>
                        <a:pt x="806" y="4"/>
                      </a:lnTo>
                      <a:lnTo>
                        <a:pt x="807" y="4"/>
                      </a:lnTo>
                      <a:lnTo>
                        <a:pt x="807" y="3"/>
                      </a:lnTo>
                      <a:lnTo>
                        <a:pt x="807" y="8"/>
                      </a:lnTo>
                      <a:lnTo>
                        <a:pt x="807" y="5"/>
                      </a:lnTo>
                      <a:lnTo>
                        <a:pt x="808" y="5"/>
                      </a:lnTo>
                      <a:lnTo>
                        <a:pt x="808" y="3"/>
                      </a:lnTo>
                      <a:lnTo>
                        <a:pt x="808" y="7"/>
                      </a:lnTo>
                      <a:lnTo>
                        <a:pt x="808" y="4"/>
                      </a:lnTo>
                      <a:lnTo>
                        <a:pt x="809" y="4"/>
                      </a:lnTo>
                      <a:lnTo>
                        <a:pt x="809" y="4"/>
                      </a:lnTo>
                      <a:lnTo>
                        <a:pt x="809" y="5"/>
                      </a:lnTo>
                      <a:lnTo>
                        <a:pt x="809" y="5"/>
                      </a:lnTo>
                      <a:lnTo>
                        <a:pt x="810" y="5"/>
                      </a:lnTo>
                      <a:lnTo>
                        <a:pt x="810" y="3"/>
                      </a:lnTo>
                      <a:lnTo>
                        <a:pt x="810" y="7"/>
                      </a:lnTo>
                      <a:lnTo>
                        <a:pt x="810" y="5"/>
                      </a:lnTo>
                      <a:lnTo>
                        <a:pt x="811" y="5"/>
                      </a:lnTo>
                      <a:lnTo>
                        <a:pt x="811" y="3"/>
                      </a:lnTo>
                      <a:lnTo>
                        <a:pt x="811" y="6"/>
                      </a:lnTo>
                      <a:lnTo>
                        <a:pt x="811" y="4"/>
                      </a:lnTo>
                      <a:lnTo>
                        <a:pt x="812" y="4"/>
                      </a:lnTo>
                      <a:lnTo>
                        <a:pt x="812" y="4"/>
                      </a:lnTo>
                      <a:lnTo>
                        <a:pt x="812" y="6"/>
                      </a:lnTo>
                      <a:lnTo>
                        <a:pt x="812" y="4"/>
                      </a:lnTo>
                      <a:lnTo>
                        <a:pt x="813" y="4"/>
                      </a:lnTo>
                      <a:lnTo>
                        <a:pt x="813" y="3"/>
                      </a:lnTo>
                      <a:lnTo>
                        <a:pt x="813" y="8"/>
                      </a:lnTo>
                      <a:lnTo>
                        <a:pt x="813" y="4"/>
                      </a:lnTo>
                      <a:lnTo>
                        <a:pt x="814" y="4"/>
                      </a:lnTo>
                      <a:lnTo>
                        <a:pt x="814" y="2"/>
                      </a:lnTo>
                      <a:lnTo>
                        <a:pt x="814" y="7"/>
                      </a:lnTo>
                      <a:lnTo>
                        <a:pt x="814" y="5"/>
                      </a:lnTo>
                      <a:lnTo>
                        <a:pt x="815" y="5"/>
                      </a:lnTo>
                      <a:lnTo>
                        <a:pt x="815" y="3"/>
                      </a:lnTo>
                      <a:lnTo>
                        <a:pt x="815" y="6"/>
                      </a:lnTo>
                      <a:lnTo>
                        <a:pt x="815" y="5"/>
                      </a:lnTo>
                      <a:lnTo>
                        <a:pt x="816" y="5"/>
                      </a:lnTo>
                      <a:lnTo>
                        <a:pt x="816" y="2"/>
                      </a:lnTo>
                      <a:lnTo>
                        <a:pt x="816" y="6"/>
                      </a:lnTo>
                      <a:lnTo>
                        <a:pt x="816" y="5"/>
                      </a:lnTo>
                      <a:lnTo>
                        <a:pt x="817" y="5"/>
                      </a:lnTo>
                      <a:lnTo>
                        <a:pt x="817" y="2"/>
                      </a:lnTo>
                      <a:lnTo>
                        <a:pt x="817" y="6"/>
                      </a:lnTo>
                      <a:lnTo>
                        <a:pt x="817" y="4"/>
                      </a:lnTo>
                      <a:lnTo>
                        <a:pt x="818" y="4"/>
                      </a:lnTo>
                      <a:lnTo>
                        <a:pt x="818" y="2"/>
                      </a:lnTo>
                      <a:lnTo>
                        <a:pt x="818" y="6"/>
                      </a:lnTo>
                      <a:lnTo>
                        <a:pt x="818" y="5"/>
                      </a:lnTo>
                      <a:lnTo>
                        <a:pt x="819" y="5"/>
                      </a:lnTo>
                      <a:lnTo>
                        <a:pt x="819" y="2"/>
                      </a:lnTo>
                      <a:lnTo>
                        <a:pt x="819" y="6"/>
                      </a:lnTo>
                      <a:lnTo>
                        <a:pt x="819" y="2"/>
                      </a:lnTo>
                      <a:lnTo>
                        <a:pt x="820" y="2"/>
                      </a:lnTo>
                      <a:lnTo>
                        <a:pt x="820" y="2"/>
                      </a:lnTo>
                      <a:lnTo>
                        <a:pt x="820" y="6"/>
                      </a:lnTo>
                      <a:lnTo>
                        <a:pt x="820" y="2"/>
                      </a:lnTo>
                      <a:lnTo>
                        <a:pt x="821" y="2"/>
                      </a:lnTo>
                      <a:lnTo>
                        <a:pt x="821" y="2"/>
                      </a:lnTo>
                      <a:lnTo>
                        <a:pt x="821" y="6"/>
                      </a:lnTo>
                      <a:lnTo>
                        <a:pt x="821" y="3"/>
                      </a:lnTo>
                      <a:lnTo>
                        <a:pt x="822" y="3"/>
                      </a:lnTo>
                      <a:lnTo>
                        <a:pt x="822" y="1"/>
                      </a:lnTo>
                      <a:lnTo>
                        <a:pt x="822" y="5"/>
                      </a:lnTo>
                      <a:lnTo>
                        <a:pt x="822" y="5"/>
                      </a:lnTo>
                      <a:lnTo>
                        <a:pt x="823" y="5"/>
                      </a:lnTo>
                      <a:lnTo>
                        <a:pt x="823" y="2"/>
                      </a:lnTo>
                      <a:lnTo>
                        <a:pt x="823" y="5"/>
                      </a:lnTo>
                      <a:lnTo>
                        <a:pt x="823" y="3"/>
                      </a:lnTo>
                      <a:lnTo>
                        <a:pt x="824" y="3"/>
                      </a:lnTo>
                      <a:lnTo>
                        <a:pt x="824" y="3"/>
                      </a:lnTo>
                      <a:lnTo>
                        <a:pt x="824" y="5"/>
                      </a:lnTo>
                      <a:lnTo>
                        <a:pt x="824" y="5"/>
                      </a:lnTo>
                      <a:lnTo>
                        <a:pt x="825" y="5"/>
                      </a:lnTo>
                      <a:lnTo>
                        <a:pt x="825" y="1"/>
                      </a:lnTo>
                      <a:lnTo>
                        <a:pt x="825" y="5"/>
                      </a:lnTo>
                      <a:lnTo>
                        <a:pt x="825" y="2"/>
                      </a:lnTo>
                      <a:lnTo>
                        <a:pt x="826" y="2"/>
                      </a:lnTo>
                      <a:lnTo>
                        <a:pt x="826" y="0"/>
                      </a:lnTo>
                      <a:lnTo>
                        <a:pt x="826" y="5"/>
                      </a:lnTo>
                      <a:lnTo>
                        <a:pt x="826" y="5"/>
                      </a:lnTo>
                      <a:lnTo>
                        <a:pt x="827" y="5"/>
                      </a:lnTo>
                      <a:lnTo>
                        <a:pt x="827" y="1"/>
                      </a:lnTo>
                      <a:lnTo>
                        <a:pt x="827" y="6"/>
                      </a:lnTo>
                      <a:lnTo>
                        <a:pt x="827" y="4"/>
                      </a:lnTo>
                      <a:lnTo>
                        <a:pt x="828" y="4"/>
                      </a:lnTo>
                      <a:lnTo>
                        <a:pt x="828" y="2"/>
                      </a:lnTo>
                      <a:lnTo>
                        <a:pt x="828" y="6"/>
                      </a:lnTo>
                      <a:lnTo>
                        <a:pt x="828" y="4"/>
                      </a:lnTo>
                      <a:lnTo>
                        <a:pt x="829" y="4"/>
                      </a:lnTo>
                      <a:lnTo>
                        <a:pt x="829" y="2"/>
                      </a:lnTo>
                      <a:lnTo>
                        <a:pt x="829" y="5"/>
                      </a:lnTo>
                      <a:lnTo>
                        <a:pt x="829" y="5"/>
                      </a:lnTo>
                      <a:lnTo>
                        <a:pt x="830" y="5"/>
                      </a:lnTo>
                      <a:lnTo>
                        <a:pt x="830" y="4"/>
                      </a:lnTo>
                      <a:lnTo>
                        <a:pt x="830" y="8"/>
                      </a:lnTo>
                      <a:lnTo>
                        <a:pt x="830" y="6"/>
                      </a:lnTo>
                      <a:lnTo>
                        <a:pt x="831" y="6"/>
                      </a:lnTo>
                      <a:lnTo>
                        <a:pt x="831" y="3"/>
                      </a:lnTo>
                      <a:lnTo>
                        <a:pt x="831" y="6"/>
                      </a:lnTo>
                      <a:lnTo>
                        <a:pt x="831" y="3"/>
                      </a:lnTo>
                      <a:lnTo>
                        <a:pt x="832" y="3"/>
                      </a:lnTo>
                      <a:lnTo>
                        <a:pt x="832" y="4"/>
                      </a:lnTo>
                      <a:lnTo>
                        <a:pt x="832" y="7"/>
                      </a:lnTo>
                      <a:lnTo>
                        <a:pt x="832" y="5"/>
                      </a:lnTo>
                      <a:lnTo>
                        <a:pt x="833" y="5"/>
                      </a:lnTo>
                      <a:lnTo>
                        <a:pt x="833" y="5"/>
                      </a:lnTo>
                      <a:lnTo>
                        <a:pt x="833" y="8"/>
                      </a:lnTo>
                      <a:lnTo>
                        <a:pt x="833" y="5"/>
                      </a:lnTo>
                      <a:lnTo>
                        <a:pt x="834" y="5"/>
                      </a:lnTo>
                      <a:lnTo>
                        <a:pt x="834" y="4"/>
                      </a:lnTo>
                      <a:lnTo>
                        <a:pt x="834" y="6"/>
                      </a:lnTo>
                      <a:lnTo>
                        <a:pt x="834" y="5"/>
                      </a:lnTo>
                      <a:lnTo>
                        <a:pt x="835" y="5"/>
                      </a:lnTo>
                      <a:lnTo>
                        <a:pt x="835" y="4"/>
                      </a:lnTo>
                      <a:lnTo>
                        <a:pt x="835" y="8"/>
                      </a:lnTo>
                      <a:lnTo>
                        <a:pt x="835" y="5"/>
                      </a:lnTo>
                      <a:lnTo>
                        <a:pt x="836" y="5"/>
                      </a:lnTo>
                      <a:lnTo>
                        <a:pt x="836" y="2"/>
                      </a:lnTo>
                      <a:lnTo>
                        <a:pt x="836" y="6"/>
                      </a:lnTo>
                      <a:lnTo>
                        <a:pt x="836" y="4"/>
                      </a:lnTo>
                      <a:lnTo>
                        <a:pt x="837" y="4"/>
                      </a:lnTo>
                      <a:lnTo>
                        <a:pt x="837" y="4"/>
                      </a:lnTo>
                      <a:lnTo>
                        <a:pt x="837" y="8"/>
                      </a:lnTo>
                      <a:lnTo>
                        <a:pt x="837" y="5"/>
                      </a:lnTo>
                      <a:lnTo>
                        <a:pt x="838" y="5"/>
                      </a:lnTo>
                      <a:lnTo>
                        <a:pt x="838" y="4"/>
                      </a:lnTo>
                      <a:lnTo>
                        <a:pt x="838" y="6"/>
                      </a:lnTo>
                      <a:lnTo>
                        <a:pt x="838" y="5"/>
                      </a:lnTo>
                      <a:lnTo>
                        <a:pt x="839" y="5"/>
                      </a:lnTo>
                      <a:lnTo>
                        <a:pt x="839" y="3"/>
                      </a:lnTo>
                      <a:lnTo>
                        <a:pt x="839" y="8"/>
                      </a:lnTo>
                      <a:lnTo>
                        <a:pt x="839" y="4"/>
                      </a:lnTo>
                      <a:lnTo>
                        <a:pt x="840" y="4"/>
                      </a:lnTo>
                      <a:lnTo>
                        <a:pt x="840" y="2"/>
                      </a:lnTo>
                      <a:lnTo>
                        <a:pt x="840" y="6"/>
                      </a:lnTo>
                      <a:lnTo>
                        <a:pt x="840" y="4"/>
                      </a:lnTo>
                      <a:lnTo>
                        <a:pt x="841" y="4"/>
                      </a:lnTo>
                      <a:lnTo>
                        <a:pt x="841" y="3"/>
                      </a:lnTo>
                      <a:lnTo>
                        <a:pt x="841" y="6"/>
                      </a:lnTo>
                      <a:lnTo>
                        <a:pt x="841" y="4"/>
                      </a:lnTo>
                      <a:lnTo>
                        <a:pt x="842" y="4"/>
                      </a:lnTo>
                      <a:lnTo>
                        <a:pt x="842" y="2"/>
                      </a:lnTo>
                      <a:lnTo>
                        <a:pt x="842" y="7"/>
                      </a:lnTo>
                      <a:lnTo>
                        <a:pt x="842" y="6"/>
                      </a:lnTo>
                      <a:lnTo>
                        <a:pt x="843" y="6"/>
                      </a:lnTo>
                      <a:lnTo>
                        <a:pt x="843" y="3"/>
                      </a:lnTo>
                      <a:lnTo>
                        <a:pt x="843" y="8"/>
                      </a:lnTo>
                      <a:lnTo>
                        <a:pt x="843" y="5"/>
                      </a:lnTo>
                      <a:lnTo>
                        <a:pt x="844" y="5"/>
                      </a:lnTo>
                      <a:lnTo>
                        <a:pt x="844" y="4"/>
                      </a:lnTo>
                      <a:lnTo>
                        <a:pt x="844" y="7"/>
                      </a:lnTo>
                      <a:lnTo>
                        <a:pt x="844" y="4"/>
                      </a:lnTo>
                      <a:lnTo>
                        <a:pt x="845" y="4"/>
                      </a:lnTo>
                      <a:lnTo>
                        <a:pt x="845" y="4"/>
                      </a:lnTo>
                      <a:lnTo>
                        <a:pt x="845" y="8"/>
                      </a:lnTo>
                      <a:lnTo>
                        <a:pt x="845" y="5"/>
                      </a:lnTo>
                      <a:lnTo>
                        <a:pt x="846" y="5"/>
                      </a:lnTo>
                      <a:lnTo>
                        <a:pt x="846" y="3"/>
                      </a:lnTo>
                      <a:lnTo>
                        <a:pt x="846" y="7"/>
                      </a:lnTo>
                      <a:lnTo>
                        <a:pt x="846" y="6"/>
                      </a:lnTo>
                      <a:lnTo>
                        <a:pt x="847" y="6"/>
                      </a:lnTo>
                      <a:lnTo>
                        <a:pt x="847" y="3"/>
                      </a:lnTo>
                      <a:lnTo>
                        <a:pt x="847" y="7"/>
                      </a:lnTo>
                      <a:lnTo>
                        <a:pt x="847" y="5"/>
                      </a:lnTo>
                      <a:lnTo>
                        <a:pt x="848" y="5"/>
                      </a:lnTo>
                      <a:lnTo>
                        <a:pt x="848" y="4"/>
                      </a:lnTo>
                      <a:lnTo>
                        <a:pt x="848" y="6"/>
                      </a:lnTo>
                      <a:lnTo>
                        <a:pt x="848" y="4"/>
                      </a:lnTo>
                      <a:lnTo>
                        <a:pt x="849" y="4"/>
                      </a:lnTo>
                      <a:lnTo>
                        <a:pt x="849" y="4"/>
                      </a:lnTo>
                      <a:lnTo>
                        <a:pt x="849" y="8"/>
                      </a:lnTo>
                      <a:lnTo>
                        <a:pt x="849" y="5"/>
                      </a:lnTo>
                      <a:lnTo>
                        <a:pt x="850" y="5"/>
                      </a:lnTo>
                      <a:lnTo>
                        <a:pt x="850" y="3"/>
                      </a:lnTo>
                      <a:lnTo>
                        <a:pt x="850" y="8"/>
                      </a:lnTo>
                      <a:lnTo>
                        <a:pt x="850" y="7"/>
                      </a:lnTo>
                      <a:lnTo>
                        <a:pt x="851" y="7"/>
                      </a:lnTo>
                      <a:lnTo>
                        <a:pt x="851" y="3"/>
                      </a:lnTo>
                      <a:lnTo>
                        <a:pt x="851" y="6"/>
                      </a:lnTo>
                      <a:lnTo>
                        <a:pt x="851" y="4"/>
                      </a:lnTo>
                      <a:lnTo>
                        <a:pt x="852" y="4"/>
                      </a:lnTo>
                      <a:lnTo>
                        <a:pt x="852" y="5"/>
                      </a:lnTo>
                      <a:lnTo>
                        <a:pt x="852" y="9"/>
                      </a:lnTo>
                      <a:lnTo>
                        <a:pt x="852" y="5"/>
                      </a:lnTo>
                      <a:lnTo>
                        <a:pt x="853" y="5"/>
                      </a:lnTo>
                      <a:lnTo>
                        <a:pt x="853" y="4"/>
                      </a:lnTo>
                      <a:lnTo>
                        <a:pt x="853" y="8"/>
                      </a:lnTo>
                      <a:lnTo>
                        <a:pt x="853" y="4"/>
                      </a:lnTo>
                      <a:lnTo>
                        <a:pt x="854" y="4"/>
                      </a:lnTo>
                      <a:lnTo>
                        <a:pt x="854" y="4"/>
                      </a:lnTo>
                      <a:lnTo>
                        <a:pt x="854" y="8"/>
                      </a:lnTo>
                      <a:lnTo>
                        <a:pt x="854" y="6"/>
                      </a:lnTo>
                      <a:lnTo>
                        <a:pt x="855" y="6"/>
                      </a:lnTo>
                      <a:lnTo>
                        <a:pt x="855" y="4"/>
                      </a:lnTo>
                      <a:lnTo>
                        <a:pt x="855" y="8"/>
                      </a:lnTo>
                      <a:lnTo>
                        <a:pt x="855" y="6"/>
                      </a:lnTo>
                      <a:lnTo>
                        <a:pt x="856" y="6"/>
                      </a:lnTo>
                      <a:lnTo>
                        <a:pt x="856" y="5"/>
                      </a:lnTo>
                      <a:lnTo>
                        <a:pt x="856" y="8"/>
                      </a:lnTo>
                      <a:lnTo>
                        <a:pt x="856" y="5"/>
                      </a:lnTo>
                      <a:lnTo>
                        <a:pt x="857" y="5"/>
                      </a:lnTo>
                      <a:lnTo>
                        <a:pt x="857" y="3"/>
                      </a:lnTo>
                      <a:lnTo>
                        <a:pt x="857" y="7"/>
                      </a:lnTo>
                      <a:lnTo>
                        <a:pt x="857" y="6"/>
                      </a:lnTo>
                      <a:lnTo>
                        <a:pt x="858" y="6"/>
                      </a:lnTo>
                      <a:lnTo>
                        <a:pt x="858" y="4"/>
                      </a:lnTo>
                      <a:lnTo>
                        <a:pt x="858" y="7"/>
                      </a:lnTo>
                      <a:lnTo>
                        <a:pt x="858" y="5"/>
                      </a:lnTo>
                      <a:lnTo>
                        <a:pt x="859" y="5"/>
                      </a:lnTo>
                      <a:lnTo>
                        <a:pt x="859" y="3"/>
                      </a:lnTo>
                      <a:lnTo>
                        <a:pt x="859" y="6"/>
                      </a:lnTo>
                      <a:lnTo>
                        <a:pt x="859" y="5"/>
                      </a:lnTo>
                      <a:lnTo>
                        <a:pt x="860" y="5"/>
                      </a:lnTo>
                      <a:lnTo>
                        <a:pt x="860" y="3"/>
                      </a:lnTo>
                      <a:lnTo>
                        <a:pt x="860" y="7"/>
                      </a:lnTo>
                      <a:lnTo>
                        <a:pt x="860" y="6"/>
                      </a:lnTo>
                      <a:lnTo>
                        <a:pt x="861" y="6"/>
                      </a:lnTo>
                      <a:lnTo>
                        <a:pt x="861" y="5"/>
                      </a:lnTo>
                      <a:lnTo>
                        <a:pt x="861" y="8"/>
                      </a:lnTo>
                      <a:lnTo>
                        <a:pt x="861" y="5"/>
                      </a:lnTo>
                      <a:lnTo>
                        <a:pt x="862" y="5"/>
                      </a:lnTo>
                      <a:lnTo>
                        <a:pt x="862" y="3"/>
                      </a:lnTo>
                      <a:lnTo>
                        <a:pt x="862" y="7"/>
                      </a:lnTo>
                      <a:lnTo>
                        <a:pt x="862" y="5"/>
                      </a:lnTo>
                      <a:lnTo>
                        <a:pt x="863" y="5"/>
                      </a:lnTo>
                      <a:lnTo>
                        <a:pt x="863" y="5"/>
                      </a:lnTo>
                      <a:lnTo>
                        <a:pt x="863" y="8"/>
                      </a:lnTo>
                      <a:lnTo>
                        <a:pt x="863" y="6"/>
                      </a:lnTo>
                      <a:lnTo>
                        <a:pt x="864" y="6"/>
                      </a:lnTo>
                      <a:lnTo>
                        <a:pt x="864" y="2"/>
                      </a:lnTo>
                      <a:lnTo>
                        <a:pt x="864" y="7"/>
                      </a:lnTo>
                      <a:lnTo>
                        <a:pt x="864" y="6"/>
                      </a:lnTo>
                      <a:lnTo>
                        <a:pt x="865" y="6"/>
                      </a:lnTo>
                      <a:lnTo>
                        <a:pt x="865" y="4"/>
                      </a:lnTo>
                      <a:lnTo>
                        <a:pt x="865" y="6"/>
                      </a:lnTo>
                      <a:lnTo>
                        <a:pt x="865" y="5"/>
                      </a:lnTo>
                      <a:lnTo>
                        <a:pt x="866" y="5"/>
                      </a:lnTo>
                      <a:lnTo>
                        <a:pt x="866" y="4"/>
                      </a:lnTo>
                      <a:lnTo>
                        <a:pt x="866" y="6"/>
                      </a:lnTo>
                      <a:lnTo>
                        <a:pt x="866" y="6"/>
                      </a:lnTo>
                      <a:lnTo>
                        <a:pt x="867" y="6"/>
                      </a:lnTo>
                      <a:lnTo>
                        <a:pt x="867" y="4"/>
                      </a:lnTo>
                      <a:lnTo>
                        <a:pt x="867" y="8"/>
                      </a:lnTo>
                      <a:lnTo>
                        <a:pt x="867" y="6"/>
                      </a:lnTo>
                      <a:lnTo>
                        <a:pt x="868" y="6"/>
                      </a:lnTo>
                      <a:lnTo>
                        <a:pt x="868" y="5"/>
                      </a:lnTo>
                      <a:lnTo>
                        <a:pt x="868" y="9"/>
                      </a:lnTo>
                      <a:lnTo>
                        <a:pt x="868" y="6"/>
                      </a:lnTo>
                      <a:lnTo>
                        <a:pt x="869" y="6"/>
                      </a:lnTo>
                      <a:lnTo>
                        <a:pt x="869" y="4"/>
                      </a:lnTo>
                      <a:lnTo>
                        <a:pt x="869" y="7"/>
                      </a:lnTo>
                      <a:lnTo>
                        <a:pt x="869" y="6"/>
                      </a:lnTo>
                      <a:lnTo>
                        <a:pt x="870" y="6"/>
                      </a:lnTo>
                      <a:lnTo>
                        <a:pt x="870" y="3"/>
                      </a:lnTo>
                      <a:lnTo>
                        <a:pt x="870" y="8"/>
                      </a:lnTo>
                      <a:lnTo>
                        <a:pt x="870" y="5"/>
                      </a:lnTo>
                      <a:lnTo>
                        <a:pt x="871" y="5"/>
                      </a:lnTo>
                      <a:lnTo>
                        <a:pt x="871" y="5"/>
                      </a:lnTo>
                      <a:lnTo>
                        <a:pt x="871" y="8"/>
                      </a:lnTo>
                      <a:lnTo>
                        <a:pt x="871" y="6"/>
                      </a:lnTo>
                      <a:lnTo>
                        <a:pt x="872" y="6"/>
                      </a:lnTo>
                      <a:lnTo>
                        <a:pt x="872" y="5"/>
                      </a:lnTo>
                      <a:lnTo>
                        <a:pt x="872" y="8"/>
                      </a:lnTo>
                      <a:lnTo>
                        <a:pt x="872" y="6"/>
                      </a:lnTo>
                      <a:lnTo>
                        <a:pt x="873" y="6"/>
                      </a:lnTo>
                      <a:lnTo>
                        <a:pt x="873" y="5"/>
                      </a:lnTo>
                      <a:lnTo>
                        <a:pt x="873" y="8"/>
                      </a:lnTo>
                      <a:lnTo>
                        <a:pt x="873" y="6"/>
                      </a:lnTo>
                      <a:lnTo>
                        <a:pt x="874" y="6"/>
                      </a:lnTo>
                      <a:lnTo>
                        <a:pt x="874" y="5"/>
                      </a:lnTo>
                      <a:lnTo>
                        <a:pt x="874" y="9"/>
                      </a:lnTo>
                      <a:lnTo>
                        <a:pt x="874" y="8"/>
                      </a:lnTo>
                      <a:lnTo>
                        <a:pt x="875" y="8"/>
                      </a:lnTo>
                      <a:lnTo>
                        <a:pt x="875" y="6"/>
                      </a:lnTo>
                      <a:lnTo>
                        <a:pt x="875" y="9"/>
                      </a:lnTo>
                      <a:lnTo>
                        <a:pt x="875" y="6"/>
                      </a:lnTo>
                      <a:lnTo>
                        <a:pt x="876" y="6"/>
                      </a:lnTo>
                      <a:lnTo>
                        <a:pt x="876" y="5"/>
                      </a:lnTo>
                      <a:lnTo>
                        <a:pt x="876" y="9"/>
                      </a:lnTo>
                      <a:lnTo>
                        <a:pt x="876" y="6"/>
                      </a:lnTo>
                      <a:lnTo>
                        <a:pt x="877" y="6"/>
                      </a:lnTo>
                      <a:lnTo>
                        <a:pt x="877" y="5"/>
                      </a:lnTo>
                      <a:lnTo>
                        <a:pt x="877" y="8"/>
                      </a:lnTo>
                      <a:lnTo>
                        <a:pt x="877" y="8"/>
                      </a:lnTo>
                      <a:lnTo>
                        <a:pt x="878" y="8"/>
                      </a:lnTo>
                      <a:lnTo>
                        <a:pt x="878" y="3"/>
                      </a:lnTo>
                      <a:lnTo>
                        <a:pt x="878" y="8"/>
                      </a:lnTo>
                      <a:lnTo>
                        <a:pt x="878" y="7"/>
                      </a:lnTo>
                      <a:lnTo>
                        <a:pt x="879" y="7"/>
                      </a:lnTo>
                      <a:lnTo>
                        <a:pt x="879" y="5"/>
                      </a:lnTo>
                      <a:lnTo>
                        <a:pt x="879" y="8"/>
                      </a:lnTo>
                      <a:lnTo>
                        <a:pt x="879" y="5"/>
                      </a:lnTo>
                      <a:lnTo>
                        <a:pt x="880" y="5"/>
                      </a:lnTo>
                      <a:lnTo>
                        <a:pt x="880" y="5"/>
                      </a:lnTo>
                      <a:lnTo>
                        <a:pt x="880" y="8"/>
                      </a:lnTo>
                      <a:lnTo>
                        <a:pt x="880" y="5"/>
                      </a:lnTo>
                      <a:lnTo>
                        <a:pt x="881" y="5"/>
                      </a:lnTo>
                      <a:lnTo>
                        <a:pt x="881" y="5"/>
                      </a:lnTo>
                      <a:lnTo>
                        <a:pt x="881" y="8"/>
                      </a:lnTo>
                      <a:lnTo>
                        <a:pt x="881" y="6"/>
                      </a:lnTo>
                      <a:lnTo>
                        <a:pt x="882" y="6"/>
                      </a:lnTo>
                      <a:lnTo>
                        <a:pt x="882" y="6"/>
                      </a:lnTo>
                      <a:lnTo>
                        <a:pt x="882" y="10"/>
                      </a:lnTo>
                      <a:lnTo>
                        <a:pt x="882" y="6"/>
                      </a:lnTo>
                      <a:lnTo>
                        <a:pt x="883" y="6"/>
                      </a:lnTo>
                      <a:lnTo>
                        <a:pt x="883" y="6"/>
                      </a:lnTo>
                      <a:lnTo>
                        <a:pt x="883" y="9"/>
                      </a:lnTo>
                      <a:lnTo>
                        <a:pt x="883" y="6"/>
                      </a:lnTo>
                      <a:lnTo>
                        <a:pt x="884" y="6"/>
                      </a:lnTo>
                      <a:lnTo>
                        <a:pt x="884" y="5"/>
                      </a:lnTo>
                      <a:lnTo>
                        <a:pt x="884" y="8"/>
                      </a:lnTo>
                      <a:lnTo>
                        <a:pt x="884" y="5"/>
                      </a:lnTo>
                      <a:lnTo>
                        <a:pt x="885" y="5"/>
                      </a:lnTo>
                      <a:lnTo>
                        <a:pt x="885" y="5"/>
                      </a:lnTo>
                      <a:lnTo>
                        <a:pt x="885" y="8"/>
                      </a:lnTo>
                      <a:lnTo>
                        <a:pt x="885" y="7"/>
                      </a:lnTo>
                      <a:lnTo>
                        <a:pt x="886" y="7"/>
                      </a:lnTo>
                      <a:lnTo>
                        <a:pt x="886" y="5"/>
                      </a:lnTo>
                      <a:lnTo>
                        <a:pt x="886" y="9"/>
                      </a:lnTo>
                      <a:lnTo>
                        <a:pt x="886" y="6"/>
                      </a:lnTo>
                      <a:lnTo>
                        <a:pt x="887" y="6"/>
                      </a:lnTo>
                      <a:lnTo>
                        <a:pt x="887" y="5"/>
                      </a:lnTo>
                      <a:lnTo>
                        <a:pt x="887" y="10"/>
                      </a:lnTo>
                      <a:lnTo>
                        <a:pt x="887" y="7"/>
                      </a:lnTo>
                      <a:lnTo>
                        <a:pt x="888" y="7"/>
                      </a:lnTo>
                      <a:lnTo>
                        <a:pt x="888" y="5"/>
                      </a:lnTo>
                      <a:lnTo>
                        <a:pt x="888" y="9"/>
                      </a:lnTo>
                      <a:lnTo>
                        <a:pt x="888" y="8"/>
                      </a:lnTo>
                      <a:lnTo>
                        <a:pt x="889" y="8"/>
                      </a:lnTo>
                      <a:lnTo>
                        <a:pt x="889" y="5"/>
                      </a:lnTo>
                      <a:lnTo>
                        <a:pt x="889" y="8"/>
                      </a:lnTo>
                      <a:lnTo>
                        <a:pt x="889" y="6"/>
                      </a:lnTo>
                      <a:lnTo>
                        <a:pt x="890" y="6"/>
                      </a:lnTo>
                      <a:lnTo>
                        <a:pt x="890" y="5"/>
                      </a:lnTo>
                      <a:lnTo>
                        <a:pt x="890" y="9"/>
                      </a:lnTo>
                      <a:lnTo>
                        <a:pt x="890" y="9"/>
                      </a:lnTo>
                      <a:lnTo>
                        <a:pt x="891" y="9"/>
                      </a:lnTo>
                      <a:lnTo>
                        <a:pt x="891" y="5"/>
                      </a:lnTo>
                      <a:lnTo>
                        <a:pt x="891" y="11"/>
                      </a:lnTo>
                      <a:lnTo>
                        <a:pt x="891" y="5"/>
                      </a:lnTo>
                      <a:lnTo>
                        <a:pt x="892" y="5"/>
                      </a:lnTo>
                      <a:lnTo>
                        <a:pt x="892" y="5"/>
                      </a:lnTo>
                      <a:lnTo>
                        <a:pt x="892" y="8"/>
                      </a:lnTo>
                      <a:lnTo>
                        <a:pt x="892" y="5"/>
                      </a:lnTo>
                      <a:lnTo>
                        <a:pt x="893" y="5"/>
                      </a:lnTo>
                      <a:lnTo>
                        <a:pt x="893" y="5"/>
                      </a:lnTo>
                      <a:lnTo>
                        <a:pt x="893" y="9"/>
                      </a:lnTo>
                      <a:lnTo>
                        <a:pt x="893" y="6"/>
                      </a:lnTo>
                      <a:lnTo>
                        <a:pt x="894" y="6"/>
                      </a:lnTo>
                      <a:lnTo>
                        <a:pt x="894" y="5"/>
                      </a:lnTo>
                      <a:lnTo>
                        <a:pt x="894" y="8"/>
                      </a:lnTo>
                      <a:lnTo>
                        <a:pt x="894" y="6"/>
                      </a:lnTo>
                      <a:lnTo>
                        <a:pt x="895" y="6"/>
                      </a:lnTo>
                      <a:lnTo>
                        <a:pt x="895" y="3"/>
                      </a:lnTo>
                      <a:lnTo>
                        <a:pt x="895" y="7"/>
                      </a:lnTo>
                      <a:lnTo>
                        <a:pt x="895" y="5"/>
                      </a:lnTo>
                      <a:lnTo>
                        <a:pt x="896" y="5"/>
                      </a:lnTo>
                      <a:lnTo>
                        <a:pt x="896" y="5"/>
                      </a:lnTo>
                      <a:lnTo>
                        <a:pt x="896" y="8"/>
                      </a:lnTo>
                      <a:lnTo>
                        <a:pt x="896" y="8"/>
                      </a:lnTo>
                      <a:lnTo>
                        <a:pt x="897" y="8"/>
                      </a:lnTo>
                      <a:lnTo>
                        <a:pt x="897" y="5"/>
                      </a:lnTo>
                      <a:lnTo>
                        <a:pt x="897" y="8"/>
                      </a:lnTo>
                      <a:lnTo>
                        <a:pt x="897" y="8"/>
                      </a:lnTo>
                      <a:lnTo>
                        <a:pt x="898" y="8"/>
                      </a:lnTo>
                      <a:lnTo>
                        <a:pt x="898" y="5"/>
                      </a:lnTo>
                      <a:lnTo>
                        <a:pt x="898" y="10"/>
                      </a:lnTo>
                      <a:lnTo>
                        <a:pt x="898" y="8"/>
                      </a:lnTo>
                      <a:lnTo>
                        <a:pt x="899" y="8"/>
                      </a:lnTo>
                      <a:lnTo>
                        <a:pt x="899" y="4"/>
                      </a:lnTo>
                      <a:lnTo>
                        <a:pt x="899" y="8"/>
                      </a:lnTo>
                      <a:lnTo>
                        <a:pt x="899" y="5"/>
                      </a:lnTo>
                      <a:lnTo>
                        <a:pt x="900" y="5"/>
                      </a:lnTo>
                      <a:lnTo>
                        <a:pt x="900" y="3"/>
                      </a:lnTo>
                      <a:lnTo>
                        <a:pt x="900" y="8"/>
                      </a:lnTo>
                      <a:lnTo>
                        <a:pt x="900" y="6"/>
                      </a:lnTo>
                      <a:lnTo>
                        <a:pt x="901" y="6"/>
                      </a:lnTo>
                      <a:lnTo>
                        <a:pt x="901" y="5"/>
                      </a:lnTo>
                      <a:lnTo>
                        <a:pt x="901" y="9"/>
                      </a:lnTo>
                      <a:lnTo>
                        <a:pt x="901" y="8"/>
                      </a:lnTo>
                      <a:lnTo>
                        <a:pt x="902" y="8"/>
                      </a:lnTo>
                      <a:lnTo>
                        <a:pt x="902" y="6"/>
                      </a:lnTo>
                      <a:lnTo>
                        <a:pt x="902" y="9"/>
                      </a:lnTo>
                      <a:lnTo>
                        <a:pt x="902" y="6"/>
                      </a:lnTo>
                      <a:lnTo>
                        <a:pt x="903" y="6"/>
                      </a:lnTo>
                      <a:lnTo>
                        <a:pt x="903" y="5"/>
                      </a:lnTo>
                      <a:lnTo>
                        <a:pt x="903" y="8"/>
                      </a:lnTo>
                      <a:lnTo>
                        <a:pt x="903" y="8"/>
                      </a:lnTo>
                      <a:lnTo>
                        <a:pt x="904" y="8"/>
                      </a:lnTo>
                      <a:lnTo>
                        <a:pt x="904" y="5"/>
                      </a:lnTo>
                      <a:lnTo>
                        <a:pt x="904" y="8"/>
                      </a:lnTo>
                      <a:lnTo>
                        <a:pt x="904" y="6"/>
                      </a:lnTo>
                      <a:lnTo>
                        <a:pt x="905" y="6"/>
                      </a:lnTo>
                      <a:lnTo>
                        <a:pt x="905" y="5"/>
                      </a:lnTo>
                      <a:lnTo>
                        <a:pt x="905" y="10"/>
                      </a:lnTo>
                      <a:lnTo>
                        <a:pt x="905" y="8"/>
                      </a:lnTo>
                      <a:lnTo>
                        <a:pt x="906" y="8"/>
                      </a:lnTo>
                      <a:lnTo>
                        <a:pt x="906" y="6"/>
                      </a:lnTo>
                      <a:lnTo>
                        <a:pt x="906" y="8"/>
                      </a:lnTo>
                      <a:lnTo>
                        <a:pt x="906" y="8"/>
                      </a:lnTo>
                      <a:lnTo>
                        <a:pt x="907" y="8"/>
                      </a:lnTo>
                      <a:lnTo>
                        <a:pt x="907" y="5"/>
                      </a:lnTo>
                      <a:lnTo>
                        <a:pt x="907" y="9"/>
                      </a:lnTo>
                      <a:lnTo>
                        <a:pt x="907" y="6"/>
                      </a:lnTo>
                      <a:lnTo>
                        <a:pt x="908" y="6"/>
                      </a:lnTo>
                      <a:lnTo>
                        <a:pt x="908" y="6"/>
                      </a:lnTo>
                      <a:lnTo>
                        <a:pt x="908" y="10"/>
                      </a:lnTo>
                      <a:lnTo>
                        <a:pt x="908" y="8"/>
                      </a:lnTo>
                      <a:lnTo>
                        <a:pt x="909" y="8"/>
                      </a:lnTo>
                      <a:lnTo>
                        <a:pt x="909" y="6"/>
                      </a:lnTo>
                      <a:lnTo>
                        <a:pt x="909" y="10"/>
                      </a:lnTo>
                      <a:lnTo>
                        <a:pt x="909" y="7"/>
                      </a:lnTo>
                      <a:lnTo>
                        <a:pt x="910" y="7"/>
                      </a:lnTo>
                      <a:lnTo>
                        <a:pt x="910" y="6"/>
                      </a:lnTo>
                      <a:lnTo>
                        <a:pt x="910" y="10"/>
                      </a:lnTo>
                      <a:lnTo>
                        <a:pt x="910" y="9"/>
                      </a:lnTo>
                      <a:lnTo>
                        <a:pt x="911" y="9"/>
                      </a:lnTo>
                      <a:lnTo>
                        <a:pt x="911" y="6"/>
                      </a:lnTo>
                      <a:lnTo>
                        <a:pt x="911" y="10"/>
                      </a:lnTo>
                      <a:lnTo>
                        <a:pt x="911" y="9"/>
                      </a:lnTo>
                      <a:lnTo>
                        <a:pt x="912" y="9"/>
                      </a:lnTo>
                      <a:lnTo>
                        <a:pt x="912" y="5"/>
                      </a:lnTo>
                      <a:lnTo>
                        <a:pt x="912" y="10"/>
                      </a:lnTo>
                      <a:lnTo>
                        <a:pt x="912" y="7"/>
                      </a:lnTo>
                      <a:lnTo>
                        <a:pt x="913" y="7"/>
                      </a:lnTo>
                      <a:lnTo>
                        <a:pt x="913" y="6"/>
                      </a:lnTo>
                      <a:lnTo>
                        <a:pt x="913" y="10"/>
                      </a:lnTo>
                      <a:lnTo>
                        <a:pt x="913" y="9"/>
                      </a:lnTo>
                      <a:lnTo>
                        <a:pt x="914" y="9"/>
                      </a:lnTo>
                      <a:lnTo>
                        <a:pt x="914" y="6"/>
                      </a:lnTo>
                      <a:lnTo>
                        <a:pt x="914" y="9"/>
                      </a:lnTo>
                      <a:lnTo>
                        <a:pt x="914" y="8"/>
                      </a:lnTo>
                      <a:lnTo>
                        <a:pt x="915" y="8"/>
                      </a:lnTo>
                      <a:lnTo>
                        <a:pt x="915" y="5"/>
                      </a:lnTo>
                      <a:lnTo>
                        <a:pt x="915" y="8"/>
                      </a:lnTo>
                      <a:lnTo>
                        <a:pt x="915" y="8"/>
                      </a:lnTo>
                      <a:lnTo>
                        <a:pt x="916" y="8"/>
                      </a:lnTo>
                      <a:lnTo>
                        <a:pt x="916" y="6"/>
                      </a:lnTo>
                      <a:lnTo>
                        <a:pt x="916" y="9"/>
                      </a:lnTo>
                      <a:lnTo>
                        <a:pt x="916" y="6"/>
                      </a:lnTo>
                      <a:lnTo>
                        <a:pt x="917" y="6"/>
                      </a:lnTo>
                      <a:lnTo>
                        <a:pt x="917" y="5"/>
                      </a:lnTo>
                      <a:lnTo>
                        <a:pt x="917" y="10"/>
                      </a:lnTo>
                      <a:lnTo>
                        <a:pt x="917" y="6"/>
                      </a:lnTo>
                      <a:lnTo>
                        <a:pt x="918" y="6"/>
                      </a:lnTo>
                      <a:lnTo>
                        <a:pt x="918" y="5"/>
                      </a:lnTo>
                      <a:lnTo>
                        <a:pt x="918" y="10"/>
                      </a:lnTo>
                      <a:lnTo>
                        <a:pt x="918" y="8"/>
                      </a:lnTo>
                      <a:lnTo>
                        <a:pt x="919" y="8"/>
                      </a:lnTo>
                      <a:lnTo>
                        <a:pt x="919" y="6"/>
                      </a:lnTo>
                      <a:lnTo>
                        <a:pt x="919" y="10"/>
                      </a:lnTo>
                      <a:lnTo>
                        <a:pt x="919" y="6"/>
                      </a:lnTo>
                      <a:lnTo>
                        <a:pt x="920" y="6"/>
                      </a:lnTo>
                      <a:lnTo>
                        <a:pt x="920" y="5"/>
                      </a:lnTo>
                      <a:lnTo>
                        <a:pt x="920" y="9"/>
                      </a:lnTo>
                      <a:lnTo>
                        <a:pt x="920" y="7"/>
                      </a:lnTo>
                      <a:lnTo>
                        <a:pt x="921" y="7"/>
                      </a:lnTo>
                      <a:lnTo>
                        <a:pt x="921" y="4"/>
                      </a:lnTo>
                      <a:lnTo>
                        <a:pt x="921" y="9"/>
                      </a:lnTo>
                      <a:lnTo>
                        <a:pt x="921" y="6"/>
                      </a:lnTo>
                      <a:lnTo>
                        <a:pt x="922" y="6"/>
                      </a:lnTo>
                      <a:lnTo>
                        <a:pt x="922" y="5"/>
                      </a:lnTo>
                      <a:lnTo>
                        <a:pt x="922" y="9"/>
                      </a:lnTo>
                      <a:lnTo>
                        <a:pt x="922" y="8"/>
                      </a:lnTo>
                      <a:lnTo>
                        <a:pt x="923" y="8"/>
                      </a:lnTo>
                      <a:lnTo>
                        <a:pt x="923" y="6"/>
                      </a:lnTo>
                      <a:lnTo>
                        <a:pt x="923" y="10"/>
                      </a:lnTo>
                      <a:lnTo>
                        <a:pt x="923" y="7"/>
                      </a:lnTo>
                      <a:lnTo>
                        <a:pt x="924" y="7"/>
                      </a:lnTo>
                      <a:lnTo>
                        <a:pt x="924" y="6"/>
                      </a:lnTo>
                      <a:lnTo>
                        <a:pt x="924" y="9"/>
                      </a:lnTo>
                      <a:lnTo>
                        <a:pt x="924" y="6"/>
                      </a:lnTo>
                      <a:lnTo>
                        <a:pt x="925" y="6"/>
                      </a:lnTo>
                      <a:lnTo>
                        <a:pt x="925" y="5"/>
                      </a:lnTo>
                      <a:lnTo>
                        <a:pt x="925" y="8"/>
                      </a:lnTo>
                      <a:lnTo>
                        <a:pt x="925" y="5"/>
                      </a:lnTo>
                      <a:lnTo>
                        <a:pt x="926" y="5"/>
                      </a:lnTo>
                      <a:lnTo>
                        <a:pt x="926" y="5"/>
                      </a:lnTo>
                      <a:lnTo>
                        <a:pt x="926" y="8"/>
                      </a:lnTo>
                      <a:lnTo>
                        <a:pt x="926" y="8"/>
                      </a:lnTo>
                      <a:lnTo>
                        <a:pt x="927" y="8"/>
                      </a:lnTo>
                      <a:lnTo>
                        <a:pt x="927" y="5"/>
                      </a:lnTo>
                      <a:lnTo>
                        <a:pt x="927" y="9"/>
                      </a:lnTo>
                      <a:lnTo>
                        <a:pt x="927" y="6"/>
                      </a:lnTo>
                      <a:lnTo>
                        <a:pt x="928" y="6"/>
                      </a:lnTo>
                      <a:lnTo>
                        <a:pt x="928" y="6"/>
                      </a:lnTo>
                      <a:lnTo>
                        <a:pt x="928" y="10"/>
                      </a:lnTo>
                      <a:lnTo>
                        <a:pt x="928" y="8"/>
                      </a:lnTo>
                      <a:lnTo>
                        <a:pt x="929" y="8"/>
                      </a:lnTo>
                      <a:lnTo>
                        <a:pt x="929" y="5"/>
                      </a:lnTo>
                      <a:lnTo>
                        <a:pt x="929" y="8"/>
                      </a:lnTo>
                      <a:lnTo>
                        <a:pt x="929" y="8"/>
                      </a:lnTo>
                      <a:lnTo>
                        <a:pt x="930" y="8"/>
                      </a:lnTo>
                      <a:lnTo>
                        <a:pt x="930" y="6"/>
                      </a:lnTo>
                      <a:lnTo>
                        <a:pt x="930" y="9"/>
                      </a:lnTo>
                      <a:lnTo>
                        <a:pt x="930" y="6"/>
                      </a:lnTo>
                      <a:lnTo>
                        <a:pt x="931" y="6"/>
                      </a:lnTo>
                      <a:lnTo>
                        <a:pt x="931" y="5"/>
                      </a:lnTo>
                      <a:lnTo>
                        <a:pt x="931" y="9"/>
                      </a:lnTo>
                      <a:lnTo>
                        <a:pt x="931" y="6"/>
                      </a:lnTo>
                      <a:lnTo>
                        <a:pt x="932" y="6"/>
                      </a:lnTo>
                      <a:lnTo>
                        <a:pt x="932" y="5"/>
                      </a:lnTo>
                      <a:lnTo>
                        <a:pt x="932" y="9"/>
                      </a:lnTo>
                      <a:lnTo>
                        <a:pt x="932" y="6"/>
                      </a:lnTo>
                      <a:lnTo>
                        <a:pt x="933" y="6"/>
                      </a:lnTo>
                      <a:lnTo>
                        <a:pt x="933" y="5"/>
                      </a:lnTo>
                      <a:lnTo>
                        <a:pt x="933" y="9"/>
                      </a:lnTo>
                      <a:lnTo>
                        <a:pt x="933" y="6"/>
                      </a:lnTo>
                      <a:lnTo>
                        <a:pt x="934" y="6"/>
                      </a:lnTo>
                      <a:lnTo>
                        <a:pt x="934" y="5"/>
                      </a:lnTo>
                      <a:lnTo>
                        <a:pt x="934" y="9"/>
                      </a:lnTo>
                      <a:lnTo>
                        <a:pt x="934" y="6"/>
                      </a:lnTo>
                      <a:lnTo>
                        <a:pt x="935" y="6"/>
                      </a:lnTo>
                      <a:lnTo>
                        <a:pt x="935" y="5"/>
                      </a:lnTo>
                      <a:lnTo>
                        <a:pt x="935" y="9"/>
                      </a:lnTo>
                      <a:lnTo>
                        <a:pt x="935" y="9"/>
                      </a:lnTo>
                      <a:lnTo>
                        <a:pt x="936" y="9"/>
                      </a:lnTo>
                      <a:lnTo>
                        <a:pt x="936" y="6"/>
                      </a:lnTo>
                      <a:lnTo>
                        <a:pt x="936" y="10"/>
                      </a:lnTo>
                      <a:lnTo>
                        <a:pt x="936" y="6"/>
                      </a:lnTo>
                      <a:lnTo>
                        <a:pt x="937" y="6"/>
                      </a:lnTo>
                      <a:lnTo>
                        <a:pt x="937" y="6"/>
                      </a:lnTo>
                      <a:lnTo>
                        <a:pt x="937" y="9"/>
                      </a:lnTo>
                      <a:lnTo>
                        <a:pt x="937" y="6"/>
                      </a:lnTo>
                      <a:lnTo>
                        <a:pt x="938" y="6"/>
                      </a:lnTo>
                      <a:lnTo>
                        <a:pt x="938" y="5"/>
                      </a:lnTo>
                      <a:lnTo>
                        <a:pt x="938" y="9"/>
                      </a:lnTo>
                      <a:lnTo>
                        <a:pt x="938" y="6"/>
                      </a:lnTo>
                      <a:lnTo>
                        <a:pt x="939" y="6"/>
                      </a:lnTo>
                      <a:lnTo>
                        <a:pt x="939" y="5"/>
                      </a:lnTo>
                      <a:lnTo>
                        <a:pt x="939" y="9"/>
                      </a:lnTo>
                      <a:lnTo>
                        <a:pt x="939" y="5"/>
                      </a:lnTo>
                      <a:lnTo>
                        <a:pt x="940" y="5"/>
                      </a:lnTo>
                      <a:lnTo>
                        <a:pt x="940" y="5"/>
                      </a:lnTo>
                      <a:lnTo>
                        <a:pt x="940" y="10"/>
                      </a:lnTo>
                      <a:lnTo>
                        <a:pt x="940" y="8"/>
                      </a:lnTo>
                      <a:lnTo>
                        <a:pt x="941" y="8"/>
                      </a:lnTo>
                      <a:lnTo>
                        <a:pt x="941" y="6"/>
                      </a:lnTo>
                      <a:lnTo>
                        <a:pt x="941" y="12"/>
                      </a:lnTo>
                      <a:lnTo>
                        <a:pt x="941" y="8"/>
                      </a:lnTo>
                      <a:lnTo>
                        <a:pt x="942" y="8"/>
                      </a:lnTo>
                      <a:lnTo>
                        <a:pt x="942" y="7"/>
                      </a:lnTo>
                      <a:lnTo>
                        <a:pt x="942" y="10"/>
                      </a:lnTo>
                      <a:lnTo>
                        <a:pt x="942" y="10"/>
                      </a:lnTo>
                      <a:lnTo>
                        <a:pt x="943" y="10"/>
                      </a:lnTo>
                      <a:lnTo>
                        <a:pt x="943" y="8"/>
                      </a:lnTo>
                      <a:lnTo>
                        <a:pt x="943" y="12"/>
                      </a:lnTo>
                      <a:lnTo>
                        <a:pt x="943" y="9"/>
                      </a:lnTo>
                      <a:lnTo>
                        <a:pt x="944" y="9"/>
                      </a:lnTo>
                      <a:lnTo>
                        <a:pt x="944" y="8"/>
                      </a:lnTo>
                      <a:lnTo>
                        <a:pt x="944" y="13"/>
                      </a:lnTo>
                      <a:lnTo>
                        <a:pt x="944" y="12"/>
                      </a:lnTo>
                      <a:lnTo>
                        <a:pt x="945" y="12"/>
                      </a:lnTo>
                      <a:lnTo>
                        <a:pt x="945" y="8"/>
                      </a:lnTo>
                      <a:lnTo>
                        <a:pt x="945" y="13"/>
                      </a:lnTo>
                      <a:lnTo>
                        <a:pt x="945" y="10"/>
                      </a:lnTo>
                      <a:lnTo>
                        <a:pt x="946" y="10"/>
                      </a:lnTo>
                      <a:lnTo>
                        <a:pt x="946" y="9"/>
                      </a:lnTo>
                      <a:lnTo>
                        <a:pt x="946" y="13"/>
                      </a:lnTo>
                      <a:lnTo>
                        <a:pt x="946" y="10"/>
                      </a:lnTo>
                      <a:lnTo>
                        <a:pt x="947" y="10"/>
                      </a:lnTo>
                      <a:lnTo>
                        <a:pt x="947" y="8"/>
                      </a:lnTo>
                      <a:lnTo>
                        <a:pt x="947" y="12"/>
                      </a:lnTo>
                      <a:lnTo>
                        <a:pt x="947" y="9"/>
                      </a:lnTo>
                      <a:lnTo>
                        <a:pt x="948" y="9"/>
                      </a:lnTo>
                      <a:lnTo>
                        <a:pt x="948" y="8"/>
                      </a:lnTo>
                      <a:lnTo>
                        <a:pt x="948" y="10"/>
                      </a:lnTo>
                      <a:lnTo>
                        <a:pt x="948" y="9"/>
                      </a:lnTo>
                      <a:lnTo>
                        <a:pt x="949" y="9"/>
                      </a:lnTo>
                      <a:lnTo>
                        <a:pt x="949" y="8"/>
                      </a:lnTo>
                      <a:lnTo>
                        <a:pt x="949" y="12"/>
                      </a:lnTo>
                      <a:lnTo>
                        <a:pt x="949" y="12"/>
                      </a:lnTo>
                      <a:lnTo>
                        <a:pt x="950" y="12"/>
                      </a:lnTo>
                      <a:lnTo>
                        <a:pt x="950" y="8"/>
                      </a:lnTo>
                      <a:lnTo>
                        <a:pt x="950" y="13"/>
                      </a:lnTo>
                      <a:lnTo>
                        <a:pt x="950" y="10"/>
                      </a:lnTo>
                      <a:lnTo>
                        <a:pt x="951" y="10"/>
                      </a:lnTo>
                      <a:lnTo>
                        <a:pt x="951" y="6"/>
                      </a:lnTo>
                      <a:lnTo>
                        <a:pt x="951" y="11"/>
                      </a:lnTo>
                      <a:lnTo>
                        <a:pt x="951" y="8"/>
                      </a:lnTo>
                      <a:lnTo>
                        <a:pt x="952" y="8"/>
                      </a:lnTo>
                      <a:lnTo>
                        <a:pt x="952" y="7"/>
                      </a:lnTo>
                      <a:lnTo>
                        <a:pt x="952" y="13"/>
                      </a:lnTo>
                      <a:lnTo>
                        <a:pt x="952" y="10"/>
                      </a:lnTo>
                      <a:lnTo>
                        <a:pt x="953" y="10"/>
                      </a:lnTo>
                      <a:lnTo>
                        <a:pt x="953" y="8"/>
                      </a:lnTo>
                      <a:lnTo>
                        <a:pt x="953" y="11"/>
                      </a:lnTo>
                      <a:lnTo>
                        <a:pt x="953" y="11"/>
                      </a:lnTo>
                      <a:lnTo>
                        <a:pt x="954" y="11"/>
                      </a:lnTo>
                      <a:lnTo>
                        <a:pt x="954" y="8"/>
                      </a:lnTo>
                      <a:lnTo>
                        <a:pt x="954" y="12"/>
                      </a:lnTo>
                      <a:lnTo>
                        <a:pt x="954" y="8"/>
                      </a:lnTo>
                      <a:lnTo>
                        <a:pt x="955" y="8"/>
                      </a:lnTo>
                      <a:lnTo>
                        <a:pt x="955" y="8"/>
                      </a:lnTo>
                      <a:lnTo>
                        <a:pt x="955" y="11"/>
                      </a:lnTo>
                      <a:lnTo>
                        <a:pt x="955" y="11"/>
                      </a:lnTo>
                      <a:lnTo>
                        <a:pt x="956" y="11"/>
                      </a:lnTo>
                      <a:lnTo>
                        <a:pt x="956" y="9"/>
                      </a:lnTo>
                      <a:lnTo>
                        <a:pt x="956" y="12"/>
                      </a:lnTo>
                      <a:lnTo>
                        <a:pt x="956" y="10"/>
                      </a:lnTo>
                      <a:lnTo>
                        <a:pt x="957" y="10"/>
                      </a:lnTo>
                      <a:lnTo>
                        <a:pt x="957" y="8"/>
                      </a:lnTo>
                      <a:lnTo>
                        <a:pt x="957" y="12"/>
                      </a:lnTo>
                      <a:lnTo>
                        <a:pt x="957" y="10"/>
                      </a:lnTo>
                      <a:lnTo>
                        <a:pt x="958" y="10"/>
                      </a:lnTo>
                      <a:lnTo>
                        <a:pt x="958" y="9"/>
                      </a:lnTo>
                      <a:lnTo>
                        <a:pt x="958" y="12"/>
                      </a:lnTo>
                      <a:lnTo>
                        <a:pt x="958" y="12"/>
                      </a:lnTo>
                      <a:lnTo>
                        <a:pt x="959" y="12"/>
                      </a:lnTo>
                      <a:lnTo>
                        <a:pt x="959" y="8"/>
                      </a:lnTo>
                      <a:lnTo>
                        <a:pt x="959" y="12"/>
                      </a:lnTo>
                      <a:lnTo>
                        <a:pt x="959" y="8"/>
                      </a:lnTo>
                      <a:lnTo>
                        <a:pt x="960" y="8"/>
                      </a:lnTo>
                      <a:lnTo>
                        <a:pt x="960" y="9"/>
                      </a:lnTo>
                      <a:lnTo>
                        <a:pt x="960" y="12"/>
                      </a:lnTo>
                      <a:lnTo>
                        <a:pt x="960" y="9"/>
                      </a:lnTo>
                      <a:lnTo>
                        <a:pt x="961" y="9"/>
                      </a:lnTo>
                      <a:lnTo>
                        <a:pt x="961" y="9"/>
                      </a:lnTo>
                      <a:lnTo>
                        <a:pt x="961" y="13"/>
                      </a:lnTo>
                      <a:lnTo>
                        <a:pt x="961" y="10"/>
                      </a:lnTo>
                      <a:lnTo>
                        <a:pt x="962" y="10"/>
                      </a:lnTo>
                      <a:lnTo>
                        <a:pt x="962" y="8"/>
                      </a:lnTo>
                      <a:lnTo>
                        <a:pt x="962" y="12"/>
                      </a:lnTo>
                      <a:lnTo>
                        <a:pt x="962" y="10"/>
                      </a:lnTo>
                      <a:lnTo>
                        <a:pt x="963" y="10"/>
                      </a:lnTo>
                      <a:lnTo>
                        <a:pt x="963" y="8"/>
                      </a:lnTo>
                      <a:lnTo>
                        <a:pt x="963" y="12"/>
                      </a:lnTo>
                      <a:lnTo>
                        <a:pt x="963" y="12"/>
                      </a:lnTo>
                      <a:lnTo>
                        <a:pt x="964" y="12"/>
                      </a:lnTo>
                      <a:lnTo>
                        <a:pt x="964" y="10"/>
                      </a:lnTo>
                      <a:lnTo>
                        <a:pt x="964" y="13"/>
                      </a:lnTo>
                      <a:lnTo>
                        <a:pt x="964" y="10"/>
                      </a:lnTo>
                      <a:lnTo>
                        <a:pt x="965" y="10"/>
                      </a:lnTo>
                      <a:lnTo>
                        <a:pt x="965" y="8"/>
                      </a:lnTo>
                      <a:lnTo>
                        <a:pt x="965" y="13"/>
                      </a:lnTo>
                      <a:lnTo>
                        <a:pt x="965" y="12"/>
                      </a:lnTo>
                      <a:lnTo>
                        <a:pt x="966" y="12"/>
                      </a:lnTo>
                      <a:lnTo>
                        <a:pt x="966" y="9"/>
                      </a:lnTo>
                      <a:lnTo>
                        <a:pt x="966" y="13"/>
                      </a:lnTo>
                      <a:lnTo>
                        <a:pt x="966" y="10"/>
                      </a:lnTo>
                      <a:lnTo>
                        <a:pt x="967" y="10"/>
                      </a:lnTo>
                      <a:lnTo>
                        <a:pt x="967" y="10"/>
                      </a:lnTo>
                      <a:lnTo>
                        <a:pt x="967" y="13"/>
                      </a:lnTo>
                      <a:lnTo>
                        <a:pt x="967" y="10"/>
                      </a:lnTo>
                      <a:lnTo>
                        <a:pt x="968" y="10"/>
                      </a:lnTo>
                      <a:lnTo>
                        <a:pt x="968" y="9"/>
                      </a:lnTo>
                      <a:lnTo>
                        <a:pt x="968" y="13"/>
                      </a:lnTo>
                      <a:lnTo>
                        <a:pt x="968" y="10"/>
                      </a:lnTo>
                      <a:lnTo>
                        <a:pt x="969" y="10"/>
                      </a:lnTo>
                      <a:lnTo>
                        <a:pt x="969" y="10"/>
                      </a:lnTo>
                      <a:lnTo>
                        <a:pt x="969" y="12"/>
                      </a:lnTo>
                      <a:lnTo>
                        <a:pt x="969" y="12"/>
                      </a:lnTo>
                      <a:lnTo>
                        <a:pt x="970" y="12"/>
                      </a:lnTo>
                      <a:lnTo>
                        <a:pt x="970" y="9"/>
                      </a:lnTo>
                      <a:lnTo>
                        <a:pt x="970" y="12"/>
                      </a:lnTo>
                      <a:lnTo>
                        <a:pt x="970" y="10"/>
                      </a:lnTo>
                      <a:lnTo>
                        <a:pt x="971" y="10"/>
                      </a:lnTo>
                      <a:lnTo>
                        <a:pt x="971" y="9"/>
                      </a:lnTo>
                      <a:lnTo>
                        <a:pt x="971" y="13"/>
                      </a:lnTo>
                      <a:lnTo>
                        <a:pt x="971" y="12"/>
                      </a:lnTo>
                      <a:lnTo>
                        <a:pt x="972" y="12"/>
                      </a:lnTo>
                      <a:lnTo>
                        <a:pt x="972" y="9"/>
                      </a:lnTo>
                      <a:lnTo>
                        <a:pt x="972" y="13"/>
                      </a:lnTo>
                      <a:lnTo>
                        <a:pt x="972" y="9"/>
                      </a:lnTo>
                      <a:lnTo>
                        <a:pt x="973" y="9"/>
                      </a:lnTo>
                      <a:lnTo>
                        <a:pt x="973" y="9"/>
                      </a:lnTo>
                      <a:lnTo>
                        <a:pt x="973" y="13"/>
                      </a:lnTo>
                      <a:lnTo>
                        <a:pt x="973" y="10"/>
                      </a:lnTo>
                      <a:lnTo>
                        <a:pt x="974" y="10"/>
                      </a:lnTo>
                      <a:lnTo>
                        <a:pt x="974" y="9"/>
                      </a:lnTo>
                      <a:lnTo>
                        <a:pt x="974" y="13"/>
                      </a:lnTo>
                      <a:lnTo>
                        <a:pt x="974" y="11"/>
                      </a:lnTo>
                      <a:lnTo>
                        <a:pt x="975" y="11"/>
                      </a:lnTo>
                      <a:lnTo>
                        <a:pt x="975" y="8"/>
                      </a:lnTo>
                      <a:lnTo>
                        <a:pt x="975" y="13"/>
                      </a:lnTo>
                      <a:lnTo>
                        <a:pt x="975" y="9"/>
                      </a:lnTo>
                      <a:lnTo>
                        <a:pt x="976" y="9"/>
                      </a:lnTo>
                      <a:lnTo>
                        <a:pt x="976" y="9"/>
                      </a:lnTo>
                      <a:lnTo>
                        <a:pt x="976" y="12"/>
                      </a:lnTo>
                      <a:lnTo>
                        <a:pt x="976" y="9"/>
                      </a:lnTo>
                      <a:lnTo>
                        <a:pt x="977" y="9"/>
                      </a:lnTo>
                      <a:lnTo>
                        <a:pt x="977" y="8"/>
                      </a:lnTo>
                      <a:lnTo>
                        <a:pt x="977" y="12"/>
                      </a:lnTo>
                      <a:lnTo>
                        <a:pt x="977" y="9"/>
                      </a:lnTo>
                      <a:lnTo>
                        <a:pt x="978" y="9"/>
                      </a:lnTo>
                      <a:lnTo>
                        <a:pt x="978" y="8"/>
                      </a:lnTo>
                      <a:lnTo>
                        <a:pt x="978" y="12"/>
                      </a:lnTo>
                      <a:lnTo>
                        <a:pt x="978" y="11"/>
                      </a:lnTo>
                      <a:lnTo>
                        <a:pt x="979" y="11"/>
                      </a:lnTo>
                      <a:lnTo>
                        <a:pt x="979" y="10"/>
                      </a:lnTo>
                      <a:lnTo>
                        <a:pt x="979" y="12"/>
                      </a:lnTo>
                      <a:lnTo>
                        <a:pt x="979" y="10"/>
                      </a:lnTo>
                      <a:lnTo>
                        <a:pt x="980" y="10"/>
                      </a:lnTo>
                      <a:lnTo>
                        <a:pt x="980" y="8"/>
                      </a:lnTo>
                      <a:lnTo>
                        <a:pt x="980" y="12"/>
                      </a:lnTo>
                      <a:lnTo>
                        <a:pt x="980" y="9"/>
                      </a:lnTo>
                      <a:lnTo>
                        <a:pt x="981" y="9"/>
                      </a:lnTo>
                      <a:lnTo>
                        <a:pt x="981" y="9"/>
                      </a:lnTo>
                      <a:lnTo>
                        <a:pt x="981" y="11"/>
                      </a:lnTo>
                      <a:lnTo>
                        <a:pt x="981" y="9"/>
                      </a:lnTo>
                      <a:lnTo>
                        <a:pt x="982" y="9"/>
                      </a:lnTo>
                      <a:lnTo>
                        <a:pt x="982" y="9"/>
                      </a:lnTo>
                      <a:lnTo>
                        <a:pt x="982" y="12"/>
                      </a:lnTo>
                      <a:lnTo>
                        <a:pt x="982" y="12"/>
                      </a:lnTo>
                      <a:lnTo>
                        <a:pt x="983" y="12"/>
                      </a:lnTo>
                      <a:lnTo>
                        <a:pt x="983" y="9"/>
                      </a:lnTo>
                      <a:lnTo>
                        <a:pt x="983" y="13"/>
                      </a:lnTo>
                      <a:lnTo>
                        <a:pt x="983" y="12"/>
                      </a:lnTo>
                      <a:lnTo>
                        <a:pt x="984" y="12"/>
                      </a:lnTo>
                      <a:lnTo>
                        <a:pt x="984" y="9"/>
                      </a:lnTo>
                      <a:lnTo>
                        <a:pt x="984" y="12"/>
                      </a:lnTo>
                      <a:lnTo>
                        <a:pt x="984" y="9"/>
                      </a:lnTo>
                      <a:lnTo>
                        <a:pt x="985" y="9"/>
                      </a:lnTo>
                      <a:lnTo>
                        <a:pt x="985" y="9"/>
                      </a:lnTo>
                      <a:lnTo>
                        <a:pt x="985" y="12"/>
                      </a:lnTo>
                      <a:lnTo>
                        <a:pt x="985" y="9"/>
                      </a:lnTo>
                      <a:lnTo>
                        <a:pt x="986" y="9"/>
                      </a:lnTo>
                      <a:lnTo>
                        <a:pt x="986" y="9"/>
                      </a:lnTo>
                      <a:lnTo>
                        <a:pt x="986" y="13"/>
                      </a:lnTo>
                      <a:lnTo>
                        <a:pt x="986" y="12"/>
                      </a:lnTo>
                      <a:lnTo>
                        <a:pt x="987" y="12"/>
                      </a:lnTo>
                      <a:lnTo>
                        <a:pt x="987" y="8"/>
                      </a:lnTo>
                      <a:lnTo>
                        <a:pt x="987" y="13"/>
                      </a:lnTo>
                      <a:lnTo>
                        <a:pt x="987" y="10"/>
                      </a:lnTo>
                      <a:lnTo>
                        <a:pt x="988" y="10"/>
                      </a:lnTo>
                      <a:lnTo>
                        <a:pt x="988" y="8"/>
                      </a:lnTo>
                      <a:lnTo>
                        <a:pt x="988" y="12"/>
                      </a:lnTo>
                      <a:lnTo>
                        <a:pt x="988" y="9"/>
                      </a:lnTo>
                      <a:lnTo>
                        <a:pt x="989" y="9"/>
                      </a:lnTo>
                      <a:lnTo>
                        <a:pt x="989" y="8"/>
                      </a:lnTo>
                      <a:lnTo>
                        <a:pt x="989" y="12"/>
                      </a:lnTo>
                      <a:lnTo>
                        <a:pt x="989" y="9"/>
                      </a:lnTo>
                      <a:lnTo>
                        <a:pt x="990" y="9"/>
                      </a:lnTo>
                      <a:lnTo>
                        <a:pt x="990" y="7"/>
                      </a:lnTo>
                      <a:lnTo>
                        <a:pt x="990" y="12"/>
                      </a:lnTo>
                      <a:lnTo>
                        <a:pt x="990" y="9"/>
                      </a:lnTo>
                      <a:lnTo>
                        <a:pt x="991" y="9"/>
                      </a:lnTo>
                      <a:lnTo>
                        <a:pt x="991" y="9"/>
                      </a:lnTo>
                      <a:lnTo>
                        <a:pt x="991" y="11"/>
                      </a:lnTo>
                      <a:lnTo>
                        <a:pt x="991" y="10"/>
                      </a:lnTo>
                      <a:lnTo>
                        <a:pt x="992" y="10"/>
                      </a:lnTo>
                      <a:lnTo>
                        <a:pt x="992" y="7"/>
                      </a:lnTo>
                      <a:lnTo>
                        <a:pt x="992" y="10"/>
                      </a:lnTo>
                      <a:lnTo>
                        <a:pt x="992" y="9"/>
                      </a:lnTo>
                      <a:lnTo>
                        <a:pt x="993" y="9"/>
                      </a:lnTo>
                      <a:lnTo>
                        <a:pt x="993" y="8"/>
                      </a:lnTo>
                      <a:lnTo>
                        <a:pt x="993" y="12"/>
                      </a:lnTo>
                      <a:lnTo>
                        <a:pt x="993" y="10"/>
                      </a:lnTo>
                      <a:lnTo>
                        <a:pt x="994" y="10"/>
                      </a:lnTo>
                      <a:lnTo>
                        <a:pt x="994" y="8"/>
                      </a:lnTo>
                      <a:lnTo>
                        <a:pt x="994" y="11"/>
                      </a:lnTo>
                      <a:lnTo>
                        <a:pt x="994" y="8"/>
                      </a:lnTo>
                      <a:lnTo>
                        <a:pt x="995" y="8"/>
                      </a:lnTo>
                      <a:lnTo>
                        <a:pt x="995" y="8"/>
                      </a:lnTo>
                      <a:lnTo>
                        <a:pt x="995" y="13"/>
                      </a:lnTo>
                      <a:lnTo>
                        <a:pt x="995" y="10"/>
                      </a:lnTo>
                      <a:lnTo>
                        <a:pt x="996" y="10"/>
                      </a:lnTo>
                      <a:lnTo>
                        <a:pt x="996" y="6"/>
                      </a:lnTo>
                      <a:lnTo>
                        <a:pt x="996" y="11"/>
                      </a:lnTo>
                      <a:lnTo>
                        <a:pt x="996" y="10"/>
                      </a:lnTo>
                      <a:lnTo>
                        <a:pt x="997" y="10"/>
                      </a:lnTo>
                      <a:lnTo>
                        <a:pt x="997" y="9"/>
                      </a:lnTo>
                      <a:lnTo>
                        <a:pt x="997" y="12"/>
                      </a:lnTo>
                      <a:lnTo>
                        <a:pt x="997" y="9"/>
                      </a:lnTo>
                      <a:lnTo>
                        <a:pt x="998" y="9"/>
                      </a:lnTo>
                      <a:lnTo>
                        <a:pt x="998" y="8"/>
                      </a:lnTo>
                      <a:lnTo>
                        <a:pt x="998" y="10"/>
                      </a:lnTo>
                      <a:lnTo>
                        <a:pt x="998" y="9"/>
                      </a:lnTo>
                      <a:lnTo>
                        <a:pt x="999" y="9"/>
                      </a:lnTo>
                      <a:lnTo>
                        <a:pt x="999" y="8"/>
                      </a:lnTo>
                      <a:lnTo>
                        <a:pt x="999" y="12"/>
                      </a:lnTo>
                      <a:lnTo>
                        <a:pt x="999" y="12"/>
                      </a:lnTo>
                      <a:lnTo>
                        <a:pt x="1000" y="12"/>
                      </a:lnTo>
                      <a:lnTo>
                        <a:pt x="1000" y="8"/>
                      </a:lnTo>
                      <a:lnTo>
                        <a:pt x="1000" y="10"/>
                      </a:lnTo>
                      <a:lnTo>
                        <a:pt x="1000" y="9"/>
                      </a:lnTo>
                      <a:lnTo>
                        <a:pt x="1001" y="9"/>
                      </a:lnTo>
                      <a:lnTo>
                        <a:pt x="1001" y="6"/>
                      </a:lnTo>
                      <a:lnTo>
                        <a:pt x="1001" y="10"/>
                      </a:lnTo>
                      <a:lnTo>
                        <a:pt x="1001" y="8"/>
                      </a:lnTo>
                      <a:lnTo>
                        <a:pt x="1002" y="8"/>
                      </a:lnTo>
                      <a:lnTo>
                        <a:pt x="1002" y="8"/>
                      </a:lnTo>
                      <a:lnTo>
                        <a:pt x="1002" y="10"/>
                      </a:lnTo>
                      <a:lnTo>
                        <a:pt x="1002" y="10"/>
                      </a:lnTo>
                      <a:lnTo>
                        <a:pt x="1003" y="10"/>
                      </a:lnTo>
                      <a:lnTo>
                        <a:pt x="1003" y="7"/>
                      </a:lnTo>
                      <a:lnTo>
                        <a:pt x="1003" y="10"/>
                      </a:lnTo>
                      <a:lnTo>
                        <a:pt x="1003" y="9"/>
                      </a:lnTo>
                      <a:lnTo>
                        <a:pt x="1004" y="9"/>
                      </a:lnTo>
                      <a:lnTo>
                        <a:pt x="1004" y="7"/>
                      </a:lnTo>
                      <a:lnTo>
                        <a:pt x="1004" y="9"/>
                      </a:lnTo>
                      <a:lnTo>
                        <a:pt x="1004" y="9"/>
                      </a:lnTo>
                      <a:lnTo>
                        <a:pt x="1005" y="9"/>
                      </a:lnTo>
                      <a:lnTo>
                        <a:pt x="1005" y="7"/>
                      </a:lnTo>
                      <a:lnTo>
                        <a:pt x="1005" y="10"/>
                      </a:lnTo>
                      <a:lnTo>
                        <a:pt x="1005" y="9"/>
                      </a:lnTo>
                      <a:lnTo>
                        <a:pt x="1006" y="9"/>
                      </a:lnTo>
                      <a:lnTo>
                        <a:pt x="1006" y="7"/>
                      </a:lnTo>
                      <a:lnTo>
                        <a:pt x="1006" y="10"/>
                      </a:lnTo>
                      <a:lnTo>
                        <a:pt x="1006" y="8"/>
                      </a:lnTo>
                      <a:lnTo>
                        <a:pt x="1007" y="8"/>
                      </a:lnTo>
                      <a:lnTo>
                        <a:pt x="1007" y="6"/>
                      </a:lnTo>
                      <a:lnTo>
                        <a:pt x="1007" y="9"/>
                      </a:lnTo>
                      <a:lnTo>
                        <a:pt x="1007" y="6"/>
                      </a:lnTo>
                      <a:lnTo>
                        <a:pt x="1008" y="6"/>
                      </a:lnTo>
                      <a:lnTo>
                        <a:pt x="1008" y="6"/>
                      </a:lnTo>
                      <a:lnTo>
                        <a:pt x="1008" y="10"/>
                      </a:lnTo>
                      <a:lnTo>
                        <a:pt x="1008" y="9"/>
                      </a:lnTo>
                      <a:lnTo>
                        <a:pt x="1009" y="9"/>
                      </a:lnTo>
                      <a:lnTo>
                        <a:pt x="1009" y="8"/>
                      </a:lnTo>
                      <a:lnTo>
                        <a:pt x="1009" y="11"/>
                      </a:lnTo>
                      <a:lnTo>
                        <a:pt x="1009" y="8"/>
                      </a:lnTo>
                      <a:lnTo>
                        <a:pt x="1010" y="8"/>
                      </a:lnTo>
                      <a:lnTo>
                        <a:pt x="1010" y="6"/>
                      </a:lnTo>
                      <a:lnTo>
                        <a:pt x="1010" y="10"/>
                      </a:lnTo>
                      <a:lnTo>
                        <a:pt x="1010" y="9"/>
                      </a:lnTo>
                      <a:lnTo>
                        <a:pt x="1011" y="9"/>
                      </a:lnTo>
                      <a:lnTo>
                        <a:pt x="1011" y="6"/>
                      </a:lnTo>
                      <a:lnTo>
                        <a:pt x="1011" y="11"/>
                      </a:lnTo>
                      <a:lnTo>
                        <a:pt x="1011" y="7"/>
                      </a:lnTo>
                      <a:lnTo>
                        <a:pt x="1012" y="7"/>
                      </a:lnTo>
                      <a:lnTo>
                        <a:pt x="1012" y="7"/>
                      </a:lnTo>
                      <a:lnTo>
                        <a:pt x="1012" y="9"/>
                      </a:lnTo>
                      <a:lnTo>
                        <a:pt x="1012" y="8"/>
                      </a:lnTo>
                      <a:lnTo>
                        <a:pt x="1013" y="8"/>
                      </a:lnTo>
                      <a:lnTo>
                        <a:pt x="1013" y="6"/>
                      </a:lnTo>
                      <a:lnTo>
                        <a:pt x="1013" y="9"/>
                      </a:lnTo>
                      <a:lnTo>
                        <a:pt x="1013" y="9"/>
                      </a:lnTo>
                      <a:lnTo>
                        <a:pt x="1014" y="9"/>
                      </a:lnTo>
                      <a:lnTo>
                        <a:pt x="1014" y="8"/>
                      </a:lnTo>
                      <a:lnTo>
                        <a:pt x="1014" y="10"/>
                      </a:lnTo>
                      <a:lnTo>
                        <a:pt x="1014" y="8"/>
                      </a:lnTo>
                      <a:lnTo>
                        <a:pt x="1015" y="8"/>
                      </a:lnTo>
                      <a:lnTo>
                        <a:pt x="1015" y="8"/>
                      </a:lnTo>
                      <a:lnTo>
                        <a:pt x="1015" y="12"/>
                      </a:lnTo>
                      <a:lnTo>
                        <a:pt x="1015" y="11"/>
                      </a:lnTo>
                      <a:lnTo>
                        <a:pt x="1016" y="11"/>
                      </a:lnTo>
                      <a:lnTo>
                        <a:pt x="1016" y="6"/>
                      </a:lnTo>
                      <a:lnTo>
                        <a:pt x="1016" y="12"/>
                      </a:lnTo>
                      <a:lnTo>
                        <a:pt x="1016" y="10"/>
                      </a:lnTo>
                      <a:lnTo>
                        <a:pt x="1017" y="10"/>
                      </a:lnTo>
                      <a:lnTo>
                        <a:pt x="1017" y="8"/>
                      </a:lnTo>
                      <a:lnTo>
                        <a:pt x="1017" y="13"/>
                      </a:lnTo>
                      <a:lnTo>
                        <a:pt x="1017" y="13"/>
                      </a:lnTo>
                      <a:lnTo>
                        <a:pt x="1018" y="13"/>
                      </a:lnTo>
                      <a:lnTo>
                        <a:pt x="1018" y="6"/>
                      </a:lnTo>
                      <a:lnTo>
                        <a:pt x="1018" y="10"/>
                      </a:lnTo>
                      <a:lnTo>
                        <a:pt x="1018" y="9"/>
                      </a:lnTo>
                      <a:lnTo>
                        <a:pt x="1019" y="9"/>
                      </a:lnTo>
                      <a:lnTo>
                        <a:pt x="1019" y="8"/>
                      </a:lnTo>
                      <a:lnTo>
                        <a:pt x="1019" y="10"/>
                      </a:lnTo>
                      <a:lnTo>
                        <a:pt x="1019" y="8"/>
                      </a:lnTo>
                      <a:lnTo>
                        <a:pt x="1020" y="8"/>
                      </a:lnTo>
                      <a:lnTo>
                        <a:pt x="1020" y="7"/>
                      </a:lnTo>
                      <a:lnTo>
                        <a:pt x="1020" y="12"/>
                      </a:lnTo>
                      <a:lnTo>
                        <a:pt x="1020" y="9"/>
                      </a:lnTo>
                      <a:lnTo>
                        <a:pt x="1021" y="9"/>
                      </a:lnTo>
                      <a:lnTo>
                        <a:pt x="1021" y="6"/>
                      </a:lnTo>
                      <a:lnTo>
                        <a:pt x="1021" y="10"/>
                      </a:lnTo>
                      <a:lnTo>
                        <a:pt x="1021" y="10"/>
                      </a:lnTo>
                      <a:lnTo>
                        <a:pt x="1022" y="10"/>
                      </a:lnTo>
                      <a:lnTo>
                        <a:pt x="1022" y="7"/>
                      </a:lnTo>
                      <a:lnTo>
                        <a:pt x="1022" y="11"/>
                      </a:lnTo>
                      <a:lnTo>
                        <a:pt x="1022" y="8"/>
                      </a:lnTo>
                      <a:lnTo>
                        <a:pt x="1023" y="8"/>
                      </a:lnTo>
                      <a:lnTo>
                        <a:pt x="1023" y="6"/>
                      </a:lnTo>
                      <a:lnTo>
                        <a:pt x="1023" y="12"/>
                      </a:lnTo>
                      <a:lnTo>
                        <a:pt x="1023" y="6"/>
                      </a:lnTo>
                      <a:lnTo>
                        <a:pt x="1024" y="6"/>
                      </a:lnTo>
                      <a:lnTo>
                        <a:pt x="1024" y="7"/>
                      </a:lnTo>
                      <a:lnTo>
                        <a:pt x="1024" y="13"/>
                      </a:lnTo>
                      <a:lnTo>
                        <a:pt x="1024" y="9"/>
                      </a:lnTo>
                      <a:lnTo>
                        <a:pt x="1025" y="9"/>
                      </a:lnTo>
                      <a:lnTo>
                        <a:pt x="1025" y="7"/>
                      </a:lnTo>
                      <a:lnTo>
                        <a:pt x="1025" y="11"/>
                      </a:lnTo>
                      <a:lnTo>
                        <a:pt x="1025" y="9"/>
                      </a:lnTo>
                      <a:lnTo>
                        <a:pt x="1026" y="9"/>
                      </a:lnTo>
                      <a:lnTo>
                        <a:pt x="1026" y="8"/>
                      </a:lnTo>
                      <a:lnTo>
                        <a:pt x="1026" y="10"/>
                      </a:lnTo>
                      <a:lnTo>
                        <a:pt x="1026" y="8"/>
                      </a:lnTo>
                      <a:lnTo>
                        <a:pt x="1027" y="8"/>
                      </a:lnTo>
                      <a:lnTo>
                        <a:pt x="1027" y="8"/>
                      </a:lnTo>
                      <a:lnTo>
                        <a:pt x="1027" y="10"/>
                      </a:lnTo>
                      <a:lnTo>
                        <a:pt x="1027" y="8"/>
                      </a:lnTo>
                      <a:lnTo>
                        <a:pt x="1028" y="8"/>
                      </a:lnTo>
                      <a:lnTo>
                        <a:pt x="1028" y="7"/>
                      </a:lnTo>
                      <a:lnTo>
                        <a:pt x="1028" y="10"/>
                      </a:lnTo>
                      <a:lnTo>
                        <a:pt x="1028" y="9"/>
                      </a:lnTo>
                      <a:lnTo>
                        <a:pt x="1029" y="9"/>
                      </a:lnTo>
                      <a:lnTo>
                        <a:pt x="1029" y="7"/>
                      </a:lnTo>
                      <a:lnTo>
                        <a:pt x="1029" y="10"/>
                      </a:lnTo>
                      <a:lnTo>
                        <a:pt x="1029" y="9"/>
                      </a:lnTo>
                      <a:lnTo>
                        <a:pt x="1030" y="9"/>
                      </a:lnTo>
                      <a:lnTo>
                        <a:pt x="1030" y="8"/>
                      </a:lnTo>
                      <a:lnTo>
                        <a:pt x="1030" y="10"/>
                      </a:lnTo>
                      <a:lnTo>
                        <a:pt x="1030" y="9"/>
                      </a:lnTo>
                      <a:lnTo>
                        <a:pt x="1031" y="9"/>
                      </a:lnTo>
                      <a:lnTo>
                        <a:pt x="1031" y="8"/>
                      </a:lnTo>
                      <a:lnTo>
                        <a:pt x="1031" y="10"/>
                      </a:lnTo>
                      <a:lnTo>
                        <a:pt x="1031" y="10"/>
                      </a:lnTo>
                      <a:lnTo>
                        <a:pt x="1032" y="10"/>
                      </a:lnTo>
                      <a:lnTo>
                        <a:pt x="1032" y="8"/>
                      </a:lnTo>
                      <a:lnTo>
                        <a:pt x="1032" y="10"/>
                      </a:lnTo>
                      <a:lnTo>
                        <a:pt x="1032" y="8"/>
                      </a:lnTo>
                      <a:lnTo>
                        <a:pt x="1033" y="8"/>
                      </a:lnTo>
                      <a:lnTo>
                        <a:pt x="1033" y="8"/>
                      </a:lnTo>
                      <a:lnTo>
                        <a:pt x="1033" y="12"/>
                      </a:lnTo>
                      <a:lnTo>
                        <a:pt x="1033" y="9"/>
                      </a:lnTo>
                      <a:lnTo>
                        <a:pt x="1034" y="9"/>
                      </a:lnTo>
                      <a:lnTo>
                        <a:pt x="1034" y="8"/>
                      </a:lnTo>
                      <a:lnTo>
                        <a:pt x="1034" y="12"/>
                      </a:lnTo>
                      <a:lnTo>
                        <a:pt x="1034" y="10"/>
                      </a:lnTo>
                      <a:lnTo>
                        <a:pt x="1035" y="10"/>
                      </a:lnTo>
                      <a:lnTo>
                        <a:pt x="1035" y="9"/>
                      </a:lnTo>
                      <a:lnTo>
                        <a:pt x="1035" y="10"/>
                      </a:lnTo>
                      <a:lnTo>
                        <a:pt x="1035" y="10"/>
                      </a:lnTo>
                      <a:lnTo>
                        <a:pt x="1036" y="10"/>
                      </a:lnTo>
                      <a:lnTo>
                        <a:pt x="1036" y="8"/>
                      </a:lnTo>
                      <a:lnTo>
                        <a:pt x="1036" y="14"/>
                      </a:lnTo>
                      <a:lnTo>
                        <a:pt x="1036" y="12"/>
                      </a:lnTo>
                      <a:lnTo>
                        <a:pt x="1037" y="12"/>
                      </a:lnTo>
                      <a:lnTo>
                        <a:pt x="1037" y="8"/>
                      </a:lnTo>
                      <a:lnTo>
                        <a:pt x="1037" y="13"/>
                      </a:lnTo>
                      <a:lnTo>
                        <a:pt x="1037" y="9"/>
                      </a:lnTo>
                      <a:lnTo>
                        <a:pt x="1038" y="9"/>
                      </a:lnTo>
                      <a:lnTo>
                        <a:pt x="1038" y="9"/>
                      </a:lnTo>
                      <a:lnTo>
                        <a:pt x="1038" y="12"/>
                      </a:lnTo>
                      <a:lnTo>
                        <a:pt x="1038" y="11"/>
                      </a:lnTo>
                      <a:lnTo>
                        <a:pt x="1039" y="11"/>
                      </a:lnTo>
                      <a:lnTo>
                        <a:pt x="1039" y="9"/>
                      </a:lnTo>
                      <a:lnTo>
                        <a:pt x="1039" y="12"/>
                      </a:lnTo>
                      <a:lnTo>
                        <a:pt x="1039" y="10"/>
                      </a:lnTo>
                      <a:lnTo>
                        <a:pt x="1040" y="10"/>
                      </a:lnTo>
                      <a:lnTo>
                        <a:pt x="1040" y="8"/>
                      </a:lnTo>
                      <a:lnTo>
                        <a:pt x="1040" y="13"/>
                      </a:lnTo>
                      <a:lnTo>
                        <a:pt x="1040" y="11"/>
                      </a:lnTo>
                      <a:lnTo>
                        <a:pt x="1041" y="11"/>
                      </a:lnTo>
                      <a:lnTo>
                        <a:pt x="1041" y="9"/>
                      </a:lnTo>
                      <a:lnTo>
                        <a:pt x="1041" y="12"/>
                      </a:lnTo>
                      <a:lnTo>
                        <a:pt x="1041" y="10"/>
                      </a:lnTo>
                      <a:lnTo>
                        <a:pt x="1042" y="10"/>
                      </a:lnTo>
                      <a:lnTo>
                        <a:pt x="1042" y="9"/>
                      </a:lnTo>
                      <a:lnTo>
                        <a:pt x="1042" y="13"/>
                      </a:lnTo>
                      <a:lnTo>
                        <a:pt x="1042" y="9"/>
                      </a:lnTo>
                      <a:lnTo>
                        <a:pt x="1043" y="9"/>
                      </a:lnTo>
                      <a:lnTo>
                        <a:pt x="1043" y="9"/>
                      </a:lnTo>
                      <a:lnTo>
                        <a:pt x="1043" y="12"/>
                      </a:lnTo>
                      <a:lnTo>
                        <a:pt x="1043" y="10"/>
                      </a:lnTo>
                      <a:lnTo>
                        <a:pt x="1044" y="10"/>
                      </a:lnTo>
                      <a:lnTo>
                        <a:pt x="1044" y="9"/>
                      </a:lnTo>
                      <a:lnTo>
                        <a:pt x="1044" y="12"/>
                      </a:lnTo>
                      <a:lnTo>
                        <a:pt x="1044" y="11"/>
                      </a:lnTo>
                      <a:lnTo>
                        <a:pt x="1045" y="11"/>
                      </a:lnTo>
                      <a:lnTo>
                        <a:pt x="1045" y="9"/>
                      </a:lnTo>
                      <a:lnTo>
                        <a:pt x="1045" y="12"/>
                      </a:lnTo>
                      <a:lnTo>
                        <a:pt x="1045" y="10"/>
                      </a:lnTo>
                      <a:lnTo>
                        <a:pt x="1046" y="10"/>
                      </a:lnTo>
                      <a:lnTo>
                        <a:pt x="1046" y="8"/>
                      </a:lnTo>
                      <a:lnTo>
                        <a:pt x="1046" y="12"/>
                      </a:lnTo>
                      <a:lnTo>
                        <a:pt x="1046" y="10"/>
                      </a:lnTo>
                      <a:lnTo>
                        <a:pt x="1047" y="10"/>
                      </a:lnTo>
                      <a:lnTo>
                        <a:pt x="1047" y="8"/>
                      </a:lnTo>
                      <a:lnTo>
                        <a:pt x="1047" y="12"/>
                      </a:lnTo>
                      <a:lnTo>
                        <a:pt x="1047" y="10"/>
                      </a:lnTo>
                      <a:lnTo>
                        <a:pt x="1048" y="10"/>
                      </a:lnTo>
                      <a:lnTo>
                        <a:pt x="1048" y="7"/>
                      </a:lnTo>
                      <a:lnTo>
                        <a:pt x="1048" y="13"/>
                      </a:lnTo>
                      <a:lnTo>
                        <a:pt x="1048" y="11"/>
                      </a:lnTo>
                      <a:lnTo>
                        <a:pt x="1049" y="11"/>
                      </a:lnTo>
                      <a:lnTo>
                        <a:pt x="1049" y="9"/>
                      </a:lnTo>
                      <a:lnTo>
                        <a:pt x="1049" y="13"/>
                      </a:lnTo>
                      <a:lnTo>
                        <a:pt x="1049" y="13"/>
                      </a:lnTo>
                      <a:lnTo>
                        <a:pt x="1050" y="13"/>
                      </a:lnTo>
                      <a:lnTo>
                        <a:pt x="1050" y="9"/>
                      </a:lnTo>
                      <a:lnTo>
                        <a:pt x="1050" y="12"/>
                      </a:lnTo>
                      <a:lnTo>
                        <a:pt x="1050" y="10"/>
                      </a:lnTo>
                      <a:lnTo>
                        <a:pt x="1051" y="10"/>
                      </a:lnTo>
                      <a:lnTo>
                        <a:pt x="1051" y="9"/>
                      </a:lnTo>
                      <a:lnTo>
                        <a:pt x="1051" y="12"/>
                      </a:lnTo>
                      <a:lnTo>
                        <a:pt x="1051" y="10"/>
                      </a:lnTo>
                      <a:lnTo>
                        <a:pt x="1052" y="10"/>
                      </a:lnTo>
                      <a:lnTo>
                        <a:pt x="1052" y="9"/>
                      </a:lnTo>
                      <a:lnTo>
                        <a:pt x="1052" y="12"/>
                      </a:lnTo>
                      <a:lnTo>
                        <a:pt x="1052" y="12"/>
                      </a:lnTo>
                      <a:lnTo>
                        <a:pt x="1053" y="12"/>
                      </a:lnTo>
                      <a:lnTo>
                        <a:pt x="1053" y="10"/>
                      </a:lnTo>
                      <a:lnTo>
                        <a:pt x="1053" y="13"/>
                      </a:lnTo>
                      <a:lnTo>
                        <a:pt x="1053" y="11"/>
                      </a:lnTo>
                      <a:lnTo>
                        <a:pt x="1054" y="11"/>
                      </a:lnTo>
                      <a:lnTo>
                        <a:pt x="1054" y="9"/>
                      </a:lnTo>
                      <a:lnTo>
                        <a:pt x="1054" y="13"/>
                      </a:lnTo>
                      <a:lnTo>
                        <a:pt x="1054" y="9"/>
                      </a:lnTo>
                      <a:lnTo>
                        <a:pt x="1055" y="9"/>
                      </a:lnTo>
                      <a:lnTo>
                        <a:pt x="1055" y="10"/>
                      </a:lnTo>
                      <a:lnTo>
                        <a:pt x="1055" y="14"/>
                      </a:lnTo>
                      <a:lnTo>
                        <a:pt x="1055" y="12"/>
                      </a:lnTo>
                      <a:lnTo>
                        <a:pt x="1056" y="12"/>
                      </a:lnTo>
                      <a:lnTo>
                        <a:pt x="1056" y="10"/>
                      </a:lnTo>
                      <a:lnTo>
                        <a:pt x="1056" y="15"/>
                      </a:lnTo>
                      <a:lnTo>
                        <a:pt x="1056" y="15"/>
                      </a:lnTo>
                      <a:lnTo>
                        <a:pt x="1057" y="15"/>
                      </a:lnTo>
                      <a:lnTo>
                        <a:pt x="1057" y="10"/>
                      </a:lnTo>
                      <a:lnTo>
                        <a:pt x="1057" y="14"/>
                      </a:lnTo>
                      <a:lnTo>
                        <a:pt x="1057" y="11"/>
                      </a:lnTo>
                      <a:lnTo>
                        <a:pt x="1058" y="11"/>
                      </a:lnTo>
                      <a:lnTo>
                        <a:pt x="1058" y="9"/>
                      </a:lnTo>
                      <a:lnTo>
                        <a:pt x="1058" y="14"/>
                      </a:lnTo>
                      <a:lnTo>
                        <a:pt x="1058" y="9"/>
                      </a:lnTo>
                      <a:lnTo>
                        <a:pt x="1059" y="9"/>
                      </a:lnTo>
                      <a:lnTo>
                        <a:pt x="1059" y="10"/>
                      </a:lnTo>
                      <a:lnTo>
                        <a:pt x="1059" y="13"/>
                      </a:lnTo>
                      <a:lnTo>
                        <a:pt x="1059" y="12"/>
                      </a:lnTo>
                      <a:lnTo>
                        <a:pt x="1060" y="12"/>
                      </a:lnTo>
                      <a:lnTo>
                        <a:pt x="1060" y="9"/>
                      </a:lnTo>
                      <a:lnTo>
                        <a:pt x="1060" y="13"/>
                      </a:lnTo>
                      <a:lnTo>
                        <a:pt x="1060" y="10"/>
                      </a:lnTo>
                      <a:lnTo>
                        <a:pt x="1061" y="10"/>
                      </a:lnTo>
                      <a:lnTo>
                        <a:pt x="1061" y="10"/>
                      </a:lnTo>
                      <a:lnTo>
                        <a:pt x="1061" y="12"/>
                      </a:lnTo>
                      <a:lnTo>
                        <a:pt x="1061" y="10"/>
                      </a:lnTo>
                      <a:lnTo>
                        <a:pt x="1062" y="10"/>
                      </a:lnTo>
                      <a:lnTo>
                        <a:pt x="1062" y="9"/>
                      </a:lnTo>
                      <a:lnTo>
                        <a:pt x="1062" y="13"/>
                      </a:lnTo>
                      <a:lnTo>
                        <a:pt x="1062" y="11"/>
                      </a:lnTo>
                      <a:lnTo>
                        <a:pt x="1063" y="11"/>
                      </a:lnTo>
                      <a:lnTo>
                        <a:pt x="1063" y="9"/>
                      </a:lnTo>
                      <a:lnTo>
                        <a:pt x="1063" y="12"/>
                      </a:lnTo>
                      <a:lnTo>
                        <a:pt x="1063" y="10"/>
                      </a:lnTo>
                      <a:lnTo>
                        <a:pt x="1064" y="10"/>
                      </a:lnTo>
                      <a:lnTo>
                        <a:pt x="1064" y="10"/>
                      </a:lnTo>
                      <a:lnTo>
                        <a:pt x="1064" y="14"/>
                      </a:lnTo>
                      <a:lnTo>
                        <a:pt x="1064" y="12"/>
                      </a:lnTo>
                      <a:lnTo>
                        <a:pt x="1065" y="12"/>
                      </a:lnTo>
                      <a:lnTo>
                        <a:pt x="1065" y="9"/>
                      </a:lnTo>
                      <a:lnTo>
                        <a:pt x="1065" y="15"/>
                      </a:lnTo>
                      <a:lnTo>
                        <a:pt x="1065" y="12"/>
                      </a:lnTo>
                      <a:lnTo>
                        <a:pt x="1066" y="12"/>
                      </a:lnTo>
                      <a:lnTo>
                        <a:pt x="1066" y="9"/>
                      </a:lnTo>
                      <a:lnTo>
                        <a:pt x="1066" y="12"/>
                      </a:lnTo>
                      <a:lnTo>
                        <a:pt x="1066" y="11"/>
                      </a:lnTo>
                      <a:lnTo>
                        <a:pt x="1067" y="11"/>
                      </a:lnTo>
                      <a:lnTo>
                        <a:pt x="1067" y="10"/>
                      </a:lnTo>
                      <a:lnTo>
                        <a:pt x="1067" y="14"/>
                      </a:lnTo>
                      <a:lnTo>
                        <a:pt x="1067" y="10"/>
                      </a:lnTo>
                      <a:lnTo>
                        <a:pt x="1068" y="10"/>
                      </a:lnTo>
                      <a:lnTo>
                        <a:pt x="1068" y="10"/>
                      </a:lnTo>
                      <a:lnTo>
                        <a:pt x="1068" y="13"/>
                      </a:lnTo>
                      <a:lnTo>
                        <a:pt x="1068" y="12"/>
                      </a:lnTo>
                      <a:lnTo>
                        <a:pt x="1069" y="12"/>
                      </a:lnTo>
                      <a:lnTo>
                        <a:pt x="1069" y="9"/>
                      </a:lnTo>
                      <a:lnTo>
                        <a:pt x="1069" y="14"/>
                      </a:lnTo>
                      <a:lnTo>
                        <a:pt x="1069" y="14"/>
                      </a:lnTo>
                      <a:lnTo>
                        <a:pt x="1070" y="14"/>
                      </a:lnTo>
                      <a:lnTo>
                        <a:pt x="1070" y="9"/>
                      </a:lnTo>
                      <a:lnTo>
                        <a:pt x="1070" y="16"/>
                      </a:lnTo>
                      <a:lnTo>
                        <a:pt x="1070" y="10"/>
                      </a:lnTo>
                      <a:lnTo>
                        <a:pt x="1071" y="10"/>
                      </a:lnTo>
                      <a:lnTo>
                        <a:pt x="1071" y="10"/>
                      </a:lnTo>
                      <a:lnTo>
                        <a:pt x="1071" y="13"/>
                      </a:lnTo>
                      <a:lnTo>
                        <a:pt x="1071" y="12"/>
                      </a:lnTo>
                      <a:lnTo>
                        <a:pt x="1072" y="12"/>
                      </a:lnTo>
                      <a:lnTo>
                        <a:pt x="1072" y="10"/>
                      </a:lnTo>
                      <a:lnTo>
                        <a:pt x="1072" y="15"/>
                      </a:lnTo>
                      <a:lnTo>
                        <a:pt x="1072" y="15"/>
                      </a:lnTo>
                      <a:lnTo>
                        <a:pt x="1073" y="15"/>
                      </a:lnTo>
                      <a:lnTo>
                        <a:pt x="1073" y="9"/>
                      </a:lnTo>
                      <a:lnTo>
                        <a:pt x="1073" y="14"/>
                      </a:lnTo>
                      <a:lnTo>
                        <a:pt x="1073" y="14"/>
                      </a:lnTo>
                      <a:lnTo>
                        <a:pt x="1074" y="14"/>
                      </a:lnTo>
                      <a:lnTo>
                        <a:pt x="1074" y="9"/>
                      </a:lnTo>
                      <a:lnTo>
                        <a:pt x="1074" y="13"/>
                      </a:lnTo>
                      <a:lnTo>
                        <a:pt x="1074" y="11"/>
                      </a:lnTo>
                      <a:lnTo>
                        <a:pt x="1075" y="11"/>
                      </a:lnTo>
                      <a:lnTo>
                        <a:pt x="1075" y="10"/>
                      </a:lnTo>
                      <a:lnTo>
                        <a:pt x="1075" y="15"/>
                      </a:lnTo>
                      <a:lnTo>
                        <a:pt x="1075" y="12"/>
                      </a:lnTo>
                      <a:lnTo>
                        <a:pt x="1076" y="12"/>
                      </a:lnTo>
                      <a:lnTo>
                        <a:pt x="1076" y="9"/>
                      </a:lnTo>
                      <a:lnTo>
                        <a:pt x="1076" y="13"/>
                      </a:lnTo>
                      <a:lnTo>
                        <a:pt x="1076" y="10"/>
                      </a:lnTo>
                      <a:lnTo>
                        <a:pt x="1077" y="10"/>
                      </a:lnTo>
                      <a:lnTo>
                        <a:pt x="1077" y="10"/>
                      </a:lnTo>
                      <a:lnTo>
                        <a:pt x="1077" y="13"/>
                      </a:lnTo>
                      <a:lnTo>
                        <a:pt x="1077" y="11"/>
                      </a:lnTo>
                      <a:lnTo>
                        <a:pt x="1078" y="11"/>
                      </a:lnTo>
                      <a:lnTo>
                        <a:pt x="1078" y="10"/>
                      </a:lnTo>
                      <a:lnTo>
                        <a:pt x="1078" y="13"/>
                      </a:lnTo>
                      <a:lnTo>
                        <a:pt x="1078" y="10"/>
                      </a:lnTo>
                      <a:lnTo>
                        <a:pt x="1079" y="10"/>
                      </a:lnTo>
                      <a:lnTo>
                        <a:pt x="1079" y="10"/>
                      </a:lnTo>
                      <a:lnTo>
                        <a:pt x="1079" y="13"/>
                      </a:lnTo>
                      <a:lnTo>
                        <a:pt x="1079" y="13"/>
                      </a:lnTo>
                      <a:lnTo>
                        <a:pt x="1080" y="13"/>
                      </a:lnTo>
                      <a:lnTo>
                        <a:pt x="1080" y="11"/>
                      </a:lnTo>
                      <a:lnTo>
                        <a:pt x="1080" y="15"/>
                      </a:lnTo>
                      <a:lnTo>
                        <a:pt x="1080" y="13"/>
                      </a:lnTo>
                      <a:lnTo>
                        <a:pt x="1081" y="13"/>
                      </a:lnTo>
                      <a:lnTo>
                        <a:pt x="1081" y="10"/>
                      </a:lnTo>
                      <a:lnTo>
                        <a:pt x="1081" y="15"/>
                      </a:lnTo>
                      <a:lnTo>
                        <a:pt x="1081" y="15"/>
                      </a:lnTo>
                      <a:lnTo>
                        <a:pt x="1082" y="15"/>
                      </a:lnTo>
                      <a:lnTo>
                        <a:pt x="1082" y="11"/>
                      </a:lnTo>
                      <a:lnTo>
                        <a:pt x="1082" y="15"/>
                      </a:lnTo>
                      <a:lnTo>
                        <a:pt x="1082" y="12"/>
                      </a:lnTo>
                      <a:lnTo>
                        <a:pt x="1083" y="12"/>
                      </a:lnTo>
                      <a:lnTo>
                        <a:pt x="1083" y="11"/>
                      </a:lnTo>
                      <a:lnTo>
                        <a:pt x="1083" y="13"/>
                      </a:lnTo>
                      <a:lnTo>
                        <a:pt x="1083" y="12"/>
                      </a:lnTo>
                      <a:lnTo>
                        <a:pt x="1084" y="12"/>
                      </a:lnTo>
                      <a:lnTo>
                        <a:pt x="1084" y="9"/>
                      </a:lnTo>
                      <a:lnTo>
                        <a:pt x="1084" y="13"/>
                      </a:lnTo>
                      <a:lnTo>
                        <a:pt x="1084" y="12"/>
                      </a:lnTo>
                      <a:lnTo>
                        <a:pt x="1085" y="12"/>
                      </a:lnTo>
                      <a:lnTo>
                        <a:pt x="1085" y="11"/>
                      </a:lnTo>
                      <a:lnTo>
                        <a:pt x="1085" y="16"/>
                      </a:lnTo>
                      <a:lnTo>
                        <a:pt x="1085" y="13"/>
                      </a:lnTo>
                      <a:lnTo>
                        <a:pt x="1086" y="13"/>
                      </a:lnTo>
                      <a:lnTo>
                        <a:pt x="1086" y="11"/>
                      </a:lnTo>
                      <a:lnTo>
                        <a:pt x="1086" y="15"/>
                      </a:lnTo>
                      <a:lnTo>
                        <a:pt x="1086" y="12"/>
                      </a:lnTo>
                      <a:lnTo>
                        <a:pt x="1087" y="12"/>
                      </a:lnTo>
                      <a:lnTo>
                        <a:pt x="1087" y="10"/>
                      </a:lnTo>
                      <a:lnTo>
                        <a:pt x="1087" y="15"/>
                      </a:lnTo>
                      <a:lnTo>
                        <a:pt x="1087" y="11"/>
                      </a:lnTo>
                      <a:lnTo>
                        <a:pt x="1088" y="11"/>
                      </a:lnTo>
                      <a:lnTo>
                        <a:pt x="1088" y="10"/>
                      </a:lnTo>
                      <a:lnTo>
                        <a:pt x="1088" y="13"/>
                      </a:lnTo>
                      <a:lnTo>
                        <a:pt x="1088" y="13"/>
                      </a:lnTo>
                      <a:lnTo>
                        <a:pt x="1089" y="13"/>
                      </a:lnTo>
                      <a:lnTo>
                        <a:pt x="1089" y="11"/>
                      </a:lnTo>
                      <a:lnTo>
                        <a:pt x="1089" y="15"/>
                      </a:lnTo>
                      <a:lnTo>
                        <a:pt x="1089" y="15"/>
                      </a:lnTo>
                      <a:lnTo>
                        <a:pt x="1090" y="15"/>
                      </a:lnTo>
                      <a:lnTo>
                        <a:pt x="1090" y="10"/>
                      </a:lnTo>
                      <a:lnTo>
                        <a:pt x="1090" y="15"/>
                      </a:lnTo>
                      <a:lnTo>
                        <a:pt x="1090" y="13"/>
                      </a:lnTo>
                      <a:lnTo>
                        <a:pt x="1091" y="13"/>
                      </a:lnTo>
                      <a:lnTo>
                        <a:pt x="1091" y="10"/>
                      </a:lnTo>
                      <a:lnTo>
                        <a:pt x="1091" y="13"/>
                      </a:lnTo>
                      <a:lnTo>
                        <a:pt x="1091" y="13"/>
                      </a:lnTo>
                      <a:lnTo>
                        <a:pt x="1092" y="13"/>
                      </a:lnTo>
                      <a:lnTo>
                        <a:pt x="1092" y="12"/>
                      </a:lnTo>
                      <a:lnTo>
                        <a:pt x="1092" y="15"/>
                      </a:lnTo>
                      <a:lnTo>
                        <a:pt x="1092" y="12"/>
                      </a:lnTo>
                      <a:lnTo>
                        <a:pt x="1093" y="12"/>
                      </a:lnTo>
                      <a:lnTo>
                        <a:pt x="1093" y="12"/>
                      </a:lnTo>
                      <a:lnTo>
                        <a:pt x="1093" y="15"/>
                      </a:lnTo>
                      <a:lnTo>
                        <a:pt x="1093" y="13"/>
                      </a:lnTo>
                      <a:lnTo>
                        <a:pt x="1094" y="13"/>
                      </a:lnTo>
                      <a:lnTo>
                        <a:pt x="1094" y="12"/>
                      </a:lnTo>
                      <a:lnTo>
                        <a:pt x="1094" y="15"/>
                      </a:lnTo>
                      <a:lnTo>
                        <a:pt x="1094" y="13"/>
                      </a:lnTo>
                      <a:lnTo>
                        <a:pt x="1095" y="13"/>
                      </a:lnTo>
                      <a:lnTo>
                        <a:pt x="1095" y="11"/>
                      </a:lnTo>
                      <a:lnTo>
                        <a:pt x="1095" y="15"/>
                      </a:lnTo>
                      <a:lnTo>
                        <a:pt x="1095" y="12"/>
                      </a:lnTo>
                      <a:lnTo>
                        <a:pt x="1096" y="12"/>
                      </a:lnTo>
                      <a:lnTo>
                        <a:pt x="1096" y="11"/>
                      </a:lnTo>
                      <a:lnTo>
                        <a:pt x="1096" y="13"/>
                      </a:lnTo>
                      <a:lnTo>
                        <a:pt x="1096" y="13"/>
                      </a:lnTo>
                      <a:lnTo>
                        <a:pt x="1097" y="13"/>
                      </a:lnTo>
                      <a:lnTo>
                        <a:pt x="1097" y="11"/>
                      </a:lnTo>
                      <a:lnTo>
                        <a:pt x="1097" y="16"/>
                      </a:lnTo>
                      <a:lnTo>
                        <a:pt x="1097" y="15"/>
                      </a:lnTo>
                      <a:lnTo>
                        <a:pt x="1098" y="15"/>
                      </a:lnTo>
                      <a:lnTo>
                        <a:pt x="1098" y="9"/>
                      </a:lnTo>
                      <a:lnTo>
                        <a:pt x="1098" y="14"/>
                      </a:lnTo>
                      <a:lnTo>
                        <a:pt x="1098" y="13"/>
                      </a:lnTo>
                      <a:lnTo>
                        <a:pt x="1099" y="13"/>
                      </a:lnTo>
                      <a:lnTo>
                        <a:pt x="1099" y="10"/>
                      </a:lnTo>
                      <a:lnTo>
                        <a:pt x="1099" y="14"/>
                      </a:lnTo>
                      <a:lnTo>
                        <a:pt x="1099" y="12"/>
                      </a:lnTo>
                      <a:lnTo>
                        <a:pt x="1100" y="12"/>
                      </a:lnTo>
                      <a:lnTo>
                        <a:pt x="1100" y="10"/>
                      </a:lnTo>
                      <a:lnTo>
                        <a:pt x="1100" y="16"/>
                      </a:lnTo>
                      <a:lnTo>
                        <a:pt x="1100" y="12"/>
                      </a:lnTo>
                      <a:lnTo>
                        <a:pt x="1101" y="12"/>
                      </a:lnTo>
                      <a:lnTo>
                        <a:pt x="1101" y="10"/>
                      </a:lnTo>
                      <a:lnTo>
                        <a:pt x="1101" y="13"/>
                      </a:lnTo>
                      <a:lnTo>
                        <a:pt x="1101" y="11"/>
                      </a:lnTo>
                      <a:lnTo>
                        <a:pt x="1102" y="11"/>
                      </a:lnTo>
                      <a:lnTo>
                        <a:pt x="1102" y="10"/>
                      </a:lnTo>
                      <a:lnTo>
                        <a:pt x="1102" y="14"/>
                      </a:lnTo>
                      <a:lnTo>
                        <a:pt x="1102" y="13"/>
                      </a:lnTo>
                      <a:lnTo>
                        <a:pt x="1103" y="13"/>
                      </a:lnTo>
                      <a:lnTo>
                        <a:pt x="1103" y="10"/>
                      </a:lnTo>
                      <a:lnTo>
                        <a:pt x="1103" y="15"/>
                      </a:lnTo>
                      <a:lnTo>
                        <a:pt x="1103" y="12"/>
                      </a:lnTo>
                      <a:lnTo>
                        <a:pt x="1104" y="12"/>
                      </a:lnTo>
                      <a:lnTo>
                        <a:pt x="1104" y="10"/>
                      </a:lnTo>
                      <a:lnTo>
                        <a:pt x="1104" y="13"/>
                      </a:lnTo>
                      <a:lnTo>
                        <a:pt x="1104" y="13"/>
                      </a:lnTo>
                      <a:lnTo>
                        <a:pt x="1105" y="13"/>
                      </a:lnTo>
                      <a:lnTo>
                        <a:pt x="1105" y="12"/>
                      </a:lnTo>
                      <a:lnTo>
                        <a:pt x="1105" y="15"/>
                      </a:lnTo>
                      <a:lnTo>
                        <a:pt x="1105" y="12"/>
                      </a:lnTo>
                      <a:lnTo>
                        <a:pt x="1106" y="12"/>
                      </a:lnTo>
                      <a:lnTo>
                        <a:pt x="1106" y="10"/>
                      </a:lnTo>
                      <a:lnTo>
                        <a:pt x="1106" y="13"/>
                      </a:lnTo>
                      <a:lnTo>
                        <a:pt x="1106" y="12"/>
                      </a:lnTo>
                      <a:lnTo>
                        <a:pt x="1107" y="12"/>
                      </a:lnTo>
                      <a:lnTo>
                        <a:pt x="1107" y="11"/>
                      </a:lnTo>
                      <a:lnTo>
                        <a:pt x="1107" y="13"/>
                      </a:lnTo>
                      <a:lnTo>
                        <a:pt x="1107" y="11"/>
                      </a:lnTo>
                      <a:lnTo>
                        <a:pt x="1108" y="11"/>
                      </a:lnTo>
                      <a:lnTo>
                        <a:pt x="1108" y="10"/>
                      </a:lnTo>
                      <a:lnTo>
                        <a:pt x="1108" y="14"/>
                      </a:lnTo>
                      <a:lnTo>
                        <a:pt x="1108" y="11"/>
                      </a:lnTo>
                      <a:lnTo>
                        <a:pt x="1109" y="11"/>
                      </a:lnTo>
                      <a:lnTo>
                        <a:pt x="1109" y="10"/>
                      </a:lnTo>
                      <a:lnTo>
                        <a:pt x="1109" y="12"/>
                      </a:lnTo>
                      <a:lnTo>
                        <a:pt x="1109" y="10"/>
                      </a:lnTo>
                      <a:lnTo>
                        <a:pt x="1110" y="10"/>
                      </a:lnTo>
                      <a:lnTo>
                        <a:pt x="1110" y="9"/>
                      </a:lnTo>
                      <a:lnTo>
                        <a:pt x="1110" y="13"/>
                      </a:lnTo>
                      <a:lnTo>
                        <a:pt x="1110" y="12"/>
                      </a:lnTo>
                      <a:lnTo>
                        <a:pt x="1111" y="12"/>
                      </a:lnTo>
                      <a:lnTo>
                        <a:pt x="1111" y="9"/>
                      </a:lnTo>
                      <a:lnTo>
                        <a:pt x="1111" y="13"/>
                      </a:lnTo>
                      <a:lnTo>
                        <a:pt x="1111" y="12"/>
                      </a:lnTo>
                      <a:lnTo>
                        <a:pt x="1112" y="12"/>
                      </a:lnTo>
                      <a:lnTo>
                        <a:pt x="1112" y="10"/>
                      </a:lnTo>
                      <a:lnTo>
                        <a:pt x="1112" y="13"/>
                      </a:lnTo>
                      <a:lnTo>
                        <a:pt x="1112" y="12"/>
                      </a:lnTo>
                      <a:lnTo>
                        <a:pt x="1113" y="12"/>
                      </a:lnTo>
                      <a:lnTo>
                        <a:pt x="1113" y="10"/>
                      </a:lnTo>
                      <a:lnTo>
                        <a:pt x="1113" y="13"/>
                      </a:lnTo>
                      <a:lnTo>
                        <a:pt x="1113" y="10"/>
                      </a:lnTo>
                      <a:lnTo>
                        <a:pt x="1114" y="10"/>
                      </a:lnTo>
                      <a:lnTo>
                        <a:pt x="1114" y="9"/>
                      </a:lnTo>
                      <a:lnTo>
                        <a:pt x="1114" y="13"/>
                      </a:lnTo>
                      <a:lnTo>
                        <a:pt x="1114" y="13"/>
                      </a:lnTo>
                      <a:lnTo>
                        <a:pt x="1115" y="13"/>
                      </a:lnTo>
                      <a:lnTo>
                        <a:pt x="1115" y="9"/>
                      </a:lnTo>
                      <a:lnTo>
                        <a:pt x="1115" y="15"/>
                      </a:lnTo>
                      <a:lnTo>
                        <a:pt x="1115" y="10"/>
                      </a:lnTo>
                      <a:lnTo>
                        <a:pt x="1116" y="10"/>
                      </a:lnTo>
                      <a:lnTo>
                        <a:pt x="1116" y="10"/>
                      </a:lnTo>
                      <a:lnTo>
                        <a:pt x="1116" y="13"/>
                      </a:lnTo>
                      <a:lnTo>
                        <a:pt x="1116" y="12"/>
                      </a:lnTo>
                      <a:lnTo>
                        <a:pt x="1117" y="12"/>
                      </a:lnTo>
                      <a:lnTo>
                        <a:pt x="1117" y="9"/>
                      </a:lnTo>
                      <a:lnTo>
                        <a:pt x="1117" y="13"/>
                      </a:lnTo>
                      <a:lnTo>
                        <a:pt x="1117" y="10"/>
                      </a:lnTo>
                      <a:lnTo>
                        <a:pt x="1118" y="10"/>
                      </a:lnTo>
                      <a:lnTo>
                        <a:pt x="1118" y="9"/>
                      </a:lnTo>
                      <a:lnTo>
                        <a:pt x="1118" y="12"/>
                      </a:lnTo>
                      <a:lnTo>
                        <a:pt x="1118" y="9"/>
                      </a:lnTo>
                      <a:lnTo>
                        <a:pt x="1119" y="9"/>
                      </a:lnTo>
                      <a:lnTo>
                        <a:pt x="1119" y="10"/>
                      </a:lnTo>
                      <a:lnTo>
                        <a:pt x="1119" y="13"/>
                      </a:lnTo>
                      <a:lnTo>
                        <a:pt x="1119" y="10"/>
                      </a:lnTo>
                      <a:lnTo>
                        <a:pt x="1120" y="10"/>
                      </a:lnTo>
                      <a:lnTo>
                        <a:pt x="1120" y="10"/>
                      </a:lnTo>
                      <a:lnTo>
                        <a:pt x="1120" y="15"/>
                      </a:lnTo>
                      <a:lnTo>
                        <a:pt x="1120" y="12"/>
                      </a:lnTo>
                      <a:lnTo>
                        <a:pt x="1121" y="12"/>
                      </a:lnTo>
                      <a:lnTo>
                        <a:pt x="1121" y="9"/>
                      </a:lnTo>
                      <a:lnTo>
                        <a:pt x="1121" y="13"/>
                      </a:lnTo>
                      <a:lnTo>
                        <a:pt x="1121" y="12"/>
                      </a:lnTo>
                      <a:lnTo>
                        <a:pt x="1122" y="12"/>
                      </a:lnTo>
                      <a:lnTo>
                        <a:pt x="1122" y="10"/>
                      </a:lnTo>
                      <a:lnTo>
                        <a:pt x="1122" y="14"/>
                      </a:lnTo>
                      <a:lnTo>
                        <a:pt x="1122" y="13"/>
                      </a:lnTo>
                      <a:lnTo>
                        <a:pt x="1123" y="13"/>
                      </a:lnTo>
                      <a:lnTo>
                        <a:pt x="1123" y="11"/>
                      </a:lnTo>
                      <a:lnTo>
                        <a:pt x="1123" y="13"/>
                      </a:lnTo>
                      <a:lnTo>
                        <a:pt x="1123" y="11"/>
                      </a:lnTo>
                      <a:lnTo>
                        <a:pt x="1124" y="11"/>
                      </a:lnTo>
                      <a:lnTo>
                        <a:pt x="1124" y="10"/>
                      </a:lnTo>
                      <a:lnTo>
                        <a:pt x="1124" y="13"/>
                      </a:lnTo>
                      <a:lnTo>
                        <a:pt x="1124" y="13"/>
                      </a:lnTo>
                      <a:lnTo>
                        <a:pt x="1125" y="13"/>
                      </a:lnTo>
                      <a:lnTo>
                        <a:pt x="1125" y="10"/>
                      </a:lnTo>
                      <a:lnTo>
                        <a:pt x="1125" y="16"/>
                      </a:lnTo>
                      <a:lnTo>
                        <a:pt x="1125" y="12"/>
                      </a:lnTo>
                      <a:lnTo>
                        <a:pt x="1126" y="12"/>
                      </a:lnTo>
                      <a:lnTo>
                        <a:pt x="1126" y="10"/>
                      </a:lnTo>
                      <a:lnTo>
                        <a:pt x="1126" y="15"/>
                      </a:lnTo>
                      <a:lnTo>
                        <a:pt x="1126" y="12"/>
                      </a:lnTo>
                      <a:lnTo>
                        <a:pt x="1127" y="12"/>
                      </a:lnTo>
                      <a:lnTo>
                        <a:pt x="1127" y="10"/>
                      </a:lnTo>
                      <a:lnTo>
                        <a:pt x="1127" y="13"/>
                      </a:lnTo>
                      <a:lnTo>
                        <a:pt x="1127" y="11"/>
                      </a:lnTo>
                      <a:lnTo>
                        <a:pt x="1128" y="11"/>
                      </a:lnTo>
                      <a:lnTo>
                        <a:pt x="1128" y="10"/>
                      </a:lnTo>
                      <a:lnTo>
                        <a:pt x="1128" y="13"/>
                      </a:lnTo>
                      <a:lnTo>
                        <a:pt x="1128" y="12"/>
                      </a:lnTo>
                      <a:lnTo>
                        <a:pt x="1129" y="12"/>
                      </a:lnTo>
                      <a:lnTo>
                        <a:pt x="1129" y="10"/>
                      </a:lnTo>
                      <a:lnTo>
                        <a:pt x="1129" y="14"/>
                      </a:lnTo>
                      <a:lnTo>
                        <a:pt x="1129" y="10"/>
                      </a:lnTo>
                      <a:lnTo>
                        <a:pt x="1130" y="10"/>
                      </a:lnTo>
                      <a:lnTo>
                        <a:pt x="1130" y="9"/>
                      </a:lnTo>
                      <a:lnTo>
                        <a:pt x="1130" y="15"/>
                      </a:lnTo>
                      <a:lnTo>
                        <a:pt x="1130" y="10"/>
                      </a:lnTo>
                      <a:lnTo>
                        <a:pt x="1131" y="10"/>
                      </a:lnTo>
                      <a:lnTo>
                        <a:pt x="1131" y="11"/>
                      </a:lnTo>
                      <a:lnTo>
                        <a:pt x="1131" y="13"/>
                      </a:lnTo>
                      <a:lnTo>
                        <a:pt x="1131" y="13"/>
                      </a:lnTo>
                      <a:lnTo>
                        <a:pt x="1132" y="13"/>
                      </a:lnTo>
                      <a:lnTo>
                        <a:pt x="1132" y="11"/>
                      </a:lnTo>
                      <a:lnTo>
                        <a:pt x="1132" y="13"/>
                      </a:lnTo>
                      <a:lnTo>
                        <a:pt x="1132" y="13"/>
                      </a:lnTo>
                      <a:lnTo>
                        <a:pt x="1133" y="13"/>
                      </a:lnTo>
                      <a:lnTo>
                        <a:pt x="1133" y="10"/>
                      </a:lnTo>
                      <a:lnTo>
                        <a:pt x="1133" y="15"/>
                      </a:lnTo>
                      <a:lnTo>
                        <a:pt x="1133" y="12"/>
                      </a:lnTo>
                      <a:lnTo>
                        <a:pt x="1134" y="12"/>
                      </a:lnTo>
                      <a:lnTo>
                        <a:pt x="1134" y="9"/>
                      </a:lnTo>
                      <a:lnTo>
                        <a:pt x="1134" y="13"/>
                      </a:lnTo>
                      <a:lnTo>
                        <a:pt x="1134" y="12"/>
                      </a:lnTo>
                      <a:lnTo>
                        <a:pt x="1135" y="12"/>
                      </a:lnTo>
                      <a:lnTo>
                        <a:pt x="1135" y="10"/>
                      </a:lnTo>
                      <a:lnTo>
                        <a:pt x="1135" y="13"/>
                      </a:lnTo>
                      <a:lnTo>
                        <a:pt x="1135" y="12"/>
                      </a:lnTo>
                      <a:lnTo>
                        <a:pt x="1136" y="12"/>
                      </a:lnTo>
                      <a:lnTo>
                        <a:pt x="1136" y="10"/>
                      </a:lnTo>
                      <a:lnTo>
                        <a:pt x="1136" y="13"/>
                      </a:lnTo>
                      <a:lnTo>
                        <a:pt x="1136" y="13"/>
                      </a:lnTo>
                      <a:lnTo>
                        <a:pt x="1137" y="13"/>
                      </a:lnTo>
                      <a:lnTo>
                        <a:pt x="1137" y="10"/>
                      </a:lnTo>
                      <a:lnTo>
                        <a:pt x="1137" y="14"/>
                      </a:lnTo>
                      <a:lnTo>
                        <a:pt x="1137" y="10"/>
                      </a:lnTo>
                      <a:lnTo>
                        <a:pt x="1138" y="10"/>
                      </a:lnTo>
                      <a:lnTo>
                        <a:pt x="1138" y="9"/>
                      </a:lnTo>
                      <a:lnTo>
                        <a:pt x="1138" y="15"/>
                      </a:lnTo>
                      <a:lnTo>
                        <a:pt x="1138" y="12"/>
                      </a:lnTo>
                      <a:lnTo>
                        <a:pt x="1139" y="12"/>
                      </a:lnTo>
                      <a:lnTo>
                        <a:pt x="1139" y="10"/>
                      </a:lnTo>
                      <a:lnTo>
                        <a:pt x="1139" y="15"/>
                      </a:lnTo>
                      <a:lnTo>
                        <a:pt x="1139" y="10"/>
                      </a:lnTo>
                      <a:lnTo>
                        <a:pt x="1140" y="10"/>
                      </a:lnTo>
                      <a:lnTo>
                        <a:pt x="1140" y="10"/>
                      </a:lnTo>
                      <a:lnTo>
                        <a:pt x="1140" y="15"/>
                      </a:lnTo>
                      <a:lnTo>
                        <a:pt x="1140" y="14"/>
                      </a:lnTo>
                      <a:lnTo>
                        <a:pt x="1141" y="14"/>
                      </a:lnTo>
                      <a:lnTo>
                        <a:pt x="1141" y="10"/>
                      </a:lnTo>
                      <a:lnTo>
                        <a:pt x="1141" y="16"/>
                      </a:lnTo>
                      <a:lnTo>
                        <a:pt x="1141" y="16"/>
                      </a:lnTo>
                      <a:lnTo>
                        <a:pt x="1142" y="16"/>
                      </a:lnTo>
                      <a:lnTo>
                        <a:pt x="1142" y="10"/>
                      </a:lnTo>
                      <a:lnTo>
                        <a:pt x="1142" y="15"/>
                      </a:lnTo>
                      <a:lnTo>
                        <a:pt x="1142" y="11"/>
                      </a:lnTo>
                      <a:lnTo>
                        <a:pt x="1143" y="11"/>
                      </a:lnTo>
                      <a:lnTo>
                        <a:pt x="1143" y="10"/>
                      </a:lnTo>
                      <a:lnTo>
                        <a:pt x="1143" y="15"/>
                      </a:lnTo>
                      <a:lnTo>
                        <a:pt x="1143" y="10"/>
                      </a:lnTo>
                      <a:lnTo>
                        <a:pt x="1144" y="10"/>
                      </a:lnTo>
                      <a:lnTo>
                        <a:pt x="1144" y="9"/>
                      </a:lnTo>
                      <a:lnTo>
                        <a:pt x="1144" y="13"/>
                      </a:lnTo>
                      <a:lnTo>
                        <a:pt x="1144" y="13"/>
                      </a:lnTo>
                      <a:lnTo>
                        <a:pt x="1145" y="13"/>
                      </a:lnTo>
                      <a:lnTo>
                        <a:pt x="1145" y="10"/>
                      </a:lnTo>
                      <a:lnTo>
                        <a:pt x="1145" y="14"/>
                      </a:lnTo>
                      <a:lnTo>
                        <a:pt x="1145" y="12"/>
                      </a:lnTo>
                      <a:lnTo>
                        <a:pt x="1146" y="12"/>
                      </a:lnTo>
                      <a:lnTo>
                        <a:pt x="1146" y="8"/>
                      </a:lnTo>
                      <a:lnTo>
                        <a:pt x="1146" y="13"/>
                      </a:lnTo>
                      <a:lnTo>
                        <a:pt x="1146" y="8"/>
                      </a:lnTo>
                      <a:lnTo>
                        <a:pt x="1147" y="8"/>
                      </a:lnTo>
                      <a:lnTo>
                        <a:pt x="1147" y="8"/>
                      </a:lnTo>
                      <a:lnTo>
                        <a:pt x="1147" y="13"/>
                      </a:lnTo>
                      <a:lnTo>
                        <a:pt x="1147" y="13"/>
                      </a:lnTo>
                      <a:lnTo>
                        <a:pt x="1148" y="13"/>
                      </a:lnTo>
                      <a:lnTo>
                        <a:pt x="1148" y="10"/>
                      </a:lnTo>
                      <a:lnTo>
                        <a:pt x="1148" y="13"/>
                      </a:lnTo>
                      <a:lnTo>
                        <a:pt x="1148" y="12"/>
                      </a:lnTo>
                      <a:lnTo>
                        <a:pt x="1149" y="12"/>
                      </a:lnTo>
                      <a:lnTo>
                        <a:pt x="1149" y="10"/>
                      </a:lnTo>
                      <a:lnTo>
                        <a:pt x="1149" y="15"/>
                      </a:lnTo>
                      <a:lnTo>
                        <a:pt x="1149" y="15"/>
                      </a:lnTo>
                      <a:lnTo>
                        <a:pt x="1150" y="15"/>
                      </a:lnTo>
                      <a:lnTo>
                        <a:pt x="1150" y="12"/>
                      </a:lnTo>
                      <a:lnTo>
                        <a:pt x="1150" y="16"/>
                      </a:lnTo>
                      <a:lnTo>
                        <a:pt x="1150" y="12"/>
                      </a:lnTo>
                      <a:lnTo>
                        <a:pt x="1151" y="12"/>
                      </a:lnTo>
                      <a:lnTo>
                        <a:pt x="1151" y="12"/>
                      </a:lnTo>
                      <a:lnTo>
                        <a:pt x="1151" y="17"/>
                      </a:lnTo>
                      <a:lnTo>
                        <a:pt x="1151" y="12"/>
                      </a:lnTo>
                      <a:lnTo>
                        <a:pt x="1152" y="12"/>
                      </a:lnTo>
                      <a:lnTo>
                        <a:pt x="1152" y="12"/>
                      </a:lnTo>
                      <a:lnTo>
                        <a:pt x="1152" y="16"/>
                      </a:lnTo>
                      <a:lnTo>
                        <a:pt x="1152" y="16"/>
                      </a:lnTo>
                      <a:lnTo>
                        <a:pt x="1153" y="16"/>
                      </a:lnTo>
                      <a:lnTo>
                        <a:pt x="1153" y="12"/>
                      </a:lnTo>
                      <a:lnTo>
                        <a:pt x="1153" y="17"/>
                      </a:lnTo>
                      <a:lnTo>
                        <a:pt x="1153" y="15"/>
                      </a:lnTo>
                      <a:lnTo>
                        <a:pt x="1154" y="15"/>
                      </a:lnTo>
                      <a:lnTo>
                        <a:pt x="1154" y="10"/>
                      </a:lnTo>
                      <a:lnTo>
                        <a:pt x="1154" y="16"/>
                      </a:lnTo>
                      <a:lnTo>
                        <a:pt x="1154" y="12"/>
                      </a:lnTo>
                      <a:lnTo>
                        <a:pt x="1155" y="12"/>
                      </a:lnTo>
                      <a:lnTo>
                        <a:pt x="1155" y="11"/>
                      </a:lnTo>
                      <a:lnTo>
                        <a:pt x="1155" y="16"/>
                      </a:lnTo>
                      <a:lnTo>
                        <a:pt x="1155" y="12"/>
                      </a:lnTo>
                      <a:lnTo>
                        <a:pt x="1156" y="12"/>
                      </a:lnTo>
                      <a:lnTo>
                        <a:pt x="1156" y="10"/>
                      </a:lnTo>
                      <a:lnTo>
                        <a:pt x="1156" y="14"/>
                      </a:lnTo>
                      <a:lnTo>
                        <a:pt x="1156" y="13"/>
                      </a:lnTo>
                      <a:lnTo>
                        <a:pt x="1157" y="13"/>
                      </a:lnTo>
                      <a:lnTo>
                        <a:pt x="1157" y="12"/>
                      </a:lnTo>
                      <a:lnTo>
                        <a:pt x="1157" y="16"/>
                      </a:lnTo>
                      <a:lnTo>
                        <a:pt x="1157" y="14"/>
                      </a:lnTo>
                      <a:lnTo>
                        <a:pt x="1158" y="14"/>
                      </a:lnTo>
                      <a:lnTo>
                        <a:pt x="1158" y="11"/>
                      </a:lnTo>
                      <a:lnTo>
                        <a:pt x="1158" y="15"/>
                      </a:lnTo>
                      <a:lnTo>
                        <a:pt x="1158" y="13"/>
                      </a:lnTo>
                      <a:lnTo>
                        <a:pt x="1159" y="13"/>
                      </a:lnTo>
                      <a:lnTo>
                        <a:pt x="1159" y="10"/>
                      </a:lnTo>
                      <a:lnTo>
                        <a:pt x="1159" y="13"/>
                      </a:lnTo>
                      <a:lnTo>
                        <a:pt x="1159" y="12"/>
                      </a:lnTo>
                      <a:lnTo>
                        <a:pt x="1160" y="12"/>
                      </a:lnTo>
                      <a:lnTo>
                        <a:pt x="1160" y="11"/>
                      </a:lnTo>
                      <a:lnTo>
                        <a:pt x="1160" y="15"/>
                      </a:lnTo>
                      <a:lnTo>
                        <a:pt x="1160" y="12"/>
                      </a:lnTo>
                      <a:lnTo>
                        <a:pt x="1161" y="12"/>
                      </a:lnTo>
                      <a:lnTo>
                        <a:pt x="1161" y="10"/>
                      </a:lnTo>
                      <a:lnTo>
                        <a:pt x="1161" y="13"/>
                      </a:lnTo>
                      <a:lnTo>
                        <a:pt x="1161" y="12"/>
                      </a:lnTo>
                      <a:lnTo>
                        <a:pt x="1162" y="12"/>
                      </a:lnTo>
                      <a:lnTo>
                        <a:pt x="1162" y="10"/>
                      </a:lnTo>
                      <a:lnTo>
                        <a:pt x="1162" y="15"/>
                      </a:lnTo>
                      <a:lnTo>
                        <a:pt x="1162" y="10"/>
                      </a:lnTo>
                      <a:lnTo>
                        <a:pt x="1163" y="10"/>
                      </a:lnTo>
                      <a:lnTo>
                        <a:pt x="1163" y="9"/>
                      </a:lnTo>
                      <a:lnTo>
                        <a:pt x="1163" y="14"/>
                      </a:lnTo>
                      <a:lnTo>
                        <a:pt x="1163" y="10"/>
                      </a:lnTo>
                      <a:lnTo>
                        <a:pt x="1164" y="10"/>
                      </a:lnTo>
                      <a:lnTo>
                        <a:pt x="1164" y="10"/>
                      </a:lnTo>
                      <a:lnTo>
                        <a:pt x="1164" y="13"/>
                      </a:lnTo>
                      <a:lnTo>
                        <a:pt x="1164" y="11"/>
                      </a:lnTo>
                      <a:lnTo>
                        <a:pt x="1165" y="11"/>
                      </a:lnTo>
                      <a:lnTo>
                        <a:pt x="1165" y="10"/>
                      </a:lnTo>
                      <a:lnTo>
                        <a:pt x="1165" y="13"/>
                      </a:lnTo>
                      <a:lnTo>
                        <a:pt x="1165" y="12"/>
                      </a:lnTo>
                      <a:lnTo>
                        <a:pt x="1166" y="12"/>
                      </a:lnTo>
                      <a:lnTo>
                        <a:pt x="1166" y="10"/>
                      </a:lnTo>
                      <a:lnTo>
                        <a:pt x="1166" y="16"/>
                      </a:lnTo>
                      <a:lnTo>
                        <a:pt x="1166" y="13"/>
                      </a:lnTo>
                      <a:lnTo>
                        <a:pt x="1167" y="13"/>
                      </a:lnTo>
                      <a:lnTo>
                        <a:pt x="1167" y="12"/>
                      </a:lnTo>
                      <a:lnTo>
                        <a:pt x="1167" y="15"/>
                      </a:lnTo>
                      <a:lnTo>
                        <a:pt x="1167" y="13"/>
                      </a:lnTo>
                      <a:lnTo>
                        <a:pt x="1168" y="13"/>
                      </a:lnTo>
                      <a:lnTo>
                        <a:pt x="1168" y="11"/>
                      </a:lnTo>
                      <a:lnTo>
                        <a:pt x="1168" y="16"/>
                      </a:lnTo>
                      <a:lnTo>
                        <a:pt x="1168" y="13"/>
                      </a:lnTo>
                      <a:lnTo>
                        <a:pt x="1169" y="13"/>
                      </a:lnTo>
                      <a:lnTo>
                        <a:pt x="1169" y="11"/>
                      </a:lnTo>
                      <a:lnTo>
                        <a:pt x="1169" y="15"/>
                      </a:lnTo>
                      <a:lnTo>
                        <a:pt x="1169" y="12"/>
                      </a:lnTo>
                      <a:lnTo>
                        <a:pt x="1170" y="12"/>
                      </a:lnTo>
                      <a:lnTo>
                        <a:pt x="1170" y="12"/>
                      </a:lnTo>
                      <a:lnTo>
                        <a:pt x="1170" y="16"/>
                      </a:lnTo>
                      <a:lnTo>
                        <a:pt x="1170" y="13"/>
                      </a:lnTo>
                      <a:lnTo>
                        <a:pt x="1171" y="13"/>
                      </a:lnTo>
                      <a:lnTo>
                        <a:pt x="1171" y="11"/>
                      </a:lnTo>
                      <a:lnTo>
                        <a:pt x="1171" y="16"/>
                      </a:lnTo>
                      <a:lnTo>
                        <a:pt x="1171" y="13"/>
                      </a:lnTo>
                      <a:lnTo>
                        <a:pt x="1172" y="13"/>
                      </a:lnTo>
                      <a:lnTo>
                        <a:pt x="1172" y="10"/>
                      </a:lnTo>
                      <a:lnTo>
                        <a:pt x="1172" y="13"/>
                      </a:lnTo>
                      <a:lnTo>
                        <a:pt x="1172" y="13"/>
                      </a:lnTo>
                      <a:lnTo>
                        <a:pt x="1173" y="13"/>
                      </a:lnTo>
                      <a:lnTo>
                        <a:pt x="1173" y="10"/>
                      </a:lnTo>
                      <a:lnTo>
                        <a:pt x="1173" y="13"/>
                      </a:lnTo>
                      <a:lnTo>
                        <a:pt x="1173" y="10"/>
                      </a:lnTo>
                      <a:lnTo>
                        <a:pt x="1174" y="10"/>
                      </a:lnTo>
                      <a:lnTo>
                        <a:pt x="1174" y="10"/>
                      </a:lnTo>
                      <a:lnTo>
                        <a:pt x="1174" y="13"/>
                      </a:lnTo>
                      <a:lnTo>
                        <a:pt x="1174" y="11"/>
                      </a:lnTo>
                      <a:lnTo>
                        <a:pt x="1175" y="11"/>
                      </a:lnTo>
                      <a:lnTo>
                        <a:pt x="1175" y="10"/>
                      </a:lnTo>
                      <a:lnTo>
                        <a:pt x="1175" y="15"/>
                      </a:lnTo>
                      <a:lnTo>
                        <a:pt x="1175" y="12"/>
                      </a:lnTo>
                      <a:lnTo>
                        <a:pt x="1176" y="12"/>
                      </a:lnTo>
                      <a:lnTo>
                        <a:pt x="1176" y="9"/>
                      </a:lnTo>
                      <a:lnTo>
                        <a:pt x="1176" y="12"/>
                      </a:lnTo>
                      <a:lnTo>
                        <a:pt x="1176" y="9"/>
                      </a:lnTo>
                      <a:lnTo>
                        <a:pt x="1177" y="9"/>
                      </a:lnTo>
                      <a:lnTo>
                        <a:pt x="1177" y="9"/>
                      </a:lnTo>
                      <a:lnTo>
                        <a:pt x="1177" y="13"/>
                      </a:lnTo>
                      <a:lnTo>
                        <a:pt x="1177" y="9"/>
                      </a:lnTo>
                      <a:lnTo>
                        <a:pt x="1178" y="9"/>
                      </a:lnTo>
                      <a:lnTo>
                        <a:pt x="1178" y="9"/>
                      </a:lnTo>
                      <a:lnTo>
                        <a:pt x="1178" y="14"/>
                      </a:lnTo>
                      <a:lnTo>
                        <a:pt x="1178" y="11"/>
                      </a:lnTo>
                      <a:lnTo>
                        <a:pt x="1179" y="11"/>
                      </a:lnTo>
                      <a:lnTo>
                        <a:pt x="1179" y="9"/>
                      </a:lnTo>
                      <a:lnTo>
                        <a:pt x="1179" y="13"/>
                      </a:lnTo>
                      <a:lnTo>
                        <a:pt x="1179" y="11"/>
                      </a:lnTo>
                      <a:lnTo>
                        <a:pt x="1180" y="11"/>
                      </a:lnTo>
                      <a:lnTo>
                        <a:pt x="1180" y="9"/>
                      </a:lnTo>
                      <a:lnTo>
                        <a:pt x="1180" y="13"/>
                      </a:lnTo>
                      <a:lnTo>
                        <a:pt x="1180" y="10"/>
                      </a:lnTo>
                      <a:lnTo>
                        <a:pt x="1181" y="10"/>
                      </a:lnTo>
                      <a:lnTo>
                        <a:pt x="1181" y="9"/>
                      </a:lnTo>
                      <a:lnTo>
                        <a:pt x="1181" y="12"/>
                      </a:lnTo>
                      <a:lnTo>
                        <a:pt x="1181" y="9"/>
                      </a:lnTo>
                      <a:lnTo>
                        <a:pt x="1182" y="9"/>
                      </a:lnTo>
                      <a:lnTo>
                        <a:pt x="1182" y="10"/>
                      </a:lnTo>
                      <a:lnTo>
                        <a:pt x="1182" y="14"/>
                      </a:lnTo>
                      <a:lnTo>
                        <a:pt x="1182" y="10"/>
                      </a:lnTo>
                      <a:lnTo>
                        <a:pt x="1183" y="10"/>
                      </a:lnTo>
                      <a:lnTo>
                        <a:pt x="1183" y="9"/>
                      </a:lnTo>
                      <a:lnTo>
                        <a:pt x="1183" y="13"/>
                      </a:lnTo>
                      <a:lnTo>
                        <a:pt x="1183" y="11"/>
                      </a:lnTo>
                      <a:lnTo>
                        <a:pt x="1184" y="11"/>
                      </a:lnTo>
                      <a:lnTo>
                        <a:pt x="1184" y="9"/>
                      </a:lnTo>
                      <a:lnTo>
                        <a:pt x="1184" y="12"/>
                      </a:lnTo>
                      <a:lnTo>
                        <a:pt x="1184" y="10"/>
                      </a:lnTo>
                      <a:lnTo>
                        <a:pt x="1185" y="10"/>
                      </a:lnTo>
                      <a:lnTo>
                        <a:pt x="1185" y="9"/>
                      </a:lnTo>
                      <a:lnTo>
                        <a:pt x="1185" y="13"/>
                      </a:lnTo>
                      <a:lnTo>
                        <a:pt x="1185" y="10"/>
                      </a:lnTo>
                      <a:lnTo>
                        <a:pt x="1186" y="10"/>
                      </a:lnTo>
                      <a:lnTo>
                        <a:pt x="1186" y="10"/>
                      </a:lnTo>
                      <a:lnTo>
                        <a:pt x="1186" y="14"/>
                      </a:lnTo>
                      <a:lnTo>
                        <a:pt x="1186" y="10"/>
                      </a:lnTo>
                      <a:lnTo>
                        <a:pt x="1187" y="10"/>
                      </a:lnTo>
                      <a:lnTo>
                        <a:pt x="1187" y="9"/>
                      </a:lnTo>
                      <a:lnTo>
                        <a:pt x="1187" y="12"/>
                      </a:lnTo>
                      <a:lnTo>
                        <a:pt x="1187" y="11"/>
                      </a:lnTo>
                      <a:lnTo>
                        <a:pt x="1188" y="11"/>
                      </a:lnTo>
                      <a:lnTo>
                        <a:pt x="1188" y="9"/>
                      </a:lnTo>
                      <a:lnTo>
                        <a:pt x="1188" y="12"/>
                      </a:lnTo>
                      <a:lnTo>
                        <a:pt x="1188" y="12"/>
                      </a:lnTo>
                      <a:lnTo>
                        <a:pt x="1189" y="12"/>
                      </a:lnTo>
                      <a:lnTo>
                        <a:pt x="1189" y="10"/>
                      </a:lnTo>
                      <a:lnTo>
                        <a:pt x="1189" y="13"/>
                      </a:lnTo>
                      <a:lnTo>
                        <a:pt x="1189" y="12"/>
                      </a:lnTo>
                      <a:lnTo>
                        <a:pt x="1190" y="12"/>
                      </a:lnTo>
                      <a:lnTo>
                        <a:pt x="1190" y="11"/>
                      </a:lnTo>
                      <a:lnTo>
                        <a:pt x="1190" y="13"/>
                      </a:lnTo>
                      <a:lnTo>
                        <a:pt x="1190" y="12"/>
                      </a:lnTo>
                      <a:lnTo>
                        <a:pt x="1191" y="12"/>
                      </a:lnTo>
                      <a:lnTo>
                        <a:pt x="1191" y="10"/>
                      </a:lnTo>
                      <a:lnTo>
                        <a:pt x="1191" y="16"/>
                      </a:lnTo>
                      <a:lnTo>
                        <a:pt x="1191" y="13"/>
                      </a:lnTo>
                      <a:lnTo>
                        <a:pt x="1192" y="13"/>
                      </a:lnTo>
                      <a:lnTo>
                        <a:pt x="1192" y="10"/>
                      </a:lnTo>
                      <a:lnTo>
                        <a:pt x="1192" y="13"/>
                      </a:lnTo>
                      <a:lnTo>
                        <a:pt x="1192" y="13"/>
                      </a:lnTo>
                      <a:lnTo>
                        <a:pt x="1193" y="13"/>
                      </a:lnTo>
                      <a:lnTo>
                        <a:pt x="1193" y="10"/>
                      </a:lnTo>
                      <a:lnTo>
                        <a:pt x="1193" y="15"/>
                      </a:lnTo>
                      <a:lnTo>
                        <a:pt x="1193" y="12"/>
                      </a:lnTo>
                      <a:lnTo>
                        <a:pt x="1194" y="12"/>
                      </a:lnTo>
                      <a:lnTo>
                        <a:pt x="1194" y="10"/>
                      </a:lnTo>
                      <a:lnTo>
                        <a:pt x="1194" y="14"/>
                      </a:lnTo>
                      <a:lnTo>
                        <a:pt x="1194" y="12"/>
                      </a:lnTo>
                      <a:lnTo>
                        <a:pt x="1195" y="12"/>
                      </a:lnTo>
                      <a:lnTo>
                        <a:pt x="1195" y="11"/>
                      </a:lnTo>
                      <a:lnTo>
                        <a:pt x="1195" y="16"/>
                      </a:lnTo>
                      <a:lnTo>
                        <a:pt x="1195" y="13"/>
                      </a:lnTo>
                      <a:lnTo>
                        <a:pt x="1196" y="13"/>
                      </a:lnTo>
                      <a:lnTo>
                        <a:pt x="1196" y="10"/>
                      </a:lnTo>
                      <a:lnTo>
                        <a:pt x="1196" y="13"/>
                      </a:lnTo>
                      <a:lnTo>
                        <a:pt x="1196" y="13"/>
                      </a:lnTo>
                      <a:lnTo>
                        <a:pt x="1197" y="13"/>
                      </a:lnTo>
                      <a:lnTo>
                        <a:pt x="1197" y="10"/>
                      </a:lnTo>
                      <a:lnTo>
                        <a:pt x="1197" y="15"/>
                      </a:lnTo>
                      <a:lnTo>
                        <a:pt x="1197" y="15"/>
                      </a:lnTo>
                      <a:lnTo>
                        <a:pt x="1198" y="15"/>
                      </a:lnTo>
                      <a:lnTo>
                        <a:pt x="1198" y="12"/>
                      </a:lnTo>
                      <a:lnTo>
                        <a:pt x="1198" y="16"/>
                      </a:lnTo>
                      <a:lnTo>
                        <a:pt x="1198" y="13"/>
                      </a:lnTo>
                      <a:lnTo>
                        <a:pt x="1199" y="13"/>
                      </a:lnTo>
                      <a:lnTo>
                        <a:pt x="1199" y="12"/>
                      </a:lnTo>
                      <a:lnTo>
                        <a:pt x="1199" y="14"/>
                      </a:lnTo>
                      <a:lnTo>
                        <a:pt x="1199" y="13"/>
                      </a:lnTo>
                      <a:lnTo>
                        <a:pt x="1200" y="13"/>
                      </a:lnTo>
                      <a:lnTo>
                        <a:pt x="1200" y="12"/>
                      </a:lnTo>
                      <a:lnTo>
                        <a:pt x="1200" y="16"/>
                      </a:lnTo>
                      <a:lnTo>
                        <a:pt x="1200" y="16"/>
                      </a:lnTo>
                      <a:lnTo>
                        <a:pt x="1201" y="16"/>
                      </a:lnTo>
                      <a:lnTo>
                        <a:pt x="1201" y="12"/>
                      </a:lnTo>
                      <a:lnTo>
                        <a:pt x="1201" y="17"/>
                      </a:lnTo>
                      <a:lnTo>
                        <a:pt x="1201" y="12"/>
                      </a:lnTo>
                      <a:lnTo>
                        <a:pt x="1202" y="12"/>
                      </a:lnTo>
                      <a:lnTo>
                        <a:pt x="1202" y="12"/>
                      </a:lnTo>
                      <a:lnTo>
                        <a:pt x="1202" y="15"/>
                      </a:lnTo>
                      <a:lnTo>
                        <a:pt x="1202" y="14"/>
                      </a:lnTo>
                      <a:lnTo>
                        <a:pt x="1203" y="14"/>
                      </a:lnTo>
                      <a:lnTo>
                        <a:pt x="1203" y="12"/>
                      </a:lnTo>
                      <a:lnTo>
                        <a:pt x="1203" y="16"/>
                      </a:lnTo>
                      <a:lnTo>
                        <a:pt x="1203" y="14"/>
                      </a:lnTo>
                      <a:lnTo>
                        <a:pt x="1204" y="14"/>
                      </a:lnTo>
                      <a:lnTo>
                        <a:pt x="1204" y="12"/>
                      </a:lnTo>
                      <a:lnTo>
                        <a:pt x="1204" y="16"/>
                      </a:lnTo>
                      <a:lnTo>
                        <a:pt x="1204" y="16"/>
                      </a:lnTo>
                      <a:lnTo>
                        <a:pt x="1205" y="16"/>
                      </a:lnTo>
                      <a:lnTo>
                        <a:pt x="1205" y="13"/>
                      </a:lnTo>
                      <a:lnTo>
                        <a:pt x="1205" y="16"/>
                      </a:lnTo>
                      <a:lnTo>
                        <a:pt x="1205" y="16"/>
                      </a:lnTo>
                      <a:lnTo>
                        <a:pt x="1206" y="16"/>
                      </a:lnTo>
                      <a:lnTo>
                        <a:pt x="1206" y="13"/>
                      </a:lnTo>
                      <a:lnTo>
                        <a:pt x="1206" y="19"/>
                      </a:lnTo>
                      <a:lnTo>
                        <a:pt x="1206" y="15"/>
                      </a:lnTo>
                      <a:lnTo>
                        <a:pt x="1207" y="15"/>
                      </a:lnTo>
                      <a:lnTo>
                        <a:pt x="1207" y="12"/>
                      </a:lnTo>
                      <a:lnTo>
                        <a:pt x="1207" y="18"/>
                      </a:lnTo>
                      <a:lnTo>
                        <a:pt x="1207" y="16"/>
                      </a:lnTo>
                      <a:lnTo>
                        <a:pt x="1208" y="16"/>
                      </a:lnTo>
                      <a:lnTo>
                        <a:pt x="1208" y="15"/>
                      </a:lnTo>
                      <a:lnTo>
                        <a:pt x="1208" y="18"/>
                      </a:lnTo>
                      <a:lnTo>
                        <a:pt x="1208" y="18"/>
                      </a:lnTo>
                      <a:lnTo>
                        <a:pt x="1209" y="18"/>
                      </a:lnTo>
                      <a:lnTo>
                        <a:pt x="1209" y="15"/>
                      </a:lnTo>
                      <a:lnTo>
                        <a:pt x="1209" y="18"/>
                      </a:lnTo>
                      <a:lnTo>
                        <a:pt x="1209" y="17"/>
                      </a:lnTo>
                      <a:lnTo>
                        <a:pt x="1210" y="17"/>
                      </a:lnTo>
                      <a:lnTo>
                        <a:pt x="1210" y="16"/>
                      </a:lnTo>
                      <a:lnTo>
                        <a:pt x="1210" y="18"/>
                      </a:lnTo>
                      <a:lnTo>
                        <a:pt x="1210" y="17"/>
                      </a:lnTo>
                      <a:lnTo>
                        <a:pt x="1211" y="17"/>
                      </a:lnTo>
                      <a:lnTo>
                        <a:pt x="1211" y="16"/>
                      </a:lnTo>
                      <a:lnTo>
                        <a:pt x="1211" y="20"/>
                      </a:lnTo>
                      <a:lnTo>
                        <a:pt x="1211" y="17"/>
                      </a:lnTo>
                      <a:lnTo>
                        <a:pt x="1212" y="17"/>
                      </a:lnTo>
                      <a:lnTo>
                        <a:pt x="1212" y="16"/>
                      </a:lnTo>
                      <a:lnTo>
                        <a:pt x="1212" y="21"/>
                      </a:lnTo>
                      <a:lnTo>
                        <a:pt x="1212" y="20"/>
                      </a:lnTo>
                      <a:lnTo>
                        <a:pt x="1213" y="20"/>
                      </a:lnTo>
                      <a:lnTo>
                        <a:pt x="1213" y="16"/>
                      </a:lnTo>
                      <a:lnTo>
                        <a:pt x="1213" y="21"/>
                      </a:lnTo>
                      <a:lnTo>
                        <a:pt x="1213" y="16"/>
                      </a:lnTo>
                      <a:lnTo>
                        <a:pt x="1214" y="16"/>
                      </a:lnTo>
                      <a:lnTo>
                        <a:pt x="1214" y="17"/>
                      </a:lnTo>
                      <a:lnTo>
                        <a:pt x="1214" y="20"/>
                      </a:lnTo>
                      <a:lnTo>
                        <a:pt x="1214" y="18"/>
                      </a:lnTo>
                      <a:lnTo>
                        <a:pt x="1215" y="18"/>
                      </a:lnTo>
                      <a:lnTo>
                        <a:pt x="1215" y="17"/>
                      </a:lnTo>
                      <a:lnTo>
                        <a:pt x="1215" y="22"/>
                      </a:lnTo>
                      <a:lnTo>
                        <a:pt x="1215" y="20"/>
                      </a:lnTo>
                      <a:lnTo>
                        <a:pt x="1216" y="20"/>
                      </a:lnTo>
                      <a:lnTo>
                        <a:pt x="1216" y="17"/>
                      </a:lnTo>
                      <a:lnTo>
                        <a:pt x="1216" y="22"/>
                      </a:lnTo>
                      <a:lnTo>
                        <a:pt x="1216" y="20"/>
                      </a:lnTo>
                      <a:lnTo>
                        <a:pt x="1217" y="20"/>
                      </a:lnTo>
                      <a:lnTo>
                        <a:pt x="1217" y="18"/>
                      </a:lnTo>
                      <a:lnTo>
                        <a:pt x="1217" y="22"/>
                      </a:lnTo>
                      <a:lnTo>
                        <a:pt x="1217" y="21"/>
                      </a:lnTo>
                      <a:lnTo>
                        <a:pt x="1218" y="21"/>
                      </a:lnTo>
                      <a:lnTo>
                        <a:pt x="1218" y="18"/>
                      </a:lnTo>
                      <a:lnTo>
                        <a:pt x="1218" y="23"/>
                      </a:lnTo>
                      <a:lnTo>
                        <a:pt x="1218" y="18"/>
                      </a:lnTo>
                      <a:lnTo>
                        <a:pt x="1219" y="18"/>
                      </a:lnTo>
                      <a:lnTo>
                        <a:pt x="1219" y="16"/>
                      </a:lnTo>
                      <a:lnTo>
                        <a:pt x="1219" y="22"/>
                      </a:lnTo>
                      <a:lnTo>
                        <a:pt x="1219" y="18"/>
                      </a:lnTo>
                      <a:lnTo>
                        <a:pt x="1220" y="18"/>
                      </a:lnTo>
                      <a:lnTo>
                        <a:pt x="1220" y="18"/>
                      </a:lnTo>
                      <a:lnTo>
                        <a:pt x="1220" y="22"/>
                      </a:lnTo>
                      <a:lnTo>
                        <a:pt x="1220" y="20"/>
                      </a:lnTo>
                      <a:lnTo>
                        <a:pt x="1221" y="20"/>
                      </a:lnTo>
                      <a:lnTo>
                        <a:pt x="1221" y="20"/>
                      </a:lnTo>
                      <a:lnTo>
                        <a:pt x="1221" y="22"/>
                      </a:lnTo>
                      <a:lnTo>
                        <a:pt x="1221" y="20"/>
                      </a:lnTo>
                      <a:lnTo>
                        <a:pt x="1222" y="20"/>
                      </a:lnTo>
                      <a:lnTo>
                        <a:pt x="1222" y="20"/>
                      </a:lnTo>
                      <a:lnTo>
                        <a:pt x="1222" y="24"/>
                      </a:lnTo>
                      <a:lnTo>
                        <a:pt x="1222" y="22"/>
                      </a:lnTo>
                      <a:lnTo>
                        <a:pt x="1223" y="22"/>
                      </a:lnTo>
                      <a:lnTo>
                        <a:pt x="1223" y="20"/>
                      </a:lnTo>
                      <a:lnTo>
                        <a:pt x="1223" y="24"/>
                      </a:lnTo>
                      <a:lnTo>
                        <a:pt x="1223" y="20"/>
                      </a:lnTo>
                      <a:lnTo>
                        <a:pt x="1224" y="20"/>
                      </a:lnTo>
                      <a:lnTo>
                        <a:pt x="1224" y="20"/>
                      </a:lnTo>
                      <a:lnTo>
                        <a:pt x="1224" y="25"/>
                      </a:lnTo>
                      <a:lnTo>
                        <a:pt x="1224" y="22"/>
                      </a:lnTo>
                      <a:lnTo>
                        <a:pt x="1225" y="22"/>
                      </a:lnTo>
                      <a:lnTo>
                        <a:pt x="1225" y="21"/>
                      </a:lnTo>
                      <a:lnTo>
                        <a:pt x="1225" y="24"/>
                      </a:lnTo>
                      <a:lnTo>
                        <a:pt x="1225" y="23"/>
                      </a:lnTo>
                      <a:lnTo>
                        <a:pt x="1226" y="23"/>
                      </a:lnTo>
                      <a:lnTo>
                        <a:pt x="1226" y="22"/>
                      </a:lnTo>
                      <a:lnTo>
                        <a:pt x="1226" y="24"/>
                      </a:lnTo>
                      <a:lnTo>
                        <a:pt x="1226" y="24"/>
                      </a:lnTo>
                      <a:lnTo>
                        <a:pt x="1227" y="24"/>
                      </a:lnTo>
                      <a:lnTo>
                        <a:pt x="1227" y="22"/>
                      </a:lnTo>
                      <a:lnTo>
                        <a:pt x="1227" y="26"/>
                      </a:lnTo>
                      <a:lnTo>
                        <a:pt x="1227" y="22"/>
                      </a:lnTo>
                      <a:lnTo>
                        <a:pt x="1228" y="22"/>
                      </a:lnTo>
                      <a:lnTo>
                        <a:pt x="1228" y="22"/>
                      </a:lnTo>
                      <a:lnTo>
                        <a:pt x="1228" y="26"/>
                      </a:lnTo>
                      <a:lnTo>
                        <a:pt x="1228" y="24"/>
                      </a:lnTo>
                      <a:lnTo>
                        <a:pt x="1229" y="24"/>
                      </a:lnTo>
                      <a:lnTo>
                        <a:pt x="1229" y="22"/>
                      </a:lnTo>
                      <a:lnTo>
                        <a:pt x="1229" y="26"/>
                      </a:lnTo>
                      <a:lnTo>
                        <a:pt x="1229" y="22"/>
                      </a:lnTo>
                      <a:lnTo>
                        <a:pt x="1230" y="22"/>
                      </a:lnTo>
                      <a:lnTo>
                        <a:pt x="1230" y="22"/>
                      </a:lnTo>
                      <a:lnTo>
                        <a:pt x="1230" y="26"/>
                      </a:lnTo>
                      <a:lnTo>
                        <a:pt x="1230" y="25"/>
                      </a:lnTo>
                      <a:lnTo>
                        <a:pt x="1231" y="25"/>
                      </a:lnTo>
                      <a:lnTo>
                        <a:pt x="1231" y="24"/>
                      </a:lnTo>
                      <a:lnTo>
                        <a:pt x="1231" y="29"/>
                      </a:lnTo>
                      <a:lnTo>
                        <a:pt x="1231" y="25"/>
                      </a:lnTo>
                      <a:lnTo>
                        <a:pt x="1232" y="25"/>
                      </a:lnTo>
                      <a:lnTo>
                        <a:pt x="1232" y="23"/>
                      </a:lnTo>
                      <a:lnTo>
                        <a:pt x="1232" y="26"/>
                      </a:lnTo>
                      <a:lnTo>
                        <a:pt x="1232" y="25"/>
                      </a:lnTo>
                      <a:lnTo>
                        <a:pt x="1233" y="25"/>
                      </a:lnTo>
                      <a:lnTo>
                        <a:pt x="1233" y="24"/>
                      </a:lnTo>
                      <a:lnTo>
                        <a:pt x="1233" y="28"/>
                      </a:lnTo>
                      <a:lnTo>
                        <a:pt x="1233" y="26"/>
                      </a:lnTo>
                      <a:lnTo>
                        <a:pt x="1234" y="26"/>
                      </a:lnTo>
                      <a:lnTo>
                        <a:pt x="1234" y="24"/>
                      </a:lnTo>
                      <a:lnTo>
                        <a:pt x="1234" y="28"/>
                      </a:lnTo>
                      <a:lnTo>
                        <a:pt x="1234" y="27"/>
                      </a:lnTo>
                      <a:lnTo>
                        <a:pt x="1235" y="27"/>
                      </a:lnTo>
                      <a:lnTo>
                        <a:pt x="1235" y="25"/>
                      </a:lnTo>
                      <a:lnTo>
                        <a:pt x="1235" y="28"/>
                      </a:lnTo>
                      <a:lnTo>
                        <a:pt x="1235" y="27"/>
                      </a:lnTo>
                      <a:lnTo>
                        <a:pt x="1236" y="27"/>
                      </a:lnTo>
                      <a:lnTo>
                        <a:pt x="1236" y="25"/>
                      </a:lnTo>
                      <a:lnTo>
                        <a:pt x="1236" y="29"/>
                      </a:lnTo>
                      <a:lnTo>
                        <a:pt x="1236" y="27"/>
                      </a:lnTo>
                      <a:lnTo>
                        <a:pt x="1237" y="27"/>
                      </a:lnTo>
                      <a:lnTo>
                        <a:pt x="1237" y="25"/>
                      </a:lnTo>
                      <a:lnTo>
                        <a:pt x="1237" y="28"/>
                      </a:lnTo>
                      <a:lnTo>
                        <a:pt x="1237" y="27"/>
                      </a:lnTo>
                      <a:lnTo>
                        <a:pt x="1238" y="27"/>
                      </a:lnTo>
                      <a:lnTo>
                        <a:pt x="1238" y="26"/>
                      </a:lnTo>
                      <a:lnTo>
                        <a:pt x="1238" y="29"/>
                      </a:lnTo>
                      <a:lnTo>
                        <a:pt x="1238" y="28"/>
                      </a:lnTo>
                      <a:lnTo>
                        <a:pt x="1239" y="28"/>
                      </a:lnTo>
                      <a:lnTo>
                        <a:pt x="1239" y="26"/>
                      </a:lnTo>
                      <a:lnTo>
                        <a:pt x="1239" y="29"/>
                      </a:lnTo>
                      <a:lnTo>
                        <a:pt x="1239" y="29"/>
                      </a:lnTo>
                      <a:lnTo>
                        <a:pt x="1240" y="29"/>
                      </a:lnTo>
                      <a:lnTo>
                        <a:pt x="1240" y="27"/>
                      </a:lnTo>
                      <a:lnTo>
                        <a:pt x="1240" y="29"/>
                      </a:lnTo>
                      <a:lnTo>
                        <a:pt x="1240" y="29"/>
                      </a:lnTo>
                      <a:lnTo>
                        <a:pt x="1241" y="29"/>
                      </a:lnTo>
                      <a:lnTo>
                        <a:pt x="1241" y="28"/>
                      </a:lnTo>
                      <a:lnTo>
                        <a:pt x="1241" y="31"/>
                      </a:lnTo>
                      <a:lnTo>
                        <a:pt x="1241" y="28"/>
                      </a:lnTo>
                      <a:lnTo>
                        <a:pt x="1242" y="28"/>
                      </a:lnTo>
                      <a:lnTo>
                        <a:pt x="1242" y="28"/>
                      </a:lnTo>
                      <a:lnTo>
                        <a:pt x="1242" y="30"/>
                      </a:lnTo>
                      <a:lnTo>
                        <a:pt x="1242" y="28"/>
                      </a:lnTo>
                      <a:lnTo>
                        <a:pt x="1243" y="28"/>
                      </a:lnTo>
                      <a:lnTo>
                        <a:pt x="1243" y="27"/>
                      </a:lnTo>
                      <a:lnTo>
                        <a:pt x="1243" y="31"/>
                      </a:lnTo>
                      <a:lnTo>
                        <a:pt x="1243" y="30"/>
                      </a:lnTo>
                      <a:lnTo>
                        <a:pt x="1244" y="30"/>
                      </a:lnTo>
                      <a:lnTo>
                        <a:pt x="1244" y="28"/>
                      </a:lnTo>
                      <a:lnTo>
                        <a:pt x="1244" y="33"/>
                      </a:lnTo>
                      <a:lnTo>
                        <a:pt x="1244" y="29"/>
                      </a:lnTo>
                      <a:lnTo>
                        <a:pt x="1245" y="29"/>
                      </a:lnTo>
                      <a:lnTo>
                        <a:pt x="1245" y="29"/>
                      </a:lnTo>
                      <a:lnTo>
                        <a:pt x="1245" y="32"/>
                      </a:lnTo>
                      <a:lnTo>
                        <a:pt x="1245" y="31"/>
                      </a:lnTo>
                      <a:lnTo>
                        <a:pt x="1246" y="31"/>
                      </a:lnTo>
                      <a:lnTo>
                        <a:pt x="1246" y="30"/>
                      </a:lnTo>
                      <a:lnTo>
                        <a:pt x="1246" y="34"/>
                      </a:lnTo>
                      <a:lnTo>
                        <a:pt x="1246" y="32"/>
                      </a:lnTo>
                      <a:lnTo>
                        <a:pt x="1247" y="32"/>
                      </a:lnTo>
                      <a:lnTo>
                        <a:pt x="1247" y="29"/>
                      </a:lnTo>
                      <a:lnTo>
                        <a:pt x="1247" y="33"/>
                      </a:lnTo>
                      <a:lnTo>
                        <a:pt x="1247" y="32"/>
                      </a:lnTo>
                      <a:lnTo>
                        <a:pt x="1248" y="32"/>
                      </a:lnTo>
                      <a:lnTo>
                        <a:pt x="1248" y="32"/>
                      </a:lnTo>
                      <a:lnTo>
                        <a:pt x="1248" y="35"/>
                      </a:lnTo>
                      <a:lnTo>
                        <a:pt x="1248" y="33"/>
                      </a:lnTo>
                      <a:lnTo>
                        <a:pt x="1249" y="33"/>
                      </a:lnTo>
                      <a:lnTo>
                        <a:pt x="1249" y="32"/>
                      </a:lnTo>
                      <a:lnTo>
                        <a:pt x="1249" y="35"/>
                      </a:lnTo>
                      <a:lnTo>
                        <a:pt x="1249" y="32"/>
                      </a:lnTo>
                      <a:lnTo>
                        <a:pt x="1250" y="32"/>
                      </a:lnTo>
                      <a:lnTo>
                        <a:pt x="1250" y="32"/>
                      </a:lnTo>
                      <a:lnTo>
                        <a:pt x="1250" y="35"/>
                      </a:lnTo>
                      <a:lnTo>
                        <a:pt x="1250" y="34"/>
                      </a:lnTo>
                      <a:lnTo>
                        <a:pt x="1251" y="34"/>
                      </a:lnTo>
                      <a:lnTo>
                        <a:pt x="1251" y="32"/>
                      </a:lnTo>
                      <a:lnTo>
                        <a:pt x="1251" y="35"/>
                      </a:lnTo>
                      <a:lnTo>
                        <a:pt x="1251" y="34"/>
                      </a:lnTo>
                      <a:lnTo>
                        <a:pt x="1252" y="34"/>
                      </a:lnTo>
                      <a:lnTo>
                        <a:pt x="1252" y="32"/>
                      </a:lnTo>
                      <a:lnTo>
                        <a:pt x="1252" y="36"/>
                      </a:lnTo>
                      <a:lnTo>
                        <a:pt x="1252" y="35"/>
                      </a:lnTo>
                      <a:lnTo>
                        <a:pt x="1253" y="35"/>
                      </a:lnTo>
                      <a:lnTo>
                        <a:pt x="1253" y="34"/>
                      </a:lnTo>
                      <a:lnTo>
                        <a:pt x="1253" y="37"/>
                      </a:lnTo>
                      <a:lnTo>
                        <a:pt x="1253" y="34"/>
                      </a:lnTo>
                      <a:lnTo>
                        <a:pt x="1254" y="34"/>
                      </a:lnTo>
                      <a:lnTo>
                        <a:pt x="1254" y="34"/>
                      </a:lnTo>
                      <a:lnTo>
                        <a:pt x="1254" y="38"/>
                      </a:lnTo>
                      <a:lnTo>
                        <a:pt x="1254" y="35"/>
                      </a:lnTo>
                      <a:lnTo>
                        <a:pt x="1255" y="35"/>
                      </a:lnTo>
                      <a:lnTo>
                        <a:pt x="1255" y="34"/>
                      </a:lnTo>
                      <a:lnTo>
                        <a:pt x="1255" y="38"/>
                      </a:lnTo>
                      <a:lnTo>
                        <a:pt x="1255" y="37"/>
                      </a:lnTo>
                      <a:lnTo>
                        <a:pt x="1256" y="37"/>
                      </a:lnTo>
                      <a:lnTo>
                        <a:pt x="1256" y="37"/>
                      </a:lnTo>
                      <a:lnTo>
                        <a:pt x="1256" y="40"/>
                      </a:lnTo>
                      <a:lnTo>
                        <a:pt x="1256" y="38"/>
                      </a:lnTo>
                      <a:lnTo>
                        <a:pt x="1257" y="38"/>
                      </a:lnTo>
                      <a:lnTo>
                        <a:pt x="1257" y="34"/>
                      </a:lnTo>
                      <a:lnTo>
                        <a:pt x="1257" y="38"/>
                      </a:lnTo>
                      <a:lnTo>
                        <a:pt x="1257" y="37"/>
                      </a:lnTo>
                      <a:lnTo>
                        <a:pt x="1258" y="37"/>
                      </a:lnTo>
                      <a:lnTo>
                        <a:pt x="1258" y="37"/>
                      </a:lnTo>
                      <a:lnTo>
                        <a:pt x="1258" y="40"/>
                      </a:lnTo>
                      <a:lnTo>
                        <a:pt x="1258" y="39"/>
                      </a:lnTo>
                      <a:lnTo>
                        <a:pt x="1259" y="39"/>
                      </a:lnTo>
                      <a:lnTo>
                        <a:pt x="1259" y="36"/>
                      </a:lnTo>
                      <a:lnTo>
                        <a:pt x="1259" y="40"/>
                      </a:lnTo>
                      <a:lnTo>
                        <a:pt x="1259" y="38"/>
                      </a:lnTo>
                      <a:lnTo>
                        <a:pt x="1260" y="38"/>
                      </a:lnTo>
                      <a:lnTo>
                        <a:pt x="1260" y="35"/>
                      </a:lnTo>
                      <a:lnTo>
                        <a:pt x="1260" y="40"/>
                      </a:lnTo>
                      <a:lnTo>
                        <a:pt x="1260" y="40"/>
                      </a:lnTo>
                      <a:lnTo>
                        <a:pt x="1261" y="40"/>
                      </a:lnTo>
                      <a:lnTo>
                        <a:pt x="1261" y="38"/>
                      </a:lnTo>
                      <a:lnTo>
                        <a:pt x="1261" y="44"/>
                      </a:lnTo>
                      <a:lnTo>
                        <a:pt x="1261" y="39"/>
                      </a:lnTo>
                      <a:lnTo>
                        <a:pt x="1262" y="39"/>
                      </a:lnTo>
                      <a:lnTo>
                        <a:pt x="1262" y="38"/>
                      </a:lnTo>
                      <a:lnTo>
                        <a:pt x="1262" y="41"/>
                      </a:lnTo>
                      <a:lnTo>
                        <a:pt x="1262" y="38"/>
                      </a:lnTo>
                      <a:lnTo>
                        <a:pt x="1263" y="38"/>
                      </a:lnTo>
                      <a:lnTo>
                        <a:pt x="1263" y="38"/>
                      </a:lnTo>
                      <a:lnTo>
                        <a:pt x="1263" y="41"/>
                      </a:lnTo>
                      <a:lnTo>
                        <a:pt x="1263" y="40"/>
                      </a:lnTo>
                      <a:lnTo>
                        <a:pt x="1264" y="40"/>
                      </a:lnTo>
                      <a:lnTo>
                        <a:pt x="1264" y="39"/>
                      </a:lnTo>
                      <a:lnTo>
                        <a:pt x="1264" y="43"/>
                      </a:lnTo>
                      <a:lnTo>
                        <a:pt x="1264" y="41"/>
                      </a:lnTo>
                      <a:lnTo>
                        <a:pt x="1265" y="41"/>
                      </a:lnTo>
                      <a:lnTo>
                        <a:pt x="1265" y="40"/>
                      </a:lnTo>
                      <a:lnTo>
                        <a:pt x="1265" y="42"/>
                      </a:lnTo>
                      <a:lnTo>
                        <a:pt x="1265" y="40"/>
                      </a:lnTo>
                      <a:lnTo>
                        <a:pt x="1266" y="40"/>
                      </a:lnTo>
                      <a:lnTo>
                        <a:pt x="1266" y="40"/>
                      </a:lnTo>
                      <a:lnTo>
                        <a:pt x="1266" y="44"/>
                      </a:lnTo>
                      <a:lnTo>
                        <a:pt x="1266" y="41"/>
                      </a:lnTo>
                      <a:lnTo>
                        <a:pt x="1267" y="41"/>
                      </a:lnTo>
                      <a:lnTo>
                        <a:pt x="1267" y="40"/>
                      </a:lnTo>
                      <a:lnTo>
                        <a:pt x="1267" y="44"/>
                      </a:lnTo>
                      <a:lnTo>
                        <a:pt x="1267" y="41"/>
                      </a:lnTo>
                      <a:lnTo>
                        <a:pt x="1268" y="41"/>
                      </a:lnTo>
                      <a:lnTo>
                        <a:pt x="1268" y="40"/>
                      </a:lnTo>
                      <a:lnTo>
                        <a:pt x="1268" y="45"/>
                      </a:lnTo>
                      <a:lnTo>
                        <a:pt x="1268" y="43"/>
                      </a:lnTo>
                      <a:lnTo>
                        <a:pt x="1269" y="43"/>
                      </a:lnTo>
                      <a:lnTo>
                        <a:pt x="1269" y="41"/>
                      </a:lnTo>
                      <a:lnTo>
                        <a:pt x="1269" y="44"/>
                      </a:lnTo>
                      <a:lnTo>
                        <a:pt x="1269" y="42"/>
                      </a:lnTo>
                      <a:lnTo>
                        <a:pt x="1270" y="42"/>
                      </a:lnTo>
                      <a:lnTo>
                        <a:pt x="1270" y="40"/>
                      </a:lnTo>
                      <a:lnTo>
                        <a:pt x="1270" y="46"/>
                      </a:lnTo>
                      <a:lnTo>
                        <a:pt x="1270" y="44"/>
                      </a:lnTo>
                      <a:lnTo>
                        <a:pt x="1271" y="44"/>
                      </a:lnTo>
                      <a:lnTo>
                        <a:pt x="1271" y="41"/>
                      </a:lnTo>
                      <a:lnTo>
                        <a:pt x="1271" y="46"/>
                      </a:lnTo>
                      <a:lnTo>
                        <a:pt x="1271" y="41"/>
                      </a:lnTo>
                      <a:lnTo>
                        <a:pt x="1272" y="41"/>
                      </a:lnTo>
                      <a:lnTo>
                        <a:pt x="1272" y="40"/>
                      </a:lnTo>
                      <a:lnTo>
                        <a:pt x="1272" y="45"/>
                      </a:lnTo>
                      <a:lnTo>
                        <a:pt x="1272" y="44"/>
                      </a:lnTo>
                      <a:lnTo>
                        <a:pt x="1273" y="44"/>
                      </a:lnTo>
                      <a:lnTo>
                        <a:pt x="1273" y="41"/>
                      </a:lnTo>
                      <a:lnTo>
                        <a:pt x="1273" y="46"/>
                      </a:lnTo>
                      <a:lnTo>
                        <a:pt x="1273" y="42"/>
                      </a:lnTo>
                      <a:lnTo>
                        <a:pt x="1274" y="42"/>
                      </a:lnTo>
                      <a:lnTo>
                        <a:pt x="1274" y="41"/>
                      </a:lnTo>
                      <a:lnTo>
                        <a:pt x="1274" y="45"/>
                      </a:lnTo>
                      <a:lnTo>
                        <a:pt x="1274" y="41"/>
                      </a:lnTo>
                      <a:lnTo>
                        <a:pt x="1275" y="41"/>
                      </a:lnTo>
                      <a:lnTo>
                        <a:pt x="1275" y="42"/>
                      </a:lnTo>
                      <a:lnTo>
                        <a:pt x="1275" y="46"/>
                      </a:lnTo>
                      <a:lnTo>
                        <a:pt x="1275" y="44"/>
                      </a:lnTo>
                      <a:lnTo>
                        <a:pt x="1276" y="44"/>
                      </a:lnTo>
                      <a:lnTo>
                        <a:pt x="1276" y="43"/>
                      </a:lnTo>
                      <a:lnTo>
                        <a:pt x="1276" y="45"/>
                      </a:lnTo>
                      <a:lnTo>
                        <a:pt x="1276" y="44"/>
                      </a:lnTo>
                      <a:lnTo>
                        <a:pt x="1277" y="44"/>
                      </a:lnTo>
                      <a:lnTo>
                        <a:pt x="1277" y="41"/>
                      </a:lnTo>
                      <a:lnTo>
                        <a:pt x="1277" y="47"/>
                      </a:lnTo>
                      <a:lnTo>
                        <a:pt x="1277" y="43"/>
                      </a:lnTo>
                      <a:lnTo>
                        <a:pt x="1278" y="43"/>
                      </a:lnTo>
                      <a:lnTo>
                        <a:pt x="1278" y="43"/>
                      </a:lnTo>
                      <a:lnTo>
                        <a:pt x="1278" y="48"/>
                      </a:lnTo>
                      <a:lnTo>
                        <a:pt x="1278" y="43"/>
                      </a:lnTo>
                      <a:lnTo>
                        <a:pt x="1279" y="43"/>
                      </a:lnTo>
                      <a:lnTo>
                        <a:pt x="1279" y="43"/>
                      </a:lnTo>
                      <a:lnTo>
                        <a:pt x="1279" y="47"/>
                      </a:lnTo>
                      <a:lnTo>
                        <a:pt x="1279" y="44"/>
                      </a:lnTo>
                      <a:lnTo>
                        <a:pt x="1280" y="44"/>
                      </a:lnTo>
                      <a:lnTo>
                        <a:pt x="1280" y="42"/>
                      </a:lnTo>
                      <a:lnTo>
                        <a:pt x="1280" y="45"/>
                      </a:lnTo>
                      <a:lnTo>
                        <a:pt x="1280" y="44"/>
                      </a:lnTo>
                      <a:lnTo>
                        <a:pt x="1281" y="44"/>
                      </a:lnTo>
                      <a:lnTo>
                        <a:pt x="1281" y="44"/>
                      </a:lnTo>
                      <a:lnTo>
                        <a:pt x="1281" y="47"/>
                      </a:lnTo>
                      <a:lnTo>
                        <a:pt x="1281" y="45"/>
                      </a:lnTo>
                      <a:lnTo>
                        <a:pt x="1282" y="45"/>
                      </a:lnTo>
                      <a:lnTo>
                        <a:pt x="1282" y="43"/>
                      </a:lnTo>
                      <a:lnTo>
                        <a:pt x="1282" y="46"/>
                      </a:lnTo>
                      <a:lnTo>
                        <a:pt x="1282" y="44"/>
                      </a:lnTo>
                      <a:lnTo>
                        <a:pt x="1283" y="44"/>
                      </a:lnTo>
                      <a:lnTo>
                        <a:pt x="1283" y="43"/>
                      </a:lnTo>
                      <a:lnTo>
                        <a:pt x="1283" y="48"/>
                      </a:lnTo>
                      <a:lnTo>
                        <a:pt x="1283" y="45"/>
                      </a:lnTo>
                      <a:lnTo>
                        <a:pt x="1284" y="45"/>
                      </a:lnTo>
                      <a:lnTo>
                        <a:pt x="1284" y="43"/>
                      </a:lnTo>
                      <a:lnTo>
                        <a:pt x="1284" y="46"/>
                      </a:lnTo>
                      <a:lnTo>
                        <a:pt x="1284" y="45"/>
                      </a:lnTo>
                      <a:lnTo>
                        <a:pt x="1285" y="45"/>
                      </a:lnTo>
                      <a:lnTo>
                        <a:pt x="1285" y="43"/>
                      </a:lnTo>
                      <a:lnTo>
                        <a:pt x="1285" y="46"/>
                      </a:lnTo>
                      <a:lnTo>
                        <a:pt x="1285" y="44"/>
                      </a:lnTo>
                      <a:lnTo>
                        <a:pt x="1286" y="44"/>
                      </a:lnTo>
                      <a:lnTo>
                        <a:pt x="1286" y="44"/>
                      </a:lnTo>
                      <a:lnTo>
                        <a:pt x="1286" y="46"/>
                      </a:lnTo>
                      <a:lnTo>
                        <a:pt x="1286" y="46"/>
                      </a:lnTo>
                      <a:lnTo>
                        <a:pt x="1287" y="46"/>
                      </a:lnTo>
                      <a:lnTo>
                        <a:pt x="1287" y="43"/>
                      </a:lnTo>
                      <a:lnTo>
                        <a:pt x="1287" y="47"/>
                      </a:lnTo>
                      <a:lnTo>
                        <a:pt x="1287" y="45"/>
                      </a:lnTo>
                      <a:lnTo>
                        <a:pt x="1288" y="45"/>
                      </a:lnTo>
                      <a:lnTo>
                        <a:pt x="1288" y="43"/>
                      </a:lnTo>
                      <a:lnTo>
                        <a:pt x="1288" y="47"/>
                      </a:lnTo>
                      <a:lnTo>
                        <a:pt x="1288" y="46"/>
                      </a:lnTo>
                      <a:lnTo>
                        <a:pt x="1289" y="46"/>
                      </a:lnTo>
                      <a:lnTo>
                        <a:pt x="1289" y="44"/>
                      </a:lnTo>
                      <a:lnTo>
                        <a:pt x="1289" y="49"/>
                      </a:lnTo>
                      <a:lnTo>
                        <a:pt x="1289" y="44"/>
                      </a:lnTo>
                      <a:lnTo>
                        <a:pt x="1290" y="44"/>
                      </a:lnTo>
                      <a:lnTo>
                        <a:pt x="1290" y="44"/>
                      </a:lnTo>
                      <a:lnTo>
                        <a:pt x="1290" y="48"/>
                      </a:lnTo>
                      <a:lnTo>
                        <a:pt x="1290" y="46"/>
                      </a:lnTo>
                      <a:lnTo>
                        <a:pt x="1291" y="46"/>
                      </a:lnTo>
                      <a:lnTo>
                        <a:pt x="1291" y="44"/>
                      </a:lnTo>
                      <a:lnTo>
                        <a:pt x="1291" y="48"/>
                      </a:lnTo>
                      <a:lnTo>
                        <a:pt x="1291" y="46"/>
                      </a:lnTo>
                      <a:lnTo>
                        <a:pt x="1292" y="46"/>
                      </a:lnTo>
                      <a:lnTo>
                        <a:pt x="1292" y="46"/>
                      </a:lnTo>
                      <a:lnTo>
                        <a:pt x="1292" y="48"/>
                      </a:lnTo>
                      <a:lnTo>
                        <a:pt x="1292" y="47"/>
                      </a:lnTo>
                      <a:lnTo>
                        <a:pt x="1293" y="47"/>
                      </a:lnTo>
                      <a:lnTo>
                        <a:pt x="1293" y="45"/>
                      </a:lnTo>
                      <a:lnTo>
                        <a:pt x="1293" y="49"/>
                      </a:lnTo>
                      <a:lnTo>
                        <a:pt x="1293" y="46"/>
                      </a:lnTo>
                      <a:lnTo>
                        <a:pt x="1294" y="46"/>
                      </a:lnTo>
                      <a:lnTo>
                        <a:pt x="1294" y="46"/>
                      </a:lnTo>
                      <a:lnTo>
                        <a:pt x="1294" y="49"/>
                      </a:lnTo>
                      <a:lnTo>
                        <a:pt x="1294" y="47"/>
                      </a:lnTo>
                      <a:lnTo>
                        <a:pt x="1295" y="47"/>
                      </a:lnTo>
                      <a:lnTo>
                        <a:pt x="1295" y="45"/>
                      </a:lnTo>
                      <a:lnTo>
                        <a:pt x="1295" y="48"/>
                      </a:lnTo>
                      <a:lnTo>
                        <a:pt x="1295" y="46"/>
                      </a:lnTo>
                      <a:lnTo>
                        <a:pt x="1296" y="46"/>
                      </a:lnTo>
                      <a:lnTo>
                        <a:pt x="1296" y="46"/>
                      </a:lnTo>
                      <a:lnTo>
                        <a:pt x="1296" y="50"/>
                      </a:lnTo>
                      <a:lnTo>
                        <a:pt x="1296" y="46"/>
                      </a:lnTo>
                      <a:lnTo>
                        <a:pt x="1297" y="46"/>
                      </a:lnTo>
                      <a:lnTo>
                        <a:pt x="1297" y="45"/>
                      </a:lnTo>
                      <a:lnTo>
                        <a:pt x="1297" y="49"/>
                      </a:lnTo>
                      <a:lnTo>
                        <a:pt x="1297" y="45"/>
                      </a:lnTo>
                      <a:lnTo>
                        <a:pt x="1298" y="45"/>
                      </a:lnTo>
                      <a:lnTo>
                        <a:pt x="1298" y="44"/>
                      </a:lnTo>
                      <a:lnTo>
                        <a:pt x="1298" y="49"/>
                      </a:lnTo>
                      <a:lnTo>
                        <a:pt x="1298" y="46"/>
                      </a:lnTo>
                      <a:lnTo>
                        <a:pt x="1299" y="46"/>
                      </a:lnTo>
                      <a:lnTo>
                        <a:pt x="1299" y="45"/>
                      </a:lnTo>
                      <a:lnTo>
                        <a:pt x="1299" y="48"/>
                      </a:lnTo>
                      <a:lnTo>
                        <a:pt x="1299" y="48"/>
                      </a:lnTo>
                      <a:lnTo>
                        <a:pt x="1300" y="48"/>
                      </a:lnTo>
                      <a:lnTo>
                        <a:pt x="1300" y="45"/>
                      </a:lnTo>
                      <a:lnTo>
                        <a:pt x="1300" y="48"/>
                      </a:lnTo>
                      <a:lnTo>
                        <a:pt x="1300" y="46"/>
                      </a:lnTo>
                      <a:lnTo>
                        <a:pt x="1301" y="46"/>
                      </a:lnTo>
                      <a:lnTo>
                        <a:pt x="1301" y="46"/>
                      </a:lnTo>
                      <a:lnTo>
                        <a:pt x="1301" y="50"/>
                      </a:lnTo>
                      <a:lnTo>
                        <a:pt x="1301" y="46"/>
                      </a:lnTo>
                      <a:lnTo>
                        <a:pt x="1302" y="46"/>
                      </a:lnTo>
                      <a:lnTo>
                        <a:pt x="1302" y="46"/>
                      </a:lnTo>
                      <a:lnTo>
                        <a:pt x="1302" y="50"/>
                      </a:lnTo>
                      <a:lnTo>
                        <a:pt x="1302" y="46"/>
                      </a:lnTo>
                      <a:lnTo>
                        <a:pt x="1303" y="46"/>
                      </a:lnTo>
                      <a:lnTo>
                        <a:pt x="1303" y="45"/>
                      </a:lnTo>
                      <a:lnTo>
                        <a:pt x="1303" y="49"/>
                      </a:lnTo>
                      <a:lnTo>
                        <a:pt x="1303" y="48"/>
                      </a:lnTo>
                      <a:lnTo>
                        <a:pt x="1304" y="48"/>
                      </a:lnTo>
                      <a:lnTo>
                        <a:pt x="1304" y="44"/>
                      </a:lnTo>
                      <a:lnTo>
                        <a:pt x="1304" y="49"/>
                      </a:lnTo>
                      <a:lnTo>
                        <a:pt x="1304" y="46"/>
                      </a:lnTo>
                      <a:lnTo>
                        <a:pt x="1305" y="46"/>
                      </a:lnTo>
                      <a:lnTo>
                        <a:pt x="1305" y="45"/>
                      </a:lnTo>
                      <a:lnTo>
                        <a:pt x="1305" y="51"/>
                      </a:lnTo>
                      <a:lnTo>
                        <a:pt x="1305" y="46"/>
                      </a:lnTo>
                      <a:lnTo>
                        <a:pt x="1306" y="46"/>
                      </a:lnTo>
                      <a:lnTo>
                        <a:pt x="1306" y="46"/>
                      </a:lnTo>
                      <a:lnTo>
                        <a:pt x="1306" y="50"/>
                      </a:lnTo>
                      <a:lnTo>
                        <a:pt x="1306" y="50"/>
                      </a:lnTo>
                      <a:lnTo>
                        <a:pt x="1307" y="50"/>
                      </a:lnTo>
                      <a:lnTo>
                        <a:pt x="1307" y="46"/>
                      </a:lnTo>
                      <a:lnTo>
                        <a:pt x="1307" y="49"/>
                      </a:lnTo>
                      <a:lnTo>
                        <a:pt x="1307" y="47"/>
                      </a:lnTo>
                      <a:lnTo>
                        <a:pt x="1308" y="47"/>
                      </a:lnTo>
                      <a:lnTo>
                        <a:pt x="1308" y="45"/>
                      </a:lnTo>
                      <a:lnTo>
                        <a:pt x="1308" y="48"/>
                      </a:lnTo>
                      <a:lnTo>
                        <a:pt x="1308" y="47"/>
                      </a:lnTo>
                      <a:lnTo>
                        <a:pt x="1309" y="47"/>
                      </a:lnTo>
                      <a:lnTo>
                        <a:pt x="1309" y="47"/>
                      </a:lnTo>
                      <a:lnTo>
                        <a:pt x="1309" y="50"/>
                      </a:lnTo>
                      <a:lnTo>
                        <a:pt x="1309" y="48"/>
                      </a:lnTo>
                      <a:lnTo>
                        <a:pt x="1310" y="48"/>
                      </a:lnTo>
                      <a:lnTo>
                        <a:pt x="1310" y="44"/>
                      </a:lnTo>
                      <a:lnTo>
                        <a:pt x="1310" y="49"/>
                      </a:lnTo>
                      <a:lnTo>
                        <a:pt x="1310" y="47"/>
                      </a:lnTo>
                      <a:lnTo>
                        <a:pt x="1311" y="47"/>
                      </a:lnTo>
                      <a:lnTo>
                        <a:pt x="1311" y="46"/>
                      </a:lnTo>
                      <a:lnTo>
                        <a:pt x="1311" y="49"/>
                      </a:lnTo>
                      <a:lnTo>
                        <a:pt x="1311" y="48"/>
                      </a:lnTo>
                      <a:lnTo>
                        <a:pt x="1312" y="48"/>
                      </a:lnTo>
                      <a:lnTo>
                        <a:pt x="1312" y="47"/>
                      </a:lnTo>
                      <a:lnTo>
                        <a:pt x="1312" y="50"/>
                      </a:lnTo>
                      <a:lnTo>
                        <a:pt x="1312" y="48"/>
                      </a:lnTo>
                      <a:lnTo>
                        <a:pt x="1313" y="48"/>
                      </a:lnTo>
                      <a:lnTo>
                        <a:pt x="1313" y="46"/>
                      </a:lnTo>
                      <a:lnTo>
                        <a:pt x="1313" y="51"/>
                      </a:lnTo>
                      <a:lnTo>
                        <a:pt x="1313" y="47"/>
                      </a:lnTo>
                      <a:lnTo>
                        <a:pt x="1314" y="47"/>
                      </a:lnTo>
                      <a:lnTo>
                        <a:pt x="1314" y="47"/>
                      </a:lnTo>
                      <a:lnTo>
                        <a:pt x="1314" y="50"/>
                      </a:lnTo>
                      <a:lnTo>
                        <a:pt x="1314" y="49"/>
                      </a:lnTo>
                      <a:lnTo>
                        <a:pt x="1315" y="49"/>
                      </a:lnTo>
                      <a:lnTo>
                        <a:pt x="1315" y="48"/>
                      </a:lnTo>
                      <a:lnTo>
                        <a:pt x="1315" y="51"/>
                      </a:lnTo>
                      <a:lnTo>
                        <a:pt x="1315" y="50"/>
                      </a:lnTo>
                      <a:lnTo>
                        <a:pt x="1316" y="50"/>
                      </a:lnTo>
                      <a:lnTo>
                        <a:pt x="1316" y="46"/>
                      </a:lnTo>
                      <a:lnTo>
                        <a:pt x="1316" y="49"/>
                      </a:lnTo>
                      <a:lnTo>
                        <a:pt x="1316" y="48"/>
                      </a:lnTo>
                      <a:lnTo>
                        <a:pt x="1317" y="48"/>
                      </a:lnTo>
                      <a:lnTo>
                        <a:pt x="1317" y="46"/>
                      </a:lnTo>
                      <a:lnTo>
                        <a:pt x="1317" y="50"/>
                      </a:lnTo>
                      <a:lnTo>
                        <a:pt x="1317" y="49"/>
                      </a:lnTo>
                      <a:lnTo>
                        <a:pt x="1318" y="49"/>
                      </a:lnTo>
                      <a:lnTo>
                        <a:pt x="1318" y="46"/>
                      </a:lnTo>
                      <a:lnTo>
                        <a:pt x="1318" y="50"/>
                      </a:lnTo>
                      <a:lnTo>
                        <a:pt x="1318" y="48"/>
                      </a:lnTo>
                      <a:lnTo>
                        <a:pt x="1319" y="48"/>
                      </a:lnTo>
                      <a:lnTo>
                        <a:pt x="1319" y="47"/>
                      </a:lnTo>
                      <a:lnTo>
                        <a:pt x="1319" y="50"/>
                      </a:lnTo>
                      <a:lnTo>
                        <a:pt x="1319" y="49"/>
                      </a:lnTo>
                      <a:lnTo>
                        <a:pt x="1320" y="49"/>
                      </a:lnTo>
                      <a:lnTo>
                        <a:pt x="1320" y="46"/>
                      </a:lnTo>
                      <a:lnTo>
                        <a:pt x="1320" y="50"/>
                      </a:lnTo>
                      <a:lnTo>
                        <a:pt x="1320" y="50"/>
                      </a:lnTo>
                      <a:lnTo>
                        <a:pt x="1321" y="50"/>
                      </a:lnTo>
                      <a:lnTo>
                        <a:pt x="1321" y="47"/>
                      </a:lnTo>
                      <a:lnTo>
                        <a:pt x="1321" y="51"/>
                      </a:lnTo>
                      <a:lnTo>
                        <a:pt x="1321" y="50"/>
                      </a:lnTo>
                      <a:lnTo>
                        <a:pt x="1322" y="50"/>
                      </a:lnTo>
                      <a:lnTo>
                        <a:pt x="1322" y="48"/>
                      </a:lnTo>
                      <a:lnTo>
                        <a:pt x="1322" y="51"/>
                      </a:lnTo>
                      <a:lnTo>
                        <a:pt x="1322" y="50"/>
                      </a:lnTo>
                      <a:lnTo>
                        <a:pt x="1323" y="50"/>
                      </a:lnTo>
                      <a:lnTo>
                        <a:pt x="1323" y="48"/>
                      </a:lnTo>
                      <a:lnTo>
                        <a:pt x="1323" y="51"/>
                      </a:lnTo>
                      <a:lnTo>
                        <a:pt x="1323" y="50"/>
                      </a:lnTo>
                      <a:lnTo>
                        <a:pt x="1324" y="50"/>
                      </a:lnTo>
                      <a:lnTo>
                        <a:pt x="1324" y="48"/>
                      </a:lnTo>
                      <a:lnTo>
                        <a:pt x="1324" y="51"/>
                      </a:lnTo>
                      <a:lnTo>
                        <a:pt x="1324" y="51"/>
                      </a:lnTo>
                      <a:lnTo>
                        <a:pt x="1325" y="51"/>
                      </a:lnTo>
                      <a:lnTo>
                        <a:pt x="1325" y="48"/>
                      </a:lnTo>
                      <a:lnTo>
                        <a:pt x="1325" y="51"/>
                      </a:lnTo>
                      <a:lnTo>
                        <a:pt x="1325" y="49"/>
                      </a:lnTo>
                      <a:lnTo>
                        <a:pt x="1326" y="49"/>
                      </a:lnTo>
                      <a:lnTo>
                        <a:pt x="1326" y="49"/>
                      </a:lnTo>
                      <a:lnTo>
                        <a:pt x="1326" y="53"/>
                      </a:lnTo>
                      <a:lnTo>
                        <a:pt x="1326" y="50"/>
                      </a:lnTo>
                      <a:lnTo>
                        <a:pt x="1327" y="50"/>
                      </a:lnTo>
                      <a:lnTo>
                        <a:pt x="1327" y="48"/>
                      </a:lnTo>
                      <a:lnTo>
                        <a:pt x="1327" y="53"/>
                      </a:lnTo>
                      <a:lnTo>
                        <a:pt x="1327" y="52"/>
                      </a:lnTo>
                      <a:lnTo>
                        <a:pt x="1328" y="52"/>
                      </a:lnTo>
                      <a:lnTo>
                        <a:pt x="1328" y="48"/>
                      </a:lnTo>
                      <a:lnTo>
                        <a:pt x="1328" y="52"/>
                      </a:lnTo>
                      <a:lnTo>
                        <a:pt x="1328" y="51"/>
                      </a:lnTo>
                      <a:lnTo>
                        <a:pt x="1329" y="51"/>
                      </a:lnTo>
                      <a:lnTo>
                        <a:pt x="1329" y="49"/>
                      </a:lnTo>
                      <a:lnTo>
                        <a:pt x="1329" y="52"/>
                      </a:lnTo>
                      <a:lnTo>
                        <a:pt x="1329" y="49"/>
                      </a:lnTo>
                      <a:lnTo>
                        <a:pt x="1330" y="49"/>
                      </a:lnTo>
                      <a:lnTo>
                        <a:pt x="1330" y="49"/>
                      </a:lnTo>
                      <a:lnTo>
                        <a:pt x="1330" y="51"/>
                      </a:lnTo>
                      <a:lnTo>
                        <a:pt x="1330" y="51"/>
                      </a:lnTo>
                      <a:lnTo>
                        <a:pt x="1331" y="51"/>
                      </a:lnTo>
                      <a:lnTo>
                        <a:pt x="1331" y="50"/>
                      </a:lnTo>
                      <a:lnTo>
                        <a:pt x="1331" y="53"/>
                      </a:lnTo>
                      <a:lnTo>
                        <a:pt x="1331" y="53"/>
                      </a:lnTo>
                      <a:lnTo>
                        <a:pt x="1332" y="53"/>
                      </a:lnTo>
                      <a:lnTo>
                        <a:pt x="1332" y="47"/>
                      </a:lnTo>
                      <a:lnTo>
                        <a:pt x="1332" y="53"/>
                      </a:lnTo>
                      <a:lnTo>
                        <a:pt x="1332" y="48"/>
                      </a:lnTo>
                      <a:lnTo>
                        <a:pt x="1333" y="48"/>
                      </a:lnTo>
                      <a:lnTo>
                        <a:pt x="1333" y="48"/>
                      </a:lnTo>
                      <a:lnTo>
                        <a:pt x="1333" y="51"/>
                      </a:lnTo>
                      <a:lnTo>
                        <a:pt x="1333" y="51"/>
                      </a:lnTo>
                      <a:lnTo>
                        <a:pt x="1334" y="51"/>
                      </a:lnTo>
                      <a:lnTo>
                        <a:pt x="1334" y="50"/>
                      </a:lnTo>
                      <a:lnTo>
                        <a:pt x="1334" y="53"/>
                      </a:lnTo>
                      <a:lnTo>
                        <a:pt x="1334" y="51"/>
                      </a:lnTo>
                      <a:lnTo>
                        <a:pt x="1335" y="51"/>
                      </a:lnTo>
                      <a:lnTo>
                        <a:pt x="1335" y="49"/>
                      </a:lnTo>
                      <a:lnTo>
                        <a:pt x="1335" y="52"/>
                      </a:lnTo>
                      <a:lnTo>
                        <a:pt x="1335" y="50"/>
                      </a:lnTo>
                      <a:lnTo>
                        <a:pt x="1336" y="50"/>
                      </a:lnTo>
                      <a:lnTo>
                        <a:pt x="1336" y="50"/>
                      </a:lnTo>
                      <a:lnTo>
                        <a:pt x="1336" y="54"/>
                      </a:lnTo>
                      <a:lnTo>
                        <a:pt x="1336" y="52"/>
                      </a:lnTo>
                      <a:lnTo>
                        <a:pt x="1337" y="52"/>
                      </a:lnTo>
                      <a:lnTo>
                        <a:pt x="1337" y="50"/>
                      </a:lnTo>
                      <a:lnTo>
                        <a:pt x="1337" y="56"/>
                      </a:lnTo>
                      <a:lnTo>
                        <a:pt x="1337" y="53"/>
                      </a:lnTo>
                      <a:lnTo>
                        <a:pt x="1338" y="53"/>
                      </a:lnTo>
                      <a:lnTo>
                        <a:pt x="1338" y="50"/>
                      </a:lnTo>
                      <a:lnTo>
                        <a:pt x="1338" y="54"/>
                      </a:lnTo>
                      <a:lnTo>
                        <a:pt x="1338" y="52"/>
                      </a:lnTo>
                      <a:lnTo>
                        <a:pt x="1339" y="52"/>
                      </a:lnTo>
                      <a:lnTo>
                        <a:pt x="1339" y="51"/>
                      </a:lnTo>
                      <a:lnTo>
                        <a:pt x="1339" y="53"/>
                      </a:lnTo>
                      <a:lnTo>
                        <a:pt x="1339" y="53"/>
                      </a:lnTo>
                      <a:lnTo>
                        <a:pt x="1340" y="53"/>
                      </a:lnTo>
                      <a:lnTo>
                        <a:pt x="1340" y="50"/>
                      </a:lnTo>
                      <a:lnTo>
                        <a:pt x="1340" y="56"/>
                      </a:lnTo>
                      <a:lnTo>
                        <a:pt x="1340" y="53"/>
                      </a:lnTo>
                      <a:lnTo>
                        <a:pt x="1341" y="53"/>
                      </a:lnTo>
                      <a:lnTo>
                        <a:pt x="1341" y="51"/>
                      </a:lnTo>
                      <a:lnTo>
                        <a:pt x="1341" y="55"/>
                      </a:lnTo>
                      <a:lnTo>
                        <a:pt x="1341" y="53"/>
                      </a:lnTo>
                      <a:lnTo>
                        <a:pt x="1342" y="53"/>
                      </a:lnTo>
                      <a:lnTo>
                        <a:pt x="1342" y="51"/>
                      </a:lnTo>
                      <a:lnTo>
                        <a:pt x="1342" y="55"/>
                      </a:lnTo>
                      <a:lnTo>
                        <a:pt x="1342" y="53"/>
                      </a:lnTo>
                      <a:lnTo>
                        <a:pt x="1343" y="53"/>
                      </a:lnTo>
                      <a:lnTo>
                        <a:pt x="1343" y="50"/>
                      </a:lnTo>
                      <a:lnTo>
                        <a:pt x="1343" y="56"/>
                      </a:lnTo>
                      <a:lnTo>
                        <a:pt x="1343" y="53"/>
                      </a:lnTo>
                      <a:lnTo>
                        <a:pt x="1344" y="53"/>
                      </a:lnTo>
                      <a:lnTo>
                        <a:pt x="1344" y="51"/>
                      </a:lnTo>
                      <a:lnTo>
                        <a:pt x="1344" y="54"/>
                      </a:lnTo>
                      <a:lnTo>
                        <a:pt x="1344" y="53"/>
                      </a:lnTo>
                      <a:lnTo>
                        <a:pt x="1345" y="53"/>
                      </a:lnTo>
                      <a:lnTo>
                        <a:pt x="1345" y="52"/>
                      </a:lnTo>
                      <a:lnTo>
                        <a:pt x="1345" y="54"/>
                      </a:lnTo>
                      <a:lnTo>
                        <a:pt x="1345" y="54"/>
                      </a:lnTo>
                      <a:lnTo>
                        <a:pt x="1346" y="54"/>
                      </a:lnTo>
                      <a:lnTo>
                        <a:pt x="1346" y="53"/>
                      </a:lnTo>
                      <a:lnTo>
                        <a:pt x="1346" y="56"/>
                      </a:lnTo>
                      <a:lnTo>
                        <a:pt x="1346" y="54"/>
                      </a:lnTo>
                      <a:lnTo>
                        <a:pt x="1347" y="54"/>
                      </a:lnTo>
                      <a:lnTo>
                        <a:pt x="1347" y="53"/>
                      </a:lnTo>
                      <a:lnTo>
                        <a:pt x="1347" y="56"/>
                      </a:lnTo>
                      <a:lnTo>
                        <a:pt x="1347" y="54"/>
                      </a:lnTo>
                      <a:lnTo>
                        <a:pt x="1348" y="54"/>
                      </a:lnTo>
                      <a:lnTo>
                        <a:pt x="1348" y="54"/>
                      </a:lnTo>
                      <a:lnTo>
                        <a:pt x="1348" y="56"/>
                      </a:lnTo>
                      <a:lnTo>
                        <a:pt x="1348" y="55"/>
                      </a:lnTo>
                      <a:lnTo>
                        <a:pt x="1349" y="55"/>
                      </a:lnTo>
                      <a:lnTo>
                        <a:pt x="1349" y="54"/>
                      </a:lnTo>
                      <a:lnTo>
                        <a:pt x="1349" y="59"/>
                      </a:lnTo>
                      <a:lnTo>
                        <a:pt x="1349" y="55"/>
                      </a:lnTo>
                      <a:lnTo>
                        <a:pt x="1350" y="55"/>
                      </a:lnTo>
                      <a:lnTo>
                        <a:pt x="1350" y="54"/>
                      </a:lnTo>
                      <a:lnTo>
                        <a:pt x="1350" y="57"/>
                      </a:lnTo>
                      <a:lnTo>
                        <a:pt x="1350" y="54"/>
                      </a:lnTo>
                      <a:lnTo>
                        <a:pt x="1351" y="54"/>
                      </a:lnTo>
                      <a:lnTo>
                        <a:pt x="1351" y="53"/>
                      </a:lnTo>
                      <a:lnTo>
                        <a:pt x="1351" y="57"/>
                      </a:lnTo>
                      <a:lnTo>
                        <a:pt x="1351" y="57"/>
                      </a:lnTo>
                      <a:lnTo>
                        <a:pt x="1352" y="57"/>
                      </a:lnTo>
                      <a:lnTo>
                        <a:pt x="1352" y="53"/>
                      </a:lnTo>
                      <a:lnTo>
                        <a:pt x="1352" y="56"/>
                      </a:lnTo>
                      <a:lnTo>
                        <a:pt x="1352" y="53"/>
                      </a:lnTo>
                      <a:lnTo>
                        <a:pt x="1353" y="53"/>
                      </a:lnTo>
                      <a:lnTo>
                        <a:pt x="1353" y="53"/>
                      </a:lnTo>
                      <a:lnTo>
                        <a:pt x="1353" y="56"/>
                      </a:lnTo>
                      <a:lnTo>
                        <a:pt x="1353" y="54"/>
                      </a:lnTo>
                      <a:lnTo>
                        <a:pt x="1354" y="54"/>
                      </a:lnTo>
                      <a:lnTo>
                        <a:pt x="1354" y="53"/>
                      </a:lnTo>
                      <a:lnTo>
                        <a:pt x="1354" y="56"/>
                      </a:lnTo>
                      <a:lnTo>
                        <a:pt x="1354" y="56"/>
                      </a:lnTo>
                      <a:lnTo>
                        <a:pt x="1355" y="56"/>
                      </a:lnTo>
                      <a:lnTo>
                        <a:pt x="1355" y="54"/>
                      </a:lnTo>
                      <a:lnTo>
                        <a:pt x="1355" y="57"/>
                      </a:lnTo>
                      <a:lnTo>
                        <a:pt x="1355" y="54"/>
                      </a:lnTo>
                      <a:lnTo>
                        <a:pt x="1356" y="54"/>
                      </a:lnTo>
                      <a:lnTo>
                        <a:pt x="1356" y="53"/>
                      </a:lnTo>
                      <a:lnTo>
                        <a:pt x="1356" y="57"/>
                      </a:lnTo>
                      <a:lnTo>
                        <a:pt x="1356" y="54"/>
                      </a:lnTo>
                      <a:lnTo>
                        <a:pt x="1357" y="54"/>
                      </a:lnTo>
                      <a:lnTo>
                        <a:pt x="1357" y="54"/>
                      </a:lnTo>
                      <a:lnTo>
                        <a:pt x="1357" y="57"/>
                      </a:lnTo>
                      <a:lnTo>
                        <a:pt x="1357" y="56"/>
                      </a:lnTo>
                      <a:lnTo>
                        <a:pt x="1358" y="56"/>
                      </a:lnTo>
                      <a:lnTo>
                        <a:pt x="1358" y="53"/>
                      </a:lnTo>
                      <a:lnTo>
                        <a:pt x="1358" y="57"/>
                      </a:lnTo>
                      <a:lnTo>
                        <a:pt x="1358" y="57"/>
                      </a:lnTo>
                      <a:lnTo>
                        <a:pt x="1359" y="57"/>
                      </a:lnTo>
                      <a:lnTo>
                        <a:pt x="1359" y="54"/>
                      </a:lnTo>
                      <a:lnTo>
                        <a:pt x="1359" y="57"/>
                      </a:lnTo>
                      <a:lnTo>
                        <a:pt x="1359" y="55"/>
                      </a:lnTo>
                      <a:lnTo>
                        <a:pt x="1360" y="55"/>
                      </a:lnTo>
                      <a:lnTo>
                        <a:pt x="1360" y="53"/>
                      </a:lnTo>
                      <a:lnTo>
                        <a:pt x="1360" y="57"/>
                      </a:lnTo>
                      <a:lnTo>
                        <a:pt x="1360" y="56"/>
                      </a:lnTo>
                      <a:lnTo>
                        <a:pt x="1361" y="56"/>
                      </a:lnTo>
                      <a:lnTo>
                        <a:pt x="1361" y="55"/>
                      </a:lnTo>
                      <a:lnTo>
                        <a:pt x="1361" y="59"/>
                      </a:lnTo>
                      <a:lnTo>
                        <a:pt x="1361" y="57"/>
                      </a:lnTo>
                      <a:lnTo>
                        <a:pt x="1362" y="57"/>
                      </a:lnTo>
                      <a:lnTo>
                        <a:pt x="1362" y="56"/>
                      </a:lnTo>
                      <a:lnTo>
                        <a:pt x="1362" y="59"/>
                      </a:lnTo>
                      <a:lnTo>
                        <a:pt x="1362" y="58"/>
                      </a:lnTo>
                      <a:lnTo>
                        <a:pt x="1363" y="58"/>
                      </a:lnTo>
                      <a:lnTo>
                        <a:pt x="1363" y="55"/>
                      </a:lnTo>
                      <a:lnTo>
                        <a:pt x="1363" y="59"/>
                      </a:lnTo>
                      <a:lnTo>
                        <a:pt x="1363" y="57"/>
                      </a:lnTo>
                      <a:lnTo>
                        <a:pt x="1364" y="57"/>
                      </a:lnTo>
                      <a:lnTo>
                        <a:pt x="1364" y="56"/>
                      </a:lnTo>
                      <a:lnTo>
                        <a:pt x="1364" y="59"/>
                      </a:lnTo>
                      <a:lnTo>
                        <a:pt x="1364" y="58"/>
                      </a:lnTo>
                      <a:lnTo>
                        <a:pt x="1365" y="58"/>
                      </a:lnTo>
                      <a:lnTo>
                        <a:pt x="1365" y="56"/>
                      </a:lnTo>
                      <a:lnTo>
                        <a:pt x="1365" y="59"/>
                      </a:lnTo>
                      <a:lnTo>
                        <a:pt x="1365" y="56"/>
                      </a:lnTo>
                      <a:lnTo>
                        <a:pt x="1366" y="56"/>
                      </a:lnTo>
                      <a:lnTo>
                        <a:pt x="1366" y="56"/>
                      </a:lnTo>
                      <a:lnTo>
                        <a:pt x="1366" y="59"/>
                      </a:lnTo>
                      <a:lnTo>
                        <a:pt x="1366" y="58"/>
                      </a:lnTo>
                      <a:lnTo>
                        <a:pt x="1367" y="58"/>
                      </a:lnTo>
                      <a:lnTo>
                        <a:pt x="1367" y="57"/>
                      </a:lnTo>
                      <a:lnTo>
                        <a:pt x="1367" y="61"/>
                      </a:lnTo>
                      <a:lnTo>
                        <a:pt x="1367" y="60"/>
                      </a:lnTo>
                      <a:lnTo>
                        <a:pt x="1368" y="60"/>
                      </a:lnTo>
                      <a:lnTo>
                        <a:pt x="1368" y="57"/>
                      </a:lnTo>
                      <a:lnTo>
                        <a:pt x="1368" y="60"/>
                      </a:lnTo>
                      <a:lnTo>
                        <a:pt x="1368" y="57"/>
                      </a:lnTo>
                      <a:lnTo>
                        <a:pt x="1369" y="57"/>
                      </a:lnTo>
                      <a:lnTo>
                        <a:pt x="1369" y="57"/>
                      </a:lnTo>
                      <a:lnTo>
                        <a:pt x="1369" y="60"/>
                      </a:lnTo>
                      <a:lnTo>
                        <a:pt x="1369" y="57"/>
                      </a:lnTo>
                      <a:lnTo>
                        <a:pt x="1370" y="57"/>
                      </a:lnTo>
                      <a:lnTo>
                        <a:pt x="1370" y="57"/>
                      </a:lnTo>
                      <a:lnTo>
                        <a:pt x="1370" y="59"/>
                      </a:lnTo>
                      <a:lnTo>
                        <a:pt x="1370" y="59"/>
                      </a:lnTo>
                      <a:lnTo>
                        <a:pt x="1371" y="59"/>
                      </a:lnTo>
                      <a:lnTo>
                        <a:pt x="1371" y="59"/>
                      </a:lnTo>
                      <a:lnTo>
                        <a:pt x="1371" y="62"/>
                      </a:lnTo>
                      <a:lnTo>
                        <a:pt x="1371" y="61"/>
                      </a:lnTo>
                      <a:lnTo>
                        <a:pt x="1372" y="61"/>
                      </a:lnTo>
                      <a:lnTo>
                        <a:pt x="1372" y="57"/>
                      </a:lnTo>
                      <a:lnTo>
                        <a:pt x="1372" y="61"/>
                      </a:lnTo>
                      <a:lnTo>
                        <a:pt x="1372" y="57"/>
                      </a:lnTo>
                      <a:lnTo>
                        <a:pt x="1373" y="57"/>
                      </a:lnTo>
                      <a:lnTo>
                        <a:pt x="1373" y="57"/>
                      </a:lnTo>
                      <a:lnTo>
                        <a:pt x="1373" y="60"/>
                      </a:lnTo>
                      <a:lnTo>
                        <a:pt x="1373" y="58"/>
                      </a:lnTo>
                      <a:lnTo>
                        <a:pt x="1374" y="58"/>
                      </a:lnTo>
                      <a:lnTo>
                        <a:pt x="1374" y="56"/>
                      </a:lnTo>
                      <a:lnTo>
                        <a:pt x="1374" y="62"/>
                      </a:lnTo>
                      <a:lnTo>
                        <a:pt x="1374" y="59"/>
                      </a:lnTo>
                      <a:lnTo>
                        <a:pt x="1375" y="59"/>
                      </a:lnTo>
                      <a:lnTo>
                        <a:pt x="1375" y="57"/>
                      </a:lnTo>
                      <a:lnTo>
                        <a:pt x="1375" y="62"/>
                      </a:lnTo>
                      <a:lnTo>
                        <a:pt x="1375" y="61"/>
                      </a:lnTo>
                      <a:lnTo>
                        <a:pt x="1376" y="61"/>
                      </a:lnTo>
                      <a:lnTo>
                        <a:pt x="1376" y="58"/>
                      </a:lnTo>
                      <a:lnTo>
                        <a:pt x="1376" y="61"/>
                      </a:lnTo>
                      <a:lnTo>
                        <a:pt x="1376" y="60"/>
                      </a:lnTo>
                      <a:lnTo>
                        <a:pt x="1377" y="60"/>
                      </a:lnTo>
                      <a:lnTo>
                        <a:pt x="1377" y="58"/>
                      </a:lnTo>
                      <a:lnTo>
                        <a:pt x="1377" y="62"/>
                      </a:lnTo>
                      <a:lnTo>
                        <a:pt x="1377" y="59"/>
                      </a:lnTo>
                      <a:lnTo>
                        <a:pt x="1378" y="59"/>
                      </a:lnTo>
                      <a:lnTo>
                        <a:pt x="1378" y="59"/>
                      </a:lnTo>
                      <a:lnTo>
                        <a:pt x="1378" y="62"/>
                      </a:lnTo>
                      <a:lnTo>
                        <a:pt x="1378" y="61"/>
                      </a:lnTo>
                      <a:lnTo>
                        <a:pt x="1379" y="61"/>
                      </a:lnTo>
                      <a:lnTo>
                        <a:pt x="1379" y="60"/>
                      </a:lnTo>
                      <a:lnTo>
                        <a:pt x="1379" y="62"/>
                      </a:lnTo>
                      <a:lnTo>
                        <a:pt x="1379" y="61"/>
                      </a:lnTo>
                      <a:lnTo>
                        <a:pt x="1380" y="61"/>
                      </a:lnTo>
                      <a:lnTo>
                        <a:pt x="1380" y="57"/>
                      </a:lnTo>
                      <a:lnTo>
                        <a:pt x="1380" y="62"/>
                      </a:lnTo>
                      <a:lnTo>
                        <a:pt x="1380" y="59"/>
                      </a:lnTo>
                      <a:lnTo>
                        <a:pt x="1381" y="59"/>
                      </a:lnTo>
                      <a:lnTo>
                        <a:pt x="1381" y="59"/>
                      </a:lnTo>
                      <a:lnTo>
                        <a:pt x="1381" y="63"/>
                      </a:lnTo>
                      <a:lnTo>
                        <a:pt x="1381" y="60"/>
                      </a:lnTo>
                      <a:lnTo>
                        <a:pt x="1382" y="60"/>
                      </a:lnTo>
                      <a:lnTo>
                        <a:pt x="1382" y="59"/>
                      </a:lnTo>
                      <a:lnTo>
                        <a:pt x="1382" y="63"/>
                      </a:lnTo>
                      <a:lnTo>
                        <a:pt x="1382" y="62"/>
                      </a:lnTo>
                      <a:lnTo>
                        <a:pt x="1383" y="62"/>
                      </a:lnTo>
                      <a:lnTo>
                        <a:pt x="1383" y="60"/>
                      </a:lnTo>
                      <a:lnTo>
                        <a:pt x="1383" y="63"/>
                      </a:lnTo>
                      <a:lnTo>
                        <a:pt x="1383" y="63"/>
                      </a:lnTo>
                      <a:lnTo>
                        <a:pt x="1384" y="63"/>
                      </a:lnTo>
                      <a:lnTo>
                        <a:pt x="1384" y="61"/>
                      </a:lnTo>
                      <a:lnTo>
                        <a:pt x="1384" y="65"/>
                      </a:lnTo>
                      <a:lnTo>
                        <a:pt x="1384" y="64"/>
                      </a:lnTo>
                      <a:lnTo>
                        <a:pt x="1385" y="64"/>
                      </a:lnTo>
                      <a:lnTo>
                        <a:pt x="1385" y="61"/>
                      </a:lnTo>
                      <a:lnTo>
                        <a:pt x="1385" y="65"/>
                      </a:lnTo>
                      <a:lnTo>
                        <a:pt x="1385" y="62"/>
                      </a:lnTo>
                      <a:lnTo>
                        <a:pt x="1386" y="62"/>
                      </a:lnTo>
                      <a:lnTo>
                        <a:pt x="1386" y="61"/>
                      </a:lnTo>
                      <a:lnTo>
                        <a:pt x="1386" y="66"/>
                      </a:lnTo>
                      <a:lnTo>
                        <a:pt x="1386" y="64"/>
                      </a:lnTo>
                      <a:lnTo>
                        <a:pt x="1387" y="64"/>
                      </a:lnTo>
                      <a:lnTo>
                        <a:pt x="1387" y="62"/>
                      </a:lnTo>
                      <a:lnTo>
                        <a:pt x="1387" y="66"/>
                      </a:lnTo>
                      <a:lnTo>
                        <a:pt x="1387" y="66"/>
                      </a:lnTo>
                      <a:lnTo>
                        <a:pt x="1388" y="66"/>
                      </a:lnTo>
                      <a:lnTo>
                        <a:pt x="1388" y="62"/>
                      </a:lnTo>
                      <a:lnTo>
                        <a:pt x="1388" y="66"/>
                      </a:lnTo>
                      <a:lnTo>
                        <a:pt x="1388" y="63"/>
                      </a:lnTo>
                      <a:lnTo>
                        <a:pt x="1389" y="63"/>
                      </a:lnTo>
                      <a:lnTo>
                        <a:pt x="1389" y="62"/>
                      </a:lnTo>
                      <a:lnTo>
                        <a:pt x="1389" y="65"/>
                      </a:lnTo>
                      <a:lnTo>
                        <a:pt x="1389" y="64"/>
                      </a:lnTo>
                      <a:lnTo>
                        <a:pt x="1390" y="64"/>
                      </a:lnTo>
                      <a:lnTo>
                        <a:pt x="1390" y="62"/>
                      </a:lnTo>
                      <a:lnTo>
                        <a:pt x="1390" y="67"/>
                      </a:lnTo>
                      <a:lnTo>
                        <a:pt x="1390" y="65"/>
                      </a:lnTo>
                      <a:lnTo>
                        <a:pt x="1391" y="65"/>
                      </a:lnTo>
                      <a:lnTo>
                        <a:pt x="1391" y="61"/>
                      </a:lnTo>
                      <a:lnTo>
                        <a:pt x="1391" y="66"/>
                      </a:lnTo>
                      <a:lnTo>
                        <a:pt x="1391" y="66"/>
                      </a:lnTo>
                      <a:lnTo>
                        <a:pt x="1392" y="66"/>
                      </a:lnTo>
                      <a:lnTo>
                        <a:pt x="1392" y="64"/>
                      </a:lnTo>
                      <a:lnTo>
                        <a:pt x="1392" y="67"/>
                      </a:lnTo>
                      <a:lnTo>
                        <a:pt x="1392" y="65"/>
                      </a:lnTo>
                      <a:lnTo>
                        <a:pt x="1393" y="65"/>
                      </a:lnTo>
                      <a:lnTo>
                        <a:pt x="1393" y="64"/>
                      </a:lnTo>
                      <a:lnTo>
                        <a:pt x="1393" y="70"/>
                      </a:lnTo>
                      <a:lnTo>
                        <a:pt x="1393" y="67"/>
                      </a:lnTo>
                      <a:lnTo>
                        <a:pt x="1394" y="67"/>
                      </a:lnTo>
                      <a:lnTo>
                        <a:pt x="1394" y="63"/>
                      </a:lnTo>
                      <a:lnTo>
                        <a:pt x="1394" y="67"/>
                      </a:lnTo>
                      <a:lnTo>
                        <a:pt x="1394" y="67"/>
                      </a:lnTo>
                      <a:lnTo>
                        <a:pt x="1395" y="67"/>
                      </a:lnTo>
                      <a:lnTo>
                        <a:pt x="1395" y="65"/>
                      </a:lnTo>
                      <a:lnTo>
                        <a:pt x="1395" y="67"/>
                      </a:lnTo>
                      <a:lnTo>
                        <a:pt x="1395" y="66"/>
                      </a:lnTo>
                      <a:lnTo>
                        <a:pt x="1396" y="66"/>
                      </a:lnTo>
                      <a:lnTo>
                        <a:pt x="1396" y="65"/>
                      </a:lnTo>
                      <a:lnTo>
                        <a:pt x="1396" y="69"/>
                      </a:lnTo>
                      <a:lnTo>
                        <a:pt x="1396" y="67"/>
                      </a:lnTo>
                      <a:lnTo>
                        <a:pt x="1397" y="67"/>
                      </a:lnTo>
                      <a:lnTo>
                        <a:pt x="1397" y="66"/>
                      </a:lnTo>
                      <a:lnTo>
                        <a:pt x="1397" y="70"/>
                      </a:lnTo>
                      <a:lnTo>
                        <a:pt x="1397" y="69"/>
                      </a:lnTo>
                      <a:lnTo>
                        <a:pt x="1398" y="69"/>
                      </a:lnTo>
                      <a:lnTo>
                        <a:pt x="1398" y="66"/>
                      </a:lnTo>
                      <a:lnTo>
                        <a:pt x="1398" y="70"/>
                      </a:lnTo>
                      <a:lnTo>
                        <a:pt x="1398" y="66"/>
                      </a:lnTo>
                      <a:lnTo>
                        <a:pt x="1399" y="66"/>
                      </a:lnTo>
                      <a:lnTo>
                        <a:pt x="1399" y="66"/>
                      </a:lnTo>
                      <a:lnTo>
                        <a:pt x="1399" y="69"/>
                      </a:lnTo>
                      <a:lnTo>
                        <a:pt x="1399" y="68"/>
                      </a:lnTo>
                      <a:lnTo>
                        <a:pt x="1400" y="68"/>
                      </a:lnTo>
                      <a:lnTo>
                        <a:pt x="1400" y="67"/>
                      </a:lnTo>
                      <a:lnTo>
                        <a:pt x="1400" y="70"/>
                      </a:lnTo>
                      <a:lnTo>
                        <a:pt x="1400" y="69"/>
                      </a:lnTo>
                      <a:lnTo>
                        <a:pt x="1401" y="69"/>
                      </a:lnTo>
                      <a:lnTo>
                        <a:pt x="1401" y="67"/>
                      </a:lnTo>
                      <a:lnTo>
                        <a:pt x="1401" y="72"/>
                      </a:lnTo>
                      <a:lnTo>
                        <a:pt x="1401" y="71"/>
                      </a:lnTo>
                      <a:lnTo>
                        <a:pt x="1402" y="71"/>
                      </a:lnTo>
                      <a:lnTo>
                        <a:pt x="1402" y="67"/>
                      </a:lnTo>
                      <a:lnTo>
                        <a:pt x="1402" y="73"/>
                      </a:lnTo>
                      <a:lnTo>
                        <a:pt x="1402" y="70"/>
                      </a:lnTo>
                      <a:lnTo>
                        <a:pt x="1403" y="70"/>
                      </a:lnTo>
                      <a:lnTo>
                        <a:pt x="1403" y="67"/>
                      </a:lnTo>
                      <a:lnTo>
                        <a:pt x="1403" y="71"/>
                      </a:lnTo>
                      <a:lnTo>
                        <a:pt x="1403" y="69"/>
                      </a:lnTo>
                      <a:lnTo>
                        <a:pt x="1404" y="69"/>
                      </a:lnTo>
                      <a:lnTo>
                        <a:pt x="1404" y="69"/>
                      </a:lnTo>
                      <a:lnTo>
                        <a:pt x="1404" y="71"/>
                      </a:lnTo>
                      <a:lnTo>
                        <a:pt x="1404" y="70"/>
                      </a:lnTo>
                      <a:lnTo>
                        <a:pt x="1405" y="70"/>
                      </a:lnTo>
                      <a:lnTo>
                        <a:pt x="1405" y="69"/>
                      </a:lnTo>
                      <a:lnTo>
                        <a:pt x="1405" y="72"/>
                      </a:lnTo>
                      <a:lnTo>
                        <a:pt x="1405" y="70"/>
                      </a:lnTo>
                      <a:lnTo>
                        <a:pt x="1406" y="70"/>
                      </a:lnTo>
                      <a:lnTo>
                        <a:pt x="1406" y="67"/>
                      </a:lnTo>
                      <a:lnTo>
                        <a:pt x="1406" y="72"/>
                      </a:lnTo>
                      <a:lnTo>
                        <a:pt x="1406" y="70"/>
                      </a:lnTo>
                      <a:lnTo>
                        <a:pt x="1407" y="70"/>
                      </a:lnTo>
                      <a:lnTo>
                        <a:pt x="1407" y="69"/>
                      </a:lnTo>
                      <a:lnTo>
                        <a:pt x="1407" y="72"/>
                      </a:lnTo>
                      <a:lnTo>
                        <a:pt x="1407" y="70"/>
                      </a:lnTo>
                      <a:lnTo>
                        <a:pt x="1408" y="70"/>
                      </a:lnTo>
                      <a:lnTo>
                        <a:pt x="1408" y="69"/>
                      </a:lnTo>
                      <a:lnTo>
                        <a:pt x="1408" y="72"/>
                      </a:lnTo>
                      <a:lnTo>
                        <a:pt x="1408" y="69"/>
                      </a:lnTo>
                      <a:lnTo>
                        <a:pt x="1409" y="69"/>
                      </a:lnTo>
                      <a:lnTo>
                        <a:pt x="1409" y="69"/>
                      </a:lnTo>
                      <a:lnTo>
                        <a:pt x="1409" y="73"/>
                      </a:lnTo>
                      <a:lnTo>
                        <a:pt x="1409" y="71"/>
                      </a:lnTo>
                      <a:lnTo>
                        <a:pt x="1410" y="71"/>
                      </a:lnTo>
                      <a:lnTo>
                        <a:pt x="1410" y="69"/>
                      </a:lnTo>
                      <a:lnTo>
                        <a:pt x="1410" y="72"/>
                      </a:lnTo>
                      <a:lnTo>
                        <a:pt x="1410" y="70"/>
                      </a:lnTo>
                      <a:lnTo>
                        <a:pt x="1411" y="70"/>
                      </a:lnTo>
                      <a:lnTo>
                        <a:pt x="1411" y="70"/>
                      </a:lnTo>
                      <a:lnTo>
                        <a:pt x="1411" y="73"/>
                      </a:lnTo>
                      <a:lnTo>
                        <a:pt x="1411" y="72"/>
                      </a:lnTo>
                      <a:lnTo>
                        <a:pt x="1412" y="72"/>
                      </a:lnTo>
                      <a:lnTo>
                        <a:pt x="1412" y="70"/>
                      </a:lnTo>
                      <a:lnTo>
                        <a:pt x="1412" y="75"/>
                      </a:lnTo>
                      <a:lnTo>
                        <a:pt x="1412" y="71"/>
                      </a:lnTo>
                      <a:lnTo>
                        <a:pt x="1413" y="71"/>
                      </a:lnTo>
                      <a:lnTo>
                        <a:pt x="1413" y="70"/>
                      </a:lnTo>
                      <a:lnTo>
                        <a:pt x="1413" y="75"/>
                      </a:lnTo>
                      <a:lnTo>
                        <a:pt x="1413" y="73"/>
                      </a:lnTo>
                      <a:lnTo>
                        <a:pt x="1414" y="73"/>
                      </a:lnTo>
                      <a:lnTo>
                        <a:pt x="1414" y="70"/>
                      </a:lnTo>
                      <a:lnTo>
                        <a:pt x="1414" y="76"/>
                      </a:lnTo>
                      <a:lnTo>
                        <a:pt x="1414" y="73"/>
                      </a:lnTo>
                      <a:lnTo>
                        <a:pt x="1415" y="73"/>
                      </a:lnTo>
                      <a:lnTo>
                        <a:pt x="1415" y="71"/>
                      </a:lnTo>
                      <a:lnTo>
                        <a:pt x="1415" y="75"/>
                      </a:lnTo>
                      <a:lnTo>
                        <a:pt x="1415" y="71"/>
                      </a:lnTo>
                      <a:lnTo>
                        <a:pt x="1416" y="71"/>
                      </a:lnTo>
                      <a:lnTo>
                        <a:pt x="1416" y="70"/>
                      </a:lnTo>
                      <a:lnTo>
                        <a:pt x="1416" y="75"/>
                      </a:lnTo>
                      <a:lnTo>
                        <a:pt x="1416" y="71"/>
                      </a:lnTo>
                      <a:lnTo>
                        <a:pt x="1417" y="71"/>
                      </a:lnTo>
                      <a:lnTo>
                        <a:pt x="1417" y="70"/>
                      </a:lnTo>
                      <a:lnTo>
                        <a:pt x="1417" y="75"/>
                      </a:lnTo>
                      <a:lnTo>
                        <a:pt x="1417" y="72"/>
                      </a:lnTo>
                      <a:lnTo>
                        <a:pt x="1418" y="72"/>
                      </a:lnTo>
                      <a:lnTo>
                        <a:pt x="1418" y="72"/>
                      </a:lnTo>
                      <a:lnTo>
                        <a:pt x="1418" y="76"/>
                      </a:lnTo>
                      <a:lnTo>
                        <a:pt x="1418" y="75"/>
                      </a:lnTo>
                      <a:lnTo>
                        <a:pt x="1419" y="75"/>
                      </a:lnTo>
                      <a:lnTo>
                        <a:pt x="1419" y="72"/>
                      </a:lnTo>
                      <a:lnTo>
                        <a:pt x="1419" y="77"/>
                      </a:lnTo>
                      <a:lnTo>
                        <a:pt x="1419" y="77"/>
                      </a:lnTo>
                      <a:lnTo>
                        <a:pt x="1420" y="77"/>
                      </a:lnTo>
                      <a:lnTo>
                        <a:pt x="1420" y="72"/>
                      </a:lnTo>
                      <a:lnTo>
                        <a:pt x="1420" y="76"/>
                      </a:lnTo>
                      <a:lnTo>
                        <a:pt x="1420" y="73"/>
                      </a:lnTo>
                      <a:lnTo>
                        <a:pt x="1421" y="73"/>
                      </a:lnTo>
                      <a:lnTo>
                        <a:pt x="1421" y="73"/>
                      </a:lnTo>
                      <a:lnTo>
                        <a:pt x="1421" y="76"/>
                      </a:lnTo>
                      <a:lnTo>
                        <a:pt x="1421" y="75"/>
                      </a:lnTo>
                      <a:lnTo>
                        <a:pt x="1422" y="75"/>
                      </a:lnTo>
                      <a:lnTo>
                        <a:pt x="1422" y="73"/>
                      </a:lnTo>
                      <a:lnTo>
                        <a:pt x="1422" y="76"/>
                      </a:lnTo>
                      <a:lnTo>
                        <a:pt x="1422" y="75"/>
                      </a:lnTo>
                      <a:lnTo>
                        <a:pt x="1423" y="75"/>
                      </a:lnTo>
                      <a:lnTo>
                        <a:pt x="1423" y="74"/>
                      </a:lnTo>
                      <a:lnTo>
                        <a:pt x="1423" y="76"/>
                      </a:lnTo>
                      <a:lnTo>
                        <a:pt x="1423" y="76"/>
                      </a:lnTo>
                      <a:lnTo>
                        <a:pt x="1424" y="76"/>
                      </a:lnTo>
                      <a:lnTo>
                        <a:pt x="1424" y="75"/>
                      </a:lnTo>
                      <a:lnTo>
                        <a:pt x="1424" y="78"/>
                      </a:lnTo>
                      <a:lnTo>
                        <a:pt x="1424" y="76"/>
                      </a:lnTo>
                      <a:lnTo>
                        <a:pt x="1425" y="76"/>
                      </a:lnTo>
                      <a:lnTo>
                        <a:pt x="1425" y="75"/>
                      </a:lnTo>
                      <a:lnTo>
                        <a:pt x="1425" y="78"/>
                      </a:lnTo>
                      <a:lnTo>
                        <a:pt x="1425" y="78"/>
                      </a:lnTo>
                      <a:lnTo>
                        <a:pt x="1426" y="78"/>
                      </a:lnTo>
                      <a:lnTo>
                        <a:pt x="1426" y="75"/>
                      </a:lnTo>
                      <a:lnTo>
                        <a:pt x="1426" y="78"/>
                      </a:lnTo>
                      <a:lnTo>
                        <a:pt x="1426" y="78"/>
                      </a:lnTo>
                      <a:lnTo>
                        <a:pt x="1427" y="78"/>
                      </a:lnTo>
                      <a:lnTo>
                        <a:pt x="1427" y="75"/>
                      </a:lnTo>
                      <a:lnTo>
                        <a:pt x="1427" y="78"/>
                      </a:lnTo>
                      <a:lnTo>
                        <a:pt x="1427" y="76"/>
                      </a:lnTo>
                      <a:lnTo>
                        <a:pt x="1428" y="76"/>
                      </a:lnTo>
                      <a:lnTo>
                        <a:pt x="1428" y="76"/>
                      </a:lnTo>
                      <a:lnTo>
                        <a:pt x="1428" y="82"/>
                      </a:lnTo>
                      <a:lnTo>
                        <a:pt x="1428" y="76"/>
                      </a:lnTo>
                      <a:lnTo>
                        <a:pt x="1429" y="76"/>
                      </a:lnTo>
                      <a:lnTo>
                        <a:pt x="1429" y="76"/>
                      </a:lnTo>
                      <a:lnTo>
                        <a:pt x="1429" y="80"/>
                      </a:lnTo>
                      <a:lnTo>
                        <a:pt x="1429" y="79"/>
                      </a:lnTo>
                      <a:lnTo>
                        <a:pt x="1430" y="79"/>
                      </a:lnTo>
                      <a:lnTo>
                        <a:pt x="1430" y="77"/>
                      </a:lnTo>
                      <a:lnTo>
                        <a:pt x="1430" y="81"/>
                      </a:lnTo>
                      <a:lnTo>
                        <a:pt x="1430" y="77"/>
                      </a:lnTo>
                      <a:lnTo>
                        <a:pt x="1431" y="77"/>
                      </a:lnTo>
                      <a:lnTo>
                        <a:pt x="1431" y="77"/>
                      </a:lnTo>
                      <a:lnTo>
                        <a:pt x="1431" y="81"/>
                      </a:lnTo>
                      <a:lnTo>
                        <a:pt x="1431" y="78"/>
                      </a:lnTo>
                      <a:lnTo>
                        <a:pt x="1432" y="78"/>
                      </a:lnTo>
                      <a:lnTo>
                        <a:pt x="1432" y="77"/>
                      </a:lnTo>
                      <a:lnTo>
                        <a:pt x="1432" y="81"/>
                      </a:lnTo>
                      <a:lnTo>
                        <a:pt x="1432" y="78"/>
                      </a:lnTo>
                      <a:lnTo>
                        <a:pt x="1433" y="78"/>
                      </a:lnTo>
                      <a:lnTo>
                        <a:pt x="1433" y="76"/>
                      </a:lnTo>
                      <a:lnTo>
                        <a:pt x="1433" y="82"/>
                      </a:lnTo>
                      <a:lnTo>
                        <a:pt x="1433" y="77"/>
                      </a:lnTo>
                      <a:lnTo>
                        <a:pt x="1434" y="77"/>
                      </a:lnTo>
                      <a:lnTo>
                        <a:pt x="1434" y="77"/>
                      </a:lnTo>
                      <a:lnTo>
                        <a:pt x="1434" y="82"/>
                      </a:lnTo>
                      <a:lnTo>
                        <a:pt x="1434" y="81"/>
                      </a:lnTo>
                      <a:lnTo>
                        <a:pt x="1435" y="81"/>
                      </a:lnTo>
                      <a:lnTo>
                        <a:pt x="1435" y="78"/>
                      </a:lnTo>
                      <a:lnTo>
                        <a:pt x="1435" y="82"/>
                      </a:lnTo>
                      <a:lnTo>
                        <a:pt x="1435" y="79"/>
                      </a:lnTo>
                      <a:lnTo>
                        <a:pt x="1436" y="79"/>
                      </a:lnTo>
                      <a:lnTo>
                        <a:pt x="1436" y="78"/>
                      </a:lnTo>
                      <a:lnTo>
                        <a:pt x="1436" y="81"/>
                      </a:lnTo>
                      <a:lnTo>
                        <a:pt x="1436" y="80"/>
                      </a:lnTo>
                      <a:lnTo>
                        <a:pt x="1437" y="80"/>
                      </a:lnTo>
                      <a:lnTo>
                        <a:pt x="1437" y="79"/>
                      </a:lnTo>
                      <a:lnTo>
                        <a:pt x="1437" y="82"/>
                      </a:lnTo>
                      <a:lnTo>
                        <a:pt x="1437" y="81"/>
                      </a:lnTo>
                      <a:lnTo>
                        <a:pt x="1438" y="81"/>
                      </a:lnTo>
                      <a:lnTo>
                        <a:pt x="1438" y="79"/>
                      </a:lnTo>
                      <a:lnTo>
                        <a:pt x="1438" y="82"/>
                      </a:lnTo>
                      <a:lnTo>
                        <a:pt x="1438" y="81"/>
                      </a:lnTo>
                      <a:lnTo>
                        <a:pt x="1439" y="81"/>
                      </a:lnTo>
                      <a:lnTo>
                        <a:pt x="1439" y="79"/>
                      </a:lnTo>
                      <a:lnTo>
                        <a:pt x="1439" y="82"/>
                      </a:lnTo>
                      <a:lnTo>
                        <a:pt x="1439" y="81"/>
                      </a:lnTo>
                      <a:lnTo>
                        <a:pt x="1440" y="81"/>
                      </a:lnTo>
                      <a:lnTo>
                        <a:pt x="1440" y="79"/>
                      </a:lnTo>
                      <a:lnTo>
                        <a:pt x="1440" y="84"/>
                      </a:lnTo>
                      <a:lnTo>
                        <a:pt x="1440" y="81"/>
                      </a:lnTo>
                      <a:lnTo>
                        <a:pt x="1441" y="81"/>
                      </a:lnTo>
                      <a:lnTo>
                        <a:pt x="1441" y="80"/>
                      </a:lnTo>
                      <a:lnTo>
                        <a:pt x="1441" y="84"/>
                      </a:lnTo>
                      <a:lnTo>
                        <a:pt x="1441" y="81"/>
                      </a:lnTo>
                      <a:lnTo>
                        <a:pt x="1442" y="81"/>
                      </a:lnTo>
                      <a:lnTo>
                        <a:pt x="1442" y="81"/>
                      </a:lnTo>
                      <a:lnTo>
                        <a:pt x="1442" y="84"/>
                      </a:lnTo>
                      <a:lnTo>
                        <a:pt x="1442" y="81"/>
                      </a:lnTo>
                      <a:lnTo>
                        <a:pt x="1443" y="81"/>
                      </a:lnTo>
                      <a:lnTo>
                        <a:pt x="1443" y="81"/>
                      </a:lnTo>
                      <a:lnTo>
                        <a:pt x="1443" y="84"/>
                      </a:lnTo>
                      <a:lnTo>
                        <a:pt x="1443" y="83"/>
                      </a:lnTo>
                      <a:lnTo>
                        <a:pt x="1444" y="83"/>
                      </a:lnTo>
                      <a:lnTo>
                        <a:pt x="1444" y="80"/>
                      </a:lnTo>
                      <a:lnTo>
                        <a:pt x="1444" y="84"/>
                      </a:lnTo>
                      <a:lnTo>
                        <a:pt x="1444" y="82"/>
                      </a:lnTo>
                      <a:lnTo>
                        <a:pt x="1445" y="82"/>
                      </a:lnTo>
                      <a:lnTo>
                        <a:pt x="1445" y="81"/>
                      </a:lnTo>
                      <a:lnTo>
                        <a:pt x="1445" y="84"/>
                      </a:lnTo>
                      <a:lnTo>
                        <a:pt x="1445" y="82"/>
                      </a:lnTo>
                      <a:lnTo>
                        <a:pt x="1446" y="82"/>
                      </a:lnTo>
                      <a:lnTo>
                        <a:pt x="1446" y="81"/>
                      </a:lnTo>
                      <a:lnTo>
                        <a:pt x="1446" y="85"/>
                      </a:lnTo>
                      <a:lnTo>
                        <a:pt x="1446" y="82"/>
                      </a:lnTo>
                      <a:lnTo>
                        <a:pt x="1447" y="82"/>
                      </a:lnTo>
                      <a:lnTo>
                        <a:pt x="1447" y="80"/>
                      </a:lnTo>
                      <a:lnTo>
                        <a:pt x="1447" y="85"/>
                      </a:lnTo>
                      <a:lnTo>
                        <a:pt x="1447" y="85"/>
                      </a:lnTo>
                      <a:lnTo>
                        <a:pt x="1448" y="85"/>
                      </a:lnTo>
                      <a:lnTo>
                        <a:pt x="1448" y="82"/>
                      </a:lnTo>
                      <a:lnTo>
                        <a:pt x="1448" y="85"/>
                      </a:lnTo>
                      <a:lnTo>
                        <a:pt x="1448" y="83"/>
                      </a:lnTo>
                      <a:lnTo>
                        <a:pt x="1449" y="83"/>
                      </a:lnTo>
                      <a:lnTo>
                        <a:pt x="1449" y="81"/>
                      </a:lnTo>
                      <a:lnTo>
                        <a:pt x="1449" y="85"/>
                      </a:lnTo>
                      <a:lnTo>
                        <a:pt x="1449" y="84"/>
                      </a:lnTo>
                      <a:lnTo>
                        <a:pt x="1450" y="84"/>
                      </a:lnTo>
                      <a:lnTo>
                        <a:pt x="1450" y="82"/>
                      </a:lnTo>
                      <a:lnTo>
                        <a:pt x="1450" y="86"/>
                      </a:lnTo>
                      <a:lnTo>
                        <a:pt x="1450" y="82"/>
                      </a:lnTo>
                      <a:lnTo>
                        <a:pt x="1451" y="82"/>
                      </a:lnTo>
                      <a:lnTo>
                        <a:pt x="1451" y="82"/>
                      </a:lnTo>
                      <a:lnTo>
                        <a:pt x="1451" y="86"/>
                      </a:lnTo>
                      <a:lnTo>
                        <a:pt x="1451" y="85"/>
                      </a:lnTo>
                      <a:lnTo>
                        <a:pt x="1452" y="85"/>
                      </a:lnTo>
                      <a:lnTo>
                        <a:pt x="1452" y="84"/>
                      </a:lnTo>
                      <a:lnTo>
                        <a:pt x="1452" y="89"/>
                      </a:lnTo>
                      <a:lnTo>
                        <a:pt x="1452" y="85"/>
                      </a:lnTo>
                      <a:lnTo>
                        <a:pt x="1453" y="85"/>
                      </a:lnTo>
                      <a:lnTo>
                        <a:pt x="1453" y="84"/>
                      </a:lnTo>
                      <a:lnTo>
                        <a:pt x="1453" y="89"/>
                      </a:lnTo>
                      <a:lnTo>
                        <a:pt x="1453" y="84"/>
                      </a:lnTo>
                      <a:lnTo>
                        <a:pt x="1454" y="84"/>
                      </a:lnTo>
                      <a:lnTo>
                        <a:pt x="1454" y="84"/>
                      </a:lnTo>
                      <a:lnTo>
                        <a:pt x="1454" y="88"/>
                      </a:lnTo>
                      <a:lnTo>
                        <a:pt x="1454" y="86"/>
                      </a:lnTo>
                      <a:lnTo>
                        <a:pt x="1455" y="86"/>
                      </a:lnTo>
                      <a:lnTo>
                        <a:pt x="1455" y="84"/>
                      </a:lnTo>
                      <a:lnTo>
                        <a:pt x="1455" y="88"/>
                      </a:lnTo>
                      <a:lnTo>
                        <a:pt x="1455" y="86"/>
                      </a:lnTo>
                      <a:lnTo>
                        <a:pt x="1456" y="86"/>
                      </a:lnTo>
                      <a:lnTo>
                        <a:pt x="1456" y="85"/>
                      </a:lnTo>
                      <a:lnTo>
                        <a:pt x="1456" y="87"/>
                      </a:lnTo>
                      <a:lnTo>
                        <a:pt x="1456" y="86"/>
                      </a:lnTo>
                      <a:lnTo>
                        <a:pt x="1457" y="86"/>
                      </a:lnTo>
                      <a:lnTo>
                        <a:pt x="1457" y="85"/>
                      </a:lnTo>
                      <a:lnTo>
                        <a:pt x="1457" y="88"/>
                      </a:lnTo>
                      <a:lnTo>
                        <a:pt x="1457" y="88"/>
                      </a:lnTo>
                      <a:lnTo>
                        <a:pt x="1458" y="88"/>
                      </a:lnTo>
                      <a:lnTo>
                        <a:pt x="1458" y="86"/>
                      </a:lnTo>
                      <a:lnTo>
                        <a:pt x="1458" y="89"/>
                      </a:lnTo>
                      <a:lnTo>
                        <a:pt x="1458" y="86"/>
                      </a:lnTo>
                      <a:lnTo>
                        <a:pt x="1459" y="86"/>
                      </a:lnTo>
                      <a:lnTo>
                        <a:pt x="1459" y="85"/>
                      </a:lnTo>
                      <a:lnTo>
                        <a:pt x="1459" y="88"/>
                      </a:lnTo>
                      <a:lnTo>
                        <a:pt x="1459" y="88"/>
                      </a:lnTo>
                      <a:lnTo>
                        <a:pt x="1460" y="88"/>
                      </a:lnTo>
                      <a:lnTo>
                        <a:pt x="1460" y="86"/>
                      </a:lnTo>
                      <a:lnTo>
                        <a:pt x="1460" y="88"/>
                      </a:lnTo>
                      <a:lnTo>
                        <a:pt x="1460" y="87"/>
                      </a:lnTo>
                      <a:lnTo>
                        <a:pt x="1461" y="87"/>
                      </a:lnTo>
                      <a:lnTo>
                        <a:pt x="1461" y="86"/>
                      </a:lnTo>
                      <a:lnTo>
                        <a:pt x="1461" y="88"/>
                      </a:lnTo>
                      <a:lnTo>
                        <a:pt x="1461" y="86"/>
                      </a:lnTo>
                      <a:lnTo>
                        <a:pt x="1462" y="86"/>
                      </a:lnTo>
                      <a:lnTo>
                        <a:pt x="1462" y="85"/>
                      </a:lnTo>
                      <a:lnTo>
                        <a:pt x="1462" y="88"/>
                      </a:lnTo>
                      <a:lnTo>
                        <a:pt x="1462" y="87"/>
                      </a:lnTo>
                      <a:lnTo>
                        <a:pt x="1463" y="87"/>
                      </a:lnTo>
                      <a:lnTo>
                        <a:pt x="1463" y="86"/>
                      </a:lnTo>
                      <a:lnTo>
                        <a:pt x="1463" y="89"/>
                      </a:lnTo>
                      <a:lnTo>
                        <a:pt x="1463" y="86"/>
                      </a:lnTo>
                      <a:lnTo>
                        <a:pt x="1464" y="86"/>
                      </a:lnTo>
                      <a:lnTo>
                        <a:pt x="1464" y="86"/>
                      </a:lnTo>
                      <a:lnTo>
                        <a:pt x="1464" y="89"/>
                      </a:lnTo>
                      <a:lnTo>
                        <a:pt x="1464" y="88"/>
                      </a:lnTo>
                      <a:lnTo>
                        <a:pt x="1465" y="88"/>
                      </a:lnTo>
                      <a:lnTo>
                        <a:pt x="1465" y="86"/>
                      </a:lnTo>
                      <a:lnTo>
                        <a:pt x="1465" y="89"/>
                      </a:lnTo>
                      <a:lnTo>
                        <a:pt x="1465" y="89"/>
                      </a:lnTo>
                      <a:lnTo>
                        <a:pt x="1466" y="89"/>
                      </a:lnTo>
                      <a:lnTo>
                        <a:pt x="1466" y="87"/>
                      </a:lnTo>
                      <a:lnTo>
                        <a:pt x="1466" y="90"/>
                      </a:lnTo>
                      <a:lnTo>
                        <a:pt x="1466" y="88"/>
                      </a:lnTo>
                      <a:lnTo>
                        <a:pt x="1467" y="88"/>
                      </a:lnTo>
                      <a:lnTo>
                        <a:pt x="1467" y="87"/>
                      </a:lnTo>
                      <a:lnTo>
                        <a:pt x="1467" y="91"/>
                      </a:lnTo>
                      <a:lnTo>
                        <a:pt x="1467" y="89"/>
                      </a:lnTo>
                      <a:lnTo>
                        <a:pt x="1468" y="89"/>
                      </a:lnTo>
                      <a:lnTo>
                        <a:pt x="1468" y="87"/>
                      </a:lnTo>
                      <a:lnTo>
                        <a:pt x="1468" y="91"/>
                      </a:lnTo>
                      <a:lnTo>
                        <a:pt x="1468" y="89"/>
                      </a:lnTo>
                      <a:lnTo>
                        <a:pt x="1469" y="89"/>
                      </a:lnTo>
                      <a:lnTo>
                        <a:pt x="1469" y="86"/>
                      </a:lnTo>
                      <a:lnTo>
                        <a:pt x="1469" y="90"/>
                      </a:lnTo>
                      <a:lnTo>
                        <a:pt x="1469" y="88"/>
                      </a:lnTo>
                      <a:lnTo>
                        <a:pt x="1470" y="88"/>
                      </a:lnTo>
                      <a:lnTo>
                        <a:pt x="1470" y="87"/>
                      </a:lnTo>
                      <a:lnTo>
                        <a:pt x="1470" y="91"/>
                      </a:lnTo>
                      <a:lnTo>
                        <a:pt x="1470" y="89"/>
                      </a:lnTo>
                      <a:lnTo>
                        <a:pt x="1471" y="89"/>
                      </a:lnTo>
                      <a:lnTo>
                        <a:pt x="1471" y="88"/>
                      </a:lnTo>
                      <a:lnTo>
                        <a:pt x="1471" y="92"/>
                      </a:lnTo>
                      <a:lnTo>
                        <a:pt x="1471" y="89"/>
                      </a:lnTo>
                      <a:lnTo>
                        <a:pt x="1472" y="89"/>
                      </a:lnTo>
                      <a:lnTo>
                        <a:pt x="1472" y="89"/>
                      </a:lnTo>
                      <a:lnTo>
                        <a:pt x="1472" y="93"/>
                      </a:lnTo>
                      <a:lnTo>
                        <a:pt x="1472" y="89"/>
                      </a:lnTo>
                      <a:lnTo>
                        <a:pt x="1473" y="89"/>
                      </a:lnTo>
                      <a:lnTo>
                        <a:pt x="1473" y="88"/>
                      </a:lnTo>
                      <a:lnTo>
                        <a:pt x="1473" y="92"/>
                      </a:lnTo>
                      <a:lnTo>
                        <a:pt x="1473" y="92"/>
                      </a:lnTo>
                      <a:lnTo>
                        <a:pt x="1474" y="92"/>
                      </a:lnTo>
                      <a:lnTo>
                        <a:pt x="1474" y="89"/>
                      </a:lnTo>
                      <a:lnTo>
                        <a:pt x="1474" y="92"/>
                      </a:lnTo>
                      <a:lnTo>
                        <a:pt x="1474" y="91"/>
                      </a:lnTo>
                      <a:lnTo>
                        <a:pt x="1475" y="91"/>
                      </a:lnTo>
                      <a:lnTo>
                        <a:pt x="1475" y="89"/>
                      </a:lnTo>
                      <a:lnTo>
                        <a:pt x="1475" y="92"/>
                      </a:lnTo>
                      <a:lnTo>
                        <a:pt x="1475" y="91"/>
                      </a:lnTo>
                      <a:lnTo>
                        <a:pt x="1476" y="91"/>
                      </a:lnTo>
                      <a:lnTo>
                        <a:pt x="1476" y="88"/>
                      </a:lnTo>
                      <a:lnTo>
                        <a:pt x="1476" y="92"/>
                      </a:lnTo>
                      <a:lnTo>
                        <a:pt x="1476" y="90"/>
                      </a:lnTo>
                      <a:lnTo>
                        <a:pt x="1477" y="90"/>
                      </a:lnTo>
                      <a:lnTo>
                        <a:pt x="1477" y="90"/>
                      </a:lnTo>
                      <a:lnTo>
                        <a:pt x="1477" y="93"/>
                      </a:lnTo>
                      <a:lnTo>
                        <a:pt x="1477" y="91"/>
                      </a:lnTo>
                      <a:lnTo>
                        <a:pt x="1478" y="91"/>
                      </a:lnTo>
                      <a:lnTo>
                        <a:pt x="1478" y="90"/>
                      </a:lnTo>
                      <a:lnTo>
                        <a:pt x="1478" y="93"/>
                      </a:lnTo>
                      <a:lnTo>
                        <a:pt x="1478" y="92"/>
                      </a:lnTo>
                      <a:lnTo>
                        <a:pt x="1479" y="92"/>
                      </a:lnTo>
                      <a:lnTo>
                        <a:pt x="1479" y="91"/>
                      </a:lnTo>
                      <a:lnTo>
                        <a:pt x="1479" y="94"/>
                      </a:lnTo>
                      <a:lnTo>
                        <a:pt x="1479" y="91"/>
                      </a:lnTo>
                      <a:lnTo>
                        <a:pt x="1480" y="91"/>
                      </a:lnTo>
                      <a:lnTo>
                        <a:pt x="1480" y="89"/>
                      </a:lnTo>
                      <a:lnTo>
                        <a:pt x="1480" y="94"/>
                      </a:lnTo>
                      <a:lnTo>
                        <a:pt x="1480" y="91"/>
                      </a:lnTo>
                      <a:lnTo>
                        <a:pt x="1481" y="91"/>
                      </a:lnTo>
                      <a:lnTo>
                        <a:pt x="1481" y="91"/>
                      </a:lnTo>
                      <a:lnTo>
                        <a:pt x="1481" y="94"/>
                      </a:lnTo>
                      <a:lnTo>
                        <a:pt x="1481" y="91"/>
                      </a:lnTo>
                      <a:lnTo>
                        <a:pt x="1482" y="91"/>
                      </a:lnTo>
                      <a:lnTo>
                        <a:pt x="1482" y="92"/>
                      </a:lnTo>
                      <a:lnTo>
                        <a:pt x="1482" y="95"/>
                      </a:lnTo>
                      <a:lnTo>
                        <a:pt x="1482" y="93"/>
                      </a:lnTo>
                      <a:lnTo>
                        <a:pt x="1483" y="93"/>
                      </a:lnTo>
                      <a:lnTo>
                        <a:pt x="1483" y="91"/>
                      </a:lnTo>
                      <a:lnTo>
                        <a:pt x="1483" y="95"/>
                      </a:lnTo>
                      <a:lnTo>
                        <a:pt x="1483" y="91"/>
                      </a:lnTo>
                      <a:lnTo>
                        <a:pt x="1484" y="91"/>
                      </a:lnTo>
                      <a:lnTo>
                        <a:pt x="1484" y="91"/>
                      </a:lnTo>
                      <a:lnTo>
                        <a:pt x="1484" y="94"/>
                      </a:lnTo>
                      <a:lnTo>
                        <a:pt x="1484" y="94"/>
                      </a:lnTo>
                      <a:lnTo>
                        <a:pt x="1485" y="94"/>
                      </a:lnTo>
                      <a:lnTo>
                        <a:pt x="1485" y="92"/>
                      </a:lnTo>
                      <a:lnTo>
                        <a:pt x="1485" y="96"/>
                      </a:lnTo>
                      <a:lnTo>
                        <a:pt x="1485" y="94"/>
                      </a:lnTo>
                      <a:lnTo>
                        <a:pt x="1486" y="94"/>
                      </a:lnTo>
                      <a:lnTo>
                        <a:pt x="1486" y="92"/>
                      </a:lnTo>
                      <a:lnTo>
                        <a:pt x="1486" y="94"/>
                      </a:lnTo>
                      <a:lnTo>
                        <a:pt x="1486" y="93"/>
                      </a:lnTo>
                      <a:lnTo>
                        <a:pt x="1487" y="93"/>
                      </a:lnTo>
                      <a:lnTo>
                        <a:pt x="1487" y="91"/>
                      </a:lnTo>
                      <a:lnTo>
                        <a:pt x="1487" y="95"/>
                      </a:lnTo>
                      <a:lnTo>
                        <a:pt x="1487" y="94"/>
                      </a:lnTo>
                      <a:lnTo>
                        <a:pt x="1488" y="94"/>
                      </a:lnTo>
                      <a:lnTo>
                        <a:pt x="1488" y="92"/>
                      </a:lnTo>
                      <a:lnTo>
                        <a:pt x="1488" y="94"/>
                      </a:lnTo>
                      <a:lnTo>
                        <a:pt x="1488" y="92"/>
                      </a:lnTo>
                      <a:lnTo>
                        <a:pt x="1489" y="92"/>
                      </a:lnTo>
                      <a:lnTo>
                        <a:pt x="1489" y="92"/>
                      </a:lnTo>
                      <a:lnTo>
                        <a:pt x="1489" y="97"/>
                      </a:lnTo>
                      <a:lnTo>
                        <a:pt x="1489" y="95"/>
                      </a:lnTo>
                      <a:lnTo>
                        <a:pt x="1490" y="95"/>
                      </a:lnTo>
                      <a:lnTo>
                        <a:pt x="1490" y="93"/>
                      </a:lnTo>
                      <a:lnTo>
                        <a:pt x="1490" y="97"/>
                      </a:lnTo>
                      <a:lnTo>
                        <a:pt x="1490" y="95"/>
                      </a:lnTo>
                      <a:lnTo>
                        <a:pt x="1491" y="95"/>
                      </a:lnTo>
                      <a:lnTo>
                        <a:pt x="1491" y="93"/>
                      </a:lnTo>
                      <a:lnTo>
                        <a:pt x="1491" y="96"/>
                      </a:lnTo>
                      <a:lnTo>
                        <a:pt x="1491" y="94"/>
                      </a:lnTo>
                      <a:lnTo>
                        <a:pt x="1492" y="94"/>
                      </a:lnTo>
                      <a:lnTo>
                        <a:pt x="1492" y="92"/>
                      </a:lnTo>
                      <a:lnTo>
                        <a:pt x="1492" y="97"/>
                      </a:lnTo>
                      <a:lnTo>
                        <a:pt x="1492" y="94"/>
                      </a:lnTo>
                      <a:lnTo>
                        <a:pt x="1493" y="94"/>
                      </a:lnTo>
                      <a:lnTo>
                        <a:pt x="1493" y="94"/>
                      </a:lnTo>
                      <a:lnTo>
                        <a:pt x="1493" y="98"/>
                      </a:lnTo>
                      <a:lnTo>
                        <a:pt x="1493" y="95"/>
                      </a:lnTo>
                      <a:lnTo>
                        <a:pt x="1494" y="95"/>
                      </a:lnTo>
                      <a:lnTo>
                        <a:pt x="1494" y="93"/>
                      </a:lnTo>
                      <a:lnTo>
                        <a:pt x="1494" y="96"/>
                      </a:lnTo>
                      <a:lnTo>
                        <a:pt x="1494" y="94"/>
                      </a:lnTo>
                      <a:lnTo>
                        <a:pt x="1495" y="94"/>
                      </a:lnTo>
                      <a:lnTo>
                        <a:pt x="1495" y="93"/>
                      </a:lnTo>
                      <a:lnTo>
                        <a:pt x="1495" y="97"/>
                      </a:lnTo>
                      <a:lnTo>
                        <a:pt x="1495" y="95"/>
                      </a:lnTo>
                      <a:lnTo>
                        <a:pt x="1496" y="95"/>
                      </a:lnTo>
                      <a:lnTo>
                        <a:pt x="1496" y="94"/>
                      </a:lnTo>
                      <a:lnTo>
                        <a:pt x="1496" y="98"/>
                      </a:lnTo>
                      <a:lnTo>
                        <a:pt x="1496" y="95"/>
                      </a:lnTo>
                      <a:lnTo>
                        <a:pt x="1497" y="95"/>
                      </a:lnTo>
                      <a:lnTo>
                        <a:pt x="1497" y="92"/>
                      </a:lnTo>
                      <a:lnTo>
                        <a:pt x="1497" y="97"/>
                      </a:lnTo>
                      <a:lnTo>
                        <a:pt x="1497" y="96"/>
                      </a:lnTo>
                      <a:lnTo>
                        <a:pt x="1498" y="96"/>
                      </a:lnTo>
                      <a:lnTo>
                        <a:pt x="1498" y="94"/>
                      </a:lnTo>
                      <a:lnTo>
                        <a:pt x="1498" y="99"/>
                      </a:lnTo>
                      <a:lnTo>
                        <a:pt x="1498" y="96"/>
                      </a:lnTo>
                      <a:lnTo>
                        <a:pt x="1499" y="96"/>
                      </a:lnTo>
                      <a:lnTo>
                        <a:pt x="1499" y="94"/>
                      </a:lnTo>
                      <a:lnTo>
                        <a:pt x="1499" y="98"/>
                      </a:lnTo>
                      <a:lnTo>
                        <a:pt x="1499" y="95"/>
                      </a:lnTo>
                      <a:lnTo>
                        <a:pt x="1500" y="95"/>
                      </a:lnTo>
                      <a:lnTo>
                        <a:pt x="1500" y="95"/>
                      </a:lnTo>
                      <a:lnTo>
                        <a:pt x="1500" y="98"/>
                      </a:lnTo>
                      <a:lnTo>
                        <a:pt x="1500" y="95"/>
                      </a:lnTo>
                      <a:lnTo>
                        <a:pt x="1501" y="95"/>
                      </a:lnTo>
                      <a:lnTo>
                        <a:pt x="1501" y="94"/>
                      </a:lnTo>
                      <a:lnTo>
                        <a:pt x="1501" y="100"/>
                      </a:lnTo>
                      <a:lnTo>
                        <a:pt x="1501" y="97"/>
                      </a:lnTo>
                      <a:lnTo>
                        <a:pt x="1502" y="97"/>
                      </a:lnTo>
                      <a:lnTo>
                        <a:pt x="1502" y="96"/>
                      </a:lnTo>
                      <a:lnTo>
                        <a:pt x="1502" y="98"/>
                      </a:lnTo>
                      <a:lnTo>
                        <a:pt x="1502" y="97"/>
                      </a:lnTo>
                      <a:lnTo>
                        <a:pt x="1503" y="97"/>
                      </a:lnTo>
                      <a:lnTo>
                        <a:pt x="1503" y="94"/>
                      </a:lnTo>
                      <a:lnTo>
                        <a:pt x="1503" y="98"/>
                      </a:lnTo>
                      <a:lnTo>
                        <a:pt x="1503" y="97"/>
                      </a:lnTo>
                      <a:lnTo>
                        <a:pt x="1504" y="97"/>
                      </a:lnTo>
                      <a:lnTo>
                        <a:pt x="1504" y="95"/>
                      </a:lnTo>
                      <a:lnTo>
                        <a:pt x="1504" y="98"/>
                      </a:lnTo>
                      <a:lnTo>
                        <a:pt x="1504" y="97"/>
                      </a:lnTo>
                      <a:lnTo>
                        <a:pt x="1505" y="97"/>
                      </a:lnTo>
                      <a:lnTo>
                        <a:pt x="1505" y="95"/>
                      </a:lnTo>
                      <a:lnTo>
                        <a:pt x="1505" y="100"/>
                      </a:lnTo>
                      <a:lnTo>
                        <a:pt x="1505" y="95"/>
                      </a:lnTo>
                      <a:lnTo>
                        <a:pt x="1506" y="95"/>
                      </a:lnTo>
                      <a:lnTo>
                        <a:pt x="1506" y="95"/>
                      </a:lnTo>
                      <a:lnTo>
                        <a:pt x="1506" y="98"/>
                      </a:lnTo>
                      <a:lnTo>
                        <a:pt x="1506" y="97"/>
                      </a:lnTo>
                      <a:lnTo>
                        <a:pt x="1507" y="97"/>
                      </a:lnTo>
                      <a:lnTo>
                        <a:pt x="1507" y="96"/>
                      </a:lnTo>
                      <a:lnTo>
                        <a:pt x="1507" y="98"/>
                      </a:lnTo>
                      <a:lnTo>
                        <a:pt x="1507" y="97"/>
                      </a:lnTo>
                      <a:lnTo>
                        <a:pt x="1508" y="97"/>
                      </a:lnTo>
                      <a:lnTo>
                        <a:pt x="1508" y="97"/>
                      </a:lnTo>
                      <a:lnTo>
                        <a:pt x="1508" y="99"/>
                      </a:lnTo>
                      <a:lnTo>
                        <a:pt x="1508" y="98"/>
                      </a:lnTo>
                      <a:lnTo>
                        <a:pt x="1509" y="98"/>
                      </a:lnTo>
                      <a:lnTo>
                        <a:pt x="1509" y="96"/>
                      </a:lnTo>
                      <a:lnTo>
                        <a:pt x="1509" y="100"/>
                      </a:lnTo>
                      <a:lnTo>
                        <a:pt x="1509" y="97"/>
                      </a:lnTo>
                      <a:lnTo>
                        <a:pt x="1510" y="97"/>
                      </a:lnTo>
                      <a:lnTo>
                        <a:pt x="1510" y="97"/>
                      </a:lnTo>
                      <a:lnTo>
                        <a:pt x="1510" y="100"/>
                      </a:lnTo>
                      <a:lnTo>
                        <a:pt x="1510" y="99"/>
                      </a:lnTo>
                      <a:lnTo>
                        <a:pt x="1511" y="99"/>
                      </a:lnTo>
                      <a:lnTo>
                        <a:pt x="1511" y="97"/>
                      </a:lnTo>
                      <a:lnTo>
                        <a:pt x="1511" y="100"/>
                      </a:lnTo>
                      <a:lnTo>
                        <a:pt x="1511" y="98"/>
                      </a:lnTo>
                      <a:lnTo>
                        <a:pt x="1512" y="98"/>
                      </a:lnTo>
                      <a:lnTo>
                        <a:pt x="1512" y="97"/>
                      </a:lnTo>
                      <a:lnTo>
                        <a:pt x="1512" y="101"/>
                      </a:lnTo>
                      <a:lnTo>
                        <a:pt x="1512" y="99"/>
                      </a:lnTo>
                      <a:lnTo>
                        <a:pt x="1513" y="99"/>
                      </a:lnTo>
                      <a:lnTo>
                        <a:pt x="1513" y="97"/>
                      </a:lnTo>
                      <a:lnTo>
                        <a:pt x="1513" y="101"/>
                      </a:lnTo>
                      <a:lnTo>
                        <a:pt x="1513" y="98"/>
                      </a:lnTo>
                      <a:lnTo>
                        <a:pt x="1514" y="98"/>
                      </a:lnTo>
                      <a:lnTo>
                        <a:pt x="1514" y="97"/>
                      </a:lnTo>
                      <a:lnTo>
                        <a:pt x="1514" y="101"/>
                      </a:lnTo>
                      <a:lnTo>
                        <a:pt x="1514" y="98"/>
                      </a:lnTo>
                      <a:lnTo>
                        <a:pt x="1515" y="98"/>
                      </a:lnTo>
                      <a:lnTo>
                        <a:pt x="1515" y="98"/>
                      </a:lnTo>
                      <a:lnTo>
                        <a:pt x="1515" y="103"/>
                      </a:lnTo>
                      <a:lnTo>
                        <a:pt x="1515" y="98"/>
                      </a:lnTo>
                      <a:lnTo>
                        <a:pt x="1516" y="98"/>
                      </a:lnTo>
                      <a:lnTo>
                        <a:pt x="1516" y="98"/>
                      </a:lnTo>
                      <a:lnTo>
                        <a:pt x="1516" y="101"/>
                      </a:lnTo>
                      <a:lnTo>
                        <a:pt x="1516" y="99"/>
                      </a:lnTo>
                      <a:lnTo>
                        <a:pt x="1517" y="99"/>
                      </a:lnTo>
                      <a:lnTo>
                        <a:pt x="1517" y="98"/>
                      </a:lnTo>
                      <a:lnTo>
                        <a:pt x="1517" y="101"/>
                      </a:lnTo>
                      <a:lnTo>
                        <a:pt x="1517" y="99"/>
                      </a:lnTo>
                      <a:lnTo>
                        <a:pt x="1518" y="99"/>
                      </a:lnTo>
                      <a:lnTo>
                        <a:pt x="1518" y="98"/>
                      </a:lnTo>
                      <a:lnTo>
                        <a:pt x="1518" y="103"/>
                      </a:lnTo>
                      <a:lnTo>
                        <a:pt x="1518" y="100"/>
                      </a:lnTo>
                      <a:lnTo>
                        <a:pt x="1519" y="100"/>
                      </a:lnTo>
                      <a:lnTo>
                        <a:pt x="1519" y="98"/>
                      </a:lnTo>
                      <a:lnTo>
                        <a:pt x="1519" y="101"/>
                      </a:lnTo>
                      <a:lnTo>
                        <a:pt x="1519" y="101"/>
                      </a:lnTo>
                      <a:lnTo>
                        <a:pt x="1520" y="101"/>
                      </a:lnTo>
                      <a:lnTo>
                        <a:pt x="1520" y="98"/>
                      </a:lnTo>
                      <a:lnTo>
                        <a:pt x="1520" y="102"/>
                      </a:lnTo>
                      <a:lnTo>
                        <a:pt x="1520" y="100"/>
                      </a:lnTo>
                      <a:lnTo>
                        <a:pt x="1521" y="100"/>
                      </a:lnTo>
                      <a:lnTo>
                        <a:pt x="1521" y="98"/>
                      </a:lnTo>
                      <a:lnTo>
                        <a:pt x="1521" y="103"/>
                      </a:lnTo>
                      <a:lnTo>
                        <a:pt x="1521" y="98"/>
                      </a:lnTo>
                      <a:lnTo>
                        <a:pt x="1522" y="98"/>
                      </a:lnTo>
                      <a:lnTo>
                        <a:pt x="1522" y="99"/>
                      </a:lnTo>
                      <a:lnTo>
                        <a:pt x="1522" y="103"/>
                      </a:lnTo>
                      <a:lnTo>
                        <a:pt x="1522" y="100"/>
                      </a:lnTo>
                      <a:lnTo>
                        <a:pt x="1523" y="100"/>
                      </a:lnTo>
                      <a:lnTo>
                        <a:pt x="1523" y="100"/>
                      </a:lnTo>
                      <a:lnTo>
                        <a:pt x="1523" y="101"/>
                      </a:lnTo>
                      <a:lnTo>
                        <a:pt x="1523" y="101"/>
                      </a:lnTo>
                      <a:lnTo>
                        <a:pt x="1524" y="101"/>
                      </a:lnTo>
                      <a:lnTo>
                        <a:pt x="1524" y="100"/>
                      </a:lnTo>
                      <a:lnTo>
                        <a:pt x="1524" y="103"/>
                      </a:lnTo>
                      <a:lnTo>
                        <a:pt x="1524" y="100"/>
                      </a:lnTo>
                      <a:lnTo>
                        <a:pt x="1525" y="100"/>
                      </a:lnTo>
                      <a:lnTo>
                        <a:pt x="1525" y="98"/>
                      </a:lnTo>
                      <a:lnTo>
                        <a:pt x="1525" y="103"/>
                      </a:lnTo>
                      <a:lnTo>
                        <a:pt x="1525" y="103"/>
                      </a:lnTo>
                      <a:lnTo>
                        <a:pt x="1526" y="103"/>
                      </a:lnTo>
                      <a:lnTo>
                        <a:pt x="1526" y="99"/>
                      </a:lnTo>
                      <a:lnTo>
                        <a:pt x="1526" y="104"/>
                      </a:lnTo>
                      <a:lnTo>
                        <a:pt x="1526" y="101"/>
                      </a:lnTo>
                      <a:lnTo>
                        <a:pt x="1527" y="101"/>
                      </a:lnTo>
                      <a:lnTo>
                        <a:pt x="1527" y="99"/>
                      </a:lnTo>
                      <a:lnTo>
                        <a:pt x="1527" y="103"/>
                      </a:lnTo>
                      <a:lnTo>
                        <a:pt x="1527" y="100"/>
                      </a:lnTo>
                      <a:lnTo>
                        <a:pt x="1528" y="100"/>
                      </a:lnTo>
                      <a:lnTo>
                        <a:pt x="1528" y="98"/>
                      </a:lnTo>
                      <a:lnTo>
                        <a:pt x="1528" y="103"/>
                      </a:lnTo>
                      <a:lnTo>
                        <a:pt x="1528" y="100"/>
                      </a:lnTo>
                      <a:lnTo>
                        <a:pt x="1529" y="100"/>
                      </a:lnTo>
                      <a:lnTo>
                        <a:pt x="1529" y="99"/>
                      </a:lnTo>
                      <a:lnTo>
                        <a:pt x="1529" y="101"/>
                      </a:lnTo>
                      <a:lnTo>
                        <a:pt x="1529" y="101"/>
                      </a:lnTo>
                      <a:lnTo>
                        <a:pt x="1530" y="101"/>
                      </a:lnTo>
                      <a:lnTo>
                        <a:pt x="1530" y="100"/>
                      </a:lnTo>
                      <a:lnTo>
                        <a:pt x="1530" y="102"/>
                      </a:lnTo>
                      <a:lnTo>
                        <a:pt x="1530" y="101"/>
                      </a:lnTo>
                      <a:lnTo>
                        <a:pt x="1531" y="101"/>
                      </a:lnTo>
                      <a:lnTo>
                        <a:pt x="1531" y="98"/>
                      </a:lnTo>
                      <a:lnTo>
                        <a:pt x="1531" y="105"/>
                      </a:lnTo>
                      <a:lnTo>
                        <a:pt x="1531" y="98"/>
                      </a:lnTo>
                      <a:lnTo>
                        <a:pt x="1532" y="98"/>
                      </a:lnTo>
                      <a:lnTo>
                        <a:pt x="1532" y="98"/>
                      </a:lnTo>
                      <a:lnTo>
                        <a:pt x="1532" y="103"/>
                      </a:lnTo>
                      <a:lnTo>
                        <a:pt x="1532" y="100"/>
                      </a:lnTo>
                      <a:lnTo>
                        <a:pt x="1533" y="100"/>
                      </a:lnTo>
                      <a:lnTo>
                        <a:pt x="1533" y="100"/>
                      </a:lnTo>
                      <a:lnTo>
                        <a:pt x="1533" y="104"/>
                      </a:lnTo>
                      <a:lnTo>
                        <a:pt x="1533" y="103"/>
                      </a:lnTo>
                      <a:lnTo>
                        <a:pt x="1534" y="103"/>
                      </a:lnTo>
                      <a:lnTo>
                        <a:pt x="1534" y="100"/>
                      </a:lnTo>
                      <a:lnTo>
                        <a:pt x="1534" y="103"/>
                      </a:lnTo>
                      <a:lnTo>
                        <a:pt x="1534" y="103"/>
                      </a:lnTo>
                      <a:lnTo>
                        <a:pt x="1535" y="103"/>
                      </a:lnTo>
                      <a:lnTo>
                        <a:pt x="1535" y="100"/>
                      </a:lnTo>
                      <a:lnTo>
                        <a:pt x="1535" y="104"/>
                      </a:lnTo>
                      <a:lnTo>
                        <a:pt x="1535" y="101"/>
                      </a:lnTo>
                      <a:lnTo>
                        <a:pt x="1536" y="101"/>
                      </a:lnTo>
                      <a:lnTo>
                        <a:pt x="1536" y="98"/>
                      </a:lnTo>
                      <a:lnTo>
                        <a:pt x="1536" y="104"/>
                      </a:lnTo>
                      <a:lnTo>
                        <a:pt x="1536" y="100"/>
                      </a:lnTo>
                      <a:lnTo>
                        <a:pt x="1537" y="100"/>
                      </a:lnTo>
                      <a:lnTo>
                        <a:pt x="1537" y="98"/>
                      </a:lnTo>
                      <a:lnTo>
                        <a:pt x="1537" y="103"/>
                      </a:lnTo>
                      <a:lnTo>
                        <a:pt x="1537" y="101"/>
                      </a:lnTo>
                      <a:lnTo>
                        <a:pt x="1538" y="101"/>
                      </a:lnTo>
                      <a:lnTo>
                        <a:pt x="1538" y="100"/>
                      </a:lnTo>
                      <a:lnTo>
                        <a:pt x="1538" y="104"/>
                      </a:lnTo>
                      <a:lnTo>
                        <a:pt x="1538" y="103"/>
                      </a:lnTo>
                      <a:lnTo>
                        <a:pt x="1539" y="103"/>
                      </a:lnTo>
                      <a:lnTo>
                        <a:pt x="1539" y="98"/>
                      </a:lnTo>
                      <a:lnTo>
                        <a:pt x="1539" y="103"/>
                      </a:lnTo>
                      <a:lnTo>
                        <a:pt x="1539" y="102"/>
                      </a:lnTo>
                      <a:lnTo>
                        <a:pt x="1540" y="102"/>
                      </a:lnTo>
                      <a:lnTo>
                        <a:pt x="1540" y="100"/>
                      </a:lnTo>
                      <a:lnTo>
                        <a:pt x="1540" y="104"/>
                      </a:lnTo>
                      <a:lnTo>
                        <a:pt x="1540" y="103"/>
                      </a:lnTo>
                      <a:lnTo>
                        <a:pt x="1541" y="103"/>
                      </a:lnTo>
                      <a:lnTo>
                        <a:pt x="1541" y="101"/>
                      </a:lnTo>
                      <a:lnTo>
                        <a:pt x="1541" y="104"/>
                      </a:lnTo>
                      <a:lnTo>
                        <a:pt x="1541" y="103"/>
                      </a:lnTo>
                      <a:lnTo>
                        <a:pt x="1542" y="103"/>
                      </a:lnTo>
                      <a:lnTo>
                        <a:pt x="1542" y="100"/>
                      </a:lnTo>
                      <a:lnTo>
                        <a:pt x="1542" y="104"/>
                      </a:lnTo>
                      <a:lnTo>
                        <a:pt x="1542" y="101"/>
                      </a:lnTo>
                      <a:lnTo>
                        <a:pt x="1543" y="101"/>
                      </a:lnTo>
                      <a:lnTo>
                        <a:pt x="1543" y="100"/>
                      </a:lnTo>
                      <a:lnTo>
                        <a:pt x="1543" y="104"/>
                      </a:lnTo>
                      <a:lnTo>
                        <a:pt x="1543" y="102"/>
                      </a:lnTo>
                      <a:lnTo>
                        <a:pt x="1544" y="102"/>
                      </a:lnTo>
                      <a:lnTo>
                        <a:pt x="1544" y="102"/>
                      </a:lnTo>
                      <a:lnTo>
                        <a:pt x="1544" y="104"/>
                      </a:lnTo>
                      <a:lnTo>
                        <a:pt x="1544" y="103"/>
                      </a:lnTo>
                      <a:lnTo>
                        <a:pt x="1545" y="103"/>
                      </a:lnTo>
                      <a:lnTo>
                        <a:pt x="1545" y="102"/>
                      </a:lnTo>
                      <a:lnTo>
                        <a:pt x="1545" y="104"/>
                      </a:lnTo>
                      <a:lnTo>
                        <a:pt x="1545" y="103"/>
                      </a:lnTo>
                      <a:lnTo>
                        <a:pt x="1546" y="103"/>
                      </a:lnTo>
                      <a:lnTo>
                        <a:pt x="1546" y="100"/>
                      </a:lnTo>
                      <a:lnTo>
                        <a:pt x="1546" y="106"/>
                      </a:lnTo>
                      <a:lnTo>
                        <a:pt x="1546" y="103"/>
                      </a:lnTo>
                      <a:lnTo>
                        <a:pt x="1547" y="103"/>
                      </a:lnTo>
                      <a:lnTo>
                        <a:pt x="1547" y="101"/>
                      </a:lnTo>
                      <a:lnTo>
                        <a:pt x="1547" y="104"/>
                      </a:lnTo>
                      <a:lnTo>
                        <a:pt x="1547" y="102"/>
                      </a:lnTo>
                      <a:lnTo>
                        <a:pt x="1548" y="102"/>
                      </a:lnTo>
                      <a:lnTo>
                        <a:pt x="1548" y="101"/>
                      </a:lnTo>
                      <a:lnTo>
                        <a:pt x="1548" y="105"/>
                      </a:lnTo>
                      <a:lnTo>
                        <a:pt x="1548" y="101"/>
                      </a:lnTo>
                      <a:lnTo>
                        <a:pt x="1549" y="101"/>
                      </a:lnTo>
                      <a:lnTo>
                        <a:pt x="1549" y="101"/>
                      </a:lnTo>
                      <a:lnTo>
                        <a:pt x="1549" y="104"/>
                      </a:lnTo>
                      <a:lnTo>
                        <a:pt x="1549" y="103"/>
                      </a:lnTo>
                      <a:lnTo>
                        <a:pt x="1550" y="103"/>
                      </a:lnTo>
                      <a:lnTo>
                        <a:pt x="1550" y="100"/>
                      </a:lnTo>
                      <a:lnTo>
                        <a:pt x="1550" y="104"/>
                      </a:lnTo>
                      <a:lnTo>
                        <a:pt x="1550" y="102"/>
                      </a:lnTo>
                      <a:lnTo>
                        <a:pt x="1551" y="102"/>
                      </a:lnTo>
                      <a:lnTo>
                        <a:pt x="1551" y="101"/>
                      </a:lnTo>
                      <a:lnTo>
                        <a:pt x="1551" y="105"/>
                      </a:lnTo>
                      <a:lnTo>
                        <a:pt x="1551" y="103"/>
                      </a:lnTo>
                      <a:lnTo>
                        <a:pt x="1552" y="103"/>
                      </a:lnTo>
                      <a:lnTo>
                        <a:pt x="1552" y="101"/>
                      </a:lnTo>
                      <a:lnTo>
                        <a:pt x="1552" y="104"/>
                      </a:lnTo>
                      <a:lnTo>
                        <a:pt x="1552" y="101"/>
                      </a:lnTo>
                      <a:lnTo>
                        <a:pt x="1553" y="101"/>
                      </a:lnTo>
                      <a:lnTo>
                        <a:pt x="1553" y="101"/>
                      </a:lnTo>
                      <a:lnTo>
                        <a:pt x="1553" y="104"/>
                      </a:lnTo>
                      <a:lnTo>
                        <a:pt x="1553" y="102"/>
                      </a:lnTo>
                      <a:lnTo>
                        <a:pt x="1554" y="102"/>
                      </a:lnTo>
                      <a:lnTo>
                        <a:pt x="1554" y="101"/>
                      </a:lnTo>
                      <a:lnTo>
                        <a:pt x="1554" y="104"/>
                      </a:lnTo>
                      <a:lnTo>
                        <a:pt x="1554" y="104"/>
                      </a:lnTo>
                      <a:lnTo>
                        <a:pt x="1555" y="104"/>
                      </a:lnTo>
                      <a:lnTo>
                        <a:pt x="1555" y="101"/>
                      </a:lnTo>
                      <a:lnTo>
                        <a:pt x="1555" y="104"/>
                      </a:lnTo>
                      <a:lnTo>
                        <a:pt x="1555" y="102"/>
                      </a:lnTo>
                      <a:lnTo>
                        <a:pt x="1556" y="102"/>
                      </a:lnTo>
                      <a:lnTo>
                        <a:pt x="1556" y="101"/>
                      </a:lnTo>
                      <a:lnTo>
                        <a:pt x="1556" y="105"/>
                      </a:lnTo>
                      <a:lnTo>
                        <a:pt x="1556" y="103"/>
                      </a:lnTo>
                      <a:lnTo>
                        <a:pt x="1557" y="103"/>
                      </a:lnTo>
                      <a:lnTo>
                        <a:pt x="1557" y="101"/>
                      </a:lnTo>
                      <a:lnTo>
                        <a:pt x="1557" y="105"/>
                      </a:lnTo>
                      <a:lnTo>
                        <a:pt x="1557" y="103"/>
                      </a:lnTo>
                      <a:lnTo>
                        <a:pt x="1558" y="103"/>
                      </a:lnTo>
                      <a:lnTo>
                        <a:pt x="1558" y="103"/>
                      </a:lnTo>
                      <a:lnTo>
                        <a:pt x="1558" y="105"/>
                      </a:lnTo>
                      <a:lnTo>
                        <a:pt x="1558" y="105"/>
                      </a:lnTo>
                      <a:lnTo>
                        <a:pt x="1559" y="105"/>
                      </a:lnTo>
                      <a:lnTo>
                        <a:pt x="1559" y="103"/>
                      </a:lnTo>
                      <a:lnTo>
                        <a:pt x="1559" y="105"/>
                      </a:lnTo>
                      <a:lnTo>
                        <a:pt x="1559" y="105"/>
                      </a:lnTo>
                      <a:lnTo>
                        <a:pt x="1560" y="105"/>
                      </a:lnTo>
                      <a:lnTo>
                        <a:pt x="1560" y="103"/>
                      </a:lnTo>
                      <a:lnTo>
                        <a:pt x="1560" y="107"/>
                      </a:lnTo>
                      <a:lnTo>
                        <a:pt x="1560" y="104"/>
                      </a:lnTo>
                      <a:lnTo>
                        <a:pt x="1561" y="104"/>
                      </a:lnTo>
                      <a:lnTo>
                        <a:pt x="1561" y="102"/>
                      </a:lnTo>
                      <a:lnTo>
                        <a:pt x="1561" y="106"/>
                      </a:lnTo>
                      <a:lnTo>
                        <a:pt x="1561" y="103"/>
                      </a:lnTo>
                      <a:lnTo>
                        <a:pt x="1562" y="103"/>
                      </a:lnTo>
                      <a:lnTo>
                        <a:pt x="1562" y="101"/>
                      </a:lnTo>
                      <a:lnTo>
                        <a:pt x="1562" y="105"/>
                      </a:lnTo>
                      <a:lnTo>
                        <a:pt x="1562" y="105"/>
                      </a:lnTo>
                      <a:lnTo>
                        <a:pt x="1563" y="105"/>
                      </a:lnTo>
                      <a:lnTo>
                        <a:pt x="1563" y="104"/>
                      </a:lnTo>
                      <a:lnTo>
                        <a:pt x="1563" y="108"/>
                      </a:lnTo>
                      <a:lnTo>
                        <a:pt x="1563" y="104"/>
                      </a:lnTo>
                      <a:lnTo>
                        <a:pt x="1564" y="104"/>
                      </a:lnTo>
                      <a:lnTo>
                        <a:pt x="1564" y="104"/>
                      </a:lnTo>
                      <a:lnTo>
                        <a:pt x="1564" y="106"/>
                      </a:lnTo>
                      <a:lnTo>
                        <a:pt x="1564" y="104"/>
                      </a:lnTo>
                      <a:lnTo>
                        <a:pt x="1565" y="104"/>
                      </a:lnTo>
                      <a:lnTo>
                        <a:pt x="1565" y="103"/>
                      </a:lnTo>
                      <a:lnTo>
                        <a:pt x="1565" y="107"/>
                      </a:lnTo>
                      <a:lnTo>
                        <a:pt x="1565" y="105"/>
                      </a:lnTo>
                      <a:lnTo>
                        <a:pt x="1566" y="105"/>
                      </a:lnTo>
                      <a:lnTo>
                        <a:pt x="1566" y="103"/>
                      </a:lnTo>
                      <a:lnTo>
                        <a:pt x="1566" y="105"/>
                      </a:lnTo>
                      <a:lnTo>
                        <a:pt x="1566" y="104"/>
                      </a:lnTo>
                      <a:lnTo>
                        <a:pt x="1567" y="104"/>
                      </a:lnTo>
                      <a:lnTo>
                        <a:pt x="1567" y="103"/>
                      </a:lnTo>
                      <a:lnTo>
                        <a:pt x="1567" y="105"/>
                      </a:lnTo>
                      <a:lnTo>
                        <a:pt x="1567" y="105"/>
                      </a:lnTo>
                      <a:lnTo>
                        <a:pt x="1568" y="105"/>
                      </a:lnTo>
                      <a:lnTo>
                        <a:pt x="1568" y="104"/>
                      </a:lnTo>
                      <a:lnTo>
                        <a:pt x="1568" y="106"/>
                      </a:lnTo>
                      <a:lnTo>
                        <a:pt x="1568" y="105"/>
                      </a:lnTo>
                      <a:lnTo>
                        <a:pt x="1569" y="105"/>
                      </a:lnTo>
                      <a:lnTo>
                        <a:pt x="1569" y="103"/>
                      </a:lnTo>
                      <a:lnTo>
                        <a:pt x="1569" y="106"/>
                      </a:lnTo>
                      <a:lnTo>
                        <a:pt x="1569" y="104"/>
                      </a:lnTo>
                      <a:lnTo>
                        <a:pt x="1570" y="104"/>
                      </a:lnTo>
                      <a:lnTo>
                        <a:pt x="1570" y="103"/>
                      </a:lnTo>
                      <a:lnTo>
                        <a:pt x="1570" y="105"/>
                      </a:lnTo>
                      <a:lnTo>
                        <a:pt x="1570" y="105"/>
                      </a:lnTo>
                      <a:lnTo>
                        <a:pt x="1571" y="105"/>
                      </a:lnTo>
                      <a:lnTo>
                        <a:pt x="1571" y="103"/>
                      </a:lnTo>
                      <a:lnTo>
                        <a:pt x="1571" y="106"/>
                      </a:lnTo>
                      <a:lnTo>
                        <a:pt x="1571" y="104"/>
                      </a:lnTo>
                      <a:lnTo>
                        <a:pt x="1572" y="104"/>
                      </a:lnTo>
                      <a:lnTo>
                        <a:pt x="1572" y="101"/>
                      </a:lnTo>
                      <a:lnTo>
                        <a:pt x="1572" y="105"/>
                      </a:lnTo>
                      <a:lnTo>
                        <a:pt x="1572" y="103"/>
                      </a:lnTo>
                      <a:lnTo>
                        <a:pt x="1573" y="103"/>
                      </a:lnTo>
                      <a:lnTo>
                        <a:pt x="1573" y="101"/>
                      </a:lnTo>
                      <a:lnTo>
                        <a:pt x="1573" y="105"/>
                      </a:lnTo>
                      <a:lnTo>
                        <a:pt x="1573" y="104"/>
                      </a:lnTo>
                      <a:lnTo>
                        <a:pt x="1574" y="104"/>
                      </a:lnTo>
                      <a:lnTo>
                        <a:pt x="1574" y="102"/>
                      </a:lnTo>
                      <a:lnTo>
                        <a:pt x="1574" y="106"/>
                      </a:lnTo>
                      <a:lnTo>
                        <a:pt x="1574" y="104"/>
                      </a:lnTo>
                      <a:lnTo>
                        <a:pt x="1575" y="104"/>
                      </a:lnTo>
                      <a:lnTo>
                        <a:pt x="1575" y="103"/>
                      </a:lnTo>
                      <a:lnTo>
                        <a:pt x="1575" y="104"/>
                      </a:lnTo>
                      <a:lnTo>
                        <a:pt x="1575" y="104"/>
                      </a:lnTo>
                      <a:lnTo>
                        <a:pt x="1576" y="104"/>
                      </a:lnTo>
                      <a:lnTo>
                        <a:pt x="1576" y="101"/>
                      </a:lnTo>
                      <a:lnTo>
                        <a:pt x="1576" y="105"/>
                      </a:lnTo>
                      <a:lnTo>
                        <a:pt x="1576" y="104"/>
                      </a:lnTo>
                      <a:lnTo>
                        <a:pt x="1577" y="104"/>
                      </a:lnTo>
                      <a:lnTo>
                        <a:pt x="1577" y="102"/>
                      </a:lnTo>
                      <a:lnTo>
                        <a:pt x="1577" y="105"/>
                      </a:lnTo>
                      <a:lnTo>
                        <a:pt x="1577" y="103"/>
                      </a:lnTo>
                      <a:lnTo>
                        <a:pt x="1578" y="103"/>
                      </a:lnTo>
                      <a:lnTo>
                        <a:pt x="1578" y="103"/>
                      </a:lnTo>
                      <a:lnTo>
                        <a:pt x="1578" y="106"/>
                      </a:lnTo>
                      <a:lnTo>
                        <a:pt x="1578" y="104"/>
                      </a:lnTo>
                      <a:lnTo>
                        <a:pt x="1579" y="104"/>
                      </a:lnTo>
                      <a:lnTo>
                        <a:pt x="1579" y="102"/>
                      </a:lnTo>
                      <a:lnTo>
                        <a:pt x="1579" y="107"/>
                      </a:lnTo>
                      <a:lnTo>
                        <a:pt x="1579" y="104"/>
                      </a:lnTo>
                      <a:lnTo>
                        <a:pt x="1580" y="104"/>
                      </a:lnTo>
                      <a:lnTo>
                        <a:pt x="1580" y="102"/>
                      </a:lnTo>
                      <a:lnTo>
                        <a:pt x="1580" y="105"/>
                      </a:lnTo>
                      <a:lnTo>
                        <a:pt x="1580" y="105"/>
                      </a:lnTo>
                      <a:lnTo>
                        <a:pt x="1581" y="105"/>
                      </a:lnTo>
                      <a:lnTo>
                        <a:pt x="1581" y="102"/>
                      </a:lnTo>
                      <a:lnTo>
                        <a:pt x="1581" y="107"/>
                      </a:lnTo>
                      <a:lnTo>
                        <a:pt x="1581" y="104"/>
                      </a:lnTo>
                      <a:lnTo>
                        <a:pt x="1582" y="104"/>
                      </a:lnTo>
                      <a:lnTo>
                        <a:pt x="1582" y="102"/>
                      </a:lnTo>
                      <a:lnTo>
                        <a:pt x="1582" y="106"/>
                      </a:lnTo>
                      <a:lnTo>
                        <a:pt x="1582" y="104"/>
                      </a:lnTo>
                      <a:lnTo>
                        <a:pt x="1583" y="104"/>
                      </a:lnTo>
                      <a:lnTo>
                        <a:pt x="1583" y="103"/>
                      </a:lnTo>
                      <a:lnTo>
                        <a:pt x="1583" y="105"/>
                      </a:lnTo>
                      <a:lnTo>
                        <a:pt x="1583" y="104"/>
                      </a:lnTo>
                      <a:lnTo>
                        <a:pt x="1584" y="104"/>
                      </a:lnTo>
                      <a:lnTo>
                        <a:pt x="1584" y="102"/>
                      </a:lnTo>
                      <a:lnTo>
                        <a:pt x="1584" y="105"/>
                      </a:lnTo>
                      <a:lnTo>
                        <a:pt x="1584" y="103"/>
                      </a:lnTo>
                      <a:lnTo>
                        <a:pt x="1585" y="103"/>
                      </a:lnTo>
                      <a:lnTo>
                        <a:pt x="1585" y="103"/>
                      </a:lnTo>
                      <a:lnTo>
                        <a:pt x="1585" y="105"/>
                      </a:lnTo>
                      <a:lnTo>
                        <a:pt x="1585" y="104"/>
                      </a:lnTo>
                      <a:lnTo>
                        <a:pt x="1586" y="104"/>
                      </a:lnTo>
                      <a:lnTo>
                        <a:pt x="1586" y="103"/>
                      </a:lnTo>
                      <a:lnTo>
                        <a:pt x="1586" y="105"/>
                      </a:lnTo>
                      <a:lnTo>
                        <a:pt x="1586" y="103"/>
                      </a:lnTo>
                      <a:lnTo>
                        <a:pt x="1587" y="103"/>
                      </a:lnTo>
                      <a:lnTo>
                        <a:pt x="1587" y="101"/>
                      </a:lnTo>
                      <a:lnTo>
                        <a:pt x="1587" y="104"/>
                      </a:lnTo>
                      <a:lnTo>
                        <a:pt x="1587" y="103"/>
                      </a:lnTo>
                      <a:lnTo>
                        <a:pt x="1588" y="103"/>
                      </a:lnTo>
                      <a:lnTo>
                        <a:pt x="1588" y="102"/>
                      </a:lnTo>
                      <a:lnTo>
                        <a:pt x="1588" y="106"/>
                      </a:lnTo>
                      <a:lnTo>
                        <a:pt x="1588" y="104"/>
                      </a:lnTo>
                      <a:lnTo>
                        <a:pt x="1589" y="104"/>
                      </a:lnTo>
                      <a:lnTo>
                        <a:pt x="1589" y="100"/>
                      </a:lnTo>
                      <a:lnTo>
                        <a:pt x="1589" y="104"/>
                      </a:lnTo>
                      <a:lnTo>
                        <a:pt x="1589" y="104"/>
                      </a:lnTo>
                      <a:lnTo>
                        <a:pt x="1590" y="104"/>
                      </a:lnTo>
                      <a:lnTo>
                        <a:pt x="1590" y="101"/>
                      </a:lnTo>
                      <a:lnTo>
                        <a:pt x="1590" y="104"/>
                      </a:lnTo>
                      <a:lnTo>
                        <a:pt x="1590" y="103"/>
                      </a:lnTo>
                      <a:lnTo>
                        <a:pt x="1591" y="103"/>
                      </a:lnTo>
                      <a:lnTo>
                        <a:pt x="1591" y="102"/>
                      </a:lnTo>
                      <a:lnTo>
                        <a:pt x="1591" y="106"/>
                      </a:lnTo>
                      <a:lnTo>
                        <a:pt x="1591" y="103"/>
                      </a:lnTo>
                      <a:lnTo>
                        <a:pt x="1592" y="103"/>
                      </a:lnTo>
                      <a:lnTo>
                        <a:pt x="1592" y="101"/>
                      </a:lnTo>
                      <a:lnTo>
                        <a:pt x="1592" y="105"/>
                      </a:lnTo>
                      <a:lnTo>
                        <a:pt x="1592" y="104"/>
                      </a:lnTo>
                      <a:lnTo>
                        <a:pt x="1593" y="104"/>
                      </a:lnTo>
                      <a:lnTo>
                        <a:pt x="1593" y="103"/>
                      </a:lnTo>
                      <a:lnTo>
                        <a:pt x="1593" y="106"/>
                      </a:lnTo>
                      <a:lnTo>
                        <a:pt x="1593" y="104"/>
                      </a:lnTo>
                      <a:lnTo>
                        <a:pt x="1594" y="104"/>
                      </a:lnTo>
                      <a:lnTo>
                        <a:pt x="1594" y="103"/>
                      </a:lnTo>
                      <a:lnTo>
                        <a:pt x="1594" y="105"/>
                      </a:lnTo>
                      <a:lnTo>
                        <a:pt x="1594" y="103"/>
                      </a:lnTo>
                      <a:lnTo>
                        <a:pt x="1595" y="103"/>
                      </a:lnTo>
                      <a:lnTo>
                        <a:pt x="1595" y="102"/>
                      </a:lnTo>
                      <a:lnTo>
                        <a:pt x="1595" y="104"/>
                      </a:lnTo>
                      <a:lnTo>
                        <a:pt x="1595" y="102"/>
                      </a:lnTo>
                      <a:lnTo>
                        <a:pt x="1596" y="102"/>
                      </a:lnTo>
                      <a:lnTo>
                        <a:pt x="1596" y="102"/>
                      </a:lnTo>
                      <a:lnTo>
                        <a:pt x="1596" y="105"/>
                      </a:lnTo>
                      <a:lnTo>
                        <a:pt x="1596" y="104"/>
                      </a:lnTo>
                      <a:lnTo>
                        <a:pt x="1597" y="104"/>
                      </a:lnTo>
                      <a:lnTo>
                        <a:pt x="1597" y="102"/>
                      </a:lnTo>
                      <a:lnTo>
                        <a:pt x="1597" y="105"/>
                      </a:lnTo>
                      <a:lnTo>
                        <a:pt x="1597" y="104"/>
                      </a:lnTo>
                      <a:lnTo>
                        <a:pt x="1598" y="104"/>
                      </a:lnTo>
                      <a:lnTo>
                        <a:pt x="1598" y="101"/>
                      </a:lnTo>
                      <a:lnTo>
                        <a:pt x="1598" y="105"/>
                      </a:lnTo>
                      <a:lnTo>
                        <a:pt x="1598" y="104"/>
                      </a:lnTo>
                      <a:lnTo>
                        <a:pt x="1599" y="104"/>
                      </a:lnTo>
                      <a:lnTo>
                        <a:pt x="1599" y="103"/>
                      </a:lnTo>
                      <a:lnTo>
                        <a:pt x="1599" y="106"/>
                      </a:lnTo>
                      <a:lnTo>
                        <a:pt x="1599" y="103"/>
                      </a:lnTo>
                      <a:lnTo>
                        <a:pt x="1600" y="103"/>
                      </a:lnTo>
                      <a:lnTo>
                        <a:pt x="1600" y="102"/>
                      </a:lnTo>
                      <a:lnTo>
                        <a:pt x="1600" y="104"/>
                      </a:lnTo>
                      <a:lnTo>
                        <a:pt x="1600" y="104"/>
                      </a:lnTo>
                      <a:lnTo>
                        <a:pt x="1601" y="104"/>
                      </a:lnTo>
                      <a:lnTo>
                        <a:pt x="1601" y="103"/>
                      </a:lnTo>
                      <a:lnTo>
                        <a:pt x="1601" y="105"/>
                      </a:lnTo>
                      <a:lnTo>
                        <a:pt x="1601" y="104"/>
                      </a:lnTo>
                      <a:lnTo>
                        <a:pt x="1602" y="104"/>
                      </a:lnTo>
                      <a:lnTo>
                        <a:pt x="1602" y="101"/>
                      </a:lnTo>
                      <a:lnTo>
                        <a:pt x="1602" y="105"/>
                      </a:lnTo>
                      <a:lnTo>
                        <a:pt x="1602" y="102"/>
                      </a:lnTo>
                      <a:lnTo>
                        <a:pt x="1603" y="102"/>
                      </a:lnTo>
                      <a:lnTo>
                        <a:pt x="1603" y="103"/>
                      </a:lnTo>
                      <a:lnTo>
                        <a:pt x="1603" y="107"/>
                      </a:lnTo>
                      <a:lnTo>
                        <a:pt x="1603" y="103"/>
                      </a:lnTo>
                      <a:lnTo>
                        <a:pt x="1604" y="103"/>
                      </a:lnTo>
                      <a:lnTo>
                        <a:pt x="1604" y="103"/>
                      </a:lnTo>
                      <a:lnTo>
                        <a:pt x="1604" y="106"/>
                      </a:lnTo>
                      <a:lnTo>
                        <a:pt x="1604" y="104"/>
                      </a:lnTo>
                      <a:lnTo>
                        <a:pt x="1605" y="104"/>
                      </a:lnTo>
                      <a:lnTo>
                        <a:pt x="1605" y="103"/>
                      </a:lnTo>
                      <a:lnTo>
                        <a:pt x="1605" y="105"/>
                      </a:lnTo>
                      <a:lnTo>
                        <a:pt x="1605" y="105"/>
                      </a:lnTo>
                      <a:lnTo>
                        <a:pt x="1606" y="105"/>
                      </a:lnTo>
                      <a:lnTo>
                        <a:pt x="1606" y="101"/>
                      </a:lnTo>
                      <a:lnTo>
                        <a:pt x="1606" y="104"/>
                      </a:lnTo>
                      <a:lnTo>
                        <a:pt x="1606" y="104"/>
                      </a:lnTo>
                      <a:lnTo>
                        <a:pt x="1607" y="104"/>
                      </a:lnTo>
                      <a:lnTo>
                        <a:pt x="1607" y="101"/>
                      </a:lnTo>
                      <a:lnTo>
                        <a:pt x="1607" y="106"/>
                      </a:lnTo>
                      <a:lnTo>
                        <a:pt x="1607" y="103"/>
                      </a:lnTo>
                      <a:lnTo>
                        <a:pt x="1608" y="103"/>
                      </a:lnTo>
                      <a:lnTo>
                        <a:pt x="1608" y="103"/>
                      </a:lnTo>
                      <a:lnTo>
                        <a:pt x="1608" y="105"/>
                      </a:lnTo>
                      <a:lnTo>
                        <a:pt x="1608" y="105"/>
                      </a:lnTo>
                      <a:lnTo>
                        <a:pt x="1609" y="105"/>
                      </a:lnTo>
                      <a:lnTo>
                        <a:pt x="1609" y="101"/>
                      </a:lnTo>
                      <a:lnTo>
                        <a:pt x="1609" y="106"/>
                      </a:lnTo>
                      <a:lnTo>
                        <a:pt x="1609" y="104"/>
                      </a:lnTo>
                      <a:lnTo>
                        <a:pt x="1610" y="104"/>
                      </a:lnTo>
                      <a:lnTo>
                        <a:pt x="1610" y="101"/>
                      </a:lnTo>
                      <a:lnTo>
                        <a:pt x="1610" y="105"/>
                      </a:lnTo>
                      <a:lnTo>
                        <a:pt x="1610" y="104"/>
                      </a:lnTo>
                      <a:lnTo>
                        <a:pt x="1611" y="104"/>
                      </a:lnTo>
                      <a:lnTo>
                        <a:pt x="1611" y="102"/>
                      </a:lnTo>
                      <a:lnTo>
                        <a:pt x="1611" y="105"/>
                      </a:lnTo>
                      <a:lnTo>
                        <a:pt x="1611" y="103"/>
                      </a:lnTo>
                      <a:lnTo>
                        <a:pt x="1612" y="103"/>
                      </a:lnTo>
                      <a:lnTo>
                        <a:pt x="1612" y="103"/>
                      </a:lnTo>
                      <a:lnTo>
                        <a:pt x="1612" y="105"/>
                      </a:lnTo>
                      <a:lnTo>
                        <a:pt x="1612" y="103"/>
                      </a:lnTo>
                      <a:lnTo>
                        <a:pt x="1613" y="103"/>
                      </a:lnTo>
                      <a:lnTo>
                        <a:pt x="1613" y="103"/>
                      </a:lnTo>
                      <a:lnTo>
                        <a:pt x="1613" y="105"/>
                      </a:lnTo>
                      <a:lnTo>
                        <a:pt x="1613" y="105"/>
                      </a:lnTo>
                      <a:lnTo>
                        <a:pt x="1614" y="105"/>
                      </a:lnTo>
                      <a:lnTo>
                        <a:pt x="1614" y="102"/>
                      </a:lnTo>
                      <a:lnTo>
                        <a:pt x="1614" y="105"/>
                      </a:lnTo>
                      <a:lnTo>
                        <a:pt x="1614" y="102"/>
                      </a:lnTo>
                      <a:lnTo>
                        <a:pt x="1615" y="102"/>
                      </a:lnTo>
                      <a:lnTo>
                        <a:pt x="1615" y="103"/>
                      </a:lnTo>
                      <a:lnTo>
                        <a:pt x="1615" y="107"/>
                      </a:lnTo>
                      <a:lnTo>
                        <a:pt x="1615" y="103"/>
                      </a:lnTo>
                      <a:lnTo>
                        <a:pt x="1616" y="103"/>
                      </a:lnTo>
                      <a:lnTo>
                        <a:pt x="1616" y="103"/>
                      </a:lnTo>
                      <a:lnTo>
                        <a:pt x="1616" y="105"/>
                      </a:lnTo>
                      <a:lnTo>
                        <a:pt x="1616" y="103"/>
                      </a:lnTo>
                      <a:lnTo>
                        <a:pt x="1617" y="103"/>
                      </a:lnTo>
                      <a:lnTo>
                        <a:pt x="1617" y="101"/>
                      </a:lnTo>
                      <a:lnTo>
                        <a:pt x="1617" y="106"/>
                      </a:lnTo>
                      <a:lnTo>
                        <a:pt x="1617" y="104"/>
                      </a:lnTo>
                      <a:lnTo>
                        <a:pt x="1618" y="104"/>
                      </a:lnTo>
                      <a:lnTo>
                        <a:pt x="1618" y="103"/>
                      </a:lnTo>
                      <a:lnTo>
                        <a:pt x="1618" y="108"/>
                      </a:lnTo>
                      <a:lnTo>
                        <a:pt x="1618" y="105"/>
                      </a:lnTo>
                      <a:lnTo>
                        <a:pt x="1619" y="105"/>
                      </a:lnTo>
                      <a:lnTo>
                        <a:pt x="1619" y="104"/>
                      </a:lnTo>
                      <a:lnTo>
                        <a:pt x="1619" y="106"/>
                      </a:lnTo>
                      <a:lnTo>
                        <a:pt x="1619" y="104"/>
                      </a:lnTo>
                      <a:lnTo>
                        <a:pt x="1620" y="104"/>
                      </a:lnTo>
                      <a:lnTo>
                        <a:pt x="1620" y="103"/>
                      </a:lnTo>
                      <a:lnTo>
                        <a:pt x="1620" y="105"/>
                      </a:lnTo>
                      <a:lnTo>
                        <a:pt x="1620" y="105"/>
                      </a:lnTo>
                      <a:lnTo>
                        <a:pt x="1621" y="105"/>
                      </a:lnTo>
                      <a:lnTo>
                        <a:pt x="1621" y="103"/>
                      </a:lnTo>
                      <a:lnTo>
                        <a:pt x="1621" y="106"/>
                      </a:lnTo>
                      <a:lnTo>
                        <a:pt x="1621" y="104"/>
                      </a:lnTo>
                      <a:lnTo>
                        <a:pt x="1622" y="104"/>
                      </a:lnTo>
                      <a:lnTo>
                        <a:pt x="1622" y="103"/>
                      </a:lnTo>
                      <a:lnTo>
                        <a:pt x="1622" y="106"/>
                      </a:lnTo>
                      <a:lnTo>
                        <a:pt x="1622" y="104"/>
                      </a:lnTo>
                      <a:lnTo>
                        <a:pt x="1623" y="104"/>
                      </a:lnTo>
                      <a:lnTo>
                        <a:pt x="1623" y="103"/>
                      </a:lnTo>
                      <a:lnTo>
                        <a:pt x="1623" y="106"/>
                      </a:lnTo>
                      <a:lnTo>
                        <a:pt x="1623" y="105"/>
                      </a:lnTo>
                      <a:lnTo>
                        <a:pt x="1624" y="105"/>
                      </a:lnTo>
                      <a:lnTo>
                        <a:pt x="1624" y="102"/>
                      </a:lnTo>
                      <a:lnTo>
                        <a:pt x="1624" y="107"/>
                      </a:lnTo>
                      <a:lnTo>
                        <a:pt x="1624" y="103"/>
                      </a:lnTo>
                      <a:lnTo>
                        <a:pt x="1625" y="103"/>
                      </a:lnTo>
                      <a:lnTo>
                        <a:pt x="1625" y="103"/>
                      </a:lnTo>
                      <a:lnTo>
                        <a:pt x="1625" y="107"/>
                      </a:lnTo>
                      <a:lnTo>
                        <a:pt x="1625" y="103"/>
                      </a:lnTo>
                      <a:lnTo>
                        <a:pt x="1626" y="103"/>
                      </a:lnTo>
                      <a:lnTo>
                        <a:pt x="1626" y="103"/>
                      </a:lnTo>
                      <a:lnTo>
                        <a:pt x="1626" y="105"/>
                      </a:lnTo>
                      <a:lnTo>
                        <a:pt x="1626" y="105"/>
                      </a:lnTo>
                      <a:lnTo>
                        <a:pt x="1627" y="105"/>
                      </a:lnTo>
                      <a:lnTo>
                        <a:pt x="1627" y="100"/>
                      </a:lnTo>
                      <a:lnTo>
                        <a:pt x="1627" y="106"/>
                      </a:lnTo>
                      <a:lnTo>
                        <a:pt x="1627" y="103"/>
                      </a:lnTo>
                      <a:lnTo>
                        <a:pt x="1628" y="103"/>
                      </a:lnTo>
                      <a:lnTo>
                        <a:pt x="1628" y="103"/>
                      </a:lnTo>
                      <a:lnTo>
                        <a:pt x="1628" y="105"/>
                      </a:lnTo>
                      <a:lnTo>
                        <a:pt x="1628" y="104"/>
                      </a:lnTo>
                      <a:lnTo>
                        <a:pt x="1629" y="104"/>
                      </a:lnTo>
                      <a:lnTo>
                        <a:pt x="1629" y="103"/>
                      </a:lnTo>
                      <a:lnTo>
                        <a:pt x="1629" y="107"/>
                      </a:lnTo>
                      <a:lnTo>
                        <a:pt x="1629" y="105"/>
                      </a:lnTo>
                      <a:lnTo>
                        <a:pt x="1630" y="105"/>
                      </a:lnTo>
                      <a:lnTo>
                        <a:pt x="1630" y="102"/>
                      </a:lnTo>
                      <a:lnTo>
                        <a:pt x="1630" y="105"/>
                      </a:lnTo>
                      <a:lnTo>
                        <a:pt x="1630" y="104"/>
                      </a:lnTo>
                      <a:lnTo>
                        <a:pt x="1631" y="104"/>
                      </a:lnTo>
                      <a:lnTo>
                        <a:pt x="1631" y="103"/>
                      </a:lnTo>
                      <a:lnTo>
                        <a:pt x="1631" y="105"/>
                      </a:lnTo>
                      <a:lnTo>
                        <a:pt x="1631" y="104"/>
                      </a:lnTo>
                      <a:lnTo>
                        <a:pt x="1632" y="104"/>
                      </a:lnTo>
                      <a:lnTo>
                        <a:pt x="1632" y="102"/>
                      </a:lnTo>
                      <a:lnTo>
                        <a:pt x="1632" y="106"/>
                      </a:lnTo>
                      <a:lnTo>
                        <a:pt x="1632" y="104"/>
                      </a:lnTo>
                      <a:lnTo>
                        <a:pt x="1633" y="104"/>
                      </a:lnTo>
                      <a:lnTo>
                        <a:pt x="1633" y="102"/>
                      </a:lnTo>
                      <a:lnTo>
                        <a:pt x="1633" y="108"/>
                      </a:lnTo>
                      <a:lnTo>
                        <a:pt x="1633" y="104"/>
                      </a:lnTo>
                      <a:lnTo>
                        <a:pt x="1634" y="104"/>
                      </a:lnTo>
                      <a:lnTo>
                        <a:pt x="1634" y="101"/>
                      </a:lnTo>
                      <a:lnTo>
                        <a:pt x="1634" y="107"/>
                      </a:lnTo>
                      <a:lnTo>
                        <a:pt x="1634" y="104"/>
                      </a:lnTo>
                      <a:lnTo>
                        <a:pt x="1635" y="104"/>
                      </a:lnTo>
                      <a:lnTo>
                        <a:pt x="1635" y="101"/>
                      </a:lnTo>
                      <a:lnTo>
                        <a:pt x="1635" y="104"/>
                      </a:lnTo>
                      <a:lnTo>
                        <a:pt x="1635" y="103"/>
                      </a:lnTo>
                      <a:lnTo>
                        <a:pt x="1636" y="103"/>
                      </a:lnTo>
                      <a:lnTo>
                        <a:pt x="1636" y="101"/>
                      </a:lnTo>
                      <a:lnTo>
                        <a:pt x="1636" y="106"/>
                      </a:lnTo>
                      <a:lnTo>
                        <a:pt x="1636" y="105"/>
                      </a:lnTo>
                      <a:lnTo>
                        <a:pt x="1637" y="105"/>
                      </a:lnTo>
                      <a:lnTo>
                        <a:pt x="1637" y="103"/>
                      </a:lnTo>
                      <a:lnTo>
                        <a:pt x="1637" y="106"/>
                      </a:lnTo>
                      <a:lnTo>
                        <a:pt x="1637" y="106"/>
                      </a:lnTo>
                      <a:lnTo>
                        <a:pt x="1638" y="106"/>
                      </a:lnTo>
                      <a:lnTo>
                        <a:pt x="1638" y="101"/>
                      </a:lnTo>
                      <a:lnTo>
                        <a:pt x="1638" y="107"/>
                      </a:lnTo>
                      <a:lnTo>
                        <a:pt x="1638" y="104"/>
                      </a:lnTo>
                      <a:lnTo>
                        <a:pt x="1639" y="104"/>
                      </a:lnTo>
                      <a:lnTo>
                        <a:pt x="1639" y="101"/>
                      </a:lnTo>
                      <a:lnTo>
                        <a:pt x="1639" y="105"/>
                      </a:lnTo>
                      <a:lnTo>
                        <a:pt x="1639" y="102"/>
                      </a:lnTo>
                      <a:lnTo>
                        <a:pt x="1640" y="102"/>
                      </a:lnTo>
                      <a:lnTo>
                        <a:pt x="1640" y="101"/>
                      </a:lnTo>
                      <a:lnTo>
                        <a:pt x="1640" y="105"/>
                      </a:lnTo>
                      <a:lnTo>
                        <a:pt x="1640" y="105"/>
                      </a:lnTo>
                      <a:lnTo>
                        <a:pt x="1641" y="105"/>
                      </a:lnTo>
                      <a:lnTo>
                        <a:pt x="1641" y="103"/>
                      </a:lnTo>
                      <a:lnTo>
                        <a:pt x="1641" y="105"/>
                      </a:lnTo>
                      <a:lnTo>
                        <a:pt x="1641" y="104"/>
                      </a:lnTo>
                      <a:lnTo>
                        <a:pt x="1642" y="104"/>
                      </a:lnTo>
                      <a:lnTo>
                        <a:pt x="1642" y="102"/>
                      </a:lnTo>
                      <a:lnTo>
                        <a:pt x="1642" y="107"/>
                      </a:lnTo>
                      <a:lnTo>
                        <a:pt x="1642" y="104"/>
                      </a:lnTo>
                      <a:lnTo>
                        <a:pt x="1643" y="104"/>
                      </a:lnTo>
                      <a:lnTo>
                        <a:pt x="1643" y="103"/>
                      </a:lnTo>
                      <a:lnTo>
                        <a:pt x="1643" y="106"/>
                      </a:lnTo>
                      <a:lnTo>
                        <a:pt x="1643" y="104"/>
                      </a:lnTo>
                      <a:lnTo>
                        <a:pt x="1644" y="104"/>
                      </a:lnTo>
                      <a:lnTo>
                        <a:pt x="1644" y="104"/>
                      </a:lnTo>
                      <a:lnTo>
                        <a:pt x="1644" y="107"/>
                      </a:lnTo>
                      <a:lnTo>
                        <a:pt x="1644" y="105"/>
                      </a:lnTo>
                      <a:lnTo>
                        <a:pt x="1645" y="105"/>
                      </a:lnTo>
                      <a:lnTo>
                        <a:pt x="1645" y="103"/>
                      </a:lnTo>
                      <a:lnTo>
                        <a:pt x="1645" y="105"/>
                      </a:lnTo>
                      <a:lnTo>
                        <a:pt x="1645" y="105"/>
                      </a:lnTo>
                      <a:lnTo>
                        <a:pt x="1646" y="105"/>
                      </a:lnTo>
                      <a:lnTo>
                        <a:pt x="1646" y="103"/>
                      </a:lnTo>
                      <a:lnTo>
                        <a:pt x="1646" y="106"/>
                      </a:lnTo>
                      <a:lnTo>
                        <a:pt x="1646" y="103"/>
                      </a:lnTo>
                      <a:lnTo>
                        <a:pt x="1647" y="103"/>
                      </a:lnTo>
                      <a:lnTo>
                        <a:pt x="1647" y="103"/>
                      </a:lnTo>
                      <a:lnTo>
                        <a:pt x="1647" y="107"/>
                      </a:lnTo>
                      <a:lnTo>
                        <a:pt x="1647" y="104"/>
                      </a:lnTo>
                      <a:lnTo>
                        <a:pt x="1648" y="104"/>
                      </a:lnTo>
                      <a:lnTo>
                        <a:pt x="1648" y="103"/>
                      </a:lnTo>
                      <a:lnTo>
                        <a:pt x="1648" y="107"/>
                      </a:lnTo>
                      <a:lnTo>
                        <a:pt x="1648" y="104"/>
                      </a:lnTo>
                      <a:lnTo>
                        <a:pt x="1649" y="104"/>
                      </a:lnTo>
                      <a:lnTo>
                        <a:pt x="1649" y="104"/>
                      </a:lnTo>
                      <a:lnTo>
                        <a:pt x="1649" y="107"/>
                      </a:lnTo>
                      <a:lnTo>
                        <a:pt x="1649" y="105"/>
                      </a:lnTo>
                      <a:lnTo>
                        <a:pt x="1650" y="105"/>
                      </a:lnTo>
                      <a:lnTo>
                        <a:pt x="1650" y="103"/>
                      </a:lnTo>
                      <a:lnTo>
                        <a:pt x="1650" y="106"/>
                      </a:lnTo>
                      <a:lnTo>
                        <a:pt x="1650" y="104"/>
                      </a:lnTo>
                      <a:lnTo>
                        <a:pt x="1651" y="104"/>
                      </a:lnTo>
                      <a:lnTo>
                        <a:pt x="1651" y="103"/>
                      </a:lnTo>
                      <a:lnTo>
                        <a:pt x="1651" y="106"/>
                      </a:lnTo>
                      <a:lnTo>
                        <a:pt x="1651" y="105"/>
                      </a:lnTo>
                      <a:lnTo>
                        <a:pt x="1652" y="105"/>
                      </a:lnTo>
                      <a:lnTo>
                        <a:pt x="1652" y="103"/>
                      </a:lnTo>
                      <a:lnTo>
                        <a:pt x="1652" y="105"/>
                      </a:lnTo>
                      <a:lnTo>
                        <a:pt x="1652" y="104"/>
                      </a:lnTo>
                      <a:lnTo>
                        <a:pt x="1653" y="104"/>
                      </a:lnTo>
                      <a:lnTo>
                        <a:pt x="1653" y="103"/>
                      </a:lnTo>
                      <a:lnTo>
                        <a:pt x="1653" y="105"/>
                      </a:lnTo>
                      <a:lnTo>
                        <a:pt x="1653" y="104"/>
                      </a:lnTo>
                      <a:lnTo>
                        <a:pt x="1654" y="104"/>
                      </a:lnTo>
                      <a:lnTo>
                        <a:pt x="1654" y="101"/>
                      </a:lnTo>
                      <a:lnTo>
                        <a:pt x="1654" y="106"/>
                      </a:lnTo>
                      <a:lnTo>
                        <a:pt x="1654" y="101"/>
                      </a:lnTo>
                      <a:lnTo>
                        <a:pt x="1655" y="101"/>
                      </a:lnTo>
                      <a:lnTo>
                        <a:pt x="1655" y="102"/>
                      </a:lnTo>
                      <a:lnTo>
                        <a:pt x="1655" y="106"/>
                      </a:lnTo>
                      <a:lnTo>
                        <a:pt x="1655" y="103"/>
                      </a:lnTo>
                      <a:lnTo>
                        <a:pt x="1656" y="103"/>
                      </a:lnTo>
                      <a:lnTo>
                        <a:pt x="1656" y="102"/>
                      </a:lnTo>
                      <a:lnTo>
                        <a:pt x="1656" y="106"/>
                      </a:lnTo>
                      <a:lnTo>
                        <a:pt x="1656" y="105"/>
                      </a:lnTo>
                      <a:lnTo>
                        <a:pt x="1657" y="105"/>
                      </a:lnTo>
                      <a:lnTo>
                        <a:pt x="1657" y="103"/>
                      </a:lnTo>
                      <a:lnTo>
                        <a:pt x="1657" y="105"/>
                      </a:lnTo>
                      <a:lnTo>
                        <a:pt x="1657" y="104"/>
                      </a:lnTo>
                      <a:lnTo>
                        <a:pt x="1658" y="104"/>
                      </a:lnTo>
                      <a:lnTo>
                        <a:pt x="1658" y="104"/>
                      </a:lnTo>
                      <a:lnTo>
                        <a:pt x="1658" y="107"/>
                      </a:lnTo>
                      <a:lnTo>
                        <a:pt x="1658" y="105"/>
                      </a:lnTo>
                      <a:lnTo>
                        <a:pt x="1659" y="105"/>
                      </a:lnTo>
                      <a:lnTo>
                        <a:pt x="1659" y="104"/>
                      </a:lnTo>
                      <a:lnTo>
                        <a:pt x="1659" y="108"/>
                      </a:lnTo>
                      <a:lnTo>
                        <a:pt x="1659" y="105"/>
                      </a:lnTo>
                      <a:lnTo>
                        <a:pt x="1660" y="105"/>
                      </a:lnTo>
                      <a:lnTo>
                        <a:pt x="1660" y="104"/>
                      </a:lnTo>
                      <a:lnTo>
                        <a:pt x="1660" y="106"/>
                      </a:lnTo>
                      <a:lnTo>
                        <a:pt x="1660" y="106"/>
                      </a:lnTo>
                      <a:lnTo>
                        <a:pt x="1661" y="106"/>
                      </a:lnTo>
                      <a:lnTo>
                        <a:pt x="1661" y="104"/>
                      </a:lnTo>
                      <a:lnTo>
                        <a:pt x="1661" y="107"/>
                      </a:lnTo>
                      <a:lnTo>
                        <a:pt x="1661" y="105"/>
                      </a:lnTo>
                      <a:lnTo>
                        <a:pt x="1662" y="105"/>
                      </a:lnTo>
                      <a:lnTo>
                        <a:pt x="1662" y="103"/>
                      </a:lnTo>
                      <a:lnTo>
                        <a:pt x="1662" y="108"/>
                      </a:lnTo>
                      <a:lnTo>
                        <a:pt x="1662" y="106"/>
                      </a:lnTo>
                      <a:lnTo>
                        <a:pt x="1663" y="106"/>
                      </a:lnTo>
                      <a:lnTo>
                        <a:pt x="1663" y="104"/>
                      </a:lnTo>
                      <a:lnTo>
                        <a:pt x="1663" y="108"/>
                      </a:lnTo>
                      <a:lnTo>
                        <a:pt x="1663" y="107"/>
                      </a:lnTo>
                      <a:lnTo>
                        <a:pt x="1664" y="107"/>
                      </a:lnTo>
                      <a:lnTo>
                        <a:pt x="1664" y="105"/>
                      </a:lnTo>
                      <a:lnTo>
                        <a:pt x="1664" y="108"/>
                      </a:lnTo>
                      <a:lnTo>
                        <a:pt x="1664" y="105"/>
                      </a:lnTo>
                      <a:lnTo>
                        <a:pt x="1665" y="105"/>
                      </a:lnTo>
                      <a:lnTo>
                        <a:pt x="1665" y="104"/>
                      </a:lnTo>
                      <a:lnTo>
                        <a:pt x="1665" y="107"/>
                      </a:lnTo>
                      <a:lnTo>
                        <a:pt x="1665" y="107"/>
                      </a:lnTo>
                      <a:lnTo>
                        <a:pt x="1666" y="107"/>
                      </a:lnTo>
                      <a:lnTo>
                        <a:pt x="1666" y="104"/>
                      </a:lnTo>
                      <a:lnTo>
                        <a:pt x="1666" y="108"/>
                      </a:lnTo>
                      <a:lnTo>
                        <a:pt x="1666" y="105"/>
                      </a:lnTo>
                      <a:lnTo>
                        <a:pt x="1667" y="105"/>
                      </a:lnTo>
                      <a:lnTo>
                        <a:pt x="1667" y="105"/>
                      </a:lnTo>
                      <a:lnTo>
                        <a:pt x="1667" y="108"/>
                      </a:lnTo>
                      <a:lnTo>
                        <a:pt x="1667" y="105"/>
                      </a:lnTo>
                      <a:lnTo>
                        <a:pt x="1668" y="105"/>
                      </a:lnTo>
                      <a:lnTo>
                        <a:pt x="1668" y="104"/>
                      </a:lnTo>
                      <a:lnTo>
                        <a:pt x="1668" y="108"/>
                      </a:lnTo>
                      <a:lnTo>
                        <a:pt x="1668" y="104"/>
                      </a:lnTo>
                      <a:lnTo>
                        <a:pt x="1669" y="104"/>
                      </a:lnTo>
                      <a:lnTo>
                        <a:pt x="1669" y="104"/>
                      </a:lnTo>
                      <a:lnTo>
                        <a:pt x="1669" y="108"/>
                      </a:lnTo>
                      <a:lnTo>
                        <a:pt x="1669" y="106"/>
                      </a:lnTo>
                      <a:lnTo>
                        <a:pt x="1670" y="106"/>
                      </a:lnTo>
                      <a:lnTo>
                        <a:pt x="1670" y="104"/>
                      </a:lnTo>
                      <a:lnTo>
                        <a:pt x="1670" y="108"/>
                      </a:lnTo>
                      <a:lnTo>
                        <a:pt x="1670" y="104"/>
                      </a:lnTo>
                      <a:lnTo>
                        <a:pt x="1671" y="104"/>
                      </a:lnTo>
                      <a:lnTo>
                        <a:pt x="1671" y="104"/>
                      </a:lnTo>
                      <a:lnTo>
                        <a:pt x="1671" y="108"/>
                      </a:lnTo>
                      <a:lnTo>
                        <a:pt x="1671" y="104"/>
                      </a:lnTo>
                      <a:lnTo>
                        <a:pt x="1672" y="104"/>
                      </a:lnTo>
                      <a:lnTo>
                        <a:pt x="1672" y="103"/>
                      </a:lnTo>
                      <a:lnTo>
                        <a:pt x="1672" y="106"/>
                      </a:lnTo>
                      <a:lnTo>
                        <a:pt x="1672" y="105"/>
                      </a:lnTo>
                      <a:lnTo>
                        <a:pt x="1673" y="105"/>
                      </a:lnTo>
                      <a:lnTo>
                        <a:pt x="1673" y="103"/>
                      </a:lnTo>
                      <a:lnTo>
                        <a:pt x="1673" y="108"/>
                      </a:lnTo>
                      <a:lnTo>
                        <a:pt x="1673" y="107"/>
                      </a:lnTo>
                      <a:lnTo>
                        <a:pt x="1674" y="107"/>
                      </a:lnTo>
                      <a:lnTo>
                        <a:pt x="1674" y="104"/>
                      </a:lnTo>
                      <a:lnTo>
                        <a:pt x="1674" y="108"/>
                      </a:lnTo>
                      <a:lnTo>
                        <a:pt x="1674" y="106"/>
                      </a:lnTo>
                      <a:lnTo>
                        <a:pt x="1675" y="106"/>
                      </a:lnTo>
                      <a:lnTo>
                        <a:pt x="1675" y="103"/>
                      </a:lnTo>
                      <a:lnTo>
                        <a:pt x="1675" y="107"/>
                      </a:lnTo>
                      <a:lnTo>
                        <a:pt x="1675" y="104"/>
                      </a:lnTo>
                      <a:lnTo>
                        <a:pt x="1676" y="104"/>
                      </a:lnTo>
                      <a:lnTo>
                        <a:pt x="1676" y="103"/>
                      </a:lnTo>
                      <a:lnTo>
                        <a:pt x="1676" y="106"/>
                      </a:lnTo>
                      <a:lnTo>
                        <a:pt x="1676" y="105"/>
                      </a:lnTo>
                      <a:lnTo>
                        <a:pt x="1677" y="105"/>
                      </a:lnTo>
                      <a:lnTo>
                        <a:pt x="1677" y="103"/>
                      </a:lnTo>
                      <a:lnTo>
                        <a:pt x="1677" y="107"/>
                      </a:lnTo>
                      <a:lnTo>
                        <a:pt x="1677" y="105"/>
                      </a:lnTo>
                      <a:lnTo>
                        <a:pt x="1678" y="105"/>
                      </a:lnTo>
                      <a:lnTo>
                        <a:pt x="1678" y="103"/>
                      </a:lnTo>
                      <a:lnTo>
                        <a:pt x="1678" y="105"/>
                      </a:lnTo>
                      <a:lnTo>
                        <a:pt x="1678" y="104"/>
                      </a:lnTo>
                      <a:lnTo>
                        <a:pt x="1679" y="104"/>
                      </a:lnTo>
                      <a:lnTo>
                        <a:pt x="1679" y="103"/>
                      </a:lnTo>
                      <a:lnTo>
                        <a:pt x="1679" y="106"/>
                      </a:lnTo>
                      <a:lnTo>
                        <a:pt x="1679" y="104"/>
                      </a:lnTo>
                      <a:lnTo>
                        <a:pt x="1680" y="104"/>
                      </a:lnTo>
                      <a:lnTo>
                        <a:pt x="1680" y="103"/>
                      </a:lnTo>
                      <a:lnTo>
                        <a:pt x="1680" y="107"/>
                      </a:lnTo>
                      <a:lnTo>
                        <a:pt x="1680" y="104"/>
                      </a:lnTo>
                      <a:lnTo>
                        <a:pt x="1681" y="104"/>
                      </a:lnTo>
                      <a:lnTo>
                        <a:pt x="1681" y="104"/>
                      </a:lnTo>
                      <a:lnTo>
                        <a:pt x="1681" y="108"/>
                      </a:lnTo>
                      <a:lnTo>
                        <a:pt x="1681" y="107"/>
                      </a:lnTo>
                      <a:lnTo>
                        <a:pt x="1682" y="107"/>
                      </a:lnTo>
                      <a:lnTo>
                        <a:pt x="1682" y="104"/>
                      </a:lnTo>
                      <a:lnTo>
                        <a:pt x="1682" y="108"/>
                      </a:lnTo>
                      <a:lnTo>
                        <a:pt x="1682" y="105"/>
                      </a:lnTo>
                      <a:lnTo>
                        <a:pt x="1683" y="105"/>
                      </a:lnTo>
                      <a:lnTo>
                        <a:pt x="1683" y="104"/>
                      </a:lnTo>
                      <a:lnTo>
                        <a:pt x="1683" y="107"/>
                      </a:lnTo>
                      <a:lnTo>
                        <a:pt x="1683" y="105"/>
                      </a:lnTo>
                      <a:lnTo>
                        <a:pt x="1684" y="105"/>
                      </a:lnTo>
                      <a:lnTo>
                        <a:pt x="1684" y="104"/>
                      </a:lnTo>
                      <a:lnTo>
                        <a:pt x="1684" y="106"/>
                      </a:lnTo>
                      <a:lnTo>
                        <a:pt x="1684" y="106"/>
                      </a:lnTo>
                      <a:lnTo>
                        <a:pt x="1685" y="106"/>
                      </a:lnTo>
                      <a:lnTo>
                        <a:pt x="1685" y="105"/>
                      </a:lnTo>
                      <a:lnTo>
                        <a:pt x="1685" y="107"/>
                      </a:lnTo>
                      <a:lnTo>
                        <a:pt x="1685" y="107"/>
                      </a:lnTo>
                      <a:lnTo>
                        <a:pt x="1686" y="107"/>
                      </a:lnTo>
                      <a:lnTo>
                        <a:pt x="1686" y="104"/>
                      </a:lnTo>
                      <a:lnTo>
                        <a:pt x="1686" y="107"/>
                      </a:lnTo>
                      <a:lnTo>
                        <a:pt x="1686" y="105"/>
                      </a:lnTo>
                      <a:lnTo>
                        <a:pt x="1687" y="105"/>
                      </a:lnTo>
                      <a:lnTo>
                        <a:pt x="1687" y="103"/>
                      </a:lnTo>
                      <a:lnTo>
                        <a:pt x="1687" y="106"/>
                      </a:lnTo>
                      <a:lnTo>
                        <a:pt x="1687" y="104"/>
                      </a:lnTo>
                      <a:lnTo>
                        <a:pt x="1688" y="104"/>
                      </a:lnTo>
                      <a:lnTo>
                        <a:pt x="1688" y="103"/>
                      </a:lnTo>
                      <a:lnTo>
                        <a:pt x="1688" y="106"/>
                      </a:lnTo>
                      <a:lnTo>
                        <a:pt x="1688" y="105"/>
                      </a:lnTo>
                      <a:lnTo>
                        <a:pt x="1689" y="105"/>
                      </a:lnTo>
                      <a:lnTo>
                        <a:pt x="1689" y="104"/>
                      </a:lnTo>
                      <a:lnTo>
                        <a:pt x="1689" y="108"/>
                      </a:lnTo>
                      <a:lnTo>
                        <a:pt x="1689" y="105"/>
                      </a:lnTo>
                      <a:lnTo>
                        <a:pt x="1690" y="105"/>
                      </a:lnTo>
                      <a:lnTo>
                        <a:pt x="1690" y="104"/>
                      </a:lnTo>
                      <a:lnTo>
                        <a:pt x="1690" y="107"/>
                      </a:lnTo>
                      <a:lnTo>
                        <a:pt x="1690" y="104"/>
                      </a:lnTo>
                      <a:lnTo>
                        <a:pt x="1691" y="104"/>
                      </a:lnTo>
                      <a:lnTo>
                        <a:pt x="1691" y="103"/>
                      </a:lnTo>
                      <a:lnTo>
                        <a:pt x="1691" y="107"/>
                      </a:lnTo>
                      <a:lnTo>
                        <a:pt x="1691" y="104"/>
                      </a:lnTo>
                      <a:lnTo>
                        <a:pt x="1692" y="104"/>
                      </a:lnTo>
                      <a:lnTo>
                        <a:pt x="1692" y="103"/>
                      </a:lnTo>
                      <a:lnTo>
                        <a:pt x="1692" y="107"/>
                      </a:lnTo>
                      <a:lnTo>
                        <a:pt x="1692" y="104"/>
                      </a:lnTo>
                      <a:lnTo>
                        <a:pt x="1693" y="104"/>
                      </a:lnTo>
                      <a:lnTo>
                        <a:pt x="1693" y="103"/>
                      </a:lnTo>
                      <a:lnTo>
                        <a:pt x="1693" y="107"/>
                      </a:lnTo>
                      <a:lnTo>
                        <a:pt x="1693" y="105"/>
                      </a:lnTo>
                      <a:lnTo>
                        <a:pt x="1694" y="105"/>
                      </a:lnTo>
                      <a:lnTo>
                        <a:pt x="1694" y="104"/>
                      </a:lnTo>
                      <a:lnTo>
                        <a:pt x="1694" y="105"/>
                      </a:lnTo>
                      <a:lnTo>
                        <a:pt x="1694" y="104"/>
                      </a:lnTo>
                      <a:lnTo>
                        <a:pt x="1695" y="104"/>
                      </a:lnTo>
                      <a:lnTo>
                        <a:pt x="1695" y="103"/>
                      </a:lnTo>
                      <a:lnTo>
                        <a:pt x="1695" y="105"/>
                      </a:lnTo>
                      <a:lnTo>
                        <a:pt x="1695" y="105"/>
                      </a:lnTo>
                      <a:lnTo>
                        <a:pt x="1696" y="105"/>
                      </a:lnTo>
                      <a:lnTo>
                        <a:pt x="1696" y="104"/>
                      </a:lnTo>
                      <a:lnTo>
                        <a:pt x="1696" y="107"/>
                      </a:lnTo>
                      <a:lnTo>
                        <a:pt x="1696" y="105"/>
                      </a:lnTo>
                      <a:lnTo>
                        <a:pt x="1697" y="105"/>
                      </a:lnTo>
                      <a:lnTo>
                        <a:pt x="1697" y="104"/>
                      </a:lnTo>
                      <a:lnTo>
                        <a:pt x="1697" y="108"/>
                      </a:lnTo>
                      <a:lnTo>
                        <a:pt x="1697" y="104"/>
                      </a:lnTo>
                      <a:lnTo>
                        <a:pt x="1698" y="104"/>
                      </a:lnTo>
                      <a:lnTo>
                        <a:pt x="1698" y="102"/>
                      </a:lnTo>
                      <a:lnTo>
                        <a:pt x="1698" y="105"/>
                      </a:lnTo>
                      <a:lnTo>
                        <a:pt x="1698" y="105"/>
                      </a:lnTo>
                      <a:lnTo>
                        <a:pt x="1699" y="105"/>
                      </a:lnTo>
                      <a:lnTo>
                        <a:pt x="1699" y="103"/>
                      </a:lnTo>
                      <a:lnTo>
                        <a:pt x="1699" y="107"/>
                      </a:lnTo>
                      <a:lnTo>
                        <a:pt x="1699" y="105"/>
                      </a:lnTo>
                      <a:lnTo>
                        <a:pt x="1700" y="105"/>
                      </a:lnTo>
                      <a:lnTo>
                        <a:pt x="1700" y="103"/>
                      </a:lnTo>
                      <a:lnTo>
                        <a:pt x="1700" y="106"/>
                      </a:lnTo>
                      <a:lnTo>
                        <a:pt x="1700" y="104"/>
                      </a:lnTo>
                      <a:lnTo>
                        <a:pt x="1701" y="104"/>
                      </a:lnTo>
                      <a:lnTo>
                        <a:pt x="1701" y="103"/>
                      </a:lnTo>
                      <a:lnTo>
                        <a:pt x="1701" y="106"/>
                      </a:lnTo>
                      <a:lnTo>
                        <a:pt x="1701" y="104"/>
                      </a:lnTo>
                      <a:lnTo>
                        <a:pt x="1702" y="104"/>
                      </a:lnTo>
                      <a:lnTo>
                        <a:pt x="1702" y="101"/>
                      </a:lnTo>
                      <a:lnTo>
                        <a:pt x="1702" y="107"/>
                      </a:lnTo>
                      <a:lnTo>
                        <a:pt x="1702" y="103"/>
                      </a:lnTo>
                      <a:lnTo>
                        <a:pt x="1703" y="103"/>
                      </a:lnTo>
                      <a:lnTo>
                        <a:pt x="1703" y="102"/>
                      </a:lnTo>
                      <a:lnTo>
                        <a:pt x="1703" y="106"/>
                      </a:lnTo>
                      <a:lnTo>
                        <a:pt x="1703" y="105"/>
                      </a:lnTo>
                      <a:lnTo>
                        <a:pt x="1704" y="105"/>
                      </a:lnTo>
                      <a:lnTo>
                        <a:pt x="1704" y="103"/>
                      </a:lnTo>
                      <a:lnTo>
                        <a:pt x="1704" y="107"/>
                      </a:lnTo>
                      <a:lnTo>
                        <a:pt x="1704" y="104"/>
                      </a:lnTo>
                      <a:lnTo>
                        <a:pt x="1705" y="104"/>
                      </a:lnTo>
                      <a:lnTo>
                        <a:pt x="1705" y="101"/>
                      </a:lnTo>
                      <a:lnTo>
                        <a:pt x="1705" y="105"/>
                      </a:lnTo>
                      <a:lnTo>
                        <a:pt x="1705" y="101"/>
                      </a:lnTo>
                      <a:lnTo>
                        <a:pt x="1706" y="101"/>
                      </a:lnTo>
                      <a:lnTo>
                        <a:pt x="1706" y="102"/>
                      </a:lnTo>
                      <a:lnTo>
                        <a:pt x="1706" y="105"/>
                      </a:lnTo>
                      <a:lnTo>
                        <a:pt x="1706" y="102"/>
                      </a:lnTo>
                      <a:lnTo>
                        <a:pt x="1707" y="102"/>
                      </a:lnTo>
                      <a:lnTo>
                        <a:pt x="1707" y="102"/>
                      </a:lnTo>
                      <a:lnTo>
                        <a:pt x="1707" y="106"/>
                      </a:lnTo>
                      <a:lnTo>
                        <a:pt x="1707" y="104"/>
                      </a:lnTo>
                      <a:lnTo>
                        <a:pt x="1708" y="104"/>
                      </a:lnTo>
                      <a:lnTo>
                        <a:pt x="1708" y="102"/>
                      </a:lnTo>
                      <a:lnTo>
                        <a:pt x="1708" y="105"/>
                      </a:lnTo>
                      <a:lnTo>
                        <a:pt x="1708" y="104"/>
                      </a:lnTo>
                      <a:lnTo>
                        <a:pt x="1709" y="104"/>
                      </a:lnTo>
                      <a:lnTo>
                        <a:pt x="1709" y="103"/>
                      </a:lnTo>
                      <a:lnTo>
                        <a:pt x="1709" y="105"/>
                      </a:lnTo>
                      <a:lnTo>
                        <a:pt x="1709" y="103"/>
                      </a:lnTo>
                      <a:lnTo>
                        <a:pt x="1710" y="103"/>
                      </a:lnTo>
                      <a:lnTo>
                        <a:pt x="1710" y="102"/>
                      </a:lnTo>
                      <a:lnTo>
                        <a:pt x="1710" y="106"/>
                      </a:lnTo>
                      <a:lnTo>
                        <a:pt x="1710" y="102"/>
                      </a:lnTo>
                      <a:lnTo>
                        <a:pt x="1711" y="102"/>
                      </a:lnTo>
                      <a:lnTo>
                        <a:pt x="1711" y="102"/>
                      </a:lnTo>
                      <a:lnTo>
                        <a:pt x="1711" y="106"/>
                      </a:lnTo>
                      <a:lnTo>
                        <a:pt x="1711" y="105"/>
                      </a:lnTo>
                      <a:lnTo>
                        <a:pt x="1712" y="105"/>
                      </a:lnTo>
                      <a:lnTo>
                        <a:pt x="1712" y="101"/>
                      </a:lnTo>
                      <a:lnTo>
                        <a:pt x="1712" y="105"/>
                      </a:lnTo>
                      <a:lnTo>
                        <a:pt x="1712" y="104"/>
                      </a:lnTo>
                      <a:lnTo>
                        <a:pt x="1713" y="104"/>
                      </a:lnTo>
                      <a:lnTo>
                        <a:pt x="1713" y="101"/>
                      </a:lnTo>
                      <a:lnTo>
                        <a:pt x="1713" y="105"/>
                      </a:lnTo>
                      <a:lnTo>
                        <a:pt x="1713" y="103"/>
                      </a:lnTo>
                      <a:lnTo>
                        <a:pt x="1714" y="103"/>
                      </a:lnTo>
                      <a:lnTo>
                        <a:pt x="1714" y="101"/>
                      </a:lnTo>
                      <a:lnTo>
                        <a:pt x="1714" y="106"/>
                      </a:lnTo>
                      <a:lnTo>
                        <a:pt x="1714" y="106"/>
                      </a:lnTo>
                      <a:lnTo>
                        <a:pt x="1715" y="106"/>
                      </a:lnTo>
                      <a:lnTo>
                        <a:pt x="1715" y="101"/>
                      </a:lnTo>
                      <a:lnTo>
                        <a:pt x="1715" y="105"/>
                      </a:lnTo>
                      <a:lnTo>
                        <a:pt x="1715" y="101"/>
                      </a:lnTo>
                      <a:lnTo>
                        <a:pt x="1716" y="101"/>
                      </a:lnTo>
                      <a:lnTo>
                        <a:pt x="1716" y="101"/>
                      </a:lnTo>
                      <a:lnTo>
                        <a:pt x="1716" y="104"/>
                      </a:lnTo>
                      <a:lnTo>
                        <a:pt x="1716" y="104"/>
                      </a:lnTo>
                      <a:lnTo>
                        <a:pt x="1717" y="104"/>
                      </a:lnTo>
                      <a:lnTo>
                        <a:pt x="1717" y="100"/>
                      </a:lnTo>
                      <a:lnTo>
                        <a:pt x="1717" y="105"/>
                      </a:lnTo>
                      <a:lnTo>
                        <a:pt x="1717" y="103"/>
                      </a:lnTo>
                      <a:lnTo>
                        <a:pt x="1718" y="103"/>
                      </a:lnTo>
                      <a:lnTo>
                        <a:pt x="1718" y="99"/>
                      </a:lnTo>
                      <a:lnTo>
                        <a:pt x="1718" y="103"/>
                      </a:lnTo>
                      <a:lnTo>
                        <a:pt x="1718" y="99"/>
                      </a:lnTo>
                      <a:lnTo>
                        <a:pt x="1719" y="99"/>
                      </a:lnTo>
                      <a:lnTo>
                        <a:pt x="1719" y="100"/>
                      </a:lnTo>
                      <a:lnTo>
                        <a:pt x="1719" y="104"/>
                      </a:lnTo>
                      <a:lnTo>
                        <a:pt x="1719" y="103"/>
                      </a:lnTo>
                      <a:lnTo>
                        <a:pt x="1720" y="103"/>
                      </a:lnTo>
                      <a:lnTo>
                        <a:pt x="1720" y="100"/>
                      </a:lnTo>
                      <a:lnTo>
                        <a:pt x="1720" y="104"/>
                      </a:lnTo>
                      <a:lnTo>
                        <a:pt x="1720" y="103"/>
                      </a:lnTo>
                      <a:lnTo>
                        <a:pt x="1721" y="103"/>
                      </a:lnTo>
                      <a:lnTo>
                        <a:pt x="1721" y="101"/>
                      </a:lnTo>
                      <a:lnTo>
                        <a:pt x="1721" y="104"/>
                      </a:lnTo>
                      <a:lnTo>
                        <a:pt x="1721" y="103"/>
                      </a:lnTo>
                      <a:lnTo>
                        <a:pt x="1722" y="103"/>
                      </a:lnTo>
                      <a:lnTo>
                        <a:pt x="1722" y="101"/>
                      </a:lnTo>
                      <a:lnTo>
                        <a:pt x="1722" y="104"/>
                      </a:lnTo>
                      <a:lnTo>
                        <a:pt x="1722" y="103"/>
                      </a:lnTo>
                      <a:lnTo>
                        <a:pt x="1723" y="103"/>
                      </a:lnTo>
                      <a:lnTo>
                        <a:pt x="1723" y="101"/>
                      </a:lnTo>
                      <a:lnTo>
                        <a:pt x="1723" y="105"/>
                      </a:lnTo>
                      <a:lnTo>
                        <a:pt x="1723" y="102"/>
                      </a:lnTo>
                      <a:lnTo>
                        <a:pt x="1724" y="102"/>
                      </a:lnTo>
                      <a:lnTo>
                        <a:pt x="1724" y="102"/>
                      </a:lnTo>
                      <a:lnTo>
                        <a:pt x="1724" y="106"/>
                      </a:lnTo>
                      <a:lnTo>
                        <a:pt x="1724" y="105"/>
                      </a:lnTo>
                      <a:lnTo>
                        <a:pt x="1725" y="105"/>
                      </a:lnTo>
                      <a:lnTo>
                        <a:pt x="1725" y="101"/>
                      </a:lnTo>
                      <a:lnTo>
                        <a:pt x="1725" y="105"/>
                      </a:lnTo>
                      <a:lnTo>
                        <a:pt x="1725" y="104"/>
                      </a:lnTo>
                      <a:lnTo>
                        <a:pt x="1726" y="104"/>
                      </a:lnTo>
                      <a:lnTo>
                        <a:pt x="1726" y="103"/>
                      </a:lnTo>
                      <a:lnTo>
                        <a:pt x="1726" y="105"/>
                      </a:lnTo>
                      <a:lnTo>
                        <a:pt x="1726" y="103"/>
                      </a:lnTo>
                      <a:lnTo>
                        <a:pt x="1727" y="103"/>
                      </a:lnTo>
                      <a:lnTo>
                        <a:pt x="1727" y="102"/>
                      </a:lnTo>
                      <a:lnTo>
                        <a:pt x="1727" y="105"/>
                      </a:lnTo>
                      <a:lnTo>
                        <a:pt x="1727" y="102"/>
                      </a:lnTo>
                      <a:lnTo>
                        <a:pt x="1728" y="102"/>
                      </a:lnTo>
                      <a:lnTo>
                        <a:pt x="1728" y="102"/>
                      </a:lnTo>
                      <a:lnTo>
                        <a:pt x="1728" y="104"/>
                      </a:lnTo>
                      <a:lnTo>
                        <a:pt x="1728" y="103"/>
                      </a:lnTo>
                      <a:lnTo>
                        <a:pt x="1729" y="103"/>
                      </a:lnTo>
                      <a:lnTo>
                        <a:pt x="1729" y="102"/>
                      </a:lnTo>
                      <a:lnTo>
                        <a:pt x="1729" y="106"/>
                      </a:lnTo>
                      <a:lnTo>
                        <a:pt x="1729" y="105"/>
                      </a:lnTo>
                      <a:lnTo>
                        <a:pt x="1730" y="105"/>
                      </a:lnTo>
                      <a:lnTo>
                        <a:pt x="1730" y="102"/>
                      </a:lnTo>
                      <a:lnTo>
                        <a:pt x="1730" y="105"/>
                      </a:lnTo>
                      <a:lnTo>
                        <a:pt x="1730" y="104"/>
                      </a:lnTo>
                      <a:lnTo>
                        <a:pt x="1731" y="104"/>
                      </a:lnTo>
                      <a:lnTo>
                        <a:pt x="1731" y="101"/>
                      </a:lnTo>
                      <a:lnTo>
                        <a:pt x="1731" y="106"/>
                      </a:lnTo>
                      <a:lnTo>
                        <a:pt x="1731" y="103"/>
                      </a:lnTo>
                      <a:lnTo>
                        <a:pt x="1732" y="103"/>
                      </a:lnTo>
                      <a:lnTo>
                        <a:pt x="1732" y="101"/>
                      </a:lnTo>
                      <a:lnTo>
                        <a:pt x="1732" y="104"/>
                      </a:lnTo>
                      <a:lnTo>
                        <a:pt x="1732" y="104"/>
                      </a:lnTo>
                      <a:lnTo>
                        <a:pt x="1733" y="104"/>
                      </a:lnTo>
                      <a:lnTo>
                        <a:pt x="1733" y="101"/>
                      </a:lnTo>
                      <a:lnTo>
                        <a:pt x="1733" y="106"/>
                      </a:lnTo>
                      <a:lnTo>
                        <a:pt x="1733" y="104"/>
                      </a:lnTo>
                      <a:lnTo>
                        <a:pt x="1734" y="104"/>
                      </a:lnTo>
                      <a:lnTo>
                        <a:pt x="1734" y="103"/>
                      </a:lnTo>
                      <a:lnTo>
                        <a:pt x="1734" y="105"/>
                      </a:lnTo>
                      <a:lnTo>
                        <a:pt x="1734" y="104"/>
                      </a:lnTo>
                      <a:lnTo>
                        <a:pt x="1735" y="104"/>
                      </a:lnTo>
                      <a:lnTo>
                        <a:pt x="1735" y="101"/>
                      </a:lnTo>
                      <a:lnTo>
                        <a:pt x="1735" y="105"/>
                      </a:lnTo>
                      <a:lnTo>
                        <a:pt x="1735" y="103"/>
                      </a:lnTo>
                      <a:lnTo>
                        <a:pt x="1736" y="103"/>
                      </a:lnTo>
                      <a:lnTo>
                        <a:pt x="1736" y="101"/>
                      </a:lnTo>
                      <a:lnTo>
                        <a:pt x="1736" y="104"/>
                      </a:lnTo>
                      <a:lnTo>
                        <a:pt x="1736" y="104"/>
                      </a:lnTo>
                      <a:lnTo>
                        <a:pt x="1737" y="104"/>
                      </a:lnTo>
                      <a:lnTo>
                        <a:pt x="1737" y="102"/>
                      </a:lnTo>
                      <a:lnTo>
                        <a:pt x="1737" y="106"/>
                      </a:lnTo>
                      <a:lnTo>
                        <a:pt x="1737" y="103"/>
                      </a:lnTo>
                      <a:lnTo>
                        <a:pt x="1738" y="103"/>
                      </a:lnTo>
                      <a:lnTo>
                        <a:pt x="1738" y="103"/>
                      </a:lnTo>
                      <a:lnTo>
                        <a:pt x="1738" y="106"/>
                      </a:lnTo>
                      <a:lnTo>
                        <a:pt x="1738" y="105"/>
                      </a:lnTo>
                      <a:lnTo>
                        <a:pt x="1739" y="105"/>
                      </a:lnTo>
                      <a:lnTo>
                        <a:pt x="1739" y="102"/>
                      </a:lnTo>
                      <a:lnTo>
                        <a:pt x="1739" y="105"/>
                      </a:lnTo>
                      <a:lnTo>
                        <a:pt x="1739" y="103"/>
                      </a:lnTo>
                      <a:lnTo>
                        <a:pt x="1740" y="103"/>
                      </a:lnTo>
                      <a:lnTo>
                        <a:pt x="1740" y="102"/>
                      </a:lnTo>
                      <a:lnTo>
                        <a:pt x="1740" y="105"/>
                      </a:lnTo>
                      <a:lnTo>
                        <a:pt x="1740" y="104"/>
                      </a:lnTo>
                      <a:lnTo>
                        <a:pt x="1741" y="104"/>
                      </a:lnTo>
                      <a:lnTo>
                        <a:pt x="1741" y="102"/>
                      </a:lnTo>
                      <a:lnTo>
                        <a:pt x="1741" y="107"/>
                      </a:lnTo>
                      <a:lnTo>
                        <a:pt x="1741" y="104"/>
                      </a:lnTo>
                      <a:lnTo>
                        <a:pt x="1742" y="104"/>
                      </a:lnTo>
                      <a:lnTo>
                        <a:pt x="1742" y="101"/>
                      </a:lnTo>
                      <a:lnTo>
                        <a:pt x="1742" y="105"/>
                      </a:lnTo>
                      <a:lnTo>
                        <a:pt x="1742" y="103"/>
                      </a:lnTo>
                      <a:lnTo>
                        <a:pt x="1743" y="103"/>
                      </a:lnTo>
                      <a:lnTo>
                        <a:pt x="1743" y="100"/>
                      </a:lnTo>
                      <a:lnTo>
                        <a:pt x="1743" y="104"/>
                      </a:lnTo>
                      <a:lnTo>
                        <a:pt x="1743" y="102"/>
                      </a:lnTo>
                      <a:lnTo>
                        <a:pt x="1744" y="102"/>
                      </a:lnTo>
                      <a:lnTo>
                        <a:pt x="1744" y="103"/>
                      </a:lnTo>
                      <a:lnTo>
                        <a:pt x="1744" y="105"/>
                      </a:lnTo>
                      <a:lnTo>
                        <a:pt x="1744" y="105"/>
                      </a:lnTo>
                      <a:lnTo>
                        <a:pt x="1745" y="105"/>
                      </a:lnTo>
                      <a:lnTo>
                        <a:pt x="1745" y="103"/>
                      </a:lnTo>
                      <a:lnTo>
                        <a:pt x="1745" y="106"/>
                      </a:lnTo>
                      <a:lnTo>
                        <a:pt x="1745" y="104"/>
                      </a:lnTo>
                      <a:lnTo>
                        <a:pt x="1746" y="104"/>
                      </a:lnTo>
                      <a:lnTo>
                        <a:pt x="1746" y="102"/>
                      </a:lnTo>
                      <a:lnTo>
                        <a:pt x="1746" y="105"/>
                      </a:lnTo>
                      <a:lnTo>
                        <a:pt x="1746" y="104"/>
                      </a:lnTo>
                      <a:lnTo>
                        <a:pt x="1747" y="104"/>
                      </a:lnTo>
                      <a:lnTo>
                        <a:pt x="1747" y="101"/>
                      </a:lnTo>
                      <a:lnTo>
                        <a:pt x="1747" y="105"/>
                      </a:lnTo>
                      <a:lnTo>
                        <a:pt x="1747" y="103"/>
                      </a:lnTo>
                      <a:lnTo>
                        <a:pt x="1748" y="103"/>
                      </a:lnTo>
                      <a:lnTo>
                        <a:pt x="1748" y="101"/>
                      </a:lnTo>
                      <a:lnTo>
                        <a:pt x="1748" y="105"/>
                      </a:lnTo>
                      <a:lnTo>
                        <a:pt x="1748" y="103"/>
                      </a:lnTo>
                      <a:lnTo>
                        <a:pt x="1749" y="103"/>
                      </a:lnTo>
                      <a:lnTo>
                        <a:pt x="1749" y="102"/>
                      </a:lnTo>
                      <a:lnTo>
                        <a:pt x="1749" y="105"/>
                      </a:lnTo>
                      <a:lnTo>
                        <a:pt x="1749" y="103"/>
                      </a:lnTo>
                      <a:lnTo>
                        <a:pt x="1750" y="103"/>
                      </a:lnTo>
                      <a:lnTo>
                        <a:pt x="1750" y="101"/>
                      </a:lnTo>
                      <a:lnTo>
                        <a:pt x="1750" y="105"/>
                      </a:lnTo>
                      <a:lnTo>
                        <a:pt x="1750" y="103"/>
                      </a:lnTo>
                      <a:lnTo>
                        <a:pt x="1751" y="103"/>
                      </a:lnTo>
                      <a:lnTo>
                        <a:pt x="1751" y="101"/>
                      </a:lnTo>
                      <a:lnTo>
                        <a:pt x="1751" y="105"/>
                      </a:lnTo>
                      <a:lnTo>
                        <a:pt x="1751" y="105"/>
                      </a:lnTo>
                      <a:lnTo>
                        <a:pt x="1752" y="105"/>
                      </a:lnTo>
                      <a:lnTo>
                        <a:pt x="1752" y="103"/>
                      </a:lnTo>
                      <a:lnTo>
                        <a:pt x="1752" y="107"/>
                      </a:lnTo>
                      <a:lnTo>
                        <a:pt x="1752" y="104"/>
                      </a:lnTo>
                      <a:lnTo>
                        <a:pt x="1753" y="104"/>
                      </a:lnTo>
                      <a:lnTo>
                        <a:pt x="1753" y="101"/>
                      </a:lnTo>
                      <a:lnTo>
                        <a:pt x="1753" y="104"/>
                      </a:lnTo>
                      <a:lnTo>
                        <a:pt x="1753" y="103"/>
                      </a:lnTo>
                      <a:lnTo>
                        <a:pt x="1754" y="103"/>
                      </a:lnTo>
                      <a:lnTo>
                        <a:pt x="1754" y="101"/>
                      </a:lnTo>
                      <a:lnTo>
                        <a:pt x="1754" y="104"/>
                      </a:lnTo>
                      <a:lnTo>
                        <a:pt x="1754" y="103"/>
                      </a:lnTo>
                      <a:lnTo>
                        <a:pt x="1755" y="103"/>
                      </a:lnTo>
                      <a:lnTo>
                        <a:pt x="1755" y="102"/>
                      </a:lnTo>
                      <a:lnTo>
                        <a:pt x="1755" y="105"/>
                      </a:lnTo>
                      <a:lnTo>
                        <a:pt x="1755" y="102"/>
                      </a:lnTo>
                      <a:lnTo>
                        <a:pt x="1756" y="102"/>
                      </a:lnTo>
                      <a:lnTo>
                        <a:pt x="1756" y="101"/>
                      </a:lnTo>
                      <a:lnTo>
                        <a:pt x="1756" y="104"/>
                      </a:lnTo>
                      <a:lnTo>
                        <a:pt x="1756" y="103"/>
                      </a:lnTo>
                      <a:lnTo>
                        <a:pt x="1757" y="103"/>
                      </a:lnTo>
                      <a:lnTo>
                        <a:pt x="1757" y="102"/>
                      </a:lnTo>
                      <a:lnTo>
                        <a:pt x="1757" y="105"/>
                      </a:lnTo>
                      <a:lnTo>
                        <a:pt x="1757" y="104"/>
                      </a:lnTo>
                      <a:lnTo>
                        <a:pt x="1758" y="104"/>
                      </a:lnTo>
                      <a:lnTo>
                        <a:pt x="1758" y="101"/>
                      </a:lnTo>
                      <a:lnTo>
                        <a:pt x="1758" y="106"/>
                      </a:lnTo>
                      <a:lnTo>
                        <a:pt x="1758" y="103"/>
                      </a:lnTo>
                      <a:lnTo>
                        <a:pt x="1759" y="103"/>
                      </a:lnTo>
                      <a:lnTo>
                        <a:pt x="1759" y="100"/>
                      </a:lnTo>
                      <a:lnTo>
                        <a:pt x="1759" y="106"/>
                      </a:lnTo>
                      <a:lnTo>
                        <a:pt x="1759" y="104"/>
                      </a:lnTo>
                      <a:lnTo>
                        <a:pt x="1760" y="104"/>
                      </a:lnTo>
                      <a:lnTo>
                        <a:pt x="1760" y="102"/>
                      </a:lnTo>
                      <a:lnTo>
                        <a:pt x="1760" y="105"/>
                      </a:lnTo>
                      <a:lnTo>
                        <a:pt x="1760" y="105"/>
                      </a:lnTo>
                      <a:lnTo>
                        <a:pt x="1761" y="105"/>
                      </a:lnTo>
                      <a:lnTo>
                        <a:pt x="1761" y="101"/>
                      </a:lnTo>
                      <a:lnTo>
                        <a:pt x="1761" y="105"/>
                      </a:lnTo>
                      <a:lnTo>
                        <a:pt x="1761" y="101"/>
                      </a:lnTo>
                      <a:lnTo>
                        <a:pt x="1762" y="101"/>
                      </a:lnTo>
                      <a:lnTo>
                        <a:pt x="1762" y="101"/>
                      </a:lnTo>
                      <a:lnTo>
                        <a:pt x="1762" y="104"/>
                      </a:lnTo>
                      <a:lnTo>
                        <a:pt x="1762" y="101"/>
                      </a:lnTo>
                      <a:lnTo>
                        <a:pt x="1763" y="101"/>
                      </a:lnTo>
                      <a:lnTo>
                        <a:pt x="1763" y="101"/>
                      </a:lnTo>
                      <a:lnTo>
                        <a:pt x="1763" y="105"/>
                      </a:lnTo>
                      <a:lnTo>
                        <a:pt x="1763" y="103"/>
                      </a:lnTo>
                      <a:lnTo>
                        <a:pt x="1764" y="103"/>
                      </a:lnTo>
                      <a:lnTo>
                        <a:pt x="1764" y="100"/>
                      </a:lnTo>
                      <a:lnTo>
                        <a:pt x="1764" y="104"/>
                      </a:lnTo>
                      <a:lnTo>
                        <a:pt x="1764" y="104"/>
                      </a:lnTo>
                      <a:lnTo>
                        <a:pt x="1765" y="104"/>
                      </a:lnTo>
                      <a:lnTo>
                        <a:pt x="1765" y="100"/>
                      </a:lnTo>
                      <a:lnTo>
                        <a:pt x="1765" y="104"/>
                      </a:lnTo>
                      <a:lnTo>
                        <a:pt x="1765" y="103"/>
                      </a:lnTo>
                      <a:lnTo>
                        <a:pt x="1766" y="103"/>
                      </a:lnTo>
                      <a:lnTo>
                        <a:pt x="1766" y="100"/>
                      </a:lnTo>
                      <a:lnTo>
                        <a:pt x="1766" y="105"/>
                      </a:lnTo>
                      <a:lnTo>
                        <a:pt x="1766" y="102"/>
                      </a:lnTo>
                      <a:lnTo>
                        <a:pt x="1767" y="102"/>
                      </a:lnTo>
                      <a:lnTo>
                        <a:pt x="1767" y="101"/>
                      </a:lnTo>
                      <a:lnTo>
                        <a:pt x="1767" y="105"/>
                      </a:lnTo>
                      <a:lnTo>
                        <a:pt x="1767" y="103"/>
                      </a:lnTo>
                      <a:lnTo>
                        <a:pt x="1768" y="103"/>
                      </a:lnTo>
                      <a:lnTo>
                        <a:pt x="1768" y="101"/>
                      </a:lnTo>
                      <a:lnTo>
                        <a:pt x="1768" y="104"/>
                      </a:lnTo>
                      <a:lnTo>
                        <a:pt x="1768" y="104"/>
                      </a:lnTo>
                      <a:lnTo>
                        <a:pt x="1769" y="104"/>
                      </a:lnTo>
                      <a:lnTo>
                        <a:pt x="1769" y="102"/>
                      </a:lnTo>
                      <a:lnTo>
                        <a:pt x="1769" y="105"/>
                      </a:lnTo>
                      <a:lnTo>
                        <a:pt x="1769" y="103"/>
                      </a:lnTo>
                      <a:lnTo>
                        <a:pt x="1770" y="103"/>
                      </a:lnTo>
                      <a:lnTo>
                        <a:pt x="1770" y="101"/>
                      </a:lnTo>
                      <a:lnTo>
                        <a:pt x="1770" y="104"/>
                      </a:lnTo>
                      <a:lnTo>
                        <a:pt x="1770" y="103"/>
                      </a:lnTo>
                      <a:lnTo>
                        <a:pt x="1771" y="103"/>
                      </a:lnTo>
                      <a:lnTo>
                        <a:pt x="1771" y="100"/>
                      </a:lnTo>
                      <a:lnTo>
                        <a:pt x="1771" y="105"/>
                      </a:lnTo>
                      <a:lnTo>
                        <a:pt x="1771" y="103"/>
                      </a:lnTo>
                      <a:lnTo>
                        <a:pt x="1772" y="103"/>
                      </a:lnTo>
                      <a:lnTo>
                        <a:pt x="1772" y="101"/>
                      </a:lnTo>
                      <a:lnTo>
                        <a:pt x="1772" y="104"/>
                      </a:lnTo>
                      <a:lnTo>
                        <a:pt x="1772" y="103"/>
                      </a:lnTo>
                      <a:lnTo>
                        <a:pt x="1773" y="103"/>
                      </a:lnTo>
                      <a:lnTo>
                        <a:pt x="1773" y="100"/>
                      </a:lnTo>
                      <a:lnTo>
                        <a:pt x="1773" y="104"/>
                      </a:lnTo>
                      <a:lnTo>
                        <a:pt x="1773" y="101"/>
                      </a:lnTo>
                      <a:lnTo>
                        <a:pt x="1774" y="101"/>
                      </a:lnTo>
                      <a:lnTo>
                        <a:pt x="1774" y="101"/>
                      </a:lnTo>
                      <a:lnTo>
                        <a:pt x="1774" y="104"/>
                      </a:lnTo>
                      <a:lnTo>
                        <a:pt x="1774" y="103"/>
                      </a:lnTo>
                      <a:lnTo>
                        <a:pt x="1775" y="103"/>
                      </a:lnTo>
                      <a:lnTo>
                        <a:pt x="1775" y="101"/>
                      </a:lnTo>
                      <a:lnTo>
                        <a:pt x="1775" y="106"/>
                      </a:lnTo>
                      <a:lnTo>
                        <a:pt x="1775" y="101"/>
                      </a:lnTo>
                      <a:lnTo>
                        <a:pt x="1776" y="101"/>
                      </a:lnTo>
                      <a:lnTo>
                        <a:pt x="1776" y="100"/>
                      </a:lnTo>
                      <a:lnTo>
                        <a:pt x="1776" y="104"/>
                      </a:lnTo>
                      <a:lnTo>
                        <a:pt x="1776" y="103"/>
                      </a:lnTo>
                      <a:lnTo>
                        <a:pt x="1777" y="103"/>
                      </a:lnTo>
                      <a:lnTo>
                        <a:pt x="1777" y="101"/>
                      </a:lnTo>
                      <a:lnTo>
                        <a:pt x="1777" y="104"/>
                      </a:lnTo>
                      <a:lnTo>
                        <a:pt x="1777" y="103"/>
                      </a:lnTo>
                      <a:lnTo>
                        <a:pt x="1778" y="103"/>
                      </a:lnTo>
                      <a:lnTo>
                        <a:pt x="1778" y="100"/>
                      </a:lnTo>
                      <a:lnTo>
                        <a:pt x="1778" y="104"/>
                      </a:lnTo>
                      <a:lnTo>
                        <a:pt x="1778" y="101"/>
                      </a:lnTo>
                      <a:lnTo>
                        <a:pt x="1779" y="101"/>
                      </a:lnTo>
                      <a:lnTo>
                        <a:pt x="1779" y="101"/>
                      </a:lnTo>
                      <a:lnTo>
                        <a:pt x="1779" y="106"/>
                      </a:lnTo>
                      <a:lnTo>
                        <a:pt x="1779" y="102"/>
                      </a:lnTo>
                      <a:lnTo>
                        <a:pt x="1780" y="102"/>
                      </a:lnTo>
                      <a:lnTo>
                        <a:pt x="1780" y="101"/>
                      </a:lnTo>
                      <a:lnTo>
                        <a:pt x="1780" y="104"/>
                      </a:lnTo>
                      <a:lnTo>
                        <a:pt x="1780" y="103"/>
                      </a:lnTo>
                      <a:lnTo>
                        <a:pt x="1781" y="103"/>
                      </a:lnTo>
                      <a:lnTo>
                        <a:pt x="1781" y="102"/>
                      </a:lnTo>
                      <a:lnTo>
                        <a:pt x="1781" y="103"/>
                      </a:lnTo>
                      <a:lnTo>
                        <a:pt x="1781" y="102"/>
                      </a:lnTo>
                      <a:lnTo>
                        <a:pt x="1782" y="102"/>
                      </a:lnTo>
                      <a:lnTo>
                        <a:pt x="1782" y="101"/>
                      </a:lnTo>
                      <a:lnTo>
                        <a:pt x="1782" y="105"/>
                      </a:lnTo>
                      <a:lnTo>
                        <a:pt x="1782" y="103"/>
                      </a:lnTo>
                      <a:lnTo>
                        <a:pt x="1783" y="103"/>
                      </a:lnTo>
                      <a:lnTo>
                        <a:pt x="1783" y="100"/>
                      </a:lnTo>
                      <a:lnTo>
                        <a:pt x="1783" y="104"/>
                      </a:lnTo>
                      <a:lnTo>
                        <a:pt x="1783" y="101"/>
                      </a:lnTo>
                      <a:lnTo>
                        <a:pt x="1784" y="101"/>
                      </a:lnTo>
                      <a:lnTo>
                        <a:pt x="1784" y="100"/>
                      </a:lnTo>
                      <a:lnTo>
                        <a:pt x="1784" y="104"/>
                      </a:lnTo>
                      <a:lnTo>
                        <a:pt x="1784" y="103"/>
                      </a:lnTo>
                      <a:lnTo>
                        <a:pt x="1785" y="103"/>
                      </a:lnTo>
                      <a:lnTo>
                        <a:pt x="1785" y="101"/>
                      </a:lnTo>
                      <a:lnTo>
                        <a:pt x="1785" y="104"/>
                      </a:lnTo>
                      <a:lnTo>
                        <a:pt x="1785" y="104"/>
                      </a:lnTo>
                      <a:lnTo>
                        <a:pt x="1786" y="104"/>
                      </a:lnTo>
                      <a:lnTo>
                        <a:pt x="1786" y="100"/>
                      </a:lnTo>
                      <a:lnTo>
                        <a:pt x="1786" y="104"/>
                      </a:lnTo>
                      <a:lnTo>
                        <a:pt x="1786" y="100"/>
                      </a:lnTo>
                      <a:lnTo>
                        <a:pt x="1787" y="100"/>
                      </a:lnTo>
                      <a:lnTo>
                        <a:pt x="1787" y="100"/>
                      </a:lnTo>
                      <a:lnTo>
                        <a:pt x="1787" y="103"/>
                      </a:lnTo>
                      <a:lnTo>
                        <a:pt x="1787" y="103"/>
                      </a:lnTo>
                      <a:lnTo>
                        <a:pt x="1788" y="103"/>
                      </a:lnTo>
                      <a:lnTo>
                        <a:pt x="1788" y="100"/>
                      </a:lnTo>
                      <a:lnTo>
                        <a:pt x="1788" y="103"/>
                      </a:lnTo>
                      <a:lnTo>
                        <a:pt x="1788" y="103"/>
                      </a:lnTo>
                      <a:lnTo>
                        <a:pt x="1789" y="103"/>
                      </a:lnTo>
                      <a:lnTo>
                        <a:pt x="1789" y="100"/>
                      </a:lnTo>
                      <a:lnTo>
                        <a:pt x="1789" y="104"/>
                      </a:lnTo>
                      <a:lnTo>
                        <a:pt x="1789" y="103"/>
                      </a:lnTo>
                      <a:lnTo>
                        <a:pt x="1790" y="103"/>
                      </a:lnTo>
                      <a:lnTo>
                        <a:pt x="1790" y="100"/>
                      </a:lnTo>
                      <a:lnTo>
                        <a:pt x="1790" y="104"/>
                      </a:lnTo>
                      <a:lnTo>
                        <a:pt x="1790" y="102"/>
                      </a:lnTo>
                      <a:lnTo>
                        <a:pt x="1791" y="102"/>
                      </a:lnTo>
                      <a:lnTo>
                        <a:pt x="1791" y="100"/>
                      </a:lnTo>
                      <a:lnTo>
                        <a:pt x="1791" y="105"/>
                      </a:lnTo>
                      <a:lnTo>
                        <a:pt x="1791" y="103"/>
                      </a:lnTo>
                      <a:lnTo>
                        <a:pt x="1792" y="103"/>
                      </a:lnTo>
                      <a:lnTo>
                        <a:pt x="1792" y="100"/>
                      </a:lnTo>
                      <a:lnTo>
                        <a:pt x="1792" y="104"/>
                      </a:lnTo>
                      <a:lnTo>
                        <a:pt x="1792" y="104"/>
                      </a:lnTo>
                      <a:lnTo>
                        <a:pt x="1793" y="104"/>
                      </a:lnTo>
                      <a:lnTo>
                        <a:pt x="1793" y="100"/>
                      </a:lnTo>
                      <a:lnTo>
                        <a:pt x="1793" y="103"/>
                      </a:lnTo>
                      <a:lnTo>
                        <a:pt x="1793" y="101"/>
                      </a:lnTo>
                      <a:lnTo>
                        <a:pt x="1794" y="101"/>
                      </a:lnTo>
                      <a:lnTo>
                        <a:pt x="1794" y="100"/>
                      </a:lnTo>
                      <a:lnTo>
                        <a:pt x="1794" y="103"/>
                      </a:lnTo>
                      <a:lnTo>
                        <a:pt x="1794" y="101"/>
                      </a:lnTo>
                      <a:lnTo>
                        <a:pt x="1795" y="101"/>
                      </a:lnTo>
                      <a:lnTo>
                        <a:pt x="1795" y="100"/>
                      </a:lnTo>
                      <a:lnTo>
                        <a:pt x="1795" y="105"/>
                      </a:lnTo>
                      <a:lnTo>
                        <a:pt x="1795" y="101"/>
                      </a:lnTo>
                      <a:lnTo>
                        <a:pt x="1796" y="101"/>
                      </a:lnTo>
                      <a:lnTo>
                        <a:pt x="1796" y="101"/>
                      </a:lnTo>
                      <a:lnTo>
                        <a:pt x="1796" y="104"/>
                      </a:lnTo>
                      <a:lnTo>
                        <a:pt x="1796" y="104"/>
                      </a:lnTo>
                      <a:lnTo>
                        <a:pt x="1797" y="104"/>
                      </a:lnTo>
                      <a:lnTo>
                        <a:pt x="1797" y="101"/>
                      </a:lnTo>
                      <a:lnTo>
                        <a:pt x="1797" y="104"/>
                      </a:lnTo>
                      <a:lnTo>
                        <a:pt x="1797" y="103"/>
                      </a:lnTo>
                      <a:lnTo>
                        <a:pt x="1798" y="103"/>
                      </a:lnTo>
                      <a:lnTo>
                        <a:pt x="1798" y="100"/>
                      </a:lnTo>
                      <a:lnTo>
                        <a:pt x="1798" y="104"/>
                      </a:lnTo>
                      <a:lnTo>
                        <a:pt x="1798" y="102"/>
                      </a:lnTo>
                      <a:lnTo>
                        <a:pt x="1799" y="102"/>
                      </a:lnTo>
                      <a:lnTo>
                        <a:pt x="1799" y="100"/>
                      </a:lnTo>
                      <a:lnTo>
                        <a:pt x="1799" y="104"/>
                      </a:lnTo>
                      <a:lnTo>
                        <a:pt x="1799" y="103"/>
                      </a:lnTo>
                      <a:lnTo>
                        <a:pt x="1800" y="103"/>
                      </a:lnTo>
                      <a:lnTo>
                        <a:pt x="1800" y="101"/>
                      </a:lnTo>
                      <a:lnTo>
                        <a:pt x="1800" y="104"/>
                      </a:lnTo>
                      <a:lnTo>
                        <a:pt x="1800" y="104"/>
                      </a:lnTo>
                      <a:lnTo>
                        <a:pt x="1801" y="104"/>
                      </a:lnTo>
                      <a:lnTo>
                        <a:pt x="1801" y="100"/>
                      </a:lnTo>
                      <a:lnTo>
                        <a:pt x="1801" y="103"/>
                      </a:lnTo>
                      <a:lnTo>
                        <a:pt x="1801" y="101"/>
                      </a:lnTo>
                      <a:lnTo>
                        <a:pt x="1802" y="101"/>
                      </a:lnTo>
                      <a:lnTo>
                        <a:pt x="1802" y="100"/>
                      </a:lnTo>
                      <a:lnTo>
                        <a:pt x="1802" y="104"/>
                      </a:lnTo>
                      <a:lnTo>
                        <a:pt x="1802" y="101"/>
                      </a:lnTo>
                      <a:lnTo>
                        <a:pt x="1803" y="101"/>
                      </a:lnTo>
                      <a:lnTo>
                        <a:pt x="1803" y="100"/>
                      </a:lnTo>
                      <a:lnTo>
                        <a:pt x="1803" y="104"/>
                      </a:lnTo>
                      <a:lnTo>
                        <a:pt x="1803" y="101"/>
                      </a:lnTo>
                      <a:lnTo>
                        <a:pt x="1804" y="101"/>
                      </a:lnTo>
                      <a:lnTo>
                        <a:pt x="1804" y="100"/>
                      </a:lnTo>
                      <a:lnTo>
                        <a:pt x="1804" y="103"/>
                      </a:lnTo>
                      <a:lnTo>
                        <a:pt x="1804" y="101"/>
                      </a:lnTo>
                      <a:lnTo>
                        <a:pt x="1805" y="101"/>
                      </a:lnTo>
                      <a:lnTo>
                        <a:pt x="1805" y="100"/>
                      </a:lnTo>
                      <a:lnTo>
                        <a:pt x="1805" y="103"/>
                      </a:lnTo>
                      <a:lnTo>
                        <a:pt x="1805" y="101"/>
                      </a:lnTo>
                      <a:lnTo>
                        <a:pt x="1806" y="101"/>
                      </a:lnTo>
                      <a:lnTo>
                        <a:pt x="1806" y="100"/>
                      </a:lnTo>
                      <a:lnTo>
                        <a:pt x="1806" y="104"/>
                      </a:lnTo>
                      <a:lnTo>
                        <a:pt x="1806" y="100"/>
                      </a:lnTo>
                      <a:lnTo>
                        <a:pt x="1807" y="100"/>
                      </a:lnTo>
                      <a:lnTo>
                        <a:pt x="1807" y="100"/>
                      </a:lnTo>
                      <a:lnTo>
                        <a:pt x="1807" y="104"/>
                      </a:lnTo>
                      <a:lnTo>
                        <a:pt x="1807" y="101"/>
                      </a:lnTo>
                      <a:lnTo>
                        <a:pt x="1808" y="101"/>
                      </a:lnTo>
                      <a:lnTo>
                        <a:pt x="1808" y="100"/>
                      </a:lnTo>
                      <a:lnTo>
                        <a:pt x="1808" y="105"/>
                      </a:lnTo>
                      <a:lnTo>
                        <a:pt x="1808" y="105"/>
                      </a:lnTo>
                      <a:lnTo>
                        <a:pt x="1809" y="105"/>
                      </a:lnTo>
                      <a:lnTo>
                        <a:pt x="1809" y="101"/>
                      </a:lnTo>
                      <a:lnTo>
                        <a:pt x="1809" y="104"/>
                      </a:lnTo>
                      <a:lnTo>
                        <a:pt x="1809" y="103"/>
                      </a:lnTo>
                      <a:lnTo>
                        <a:pt x="1810" y="103"/>
                      </a:lnTo>
                      <a:lnTo>
                        <a:pt x="1810" y="102"/>
                      </a:lnTo>
                      <a:lnTo>
                        <a:pt x="1810" y="105"/>
                      </a:lnTo>
                      <a:lnTo>
                        <a:pt x="1810" y="104"/>
                      </a:lnTo>
                      <a:lnTo>
                        <a:pt x="1811" y="104"/>
                      </a:lnTo>
                      <a:lnTo>
                        <a:pt x="1811" y="100"/>
                      </a:lnTo>
                      <a:lnTo>
                        <a:pt x="1811" y="104"/>
                      </a:lnTo>
                      <a:lnTo>
                        <a:pt x="1811" y="101"/>
                      </a:lnTo>
                      <a:lnTo>
                        <a:pt x="1812" y="101"/>
                      </a:lnTo>
                      <a:lnTo>
                        <a:pt x="1812" y="100"/>
                      </a:lnTo>
                      <a:lnTo>
                        <a:pt x="1812" y="105"/>
                      </a:lnTo>
                      <a:lnTo>
                        <a:pt x="1812" y="103"/>
                      </a:lnTo>
                      <a:lnTo>
                        <a:pt x="1813" y="103"/>
                      </a:lnTo>
                      <a:lnTo>
                        <a:pt x="1813" y="100"/>
                      </a:lnTo>
                      <a:lnTo>
                        <a:pt x="1813" y="104"/>
                      </a:lnTo>
                      <a:lnTo>
                        <a:pt x="1813" y="101"/>
                      </a:lnTo>
                      <a:lnTo>
                        <a:pt x="1814" y="101"/>
                      </a:lnTo>
                      <a:lnTo>
                        <a:pt x="1814" y="101"/>
                      </a:lnTo>
                      <a:lnTo>
                        <a:pt x="1814" y="104"/>
                      </a:lnTo>
                      <a:lnTo>
                        <a:pt x="1814" y="102"/>
                      </a:lnTo>
                      <a:lnTo>
                        <a:pt x="1815" y="102"/>
                      </a:lnTo>
                      <a:lnTo>
                        <a:pt x="1815" y="100"/>
                      </a:lnTo>
                      <a:lnTo>
                        <a:pt x="1815" y="103"/>
                      </a:lnTo>
                      <a:lnTo>
                        <a:pt x="1815" y="103"/>
                      </a:lnTo>
                      <a:lnTo>
                        <a:pt x="1816" y="103"/>
                      </a:lnTo>
                      <a:lnTo>
                        <a:pt x="1816" y="101"/>
                      </a:lnTo>
                      <a:lnTo>
                        <a:pt x="1816" y="104"/>
                      </a:lnTo>
                      <a:lnTo>
                        <a:pt x="1816" y="103"/>
                      </a:lnTo>
                      <a:lnTo>
                        <a:pt x="1817" y="103"/>
                      </a:lnTo>
                      <a:lnTo>
                        <a:pt x="1817" y="100"/>
                      </a:lnTo>
                      <a:lnTo>
                        <a:pt x="1817" y="104"/>
                      </a:lnTo>
                      <a:lnTo>
                        <a:pt x="1817" y="100"/>
                      </a:lnTo>
                      <a:lnTo>
                        <a:pt x="1818" y="100"/>
                      </a:lnTo>
                      <a:lnTo>
                        <a:pt x="1818" y="100"/>
                      </a:lnTo>
                      <a:lnTo>
                        <a:pt x="1818" y="104"/>
                      </a:lnTo>
                      <a:lnTo>
                        <a:pt x="1818" y="103"/>
                      </a:lnTo>
                      <a:lnTo>
                        <a:pt x="1819" y="103"/>
                      </a:lnTo>
                      <a:lnTo>
                        <a:pt x="1819" y="100"/>
                      </a:lnTo>
                      <a:lnTo>
                        <a:pt x="1819" y="105"/>
                      </a:lnTo>
                      <a:lnTo>
                        <a:pt x="1819" y="104"/>
                      </a:lnTo>
                      <a:lnTo>
                        <a:pt x="1820" y="104"/>
                      </a:lnTo>
                      <a:lnTo>
                        <a:pt x="1820" y="101"/>
                      </a:lnTo>
                      <a:lnTo>
                        <a:pt x="1820" y="104"/>
                      </a:lnTo>
                      <a:lnTo>
                        <a:pt x="1820" y="101"/>
                      </a:lnTo>
                      <a:lnTo>
                        <a:pt x="1821" y="101"/>
                      </a:lnTo>
                      <a:lnTo>
                        <a:pt x="1821" y="100"/>
                      </a:lnTo>
                      <a:lnTo>
                        <a:pt x="1821" y="103"/>
                      </a:lnTo>
                      <a:lnTo>
                        <a:pt x="1821" y="101"/>
                      </a:lnTo>
                      <a:lnTo>
                        <a:pt x="1822" y="101"/>
                      </a:lnTo>
                      <a:lnTo>
                        <a:pt x="1822" y="101"/>
                      </a:lnTo>
                      <a:lnTo>
                        <a:pt x="1822" y="104"/>
                      </a:lnTo>
                      <a:lnTo>
                        <a:pt x="1822" y="104"/>
                      </a:lnTo>
                      <a:lnTo>
                        <a:pt x="1823" y="104"/>
                      </a:lnTo>
                      <a:lnTo>
                        <a:pt x="1823" y="102"/>
                      </a:lnTo>
                      <a:lnTo>
                        <a:pt x="1823" y="105"/>
                      </a:lnTo>
                      <a:lnTo>
                        <a:pt x="1823" y="104"/>
                      </a:lnTo>
                      <a:lnTo>
                        <a:pt x="1824" y="104"/>
                      </a:lnTo>
                      <a:lnTo>
                        <a:pt x="1824" y="102"/>
                      </a:lnTo>
                      <a:lnTo>
                        <a:pt x="1824" y="105"/>
                      </a:lnTo>
                      <a:lnTo>
                        <a:pt x="1824" y="105"/>
                      </a:lnTo>
                      <a:lnTo>
                        <a:pt x="1825" y="105"/>
                      </a:lnTo>
                      <a:lnTo>
                        <a:pt x="1825" y="102"/>
                      </a:lnTo>
                      <a:lnTo>
                        <a:pt x="1825" y="105"/>
                      </a:lnTo>
                      <a:lnTo>
                        <a:pt x="1825" y="105"/>
                      </a:lnTo>
                      <a:lnTo>
                        <a:pt x="1826" y="105"/>
                      </a:lnTo>
                      <a:lnTo>
                        <a:pt x="1826" y="103"/>
                      </a:lnTo>
                      <a:lnTo>
                        <a:pt x="1826" y="105"/>
                      </a:lnTo>
                      <a:lnTo>
                        <a:pt x="1826" y="103"/>
                      </a:lnTo>
                      <a:lnTo>
                        <a:pt x="1827" y="103"/>
                      </a:lnTo>
                      <a:lnTo>
                        <a:pt x="1827" y="102"/>
                      </a:lnTo>
                      <a:lnTo>
                        <a:pt x="1827" y="105"/>
                      </a:lnTo>
                      <a:lnTo>
                        <a:pt x="1827" y="104"/>
                      </a:lnTo>
                      <a:lnTo>
                        <a:pt x="1828" y="104"/>
                      </a:lnTo>
                      <a:lnTo>
                        <a:pt x="1828" y="102"/>
                      </a:lnTo>
                      <a:lnTo>
                        <a:pt x="1828" y="106"/>
                      </a:lnTo>
                      <a:lnTo>
                        <a:pt x="1828" y="102"/>
                      </a:lnTo>
                      <a:lnTo>
                        <a:pt x="1829" y="102"/>
                      </a:lnTo>
                      <a:lnTo>
                        <a:pt x="1829" y="101"/>
                      </a:lnTo>
                      <a:lnTo>
                        <a:pt x="1829" y="104"/>
                      </a:lnTo>
                      <a:lnTo>
                        <a:pt x="1829" y="103"/>
                      </a:lnTo>
                      <a:lnTo>
                        <a:pt x="1830" y="103"/>
                      </a:lnTo>
                      <a:lnTo>
                        <a:pt x="1830" y="103"/>
                      </a:lnTo>
                      <a:lnTo>
                        <a:pt x="1830" y="105"/>
                      </a:lnTo>
                      <a:lnTo>
                        <a:pt x="1830" y="103"/>
                      </a:lnTo>
                      <a:lnTo>
                        <a:pt x="1831" y="103"/>
                      </a:lnTo>
                      <a:lnTo>
                        <a:pt x="1831" y="102"/>
                      </a:lnTo>
                      <a:lnTo>
                        <a:pt x="1831" y="105"/>
                      </a:lnTo>
                      <a:lnTo>
                        <a:pt x="1831" y="104"/>
                      </a:lnTo>
                      <a:lnTo>
                        <a:pt x="1832" y="104"/>
                      </a:lnTo>
                      <a:lnTo>
                        <a:pt x="1832" y="102"/>
                      </a:lnTo>
                      <a:lnTo>
                        <a:pt x="1832" y="105"/>
                      </a:lnTo>
                      <a:lnTo>
                        <a:pt x="1832" y="104"/>
                      </a:lnTo>
                      <a:lnTo>
                        <a:pt x="1833" y="104"/>
                      </a:lnTo>
                      <a:lnTo>
                        <a:pt x="1833" y="101"/>
                      </a:lnTo>
                      <a:lnTo>
                        <a:pt x="1833" y="104"/>
                      </a:lnTo>
                      <a:lnTo>
                        <a:pt x="1833" y="101"/>
                      </a:lnTo>
                      <a:lnTo>
                        <a:pt x="1834" y="101"/>
                      </a:lnTo>
                      <a:lnTo>
                        <a:pt x="1834" y="102"/>
                      </a:lnTo>
                      <a:lnTo>
                        <a:pt x="1834" y="105"/>
                      </a:lnTo>
                      <a:lnTo>
                        <a:pt x="1834" y="103"/>
                      </a:lnTo>
                      <a:lnTo>
                        <a:pt x="1835" y="103"/>
                      </a:lnTo>
                      <a:lnTo>
                        <a:pt x="1835" y="102"/>
                      </a:lnTo>
                      <a:lnTo>
                        <a:pt x="1835" y="104"/>
                      </a:lnTo>
                      <a:lnTo>
                        <a:pt x="1835" y="103"/>
                      </a:lnTo>
                      <a:lnTo>
                        <a:pt x="1836" y="103"/>
                      </a:lnTo>
                      <a:lnTo>
                        <a:pt x="1836" y="101"/>
                      </a:lnTo>
                      <a:lnTo>
                        <a:pt x="1836" y="104"/>
                      </a:lnTo>
                      <a:lnTo>
                        <a:pt x="1836" y="103"/>
                      </a:lnTo>
                      <a:lnTo>
                        <a:pt x="1837" y="103"/>
                      </a:lnTo>
                      <a:lnTo>
                        <a:pt x="1837" y="101"/>
                      </a:lnTo>
                      <a:lnTo>
                        <a:pt x="1837" y="105"/>
                      </a:lnTo>
                      <a:lnTo>
                        <a:pt x="1837" y="103"/>
                      </a:lnTo>
                      <a:lnTo>
                        <a:pt x="1838" y="103"/>
                      </a:lnTo>
                      <a:lnTo>
                        <a:pt x="1838" y="101"/>
                      </a:lnTo>
                      <a:lnTo>
                        <a:pt x="1838" y="105"/>
                      </a:lnTo>
                      <a:lnTo>
                        <a:pt x="1838" y="103"/>
                      </a:lnTo>
                      <a:lnTo>
                        <a:pt x="1839" y="103"/>
                      </a:lnTo>
                      <a:lnTo>
                        <a:pt x="1839" y="101"/>
                      </a:lnTo>
                      <a:lnTo>
                        <a:pt x="1839" y="104"/>
                      </a:lnTo>
                      <a:lnTo>
                        <a:pt x="1839" y="104"/>
                      </a:lnTo>
                      <a:lnTo>
                        <a:pt x="1840" y="104"/>
                      </a:lnTo>
                      <a:lnTo>
                        <a:pt x="1840" y="102"/>
                      </a:lnTo>
                      <a:lnTo>
                        <a:pt x="1840" y="105"/>
                      </a:lnTo>
                      <a:lnTo>
                        <a:pt x="1840" y="104"/>
                      </a:lnTo>
                      <a:lnTo>
                        <a:pt x="1841" y="104"/>
                      </a:lnTo>
                      <a:lnTo>
                        <a:pt x="1841" y="102"/>
                      </a:lnTo>
                      <a:lnTo>
                        <a:pt x="1841" y="106"/>
                      </a:lnTo>
                      <a:lnTo>
                        <a:pt x="1841" y="103"/>
                      </a:lnTo>
                      <a:lnTo>
                        <a:pt x="1842" y="103"/>
                      </a:lnTo>
                      <a:lnTo>
                        <a:pt x="1842" y="102"/>
                      </a:lnTo>
                      <a:lnTo>
                        <a:pt x="1842" y="105"/>
                      </a:lnTo>
                      <a:lnTo>
                        <a:pt x="1842" y="102"/>
                      </a:lnTo>
                      <a:lnTo>
                        <a:pt x="1843" y="102"/>
                      </a:lnTo>
                      <a:lnTo>
                        <a:pt x="1843" y="101"/>
                      </a:lnTo>
                      <a:lnTo>
                        <a:pt x="1843" y="104"/>
                      </a:lnTo>
                      <a:lnTo>
                        <a:pt x="1843" y="103"/>
                      </a:lnTo>
                      <a:lnTo>
                        <a:pt x="1844" y="103"/>
                      </a:lnTo>
                      <a:lnTo>
                        <a:pt x="1844" y="101"/>
                      </a:lnTo>
                      <a:lnTo>
                        <a:pt x="1844" y="105"/>
                      </a:lnTo>
                      <a:lnTo>
                        <a:pt x="1844" y="104"/>
                      </a:lnTo>
                      <a:lnTo>
                        <a:pt x="1845" y="104"/>
                      </a:lnTo>
                      <a:lnTo>
                        <a:pt x="1845" y="102"/>
                      </a:lnTo>
                      <a:lnTo>
                        <a:pt x="1845" y="105"/>
                      </a:lnTo>
                      <a:lnTo>
                        <a:pt x="1845" y="103"/>
                      </a:lnTo>
                      <a:lnTo>
                        <a:pt x="1846" y="103"/>
                      </a:lnTo>
                      <a:lnTo>
                        <a:pt x="1846" y="102"/>
                      </a:lnTo>
                      <a:lnTo>
                        <a:pt x="1846" y="104"/>
                      </a:lnTo>
                      <a:lnTo>
                        <a:pt x="1846" y="103"/>
                      </a:lnTo>
                      <a:lnTo>
                        <a:pt x="1847" y="103"/>
                      </a:lnTo>
                      <a:lnTo>
                        <a:pt x="1847" y="101"/>
                      </a:lnTo>
                      <a:lnTo>
                        <a:pt x="1847" y="106"/>
                      </a:lnTo>
                      <a:lnTo>
                        <a:pt x="1847" y="104"/>
                      </a:lnTo>
                      <a:lnTo>
                        <a:pt x="1848" y="104"/>
                      </a:lnTo>
                      <a:lnTo>
                        <a:pt x="1848" y="101"/>
                      </a:lnTo>
                      <a:lnTo>
                        <a:pt x="1848" y="105"/>
                      </a:lnTo>
                      <a:lnTo>
                        <a:pt x="1848" y="104"/>
                      </a:lnTo>
                      <a:lnTo>
                        <a:pt x="1849" y="104"/>
                      </a:lnTo>
                      <a:lnTo>
                        <a:pt x="1849" y="100"/>
                      </a:lnTo>
                      <a:lnTo>
                        <a:pt x="1849" y="104"/>
                      </a:lnTo>
                      <a:lnTo>
                        <a:pt x="1849" y="103"/>
                      </a:lnTo>
                      <a:lnTo>
                        <a:pt x="1850" y="103"/>
                      </a:lnTo>
                      <a:lnTo>
                        <a:pt x="1850" y="101"/>
                      </a:lnTo>
                      <a:lnTo>
                        <a:pt x="1850" y="105"/>
                      </a:lnTo>
                      <a:lnTo>
                        <a:pt x="1850" y="101"/>
                      </a:lnTo>
                      <a:lnTo>
                        <a:pt x="1851" y="101"/>
                      </a:lnTo>
                      <a:lnTo>
                        <a:pt x="1851" y="101"/>
                      </a:lnTo>
                      <a:lnTo>
                        <a:pt x="1851" y="105"/>
                      </a:lnTo>
                      <a:lnTo>
                        <a:pt x="1851" y="104"/>
                      </a:lnTo>
                      <a:lnTo>
                        <a:pt x="1852" y="104"/>
                      </a:lnTo>
                      <a:lnTo>
                        <a:pt x="1852" y="101"/>
                      </a:lnTo>
                      <a:lnTo>
                        <a:pt x="1852" y="106"/>
                      </a:lnTo>
                      <a:lnTo>
                        <a:pt x="1852" y="104"/>
                      </a:lnTo>
                      <a:lnTo>
                        <a:pt x="1853" y="104"/>
                      </a:lnTo>
                      <a:lnTo>
                        <a:pt x="1853" y="101"/>
                      </a:lnTo>
                      <a:lnTo>
                        <a:pt x="1853" y="105"/>
                      </a:lnTo>
                      <a:lnTo>
                        <a:pt x="1853" y="103"/>
                      </a:lnTo>
                      <a:lnTo>
                        <a:pt x="1854" y="103"/>
                      </a:lnTo>
                      <a:lnTo>
                        <a:pt x="1854" y="101"/>
                      </a:lnTo>
                      <a:lnTo>
                        <a:pt x="1854" y="104"/>
                      </a:lnTo>
                      <a:lnTo>
                        <a:pt x="1854" y="103"/>
                      </a:lnTo>
                      <a:lnTo>
                        <a:pt x="1855" y="103"/>
                      </a:lnTo>
                      <a:lnTo>
                        <a:pt x="1855" y="103"/>
                      </a:lnTo>
                      <a:lnTo>
                        <a:pt x="1855" y="106"/>
                      </a:lnTo>
                      <a:lnTo>
                        <a:pt x="1855" y="104"/>
                      </a:lnTo>
                      <a:lnTo>
                        <a:pt x="1856" y="104"/>
                      </a:lnTo>
                      <a:lnTo>
                        <a:pt x="1856" y="101"/>
                      </a:lnTo>
                      <a:lnTo>
                        <a:pt x="1856" y="105"/>
                      </a:lnTo>
                      <a:lnTo>
                        <a:pt x="1856" y="104"/>
                      </a:lnTo>
                      <a:lnTo>
                        <a:pt x="1857" y="104"/>
                      </a:lnTo>
                      <a:lnTo>
                        <a:pt x="1857" y="101"/>
                      </a:lnTo>
                      <a:lnTo>
                        <a:pt x="1857" y="105"/>
                      </a:lnTo>
                      <a:lnTo>
                        <a:pt x="1857" y="104"/>
                      </a:lnTo>
                      <a:lnTo>
                        <a:pt x="1858" y="104"/>
                      </a:lnTo>
                      <a:lnTo>
                        <a:pt x="1858" y="101"/>
                      </a:lnTo>
                      <a:lnTo>
                        <a:pt x="1858" y="104"/>
                      </a:lnTo>
                      <a:lnTo>
                        <a:pt x="1858" y="103"/>
                      </a:lnTo>
                      <a:lnTo>
                        <a:pt x="1859" y="103"/>
                      </a:lnTo>
                      <a:lnTo>
                        <a:pt x="1859" y="101"/>
                      </a:lnTo>
                      <a:lnTo>
                        <a:pt x="1859" y="105"/>
                      </a:lnTo>
                      <a:lnTo>
                        <a:pt x="1859" y="103"/>
                      </a:lnTo>
                      <a:lnTo>
                        <a:pt x="1860" y="103"/>
                      </a:lnTo>
                      <a:lnTo>
                        <a:pt x="1860" y="103"/>
                      </a:lnTo>
                      <a:lnTo>
                        <a:pt x="1860" y="107"/>
                      </a:lnTo>
                      <a:lnTo>
                        <a:pt x="1860" y="105"/>
                      </a:lnTo>
                      <a:lnTo>
                        <a:pt x="1861" y="105"/>
                      </a:lnTo>
                      <a:lnTo>
                        <a:pt x="1861" y="101"/>
                      </a:lnTo>
                      <a:lnTo>
                        <a:pt x="1861" y="105"/>
                      </a:lnTo>
                      <a:lnTo>
                        <a:pt x="1861" y="103"/>
                      </a:lnTo>
                      <a:lnTo>
                        <a:pt x="1862" y="103"/>
                      </a:lnTo>
                      <a:lnTo>
                        <a:pt x="1862" y="102"/>
                      </a:lnTo>
                      <a:lnTo>
                        <a:pt x="1862" y="106"/>
                      </a:lnTo>
                      <a:lnTo>
                        <a:pt x="1862" y="103"/>
                      </a:lnTo>
                      <a:lnTo>
                        <a:pt x="1863" y="103"/>
                      </a:lnTo>
                      <a:lnTo>
                        <a:pt x="1863" y="102"/>
                      </a:lnTo>
                      <a:lnTo>
                        <a:pt x="1863" y="104"/>
                      </a:lnTo>
                      <a:lnTo>
                        <a:pt x="1863" y="102"/>
                      </a:lnTo>
                      <a:lnTo>
                        <a:pt x="1864" y="102"/>
                      </a:lnTo>
                      <a:lnTo>
                        <a:pt x="1864" y="101"/>
                      </a:lnTo>
                      <a:lnTo>
                        <a:pt x="1864" y="104"/>
                      </a:lnTo>
                      <a:lnTo>
                        <a:pt x="1864" y="101"/>
                      </a:lnTo>
                      <a:lnTo>
                        <a:pt x="1865" y="101"/>
                      </a:lnTo>
                      <a:lnTo>
                        <a:pt x="1865" y="101"/>
                      </a:lnTo>
                      <a:lnTo>
                        <a:pt x="1865" y="104"/>
                      </a:lnTo>
                      <a:lnTo>
                        <a:pt x="1865" y="103"/>
                      </a:lnTo>
                      <a:lnTo>
                        <a:pt x="1866" y="103"/>
                      </a:lnTo>
                      <a:lnTo>
                        <a:pt x="1866" y="100"/>
                      </a:lnTo>
                      <a:lnTo>
                        <a:pt x="1866" y="105"/>
                      </a:lnTo>
                      <a:lnTo>
                        <a:pt x="1866" y="103"/>
                      </a:lnTo>
                      <a:lnTo>
                        <a:pt x="1867" y="103"/>
                      </a:lnTo>
                      <a:lnTo>
                        <a:pt x="1867" y="101"/>
                      </a:lnTo>
                      <a:lnTo>
                        <a:pt x="1867" y="105"/>
                      </a:lnTo>
                      <a:lnTo>
                        <a:pt x="1867" y="103"/>
                      </a:lnTo>
                      <a:lnTo>
                        <a:pt x="1868" y="103"/>
                      </a:lnTo>
                      <a:lnTo>
                        <a:pt x="1868" y="100"/>
                      </a:lnTo>
                      <a:lnTo>
                        <a:pt x="1868" y="107"/>
                      </a:lnTo>
                      <a:lnTo>
                        <a:pt x="1868" y="103"/>
                      </a:lnTo>
                      <a:lnTo>
                        <a:pt x="1869" y="103"/>
                      </a:lnTo>
                      <a:lnTo>
                        <a:pt x="1869" y="101"/>
                      </a:lnTo>
                      <a:lnTo>
                        <a:pt x="1869" y="103"/>
                      </a:lnTo>
                      <a:lnTo>
                        <a:pt x="1869" y="101"/>
                      </a:lnTo>
                      <a:lnTo>
                        <a:pt x="1870" y="101"/>
                      </a:lnTo>
                      <a:lnTo>
                        <a:pt x="1870" y="101"/>
                      </a:lnTo>
                      <a:lnTo>
                        <a:pt x="1870" y="106"/>
                      </a:lnTo>
                      <a:lnTo>
                        <a:pt x="1870" y="101"/>
                      </a:lnTo>
                      <a:lnTo>
                        <a:pt x="1871" y="101"/>
                      </a:lnTo>
                      <a:lnTo>
                        <a:pt x="1871" y="100"/>
                      </a:lnTo>
                      <a:lnTo>
                        <a:pt x="1871" y="103"/>
                      </a:lnTo>
                      <a:lnTo>
                        <a:pt x="1871" y="101"/>
                      </a:lnTo>
                      <a:lnTo>
                        <a:pt x="1872" y="101"/>
                      </a:lnTo>
                      <a:lnTo>
                        <a:pt x="1872" y="100"/>
                      </a:lnTo>
                      <a:lnTo>
                        <a:pt x="1872" y="104"/>
                      </a:lnTo>
                      <a:lnTo>
                        <a:pt x="1872" y="101"/>
                      </a:lnTo>
                      <a:lnTo>
                        <a:pt x="1873" y="101"/>
                      </a:lnTo>
                      <a:lnTo>
                        <a:pt x="1873" y="100"/>
                      </a:lnTo>
                      <a:lnTo>
                        <a:pt x="1873" y="105"/>
                      </a:lnTo>
                      <a:lnTo>
                        <a:pt x="1873" y="102"/>
                      </a:lnTo>
                      <a:lnTo>
                        <a:pt x="1874" y="102"/>
                      </a:lnTo>
                      <a:lnTo>
                        <a:pt x="1874" y="99"/>
                      </a:lnTo>
                      <a:lnTo>
                        <a:pt x="1874" y="103"/>
                      </a:lnTo>
                      <a:lnTo>
                        <a:pt x="1874" y="103"/>
                      </a:lnTo>
                      <a:lnTo>
                        <a:pt x="1875" y="103"/>
                      </a:lnTo>
                      <a:lnTo>
                        <a:pt x="1875" y="100"/>
                      </a:lnTo>
                      <a:lnTo>
                        <a:pt x="1875" y="104"/>
                      </a:lnTo>
                      <a:lnTo>
                        <a:pt x="1875" y="103"/>
                      </a:lnTo>
                      <a:lnTo>
                        <a:pt x="1876" y="103"/>
                      </a:lnTo>
                      <a:lnTo>
                        <a:pt x="1876" y="98"/>
                      </a:lnTo>
                      <a:lnTo>
                        <a:pt x="1876" y="103"/>
                      </a:lnTo>
                      <a:lnTo>
                        <a:pt x="1876" y="103"/>
                      </a:lnTo>
                      <a:lnTo>
                        <a:pt x="1877" y="103"/>
                      </a:lnTo>
                      <a:lnTo>
                        <a:pt x="1877" y="100"/>
                      </a:lnTo>
                      <a:lnTo>
                        <a:pt x="1877" y="103"/>
                      </a:lnTo>
                      <a:lnTo>
                        <a:pt x="1877" y="103"/>
                      </a:lnTo>
                      <a:lnTo>
                        <a:pt x="1878" y="103"/>
                      </a:lnTo>
                      <a:lnTo>
                        <a:pt x="1878" y="99"/>
                      </a:lnTo>
                      <a:lnTo>
                        <a:pt x="1878" y="104"/>
                      </a:lnTo>
                      <a:lnTo>
                        <a:pt x="1878" y="101"/>
                      </a:lnTo>
                      <a:lnTo>
                        <a:pt x="1879" y="101"/>
                      </a:lnTo>
                      <a:lnTo>
                        <a:pt x="1879" y="98"/>
                      </a:lnTo>
                      <a:lnTo>
                        <a:pt x="1879" y="102"/>
                      </a:lnTo>
                      <a:lnTo>
                        <a:pt x="1879" y="101"/>
                      </a:lnTo>
                      <a:lnTo>
                        <a:pt x="1880" y="101"/>
                      </a:lnTo>
                      <a:lnTo>
                        <a:pt x="1880" y="100"/>
                      </a:lnTo>
                      <a:lnTo>
                        <a:pt x="1880" y="103"/>
                      </a:lnTo>
                      <a:lnTo>
                        <a:pt x="1880" y="103"/>
                      </a:lnTo>
                      <a:lnTo>
                        <a:pt x="1881" y="103"/>
                      </a:lnTo>
                      <a:lnTo>
                        <a:pt x="1881" y="100"/>
                      </a:lnTo>
                      <a:lnTo>
                        <a:pt x="1881" y="104"/>
                      </a:lnTo>
                      <a:lnTo>
                        <a:pt x="1881" y="103"/>
                      </a:lnTo>
                      <a:lnTo>
                        <a:pt x="1882" y="103"/>
                      </a:lnTo>
                      <a:lnTo>
                        <a:pt x="1882" y="100"/>
                      </a:lnTo>
                      <a:lnTo>
                        <a:pt x="1882" y="104"/>
                      </a:lnTo>
                      <a:lnTo>
                        <a:pt x="1882" y="103"/>
                      </a:lnTo>
                      <a:lnTo>
                        <a:pt x="1883" y="103"/>
                      </a:lnTo>
                      <a:lnTo>
                        <a:pt x="1883" y="101"/>
                      </a:lnTo>
                      <a:lnTo>
                        <a:pt x="1883" y="105"/>
                      </a:lnTo>
                      <a:lnTo>
                        <a:pt x="1883" y="102"/>
                      </a:lnTo>
                      <a:lnTo>
                        <a:pt x="1884" y="102"/>
                      </a:lnTo>
                      <a:lnTo>
                        <a:pt x="1884" y="98"/>
                      </a:lnTo>
                      <a:lnTo>
                        <a:pt x="1884" y="102"/>
                      </a:lnTo>
                      <a:lnTo>
                        <a:pt x="1884" y="102"/>
                      </a:lnTo>
                      <a:lnTo>
                        <a:pt x="1885" y="102"/>
                      </a:lnTo>
                      <a:lnTo>
                        <a:pt x="1885" y="98"/>
                      </a:lnTo>
                      <a:lnTo>
                        <a:pt x="1885" y="103"/>
                      </a:lnTo>
                      <a:lnTo>
                        <a:pt x="1885" y="101"/>
                      </a:lnTo>
                      <a:lnTo>
                        <a:pt x="1886" y="101"/>
                      </a:lnTo>
                      <a:lnTo>
                        <a:pt x="1886" y="100"/>
                      </a:lnTo>
                      <a:lnTo>
                        <a:pt x="1886" y="104"/>
                      </a:lnTo>
                      <a:lnTo>
                        <a:pt x="1886" y="101"/>
                      </a:lnTo>
                      <a:lnTo>
                        <a:pt x="1887" y="101"/>
                      </a:lnTo>
                      <a:lnTo>
                        <a:pt x="1887" y="98"/>
                      </a:lnTo>
                      <a:lnTo>
                        <a:pt x="1887" y="103"/>
                      </a:lnTo>
                      <a:lnTo>
                        <a:pt x="1887" y="102"/>
                      </a:lnTo>
                      <a:lnTo>
                        <a:pt x="1888" y="102"/>
                      </a:lnTo>
                      <a:lnTo>
                        <a:pt x="1888" y="99"/>
                      </a:lnTo>
                      <a:lnTo>
                        <a:pt x="1888" y="104"/>
                      </a:lnTo>
                      <a:lnTo>
                        <a:pt x="1888" y="102"/>
                      </a:lnTo>
                      <a:lnTo>
                        <a:pt x="1889" y="102"/>
                      </a:lnTo>
                      <a:lnTo>
                        <a:pt x="1889" y="98"/>
                      </a:lnTo>
                      <a:lnTo>
                        <a:pt x="1889" y="103"/>
                      </a:lnTo>
                      <a:lnTo>
                        <a:pt x="1889" y="101"/>
                      </a:lnTo>
                      <a:lnTo>
                        <a:pt x="1890" y="101"/>
                      </a:lnTo>
                      <a:lnTo>
                        <a:pt x="1890" y="98"/>
                      </a:lnTo>
                      <a:lnTo>
                        <a:pt x="1890" y="101"/>
                      </a:lnTo>
                      <a:lnTo>
                        <a:pt x="1890" y="99"/>
                      </a:lnTo>
                      <a:lnTo>
                        <a:pt x="1891" y="99"/>
                      </a:lnTo>
                      <a:lnTo>
                        <a:pt x="1891" y="98"/>
                      </a:lnTo>
                      <a:lnTo>
                        <a:pt x="1891" y="103"/>
                      </a:lnTo>
                      <a:lnTo>
                        <a:pt x="1891" y="100"/>
                      </a:lnTo>
                      <a:lnTo>
                        <a:pt x="1892" y="100"/>
                      </a:lnTo>
                      <a:lnTo>
                        <a:pt x="1892" y="98"/>
                      </a:lnTo>
                      <a:lnTo>
                        <a:pt x="1892" y="103"/>
                      </a:lnTo>
                      <a:lnTo>
                        <a:pt x="1892" y="101"/>
                      </a:lnTo>
                      <a:lnTo>
                        <a:pt x="1893" y="101"/>
                      </a:lnTo>
                      <a:lnTo>
                        <a:pt x="1893" y="99"/>
                      </a:lnTo>
                      <a:lnTo>
                        <a:pt x="1893" y="101"/>
                      </a:lnTo>
                      <a:lnTo>
                        <a:pt x="1893" y="100"/>
                      </a:lnTo>
                      <a:lnTo>
                        <a:pt x="1894" y="100"/>
                      </a:lnTo>
                      <a:lnTo>
                        <a:pt x="1894" y="99"/>
                      </a:lnTo>
                      <a:lnTo>
                        <a:pt x="1894" y="102"/>
                      </a:lnTo>
                      <a:lnTo>
                        <a:pt x="1894" y="100"/>
                      </a:lnTo>
                      <a:lnTo>
                        <a:pt x="1895" y="100"/>
                      </a:lnTo>
                      <a:lnTo>
                        <a:pt x="1895" y="98"/>
                      </a:lnTo>
                      <a:lnTo>
                        <a:pt x="1895" y="101"/>
                      </a:lnTo>
                      <a:lnTo>
                        <a:pt x="1895" y="101"/>
                      </a:lnTo>
                      <a:lnTo>
                        <a:pt x="1896" y="101"/>
                      </a:lnTo>
                      <a:lnTo>
                        <a:pt x="1896" y="99"/>
                      </a:lnTo>
                      <a:lnTo>
                        <a:pt x="1896" y="103"/>
                      </a:lnTo>
                      <a:lnTo>
                        <a:pt x="1896" y="101"/>
                      </a:lnTo>
                      <a:lnTo>
                        <a:pt x="1897" y="101"/>
                      </a:lnTo>
                      <a:lnTo>
                        <a:pt x="1897" y="99"/>
                      </a:lnTo>
                      <a:lnTo>
                        <a:pt x="1897" y="103"/>
                      </a:lnTo>
                      <a:lnTo>
                        <a:pt x="1897" y="100"/>
                      </a:lnTo>
                      <a:lnTo>
                        <a:pt x="1898" y="100"/>
                      </a:lnTo>
                      <a:lnTo>
                        <a:pt x="1898" y="99"/>
                      </a:lnTo>
                      <a:lnTo>
                        <a:pt x="1898" y="103"/>
                      </a:lnTo>
                      <a:lnTo>
                        <a:pt x="1898" y="99"/>
                      </a:lnTo>
                      <a:lnTo>
                        <a:pt x="1899" y="99"/>
                      </a:lnTo>
                      <a:lnTo>
                        <a:pt x="1899" y="99"/>
                      </a:lnTo>
                      <a:lnTo>
                        <a:pt x="1899" y="103"/>
                      </a:lnTo>
                      <a:lnTo>
                        <a:pt x="1899" y="103"/>
                      </a:lnTo>
                      <a:lnTo>
                        <a:pt x="1900" y="103"/>
                      </a:lnTo>
                      <a:lnTo>
                        <a:pt x="1900" y="98"/>
                      </a:lnTo>
                      <a:lnTo>
                        <a:pt x="1900" y="103"/>
                      </a:lnTo>
                      <a:lnTo>
                        <a:pt x="1900" y="101"/>
                      </a:lnTo>
                      <a:lnTo>
                        <a:pt x="1901" y="101"/>
                      </a:lnTo>
                      <a:lnTo>
                        <a:pt x="1901" y="98"/>
                      </a:lnTo>
                      <a:lnTo>
                        <a:pt x="1901" y="103"/>
                      </a:lnTo>
                      <a:lnTo>
                        <a:pt x="1901" y="98"/>
                      </a:lnTo>
                      <a:lnTo>
                        <a:pt x="1902" y="98"/>
                      </a:lnTo>
                      <a:lnTo>
                        <a:pt x="1902" y="98"/>
                      </a:lnTo>
                      <a:lnTo>
                        <a:pt x="1902" y="101"/>
                      </a:lnTo>
                      <a:lnTo>
                        <a:pt x="1902" y="101"/>
                      </a:lnTo>
                      <a:lnTo>
                        <a:pt x="1903" y="101"/>
                      </a:lnTo>
                      <a:lnTo>
                        <a:pt x="1903" y="100"/>
                      </a:lnTo>
                      <a:lnTo>
                        <a:pt x="1903" y="103"/>
                      </a:lnTo>
                      <a:lnTo>
                        <a:pt x="1903" y="103"/>
                      </a:lnTo>
                      <a:lnTo>
                        <a:pt x="1904" y="103"/>
                      </a:lnTo>
                      <a:lnTo>
                        <a:pt x="1904" y="98"/>
                      </a:lnTo>
                      <a:lnTo>
                        <a:pt x="1904" y="104"/>
                      </a:lnTo>
                      <a:lnTo>
                        <a:pt x="1904" y="100"/>
                      </a:lnTo>
                      <a:lnTo>
                        <a:pt x="1905" y="100"/>
                      </a:lnTo>
                      <a:lnTo>
                        <a:pt x="1905" y="100"/>
                      </a:lnTo>
                      <a:lnTo>
                        <a:pt x="1905" y="102"/>
                      </a:lnTo>
                      <a:lnTo>
                        <a:pt x="1905" y="101"/>
                      </a:lnTo>
                      <a:lnTo>
                        <a:pt x="1906" y="101"/>
                      </a:lnTo>
                      <a:lnTo>
                        <a:pt x="1906" y="98"/>
                      </a:lnTo>
                      <a:lnTo>
                        <a:pt x="1906" y="103"/>
                      </a:lnTo>
                      <a:lnTo>
                        <a:pt x="1906" y="100"/>
                      </a:lnTo>
                      <a:lnTo>
                        <a:pt x="1907" y="100"/>
                      </a:lnTo>
                      <a:lnTo>
                        <a:pt x="1907" y="98"/>
                      </a:lnTo>
                      <a:lnTo>
                        <a:pt x="1907" y="101"/>
                      </a:lnTo>
                      <a:lnTo>
                        <a:pt x="1907" y="101"/>
                      </a:lnTo>
                      <a:lnTo>
                        <a:pt x="1908" y="101"/>
                      </a:lnTo>
                      <a:lnTo>
                        <a:pt x="1908" y="100"/>
                      </a:lnTo>
                      <a:lnTo>
                        <a:pt x="1908" y="103"/>
                      </a:lnTo>
                      <a:lnTo>
                        <a:pt x="1908" y="101"/>
                      </a:lnTo>
                      <a:lnTo>
                        <a:pt x="1909" y="101"/>
                      </a:lnTo>
                      <a:lnTo>
                        <a:pt x="1909" y="100"/>
                      </a:lnTo>
                      <a:lnTo>
                        <a:pt x="1909" y="104"/>
                      </a:lnTo>
                      <a:lnTo>
                        <a:pt x="1909" y="100"/>
                      </a:lnTo>
                      <a:lnTo>
                        <a:pt x="1910" y="100"/>
                      </a:lnTo>
                      <a:lnTo>
                        <a:pt x="1910" y="99"/>
                      </a:lnTo>
                      <a:lnTo>
                        <a:pt x="1910" y="104"/>
                      </a:lnTo>
                      <a:lnTo>
                        <a:pt x="1910" y="102"/>
                      </a:lnTo>
                      <a:lnTo>
                        <a:pt x="1911" y="102"/>
                      </a:lnTo>
                      <a:lnTo>
                        <a:pt x="1911" y="100"/>
                      </a:lnTo>
                      <a:lnTo>
                        <a:pt x="1911" y="105"/>
                      </a:lnTo>
                      <a:lnTo>
                        <a:pt x="1911" y="102"/>
                      </a:lnTo>
                      <a:lnTo>
                        <a:pt x="1912" y="102"/>
                      </a:lnTo>
                      <a:lnTo>
                        <a:pt x="1912" y="99"/>
                      </a:lnTo>
                      <a:lnTo>
                        <a:pt x="1912" y="104"/>
                      </a:lnTo>
                      <a:lnTo>
                        <a:pt x="1912" y="102"/>
                      </a:lnTo>
                      <a:lnTo>
                        <a:pt x="1913" y="102"/>
                      </a:lnTo>
                      <a:lnTo>
                        <a:pt x="1913" y="99"/>
                      </a:lnTo>
                      <a:lnTo>
                        <a:pt x="1913" y="104"/>
                      </a:lnTo>
                      <a:lnTo>
                        <a:pt x="1913" y="102"/>
                      </a:lnTo>
                      <a:lnTo>
                        <a:pt x="1914" y="102"/>
                      </a:lnTo>
                      <a:lnTo>
                        <a:pt x="1914" y="100"/>
                      </a:lnTo>
                      <a:lnTo>
                        <a:pt x="1914" y="104"/>
                      </a:lnTo>
                      <a:lnTo>
                        <a:pt x="1914" y="104"/>
                      </a:lnTo>
                      <a:lnTo>
                        <a:pt x="1915" y="104"/>
                      </a:lnTo>
                      <a:lnTo>
                        <a:pt x="1915" y="101"/>
                      </a:lnTo>
                      <a:lnTo>
                        <a:pt x="1915" y="105"/>
                      </a:lnTo>
                      <a:lnTo>
                        <a:pt x="1915" y="103"/>
                      </a:lnTo>
                      <a:lnTo>
                        <a:pt x="1916" y="103"/>
                      </a:lnTo>
                      <a:lnTo>
                        <a:pt x="1916" y="101"/>
                      </a:lnTo>
                      <a:lnTo>
                        <a:pt x="1916" y="104"/>
                      </a:lnTo>
                      <a:lnTo>
                        <a:pt x="1916" y="104"/>
                      </a:lnTo>
                      <a:lnTo>
                        <a:pt x="1917" y="104"/>
                      </a:lnTo>
                      <a:lnTo>
                        <a:pt x="1917" y="101"/>
                      </a:lnTo>
                      <a:lnTo>
                        <a:pt x="1917" y="104"/>
                      </a:lnTo>
                      <a:lnTo>
                        <a:pt x="1917" y="103"/>
                      </a:lnTo>
                      <a:lnTo>
                        <a:pt x="1918" y="103"/>
                      </a:lnTo>
                      <a:lnTo>
                        <a:pt x="1918" y="102"/>
                      </a:lnTo>
                      <a:lnTo>
                        <a:pt x="1918" y="104"/>
                      </a:lnTo>
                      <a:lnTo>
                        <a:pt x="1918" y="104"/>
                      </a:lnTo>
                      <a:lnTo>
                        <a:pt x="1919" y="104"/>
                      </a:lnTo>
                      <a:lnTo>
                        <a:pt x="1919" y="100"/>
                      </a:lnTo>
                      <a:lnTo>
                        <a:pt x="1919" y="104"/>
                      </a:lnTo>
                      <a:lnTo>
                        <a:pt x="1919" y="103"/>
                      </a:lnTo>
                      <a:lnTo>
                        <a:pt x="1920" y="103"/>
                      </a:lnTo>
                      <a:lnTo>
                        <a:pt x="1920" y="101"/>
                      </a:lnTo>
                      <a:lnTo>
                        <a:pt x="1920" y="106"/>
                      </a:lnTo>
                      <a:lnTo>
                        <a:pt x="1920" y="103"/>
                      </a:lnTo>
                      <a:lnTo>
                        <a:pt x="1921" y="103"/>
                      </a:lnTo>
                      <a:lnTo>
                        <a:pt x="1921" y="101"/>
                      </a:lnTo>
                      <a:lnTo>
                        <a:pt x="1921" y="105"/>
                      </a:lnTo>
                      <a:lnTo>
                        <a:pt x="1921" y="103"/>
                      </a:lnTo>
                      <a:lnTo>
                        <a:pt x="1922" y="103"/>
                      </a:lnTo>
                      <a:lnTo>
                        <a:pt x="1922" y="101"/>
                      </a:lnTo>
                      <a:lnTo>
                        <a:pt x="1922" y="105"/>
                      </a:lnTo>
                      <a:lnTo>
                        <a:pt x="1922" y="104"/>
                      </a:lnTo>
                      <a:lnTo>
                        <a:pt x="1923" y="104"/>
                      </a:lnTo>
                      <a:lnTo>
                        <a:pt x="1923" y="101"/>
                      </a:lnTo>
                      <a:lnTo>
                        <a:pt x="1923" y="104"/>
                      </a:lnTo>
                      <a:lnTo>
                        <a:pt x="1923" y="104"/>
                      </a:lnTo>
                      <a:lnTo>
                        <a:pt x="1924" y="104"/>
                      </a:lnTo>
                      <a:lnTo>
                        <a:pt x="1924" y="101"/>
                      </a:lnTo>
                      <a:lnTo>
                        <a:pt x="1924" y="104"/>
                      </a:lnTo>
                      <a:lnTo>
                        <a:pt x="1924" y="103"/>
                      </a:lnTo>
                      <a:lnTo>
                        <a:pt x="1925" y="103"/>
                      </a:lnTo>
                      <a:lnTo>
                        <a:pt x="1925" y="102"/>
                      </a:lnTo>
                      <a:lnTo>
                        <a:pt x="1925" y="105"/>
                      </a:lnTo>
                      <a:lnTo>
                        <a:pt x="1925" y="102"/>
                      </a:lnTo>
                      <a:lnTo>
                        <a:pt x="1926" y="102"/>
                      </a:lnTo>
                      <a:lnTo>
                        <a:pt x="1926" y="101"/>
                      </a:lnTo>
                      <a:lnTo>
                        <a:pt x="1926" y="104"/>
                      </a:lnTo>
                      <a:lnTo>
                        <a:pt x="1926" y="103"/>
                      </a:lnTo>
                      <a:lnTo>
                        <a:pt x="1927" y="103"/>
                      </a:lnTo>
                      <a:lnTo>
                        <a:pt x="1927" y="100"/>
                      </a:lnTo>
                      <a:lnTo>
                        <a:pt x="1927" y="104"/>
                      </a:lnTo>
                      <a:lnTo>
                        <a:pt x="1927" y="104"/>
                      </a:lnTo>
                      <a:lnTo>
                        <a:pt x="1928" y="104"/>
                      </a:lnTo>
                      <a:lnTo>
                        <a:pt x="1928" y="100"/>
                      </a:lnTo>
                      <a:lnTo>
                        <a:pt x="1928" y="105"/>
                      </a:lnTo>
                      <a:lnTo>
                        <a:pt x="1928" y="103"/>
                      </a:lnTo>
                      <a:lnTo>
                        <a:pt x="1929" y="103"/>
                      </a:lnTo>
                      <a:lnTo>
                        <a:pt x="1929" y="100"/>
                      </a:lnTo>
                      <a:lnTo>
                        <a:pt x="1929" y="105"/>
                      </a:lnTo>
                      <a:lnTo>
                        <a:pt x="1929" y="100"/>
                      </a:lnTo>
                      <a:lnTo>
                        <a:pt x="1930" y="100"/>
                      </a:lnTo>
                      <a:lnTo>
                        <a:pt x="1930" y="100"/>
                      </a:lnTo>
                      <a:lnTo>
                        <a:pt x="1930" y="105"/>
                      </a:lnTo>
                      <a:lnTo>
                        <a:pt x="1930" y="103"/>
                      </a:lnTo>
                      <a:lnTo>
                        <a:pt x="1931" y="103"/>
                      </a:lnTo>
                      <a:lnTo>
                        <a:pt x="1931" y="99"/>
                      </a:lnTo>
                      <a:lnTo>
                        <a:pt x="1931" y="104"/>
                      </a:lnTo>
                      <a:lnTo>
                        <a:pt x="1931" y="104"/>
                      </a:lnTo>
                      <a:lnTo>
                        <a:pt x="1932" y="104"/>
                      </a:lnTo>
                      <a:lnTo>
                        <a:pt x="1932" y="100"/>
                      </a:lnTo>
                      <a:lnTo>
                        <a:pt x="1932" y="104"/>
                      </a:lnTo>
                      <a:lnTo>
                        <a:pt x="1932" y="100"/>
                      </a:lnTo>
                      <a:lnTo>
                        <a:pt x="1933" y="100"/>
                      </a:lnTo>
                      <a:lnTo>
                        <a:pt x="1933" y="100"/>
                      </a:lnTo>
                      <a:lnTo>
                        <a:pt x="1933" y="103"/>
                      </a:lnTo>
                      <a:lnTo>
                        <a:pt x="1933" y="103"/>
                      </a:lnTo>
                      <a:lnTo>
                        <a:pt x="1934" y="103"/>
                      </a:lnTo>
                      <a:lnTo>
                        <a:pt x="1934" y="98"/>
                      </a:lnTo>
                      <a:lnTo>
                        <a:pt x="1934" y="103"/>
                      </a:lnTo>
                      <a:lnTo>
                        <a:pt x="1934" y="99"/>
                      </a:lnTo>
                      <a:lnTo>
                        <a:pt x="1935" y="99"/>
                      </a:lnTo>
                      <a:lnTo>
                        <a:pt x="1935" y="98"/>
                      </a:lnTo>
                      <a:lnTo>
                        <a:pt x="1935" y="103"/>
                      </a:lnTo>
                      <a:lnTo>
                        <a:pt x="1935" y="103"/>
                      </a:lnTo>
                      <a:lnTo>
                        <a:pt x="1936" y="103"/>
                      </a:lnTo>
                      <a:lnTo>
                        <a:pt x="1936" y="100"/>
                      </a:lnTo>
                      <a:lnTo>
                        <a:pt x="1936" y="104"/>
                      </a:lnTo>
                      <a:lnTo>
                        <a:pt x="1936" y="104"/>
                      </a:lnTo>
                      <a:lnTo>
                        <a:pt x="1937" y="104"/>
                      </a:lnTo>
                      <a:lnTo>
                        <a:pt x="1937" y="99"/>
                      </a:lnTo>
                      <a:lnTo>
                        <a:pt x="1937" y="103"/>
                      </a:lnTo>
                      <a:lnTo>
                        <a:pt x="1937" y="100"/>
                      </a:lnTo>
                      <a:lnTo>
                        <a:pt x="1938" y="100"/>
                      </a:lnTo>
                      <a:lnTo>
                        <a:pt x="1938" y="100"/>
                      </a:lnTo>
                      <a:lnTo>
                        <a:pt x="1938" y="103"/>
                      </a:lnTo>
                      <a:lnTo>
                        <a:pt x="1938" y="100"/>
                      </a:lnTo>
                      <a:lnTo>
                        <a:pt x="1939" y="100"/>
                      </a:lnTo>
                      <a:lnTo>
                        <a:pt x="1939" y="98"/>
                      </a:lnTo>
                      <a:lnTo>
                        <a:pt x="1939" y="102"/>
                      </a:lnTo>
                      <a:lnTo>
                        <a:pt x="1939" y="100"/>
                      </a:lnTo>
                      <a:lnTo>
                        <a:pt x="1940" y="100"/>
                      </a:lnTo>
                      <a:lnTo>
                        <a:pt x="1940" y="98"/>
                      </a:lnTo>
                      <a:lnTo>
                        <a:pt x="1940" y="101"/>
                      </a:lnTo>
                      <a:lnTo>
                        <a:pt x="1940" y="99"/>
                      </a:lnTo>
                      <a:lnTo>
                        <a:pt x="1941" y="99"/>
                      </a:lnTo>
                      <a:lnTo>
                        <a:pt x="1941" y="98"/>
                      </a:lnTo>
                      <a:lnTo>
                        <a:pt x="1941" y="102"/>
                      </a:lnTo>
                      <a:lnTo>
                        <a:pt x="1941" y="100"/>
                      </a:lnTo>
                      <a:lnTo>
                        <a:pt x="1942" y="100"/>
                      </a:lnTo>
                      <a:lnTo>
                        <a:pt x="1942" y="97"/>
                      </a:lnTo>
                      <a:lnTo>
                        <a:pt x="1942" y="101"/>
                      </a:lnTo>
                      <a:lnTo>
                        <a:pt x="1942" y="99"/>
                      </a:lnTo>
                      <a:lnTo>
                        <a:pt x="1943" y="99"/>
                      </a:lnTo>
                      <a:lnTo>
                        <a:pt x="1943" y="98"/>
                      </a:lnTo>
                      <a:lnTo>
                        <a:pt x="1943" y="101"/>
                      </a:lnTo>
                      <a:lnTo>
                        <a:pt x="1943" y="100"/>
                      </a:lnTo>
                      <a:lnTo>
                        <a:pt x="1944" y="100"/>
                      </a:lnTo>
                      <a:lnTo>
                        <a:pt x="1944" y="98"/>
                      </a:lnTo>
                      <a:lnTo>
                        <a:pt x="1944" y="101"/>
                      </a:lnTo>
                      <a:lnTo>
                        <a:pt x="1944" y="98"/>
                      </a:lnTo>
                      <a:lnTo>
                        <a:pt x="1945" y="98"/>
                      </a:lnTo>
                      <a:lnTo>
                        <a:pt x="1945" y="98"/>
                      </a:lnTo>
                      <a:lnTo>
                        <a:pt x="1945" y="101"/>
                      </a:lnTo>
                      <a:lnTo>
                        <a:pt x="1945" y="98"/>
                      </a:lnTo>
                      <a:lnTo>
                        <a:pt x="1946" y="98"/>
                      </a:lnTo>
                      <a:lnTo>
                        <a:pt x="1946" y="98"/>
                      </a:lnTo>
                      <a:lnTo>
                        <a:pt x="1946" y="100"/>
                      </a:lnTo>
                      <a:lnTo>
                        <a:pt x="1946" y="99"/>
                      </a:lnTo>
                      <a:lnTo>
                        <a:pt x="1947" y="99"/>
                      </a:lnTo>
                      <a:lnTo>
                        <a:pt x="1947" y="98"/>
                      </a:lnTo>
                      <a:lnTo>
                        <a:pt x="1947" y="101"/>
                      </a:lnTo>
                      <a:lnTo>
                        <a:pt x="1947" y="98"/>
                      </a:lnTo>
                      <a:lnTo>
                        <a:pt x="1948" y="98"/>
                      </a:lnTo>
                      <a:lnTo>
                        <a:pt x="1948" y="98"/>
                      </a:lnTo>
                      <a:lnTo>
                        <a:pt x="1948" y="103"/>
                      </a:lnTo>
                      <a:lnTo>
                        <a:pt x="1948" y="99"/>
                      </a:lnTo>
                      <a:lnTo>
                        <a:pt x="1949" y="99"/>
                      </a:lnTo>
                      <a:lnTo>
                        <a:pt x="1949" y="96"/>
                      </a:lnTo>
                      <a:lnTo>
                        <a:pt x="1949" y="101"/>
                      </a:lnTo>
                      <a:lnTo>
                        <a:pt x="1949" y="98"/>
                      </a:lnTo>
                      <a:lnTo>
                        <a:pt x="1950" y="98"/>
                      </a:lnTo>
                      <a:lnTo>
                        <a:pt x="1950" y="97"/>
                      </a:lnTo>
                      <a:lnTo>
                        <a:pt x="1950" y="101"/>
                      </a:lnTo>
                      <a:lnTo>
                        <a:pt x="1950" y="98"/>
                      </a:lnTo>
                      <a:lnTo>
                        <a:pt x="1951" y="98"/>
                      </a:lnTo>
                      <a:lnTo>
                        <a:pt x="1951" y="98"/>
                      </a:lnTo>
                      <a:lnTo>
                        <a:pt x="1951" y="101"/>
                      </a:lnTo>
                      <a:lnTo>
                        <a:pt x="1951" y="100"/>
                      </a:lnTo>
                      <a:lnTo>
                        <a:pt x="1952" y="100"/>
                      </a:lnTo>
                      <a:lnTo>
                        <a:pt x="1952" y="98"/>
                      </a:lnTo>
                      <a:lnTo>
                        <a:pt x="1952" y="101"/>
                      </a:lnTo>
                      <a:lnTo>
                        <a:pt x="1952" y="101"/>
                      </a:lnTo>
                      <a:lnTo>
                        <a:pt x="1953" y="101"/>
                      </a:lnTo>
                      <a:lnTo>
                        <a:pt x="1953" y="99"/>
                      </a:lnTo>
                      <a:lnTo>
                        <a:pt x="1953" y="102"/>
                      </a:lnTo>
                      <a:lnTo>
                        <a:pt x="1953" y="99"/>
                      </a:lnTo>
                      <a:lnTo>
                        <a:pt x="1954" y="99"/>
                      </a:lnTo>
                      <a:lnTo>
                        <a:pt x="1954" y="98"/>
                      </a:lnTo>
                      <a:lnTo>
                        <a:pt x="1954" y="103"/>
                      </a:lnTo>
                      <a:lnTo>
                        <a:pt x="1954" y="102"/>
                      </a:lnTo>
                      <a:lnTo>
                        <a:pt x="1955" y="102"/>
                      </a:lnTo>
                      <a:lnTo>
                        <a:pt x="1955" y="97"/>
                      </a:lnTo>
                      <a:lnTo>
                        <a:pt x="1955" y="102"/>
                      </a:lnTo>
                      <a:lnTo>
                        <a:pt x="1955" y="98"/>
                      </a:lnTo>
                      <a:lnTo>
                        <a:pt x="1956" y="98"/>
                      </a:lnTo>
                      <a:lnTo>
                        <a:pt x="1956" y="98"/>
                      </a:lnTo>
                      <a:lnTo>
                        <a:pt x="1956" y="103"/>
                      </a:lnTo>
                      <a:lnTo>
                        <a:pt x="1956" y="100"/>
                      </a:lnTo>
                      <a:lnTo>
                        <a:pt x="1957" y="100"/>
                      </a:lnTo>
                      <a:lnTo>
                        <a:pt x="1957" y="97"/>
                      </a:lnTo>
                      <a:lnTo>
                        <a:pt x="1957" y="104"/>
                      </a:lnTo>
                      <a:lnTo>
                        <a:pt x="1957" y="99"/>
                      </a:lnTo>
                      <a:lnTo>
                        <a:pt x="1958" y="99"/>
                      </a:lnTo>
                      <a:lnTo>
                        <a:pt x="1958" y="98"/>
                      </a:lnTo>
                      <a:lnTo>
                        <a:pt x="1958" y="101"/>
                      </a:lnTo>
                      <a:lnTo>
                        <a:pt x="1958" y="101"/>
                      </a:lnTo>
                      <a:lnTo>
                        <a:pt x="1959" y="101"/>
                      </a:lnTo>
                      <a:lnTo>
                        <a:pt x="1959" y="98"/>
                      </a:lnTo>
                      <a:lnTo>
                        <a:pt x="1959" y="103"/>
                      </a:lnTo>
                      <a:lnTo>
                        <a:pt x="1959" y="101"/>
                      </a:lnTo>
                      <a:lnTo>
                        <a:pt x="1960" y="101"/>
                      </a:lnTo>
                      <a:lnTo>
                        <a:pt x="1960" y="98"/>
                      </a:lnTo>
                      <a:lnTo>
                        <a:pt x="1960" y="101"/>
                      </a:lnTo>
                      <a:lnTo>
                        <a:pt x="1960" y="98"/>
                      </a:lnTo>
                      <a:lnTo>
                        <a:pt x="1961" y="98"/>
                      </a:lnTo>
                      <a:lnTo>
                        <a:pt x="1961" y="98"/>
                      </a:lnTo>
                      <a:lnTo>
                        <a:pt x="1961" y="101"/>
                      </a:lnTo>
                      <a:lnTo>
                        <a:pt x="1961" y="100"/>
                      </a:lnTo>
                      <a:lnTo>
                        <a:pt x="1962" y="100"/>
                      </a:lnTo>
                      <a:lnTo>
                        <a:pt x="1962" y="97"/>
                      </a:lnTo>
                      <a:lnTo>
                        <a:pt x="1962" y="102"/>
                      </a:lnTo>
                      <a:lnTo>
                        <a:pt x="1962" y="99"/>
                      </a:lnTo>
                      <a:lnTo>
                        <a:pt x="1963" y="99"/>
                      </a:lnTo>
                      <a:lnTo>
                        <a:pt x="1963" y="98"/>
                      </a:lnTo>
                      <a:lnTo>
                        <a:pt x="1963" y="103"/>
                      </a:lnTo>
                      <a:lnTo>
                        <a:pt x="1963" y="103"/>
                      </a:lnTo>
                      <a:lnTo>
                        <a:pt x="1964" y="103"/>
                      </a:lnTo>
                      <a:lnTo>
                        <a:pt x="1964" y="98"/>
                      </a:lnTo>
                      <a:lnTo>
                        <a:pt x="1964" y="101"/>
                      </a:lnTo>
                      <a:lnTo>
                        <a:pt x="1964" y="98"/>
                      </a:lnTo>
                      <a:lnTo>
                        <a:pt x="1965" y="98"/>
                      </a:lnTo>
                      <a:lnTo>
                        <a:pt x="1965" y="97"/>
                      </a:lnTo>
                      <a:lnTo>
                        <a:pt x="1965" y="101"/>
                      </a:lnTo>
                      <a:lnTo>
                        <a:pt x="1965" y="100"/>
                      </a:lnTo>
                      <a:lnTo>
                        <a:pt x="1966" y="100"/>
                      </a:lnTo>
                      <a:lnTo>
                        <a:pt x="1966" y="97"/>
                      </a:lnTo>
                      <a:lnTo>
                        <a:pt x="1966" y="101"/>
                      </a:lnTo>
                      <a:lnTo>
                        <a:pt x="1966" y="100"/>
                      </a:lnTo>
                      <a:lnTo>
                        <a:pt x="1967" y="100"/>
                      </a:lnTo>
                      <a:lnTo>
                        <a:pt x="1967" y="98"/>
                      </a:lnTo>
                      <a:lnTo>
                        <a:pt x="1967" y="102"/>
                      </a:lnTo>
                      <a:lnTo>
                        <a:pt x="1967" y="99"/>
                      </a:lnTo>
                      <a:lnTo>
                        <a:pt x="1968" y="99"/>
                      </a:lnTo>
                      <a:lnTo>
                        <a:pt x="1968" y="97"/>
                      </a:lnTo>
                      <a:lnTo>
                        <a:pt x="1968" y="101"/>
                      </a:lnTo>
                      <a:lnTo>
                        <a:pt x="1968" y="99"/>
                      </a:lnTo>
                      <a:lnTo>
                        <a:pt x="1969" y="99"/>
                      </a:lnTo>
                      <a:lnTo>
                        <a:pt x="1969" y="97"/>
                      </a:lnTo>
                      <a:lnTo>
                        <a:pt x="1969" y="100"/>
                      </a:lnTo>
                      <a:lnTo>
                        <a:pt x="1969" y="97"/>
                      </a:lnTo>
                      <a:lnTo>
                        <a:pt x="1970" y="97"/>
                      </a:lnTo>
                      <a:lnTo>
                        <a:pt x="1970" y="97"/>
                      </a:lnTo>
                      <a:lnTo>
                        <a:pt x="1970" y="101"/>
                      </a:lnTo>
                      <a:lnTo>
                        <a:pt x="1970" y="98"/>
                      </a:lnTo>
                      <a:lnTo>
                        <a:pt x="1971" y="98"/>
                      </a:lnTo>
                      <a:lnTo>
                        <a:pt x="1971" y="98"/>
                      </a:lnTo>
                      <a:lnTo>
                        <a:pt x="1971" y="101"/>
                      </a:lnTo>
                      <a:lnTo>
                        <a:pt x="1971" y="99"/>
                      </a:lnTo>
                      <a:lnTo>
                        <a:pt x="1972" y="99"/>
                      </a:lnTo>
                      <a:lnTo>
                        <a:pt x="1972" y="97"/>
                      </a:lnTo>
                      <a:lnTo>
                        <a:pt x="1972" y="100"/>
                      </a:lnTo>
                      <a:lnTo>
                        <a:pt x="1972" y="98"/>
                      </a:lnTo>
                      <a:lnTo>
                        <a:pt x="1973" y="98"/>
                      </a:lnTo>
                      <a:lnTo>
                        <a:pt x="1973" y="98"/>
                      </a:lnTo>
                      <a:lnTo>
                        <a:pt x="1973" y="101"/>
                      </a:lnTo>
                      <a:lnTo>
                        <a:pt x="1973" y="99"/>
                      </a:lnTo>
                      <a:lnTo>
                        <a:pt x="1974" y="99"/>
                      </a:lnTo>
                      <a:lnTo>
                        <a:pt x="1974" y="97"/>
                      </a:lnTo>
                      <a:lnTo>
                        <a:pt x="1974" y="101"/>
                      </a:lnTo>
                      <a:lnTo>
                        <a:pt x="1974" y="98"/>
                      </a:lnTo>
                      <a:lnTo>
                        <a:pt x="1975" y="98"/>
                      </a:lnTo>
                      <a:lnTo>
                        <a:pt x="1975" y="97"/>
                      </a:lnTo>
                      <a:lnTo>
                        <a:pt x="1975" y="101"/>
                      </a:lnTo>
                      <a:lnTo>
                        <a:pt x="1975" y="101"/>
                      </a:lnTo>
                      <a:lnTo>
                        <a:pt x="1976" y="101"/>
                      </a:lnTo>
                      <a:lnTo>
                        <a:pt x="1976" y="98"/>
                      </a:lnTo>
                      <a:lnTo>
                        <a:pt x="1976" y="101"/>
                      </a:lnTo>
                      <a:lnTo>
                        <a:pt x="1976" y="99"/>
                      </a:lnTo>
                      <a:lnTo>
                        <a:pt x="1977" y="99"/>
                      </a:lnTo>
                      <a:lnTo>
                        <a:pt x="1977" y="98"/>
                      </a:lnTo>
                      <a:lnTo>
                        <a:pt x="1977" y="101"/>
                      </a:lnTo>
                      <a:lnTo>
                        <a:pt x="1977" y="101"/>
                      </a:lnTo>
                      <a:lnTo>
                        <a:pt x="1978" y="101"/>
                      </a:lnTo>
                      <a:lnTo>
                        <a:pt x="1978" y="98"/>
                      </a:lnTo>
                      <a:lnTo>
                        <a:pt x="1978" y="102"/>
                      </a:lnTo>
                      <a:lnTo>
                        <a:pt x="1978" y="98"/>
                      </a:lnTo>
                      <a:lnTo>
                        <a:pt x="1979" y="98"/>
                      </a:lnTo>
                      <a:lnTo>
                        <a:pt x="1979" y="96"/>
                      </a:lnTo>
                      <a:lnTo>
                        <a:pt x="1979" y="100"/>
                      </a:lnTo>
                      <a:lnTo>
                        <a:pt x="1979" y="98"/>
                      </a:lnTo>
                      <a:lnTo>
                        <a:pt x="1980" y="98"/>
                      </a:lnTo>
                      <a:lnTo>
                        <a:pt x="1980" y="98"/>
                      </a:lnTo>
                      <a:lnTo>
                        <a:pt x="1980" y="101"/>
                      </a:lnTo>
                      <a:lnTo>
                        <a:pt x="1980" y="98"/>
                      </a:lnTo>
                      <a:lnTo>
                        <a:pt x="1981" y="98"/>
                      </a:lnTo>
                      <a:lnTo>
                        <a:pt x="1981" y="98"/>
                      </a:lnTo>
                      <a:lnTo>
                        <a:pt x="1981" y="103"/>
                      </a:lnTo>
                      <a:lnTo>
                        <a:pt x="1981" y="100"/>
                      </a:lnTo>
                      <a:lnTo>
                        <a:pt x="1982" y="100"/>
                      </a:lnTo>
                      <a:lnTo>
                        <a:pt x="1982" y="97"/>
                      </a:lnTo>
                      <a:lnTo>
                        <a:pt x="1982" y="100"/>
                      </a:lnTo>
                      <a:lnTo>
                        <a:pt x="1982" y="98"/>
                      </a:lnTo>
                      <a:lnTo>
                        <a:pt x="1983" y="98"/>
                      </a:lnTo>
                      <a:lnTo>
                        <a:pt x="1983" y="98"/>
                      </a:lnTo>
                      <a:lnTo>
                        <a:pt x="1983" y="103"/>
                      </a:lnTo>
                      <a:lnTo>
                        <a:pt x="1983" y="100"/>
                      </a:lnTo>
                      <a:lnTo>
                        <a:pt x="1984" y="100"/>
                      </a:lnTo>
                      <a:lnTo>
                        <a:pt x="1984" y="98"/>
                      </a:lnTo>
                      <a:lnTo>
                        <a:pt x="1984" y="101"/>
                      </a:lnTo>
                      <a:lnTo>
                        <a:pt x="1984" y="99"/>
                      </a:lnTo>
                      <a:lnTo>
                        <a:pt x="1985" y="99"/>
                      </a:lnTo>
                      <a:lnTo>
                        <a:pt x="1985" y="99"/>
                      </a:lnTo>
                      <a:lnTo>
                        <a:pt x="1985" y="101"/>
                      </a:lnTo>
                      <a:lnTo>
                        <a:pt x="1985" y="99"/>
                      </a:lnTo>
                      <a:lnTo>
                        <a:pt x="1986" y="99"/>
                      </a:lnTo>
                      <a:lnTo>
                        <a:pt x="1986" y="98"/>
                      </a:lnTo>
                      <a:lnTo>
                        <a:pt x="1986" y="102"/>
                      </a:lnTo>
                      <a:lnTo>
                        <a:pt x="1986" y="100"/>
                      </a:lnTo>
                      <a:lnTo>
                        <a:pt x="1987" y="100"/>
                      </a:lnTo>
                      <a:lnTo>
                        <a:pt x="1987" y="98"/>
                      </a:lnTo>
                      <a:lnTo>
                        <a:pt x="1987" y="101"/>
                      </a:lnTo>
                      <a:lnTo>
                        <a:pt x="1987" y="100"/>
                      </a:lnTo>
                      <a:lnTo>
                        <a:pt x="1988" y="100"/>
                      </a:lnTo>
                      <a:lnTo>
                        <a:pt x="1988" y="98"/>
                      </a:lnTo>
                      <a:lnTo>
                        <a:pt x="1988" y="101"/>
                      </a:lnTo>
                      <a:lnTo>
                        <a:pt x="1988" y="100"/>
                      </a:lnTo>
                      <a:lnTo>
                        <a:pt x="1989" y="100"/>
                      </a:lnTo>
                      <a:lnTo>
                        <a:pt x="1989" y="98"/>
                      </a:lnTo>
                      <a:lnTo>
                        <a:pt x="1989" y="101"/>
                      </a:lnTo>
                      <a:lnTo>
                        <a:pt x="1989" y="99"/>
                      </a:lnTo>
                      <a:lnTo>
                        <a:pt x="1990" y="99"/>
                      </a:lnTo>
                      <a:lnTo>
                        <a:pt x="1990" y="97"/>
                      </a:lnTo>
                      <a:lnTo>
                        <a:pt x="1990" y="100"/>
                      </a:lnTo>
                      <a:lnTo>
                        <a:pt x="1990" y="100"/>
                      </a:lnTo>
                      <a:lnTo>
                        <a:pt x="1991" y="100"/>
                      </a:lnTo>
                      <a:lnTo>
                        <a:pt x="1991" y="97"/>
                      </a:lnTo>
                      <a:lnTo>
                        <a:pt x="1991" y="101"/>
                      </a:lnTo>
                      <a:lnTo>
                        <a:pt x="1991" y="100"/>
                      </a:lnTo>
                      <a:lnTo>
                        <a:pt x="1992" y="100"/>
                      </a:lnTo>
                      <a:lnTo>
                        <a:pt x="1992" y="97"/>
                      </a:lnTo>
                      <a:lnTo>
                        <a:pt x="1992" y="101"/>
                      </a:lnTo>
                      <a:lnTo>
                        <a:pt x="1992" y="100"/>
                      </a:lnTo>
                      <a:lnTo>
                        <a:pt x="1993" y="100"/>
                      </a:lnTo>
                      <a:lnTo>
                        <a:pt x="1993" y="98"/>
                      </a:lnTo>
                      <a:lnTo>
                        <a:pt x="1993" y="101"/>
                      </a:lnTo>
                    </a:path>
                  </a:pathLst>
                </a:custGeom>
                <a:noFill/>
                <a:ln w="11160">
                  <a:solidFill>
                    <a:srgbClr val="948a5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68400" rIns="68400" tIns="34200" bIns="34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5" name="Text Box 493"/>
              <p:cNvSpPr/>
              <p:nvPr/>
            </p:nvSpPr>
            <p:spPr>
              <a:xfrm rot="16200000">
                <a:off x="4535640" y="2072520"/>
                <a:ext cx="1046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Isc (µA/cm</a:t>
                </a:r>
                <a:r>
                  <a:rPr b="0" lang="fr-FR" sz="10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Connecteur droit 223"/>
              <p:cNvSpPr/>
              <p:nvPr/>
            </p:nvSpPr>
            <p:spPr>
              <a:xfrm flipV="1">
                <a:off x="5946840" y="1257840"/>
                <a:ext cx="2741760" cy="23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Connecteur droit 225"/>
              <p:cNvSpPr/>
              <p:nvPr/>
            </p:nvSpPr>
            <p:spPr>
              <a:xfrm flipV="1">
                <a:off x="6477120" y="1492200"/>
                <a:ext cx="2211480" cy="6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Connecteur droit 227"/>
              <p:cNvSpPr/>
              <p:nvPr/>
            </p:nvSpPr>
            <p:spPr>
              <a:xfrm flipV="1">
                <a:off x="7604280" y="1708560"/>
                <a:ext cx="1084320" cy="7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ZoneTexte 230"/>
              <p:cNvSpPr/>
              <p:nvPr/>
            </p:nvSpPr>
            <p:spPr>
              <a:xfrm>
                <a:off x="7242120" y="1280520"/>
                <a:ext cx="1352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sk/IBMx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ZoneTexte 231"/>
              <p:cNvSpPr/>
              <p:nvPr/>
            </p:nvSpPr>
            <p:spPr>
              <a:xfrm>
                <a:off x="7736040" y="1475640"/>
                <a:ext cx="1353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fr-FR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umetanid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21" name="ZoneTexte 6"/>
          <p:cNvSpPr/>
          <p:nvPr/>
        </p:nvSpPr>
        <p:spPr>
          <a:xfrm rot="18355800">
            <a:off x="4258080" y="6164640"/>
            <a:ext cx="5814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ZoneTexte 7"/>
          <p:cNvSpPr/>
          <p:nvPr/>
        </p:nvSpPr>
        <p:spPr>
          <a:xfrm rot="18801000">
            <a:off x="5716800" y="6094800"/>
            <a:ext cx="4291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40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10T06:45:07Z</dcterms:created>
  <dc:creator>EDELMAN</dc:creator>
  <dc:description/>
  <dc:language>en-US</dc:language>
  <cp:lastModifiedBy>SERMET-GAUDELUS Isabelle</cp:lastModifiedBy>
  <cp:lastPrinted>2016-10-18T08:25:53Z</cp:lastPrinted>
  <dcterms:modified xsi:type="dcterms:W3CDTF">2021-11-30T17:55:33Z</dcterms:modified>
  <cp:revision>304</cp:revision>
  <dc:subject/>
  <dc:title>Présentation PowerPoint</dc:title>
</cp:coreProperties>
</file>